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16459200" cy="9144000"/>
  <p:notesSz cx="16459200" cy="91440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234440" y="2834640"/>
            <a:ext cx="1399032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2468880" y="5120640"/>
            <a:ext cx="1152144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822960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8476488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488695" y="3583304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488695" y="2766060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488695" y="1948688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563880"/>
                </a:moveTo>
                <a:lnTo>
                  <a:pt x="15900908" y="563880"/>
                </a:lnTo>
              </a:path>
              <a:path w="15901035" h="3416935">
                <a:moveTo>
                  <a:pt x="2168271" y="3416427"/>
                </a:moveTo>
                <a:lnTo>
                  <a:pt x="2168271" y="0"/>
                </a:lnTo>
              </a:path>
              <a:path w="15901035" h="3416935">
                <a:moveTo>
                  <a:pt x="5059426" y="3416427"/>
                </a:moveTo>
                <a:lnTo>
                  <a:pt x="5059426" y="0"/>
                </a:lnTo>
              </a:path>
              <a:path w="15901035" h="3416935">
                <a:moveTo>
                  <a:pt x="7950454" y="3416427"/>
                </a:moveTo>
                <a:lnTo>
                  <a:pt x="7950454" y="0"/>
                </a:lnTo>
              </a:path>
              <a:path w="15901035" h="3416935">
                <a:moveTo>
                  <a:pt x="10841482" y="3416427"/>
                </a:moveTo>
                <a:lnTo>
                  <a:pt x="10841482" y="0"/>
                </a:lnTo>
              </a:path>
              <a:path w="15901035" h="3416935">
                <a:moveTo>
                  <a:pt x="13732637" y="3416427"/>
                </a:moveTo>
                <a:lnTo>
                  <a:pt x="13732637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" name="bg object 20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2607310"/>
                </a:moveTo>
                <a:lnTo>
                  <a:pt x="15900908" y="2607310"/>
                </a:lnTo>
              </a:path>
              <a:path w="15901035" h="3416935">
                <a:moveTo>
                  <a:pt x="0" y="1789938"/>
                </a:moveTo>
                <a:lnTo>
                  <a:pt x="15900908" y="1789938"/>
                </a:lnTo>
              </a:path>
              <a:path w="15901035" h="3416935">
                <a:moveTo>
                  <a:pt x="0" y="972566"/>
                </a:moveTo>
                <a:lnTo>
                  <a:pt x="15900908" y="972566"/>
                </a:lnTo>
              </a:path>
              <a:path w="15901035" h="3416935">
                <a:moveTo>
                  <a:pt x="0" y="155321"/>
                </a:moveTo>
                <a:lnTo>
                  <a:pt x="15900908" y="155321"/>
                </a:lnTo>
              </a:path>
              <a:path w="15901035" h="3416935">
                <a:moveTo>
                  <a:pt x="722757" y="3416427"/>
                </a:moveTo>
                <a:lnTo>
                  <a:pt x="722757" y="0"/>
                </a:lnTo>
              </a:path>
              <a:path w="15901035" h="3416935">
                <a:moveTo>
                  <a:pt x="3613912" y="3416427"/>
                </a:moveTo>
                <a:lnTo>
                  <a:pt x="3613912" y="0"/>
                </a:lnTo>
              </a:path>
              <a:path w="15901035" h="3416935">
                <a:moveTo>
                  <a:pt x="6504939" y="3416427"/>
                </a:moveTo>
                <a:lnTo>
                  <a:pt x="6504939" y="0"/>
                </a:lnTo>
              </a:path>
              <a:path w="15901035" h="3416935">
                <a:moveTo>
                  <a:pt x="9395968" y="3416427"/>
                </a:moveTo>
                <a:lnTo>
                  <a:pt x="9395968" y="0"/>
                </a:lnTo>
              </a:path>
              <a:path w="15901035" h="3416935">
                <a:moveTo>
                  <a:pt x="12287123" y="3416427"/>
                </a:moveTo>
                <a:lnTo>
                  <a:pt x="12287123" y="0"/>
                </a:lnTo>
              </a:path>
              <a:path w="15901035" h="3416935">
                <a:moveTo>
                  <a:pt x="15178150" y="3416427"/>
                </a:moveTo>
                <a:lnTo>
                  <a:pt x="15178150" y="0"/>
                </a:lnTo>
              </a:path>
            </a:pathLst>
          </a:custGeom>
          <a:ln w="13589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" name="bg object 21"/>
          <p:cNvSpPr/>
          <p:nvPr/>
        </p:nvSpPr>
        <p:spPr>
          <a:xfrm>
            <a:off x="1211452" y="722757"/>
            <a:ext cx="14340205" cy="154940"/>
          </a:xfrm>
          <a:custGeom>
            <a:avLst/>
            <a:gdLst/>
            <a:ahLst/>
            <a:cxnLst/>
            <a:rect l="l" t="t" r="r" b="b"/>
            <a:pathLst>
              <a:path w="14340205" h="154940">
                <a:moveTo>
                  <a:pt x="0" y="0"/>
                </a:moveTo>
                <a:lnTo>
                  <a:pt x="404749" y="0"/>
                </a:lnTo>
                <a:lnTo>
                  <a:pt x="404749" y="1397"/>
                </a:lnTo>
                <a:lnTo>
                  <a:pt x="520446" y="1397"/>
                </a:lnTo>
                <a:lnTo>
                  <a:pt x="578230" y="1397"/>
                </a:lnTo>
                <a:lnTo>
                  <a:pt x="578230" y="2794"/>
                </a:lnTo>
                <a:lnTo>
                  <a:pt x="636016" y="2794"/>
                </a:lnTo>
                <a:lnTo>
                  <a:pt x="693928" y="2794"/>
                </a:lnTo>
                <a:lnTo>
                  <a:pt x="751713" y="2794"/>
                </a:lnTo>
                <a:lnTo>
                  <a:pt x="809497" y="2794"/>
                </a:lnTo>
                <a:lnTo>
                  <a:pt x="867283" y="2794"/>
                </a:lnTo>
                <a:lnTo>
                  <a:pt x="925195" y="2794"/>
                </a:lnTo>
                <a:lnTo>
                  <a:pt x="925195" y="4318"/>
                </a:lnTo>
                <a:lnTo>
                  <a:pt x="982979" y="4318"/>
                </a:lnTo>
                <a:lnTo>
                  <a:pt x="982979" y="5842"/>
                </a:lnTo>
                <a:lnTo>
                  <a:pt x="1040765" y="5842"/>
                </a:lnTo>
                <a:lnTo>
                  <a:pt x="1040765" y="7366"/>
                </a:lnTo>
                <a:lnTo>
                  <a:pt x="1098677" y="7366"/>
                </a:lnTo>
                <a:lnTo>
                  <a:pt x="1156461" y="7366"/>
                </a:lnTo>
                <a:lnTo>
                  <a:pt x="1156461" y="8890"/>
                </a:lnTo>
                <a:lnTo>
                  <a:pt x="1214247" y="8890"/>
                </a:lnTo>
                <a:lnTo>
                  <a:pt x="1272032" y="8890"/>
                </a:lnTo>
                <a:lnTo>
                  <a:pt x="1329944" y="8890"/>
                </a:lnTo>
                <a:lnTo>
                  <a:pt x="1387729" y="8890"/>
                </a:lnTo>
                <a:lnTo>
                  <a:pt x="1387729" y="10414"/>
                </a:lnTo>
                <a:lnTo>
                  <a:pt x="1445514" y="10414"/>
                </a:lnTo>
                <a:lnTo>
                  <a:pt x="1503426" y="10414"/>
                </a:lnTo>
                <a:lnTo>
                  <a:pt x="1561211" y="10414"/>
                </a:lnTo>
                <a:lnTo>
                  <a:pt x="1618996" y="10414"/>
                </a:lnTo>
                <a:lnTo>
                  <a:pt x="1676780" y="10414"/>
                </a:lnTo>
                <a:lnTo>
                  <a:pt x="1734692" y="10414"/>
                </a:lnTo>
                <a:lnTo>
                  <a:pt x="1792477" y="10414"/>
                </a:lnTo>
                <a:lnTo>
                  <a:pt x="1850263" y="10414"/>
                </a:lnTo>
                <a:lnTo>
                  <a:pt x="1908175" y="10414"/>
                </a:lnTo>
                <a:lnTo>
                  <a:pt x="1965960" y="10414"/>
                </a:lnTo>
                <a:lnTo>
                  <a:pt x="2023745" y="10414"/>
                </a:lnTo>
                <a:lnTo>
                  <a:pt x="2081530" y="10414"/>
                </a:lnTo>
                <a:lnTo>
                  <a:pt x="2139442" y="10414"/>
                </a:lnTo>
                <a:lnTo>
                  <a:pt x="2139442" y="12065"/>
                </a:lnTo>
                <a:lnTo>
                  <a:pt x="2197227" y="12065"/>
                </a:lnTo>
                <a:lnTo>
                  <a:pt x="2255012" y="12065"/>
                </a:lnTo>
                <a:lnTo>
                  <a:pt x="2312924" y="12065"/>
                </a:lnTo>
                <a:lnTo>
                  <a:pt x="2370709" y="12065"/>
                </a:lnTo>
                <a:lnTo>
                  <a:pt x="2428494" y="12065"/>
                </a:lnTo>
                <a:lnTo>
                  <a:pt x="2428494" y="13716"/>
                </a:lnTo>
                <a:lnTo>
                  <a:pt x="2486406" y="13716"/>
                </a:lnTo>
                <a:lnTo>
                  <a:pt x="2486406" y="17145"/>
                </a:lnTo>
                <a:lnTo>
                  <a:pt x="2544191" y="17145"/>
                </a:lnTo>
                <a:lnTo>
                  <a:pt x="2601976" y="17145"/>
                </a:lnTo>
                <a:lnTo>
                  <a:pt x="2659761" y="17145"/>
                </a:lnTo>
                <a:lnTo>
                  <a:pt x="2717673" y="17145"/>
                </a:lnTo>
                <a:lnTo>
                  <a:pt x="2775458" y="17145"/>
                </a:lnTo>
                <a:lnTo>
                  <a:pt x="2775458" y="18923"/>
                </a:lnTo>
                <a:lnTo>
                  <a:pt x="2833243" y="18923"/>
                </a:lnTo>
                <a:lnTo>
                  <a:pt x="2891155" y="18923"/>
                </a:lnTo>
                <a:lnTo>
                  <a:pt x="2948940" y="18923"/>
                </a:lnTo>
                <a:lnTo>
                  <a:pt x="3006725" y="18923"/>
                </a:lnTo>
                <a:lnTo>
                  <a:pt x="3064510" y="18923"/>
                </a:lnTo>
                <a:lnTo>
                  <a:pt x="3122422" y="18923"/>
                </a:lnTo>
                <a:lnTo>
                  <a:pt x="3180207" y="18923"/>
                </a:lnTo>
                <a:lnTo>
                  <a:pt x="3237992" y="18923"/>
                </a:lnTo>
                <a:lnTo>
                  <a:pt x="3295904" y="18923"/>
                </a:lnTo>
                <a:lnTo>
                  <a:pt x="3353689" y="18923"/>
                </a:lnTo>
                <a:lnTo>
                  <a:pt x="3411474" y="18923"/>
                </a:lnTo>
                <a:lnTo>
                  <a:pt x="3469259" y="18923"/>
                </a:lnTo>
                <a:lnTo>
                  <a:pt x="3527171" y="18923"/>
                </a:lnTo>
                <a:lnTo>
                  <a:pt x="3584956" y="18923"/>
                </a:lnTo>
                <a:lnTo>
                  <a:pt x="3642741" y="18923"/>
                </a:lnTo>
                <a:lnTo>
                  <a:pt x="3642741" y="22733"/>
                </a:lnTo>
                <a:lnTo>
                  <a:pt x="3700653" y="22733"/>
                </a:lnTo>
                <a:lnTo>
                  <a:pt x="3758438" y="22733"/>
                </a:lnTo>
                <a:lnTo>
                  <a:pt x="3758438" y="24638"/>
                </a:lnTo>
                <a:lnTo>
                  <a:pt x="3816223" y="24638"/>
                </a:lnTo>
                <a:lnTo>
                  <a:pt x="3874008" y="24638"/>
                </a:lnTo>
                <a:lnTo>
                  <a:pt x="3931920" y="24638"/>
                </a:lnTo>
                <a:lnTo>
                  <a:pt x="3931920" y="26543"/>
                </a:lnTo>
                <a:lnTo>
                  <a:pt x="3989705" y="26543"/>
                </a:lnTo>
                <a:lnTo>
                  <a:pt x="4047490" y="26543"/>
                </a:lnTo>
                <a:lnTo>
                  <a:pt x="4105402" y="26543"/>
                </a:lnTo>
                <a:lnTo>
                  <a:pt x="4163187" y="26543"/>
                </a:lnTo>
                <a:lnTo>
                  <a:pt x="4220972" y="26543"/>
                </a:lnTo>
                <a:lnTo>
                  <a:pt x="4278757" y="26543"/>
                </a:lnTo>
                <a:lnTo>
                  <a:pt x="4336669" y="26543"/>
                </a:lnTo>
                <a:lnTo>
                  <a:pt x="4394454" y="26543"/>
                </a:lnTo>
                <a:lnTo>
                  <a:pt x="4394454" y="30734"/>
                </a:lnTo>
                <a:lnTo>
                  <a:pt x="4452239" y="30734"/>
                </a:lnTo>
                <a:lnTo>
                  <a:pt x="4510151" y="30734"/>
                </a:lnTo>
                <a:lnTo>
                  <a:pt x="4567936" y="30734"/>
                </a:lnTo>
                <a:lnTo>
                  <a:pt x="4567936" y="32893"/>
                </a:lnTo>
                <a:lnTo>
                  <a:pt x="4625721" y="32893"/>
                </a:lnTo>
                <a:lnTo>
                  <a:pt x="4683506" y="32893"/>
                </a:lnTo>
                <a:lnTo>
                  <a:pt x="4741418" y="32893"/>
                </a:lnTo>
                <a:lnTo>
                  <a:pt x="4799203" y="32893"/>
                </a:lnTo>
                <a:lnTo>
                  <a:pt x="4799203" y="35051"/>
                </a:lnTo>
                <a:lnTo>
                  <a:pt x="4856988" y="35051"/>
                </a:lnTo>
                <a:lnTo>
                  <a:pt x="4914900" y="35051"/>
                </a:lnTo>
                <a:lnTo>
                  <a:pt x="4972685" y="35051"/>
                </a:lnTo>
                <a:lnTo>
                  <a:pt x="4972685" y="37338"/>
                </a:lnTo>
                <a:lnTo>
                  <a:pt x="5030470" y="37338"/>
                </a:lnTo>
                <a:lnTo>
                  <a:pt x="5088255" y="37338"/>
                </a:lnTo>
                <a:lnTo>
                  <a:pt x="5146167" y="37338"/>
                </a:lnTo>
                <a:lnTo>
                  <a:pt x="5203952" y="37338"/>
                </a:lnTo>
                <a:lnTo>
                  <a:pt x="5261737" y="37338"/>
                </a:lnTo>
                <a:lnTo>
                  <a:pt x="5319649" y="37338"/>
                </a:lnTo>
                <a:lnTo>
                  <a:pt x="5377433" y="37338"/>
                </a:lnTo>
                <a:lnTo>
                  <a:pt x="5435219" y="37338"/>
                </a:lnTo>
                <a:lnTo>
                  <a:pt x="5493004" y="37338"/>
                </a:lnTo>
                <a:lnTo>
                  <a:pt x="5550916" y="37338"/>
                </a:lnTo>
                <a:lnTo>
                  <a:pt x="5608701" y="37338"/>
                </a:lnTo>
                <a:lnTo>
                  <a:pt x="5666486" y="37338"/>
                </a:lnTo>
                <a:lnTo>
                  <a:pt x="5724398" y="37338"/>
                </a:lnTo>
                <a:lnTo>
                  <a:pt x="5782183" y="37338"/>
                </a:lnTo>
                <a:lnTo>
                  <a:pt x="5839968" y="37338"/>
                </a:lnTo>
                <a:lnTo>
                  <a:pt x="5897753" y="37338"/>
                </a:lnTo>
                <a:lnTo>
                  <a:pt x="5897753" y="39877"/>
                </a:lnTo>
                <a:lnTo>
                  <a:pt x="5955665" y="39877"/>
                </a:lnTo>
                <a:lnTo>
                  <a:pt x="6013450" y="39877"/>
                </a:lnTo>
                <a:lnTo>
                  <a:pt x="6013450" y="42418"/>
                </a:lnTo>
                <a:lnTo>
                  <a:pt x="6071235" y="42418"/>
                </a:lnTo>
                <a:lnTo>
                  <a:pt x="6129147" y="42418"/>
                </a:lnTo>
                <a:lnTo>
                  <a:pt x="6186932" y="42418"/>
                </a:lnTo>
                <a:lnTo>
                  <a:pt x="6244717" y="42418"/>
                </a:lnTo>
                <a:lnTo>
                  <a:pt x="6302502" y="42418"/>
                </a:lnTo>
                <a:lnTo>
                  <a:pt x="6302502" y="44958"/>
                </a:lnTo>
                <a:lnTo>
                  <a:pt x="6360414" y="44958"/>
                </a:lnTo>
                <a:lnTo>
                  <a:pt x="6360414" y="47625"/>
                </a:lnTo>
                <a:lnTo>
                  <a:pt x="6418199" y="47625"/>
                </a:lnTo>
                <a:lnTo>
                  <a:pt x="6475983" y="47625"/>
                </a:lnTo>
                <a:lnTo>
                  <a:pt x="6475983" y="50419"/>
                </a:lnTo>
                <a:lnTo>
                  <a:pt x="6533896" y="50419"/>
                </a:lnTo>
                <a:lnTo>
                  <a:pt x="6591681" y="50419"/>
                </a:lnTo>
                <a:lnTo>
                  <a:pt x="6649466" y="50419"/>
                </a:lnTo>
                <a:lnTo>
                  <a:pt x="6707251" y="50419"/>
                </a:lnTo>
                <a:lnTo>
                  <a:pt x="6765163" y="50419"/>
                </a:lnTo>
                <a:lnTo>
                  <a:pt x="6822948" y="50419"/>
                </a:lnTo>
                <a:lnTo>
                  <a:pt x="6822948" y="53213"/>
                </a:lnTo>
                <a:lnTo>
                  <a:pt x="6880733" y="53213"/>
                </a:lnTo>
                <a:lnTo>
                  <a:pt x="6880733" y="56007"/>
                </a:lnTo>
                <a:lnTo>
                  <a:pt x="6938645" y="56007"/>
                </a:lnTo>
                <a:lnTo>
                  <a:pt x="6996430" y="56007"/>
                </a:lnTo>
                <a:lnTo>
                  <a:pt x="6996430" y="58927"/>
                </a:lnTo>
                <a:lnTo>
                  <a:pt x="7054215" y="58927"/>
                </a:lnTo>
                <a:lnTo>
                  <a:pt x="7112000" y="58927"/>
                </a:lnTo>
                <a:lnTo>
                  <a:pt x="7169912" y="58927"/>
                </a:lnTo>
                <a:lnTo>
                  <a:pt x="7227697" y="58927"/>
                </a:lnTo>
                <a:lnTo>
                  <a:pt x="7285482" y="58927"/>
                </a:lnTo>
                <a:lnTo>
                  <a:pt x="7343394" y="58927"/>
                </a:lnTo>
                <a:lnTo>
                  <a:pt x="7343394" y="61849"/>
                </a:lnTo>
                <a:lnTo>
                  <a:pt x="7401179" y="61849"/>
                </a:lnTo>
                <a:lnTo>
                  <a:pt x="7401179" y="64897"/>
                </a:lnTo>
                <a:lnTo>
                  <a:pt x="7458964" y="64897"/>
                </a:lnTo>
                <a:lnTo>
                  <a:pt x="7458964" y="70993"/>
                </a:lnTo>
                <a:lnTo>
                  <a:pt x="7516749" y="70993"/>
                </a:lnTo>
                <a:lnTo>
                  <a:pt x="7574661" y="70993"/>
                </a:lnTo>
                <a:lnTo>
                  <a:pt x="7574661" y="74168"/>
                </a:lnTo>
                <a:lnTo>
                  <a:pt x="7632446" y="74168"/>
                </a:lnTo>
                <a:lnTo>
                  <a:pt x="7690231" y="74168"/>
                </a:lnTo>
                <a:lnTo>
                  <a:pt x="7748143" y="74168"/>
                </a:lnTo>
                <a:lnTo>
                  <a:pt x="7805928" y="74168"/>
                </a:lnTo>
                <a:lnTo>
                  <a:pt x="7863713" y="74168"/>
                </a:lnTo>
                <a:lnTo>
                  <a:pt x="7863713" y="80645"/>
                </a:lnTo>
                <a:lnTo>
                  <a:pt x="7921625" y="80645"/>
                </a:lnTo>
                <a:lnTo>
                  <a:pt x="7979410" y="80645"/>
                </a:lnTo>
                <a:lnTo>
                  <a:pt x="8037195" y="80645"/>
                </a:lnTo>
                <a:lnTo>
                  <a:pt x="8094980" y="80645"/>
                </a:lnTo>
                <a:lnTo>
                  <a:pt x="8152892" y="80645"/>
                </a:lnTo>
                <a:lnTo>
                  <a:pt x="8210677" y="80645"/>
                </a:lnTo>
                <a:lnTo>
                  <a:pt x="8210677" y="84200"/>
                </a:lnTo>
                <a:lnTo>
                  <a:pt x="8268462" y="84200"/>
                </a:lnTo>
                <a:lnTo>
                  <a:pt x="8268462" y="87629"/>
                </a:lnTo>
                <a:lnTo>
                  <a:pt x="8326374" y="87629"/>
                </a:lnTo>
                <a:lnTo>
                  <a:pt x="8384158" y="87629"/>
                </a:lnTo>
                <a:lnTo>
                  <a:pt x="8441944" y="87629"/>
                </a:lnTo>
                <a:lnTo>
                  <a:pt x="8499729" y="87629"/>
                </a:lnTo>
                <a:lnTo>
                  <a:pt x="8557641" y="87629"/>
                </a:lnTo>
                <a:lnTo>
                  <a:pt x="8557641" y="95250"/>
                </a:lnTo>
                <a:lnTo>
                  <a:pt x="8615426" y="95250"/>
                </a:lnTo>
                <a:lnTo>
                  <a:pt x="8673211" y="95250"/>
                </a:lnTo>
                <a:lnTo>
                  <a:pt x="8731123" y="95250"/>
                </a:lnTo>
                <a:lnTo>
                  <a:pt x="8788908" y="95250"/>
                </a:lnTo>
                <a:lnTo>
                  <a:pt x="8788908" y="99187"/>
                </a:lnTo>
                <a:lnTo>
                  <a:pt x="8846693" y="99187"/>
                </a:lnTo>
                <a:lnTo>
                  <a:pt x="8904478" y="99187"/>
                </a:lnTo>
                <a:lnTo>
                  <a:pt x="8904478" y="103124"/>
                </a:lnTo>
                <a:lnTo>
                  <a:pt x="8962390" y="103124"/>
                </a:lnTo>
                <a:lnTo>
                  <a:pt x="9020175" y="103124"/>
                </a:lnTo>
                <a:lnTo>
                  <a:pt x="9077960" y="103124"/>
                </a:lnTo>
                <a:lnTo>
                  <a:pt x="9135872" y="103124"/>
                </a:lnTo>
                <a:lnTo>
                  <a:pt x="9193657" y="103124"/>
                </a:lnTo>
                <a:lnTo>
                  <a:pt x="9251442" y="103124"/>
                </a:lnTo>
                <a:lnTo>
                  <a:pt x="9309227" y="103124"/>
                </a:lnTo>
                <a:lnTo>
                  <a:pt x="9367139" y="103124"/>
                </a:lnTo>
                <a:lnTo>
                  <a:pt x="9424924" y="103124"/>
                </a:lnTo>
                <a:lnTo>
                  <a:pt x="9482709" y="103124"/>
                </a:lnTo>
                <a:lnTo>
                  <a:pt x="9482709" y="107823"/>
                </a:lnTo>
                <a:lnTo>
                  <a:pt x="9540621" y="107823"/>
                </a:lnTo>
                <a:lnTo>
                  <a:pt x="9540621" y="112649"/>
                </a:lnTo>
                <a:lnTo>
                  <a:pt x="9598406" y="112649"/>
                </a:lnTo>
                <a:lnTo>
                  <a:pt x="9598406" y="117475"/>
                </a:lnTo>
                <a:lnTo>
                  <a:pt x="9656191" y="117475"/>
                </a:lnTo>
                <a:lnTo>
                  <a:pt x="9713976" y="117475"/>
                </a:lnTo>
                <a:lnTo>
                  <a:pt x="9713976" y="122554"/>
                </a:lnTo>
                <a:lnTo>
                  <a:pt x="9771888" y="122554"/>
                </a:lnTo>
                <a:lnTo>
                  <a:pt x="9771888" y="127762"/>
                </a:lnTo>
                <a:lnTo>
                  <a:pt x="9829673" y="127762"/>
                </a:lnTo>
                <a:lnTo>
                  <a:pt x="9829673" y="127762"/>
                </a:lnTo>
                <a:lnTo>
                  <a:pt x="9887458" y="127762"/>
                </a:lnTo>
                <a:lnTo>
                  <a:pt x="9945370" y="127762"/>
                </a:lnTo>
                <a:lnTo>
                  <a:pt x="10003155" y="127762"/>
                </a:lnTo>
                <a:lnTo>
                  <a:pt x="10060940" y="127762"/>
                </a:lnTo>
                <a:lnTo>
                  <a:pt x="10118725" y="127762"/>
                </a:lnTo>
                <a:lnTo>
                  <a:pt x="10176637" y="127762"/>
                </a:lnTo>
                <a:lnTo>
                  <a:pt x="10234422" y="127762"/>
                </a:lnTo>
                <a:lnTo>
                  <a:pt x="10292207" y="127762"/>
                </a:lnTo>
                <a:lnTo>
                  <a:pt x="10350119" y="127762"/>
                </a:lnTo>
                <a:lnTo>
                  <a:pt x="10407904" y="127762"/>
                </a:lnTo>
                <a:lnTo>
                  <a:pt x="10465689" y="127762"/>
                </a:lnTo>
                <a:lnTo>
                  <a:pt x="10523474" y="127762"/>
                </a:lnTo>
                <a:lnTo>
                  <a:pt x="10581386" y="127762"/>
                </a:lnTo>
                <a:lnTo>
                  <a:pt x="10581386" y="134620"/>
                </a:lnTo>
                <a:lnTo>
                  <a:pt x="10639171" y="134620"/>
                </a:lnTo>
                <a:lnTo>
                  <a:pt x="10696956" y="134620"/>
                </a:lnTo>
                <a:lnTo>
                  <a:pt x="10754868" y="134620"/>
                </a:lnTo>
                <a:lnTo>
                  <a:pt x="10812653" y="134620"/>
                </a:lnTo>
                <a:lnTo>
                  <a:pt x="10870438" y="134620"/>
                </a:lnTo>
                <a:lnTo>
                  <a:pt x="10928223" y="134620"/>
                </a:lnTo>
                <a:lnTo>
                  <a:pt x="10986135" y="134620"/>
                </a:lnTo>
                <a:lnTo>
                  <a:pt x="11043920" y="134620"/>
                </a:lnTo>
                <a:lnTo>
                  <a:pt x="11101705" y="134620"/>
                </a:lnTo>
                <a:lnTo>
                  <a:pt x="11159617" y="134620"/>
                </a:lnTo>
                <a:lnTo>
                  <a:pt x="11217402" y="134620"/>
                </a:lnTo>
                <a:lnTo>
                  <a:pt x="11275187" y="134620"/>
                </a:lnTo>
                <a:lnTo>
                  <a:pt x="11332972" y="134620"/>
                </a:lnTo>
                <a:lnTo>
                  <a:pt x="11390884" y="134620"/>
                </a:lnTo>
                <a:lnTo>
                  <a:pt x="11448669" y="134620"/>
                </a:lnTo>
                <a:lnTo>
                  <a:pt x="11506454" y="134620"/>
                </a:lnTo>
                <a:lnTo>
                  <a:pt x="11564366" y="134620"/>
                </a:lnTo>
                <a:lnTo>
                  <a:pt x="11622151" y="134620"/>
                </a:lnTo>
                <a:lnTo>
                  <a:pt x="11622151" y="144145"/>
                </a:lnTo>
                <a:lnTo>
                  <a:pt x="11679936" y="144145"/>
                </a:lnTo>
                <a:lnTo>
                  <a:pt x="11737721" y="144145"/>
                </a:lnTo>
                <a:lnTo>
                  <a:pt x="11795633" y="144145"/>
                </a:lnTo>
                <a:lnTo>
                  <a:pt x="11853418" y="144145"/>
                </a:lnTo>
                <a:lnTo>
                  <a:pt x="11911203" y="144145"/>
                </a:lnTo>
                <a:lnTo>
                  <a:pt x="11911203" y="154686"/>
                </a:lnTo>
                <a:lnTo>
                  <a:pt x="11969115" y="154686"/>
                </a:lnTo>
                <a:lnTo>
                  <a:pt x="12026900" y="154686"/>
                </a:lnTo>
                <a:lnTo>
                  <a:pt x="12084685" y="154686"/>
                </a:lnTo>
                <a:lnTo>
                  <a:pt x="12142470" y="154686"/>
                </a:lnTo>
                <a:lnTo>
                  <a:pt x="12200382" y="154686"/>
                </a:lnTo>
                <a:lnTo>
                  <a:pt x="12258166" y="154686"/>
                </a:lnTo>
                <a:lnTo>
                  <a:pt x="12315952" y="154686"/>
                </a:lnTo>
                <a:lnTo>
                  <a:pt x="12373864" y="154686"/>
                </a:lnTo>
                <a:lnTo>
                  <a:pt x="12431649" y="154686"/>
                </a:lnTo>
                <a:lnTo>
                  <a:pt x="12489434" y="154686"/>
                </a:lnTo>
                <a:lnTo>
                  <a:pt x="12547218" y="154686"/>
                </a:lnTo>
                <a:lnTo>
                  <a:pt x="12605131" y="154686"/>
                </a:lnTo>
                <a:lnTo>
                  <a:pt x="12662916" y="154686"/>
                </a:lnTo>
                <a:lnTo>
                  <a:pt x="12720701" y="154686"/>
                </a:lnTo>
                <a:lnTo>
                  <a:pt x="12778613" y="154686"/>
                </a:lnTo>
                <a:lnTo>
                  <a:pt x="12836398" y="154686"/>
                </a:lnTo>
                <a:lnTo>
                  <a:pt x="12894183" y="154686"/>
                </a:lnTo>
                <a:lnTo>
                  <a:pt x="12951968" y="154686"/>
                </a:lnTo>
                <a:lnTo>
                  <a:pt x="13009879" y="154686"/>
                </a:lnTo>
                <a:lnTo>
                  <a:pt x="13067664" y="154686"/>
                </a:lnTo>
                <a:lnTo>
                  <a:pt x="13125450" y="154686"/>
                </a:lnTo>
                <a:lnTo>
                  <a:pt x="13183362" y="154686"/>
                </a:lnTo>
                <a:lnTo>
                  <a:pt x="13241146" y="154686"/>
                </a:lnTo>
                <a:lnTo>
                  <a:pt x="13298931" y="154686"/>
                </a:lnTo>
                <a:lnTo>
                  <a:pt x="13356843" y="154686"/>
                </a:lnTo>
                <a:lnTo>
                  <a:pt x="13414629" y="154686"/>
                </a:lnTo>
                <a:lnTo>
                  <a:pt x="13472414" y="154686"/>
                </a:lnTo>
                <a:lnTo>
                  <a:pt x="13530198" y="154686"/>
                </a:lnTo>
                <a:lnTo>
                  <a:pt x="13588110" y="154686"/>
                </a:lnTo>
                <a:lnTo>
                  <a:pt x="13645895" y="154686"/>
                </a:lnTo>
                <a:lnTo>
                  <a:pt x="13703681" y="154686"/>
                </a:lnTo>
                <a:lnTo>
                  <a:pt x="13761592" y="154686"/>
                </a:lnTo>
                <a:lnTo>
                  <a:pt x="13819377" y="154686"/>
                </a:lnTo>
                <a:lnTo>
                  <a:pt x="13877162" y="154686"/>
                </a:lnTo>
                <a:lnTo>
                  <a:pt x="13934948" y="154686"/>
                </a:lnTo>
                <a:lnTo>
                  <a:pt x="13992860" y="154686"/>
                </a:lnTo>
                <a:lnTo>
                  <a:pt x="14050644" y="154686"/>
                </a:lnTo>
                <a:lnTo>
                  <a:pt x="14108429" y="154686"/>
                </a:lnTo>
                <a:lnTo>
                  <a:pt x="14166341" y="154686"/>
                </a:lnTo>
                <a:lnTo>
                  <a:pt x="14224127" y="154686"/>
                </a:lnTo>
                <a:lnTo>
                  <a:pt x="14281912" y="154686"/>
                </a:lnTo>
                <a:lnTo>
                  <a:pt x="14339696" y="154686"/>
                </a:lnTo>
              </a:path>
            </a:pathLst>
          </a:custGeom>
          <a:ln w="27051">
            <a:solidFill>
              <a:srgbClr val="E95359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" name="bg object 22"/>
          <p:cNvSpPr/>
          <p:nvPr/>
        </p:nvSpPr>
        <p:spPr>
          <a:xfrm>
            <a:off x="1211452" y="722757"/>
            <a:ext cx="14397990" cy="553085"/>
          </a:xfrm>
          <a:custGeom>
            <a:avLst/>
            <a:gdLst/>
            <a:ahLst/>
            <a:cxnLst/>
            <a:rect l="l" t="t" r="r" b="b"/>
            <a:pathLst>
              <a:path w="14397990" h="553085">
                <a:moveTo>
                  <a:pt x="0" y="0"/>
                </a:moveTo>
                <a:lnTo>
                  <a:pt x="57784" y="0"/>
                </a:lnTo>
                <a:lnTo>
                  <a:pt x="57784" y="635"/>
                </a:lnTo>
                <a:lnTo>
                  <a:pt x="115697" y="635"/>
                </a:lnTo>
                <a:lnTo>
                  <a:pt x="115697" y="1270"/>
                </a:lnTo>
                <a:lnTo>
                  <a:pt x="173481" y="1270"/>
                </a:lnTo>
                <a:lnTo>
                  <a:pt x="173481" y="1904"/>
                </a:lnTo>
                <a:lnTo>
                  <a:pt x="231266" y="1904"/>
                </a:lnTo>
                <a:lnTo>
                  <a:pt x="231266" y="2540"/>
                </a:lnTo>
                <a:lnTo>
                  <a:pt x="289178" y="2540"/>
                </a:lnTo>
                <a:lnTo>
                  <a:pt x="289178" y="3175"/>
                </a:lnTo>
                <a:lnTo>
                  <a:pt x="346963" y="3175"/>
                </a:lnTo>
                <a:lnTo>
                  <a:pt x="346963" y="5207"/>
                </a:lnTo>
                <a:lnTo>
                  <a:pt x="404749" y="5207"/>
                </a:lnTo>
                <a:lnTo>
                  <a:pt x="404749" y="7112"/>
                </a:lnTo>
                <a:lnTo>
                  <a:pt x="462534" y="7112"/>
                </a:lnTo>
                <a:lnTo>
                  <a:pt x="520446" y="7112"/>
                </a:lnTo>
                <a:lnTo>
                  <a:pt x="520446" y="9778"/>
                </a:lnTo>
                <a:lnTo>
                  <a:pt x="578230" y="9778"/>
                </a:lnTo>
                <a:lnTo>
                  <a:pt x="578230" y="12319"/>
                </a:lnTo>
                <a:lnTo>
                  <a:pt x="636016" y="12319"/>
                </a:lnTo>
                <a:lnTo>
                  <a:pt x="636016" y="13716"/>
                </a:lnTo>
                <a:lnTo>
                  <a:pt x="693928" y="13716"/>
                </a:lnTo>
                <a:lnTo>
                  <a:pt x="693928" y="14986"/>
                </a:lnTo>
                <a:lnTo>
                  <a:pt x="751713" y="14986"/>
                </a:lnTo>
                <a:lnTo>
                  <a:pt x="751713" y="17652"/>
                </a:lnTo>
                <a:lnTo>
                  <a:pt x="809497" y="17652"/>
                </a:lnTo>
                <a:lnTo>
                  <a:pt x="809497" y="19558"/>
                </a:lnTo>
                <a:lnTo>
                  <a:pt x="867283" y="19558"/>
                </a:lnTo>
                <a:lnTo>
                  <a:pt x="867283" y="20320"/>
                </a:lnTo>
                <a:lnTo>
                  <a:pt x="925195" y="20320"/>
                </a:lnTo>
                <a:lnTo>
                  <a:pt x="925195" y="23622"/>
                </a:lnTo>
                <a:lnTo>
                  <a:pt x="982979" y="23622"/>
                </a:lnTo>
                <a:lnTo>
                  <a:pt x="982979" y="24257"/>
                </a:lnTo>
                <a:lnTo>
                  <a:pt x="1040765" y="24257"/>
                </a:lnTo>
                <a:lnTo>
                  <a:pt x="1040765" y="25653"/>
                </a:lnTo>
                <a:lnTo>
                  <a:pt x="1098677" y="25653"/>
                </a:lnTo>
                <a:lnTo>
                  <a:pt x="1156461" y="25653"/>
                </a:lnTo>
                <a:lnTo>
                  <a:pt x="1214247" y="25653"/>
                </a:lnTo>
                <a:lnTo>
                  <a:pt x="1214247" y="27050"/>
                </a:lnTo>
                <a:lnTo>
                  <a:pt x="1272032" y="27050"/>
                </a:lnTo>
                <a:lnTo>
                  <a:pt x="1272032" y="29845"/>
                </a:lnTo>
                <a:lnTo>
                  <a:pt x="1329944" y="29845"/>
                </a:lnTo>
                <a:lnTo>
                  <a:pt x="1329944" y="30479"/>
                </a:lnTo>
                <a:lnTo>
                  <a:pt x="1387729" y="30479"/>
                </a:lnTo>
                <a:lnTo>
                  <a:pt x="1387729" y="32639"/>
                </a:lnTo>
                <a:lnTo>
                  <a:pt x="1445514" y="32639"/>
                </a:lnTo>
                <a:lnTo>
                  <a:pt x="1445514" y="33400"/>
                </a:lnTo>
                <a:lnTo>
                  <a:pt x="1503426" y="33400"/>
                </a:lnTo>
                <a:lnTo>
                  <a:pt x="1503426" y="34798"/>
                </a:lnTo>
                <a:lnTo>
                  <a:pt x="1561211" y="34798"/>
                </a:lnTo>
                <a:lnTo>
                  <a:pt x="1561211" y="38353"/>
                </a:lnTo>
                <a:lnTo>
                  <a:pt x="1618996" y="38353"/>
                </a:lnTo>
                <a:lnTo>
                  <a:pt x="1618996" y="41275"/>
                </a:lnTo>
                <a:lnTo>
                  <a:pt x="1676780" y="41275"/>
                </a:lnTo>
                <a:lnTo>
                  <a:pt x="1676780" y="44196"/>
                </a:lnTo>
                <a:lnTo>
                  <a:pt x="1734692" y="44196"/>
                </a:lnTo>
                <a:lnTo>
                  <a:pt x="1792477" y="44196"/>
                </a:lnTo>
                <a:lnTo>
                  <a:pt x="1850263" y="44196"/>
                </a:lnTo>
                <a:lnTo>
                  <a:pt x="1850263" y="46482"/>
                </a:lnTo>
                <a:lnTo>
                  <a:pt x="1908175" y="46482"/>
                </a:lnTo>
                <a:lnTo>
                  <a:pt x="1965960" y="46482"/>
                </a:lnTo>
                <a:lnTo>
                  <a:pt x="1965960" y="48006"/>
                </a:lnTo>
                <a:lnTo>
                  <a:pt x="2023745" y="48006"/>
                </a:lnTo>
                <a:lnTo>
                  <a:pt x="2081530" y="48006"/>
                </a:lnTo>
                <a:lnTo>
                  <a:pt x="2081530" y="49529"/>
                </a:lnTo>
                <a:lnTo>
                  <a:pt x="2139442" y="49529"/>
                </a:lnTo>
                <a:lnTo>
                  <a:pt x="2139442" y="51053"/>
                </a:lnTo>
                <a:lnTo>
                  <a:pt x="2197227" y="51053"/>
                </a:lnTo>
                <a:lnTo>
                  <a:pt x="2197227" y="52577"/>
                </a:lnTo>
                <a:lnTo>
                  <a:pt x="2255012" y="52577"/>
                </a:lnTo>
                <a:lnTo>
                  <a:pt x="2255012" y="54991"/>
                </a:lnTo>
                <a:lnTo>
                  <a:pt x="2312924" y="54991"/>
                </a:lnTo>
                <a:lnTo>
                  <a:pt x="2312924" y="56515"/>
                </a:lnTo>
                <a:lnTo>
                  <a:pt x="2370709" y="56515"/>
                </a:lnTo>
                <a:lnTo>
                  <a:pt x="2370709" y="58166"/>
                </a:lnTo>
                <a:lnTo>
                  <a:pt x="2428494" y="58166"/>
                </a:lnTo>
                <a:lnTo>
                  <a:pt x="2428494" y="58927"/>
                </a:lnTo>
                <a:lnTo>
                  <a:pt x="2486406" y="58927"/>
                </a:lnTo>
                <a:lnTo>
                  <a:pt x="2486406" y="63753"/>
                </a:lnTo>
                <a:lnTo>
                  <a:pt x="2544191" y="63753"/>
                </a:lnTo>
                <a:lnTo>
                  <a:pt x="2544191" y="67056"/>
                </a:lnTo>
                <a:lnTo>
                  <a:pt x="2601976" y="67056"/>
                </a:lnTo>
                <a:lnTo>
                  <a:pt x="2601976" y="68707"/>
                </a:lnTo>
                <a:lnTo>
                  <a:pt x="2659761" y="68707"/>
                </a:lnTo>
                <a:lnTo>
                  <a:pt x="2659761" y="70358"/>
                </a:lnTo>
                <a:lnTo>
                  <a:pt x="2717673" y="70358"/>
                </a:lnTo>
                <a:lnTo>
                  <a:pt x="2717673" y="71120"/>
                </a:lnTo>
                <a:lnTo>
                  <a:pt x="2775458" y="71120"/>
                </a:lnTo>
                <a:lnTo>
                  <a:pt x="2775458" y="72771"/>
                </a:lnTo>
                <a:lnTo>
                  <a:pt x="2833243" y="72771"/>
                </a:lnTo>
                <a:lnTo>
                  <a:pt x="2833243" y="75311"/>
                </a:lnTo>
                <a:lnTo>
                  <a:pt x="2891155" y="75311"/>
                </a:lnTo>
                <a:lnTo>
                  <a:pt x="2891155" y="76962"/>
                </a:lnTo>
                <a:lnTo>
                  <a:pt x="2948940" y="76962"/>
                </a:lnTo>
                <a:lnTo>
                  <a:pt x="2948940" y="79628"/>
                </a:lnTo>
                <a:lnTo>
                  <a:pt x="3006725" y="79628"/>
                </a:lnTo>
                <a:lnTo>
                  <a:pt x="3006725" y="83058"/>
                </a:lnTo>
                <a:lnTo>
                  <a:pt x="3064510" y="83058"/>
                </a:lnTo>
                <a:lnTo>
                  <a:pt x="3064510" y="84836"/>
                </a:lnTo>
                <a:lnTo>
                  <a:pt x="3122422" y="84836"/>
                </a:lnTo>
                <a:lnTo>
                  <a:pt x="3122422" y="88265"/>
                </a:lnTo>
                <a:lnTo>
                  <a:pt x="3180207" y="88265"/>
                </a:lnTo>
                <a:lnTo>
                  <a:pt x="3180207" y="91821"/>
                </a:lnTo>
                <a:lnTo>
                  <a:pt x="3237992" y="91821"/>
                </a:lnTo>
                <a:lnTo>
                  <a:pt x="3237992" y="97154"/>
                </a:lnTo>
                <a:lnTo>
                  <a:pt x="3295904" y="97154"/>
                </a:lnTo>
                <a:lnTo>
                  <a:pt x="3295904" y="98933"/>
                </a:lnTo>
                <a:lnTo>
                  <a:pt x="3353689" y="98933"/>
                </a:lnTo>
                <a:lnTo>
                  <a:pt x="3353689" y="104394"/>
                </a:lnTo>
                <a:lnTo>
                  <a:pt x="3411474" y="104394"/>
                </a:lnTo>
                <a:lnTo>
                  <a:pt x="3411474" y="107061"/>
                </a:lnTo>
                <a:lnTo>
                  <a:pt x="3469259" y="107061"/>
                </a:lnTo>
                <a:lnTo>
                  <a:pt x="3527171" y="107061"/>
                </a:lnTo>
                <a:lnTo>
                  <a:pt x="3527171" y="108966"/>
                </a:lnTo>
                <a:lnTo>
                  <a:pt x="3584956" y="108966"/>
                </a:lnTo>
                <a:lnTo>
                  <a:pt x="3584956" y="110744"/>
                </a:lnTo>
                <a:lnTo>
                  <a:pt x="3642741" y="110744"/>
                </a:lnTo>
                <a:lnTo>
                  <a:pt x="3642741" y="111760"/>
                </a:lnTo>
                <a:lnTo>
                  <a:pt x="3700653" y="111760"/>
                </a:lnTo>
                <a:lnTo>
                  <a:pt x="3700653" y="114553"/>
                </a:lnTo>
                <a:lnTo>
                  <a:pt x="3758438" y="114553"/>
                </a:lnTo>
                <a:lnTo>
                  <a:pt x="3758438" y="118364"/>
                </a:lnTo>
                <a:lnTo>
                  <a:pt x="3816223" y="118364"/>
                </a:lnTo>
                <a:lnTo>
                  <a:pt x="3874008" y="118364"/>
                </a:lnTo>
                <a:lnTo>
                  <a:pt x="3874008" y="121158"/>
                </a:lnTo>
                <a:lnTo>
                  <a:pt x="3931920" y="121158"/>
                </a:lnTo>
                <a:lnTo>
                  <a:pt x="3931920" y="124078"/>
                </a:lnTo>
                <a:lnTo>
                  <a:pt x="3989705" y="124078"/>
                </a:lnTo>
                <a:lnTo>
                  <a:pt x="3989705" y="127000"/>
                </a:lnTo>
                <a:lnTo>
                  <a:pt x="4047490" y="127000"/>
                </a:lnTo>
                <a:lnTo>
                  <a:pt x="4047490" y="129032"/>
                </a:lnTo>
                <a:lnTo>
                  <a:pt x="4105402" y="129032"/>
                </a:lnTo>
                <a:lnTo>
                  <a:pt x="4105402" y="130048"/>
                </a:lnTo>
                <a:lnTo>
                  <a:pt x="4163187" y="130048"/>
                </a:lnTo>
                <a:lnTo>
                  <a:pt x="4163187" y="132969"/>
                </a:lnTo>
                <a:lnTo>
                  <a:pt x="4220972" y="132969"/>
                </a:lnTo>
                <a:lnTo>
                  <a:pt x="4220972" y="135000"/>
                </a:lnTo>
                <a:lnTo>
                  <a:pt x="4278757" y="135000"/>
                </a:lnTo>
                <a:lnTo>
                  <a:pt x="4278757" y="138049"/>
                </a:lnTo>
                <a:lnTo>
                  <a:pt x="4336669" y="138049"/>
                </a:lnTo>
                <a:lnTo>
                  <a:pt x="4336669" y="139065"/>
                </a:lnTo>
                <a:lnTo>
                  <a:pt x="4394454" y="139065"/>
                </a:lnTo>
                <a:lnTo>
                  <a:pt x="4394454" y="142240"/>
                </a:lnTo>
                <a:lnTo>
                  <a:pt x="4452239" y="142240"/>
                </a:lnTo>
                <a:lnTo>
                  <a:pt x="4452239" y="146431"/>
                </a:lnTo>
                <a:lnTo>
                  <a:pt x="4510151" y="146431"/>
                </a:lnTo>
                <a:lnTo>
                  <a:pt x="4510151" y="149606"/>
                </a:lnTo>
                <a:lnTo>
                  <a:pt x="4567936" y="149606"/>
                </a:lnTo>
                <a:lnTo>
                  <a:pt x="4567936" y="150622"/>
                </a:lnTo>
                <a:lnTo>
                  <a:pt x="4625721" y="150622"/>
                </a:lnTo>
                <a:lnTo>
                  <a:pt x="4625721" y="152781"/>
                </a:lnTo>
                <a:lnTo>
                  <a:pt x="4683506" y="152781"/>
                </a:lnTo>
                <a:lnTo>
                  <a:pt x="4683506" y="153924"/>
                </a:lnTo>
                <a:lnTo>
                  <a:pt x="4741418" y="153924"/>
                </a:lnTo>
                <a:lnTo>
                  <a:pt x="4741418" y="155067"/>
                </a:lnTo>
                <a:lnTo>
                  <a:pt x="4799203" y="155067"/>
                </a:lnTo>
                <a:lnTo>
                  <a:pt x="4799203" y="157225"/>
                </a:lnTo>
                <a:lnTo>
                  <a:pt x="4856988" y="157225"/>
                </a:lnTo>
                <a:lnTo>
                  <a:pt x="4856988" y="159512"/>
                </a:lnTo>
                <a:lnTo>
                  <a:pt x="4914900" y="159512"/>
                </a:lnTo>
                <a:lnTo>
                  <a:pt x="4914900" y="160654"/>
                </a:lnTo>
                <a:lnTo>
                  <a:pt x="4972685" y="160654"/>
                </a:lnTo>
                <a:lnTo>
                  <a:pt x="4972685" y="164084"/>
                </a:lnTo>
                <a:lnTo>
                  <a:pt x="5030470" y="164084"/>
                </a:lnTo>
                <a:lnTo>
                  <a:pt x="5030470" y="166370"/>
                </a:lnTo>
                <a:lnTo>
                  <a:pt x="5088255" y="166370"/>
                </a:lnTo>
                <a:lnTo>
                  <a:pt x="5146167" y="166370"/>
                </a:lnTo>
                <a:lnTo>
                  <a:pt x="5146167" y="168656"/>
                </a:lnTo>
                <a:lnTo>
                  <a:pt x="5203952" y="168656"/>
                </a:lnTo>
                <a:lnTo>
                  <a:pt x="5261737" y="168656"/>
                </a:lnTo>
                <a:lnTo>
                  <a:pt x="5261737" y="169925"/>
                </a:lnTo>
                <a:lnTo>
                  <a:pt x="5319649" y="169925"/>
                </a:lnTo>
                <a:lnTo>
                  <a:pt x="5319649" y="173482"/>
                </a:lnTo>
                <a:lnTo>
                  <a:pt x="5377433" y="173482"/>
                </a:lnTo>
                <a:lnTo>
                  <a:pt x="5377433" y="177165"/>
                </a:lnTo>
                <a:lnTo>
                  <a:pt x="5435219" y="177165"/>
                </a:lnTo>
                <a:lnTo>
                  <a:pt x="5435219" y="178308"/>
                </a:lnTo>
                <a:lnTo>
                  <a:pt x="5493004" y="178308"/>
                </a:lnTo>
                <a:lnTo>
                  <a:pt x="5493004" y="179577"/>
                </a:lnTo>
                <a:lnTo>
                  <a:pt x="5550916" y="179577"/>
                </a:lnTo>
                <a:lnTo>
                  <a:pt x="5550916" y="184531"/>
                </a:lnTo>
                <a:lnTo>
                  <a:pt x="5608701" y="184531"/>
                </a:lnTo>
                <a:lnTo>
                  <a:pt x="5608701" y="187071"/>
                </a:lnTo>
                <a:lnTo>
                  <a:pt x="5666486" y="187071"/>
                </a:lnTo>
                <a:lnTo>
                  <a:pt x="5666486" y="189611"/>
                </a:lnTo>
                <a:lnTo>
                  <a:pt x="5724398" y="189611"/>
                </a:lnTo>
                <a:lnTo>
                  <a:pt x="5724398" y="190881"/>
                </a:lnTo>
                <a:lnTo>
                  <a:pt x="5782183" y="190881"/>
                </a:lnTo>
                <a:lnTo>
                  <a:pt x="5782183" y="194818"/>
                </a:lnTo>
                <a:lnTo>
                  <a:pt x="5839968" y="194818"/>
                </a:lnTo>
                <a:lnTo>
                  <a:pt x="5839968" y="197358"/>
                </a:lnTo>
                <a:lnTo>
                  <a:pt x="5897753" y="197358"/>
                </a:lnTo>
                <a:lnTo>
                  <a:pt x="5897753" y="198754"/>
                </a:lnTo>
                <a:lnTo>
                  <a:pt x="5955665" y="198754"/>
                </a:lnTo>
                <a:lnTo>
                  <a:pt x="5955665" y="201422"/>
                </a:lnTo>
                <a:lnTo>
                  <a:pt x="6013450" y="201422"/>
                </a:lnTo>
                <a:lnTo>
                  <a:pt x="6013450" y="202819"/>
                </a:lnTo>
                <a:lnTo>
                  <a:pt x="6071235" y="202819"/>
                </a:lnTo>
                <a:lnTo>
                  <a:pt x="6071235" y="204089"/>
                </a:lnTo>
                <a:lnTo>
                  <a:pt x="6129147" y="204089"/>
                </a:lnTo>
                <a:lnTo>
                  <a:pt x="6129147" y="205486"/>
                </a:lnTo>
                <a:lnTo>
                  <a:pt x="6186932" y="205486"/>
                </a:lnTo>
                <a:lnTo>
                  <a:pt x="6186932" y="206883"/>
                </a:lnTo>
                <a:lnTo>
                  <a:pt x="6244717" y="206883"/>
                </a:lnTo>
                <a:lnTo>
                  <a:pt x="6302502" y="206883"/>
                </a:lnTo>
                <a:lnTo>
                  <a:pt x="6302502" y="208407"/>
                </a:lnTo>
                <a:lnTo>
                  <a:pt x="6360414" y="208407"/>
                </a:lnTo>
                <a:lnTo>
                  <a:pt x="6360414" y="209803"/>
                </a:lnTo>
                <a:lnTo>
                  <a:pt x="6418199" y="209803"/>
                </a:lnTo>
                <a:lnTo>
                  <a:pt x="6418199" y="211200"/>
                </a:lnTo>
                <a:lnTo>
                  <a:pt x="6475983" y="211200"/>
                </a:lnTo>
                <a:lnTo>
                  <a:pt x="6533896" y="211200"/>
                </a:lnTo>
                <a:lnTo>
                  <a:pt x="6533896" y="214122"/>
                </a:lnTo>
                <a:lnTo>
                  <a:pt x="6591681" y="214122"/>
                </a:lnTo>
                <a:lnTo>
                  <a:pt x="6591681" y="221615"/>
                </a:lnTo>
                <a:lnTo>
                  <a:pt x="6649466" y="221615"/>
                </a:lnTo>
                <a:lnTo>
                  <a:pt x="6649466" y="227584"/>
                </a:lnTo>
                <a:lnTo>
                  <a:pt x="6707251" y="227584"/>
                </a:lnTo>
                <a:lnTo>
                  <a:pt x="6707251" y="229108"/>
                </a:lnTo>
                <a:lnTo>
                  <a:pt x="6765163" y="229108"/>
                </a:lnTo>
                <a:lnTo>
                  <a:pt x="6765163" y="230632"/>
                </a:lnTo>
                <a:lnTo>
                  <a:pt x="6822948" y="230632"/>
                </a:lnTo>
                <a:lnTo>
                  <a:pt x="6822948" y="232156"/>
                </a:lnTo>
                <a:lnTo>
                  <a:pt x="6880733" y="232156"/>
                </a:lnTo>
                <a:lnTo>
                  <a:pt x="6880733" y="233807"/>
                </a:lnTo>
                <a:lnTo>
                  <a:pt x="6938645" y="233807"/>
                </a:lnTo>
                <a:lnTo>
                  <a:pt x="6938645" y="240029"/>
                </a:lnTo>
                <a:lnTo>
                  <a:pt x="6996430" y="240029"/>
                </a:lnTo>
                <a:lnTo>
                  <a:pt x="6996430" y="243204"/>
                </a:lnTo>
                <a:lnTo>
                  <a:pt x="7054215" y="243204"/>
                </a:lnTo>
                <a:lnTo>
                  <a:pt x="7054215" y="252984"/>
                </a:lnTo>
                <a:lnTo>
                  <a:pt x="7112000" y="252984"/>
                </a:lnTo>
                <a:lnTo>
                  <a:pt x="7112000" y="254635"/>
                </a:lnTo>
                <a:lnTo>
                  <a:pt x="7169912" y="254635"/>
                </a:lnTo>
                <a:lnTo>
                  <a:pt x="7169912" y="256286"/>
                </a:lnTo>
                <a:lnTo>
                  <a:pt x="7227697" y="256286"/>
                </a:lnTo>
                <a:lnTo>
                  <a:pt x="7227697" y="262890"/>
                </a:lnTo>
                <a:lnTo>
                  <a:pt x="7285482" y="262890"/>
                </a:lnTo>
                <a:lnTo>
                  <a:pt x="7285482" y="266319"/>
                </a:lnTo>
                <a:lnTo>
                  <a:pt x="7343394" y="266319"/>
                </a:lnTo>
                <a:lnTo>
                  <a:pt x="7401179" y="266319"/>
                </a:lnTo>
                <a:lnTo>
                  <a:pt x="7401179" y="267970"/>
                </a:lnTo>
                <a:lnTo>
                  <a:pt x="7458964" y="267970"/>
                </a:lnTo>
                <a:lnTo>
                  <a:pt x="7458964" y="269748"/>
                </a:lnTo>
                <a:lnTo>
                  <a:pt x="7516749" y="269748"/>
                </a:lnTo>
                <a:lnTo>
                  <a:pt x="7516749" y="271525"/>
                </a:lnTo>
                <a:lnTo>
                  <a:pt x="7574661" y="271525"/>
                </a:lnTo>
                <a:lnTo>
                  <a:pt x="7632446" y="271525"/>
                </a:lnTo>
                <a:lnTo>
                  <a:pt x="7632446" y="275082"/>
                </a:lnTo>
                <a:lnTo>
                  <a:pt x="7690231" y="275082"/>
                </a:lnTo>
                <a:lnTo>
                  <a:pt x="7748143" y="275082"/>
                </a:lnTo>
                <a:lnTo>
                  <a:pt x="7748143" y="280670"/>
                </a:lnTo>
                <a:lnTo>
                  <a:pt x="7805928" y="280670"/>
                </a:lnTo>
                <a:lnTo>
                  <a:pt x="7805928" y="284479"/>
                </a:lnTo>
                <a:lnTo>
                  <a:pt x="7863713" y="284479"/>
                </a:lnTo>
                <a:lnTo>
                  <a:pt x="7863713" y="286385"/>
                </a:lnTo>
                <a:lnTo>
                  <a:pt x="7921625" y="286385"/>
                </a:lnTo>
                <a:lnTo>
                  <a:pt x="7979410" y="286385"/>
                </a:lnTo>
                <a:lnTo>
                  <a:pt x="8037195" y="286385"/>
                </a:lnTo>
                <a:lnTo>
                  <a:pt x="8037195" y="290322"/>
                </a:lnTo>
                <a:lnTo>
                  <a:pt x="8094980" y="290322"/>
                </a:lnTo>
                <a:lnTo>
                  <a:pt x="8094980" y="296418"/>
                </a:lnTo>
                <a:lnTo>
                  <a:pt x="8152892" y="296418"/>
                </a:lnTo>
                <a:lnTo>
                  <a:pt x="8152892" y="300354"/>
                </a:lnTo>
                <a:lnTo>
                  <a:pt x="8210677" y="300354"/>
                </a:lnTo>
                <a:lnTo>
                  <a:pt x="8210677" y="302514"/>
                </a:lnTo>
                <a:lnTo>
                  <a:pt x="8268462" y="302514"/>
                </a:lnTo>
                <a:lnTo>
                  <a:pt x="8268462" y="308737"/>
                </a:lnTo>
                <a:lnTo>
                  <a:pt x="8326374" y="308737"/>
                </a:lnTo>
                <a:lnTo>
                  <a:pt x="8326374" y="312927"/>
                </a:lnTo>
                <a:lnTo>
                  <a:pt x="8384158" y="312927"/>
                </a:lnTo>
                <a:lnTo>
                  <a:pt x="8441944" y="312927"/>
                </a:lnTo>
                <a:lnTo>
                  <a:pt x="8441944" y="315087"/>
                </a:lnTo>
                <a:lnTo>
                  <a:pt x="8499729" y="315087"/>
                </a:lnTo>
                <a:lnTo>
                  <a:pt x="8557641" y="315087"/>
                </a:lnTo>
                <a:lnTo>
                  <a:pt x="8557641" y="317373"/>
                </a:lnTo>
                <a:lnTo>
                  <a:pt x="8615426" y="317373"/>
                </a:lnTo>
                <a:lnTo>
                  <a:pt x="8615426" y="324358"/>
                </a:lnTo>
                <a:lnTo>
                  <a:pt x="8673211" y="324358"/>
                </a:lnTo>
                <a:lnTo>
                  <a:pt x="8673211" y="331343"/>
                </a:lnTo>
                <a:lnTo>
                  <a:pt x="8731123" y="331343"/>
                </a:lnTo>
                <a:lnTo>
                  <a:pt x="8731123" y="338454"/>
                </a:lnTo>
                <a:lnTo>
                  <a:pt x="8788908" y="338454"/>
                </a:lnTo>
                <a:lnTo>
                  <a:pt x="8846693" y="338454"/>
                </a:lnTo>
                <a:lnTo>
                  <a:pt x="8846693" y="345821"/>
                </a:lnTo>
                <a:lnTo>
                  <a:pt x="8904478" y="345821"/>
                </a:lnTo>
                <a:lnTo>
                  <a:pt x="8962390" y="345821"/>
                </a:lnTo>
                <a:lnTo>
                  <a:pt x="9020175" y="345821"/>
                </a:lnTo>
                <a:lnTo>
                  <a:pt x="9020175" y="355981"/>
                </a:lnTo>
                <a:lnTo>
                  <a:pt x="9077960" y="355981"/>
                </a:lnTo>
                <a:lnTo>
                  <a:pt x="9135872" y="355981"/>
                </a:lnTo>
                <a:lnTo>
                  <a:pt x="9135872" y="358521"/>
                </a:lnTo>
                <a:lnTo>
                  <a:pt x="9193657" y="358521"/>
                </a:lnTo>
                <a:lnTo>
                  <a:pt x="9251442" y="358521"/>
                </a:lnTo>
                <a:lnTo>
                  <a:pt x="9251442" y="361188"/>
                </a:lnTo>
                <a:lnTo>
                  <a:pt x="9309227" y="361188"/>
                </a:lnTo>
                <a:lnTo>
                  <a:pt x="9367139" y="361188"/>
                </a:lnTo>
                <a:lnTo>
                  <a:pt x="9424924" y="361188"/>
                </a:lnTo>
                <a:lnTo>
                  <a:pt x="9424924" y="366902"/>
                </a:lnTo>
                <a:lnTo>
                  <a:pt x="9482709" y="366902"/>
                </a:lnTo>
                <a:lnTo>
                  <a:pt x="9540621" y="366902"/>
                </a:lnTo>
                <a:lnTo>
                  <a:pt x="9540621" y="369824"/>
                </a:lnTo>
                <a:lnTo>
                  <a:pt x="9598406" y="369824"/>
                </a:lnTo>
                <a:lnTo>
                  <a:pt x="9656191" y="369824"/>
                </a:lnTo>
                <a:lnTo>
                  <a:pt x="9713976" y="369824"/>
                </a:lnTo>
                <a:lnTo>
                  <a:pt x="9713976" y="372999"/>
                </a:lnTo>
                <a:lnTo>
                  <a:pt x="9771888" y="372999"/>
                </a:lnTo>
                <a:lnTo>
                  <a:pt x="9829673" y="372999"/>
                </a:lnTo>
                <a:lnTo>
                  <a:pt x="9829673" y="382650"/>
                </a:lnTo>
                <a:lnTo>
                  <a:pt x="9887458" y="382650"/>
                </a:lnTo>
                <a:lnTo>
                  <a:pt x="9945370" y="382650"/>
                </a:lnTo>
                <a:lnTo>
                  <a:pt x="10003155" y="382650"/>
                </a:lnTo>
                <a:lnTo>
                  <a:pt x="10060940" y="382650"/>
                </a:lnTo>
                <a:lnTo>
                  <a:pt x="10060940" y="386079"/>
                </a:lnTo>
                <a:lnTo>
                  <a:pt x="10118725" y="386079"/>
                </a:lnTo>
                <a:lnTo>
                  <a:pt x="10176637" y="386079"/>
                </a:lnTo>
                <a:lnTo>
                  <a:pt x="10176637" y="389763"/>
                </a:lnTo>
                <a:lnTo>
                  <a:pt x="10234422" y="389763"/>
                </a:lnTo>
                <a:lnTo>
                  <a:pt x="10234422" y="393446"/>
                </a:lnTo>
                <a:lnTo>
                  <a:pt x="10292207" y="393446"/>
                </a:lnTo>
                <a:lnTo>
                  <a:pt x="10292207" y="397256"/>
                </a:lnTo>
                <a:lnTo>
                  <a:pt x="10350119" y="397256"/>
                </a:lnTo>
                <a:lnTo>
                  <a:pt x="10350119" y="401193"/>
                </a:lnTo>
                <a:lnTo>
                  <a:pt x="10407904" y="401193"/>
                </a:lnTo>
                <a:lnTo>
                  <a:pt x="10465689" y="401193"/>
                </a:lnTo>
                <a:lnTo>
                  <a:pt x="10465689" y="405257"/>
                </a:lnTo>
                <a:lnTo>
                  <a:pt x="10523474" y="405257"/>
                </a:lnTo>
                <a:lnTo>
                  <a:pt x="10581386" y="405257"/>
                </a:lnTo>
                <a:lnTo>
                  <a:pt x="10581386" y="409448"/>
                </a:lnTo>
                <a:lnTo>
                  <a:pt x="10639171" y="409448"/>
                </a:lnTo>
                <a:lnTo>
                  <a:pt x="10639171" y="413639"/>
                </a:lnTo>
                <a:lnTo>
                  <a:pt x="10696956" y="413639"/>
                </a:lnTo>
                <a:lnTo>
                  <a:pt x="10696956" y="418084"/>
                </a:lnTo>
                <a:lnTo>
                  <a:pt x="10754868" y="418084"/>
                </a:lnTo>
                <a:lnTo>
                  <a:pt x="10812653" y="418084"/>
                </a:lnTo>
                <a:lnTo>
                  <a:pt x="10812653" y="422528"/>
                </a:lnTo>
                <a:lnTo>
                  <a:pt x="10870438" y="422528"/>
                </a:lnTo>
                <a:lnTo>
                  <a:pt x="10870438" y="426974"/>
                </a:lnTo>
                <a:lnTo>
                  <a:pt x="10928223" y="426974"/>
                </a:lnTo>
                <a:lnTo>
                  <a:pt x="10928223" y="431546"/>
                </a:lnTo>
                <a:lnTo>
                  <a:pt x="10986135" y="431546"/>
                </a:lnTo>
                <a:lnTo>
                  <a:pt x="11043920" y="431546"/>
                </a:lnTo>
                <a:lnTo>
                  <a:pt x="11101705" y="431546"/>
                </a:lnTo>
                <a:lnTo>
                  <a:pt x="11101705" y="436245"/>
                </a:lnTo>
                <a:lnTo>
                  <a:pt x="11159617" y="436245"/>
                </a:lnTo>
                <a:lnTo>
                  <a:pt x="11217402" y="436245"/>
                </a:lnTo>
                <a:lnTo>
                  <a:pt x="11275187" y="436245"/>
                </a:lnTo>
                <a:lnTo>
                  <a:pt x="11275187" y="441451"/>
                </a:lnTo>
                <a:lnTo>
                  <a:pt x="11332972" y="441451"/>
                </a:lnTo>
                <a:lnTo>
                  <a:pt x="11390884" y="441451"/>
                </a:lnTo>
                <a:lnTo>
                  <a:pt x="11390884" y="446913"/>
                </a:lnTo>
                <a:lnTo>
                  <a:pt x="11448669" y="446913"/>
                </a:lnTo>
                <a:lnTo>
                  <a:pt x="11506454" y="446913"/>
                </a:lnTo>
                <a:lnTo>
                  <a:pt x="11506454" y="458343"/>
                </a:lnTo>
                <a:lnTo>
                  <a:pt x="11564366" y="458343"/>
                </a:lnTo>
                <a:lnTo>
                  <a:pt x="11564366" y="464312"/>
                </a:lnTo>
                <a:lnTo>
                  <a:pt x="11622151" y="464312"/>
                </a:lnTo>
                <a:lnTo>
                  <a:pt x="11679936" y="464312"/>
                </a:lnTo>
                <a:lnTo>
                  <a:pt x="11737721" y="464312"/>
                </a:lnTo>
                <a:lnTo>
                  <a:pt x="11737721" y="470662"/>
                </a:lnTo>
                <a:lnTo>
                  <a:pt x="11795633" y="470662"/>
                </a:lnTo>
                <a:lnTo>
                  <a:pt x="11853418" y="470662"/>
                </a:lnTo>
                <a:lnTo>
                  <a:pt x="11853418" y="477139"/>
                </a:lnTo>
                <a:lnTo>
                  <a:pt x="11911203" y="477139"/>
                </a:lnTo>
                <a:lnTo>
                  <a:pt x="11969115" y="477139"/>
                </a:lnTo>
                <a:lnTo>
                  <a:pt x="12026900" y="477139"/>
                </a:lnTo>
                <a:lnTo>
                  <a:pt x="12084685" y="477139"/>
                </a:lnTo>
                <a:lnTo>
                  <a:pt x="12142470" y="477139"/>
                </a:lnTo>
                <a:lnTo>
                  <a:pt x="12142470" y="484504"/>
                </a:lnTo>
                <a:lnTo>
                  <a:pt x="12200382" y="484504"/>
                </a:lnTo>
                <a:lnTo>
                  <a:pt x="12258166" y="484504"/>
                </a:lnTo>
                <a:lnTo>
                  <a:pt x="12315952" y="484504"/>
                </a:lnTo>
                <a:lnTo>
                  <a:pt x="12373864" y="484504"/>
                </a:lnTo>
                <a:lnTo>
                  <a:pt x="12431649" y="484504"/>
                </a:lnTo>
                <a:lnTo>
                  <a:pt x="12489434" y="484504"/>
                </a:lnTo>
                <a:lnTo>
                  <a:pt x="12489434" y="493649"/>
                </a:lnTo>
                <a:lnTo>
                  <a:pt x="12547218" y="493649"/>
                </a:lnTo>
                <a:lnTo>
                  <a:pt x="12605131" y="493649"/>
                </a:lnTo>
                <a:lnTo>
                  <a:pt x="12662916" y="493649"/>
                </a:lnTo>
                <a:lnTo>
                  <a:pt x="12720701" y="493649"/>
                </a:lnTo>
                <a:lnTo>
                  <a:pt x="12720701" y="504951"/>
                </a:lnTo>
                <a:lnTo>
                  <a:pt x="12778613" y="504951"/>
                </a:lnTo>
                <a:lnTo>
                  <a:pt x="12836398" y="504951"/>
                </a:lnTo>
                <a:lnTo>
                  <a:pt x="12894183" y="504951"/>
                </a:lnTo>
                <a:lnTo>
                  <a:pt x="12951968" y="504951"/>
                </a:lnTo>
                <a:lnTo>
                  <a:pt x="13009879" y="504951"/>
                </a:lnTo>
                <a:lnTo>
                  <a:pt x="13067664" y="504951"/>
                </a:lnTo>
                <a:lnTo>
                  <a:pt x="13125450" y="504951"/>
                </a:lnTo>
                <a:lnTo>
                  <a:pt x="13183362" y="504951"/>
                </a:lnTo>
                <a:lnTo>
                  <a:pt x="13241146" y="504951"/>
                </a:lnTo>
                <a:lnTo>
                  <a:pt x="13298931" y="504951"/>
                </a:lnTo>
                <a:lnTo>
                  <a:pt x="13298931" y="526288"/>
                </a:lnTo>
                <a:lnTo>
                  <a:pt x="13356843" y="526288"/>
                </a:lnTo>
                <a:lnTo>
                  <a:pt x="13414629" y="526288"/>
                </a:lnTo>
                <a:lnTo>
                  <a:pt x="13472414" y="526288"/>
                </a:lnTo>
                <a:lnTo>
                  <a:pt x="13472414" y="552576"/>
                </a:lnTo>
                <a:lnTo>
                  <a:pt x="13530198" y="552576"/>
                </a:lnTo>
                <a:lnTo>
                  <a:pt x="13588110" y="552576"/>
                </a:lnTo>
                <a:lnTo>
                  <a:pt x="13645895" y="552576"/>
                </a:lnTo>
                <a:lnTo>
                  <a:pt x="13703681" y="552576"/>
                </a:lnTo>
                <a:lnTo>
                  <a:pt x="13761592" y="552576"/>
                </a:lnTo>
                <a:lnTo>
                  <a:pt x="13819377" y="552576"/>
                </a:lnTo>
                <a:lnTo>
                  <a:pt x="13877162" y="552576"/>
                </a:lnTo>
                <a:lnTo>
                  <a:pt x="13934948" y="552576"/>
                </a:lnTo>
                <a:lnTo>
                  <a:pt x="13992860" y="552576"/>
                </a:lnTo>
                <a:lnTo>
                  <a:pt x="14050644" y="552576"/>
                </a:lnTo>
                <a:lnTo>
                  <a:pt x="14108429" y="552576"/>
                </a:lnTo>
                <a:lnTo>
                  <a:pt x="14166341" y="552576"/>
                </a:lnTo>
                <a:lnTo>
                  <a:pt x="14224127" y="552576"/>
                </a:lnTo>
                <a:lnTo>
                  <a:pt x="14281912" y="552576"/>
                </a:lnTo>
                <a:lnTo>
                  <a:pt x="14339696" y="552576"/>
                </a:lnTo>
                <a:lnTo>
                  <a:pt x="14397608" y="552576"/>
                </a:lnTo>
              </a:path>
            </a:pathLst>
          </a:custGeom>
          <a:ln w="27051">
            <a:solidFill>
              <a:srgbClr val="41A3FF"/>
            </a:solidFill>
            <a:prstDash val="dash"/>
          </a:ln>
        </p:spPr>
        <p:txBody>
          <a:bodyPr wrap="square" lIns="0" tIns="0" rIns="0" bIns="0" rtlCol="0"/>
          <a:lstStyle/>
          <a:p/>
        </p:txBody>
      </p:sp>
      <p:sp>
        <p:nvSpPr>
          <p:cNvPr id="23" name="bg object 23"/>
          <p:cNvSpPr/>
          <p:nvPr/>
        </p:nvSpPr>
        <p:spPr>
          <a:xfrm>
            <a:off x="1211452" y="722757"/>
            <a:ext cx="14397990" cy="1390015"/>
          </a:xfrm>
          <a:custGeom>
            <a:avLst/>
            <a:gdLst/>
            <a:ahLst/>
            <a:cxnLst/>
            <a:rect l="l" t="t" r="r" b="b"/>
            <a:pathLst>
              <a:path w="14397990" h="1390014">
                <a:moveTo>
                  <a:pt x="0" y="0"/>
                </a:moveTo>
                <a:lnTo>
                  <a:pt x="57784" y="0"/>
                </a:lnTo>
                <a:lnTo>
                  <a:pt x="57784" y="2794"/>
                </a:lnTo>
                <a:lnTo>
                  <a:pt x="115697" y="2794"/>
                </a:lnTo>
                <a:lnTo>
                  <a:pt x="115697" y="5715"/>
                </a:lnTo>
                <a:lnTo>
                  <a:pt x="173481" y="5715"/>
                </a:lnTo>
                <a:lnTo>
                  <a:pt x="173481" y="8636"/>
                </a:lnTo>
                <a:lnTo>
                  <a:pt x="231266" y="8636"/>
                </a:lnTo>
                <a:lnTo>
                  <a:pt x="231266" y="13081"/>
                </a:lnTo>
                <a:lnTo>
                  <a:pt x="289178" y="13081"/>
                </a:lnTo>
                <a:lnTo>
                  <a:pt x="289178" y="14477"/>
                </a:lnTo>
                <a:lnTo>
                  <a:pt x="346963" y="14477"/>
                </a:lnTo>
                <a:lnTo>
                  <a:pt x="346963" y="17399"/>
                </a:lnTo>
                <a:lnTo>
                  <a:pt x="404749" y="17399"/>
                </a:lnTo>
                <a:lnTo>
                  <a:pt x="404749" y="23368"/>
                </a:lnTo>
                <a:lnTo>
                  <a:pt x="462534" y="23368"/>
                </a:lnTo>
                <a:lnTo>
                  <a:pt x="462534" y="27686"/>
                </a:lnTo>
                <a:lnTo>
                  <a:pt x="520446" y="27686"/>
                </a:lnTo>
                <a:lnTo>
                  <a:pt x="520446" y="32131"/>
                </a:lnTo>
                <a:lnTo>
                  <a:pt x="578230" y="32131"/>
                </a:lnTo>
                <a:lnTo>
                  <a:pt x="636016" y="32131"/>
                </a:lnTo>
                <a:lnTo>
                  <a:pt x="636016" y="33654"/>
                </a:lnTo>
                <a:lnTo>
                  <a:pt x="693928" y="33654"/>
                </a:lnTo>
                <a:lnTo>
                  <a:pt x="751713" y="33654"/>
                </a:lnTo>
                <a:lnTo>
                  <a:pt x="751713" y="36575"/>
                </a:lnTo>
                <a:lnTo>
                  <a:pt x="809497" y="36575"/>
                </a:lnTo>
                <a:lnTo>
                  <a:pt x="867283" y="36575"/>
                </a:lnTo>
                <a:lnTo>
                  <a:pt x="867283" y="38100"/>
                </a:lnTo>
                <a:lnTo>
                  <a:pt x="925195" y="38100"/>
                </a:lnTo>
                <a:lnTo>
                  <a:pt x="925195" y="41148"/>
                </a:lnTo>
                <a:lnTo>
                  <a:pt x="982979" y="41148"/>
                </a:lnTo>
                <a:lnTo>
                  <a:pt x="982979" y="44196"/>
                </a:lnTo>
                <a:lnTo>
                  <a:pt x="1040765" y="44196"/>
                </a:lnTo>
                <a:lnTo>
                  <a:pt x="1098677" y="44196"/>
                </a:lnTo>
                <a:lnTo>
                  <a:pt x="1098677" y="47371"/>
                </a:lnTo>
                <a:lnTo>
                  <a:pt x="1156461" y="47371"/>
                </a:lnTo>
                <a:lnTo>
                  <a:pt x="1214247" y="47371"/>
                </a:lnTo>
                <a:lnTo>
                  <a:pt x="1214247" y="48895"/>
                </a:lnTo>
                <a:lnTo>
                  <a:pt x="1272032" y="48895"/>
                </a:lnTo>
                <a:lnTo>
                  <a:pt x="1329944" y="48895"/>
                </a:lnTo>
                <a:lnTo>
                  <a:pt x="1329944" y="52070"/>
                </a:lnTo>
                <a:lnTo>
                  <a:pt x="1387729" y="52070"/>
                </a:lnTo>
                <a:lnTo>
                  <a:pt x="1387729" y="55372"/>
                </a:lnTo>
                <a:lnTo>
                  <a:pt x="1445514" y="55372"/>
                </a:lnTo>
                <a:lnTo>
                  <a:pt x="1445514" y="58547"/>
                </a:lnTo>
                <a:lnTo>
                  <a:pt x="1503426" y="58547"/>
                </a:lnTo>
                <a:lnTo>
                  <a:pt x="1503426" y="61849"/>
                </a:lnTo>
                <a:lnTo>
                  <a:pt x="1561211" y="61849"/>
                </a:lnTo>
                <a:lnTo>
                  <a:pt x="1561211" y="65150"/>
                </a:lnTo>
                <a:lnTo>
                  <a:pt x="1618996" y="65150"/>
                </a:lnTo>
                <a:lnTo>
                  <a:pt x="1618996" y="66928"/>
                </a:lnTo>
                <a:lnTo>
                  <a:pt x="1676780" y="66928"/>
                </a:lnTo>
                <a:lnTo>
                  <a:pt x="1676780" y="75311"/>
                </a:lnTo>
                <a:lnTo>
                  <a:pt x="1734692" y="75311"/>
                </a:lnTo>
                <a:lnTo>
                  <a:pt x="1792477" y="75311"/>
                </a:lnTo>
                <a:lnTo>
                  <a:pt x="1792477" y="76962"/>
                </a:lnTo>
                <a:lnTo>
                  <a:pt x="1850263" y="76962"/>
                </a:lnTo>
                <a:lnTo>
                  <a:pt x="1850263" y="82042"/>
                </a:lnTo>
                <a:lnTo>
                  <a:pt x="1908175" y="82042"/>
                </a:lnTo>
                <a:lnTo>
                  <a:pt x="1908175" y="85471"/>
                </a:lnTo>
                <a:lnTo>
                  <a:pt x="1965960" y="85471"/>
                </a:lnTo>
                <a:lnTo>
                  <a:pt x="1965960" y="87249"/>
                </a:lnTo>
                <a:lnTo>
                  <a:pt x="2023745" y="87249"/>
                </a:lnTo>
                <a:lnTo>
                  <a:pt x="2023745" y="96012"/>
                </a:lnTo>
                <a:lnTo>
                  <a:pt x="2081530" y="96012"/>
                </a:lnTo>
                <a:lnTo>
                  <a:pt x="2081530" y="104775"/>
                </a:lnTo>
                <a:lnTo>
                  <a:pt x="2139442" y="104775"/>
                </a:lnTo>
                <a:lnTo>
                  <a:pt x="2139442" y="111760"/>
                </a:lnTo>
                <a:lnTo>
                  <a:pt x="2197227" y="111760"/>
                </a:lnTo>
                <a:lnTo>
                  <a:pt x="2197227" y="118872"/>
                </a:lnTo>
                <a:lnTo>
                  <a:pt x="2255012" y="118872"/>
                </a:lnTo>
                <a:lnTo>
                  <a:pt x="2255012" y="120650"/>
                </a:lnTo>
                <a:lnTo>
                  <a:pt x="2312924" y="120650"/>
                </a:lnTo>
                <a:lnTo>
                  <a:pt x="2312924" y="124333"/>
                </a:lnTo>
                <a:lnTo>
                  <a:pt x="2370709" y="124333"/>
                </a:lnTo>
                <a:lnTo>
                  <a:pt x="2370709" y="127889"/>
                </a:lnTo>
                <a:lnTo>
                  <a:pt x="2428494" y="127889"/>
                </a:lnTo>
                <a:lnTo>
                  <a:pt x="2428494" y="131572"/>
                </a:lnTo>
                <a:lnTo>
                  <a:pt x="2486406" y="131572"/>
                </a:lnTo>
                <a:lnTo>
                  <a:pt x="2486406" y="140843"/>
                </a:lnTo>
                <a:lnTo>
                  <a:pt x="2544191" y="140843"/>
                </a:lnTo>
                <a:lnTo>
                  <a:pt x="2601976" y="140843"/>
                </a:lnTo>
                <a:lnTo>
                  <a:pt x="2601976" y="148336"/>
                </a:lnTo>
                <a:lnTo>
                  <a:pt x="2659761" y="148336"/>
                </a:lnTo>
                <a:lnTo>
                  <a:pt x="2659761" y="155956"/>
                </a:lnTo>
                <a:lnTo>
                  <a:pt x="2717673" y="155956"/>
                </a:lnTo>
                <a:lnTo>
                  <a:pt x="2775458" y="155956"/>
                </a:lnTo>
                <a:lnTo>
                  <a:pt x="2775458" y="159766"/>
                </a:lnTo>
                <a:lnTo>
                  <a:pt x="2833243" y="159766"/>
                </a:lnTo>
                <a:lnTo>
                  <a:pt x="2833243" y="163702"/>
                </a:lnTo>
                <a:lnTo>
                  <a:pt x="2891155" y="163702"/>
                </a:lnTo>
                <a:lnTo>
                  <a:pt x="2891155" y="165608"/>
                </a:lnTo>
                <a:lnTo>
                  <a:pt x="2948940" y="165608"/>
                </a:lnTo>
                <a:lnTo>
                  <a:pt x="2948940" y="171450"/>
                </a:lnTo>
                <a:lnTo>
                  <a:pt x="3006725" y="171450"/>
                </a:lnTo>
                <a:lnTo>
                  <a:pt x="3064510" y="171450"/>
                </a:lnTo>
                <a:lnTo>
                  <a:pt x="3064510" y="175514"/>
                </a:lnTo>
                <a:lnTo>
                  <a:pt x="3122422" y="175514"/>
                </a:lnTo>
                <a:lnTo>
                  <a:pt x="3122422" y="183642"/>
                </a:lnTo>
                <a:lnTo>
                  <a:pt x="3180207" y="183642"/>
                </a:lnTo>
                <a:lnTo>
                  <a:pt x="3180207" y="187706"/>
                </a:lnTo>
                <a:lnTo>
                  <a:pt x="3237992" y="187706"/>
                </a:lnTo>
                <a:lnTo>
                  <a:pt x="3237992" y="191770"/>
                </a:lnTo>
                <a:lnTo>
                  <a:pt x="3295904" y="191770"/>
                </a:lnTo>
                <a:lnTo>
                  <a:pt x="3295904" y="193801"/>
                </a:lnTo>
                <a:lnTo>
                  <a:pt x="3353689" y="193801"/>
                </a:lnTo>
                <a:lnTo>
                  <a:pt x="3353689" y="200025"/>
                </a:lnTo>
                <a:lnTo>
                  <a:pt x="3411474" y="200025"/>
                </a:lnTo>
                <a:lnTo>
                  <a:pt x="3469259" y="200025"/>
                </a:lnTo>
                <a:lnTo>
                  <a:pt x="3469259" y="202184"/>
                </a:lnTo>
                <a:lnTo>
                  <a:pt x="3527171" y="202184"/>
                </a:lnTo>
                <a:lnTo>
                  <a:pt x="3527171" y="208534"/>
                </a:lnTo>
                <a:lnTo>
                  <a:pt x="3584956" y="208534"/>
                </a:lnTo>
                <a:lnTo>
                  <a:pt x="3584956" y="210693"/>
                </a:lnTo>
                <a:lnTo>
                  <a:pt x="3642741" y="210693"/>
                </a:lnTo>
                <a:lnTo>
                  <a:pt x="3642741" y="215138"/>
                </a:lnTo>
                <a:lnTo>
                  <a:pt x="3700653" y="215138"/>
                </a:lnTo>
                <a:lnTo>
                  <a:pt x="3700653" y="219456"/>
                </a:lnTo>
                <a:lnTo>
                  <a:pt x="3758438" y="219456"/>
                </a:lnTo>
                <a:lnTo>
                  <a:pt x="3758438" y="223900"/>
                </a:lnTo>
                <a:lnTo>
                  <a:pt x="3816223" y="223900"/>
                </a:lnTo>
                <a:lnTo>
                  <a:pt x="3816223" y="230504"/>
                </a:lnTo>
                <a:lnTo>
                  <a:pt x="3874008" y="230504"/>
                </a:lnTo>
                <a:lnTo>
                  <a:pt x="3874008" y="235076"/>
                </a:lnTo>
                <a:lnTo>
                  <a:pt x="3931920" y="235076"/>
                </a:lnTo>
                <a:lnTo>
                  <a:pt x="3931920" y="237363"/>
                </a:lnTo>
                <a:lnTo>
                  <a:pt x="3989705" y="237363"/>
                </a:lnTo>
                <a:lnTo>
                  <a:pt x="3989705" y="239649"/>
                </a:lnTo>
                <a:lnTo>
                  <a:pt x="4047490" y="239649"/>
                </a:lnTo>
                <a:lnTo>
                  <a:pt x="4047490" y="246634"/>
                </a:lnTo>
                <a:lnTo>
                  <a:pt x="4105402" y="246634"/>
                </a:lnTo>
                <a:lnTo>
                  <a:pt x="4105402" y="256032"/>
                </a:lnTo>
                <a:lnTo>
                  <a:pt x="4163187" y="256032"/>
                </a:lnTo>
                <a:lnTo>
                  <a:pt x="4163187" y="258318"/>
                </a:lnTo>
                <a:lnTo>
                  <a:pt x="4220972" y="258318"/>
                </a:lnTo>
                <a:lnTo>
                  <a:pt x="4220972" y="260731"/>
                </a:lnTo>
                <a:lnTo>
                  <a:pt x="4278757" y="260731"/>
                </a:lnTo>
                <a:lnTo>
                  <a:pt x="4336669" y="260731"/>
                </a:lnTo>
                <a:lnTo>
                  <a:pt x="4336669" y="263144"/>
                </a:lnTo>
                <a:lnTo>
                  <a:pt x="4394454" y="263144"/>
                </a:lnTo>
                <a:lnTo>
                  <a:pt x="4394454" y="270637"/>
                </a:lnTo>
                <a:lnTo>
                  <a:pt x="4452239" y="270637"/>
                </a:lnTo>
                <a:lnTo>
                  <a:pt x="4452239" y="273176"/>
                </a:lnTo>
                <a:lnTo>
                  <a:pt x="4510151" y="273176"/>
                </a:lnTo>
                <a:lnTo>
                  <a:pt x="4510151" y="283210"/>
                </a:lnTo>
                <a:lnTo>
                  <a:pt x="4567936" y="283210"/>
                </a:lnTo>
                <a:lnTo>
                  <a:pt x="4567936" y="285750"/>
                </a:lnTo>
                <a:lnTo>
                  <a:pt x="4625721" y="285750"/>
                </a:lnTo>
                <a:lnTo>
                  <a:pt x="4625721" y="288417"/>
                </a:lnTo>
                <a:lnTo>
                  <a:pt x="4683506" y="288417"/>
                </a:lnTo>
                <a:lnTo>
                  <a:pt x="4683506" y="290957"/>
                </a:lnTo>
                <a:lnTo>
                  <a:pt x="4741418" y="290957"/>
                </a:lnTo>
                <a:lnTo>
                  <a:pt x="4799203" y="290957"/>
                </a:lnTo>
                <a:lnTo>
                  <a:pt x="4799203" y="296418"/>
                </a:lnTo>
                <a:lnTo>
                  <a:pt x="4856988" y="296418"/>
                </a:lnTo>
                <a:lnTo>
                  <a:pt x="4856988" y="307086"/>
                </a:lnTo>
                <a:lnTo>
                  <a:pt x="4914900" y="307086"/>
                </a:lnTo>
                <a:lnTo>
                  <a:pt x="4914900" y="309879"/>
                </a:lnTo>
                <a:lnTo>
                  <a:pt x="4972685" y="309879"/>
                </a:lnTo>
                <a:lnTo>
                  <a:pt x="4972685" y="312547"/>
                </a:lnTo>
                <a:lnTo>
                  <a:pt x="5030470" y="312547"/>
                </a:lnTo>
                <a:lnTo>
                  <a:pt x="5030470" y="315214"/>
                </a:lnTo>
                <a:lnTo>
                  <a:pt x="5088255" y="315214"/>
                </a:lnTo>
                <a:lnTo>
                  <a:pt x="5146167" y="315214"/>
                </a:lnTo>
                <a:lnTo>
                  <a:pt x="5146167" y="320801"/>
                </a:lnTo>
                <a:lnTo>
                  <a:pt x="5203952" y="320801"/>
                </a:lnTo>
                <a:lnTo>
                  <a:pt x="5203952" y="329311"/>
                </a:lnTo>
                <a:lnTo>
                  <a:pt x="5261737" y="329311"/>
                </a:lnTo>
                <a:lnTo>
                  <a:pt x="5261737" y="332104"/>
                </a:lnTo>
                <a:lnTo>
                  <a:pt x="5319649" y="332104"/>
                </a:lnTo>
                <a:lnTo>
                  <a:pt x="5377433" y="332104"/>
                </a:lnTo>
                <a:lnTo>
                  <a:pt x="5377433" y="335025"/>
                </a:lnTo>
                <a:lnTo>
                  <a:pt x="5435219" y="335025"/>
                </a:lnTo>
                <a:lnTo>
                  <a:pt x="5493004" y="335025"/>
                </a:lnTo>
                <a:lnTo>
                  <a:pt x="5493004" y="341122"/>
                </a:lnTo>
                <a:lnTo>
                  <a:pt x="5550916" y="341122"/>
                </a:lnTo>
                <a:lnTo>
                  <a:pt x="5608701" y="341122"/>
                </a:lnTo>
                <a:lnTo>
                  <a:pt x="5608701" y="356362"/>
                </a:lnTo>
                <a:lnTo>
                  <a:pt x="5666486" y="356362"/>
                </a:lnTo>
                <a:lnTo>
                  <a:pt x="5666486" y="368681"/>
                </a:lnTo>
                <a:lnTo>
                  <a:pt x="5724398" y="368681"/>
                </a:lnTo>
                <a:lnTo>
                  <a:pt x="5782183" y="368681"/>
                </a:lnTo>
                <a:lnTo>
                  <a:pt x="5839968" y="368681"/>
                </a:lnTo>
                <a:lnTo>
                  <a:pt x="5839968" y="371856"/>
                </a:lnTo>
                <a:lnTo>
                  <a:pt x="5897753" y="371856"/>
                </a:lnTo>
                <a:lnTo>
                  <a:pt x="5897753" y="378333"/>
                </a:lnTo>
                <a:lnTo>
                  <a:pt x="5955665" y="378333"/>
                </a:lnTo>
                <a:lnTo>
                  <a:pt x="5955665" y="381508"/>
                </a:lnTo>
                <a:lnTo>
                  <a:pt x="6013450" y="381508"/>
                </a:lnTo>
                <a:lnTo>
                  <a:pt x="6013450" y="381508"/>
                </a:lnTo>
                <a:lnTo>
                  <a:pt x="6071235" y="381508"/>
                </a:lnTo>
                <a:lnTo>
                  <a:pt x="6129147" y="381508"/>
                </a:lnTo>
                <a:lnTo>
                  <a:pt x="6186932" y="381508"/>
                </a:lnTo>
                <a:lnTo>
                  <a:pt x="6186932" y="394970"/>
                </a:lnTo>
                <a:lnTo>
                  <a:pt x="6244717" y="394970"/>
                </a:lnTo>
                <a:lnTo>
                  <a:pt x="6302502" y="394970"/>
                </a:lnTo>
                <a:lnTo>
                  <a:pt x="6302502" y="398399"/>
                </a:lnTo>
                <a:lnTo>
                  <a:pt x="6360414" y="398399"/>
                </a:lnTo>
                <a:lnTo>
                  <a:pt x="6360414" y="412242"/>
                </a:lnTo>
                <a:lnTo>
                  <a:pt x="6418199" y="412242"/>
                </a:lnTo>
                <a:lnTo>
                  <a:pt x="6418199" y="415798"/>
                </a:lnTo>
                <a:lnTo>
                  <a:pt x="6475983" y="415798"/>
                </a:lnTo>
                <a:lnTo>
                  <a:pt x="6533896" y="415798"/>
                </a:lnTo>
                <a:lnTo>
                  <a:pt x="6533896" y="423037"/>
                </a:lnTo>
                <a:lnTo>
                  <a:pt x="6591681" y="423037"/>
                </a:lnTo>
                <a:lnTo>
                  <a:pt x="6591681" y="426593"/>
                </a:lnTo>
                <a:lnTo>
                  <a:pt x="6649466" y="426593"/>
                </a:lnTo>
                <a:lnTo>
                  <a:pt x="6649466" y="441325"/>
                </a:lnTo>
                <a:lnTo>
                  <a:pt x="6707251" y="441325"/>
                </a:lnTo>
                <a:lnTo>
                  <a:pt x="6707251" y="445135"/>
                </a:lnTo>
                <a:lnTo>
                  <a:pt x="6765163" y="445135"/>
                </a:lnTo>
                <a:lnTo>
                  <a:pt x="6765163" y="448818"/>
                </a:lnTo>
                <a:lnTo>
                  <a:pt x="6822948" y="448818"/>
                </a:lnTo>
                <a:lnTo>
                  <a:pt x="6880733" y="448818"/>
                </a:lnTo>
                <a:lnTo>
                  <a:pt x="6880733" y="452754"/>
                </a:lnTo>
                <a:lnTo>
                  <a:pt x="6938645" y="452754"/>
                </a:lnTo>
                <a:lnTo>
                  <a:pt x="6938645" y="460628"/>
                </a:lnTo>
                <a:lnTo>
                  <a:pt x="6996430" y="460628"/>
                </a:lnTo>
                <a:lnTo>
                  <a:pt x="6996430" y="472440"/>
                </a:lnTo>
                <a:lnTo>
                  <a:pt x="7054215" y="472440"/>
                </a:lnTo>
                <a:lnTo>
                  <a:pt x="7054215" y="484504"/>
                </a:lnTo>
                <a:lnTo>
                  <a:pt x="7112000" y="484504"/>
                </a:lnTo>
                <a:lnTo>
                  <a:pt x="7169912" y="484504"/>
                </a:lnTo>
                <a:lnTo>
                  <a:pt x="7169912" y="488696"/>
                </a:lnTo>
                <a:lnTo>
                  <a:pt x="7227697" y="488696"/>
                </a:lnTo>
                <a:lnTo>
                  <a:pt x="7285482" y="488696"/>
                </a:lnTo>
                <a:lnTo>
                  <a:pt x="7343394" y="488696"/>
                </a:lnTo>
                <a:lnTo>
                  <a:pt x="7343394" y="493014"/>
                </a:lnTo>
                <a:lnTo>
                  <a:pt x="7401179" y="493014"/>
                </a:lnTo>
                <a:lnTo>
                  <a:pt x="7401179" y="497332"/>
                </a:lnTo>
                <a:lnTo>
                  <a:pt x="7458964" y="497332"/>
                </a:lnTo>
                <a:lnTo>
                  <a:pt x="7516749" y="497332"/>
                </a:lnTo>
                <a:lnTo>
                  <a:pt x="7516749" y="501903"/>
                </a:lnTo>
                <a:lnTo>
                  <a:pt x="7574661" y="501903"/>
                </a:lnTo>
                <a:lnTo>
                  <a:pt x="7632446" y="501903"/>
                </a:lnTo>
                <a:lnTo>
                  <a:pt x="7632446" y="511301"/>
                </a:lnTo>
                <a:lnTo>
                  <a:pt x="7690231" y="511301"/>
                </a:lnTo>
                <a:lnTo>
                  <a:pt x="7748143" y="511301"/>
                </a:lnTo>
                <a:lnTo>
                  <a:pt x="7805928" y="511301"/>
                </a:lnTo>
                <a:lnTo>
                  <a:pt x="7863713" y="511301"/>
                </a:lnTo>
                <a:lnTo>
                  <a:pt x="7921625" y="511301"/>
                </a:lnTo>
                <a:lnTo>
                  <a:pt x="7979410" y="511301"/>
                </a:lnTo>
                <a:lnTo>
                  <a:pt x="7979410" y="516509"/>
                </a:lnTo>
                <a:lnTo>
                  <a:pt x="8037195" y="516509"/>
                </a:lnTo>
                <a:lnTo>
                  <a:pt x="8094980" y="516509"/>
                </a:lnTo>
                <a:lnTo>
                  <a:pt x="8094980" y="527050"/>
                </a:lnTo>
                <a:lnTo>
                  <a:pt x="8152892" y="527050"/>
                </a:lnTo>
                <a:lnTo>
                  <a:pt x="8152892" y="543178"/>
                </a:lnTo>
                <a:lnTo>
                  <a:pt x="8210677" y="543178"/>
                </a:lnTo>
                <a:lnTo>
                  <a:pt x="8210677" y="548513"/>
                </a:lnTo>
                <a:lnTo>
                  <a:pt x="8268462" y="548513"/>
                </a:lnTo>
                <a:lnTo>
                  <a:pt x="8326374" y="548513"/>
                </a:lnTo>
                <a:lnTo>
                  <a:pt x="8326374" y="554101"/>
                </a:lnTo>
                <a:lnTo>
                  <a:pt x="8384158" y="554101"/>
                </a:lnTo>
                <a:lnTo>
                  <a:pt x="8441944" y="554101"/>
                </a:lnTo>
                <a:lnTo>
                  <a:pt x="8441944" y="559816"/>
                </a:lnTo>
                <a:lnTo>
                  <a:pt x="8499729" y="559816"/>
                </a:lnTo>
                <a:lnTo>
                  <a:pt x="8557641" y="559816"/>
                </a:lnTo>
                <a:lnTo>
                  <a:pt x="8615426" y="559816"/>
                </a:lnTo>
                <a:lnTo>
                  <a:pt x="8615426" y="565785"/>
                </a:lnTo>
                <a:lnTo>
                  <a:pt x="8673211" y="565785"/>
                </a:lnTo>
                <a:lnTo>
                  <a:pt x="8673211" y="571881"/>
                </a:lnTo>
                <a:lnTo>
                  <a:pt x="8731123" y="571881"/>
                </a:lnTo>
                <a:lnTo>
                  <a:pt x="8731123" y="590296"/>
                </a:lnTo>
                <a:lnTo>
                  <a:pt x="8788908" y="590296"/>
                </a:lnTo>
                <a:lnTo>
                  <a:pt x="8846693" y="590296"/>
                </a:lnTo>
                <a:lnTo>
                  <a:pt x="8846693" y="596646"/>
                </a:lnTo>
                <a:lnTo>
                  <a:pt x="8904478" y="596646"/>
                </a:lnTo>
                <a:lnTo>
                  <a:pt x="8962390" y="596646"/>
                </a:lnTo>
                <a:lnTo>
                  <a:pt x="8962390" y="603123"/>
                </a:lnTo>
                <a:lnTo>
                  <a:pt x="9020175" y="603123"/>
                </a:lnTo>
                <a:lnTo>
                  <a:pt x="9020175" y="609726"/>
                </a:lnTo>
                <a:lnTo>
                  <a:pt x="9077960" y="609726"/>
                </a:lnTo>
                <a:lnTo>
                  <a:pt x="9077960" y="623189"/>
                </a:lnTo>
                <a:lnTo>
                  <a:pt x="9135872" y="623189"/>
                </a:lnTo>
                <a:lnTo>
                  <a:pt x="9193657" y="623189"/>
                </a:lnTo>
                <a:lnTo>
                  <a:pt x="9193657" y="630174"/>
                </a:lnTo>
                <a:lnTo>
                  <a:pt x="9251442" y="630174"/>
                </a:lnTo>
                <a:lnTo>
                  <a:pt x="9251442" y="637286"/>
                </a:lnTo>
                <a:lnTo>
                  <a:pt x="9309227" y="637286"/>
                </a:lnTo>
                <a:lnTo>
                  <a:pt x="9367139" y="637286"/>
                </a:lnTo>
                <a:lnTo>
                  <a:pt x="9367139" y="651891"/>
                </a:lnTo>
                <a:lnTo>
                  <a:pt x="9424924" y="651891"/>
                </a:lnTo>
                <a:lnTo>
                  <a:pt x="9482709" y="651891"/>
                </a:lnTo>
                <a:lnTo>
                  <a:pt x="9482709" y="659638"/>
                </a:lnTo>
                <a:lnTo>
                  <a:pt x="9540621" y="659638"/>
                </a:lnTo>
                <a:lnTo>
                  <a:pt x="9540621" y="667385"/>
                </a:lnTo>
                <a:lnTo>
                  <a:pt x="9598406" y="667385"/>
                </a:lnTo>
                <a:lnTo>
                  <a:pt x="9656191" y="667385"/>
                </a:lnTo>
                <a:lnTo>
                  <a:pt x="9656191" y="691261"/>
                </a:lnTo>
                <a:lnTo>
                  <a:pt x="9713976" y="691261"/>
                </a:lnTo>
                <a:lnTo>
                  <a:pt x="9771888" y="691261"/>
                </a:lnTo>
                <a:lnTo>
                  <a:pt x="9771888" y="699770"/>
                </a:lnTo>
                <a:lnTo>
                  <a:pt x="9829673" y="699770"/>
                </a:lnTo>
                <a:lnTo>
                  <a:pt x="9829673" y="708533"/>
                </a:lnTo>
                <a:lnTo>
                  <a:pt x="9887458" y="708533"/>
                </a:lnTo>
                <a:lnTo>
                  <a:pt x="9945370" y="708533"/>
                </a:lnTo>
                <a:lnTo>
                  <a:pt x="9945370" y="717803"/>
                </a:lnTo>
                <a:lnTo>
                  <a:pt x="10003155" y="717803"/>
                </a:lnTo>
                <a:lnTo>
                  <a:pt x="10060940" y="717803"/>
                </a:lnTo>
                <a:lnTo>
                  <a:pt x="10118725" y="717803"/>
                </a:lnTo>
                <a:lnTo>
                  <a:pt x="10176637" y="717803"/>
                </a:lnTo>
                <a:lnTo>
                  <a:pt x="10176637" y="727583"/>
                </a:lnTo>
                <a:lnTo>
                  <a:pt x="10234422" y="727583"/>
                </a:lnTo>
                <a:lnTo>
                  <a:pt x="10292207" y="727583"/>
                </a:lnTo>
                <a:lnTo>
                  <a:pt x="10350119" y="727583"/>
                </a:lnTo>
                <a:lnTo>
                  <a:pt x="10407904" y="727583"/>
                </a:lnTo>
                <a:lnTo>
                  <a:pt x="10465689" y="727583"/>
                </a:lnTo>
                <a:lnTo>
                  <a:pt x="10465689" y="738124"/>
                </a:lnTo>
                <a:lnTo>
                  <a:pt x="10523474" y="738124"/>
                </a:lnTo>
                <a:lnTo>
                  <a:pt x="10581386" y="738124"/>
                </a:lnTo>
                <a:lnTo>
                  <a:pt x="10639171" y="738124"/>
                </a:lnTo>
                <a:lnTo>
                  <a:pt x="10639171" y="760729"/>
                </a:lnTo>
                <a:lnTo>
                  <a:pt x="10696956" y="760729"/>
                </a:lnTo>
                <a:lnTo>
                  <a:pt x="10754868" y="760729"/>
                </a:lnTo>
                <a:lnTo>
                  <a:pt x="10812653" y="760729"/>
                </a:lnTo>
                <a:lnTo>
                  <a:pt x="10870438" y="760729"/>
                </a:lnTo>
                <a:lnTo>
                  <a:pt x="10928223" y="760729"/>
                </a:lnTo>
                <a:lnTo>
                  <a:pt x="10986135" y="760729"/>
                </a:lnTo>
                <a:lnTo>
                  <a:pt x="11043920" y="760729"/>
                </a:lnTo>
                <a:lnTo>
                  <a:pt x="11043920" y="774065"/>
                </a:lnTo>
                <a:lnTo>
                  <a:pt x="11101705" y="774065"/>
                </a:lnTo>
                <a:lnTo>
                  <a:pt x="11159617" y="774065"/>
                </a:lnTo>
                <a:lnTo>
                  <a:pt x="11217402" y="774065"/>
                </a:lnTo>
                <a:lnTo>
                  <a:pt x="11275187" y="774065"/>
                </a:lnTo>
                <a:lnTo>
                  <a:pt x="11332972" y="774065"/>
                </a:lnTo>
                <a:lnTo>
                  <a:pt x="11390884" y="774065"/>
                </a:lnTo>
                <a:lnTo>
                  <a:pt x="11390884" y="805052"/>
                </a:lnTo>
                <a:lnTo>
                  <a:pt x="11448669" y="805052"/>
                </a:lnTo>
                <a:lnTo>
                  <a:pt x="11506454" y="805052"/>
                </a:lnTo>
                <a:lnTo>
                  <a:pt x="11506454" y="821817"/>
                </a:lnTo>
                <a:lnTo>
                  <a:pt x="11564366" y="821817"/>
                </a:lnTo>
                <a:lnTo>
                  <a:pt x="11622151" y="821817"/>
                </a:lnTo>
                <a:lnTo>
                  <a:pt x="11679936" y="821817"/>
                </a:lnTo>
                <a:lnTo>
                  <a:pt x="11679936" y="840232"/>
                </a:lnTo>
                <a:lnTo>
                  <a:pt x="11737721" y="840232"/>
                </a:lnTo>
                <a:lnTo>
                  <a:pt x="11737721" y="859027"/>
                </a:lnTo>
                <a:lnTo>
                  <a:pt x="11795633" y="859027"/>
                </a:lnTo>
                <a:lnTo>
                  <a:pt x="11853418" y="859027"/>
                </a:lnTo>
                <a:lnTo>
                  <a:pt x="11911203" y="859027"/>
                </a:lnTo>
                <a:lnTo>
                  <a:pt x="11911203" y="901319"/>
                </a:lnTo>
                <a:lnTo>
                  <a:pt x="11969115" y="901319"/>
                </a:lnTo>
                <a:lnTo>
                  <a:pt x="12026900" y="901319"/>
                </a:lnTo>
                <a:lnTo>
                  <a:pt x="12142470" y="901319"/>
                </a:lnTo>
                <a:lnTo>
                  <a:pt x="12200382" y="901319"/>
                </a:lnTo>
                <a:lnTo>
                  <a:pt x="12200382" y="924814"/>
                </a:lnTo>
                <a:lnTo>
                  <a:pt x="12258166" y="924814"/>
                </a:lnTo>
                <a:lnTo>
                  <a:pt x="12315952" y="924814"/>
                </a:lnTo>
                <a:lnTo>
                  <a:pt x="12373864" y="924814"/>
                </a:lnTo>
                <a:lnTo>
                  <a:pt x="12431649" y="924814"/>
                </a:lnTo>
                <a:lnTo>
                  <a:pt x="12547218" y="924814"/>
                </a:lnTo>
                <a:lnTo>
                  <a:pt x="12605131" y="924814"/>
                </a:lnTo>
                <a:lnTo>
                  <a:pt x="12605131" y="990853"/>
                </a:lnTo>
                <a:lnTo>
                  <a:pt x="12662916" y="990853"/>
                </a:lnTo>
                <a:lnTo>
                  <a:pt x="12720701" y="990853"/>
                </a:lnTo>
                <a:lnTo>
                  <a:pt x="12778613" y="990853"/>
                </a:lnTo>
                <a:lnTo>
                  <a:pt x="12836398" y="990853"/>
                </a:lnTo>
                <a:lnTo>
                  <a:pt x="12894183" y="990853"/>
                </a:lnTo>
                <a:lnTo>
                  <a:pt x="12951968" y="990853"/>
                </a:lnTo>
                <a:lnTo>
                  <a:pt x="13009879" y="990853"/>
                </a:lnTo>
                <a:lnTo>
                  <a:pt x="13067664" y="990853"/>
                </a:lnTo>
                <a:lnTo>
                  <a:pt x="13125450" y="990853"/>
                </a:lnTo>
                <a:lnTo>
                  <a:pt x="13125450" y="1054100"/>
                </a:lnTo>
                <a:lnTo>
                  <a:pt x="13241146" y="1054100"/>
                </a:lnTo>
                <a:lnTo>
                  <a:pt x="13298931" y="1054100"/>
                </a:lnTo>
                <a:lnTo>
                  <a:pt x="13356843" y="1054100"/>
                </a:lnTo>
                <a:lnTo>
                  <a:pt x="13414629" y="1054100"/>
                </a:lnTo>
                <a:lnTo>
                  <a:pt x="13414629" y="1201801"/>
                </a:lnTo>
                <a:lnTo>
                  <a:pt x="13472414" y="1201801"/>
                </a:lnTo>
                <a:lnTo>
                  <a:pt x="13530198" y="1201801"/>
                </a:lnTo>
                <a:lnTo>
                  <a:pt x="13588110" y="1201801"/>
                </a:lnTo>
                <a:lnTo>
                  <a:pt x="13645895" y="1201801"/>
                </a:lnTo>
                <a:lnTo>
                  <a:pt x="13703681" y="1201801"/>
                </a:lnTo>
                <a:lnTo>
                  <a:pt x="13761592" y="1201801"/>
                </a:lnTo>
                <a:lnTo>
                  <a:pt x="13819377" y="1201801"/>
                </a:lnTo>
                <a:lnTo>
                  <a:pt x="13934948" y="1201801"/>
                </a:lnTo>
                <a:lnTo>
                  <a:pt x="13992860" y="1201801"/>
                </a:lnTo>
                <a:lnTo>
                  <a:pt x="14108429" y="1201801"/>
                </a:lnTo>
                <a:lnTo>
                  <a:pt x="14108429" y="1389761"/>
                </a:lnTo>
                <a:lnTo>
                  <a:pt x="14166341" y="1389761"/>
                </a:lnTo>
                <a:lnTo>
                  <a:pt x="14224127" y="1389761"/>
                </a:lnTo>
                <a:lnTo>
                  <a:pt x="14397608" y="1389761"/>
                </a:lnTo>
              </a:path>
            </a:pathLst>
          </a:custGeom>
          <a:ln w="27051">
            <a:solidFill>
              <a:srgbClr val="DFD625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4" name="bg object 24"/>
          <p:cNvSpPr/>
          <p:nvPr/>
        </p:nvSpPr>
        <p:spPr>
          <a:xfrm>
            <a:off x="1211452" y="722757"/>
            <a:ext cx="14166850" cy="1191895"/>
          </a:xfrm>
          <a:custGeom>
            <a:avLst/>
            <a:gdLst/>
            <a:ahLst/>
            <a:cxnLst/>
            <a:rect l="l" t="t" r="r" b="b"/>
            <a:pathLst>
              <a:path w="14166850" h="1191895">
                <a:moveTo>
                  <a:pt x="0" y="0"/>
                </a:moveTo>
                <a:lnTo>
                  <a:pt x="0" y="5969"/>
                </a:lnTo>
                <a:lnTo>
                  <a:pt x="57784" y="5969"/>
                </a:lnTo>
                <a:lnTo>
                  <a:pt x="115697" y="5969"/>
                </a:lnTo>
                <a:lnTo>
                  <a:pt x="173481" y="5969"/>
                </a:lnTo>
                <a:lnTo>
                  <a:pt x="173481" y="12192"/>
                </a:lnTo>
                <a:lnTo>
                  <a:pt x="231266" y="12192"/>
                </a:lnTo>
                <a:lnTo>
                  <a:pt x="289178" y="12192"/>
                </a:lnTo>
                <a:lnTo>
                  <a:pt x="346963" y="12192"/>
                </a:lnTo>
                <a:lnTo>
                  <a:pt x="404749" y="12192"/>
                </a:lnTo>
                <a:lnTo>
                  <a:pt x="404749" y="18288"/>
                </a:lnTo>
                <a:lnTo>
                  <a:pt x="462534" y="18288"/>
                </a:lnTo>
                <a:lnTo>
                  <a:pt x="462534" y="21336"/>
                </a:lnTo>
                <a:lnTo>
                  <a:pt x="520446" y="21336"/>
                </a:lnTo>
                <a:lnTo>
                  <a:pt x="520446" y="30607"/>
                </a:lnTo>
                <a:lnTo>
                  <a:pt x="578230" y="30607"/>
                </a:lnTo>
                <a:lnTo>
                  <a:pt x="578230" y="33782"/>
                </a:lnTo>
                <a:lnTo>
                  <a:pt x="636016" y="33782"/>
                </a:lnTo>
                <a:lnTo>
                  <a:pt x="636016" y="39877"/>
                </a:lnTo>
                <a:lnTo>
                  <a:pt x="693928" y="39877"/>
                </a:lnTo>
                <a:lnTo>
                  <a:pt x="693928" y="43052"/>
                </a:lnTo>
                <a:lnTo>
                  <a:pt x="751713" y="43052"/>
                </a:lnTo>
                <a:lnTo>
                  <a:pt x="809497" y="43052"/>
                </a:lnTo>
                <a:lnTo>
                  <a:pt x="809497" y="49402"/>
                </a:lnTo>
                <a:lnTo>
                  <a:pt x="867283" y="49402"/>
                </a:lnTo>
                <a:lnTo>
                  <a:pt x="867283" y="52577"/>
                </a:lnTo>
                <a:lnTo>
                  <a:pt x="925195" y="52577"/>
                </a:lnTo>
                <a:lnTo>
                  <a:pt x="925195" y="55752"/>
                </a:lnTo>
                <a:lnTo>
                  <a:pt x="982979" y="55752"/>
                </a:lnTo>
                <a:lnTo>
                  <a:pt x="982979" y="58927"/>
                </a:lnTo>
                <a:lnTo>
                  <a:pt x="1040765" y="58927"/>
                </a:lnTo>
                <a:lnTo>
                  <a:pt x="1040765" y="62102"/>
                </a:lnTo>
                <a:lnTo>
                  <a:pt x="1098677" y="62102"/>
                </a:lnTo>
                <a:lnTo>
                  <a:pt x="1098677" y="78486"/>
                </a:lnTo>
                <a:lnTo>
                  <a:pt x="1156461" y="78486"/>
                </a:lnTo>
                <a:lnTo>
                  <a:pt x="1214247" y="78486"/>
                </a:lnTo>
                <a:lnTo>
                  <a:pt x="1214247" y="81788"/>
                </a:lnTo>
                <a:lnTo>
                  <a:pt x="1272032" y="81788"/>
                </a:lnTo>
                <a:lnTo>
                  <a:pt x="1272032" y="88392"/>
                </a:lnTo>
                <a:lnTo>
                  <a:pt x="1329944" y="88392"/>
                </a:lnTo>
                <a:lnTo>
                  <a:pt x="1387729" y="88392"/>
                </a:lnTo>
                <a:lnTo>
                  <a:pt x="1387729" y="95250"/>
                </a:lnTo>
                <a:lnTo>
                  <a:pt x="1445514" y="95250"/>
                </a:lnTo>
                <a:lnTo>
                  <a:pt x="1445514" y="98678"/>
                </a:lnTo>
                <a:lnTo>
                  <a:pt x="1503426" y="98678"/>
                </a:lnTo>
                <a:lnTo>
                  <a:pt x="1503426" y="105537"/>
                </a:lnTo>
                <a:lnTo>
                  <a:pt x="1561211" y="105537"/>
                </a:lnTo>
                <a:lnTo>
                  <a:pt x="1561211" y="116077"/>
                </a:lnTo>
                <a:lnTo>
                  <a:pt x="1618996" y="116077"/>
                </a:lnTo>
                <a:lnTo>
                  <a:pt x="1618996" y="126619"/>
                </a:lnTo>
                <a:lnTo>
                  <a:pt x="1676780" y="126619"/>
                </a:lnTo>
                <a:lnTo>
                  <a:pt x="1676780" y="130175"/>
                </a:lnTo>
                <a:lnTo>
                  <a:pt x="1734692" y="130175"/>
                </a:lnTo>
                <a:lnTo>
                  <a:pt x="1792477" y="130175"/>
                </a:lnTo>
                <a:lnTo>
                  <a:pt x="1850263" y="130175"/>
                </a:lnTo>
                <a:lnTo>
                  <a:pt x="1850263" y="141097"/>
                </a:lnTo>
                <a:lnTo>
                  <a:pt x="1908175" y="141097"/>
                </a:lnTo>
                <a:lnTo>
                  <a:pt x="1908175" y="144779"/>
                </a:lnTo>
                <a:lnTo>
                  <a:pt x="1965960" y="144779"/>
                </a:lnTo>
                <a:lnTo>
                  <a:pt x="2023745" y="144779"/>
                </a:lnTo>
                <a:lnTo>
                  <a:pt x="2081530" y="144779"/>
                </a:lnTo>
                <a:lnTo>
                  <a:pt x="2139442" y="144779"/>
                </a:lnTo>
                <a:lnTo>
                  <a:pt x="2139442" y="148590"/>
                </a:lnTo>
                <a:lnTo>
                  <a:pt x="2197227" y="148590"/>
                </a:lnTo>
                <a:lnTo>
                  <a:pt x="2197227" y="152400"/>
                </a:lnTo>
                <a:lnTo>
                  <a:pt x="2255012" y="152400"/>
                </a:lnTo>
                <a:lnTo>
                  <a:pt x="2255012" y="156210"/>
                </a:lnTo>
                <a:lnTo>
                  <a:pt x="2312924" y="156210"/>
                </a:lnTo>
                <a:lnTo>
                  <a:pt x="2312924" y="171831"/>
                </a:lnTo>
                <a:lnTo>
                  <a:pt x="2370709" y="171831"/>
                </a:lnTo>
                <a:lnTo>
                  <a:pt x="2370709" y="179704"/>
                </a:lnTo>
                <a:lnTo>
                  <a:pt x="2428494" y="179704"/>
                </a:lnTo>
                <a:lnTo>
                  <a:pt x="2428494" y="183642"/>
                </a:lnTo>
                <a:lnTo>
                  <a:pt x="2486406" y="183642"/>
                </a:lnTo>
                <a:lnTo>
                  <a:pt x="2486406" y="187578"/>
                </a:lnTo>
                <a:lnTo>
                  <a:pt x="2544191" y="187578"/>
                </a:lnTo>
                <a:lnTo>
                  <a:pt x="2601976" y="187578"/>
                </a:lnTo>
                <a:lnTo>
                  <a:pt x="2601976" y="191643"/>
                </a:lnTo>
                <a:lnTo>
                  <a:pt x="2659761" y="191643"/>
                </a:lnTo>
                <a:lnTo>
                  <a:pt x="2659761" y="199898"/>
                </a:lnTo>
                <a:lnTo>
                  <a:pt x="2717673" y="199898"/>
                </a:lnTo>
                <a:lnTo>
                  <a:pt x="2717673" y="212217"/>
                </a:lnTo>
                <a:lnTo>
                  <a:pt x="2775458" y="212217"/>
                </a:lnTo>
                <a:lnTo>
                  <a:pt x="2775458" y="220472"/>
                </a:lnTo>
                <a:lnTo>
                  <a:pt x="2833243" y="220472"/>
                </a:lnTo>
                <a:lnTo>
                  <a:pt x="2833243" y="224663"/>
                </a:lnTo>
                <a:lnTo>
                  <a:pt x="2891155" y="224663"/>
                </a:lnTo>
                <a:lnTo>
                  <a:pt x="2948940" y="224663"/>
                </a:lnTo>
                <a:lnTo>
                  <a:pt x="2948940" y="228981"/>
                </a:lnTo>
                <a:lnTo>
                  <a:pt x="3006725" y="228981"/>
                </a:lnTo>
                <a:lnTo>
                  <a:pt x="3064510" y="228981"/>
                </a:lnTo>
                <a:lnTo>
                  <a:pt x="3122422" y="228981"/>
                </a:lnTo>
                <a:lnTo>
                  <a:pt x="3122422" y="233425"/>
                </a:lnTo>
                <a:lnTo>
                  <a:pt x="3180207" y="233425"/>
                </a:lnTo>
                <a:lnTo>
                  <a:pt x="3237992" y="233425"/>
                </a:lnTo>
                <a:lnTo>
                  <a:pt x="3237992" y="242316"/>
                </a:lnTo>
                <a:lnTo>
                  <a:pt x="3295904" y="242316"/>
                </a:lnTo>
                <a:lnTo>
                  <a:pt x="3353689" y="242316"/>
                </a:lnTo>
                <a:lnTo>
                  <a:pt x="3353689" y="246761"/>
                </a:lnTo>
                <a:lnTo>
                  <a:pt x="3411474" y="246761"/>
                </a:lnTo>
                <a:lnTo>
                  <a:pt x="3411474" y="260603"/>
                </a:lnTo>
                <a:lnTo>
                  <a:pt x="3469259" y="260603"/>
                </a:lnTo>
                <a:lnTo>
                  <a:pt x="3527171" y="260603"/>
                </a:lnTo>
                <a:lnTo>
                  <a:pt x="3584956" y="260603"/>
                </a:lnTo>
                <a:lnTo>
                  <a:pt x="3642741" y="260603"/>
                </a:lnTo>
                <a:lnTo>
                  <a:pt x="3642741" y="270001"/>
                </a:lnTo>
                <a:lnTo>
                  <a:pt x="3700653" y="270001"/>
                </a:lnTo>
                <a:lnTo>
                  <a:pt x="3700653" y="274827"/>
                </a:lnTo>
                <a:lnTo>
                  <a:pt x="3758438" y="274827"/>
                </a:lnTo>
                <a:lnTo>
                  <a:pt x="3758438" y="279653"/>
                </a:lnTo>
                <a:lnTo>
                  <a:pt x="3816223" y="279653"/>
                </a:lnTo>
                <a:lnTo>
                  <a:pt x="3816223" y="289433"/>
                </a:lnTo>
                <a:lnTo>
                  <a:pt x="3874008" y="289433"/>
                </a:lnTo>
                <a:lnTo>
                  <a:pt x="3874008" y="299339"/>
                </a:lnTo>
                <a:lnTo>
                  <a:pt x="3931920" y="299339"/>
                </a:lnTo>
                <a:lnTo>
                  <a:pt x="3989705" y="299339"/>
                </a:lnTo>
                <a:lnTo>
                  <a:pt x="3989705" y="304419"/>
                </a:lnTo>
                <a:lnTo>
                  <a:pt x="4047490" y="304419"/>
                </a:lnTo>
                <a:lnTo>
                  <a:pt x="4047490" y="320040"/>
                </a:lnTo>
                <a:lnTo>
                  <a:pt x="4105402" y="320040"/>
                </a:lnTo>
                <a:lnTo>
                  <a:pt x="4105402" y="330581"/>
                </a:lnTo>
                <a:lnTo>
                  <a:pt x="4163187" y="330581"/>
                </a:lnTo>
                <a:lnTo>
                  <a:pt x="4220972" y="330581"/>
                </a:lnTo>
                <a:lnTo>
                  <a:pt x="4220972" y="335915"/>
                </a:lnTo>
                <a:lnTo>
                  <a:pt x="4278757" y="335915"/>
                </a:lnTo>
                <a:lnTo>
                  <a:pt x="4278757" y="341249"/>
                </a:lnTo>
                <a:lnTo>
                  <a:pt x="4336669" y="341249"/>
                </a:lnTo>
                <a:lnTo>
                  <a:pt x="4336669" y="346710"/>
                </a:lnTo>
                <a:lnTo>
                  <a:pt x="4394454" y="346710"/>
                </a:lnTo>
                <a:lnTo>
                  <a:pt x="4394454" y="357632"/>
                </a:lnTo>
                <a:lnTo>
                  <a:pt x="4452239" y="357632"/>
                </a:lnTo>
                <a:lnTo>
                  <a:pt x="4510151" y="357632"/>
                </a:lnTo>
                <a:lnTo>
                  <a:pt x="4567936" y="357632"/>
                </a:lnTo>
                <a:lnTo>
                  <a:pt x="4567936" y="374650"/>
                </a:lnTo>
                <a:lnTo>
                  <a:pt x="4625721" y="374650"/>
                </a:lnTo>
                <a:lnTo>
                  <a:pt x="4625721" y="380365"/>
                </a:lnTo>
                <a:lnTo>
                  <a:pt x="4683506" y="380365"/>
                </a:lnTo>
                <a:lnTo>
                  <a:pt x="4683506" y="386079"/>
                </a:lnTo>
                <a:lnTo>
                  <a:pt x="4741418" y="386079"/>
                </a:lnTo>
                <a:lnTo>
                  <a:pt x="4799203" y="386079"/>
                </a:lnTo>
                <a:lnTo>
                  <a:pt x="4856988" y="386079"/>
                </a:lnTo>
                <a:lnTo>
                  <a:pt x="4856988" y="397764"/>
                </a:lnTo>
                <a:lnTo>
                  <a:pt x="4914900" y="397764"/>
                </a:lnTo>
                <a:lnTo>
                  <a:pt x="4914900" y="409575"/>
                </a:lnTo>
                <a:lnTo>
                  <a:pt x="4972685" y="409575"/>
                </a:lnTo>
                <a:lnTo>
                  <a:pt x="5030470" y="409575"/>
                </a:lnTo>
                <a:lnTo>
                  <a:pt x="5088255" y="409575"/>
                </a:lnTo>
                <a:lnTo>
                  <a:pt x="5146167" y="409575"/>
                </a:lnTo>
                <a:lnTo>
                  <a:pt x="5203952" y="409575"/>
                </a:lnTo>
                <a:lnTo>
                  <a:pt x="5261737" y="409575"/>
                </a:lnTo>
                <a:lnTo>
                  <a:pt x="5261737" y="415798"/>
                </a:lnTo>
                <a:lnTo>
                  <a:pt x="5319649" y="415798"/>
                </a:lnTo>
                <a:lnTo>
                  <a:pt x="5319649" y="428751"/>
                </a:lnTo>
                <a:lnTo>
                  <a:pt x="5377433" y="428751"/>
                </a:lnTo>
                <a:lnTo>
                  <a:pt x="5377433" y="441706"/>
                </a:lnTo>
                <a:lnTo>
                  <a:pt x="5435219" y="441706"/>
                </a:lnTo>
                <a:lnTo>
                  <a:pt x="5493004" y="441706"/>
                </a:lnTo>
                <a:lnTo>
                  <a:pt x="5493004" y="454914"/>
                </a:lnTo>
                <a:lnTo>
                  <a:pt x="5550916" y="454914"/>
                </a:lnTo>
                <a:lnTo>
                  <a:pt x="5550916" y="468249"/>
                </a:lnTo>
                <a:lnTo>
                  <a:pt x="5608701" y="468249"/>
                </a:lnTo>
                <a:lnTo>
                  <a:pt x="5608701" y="481838"/>
                </a:lnTo>
                <a:lnTo>
                  <a:pt x="5666486" y="481838"/>
                </a:lnTo>
                <a:lnTo>
                  <a:pt x="5724398" y="481838"/>
                </a:lnTo>
                <a:lnTo>
                  <a:pt x="5724398" y="495681"/>
                </a:lnTo>
                <a:lnTo>
                  <a:pt x="5782183" y="495681"/>
                </a:lnTo>
                <a:lnTo>
                  <a:pt x="5839968" y="495681"/>
                </a:lnTo>
                <a:lnTo>
                  <a:pt x="5839968" y="502666"/>
                </a:lnTo>
                <a:lnTo>
                  <a:pt x="5897753" y="502666"/>
                </a:lnTo>
                <a:lnTo>
                  <a:pt x="5897753" y="509777"/>
                </a:lnTo>
                <a:lnTo>
                  <a:pt x="5955665" y="509777"/>
                </a:lnTo>
                <a:lnTo>
                  <a:pt x="5955665" y="517017"/>
                </a:lnTo>
                <a:lnTo>
                  <a:pt x="6013450" y="517017"/>
                </a:lnTo>
                <a:lnTo>
                  <a:pt x="6013450" y="524510"/>
                </a:lnTo>
                <a:lnTo>
                  <a:pt x="6071235" y="524510"/>
                </a:lnTo>
                <a:lnTo>
                  <a:pt x="6129147" y="524510"/>
                </a:lnTo>
                <a:lnTo>
                  <a:pt x="6186932" y="524510"/>
                </a:lnTo>
                <a:lnTo>
                  <a:pt x="6186932" y="532129"/>
                </a:lnTo>
                <a:lnTo>
                  <a:pt x="6244717" y="532129"/>
                </a:lnTo>
                <a:lnTo>
                  <a:pt x="6302502" y="532129"/>
                </a:lnTo>
                <a:lnTo>
                  <a:pt x="6360414" y="532129"/>
                </a:lnTo>
                <a:lnTo>
                  <a:pt x="6418199" y="532129"/>
                </a:lnTo>
                <a:lnTo>
                  <a:pt x="6475983" y="532129"/>
                </a:lnTo>
                <a:lnTo>
                  <a:pt x="6475983" y="548513"/>
                </a:lnTo>
                <a:lnTo>
                  <a:pt x="6533896" y="548513"/>
                </a:lnTo>
                <a:lnTo>
                  <a:pt x="6533896" y="565403"/>
                </a:lnTo>
                <a:lnTo>
                  <a:pt x="6591681" y="565403"/>
                </a:lnTo>
                <a:lnTo>
                  <a:pt x="6649466" y="565403"/>
                </a:lnTo>
                <a:lnTo>
                  <a:pt x="6649466" y="573913"/>
                </a:lnTo>
                <a:lnTo>
                  <a:pt x="6707251" y="573913"/>
                </a:lnTo>
                <a:lnTo>
                  <a:pt x="6707251" y="582549"/>
                </a:lnTo>
                <a:lnTo>
                  <a:pt x="6765163" y="582549"/>
                </a:lnTo>
                <a:lnTo>
                  <a:pt x="6822948" y="582549"/>
                </a:lnTo>
                <a:lnTo>
                  <a:pt x="6822948" y="591439"/>
                </a:lnTo>
                <a:lnTo>
                  <a:pt x="6938645" y="591439"/>
                </a:lnTo>
                <a:lnTo>
                  <a:pt x="6996430" y="591439"/>
                </a:lnTo>
                <a:lnTo>
                  <a:pt x="7054215" y="591439"/>
                </a:lnTo>
                <a:lnTo>
                  <a:pt x="7054215" y="600837"/>
                </a:lnTo>
                <a:lnTo>
                  <a:pt x="7112000" y="600837"/>
                </a:lnTo>
                <a:lnTo>
                  <a:pt x="7169912" y="600837"/>
                </a:lnTo>
                <a:lnTo>
                  <a:pt x="7227697" y="600837"/>
                </a:lnTo>
                <a:lnTo>
                  <a:pt x="7285482" y="600837"/>
                </a:lnTo>
                <a:lnTo>
                  <a:pt x="7343394" y="600837"/>
                </a:lnTo>
                <a:lnTo>
                  <a:pt x="7401179" y="600837"/>
                </a:lnTo>
                <a:lnTo>
                  <a:pt x="7401179" y="620776"/>
                </a:lnTo>
                <a:lnTo>
                  <a:pt x="7458964" y="620776"/>
                </a:lnTo>
                <a:lnTo>
                  <a:pt x="7458964" y="631190"/>
                </a:lnTo>
                <a:lnTo>
                  <a:pt x="7516749" y="631190"/>
                </a:lnTo>
                <a:lnTo>
                  <a:pt x="7574661" y="631190"/>
                </a:lnTo>
                <a:lnTo>
                  <a:pt x="7574661" y="641858"/>
                </a:lnTo>
                <a:lnTo>
                  <a:pt x="7632446" y="641858"/>
                </a:lnTo>
                <a:lnTo>
                  <a:pt x="7690231" y="641858"/>
                </a:lnTo>
                <a:lnTo>
                  <a:pt x="7690231" y="652907"/>
                </a:lnTo>
                <a:lnTo>
                  <a:pt x="7748143" y="652907"/>
                </a:lnTo>
                <a:lnTo>
                  <a:pt x="7805928" y="652907"/>
                </a:lnTo>
                <a:lnTo>
                  <a:pt x="7863713" y="652907"/>
                </a:lnTo>
                <a:lnTo>
                  <a:pt x="7921625" y="652907"/>
                </a:lnTo>
                <a:lnTo>
                  <a:pt x="7979410" y="652907"/>
                </a:lnTo>
                <a:lnTo>
                  <a:pt x="7979410" y="676910"/>
                </a:lnTo>
                <a:lnTo>
                  <a:pt x="8037195" y="676910"/>
                </a:lnTo>
                <a:lnTo>
                  <a:pt x="8094980" y="676910"/>
                </a:lnTo>
                <a:lnTo>
                  <a:pt x="8152892" y="676910"/>
                </a:lnTo>
                <a:lnTo>
                  <a:pt x="8210677" y="676910"/>
                </a:lnTo>
                <a:lnTo>
                  <a:pt x="8210677" y="689356"/>
                </a:lnTo>
                <a:lnTo>
                  <a:pt x="8268462" y="689356"/>
                </a:lnTo>
                <a:lnTo>
                  <a:pt x="8326374" y="689356"/>
                </a:lnTo>
                <a:lnTo>
                  <a:pt x="8384158" y="689356"/>
                </a:lnTo>
                <a:lnTo>
                  <a:pt x="8384158" y="702310"/>
                </a:lnTo>
                <a:lnTo>
                  <a:pt x="8441944" y="702310"/>
                </a:lnTo>
                <a:lnTo>
                  <a:pt x="8499729" y="702310"/>
                </a:lnTo>
                <a:lnTo>
                  <a:pt x="8557641" y="702310"/>
                </a:lnTo>
                <a:lnTo>
                  <a:pt x="8615426" y="702310"/>
                </a:lnTo>
                <a:lnTo>
                  <a:pt x="8673211" y="702310"/>
                </a:lnTo>
                <a:lnTo>
                  <a:pt x="8731123" y="702310"/>
                </a:lnTo>
                <a:lnTo>
                  <a:pt x="8731123" y="717169"/>
                </a:lnTo>
                <a:lnTo>
                  <a:pt x="8788908" y="717169"/>
                </a:lnTo>
                <a:lnTo>
                  <a:pt x="8846693" y="717169"/>
                </a:lnTo>
                <a:lnTo>
                  <a:pt x="8904478" y="717169"/>
                </a:lnTo>
                <a:lnTo>
                  <a:pt x="8962390" y="717169"/>
                </a:lnTo>
                <a:lnTo>
                  <a:pt x="9020175" y="717169"/>
                </a:lnTo>
                <a:lnTo>
                  <a:pt x="9020175" y="733044"/>
                </a:lnTo>
                <a:lnTo>
                  <a:pt x="9077960" y="733044"/>
                </a:lnTo>
                <a:lnTo>
                  <a:pt x="9135872" y="733044"/>
                </a:lnTo>
                <a:lnTo>
                  <a:pt x="9135872" y="766572"/>
                </a:lnTo>
                <a:lnTo>
                  <a:pt x="9193657" y="766572"/>
                </a:lnTo>
                <a:lnTo>
                  <a:pt x="9251442" y="766572"/>
                </a:lnTo>
                <a:lnTo>
                  <a:pt x="9309227" y="766572"/>
                </a:lnTo>
                <a:lnTo>
                  <a:pt x="9424924" y="766572"/>
                </a:lnTo>
                <a:lnTo>
                  <a:pt x="9482709" y="766572"/>
                </a:lnTo>
                <a:lnTo>
                  <a:pt x="9540621" y="766572"/>
                </a:lnTo>
                <a:lnTo>
                  <a:pt x="9540621" y="785749"/>
                </a:lnTo>
                <a:lnTo>
                  <a:pt x="9598406" y="785749"/>
                </a:lnTo>
                <a:lnTo>
                  <a:pt x="9598406" y="805179"/>
                </a:lnTo>
                <a:lnTo>
                  <a:pt x="9656191" y="805179"/>
                </a:lnTo>
                <a:lnTo>
                  <a:pt x="9713976" y="805179"/>
                </a:lnTo>
                <a:lnTo>
                  <a:pt x="9713976" y="825119"/>
                </a:lnTo>
                <a:lnTo>
                  <a:pt x="9771888" y="825119"/>
                </a:lnTo>
                <a:lnTo>
                  <a:pt x="9771888" y="845185"/>
                </a:lnTo>
                <a:lnTo>
                  <a:pt x="9829673" y="845185"/>
                </a:lnTo>
                <a:lnTo>
                  <a:pt x="9887458" y="845185"/>
                </a:lnTo>
                <a:lnTo>
                  <a:pt x="10003155" y="845185"/>
                </a:lnTo>
                <a:lnTo>
                  <a:pt x="10060940" y="845185"/>
                </a:lnTo>
                <a:lnTo>
                  <a:pt x="10060940" y="867283"/>
                </a:lnTo>
                <a:lnTo>
                  <a:pt x="10118725" y="867283"/>
                </a:lnTo>
                <a:lnTo>
                  <a:pt x="10118725" y="890143"/>
                </a:lnTo>
                <a:lnTo>
                  <a:pt x="10176637" y="890143"/>
                </a:lnTo>
                <a:lnTo>
                  <a:pt x="10234422" y="890143"/>
                </a:lnTo>
                <a:lnTo>
                  <a:pt x="10292207" y="890143"/>
                </a:lnTo>
                <a:lnTo>
                  <a:pt x="10350119" y="890143"/>
                </a:lnTo>
                <a:lnTo>
                  <a:pt x="10407904" y="890143"/>
                </a:lnTo>
                <a:lnTo>
                  <a:pt x="10465689" y="890143"/>
                </a:lnTo>
                <a:lnTo>
                  <a:pt x="10465689" y="918718"/>
                </a:lnTo>
                <a:lnTo>
                  <a:pt x="10581386" y="918718"/>
                </a:lnTo>
                <a:lnTo>
                  <a:pt x="10581386" y="948182"/>
                </a:lnTo>
                <a:lnTo>
                  <a:pt x="10639171" y="948182"/>
                </a:lnTo>
                <a:lnTo>
                  <a:pt x="10754868" y="948182"/>
                </a:lnTo>
                <a:lnTo>
                  <a:pt x="10812653" y="948182"/>
                </a:lnTo>
                <a:lnTo>
                  <a:pt x="10870438" y="948182"/>
                </a:lnTo>
                <a:lnTo>
                  <a:pt x="10870438" y="980440"/>
                </a:lnTo>
                <a:lnTo>
                  <a:pt x="10986135" y="980440"/>
                </a:lnTo>
                <a:lnTo>
                  <a:pt x="10986135" y="1013587"/>
                </a:lnTo>
                <a:lnTo>
                  <a:pt x="11043920" y="1013587"/>
                </a:lnTo>
                <a:lnTo>
                  <a:pt x="11101705" y="1013587"/>
                </a:lnTo>
                <a:lnTo>
                  <a:pt x="11159617" y="1013587"/>
                </a:lnTo>
                <a:lnTo>
                  <a:pt x="11217402" y="1013587"/>
                </a:lnTo>
                <a:lnTo>
                  <a:pt x="11217402" y="1049909"/>
                </a:lnTo>
                <a:lnTo>
                  <a:pt x="11275187" y="1049909"/>
                </a:lnTo>
                <a:lnTo>
                  <a:pt x="11332972" y="1049909"/>
                </a:lnTo>
                <a:lnTo>
                  <a:pt x="11506454" y="1049909"/>
                </a:lnTo>
                <a:lnTo>
                  <a:pt x="11506454" y="1091819"/>
                </a:lnTo>
                <a:lnTo>
                  <a:pt x="11564366" y="1091819"/>
                </a:lnTo>
                <a:lnTo>
                  <a:pt x="11622151" y="1091819"/>
                </a:lnTo>
                <a:lnTo>
                  <a:pt x="11622151" y="1137158"/>
                </a:lnTo>
                <a:lnTo>
                  <a:pt x="11679936" y="1137158"/>
                </a:lnTo>
                <a:lnTo>
                  <a:pt x="11737721" y="1137158"/>
                </a:lnTo>
                <a:lnTo>
                  <a:pt x="11795633" y="1137158"/>
                </a:lnTo>
                <a:lnTo>
                  <a:pt x="11853418" y="1137158"/>
                </a:lnTo>
                <a:lnTo>
                  <a:pt x="11969115" y="1137158"/>
                </a:lnTo>
                <a:lnTo>
                  <a:pt x="12026900" y="1137158"/>
                </a:lnTo>
                <a:lnTo>
                  <a:pt x="12026900" y="1191895"/>
                </a:lnTo>
                <a:lnTo>
                  <a:pt x="12084685" y="1191895"/>
                </a:lnTo>
                <a:lnTo>
                  <a:pt x="12200382" y="1191895"/>
                </a:lnTo>
                <a:lnTo>
                  <a:pt x="12258166" y="1191895"/>
                </a:lnTo>
                <a:lnTo>
                  <a:pt x="12315952" y="1191895"/>
                </a:lnTo>
                <a:lnTo>
                  <a:pt x="12373864" y="1191895"/>
                </a:lnTo>
                <a:lnTo>
                  <a:pt x="12489434" y="1191895"/>
                </a:lnTo>
                <a:lnTo>
                  <a:pt x="12605131" y="1191895"/>
                </a:lnTo>
                <a:lnTo>
                  <a:pt x="12662916" y="1191895"/>
                </a:lnTo>
                <a:lnTo>
                  <a:pt x="12720701" y="1191895"/>
                </a:lnTo>
                <a:lnTo>
                  <a:pt x="12778613" y="1191895"/>
                </a:lnTo>
                <a:lnTo>
                  <a:pt x="12836398" y="1191895"/>
                </a:lnTo>
                <a:lnTo>
                  <a:pt x="12894183" y="1191895"/>
                </a:lnTo>
                <a:lnTo>
                  <a:pt x="12951968" y="1191895"/>
                </a:lnTo>
                <a:lnTo>
                  <a:pt x="13009879" y="1191895"/>
                </a:lnTo>
                <a:lnTo>
                  <a:pt x="13067664" y="1191895"/>
                </a:lnTo>
                <a:lnTo>
                  <a:pt x="13125450" y="1191895"/>
                </a:lnTo>
                <a:lnTo>
                  <a:pt x="13241146" y="1191895"/>
                </a:lnTo>
                <a:lnTo>
                  <a:pt x="13298931" y="1191895"/>
                </a:lnTo>
                <a:lnTo>
                  <a:pt x="13356843" y="1191895"/>
                </a:lnTo>
                <a:lnTo>
                  <a:pt x="13530198" y="1191895"/>
                </a:lnTo>
                <a:lnTo>
                  <a:pt x="13588110" y="1191895"/>
                </a:lnTo>
                <a:lnTo>
                  <a:pt x="13645895" y="1191895"/>
                </a:lnTo>
                <a:lnTo>
                  <a:pt x="13761592" y="1191895"/>
                </a:lnTo>
                <a:lnTo>
                  <a:pt x="13819377" y="1191895"/>
                </a:lnTo>
                <a:lnTo>
                  <a:pt x="13877162" y="1191895"/>
                </a:lnTo>
                <a:lnTo>
                  <a:pt x="13934948" y="1191895"/>
                </a:lnTo>
                <a:lnTo>
                  <a:pt x="13992860" y="1191895"/>
                </a:lnTo>
                <a:lnTo>
                  <a:pt x="14108429" y="1191895"/>
                </a:lnTo>
                <a:lnTo>
                  <a:pt x="14166341" y="1191895"/>
                </a:lnTo>
              </a:path>
            </a:pathLst>
          </a:custGeom>
          <a:ln w="27051">
            <a:solidFill>
              <a:srgbClr val="4DCE6B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5" name="bg object 25"/>
          <p:cNvSpPr/>
          <p:nvPr/>
        </p:nvSpPr>
        <p:spPr>
          <a:xfrm>
            <a:off x="1211452" y="722757"/>
            <a:ext cx="14340205" cy="1534795"/>
          </a:xfrm>
          <a:custGeom>
            <a:avLst/>
            <a:gdLst/>
            <a:ahLst/>
            <a:cxnLst/>
            <a:rect l="l" t="t" r="r" b="b"/>
            <a:pathLst>
              <a:path w="14340205" h="1534795">
                <a:moveTo>
                  <a:pt x="0" y="0"/>
                </a:moveTo>
                <a:lnTo>
                  <a:pt x="0" y="1524"/>
                </a:lnTo>
                <a:lnTo>
                  <a:pt x="57784" y="1524"/>
                </a:lnTo>
                <a:lnTo>
                  <a:pt x="57784" y="3175"/>
                </a:lnTo>
                <a:lnTo>
                  <a:pt x="115697" y="3175"/>
                </a:lnTo>
                <a:lnTo>
                  <a:pt x="115697" y="4699"/>
                </a:lnTo>
                <a:lnTo>
                  <a:pt x="173481" y="4699"/>
                </a:lnTo>
                <a:lnTo>
                  <a:pt x="173481" y="7874"/>
                </a:lnTo>
                <a:lnTo>
                  <a:pt x="231266" y="7874"/>
                </a:lnTo>
                <a:lnTo>
                  <a:pt x="231266" y="12700"/>
                </a:lnTo>
                <a:lnTo>
                  <a:pt x="289178" y="12700"/>
                </a:lnTo>
                <a:lnTo>
                  <a:pt x="289178" y="19176"/>
                </a:lnTo>
                <a:lnTo>
                  <a:pt x="346963" y="19176"/>
                </a:lnTo>
                <a:lnTo>
                  <a:pt x="346963" y="24002"/>
                </a:lnTo>
                <a:lnTo>
                  <a:pt x="404749" y="24002"/>
                </a:lnTo>
                <a:lnTo>
                  <a:pt x="404749" y="25653"/>
                </a:lnTo>
                <a:lnTo>
                  <a:pt x="462534" y="25653"/>
                </a:lnTo>
                <a:lnTo>
                  <a:pt x="462534" y="35306"/>
                </a:lnTo>
                <a:lnTo>
                  <a:pt x="520446" y="35306"/>
                </a:lnTo>
                <a:lnTo>
                  <a:pt x="520446" y="41910"/>
                </a:lnTo>
                <a:lnTo>
                  <a:pt x="578230" y="41910"/>
                </a:lnTo>
                <a:lnTo>
                  <a:pt x="578230" y="43561"/>
                </a:lnTo>
                <a:lnTo>
                  <a:pt x="636016" y="43561"/>
                </a:lnTo>
                <a:lnTo>
                  <a:pt x="636016" y="50038"/>
                </a:lnTo>
                <a:lnTo>
                  <a:pt x="693928" y="50038"/>
                </a:lnTo>
                <a:lnTo>
                  <a:pt x="693928" y="56642"/>
                </a:lnTo>
                <a:lnTo>
                  <a:pt x="751713" y="56642"/>
                </a:lnTo>
                <a:lnTo>
                  <a:pt x="751713" y="59944"/>
                </a:lnTo>
                <a:lnTo>
                  <a:pt x="809497" y="59944"/>
                </a:lnTo>
                <a:lnTo>
                  <a:pt x="809497" y="61595"/>
                </a:lnTo>
                <a:lnTo>
                  <a:pt x="867283" y="61595"/>
                </a:lnTo>
                <a:lnTo>
                  <a:pt x="867283" y="69976"/>
                </a:lnTo>
                <a:lnTo>
                  <a:pt x="925195" y="69976"/>
                </a:lnTo>
                <a:lnTo>
                  <a:pt x="925195" y="76835"/>
                </a:lnTo>
                <a:lnTo>
                  <a:pt x="982979" y="76835"/>
                </a:lnTo>
                <a:lnTo>
                  <a:pt x="982979" y="83566"/>
                </a:lnTo>
                <a:lnTo>
                  <a:pt x="1040765" y="83566"/>
                </a:lnTo>
                <a:lnTo>
                  <a:pt x="1040765" y="86995"/>
                </a:lnTo>
                <a:lnTo>
                  <a:pt x="1098677" y="86995"/>
                </a:lnTo>
                <a:lnTo>
                  <a:pt x="1098677" y="95758"/>
                </a:lnTo>
                <a:lnTo>
                  <a:pt x="1156461" y="95758"/>
                </a:lnTo>
                <a:lnTo>
                  <a:pt x="1156461" y="97409"/>
                </a:lnTo>
                <a:lnTo>
                  <a:pt x="1214247" y="97409"/>
                </a:lnTo>
                <a:lnTo>
                  <a:pt x="1214247" y="106299"/>
                </a:lnTo>
                <a:lnTo>
                  <a:pt x="1272032" y="106299"/>
                </a:lnTo>
                <a:lnTo>
                  <a:pt x="1272032" y="109854"/>
                </a:lnTo>
                <a:lnTo>
                  <a:pt x="1329944" y="109854"/>
                </a:lnTo>
                <a:lnTo>
                  <a:pt x="1329944" y="120523"/>
                </a:lnTo>
                <a:lnTo>
                  <a:pt x="1387729" y="120523"/>
                </a:lnTo>
                <a:lnTo>
                  <a:pt x="1387729" y="124078"/>
                </a:lnTo>
                <a:lnTo>
                  <a:pt x="1445514" y="124078"/>
                </a:lnTo>
                <a:lnTo>
                  <a:pt x="1445514" y="127762"/>
                </a:lnTo>
                <a:lnTo>
                  <a:pt x="1503426" y="127762"/>
                </a:lnTo>
                <a:lnTo>
                  <a:pt x="1503426" y="129540"/>
                </a:lnTo>
                <a:lnTo>
                  <a:pt x="1561211" y="129540"/>
                </a:lnTo>
                <a:lnTo>
                  <a:pt x="1561211" y="133350"/>
                </a:lnTo>
                <a:lnTo>
                  <a:pt x="1618996" y="133350"/>
                </a:lnTo>
                <a:lnTo>
                  <a:pt x="1618996" y="135127"/>
                </a:lnTo>
                <a:lnTo>
                  <a:pt x="1676780" y="135127"/>
                </a:lnTo>
                <a:lnTo>
                  <a:pt x="1676780" y="142621"/>
                </a:lnTo>
                <a:lnTo>
                  <a:pt x="1734692" y="142621"/>
                </a:lnTo>
                <a:lnTo>
                  <a:pt x="1734692" y="154050"/>
                </a:lnTo>
                <a:lnTo>
                  <a:pt x="1792477" y="154050"/>
                </a:lnTo>
                <a:lnTo>
                  <a:pt x="1792477" y="159766"/>
                </a:lnTo>
                <a:lnTo>
                  <a:pt x="1850263" y="159766"/>
                </a:lnTo>
                <a:lnTo>
                  <a:pt x="1850263" y="165608"/>
                </a:lnTo>
                <a:lnTo>
                  <a:pt x="1908175" y="165608"/>
                </a:lnTo>
                <a:lnTo>
                  <a:pt x="1908175" y="173354"/>
                </a:lnTo>
                <a:lnTo>
                  <a:pt x="1965960" y="173354"/>
                </a:lnTo>
                <a:lnTo>
                  <a:pt x="1965960" y="181228"/>
                </a:lnTo>
                <a:lnTo>
                  <a:pt x="2023745" y="181228"/>
                </a:lnTo>
                <a:lnTo>
                  <a:pt x="2023745" y="185293"/>
                </a:lnTo>
                <a:lnTo>
                  <a:pt x="2081530" y="185293"/>
                </a:lnTo>
                <a:lnTo>
                  <a:pt x="2081530" y="187325"/>
                </a:lnTo>
                <a:lnTo>
                  <a:pt x="2139442" y="187325"/>
                </a:lnTo>
                <a:lnTo>
                  <a:pt x="2139442" y="191262"/>
                </a:lnTo>
                <a:lnTo>
                  <a:pt x="2197227" y="191262"/>
                </a:lnTo>
                <a:lnTo>
                  <a:pt x="2197227" y="199390"/>
                </a:lnTo>
                <a:lnTo>
                  <a:pt x="2255012" y="199390"/>
                </a:lnTo>
                <a:lnTo>
                  <a:pt x="2255012" y="201422"/>
                </a:lnTo>
                <a:lnTo>
                  <a:pt x="2312924" y="201422"/>
                </a:lnTo>
                <a:lnTo>
                  <a:pt x="2312924" y="205613"/>
                </a:lnTo>
                <a:lnTo>
                  <a:pt x="2370709" y="205613"/>
                </a:lnTo>
                <a:lnTo>
                  <a:pt x="2370709" y="216026"/>
                </a:lnTo>
                <a:lnTo>
                  <a:pt x="2428494" y="216026"/>
                </a:lnTo>
                <a:lnTo>
                  <a:pt x="2428494" y="218059"/>
                </a:lnTo>
                <a:lnTo>
                  <a:pt x="2486406" y="218059"/>
                </a:lnTo>
                <a:lnTo>
                  <a:pt x="2486406" y="224409"/>
                </a:lnTo>
                <a:lnTo>
                  <a:pt x="2544191" y="224409"/>
                </a:lnTo>
                <a:lnTo>
                  <a:pt x="2544191" y="230759"/>
                </a:lnTo>
                <a:lnTo>
                  <a:pt x="2601976" y="230759"/>
                </a:lnTo>
                <a:lnTo>
                  <a:pt x="2601976" y="239395"/>
                </a:lnTo>
                <a:lnTo>
                  <a:pt x="2659761" y="239395"/>
                </a:lnTo>
                <a:lnTo>
                  <a:pt x="2659761" y="241553"/>
                </a:lnTo>
                <a:lnTo>
                  <a:pt x="2717673" y="241553"/>
                </a:lnTo>
                <a:lnTo>
                  <a:pt x="2717673" y="248031"/>
                </a:lnTo>
                <a:lnTo>
                  <a:pt x="2775458" y="248031"/>
                </a:lnTo>
                <a:lnTo>
                  <a:pt x="2775458" y="252475"/>
                </a:lnTo>
                <a:lnTo>
                  <a:pt x="2833243" y="252475"/>
                </a:lnTo>
                <a:lnTo>
                  <a:pt x="2833243" y="259079"/>
                </a:lnTo>
                <a:lnTo>
                  <a:pt x="2891155" y="259079"/>
                </a:lnTo>
                <a:lnTo>
                  <a:pt x="2891155" y="265684"/>
                </a:lnTo>
                <a:lnTo>
                  <a:pt x="2948940" y="265684"/>
                </a:lnTo>
                <a:lnTo>
                  <a:pt x="2948940" y="274700"/>
                </a:lnTo>
                <a:lnTo>
                  <a:pt x="3006725" y="274700"/>
                </a:lnTo>
                <a:lnTo>
                  <a:pt x="3006725" y="283845"/>
                </a:lnTo>
                <a:lnTo>
                  <a:pt x="3064510" y="283845"/>
                </a:lnTo>
                <a:lnTo>
                  <a:pt x="3064510" y="293116"/>
                </a:lnTo>
                <a:lnTo>
                  <a:pt x="3122422" y="293116"/>
                </a:lnTo>
                <a:lnTo>
                  <a:pt x="3122422" y="297688"/>
                </a:lnTo>
                <a:lnTo>
                  <a:pt x="3180207" y="297688"/>
                </a:lnTo>
                <a:lnTo>
                  <a:pt x="3180207" y="304673"/>
                </a:lnTo>
                <a:lnTo>
                  <a:pt x="3237992" y="304673"/>
                </a:lnTo>
                <a:lnTo>
                  <a:pt x="3237992" y="309372"/>
                </a:lnTo>
                <a:lnTo>
                  <a:pt x="3295904" y="309372"/>
                </a:lnTo>
                <a:lnTo>
                  <a:pt x="3353689" y="309372"/>
                </a:lnTo>
                <a:lnTo>
                  <a:pt x="3353689" y="316611"/>
                </a:lnTo>
                <a:lnTo>
                  <a:pt x="3411474" y="316611"/>
                </a:lnTo>
                <a:lnTo>
                  <a:pt x="3411474" y="326263"/>
                </a:lnTo>
                <a:lnTo>
                  <a:pt x="3469259" y="326263"/>
                </a:lnTo>
                <a:lnTo>
                  <a:pt x="3469259" y="336042"/>
                </a:lnTo>
                <a:lnTo>
                  <a:pt x="3527171" y="336042"/>
                </a:lnTo>
                <a:lnTo>
                  <a:pt x="3527171" y="338454"/>
                </a:lnTo>
                <a:lnTo>
                  <a:pt x="3584956" y="338454"/>
                </a:lnTo>
                <a:lnTo>
                  <a:pt x="3642741" y="338454"/>
                </a:lnTo>
                <a:lnTo>
                  <a:pt x="3642741" y="356108"/>
                </a:lnTo>
                <a:lnTo>
                  <a:pt x="3700653" y="356108"/>
                </a:lnTo>
                <a:lnTo>
                  <a:pt x="3758438" y="356108"/>
                </a:lnTo>
                <a:lnTo>
                  <a:pt x="3758438" y="358648"/>
                </a:lnTo>
                <a:lnTo>
                  <a:pt x="3816223" y="358648"/>
                </a:lnTo>
                <a:lnTo>
                  <a:pt x="3816223" y="361188"/>
                </a:lnTo>
                <a:lnTo>
                  <a:pt x="3874008" y="361188"/>
                </a:lnTo>
                <a:lnTo>
                  <a:pt x="3874008" y="371728"/>
                </a:lnTo>
                <a:lnTo>
                  <a:pt x="3931920" y="371728"/>
                </a:lnTo>
                <a:lnTo>
                  <a:pt x="3989705" y="371728"/>
                </a:lnTo>
                <a:lnTo>
                  <a:pt x="4047490" y="371728"/>
                </a:lnTo>
                <a:lnTo>
                  <a:pt x="4047490" y="374396"/>
                </a:lnTo>
                <a:lnTo>
                  <a:pt x="4105402" y="374396"/>
                </a:lnTo>
                <a:lnTo>
                  <a:pt x="4105402" y="382650"/>
                </a:lnTo>
                <a:lnTo>
                  <a:pt x="4163187" y="382650"/>
                </a:lnTo>
                <a:lnTo>
                  <a:pt x="4163187" y="390906"/>
                </a:lnTo>
                <a:lnTo>
                  <a:pt x="4220972" y="390906"/>
                </a:lnTo>
                <a:lnTo>
                  <a:pt x="4220972" y="399288"/>
                </a:lnTo>
                <a:lnTo>
                  <a:pt x="4278757" y="399288"/>
                </a:lnTo>
                <a:lnTo>
                  <a:pt x="4278757" y="402082"/>
                </a:lnTo>
                <a:lnTo>
                  <a:pt x="4336669" y="402082"/>
                </a:lnTo>
                <a:lnTo>
                  <a:pt x="4336669" y="410591"/>
                </a:lnTo>
                <a:lnTo>
                  <a:pt x="4394454" y="410591"/>
                </a:lnTo>
                <a:lnTo>
                  <a:pt x="4452239" y="410591"/>
                </a:lnTo>
                <a:lnTo>
                  <a:pt x="4452239" y="413512"/>
                </a:lnTo>
                <a:lnTo>
                  <a:pt x="4510151" y="413512"/>
                </a:lnTo>
                <a:lnTo>
                  <a:pt x="4510151" y="419353"/>
                </a:lnTo>
                <a:lnTo>
                  <a:pt x="4567936" y="419353"/>
                </a:lnTo>
                <a:lnTo>
                  <a:pt x="4567936" y="425323"/>
                </a:lnTo>
                <a:lnTo>
                  <a:pt x="4625721" y="425323"/>
                </a:lnTo>
                <a:lnTo>
                  <a:pt x="4625721" y="431419"/>
                </a:lnTo>
                <a:lnTo>
                  <a:pt x="4683506" y="431419"/>
                </a:lnTo>
                <a:lnTo>
                  <a:pt x="4741418" y="431419"/>
                </a:lnTo>
                <a:lnTo>
                  <a:pt x="4741418" y="437642"/>
                </a:lnTo>
                <a:lnTo>
                  <a:pt x="4799203" y="437642"/>
                </a:lnTo>
                <a:lnTo>
                  <a:pt x="4799203" y="443992"/>
                </a:lnTo>
                <a:lnTo>
                  <a:pt x="4856988" y="443992"/>
                </a:lnTo>
                <a:lnTo>
                  <a:pt x="4856988" y="447167"/>
                </a:lnTo>
                <a:lnTo>
                  <a:pt x="4914900" y="447167"/>
                </a:lnTo>
                <a:lnTo>
                  <a:pt x="4914900" y="450469"/>
                </a:lnTo>
                <a:lnTo>
                  <a:pt x="4972685" y="450469"/>
                </a:lnTo>
                <a:lnTo>
                  <a:pt x="4972685" y="463550"/>
                </a:lnTo>
                <a:lnTo>
                  <a:pt x="5030470" y="463550"/>
                </a:lnTo>
                <a:lnTo>
                  <a:pt x="5030470" y="470281"/>
                </a:lnTo>
                <a:lnTo>
                  <a:pt x="5088255" y="470281"/>
                </a:lnTo>
                <a:lnTo>
                  <a:pt x="5088255" y="480314"/>
                </a:lnTo>
                <a:lnTo>
                  <a:pt x="5146167" y="480314"/>
                </a:lnTo>
                <a:lnTo>
                  <a:pt x="5146167" y="483743"/>
                </a:lnTo>
                <a:lnTo>
                  <a:pt x="5203952" y="483743"/>
                </a:lnTo>
                <a:lnTo>
                  <a:pt x="5203952" y="497586"/>
                </a:lnTo>
                <a:lnTo>
                  <a:pt x="5261737" y="497586"/>
                </a:lnTo>
                <a:lnTo>
                  <a:pt x="5261737" y="514858"/>
                </a:lnTo>
                <a:lnTo>
                  <a:pt x="5319649" y="514858"/>
                </a:lnTo>
                <a:lnTo>
                  <a:pt x="5319649" y="521970"/>
                </a:lnTo>
                <a:lnTo>
                  <a:pt x="5377433" y="521970"/>
                </a:lnTo>
                <a:lnTo>
                  <a:pt x="5377433" y="532765"/>
                </a:lnTo>
                <a:lnTo>
                  <a:pt x="5435219" y="532765"/>
                </a:lnTo>
                <a:lnTo>
                  <a:pt x="5435219" y="540131"/>
                </a:lnTo>
                <a:lnTo>
                  <a:pt x="5493004" y="540131"/>
                </a:lnTo>
                <a:lnTo>
                  <a:pt x="5493004" y="551052"/>
                </a:lnTo>
                <a:lnTo>
                  <a:pt x="5550916" y="551052"/>
                </a:lnTo>
                <a:lnTo>
                  <a:pt x="5550916" y="554863"/>
                </a:lnTo>
                <a:lnTo>
                  <a:pt x="5608701" y="554863"/>
                </a:lnTo>
                <a:lnTo>
                  <a:pt x="5608701" y="558546"/>
                </a:lnTo>
                <a:lnTo>
                  <a:pt x="5666486" y="558546"/>
                </a:lnTo>
                <a:lnTo>
                  <a:pt x="5724398" y="558546"/>
                </a:lnTo>
                <a:lnTo>
                  <a:pt x="5724398" y="573913"/>
                </a:lnTo>
                <a:lnTo>
                  <a:pt x="5782183" y="573913"/>
                </a:lnTo>
                <a:lnTo>
                  <a:pt x="5782183" y="577850"/>
                </a:lnTo>
                <a:lnTo>
                  <a:pt x="5839968" y="577850"/>
                </a:lnTo>
                <a:lnTo>
                  <a:pt x="5897753" y="577850"/>
                </a:lnTo>
                <a:lnTo>
                  <a:pt x="5897753" y="581787"/>
                </a:lnTo>
                <a:lnTo>
                  <a:pt x="5955665" y="581787"/>
                </a:lnTo>
                <a:lnTo>
                  <a:pt x="5955665" y="589915"/>
                </a:lnTo>
                <a:lnTo>
                  <a:pt x="6013450" y="589915"/>
                </a:lnTo>
                <a:lnTo>
                  <a:pt x="6013450" y="606425"/>
                </a:lnTo>
                <a:lnTo>
                  <a:pt x="6071235" y="606425"/>
                </a:lnTo>
                <a:lnTo>
                  <a:pt x="6071235" y="619125"/>
                </a:lnTo>
                <a:lnTo>
                  <a:pt x="6129147" y="619125"/>
                </a:lnTo>
                <a:lnTo>
                  <a:pt x="6129147" y="627634"/>
                </a:lnTo>
                <a:lnTo>
                  <a:pt x="6186932" y="627634"/>
                </a:lnTo>
                <a:lnTo>
                  <a:pt x="6186932" y="631951"/>
                </a:lnTo>
                <a:lnTo>
                  <a:pt x="6244717" y="631951"/>
                </a:lnTo>
                <a:lnTo>
                  <a:pt x="6244717" y="636397"/>
                </a:lnTo>
                <a:lnTo>
                  <a:pt x="6302502" y="636397"/>
                </a:lnTo>
                <a:lnTo>
                  <a:pt x="6302502" y="649604"/>
                </a:lnTo>
                <a:lnTo>
                  <a:pt x="6360414" y="649604"/>
                </a:lnTo>
                <a:lnTo>
                  <a:pt x="6360414" y="658495"/>
                </a:lnTo>
                <a:lnTo>
                  <a:pt x="6418199" y="658495"/>
                </a:lnTo>
                <a:lnTo>
                  <a:pt x="6475983" y="658495"/>
                </a:lnTo>
                <a:lnTo>
                  <a:pt x="6475983" y="662940"/>
                </a:lnTo>
                <a:lnTo>
                  <a:pt x="6533896" y="662940"/>
                </a:lnTo>
                <a:lnTo>
                  <a:pt x="6533896" y="672084"/>
                </a:lnTo>
                <a:lnTo>
                  <a:pt x="6591681" y="672084"/>
                </a:lnTo>
                <a:lnTo>
                  <a:pt x="6649466" y="672084"/>
                </a:lnTo>
                <a:lnTo>
                  <a:pt x="6707251" y="672084"/>
                </a:lnTo>
                <a:lnTo>
                  <a:pt x="6707251" y="676910"/>
                </a:lnTo>
                <a:lnTo>
                  <a:pt x="6765163" y="676910"/>
                </a:lnTo>
                <a:lnTo>
                  <a:pt x="6765163" y="686435"/>
                </a:lnTo>
                <a:lnTo>
                  <a:pt x="6822948" y="686435"/>
                </a:lnTo>
                <a:lnTo>
                  <a:pt x="6822948" y="691261"/>
                </a:lnTo>
                <a:lnTo>
                  <a:pt x="6880733" y="691261"/>
                </a:lnTo>
                <a:lnTo>
                  <a:pt x="6880733" y="696087"/>
                </a:lnTo>
                <a:lnTo>
                  <a:pt x="6938645" y="696087"/>
                </a:lnTo>
                <a:lnTo>
                  <a:pt x="6938645" y="705866"/>
                </a:lnTo>
                <a:lnTo>
                  <a:pt x="6996430" y="705866"/>
                </a:lnTo>
                <a:lnTo>
                  <a:pt x="6996430" y="715772"/>
                </a:lnTo>
                <a:lnTo>
                  <a:pt x="7054215" y="715772"/>
                </a:lnTo>
                <a:lnTo>
                  <a:pt x="7112000" y="715772"/>
                </a:lnTo>
                <a:lnTo>
                  <a:pt x="7112000" y="726186"/>
                </a:lnTo>
                <a:lnTo>
                  <a:pt x="7169912" y="726186"/>
                </a:lnTo>
                <a:lnTo>
                  <a:pt x="7169912" y="736726"/>
                </a:lnTo>
                <a:lnTo>
                  <a:pt x="7227697" y="736726"/>
                </a:lnTo>
                <a:lnTo>
                  <a:pt x="7227697" y="747522"/>
                </a:lnTo>
                <a:lnTo>
                  <a:pt x="7285482" y="747522"/>
                </a:lnTo>
                <a:lnTo>
                  <a:pt x="7285482" y="758317"/>
                </a:lnTo>
                <a:lnTo>
                  <a:pt x="7343394" y="758317"/>
                </a:lnTo>
                <a:lnTo>
                  <a:pt x="7343394" y="769239"/>
                </a:lnTo>
                <a:lnTo>
                  <a:pt x="7401179" y="769239"/>
                </a:lnTo>
                <a:lnTo>
                  <a:pt x="7401179" y="786002"/>
                </a:lnTo>
                <a:lnTo>
                  <a:pt x="7458964" y="786002"/>
                </a:lnTo>
                <a:lnTo>
                  <a:pt x="7516749" y="786002"/>
                </a:lnTo>
                <a:lnTo>
                  <a:pt x="7516749" y="791718"/>
                </a:lnTo>
                <a:lnTo>
                  <a:pt x="7574661" y="791718"/>
                </a:lnTo>
                <a:lnTo>
                  <a:pt x="7632446" y="791718"/>
                </a:lnTo>
                <a:lnTo>
                  <a:pt x="7632446" y="797560"/>
                </a:lnTo>
                <a:lnTo>
                  <a:pt x="7690231" y="797560"/>
                </a:lnTo>
                <a:lnTo>
                  <a:pt x="7748143" y="797560"/>
                </a:lnTo>
                <a:lnTo>
                  <a:pt x="7748143" y="803656"/>
                </a:lnTo>
                <a:lnTo>
                  <a:pt x="7805928" y="803656"/>
                </a:lnTo>
                <a:lnTo>
                  <a:pt x="7805928" y="816101"/>
                </a:lnTo>
                <a:lnTo>
                  <a:pt x="7863713" y="816101"/>
                </a:lnTo>
                <a:lnTo>
                  <a:pt x="7863713" y="822451"/>
                </a:lnTo>
                <a:lnTo>
                  <a:pt x="7921625" y="822451"/>
                </a:lnTo>
                <a:lnTo>
                  <a:pt x="7921625" y="828928"/>
                </a:lnTo>
                <a:lnTo>
                  <a:pt x="7979410" y="828928"/>
                </a:lnTo>
                <a:lnTo>
                  <a:pt x="7979410" y="835533"/>
                </a:lnTo>
                <a:lnTo>
                  <a:pt x="8037195" y="835533"/>
                </a:lnTo>
                <a:lnTo>
                  <a:pt x="8037195" y="842264"/>
                </a:lnTo>
                <a:lnTo>
                  <a:pt x="8094980" y="842264"/>
                </a:lnTo>
                <a:lnTo>
                  <a:pt x="8094980" y="842264"/>
                </a:lnTo>
                <a:lnTo>
                  <a:pt x="8152892" y="842264"/>
                </a:lnTo>
                <a:lnTo>
                  <a:pt x="8210677" y="842264"/>
                </a:lnTo>
                <a:lnTo>
                  <a:pt x="8268462" y="842264"/>
                </a:lnTo>
                <a:lnTo>
                  <a:pt x="8268462" y="849629"/>
                </a:lnTo>
                <a:lnTo>
                  <a:pt x="8326374" y="849629"/>
                </a:lnTo>
                <a:lnTo>
                  <a:pt x="8384158" y="849629"/>
                </a:lnTo>
                <a:lnTo>
                  <a:pt x="8384158" y="880110"/>
                </a:lnTo>
                <a:lnTo>
                  <a:pt x="8441944" y="880110"/>
                </a:lnTo>
                <a:lnTo>
                  <a:pt x="8499729" y="880110"/>
                </a:lnTo>
                <a:lnTo>
                  <a:pt x="8499729" y="903477"/>
                </a:lnTo>
                <a:lnTo>
                  <a:pt x="8557641" y="903477"/>
                </a:lnTo>
                <a:lnTo>
                  <a:pt x="8615426" y="903477"/>
                </a:lnTo>
                <a:lnTo>
                  <a:pt x="8615426" y="911733"/>
                </a:lnTo>
                <a:lnTo>
                  <a:pt x="8673211" y="911733"/>
                </a:lnTo>
                <a:lnTo>
                  <a:pt x="8731123" y="911733"/>
                </a:lnTo>
                <a:lnTo>
                  <a:pt x="8731123" y="936878"/>
                </a:lnTo>
                <a:lnTo>
                  <a:pt x="8788908" y="936878"/>
                </a:lnTo>
                <a:lnTo>
                  <a:pt x="8846693" y="936878"/>
                </a:lnTo>
                <a:lnTo>
                  <a:pt x="8846693" y="945642"/>
                </a:lnTo>
                <a:lnTo>
                  <a:pt x="8962390" y="945642"/>
                </a:lnTo>
                <a:lnTo>
                  <a:pt x="8962390" y="954532"/>
                </a:lnTo>
                <a:lnTo>
                  <a:pt x="9020175" y="954532"/>
                </a:lnTo>
                <a:lnTo>
                  <a:pt x="9020175" y="972566"/>
                </a:lnTo>
                <a:lnTo>
                  <a:pt x="9077960" y="972566"/>
                </a:lnTo>
                <a:lnTo>
                  <a:pt x="9135872" y="972566"/>
                </a:lnTo>
                <a:lnTo>
                  <a:pt x="9193657" y="972566"/>
                </a:lnTo>
                <a:lnTo>
                  <a:pt x="9193657" y="982091"/>
                </a:lnTo>
                <a:lnTo>
                  <a:pt x="9251442" y="982091"/>
                </a:lnTo>
                <a:lnTo>
                  <a:pt x="9251442" y="991997"/>
                </a:lnTo>
                <a:lnTo>
                  <a:pt x="9309227" y="991997"/>
                </a:lnTo>
                <a:lnTo>
                  <a:pt x="9367139" y="991997"/>
                </a:lnTo>
                <a:lnTo>
                  <a:pt x="9367139" y="1023112"/>
                </a:lnTo>
                <a:lnTo>
                  <a:pt x="9424924" y="1023112"/>
                </a:lnTo>
                <a:lnTo>
                  <a:pt x="9482709" y="1023112"/>
                </a:lnTo>
                <a:lnTo>
                  <a:pt x="9540621" y="1023112"/>
                </a:lnTo>
                <a:lnTo>
                  <a:pt x="9540621" y="1055497"/>
                </a:lnTo>
                <a:lnTo>
                  <a:pt x="9598406" y="1055497"/>
                </a:lnTo>
                <a:lnTo>
                  <a:pt x="9656191" y="1055497"/>
                </a:lnTo>
                <a:lnTo>
                  <a:pt x="9713976" y="1055497"/>
                </a:lnTo>
                <a:lnTo>
                  <a:pt x="9771888" y="1055497"/>
                </a:lnTo>
                <a:lnTo>
                  <a:pt x="9771888" y="1066927"/>
                </a:lnTo>
                <a:lnTo>
                  <a:pt x="9829673" y="1066927"/>
                </a:lnTo>
                <a:lnTo>
                  <a:pt x="9829673" y="1078738"/>
                </a:lnTo>
                <a:lnTo>
                  <a:pt x="9887458" y="1078738"/>
                </a:lnTo>
                <a:lnTo>
                  <a:pt x="9887458" y="1090676"/>
                </a:lnTo>
                <a:lnTo>
                  <a:pt x="9945370" y="1090676"/>
                </a:lnTo>
                <a:lnTo>
                  <a:pt x="10003155" y="1090676"/>
                </a:lnTo>
                <a:lnTo>
                  <a:pt x="10060940" y="1090676"/>
                </a:lnTo>
                <a:lnTo>
                  <a:pt x="10060940" y="1103249"/>
                </a:lnTo>
                <a:lnTo>
                  <a:pt x="10118725" y="1103249"/>
                </a:lnTo>
                <a:lnTo>
                  <a:pt x="10118725" y="1128776"/>
                </a:lnTo>
                <a:lnTo>
                  <a:pt x="10176637" y="1128776"/>
                </a:lnTo>
                <a:lnTo>
                  <a:pt x="10176637" y="1141729"/>
                </a:lnTo>
                <a:lnTo>
                  <a:pt x="10234422" y="1141729"/>
                </a:lnTo>
                <a:lnTo>
                  <a:pt x="10234422" y="1155065"/>
                </a:lnTo>
                <a:lnTo>
                  <a:pt x="10292207" y="1155065"/>
                </a:lnTo>
                <a:lnTo>
                  <a:pt x="10350119" y="1155065"/>
                </a:lnTo>
                <a:lnTo>
                  <a:pt x="10407904" y="1155065"/>
                </a:lnTo>
                <a:lnTo>
                  <a:pt x="10407904" y="1169416"/>
                </a:lnTo>
                <a:lnTo>
                  <a:pt x="10465689" y="1169416"/>
                </a:lnTo>
                <a:lnTo>
                  <a:pt x="10465689" y="1184275"/>
                </a:lnTo>
                <a:lnTo>
                  <a:pt x="10523474" y="1184275"/>
                </a:lnTo>
                <a:lnTo>
                  <a:pt x="10581386" y="1184275"/>
                </a:lnTo>
                <a:lnTo>
                  <a:pt x="10639171" y="1184275"/>
                </a:lnTo>
                <a:lnTo>
                  <a:pt x="10696956" y="1184275"/>
                </a:lnTo>
                <a:lnTo>
                  <a:pt x="10696956" y="1199896"/>
                </a:lnTo>
                <a:lnTo>
                  <a:pt x="10754868" y="1199896"/>
                </a:lnTo>
                <a:lnTo>
                  <a:pt x="10812653" y="1199896"/>
                </a:lnTo>
                <a:lnTo>
                  <a:pt x="10812653" y="1216152"/>
                </a:lnTo>
                <a:lnTo>
                  <a:pt x="10870438" y="1216152"/>
                </a:lnTo>
                <a:lnTo>
                  <a:pt x="10928223" y="1216152"/>
                </a:lnTo>
                <a:lnTo>
                  <a:pt x="10928223" y="1233677"/>
                </a:lnTo>
                <a:lnTo>
                  <a:pt x="10986135" y="1233677"/>
                </a:lnTo>
                <a:lnTo>
                  <a:pt x="11043920" y="1233677"/>
                </a:lnTo>
                <a:lnTo>
                  <a:pt x="11043920" y="1251839"/>
                </a:lnTo>
                <a:lnTo>
                  <a:pt x="11101705" y="1251839"/>
                </a:lnTo>
                <a:lnTo>
                  <a:pt x="11159617" y="1251839"/>
                </a:lnTo>
                <a:lnTo>
                  <a:pt x="11217402" y="1251839"/>
                </a:lnTo>
                <a:lnTo>
                  <a:pt x="11275187" y="1251839"/>
                </a:lnTo>
                <a:lnTo>
                  <a:pt x="11275187" y="1272159"/>
                </a:lnTo>
                <a:lnTo>
                  <a:pt x="11332972" y="1272159"/>
                </a:lnTo>
                <a:lnTo>
                  <a:pt x="11390884" y="1272159"/>
                </a:lnTo>
                <a:lnTo>
                  <a:pt x="11448669" y="1272159"/>
                </a:lnTo>
                <a:lnTo>
                  <a:pt x="11506454" y="1272159"/>
                </a:lnTo>
                <a:lnTo>
                  <a:pt x="11564366" y="1272159"/>
                </a:lnTo>
                <a:lnTo>
                  <a:pt x="11622151" y="1272159"/>
                </a:lnTo>
                <a:lnTo>
                  <a:pt x="11679936" y="1272159"/>
                </a:lnTo>
                <a:lnTo>
                  <a:pt x="11679936" y="1300734"/>
                </a:lnTo>
                <a:lnTo>
                  <a:pt x="11737721" y="1300734"/>
                </a:lnTo>
                <a:lnTo>
                  <a:pt x="11795633" y="1300734"/>
                </a:lnTo>
                <a:lnTo>
                  <a:pt x="11853418" y="1300734"/>
                </a:lnTo>
                <a:lnTo>
                  <a:pt x="11911203" y="1300734"/>
                </a:lnTo>
                <a:lnTo>
                  <a:pt x="11969115" y="1300734"/>
                </a:lnTo>
                <a:lnTo>
                  <a:pt x="12142470" y="1300734"/>
                </a:lnTo>
                <a:lnTo>
                  <a:pt x="12142470" y="1341754"/>
                </a:lnTo>
                <a:lnTo>
                  <a:pt x="12200382" y="1341754"/>
                </a:lnTo>
                <a:lnTo>
                  <a:pt x="12258166" y="1341754"/>
                </a:lnTo>
                <a:lnTo>
                  <a:pt x="12431649" y="1341754"/>
                </a:lnTo>
                <a:lnTo>
                  <a:pt x="12489434" y="1341754"/>
                </a:lnTo>
                <a:lnTo>
                  <a:pt x="12547218" y="1341754"/>
                </a:lnTo>
                <a:lnTo>
                  <a:pt x="12662916" y="1341754"/>
                </a:lnTo>
                <a:lnTo>
                  <a:pt x="12720701" y="1341754"/>
                </a:lnTo>
                <a:lnTo>
                  <a:pt x="12778613" y="1341754"/>
                </a:lnTo>
                <a:lnTo>
                  <a:pt x="12836398" y="1341754"/>
                </a:lnTo>
                <a:lnTo>
                  <a:pt x="12894183" y="1341754"/>
                </a:lnTo>
                <a:lnTo>
                  <a:pt x="12951968" y="1341754"/>
                </a:lnTo>
                <a:lnTo>
                  <a:pt x="13009879" y="1341754"/>
                </a:lnTo>
                <a:lnTo>
                  <a:pt x="13067664" y="1341754"/>
                </a:lnTo>
                <a:lnTo>
                  <a:pt x="13183362" y="1341754"/>
                </a:lnTo>
                <a:lnTo>
                  <a:pt x="13183362" y="1534541"/>
                </a:lnTo>
                <a:lnTo>
                  <a:pt x="13298931" y="1534541"/>
                </a:lnTo>
                <a:lnTo>
                  <a:pt x="13356843" y="1534541"/>
                </a:lnTo>
                <a:lnTo>
                  <a:pt x="13472414" y="1534541"/>
                </a:lnTo>
                <a:lnTo>
                  <a:pt x="13530198" y="1534541"/>
                </a:lnTo>
                <a:lnTo>
                  <a:pt x="13645895" y="1534541"/>
                </a:lnTo>
                <a:lnTo>
                  <a:pt x="14281912" y="1534541"/>
                </a:lnTo>
                <a:lnTo>
                  <a:pt x="14339696" y="1534541"/>
                </a:lnTo>
              </a:path>
            </a:pathLst>
          </a:custGeom>
          <a:ln w="27051">
            <a:solidFill>
              <a:srgbClr val="BCA7E8"/>
            </a:solidFill>
            <a:prstDash val="sysDash"/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bg object 26"/>
          <p:cNvSpPr/>
          <p:nvPr/>
        </p:nvSpPr>
        <p:spPr>
          <a:xfrm>
            <a:off x="1616202" y="722629"/>
            <a:ext cx="13935075" cy="203200"/>
          </a:xfrm>
          <a:custGeom>
            <a:avLst/>
            <a:gdLst/>
            <a:ahLst/>
            <a:cxnLst/>
            <a:rect l="l" t="t" r="r" b="b"/>
            <a:pathLst>
              <a:path w="13935075" h="203200">
                <a:moveTo>
                  <a:pt x="11217402" y="93980"/>
                </a:moveTo>
                <a:lnTo>
                  <a:pt x="10176637" y="93980"/>
                </a:lnTo>
                <a:lnTo>
                  <a:pt x="10176637" y="88900"/>
                </a:lnTo>
                <a:lnTo>
                  <a:pt x="9367139" y="88900"/>
                </a:lnTo>
                <a:lnTo>
                  <a:pt x="9367139" y="85090"/>
                </a:lnTo>
                <a:lnTo>
                  <a:pt x="9309227" y="85090"/>
                </a:lnTo>
                <a:lnTo>
                  <a:pt x="9309227" y="81280"/>
                </a:lnTo>
                <a:lnTo>
                  <a:pt x="9193657" y="81280"/>
                </a:lnTo>
                <a:lnTo>
                  <a:pt x="9193657" y="77470"/>
                </a:lnTo>
                <a:lnTo>
                  <a:pt x="9135872" y="77470"/>
                </a:lnTo>
                <a:lnTo>
                  <a:pt x="9135872" y="74930"/>
                </a:lnTo>
                <a:lnTo>
                  <a:pt x="9077960" y="74930"/>
                </a:lnTo>
                <a:lnTo>
                  <a:pt x="9077960" y="73660"/>
                </a:lnTo>
                <a:lnTo>
                  <a:pt x="9077960" y="71120"/>
                </a:lnTo>
                <a:lnTo>
                  <a:pt x="8499729" y="71120"/>
                </a:lnTo>
                <a:lnTo>
                  <a:pt x="8499729" y="69850"/>
                </a:lnTo>
                <a:lnTo>
                  <a:pt x="8499729" y="67310"/>
                </a:lnTo>
                <a:lnTo>
                  <a:pt x="8384159" y="67310"/>
                </a:lnTo>
                <a:lnTo>
                  <a:pt x="8384159" y="64770"/>
                </a:lnTo>
                <a:lnTo>
                  <a:pt x="8152892" y="64770"/>
                </a:lnTo>
                <a:lnTo>
                  <a:pt x="8152892" y="63500"/>
                </a:lnTo>
                <a:lnTo>
                  <a:pt x="8152892" y="59690"/>
                </a:lnTo>
                <a:lnTo>
                  <a:pt x="7863713" y="59690"/>
                </a:lnTo>
                <a:lnTo>
                  <a:pt x="7863713" y="57150"/>
                </a:lnTo>
                <a:lnTo>
                  <a:pt x="7863713" y="55880"/>
                </a:lnTo>
                <a:lnTo>
                  <a:pt x="7805928" y="55880"/>
                </a:lnTo>
                <a:lnTo>
                  <a:pt x="7805928" y="53340"/>
                </a:lnTo>
                <a:lnTo>
                  <a:pt x="7458964" y="53340"/>
                </a:lnTo>
                <a:lnTo>
                  <a:pt x="7458964" y="50800"/>
                </a:lnTo>
                <a:lnTo>
                  <a:pt x="7458964" y="48260"/>
                </a:lnTo>
                <a:lnTo>
                  <a:pt x="7169912" y="48260"/>
                </a:lnTo>
                <a:lnTo>
                  <a:pt x="7169912" y="45720"/>
                </a:lnTo>
                <a:lnTo>
                  <a:pt x="7054215" y="45720"/>
                </a:lnTo>
                <a:lnTo>
                  <a:pt x="7054215" y="41910"/>
                </a:lnTo>
                <a:lnTo>
                  <a:pt x="6996430" y="41910"/>
                </a:lnTo>
                <a:lnTo>
                  <a:pt x="6996430" y="39370"/>
                </a:lnTo>
                <a:lnTo>
                  <a:pt x="6938645" y="39370"/>
                </a:lnTo>
                <a:lnTo>
                  <a:pt x="6938645" y="36830"/>
                </a:lnTo>
                <a:lnTo>
                  <a:pt x="6591681" y="36830"/>
                </a:lnTo>
                <a:lnTo>
                  <a:pt x="6591681" y="35560"/>
                </a:lnTo>
                <a:lnTo>
                  <a:pt x="6475984" y="35560"/>
                </a:lnTo>
                <a:lnTo>
                  <a:pt x="6475984" y="34290"/>
                </a:lnTo>
                <a:lnTo>
                  <a:pt x="6475984" y="33020"/>
                </a:lnTo>
                <a:lnTo>
                  <a:pt x="6418199" y="33020"/>
                </a:lnTo>
                <a:lnTo>
                  <a:pt x="6418199" y="30480"/>
                </a:lnTo>
                <a:lnTo>
                  <a:pt x="6071235" y="30480"/>
                </a:lnTo>
                <a:lnTo>
                  <a:pt x="6071235" y="29210"/>
                </a:lnTo>
                <a:lnTo>
                  <a:pt x="5955665" y="29210"/>
                </a:lnTo>
                <a:lnTo>
                  <a:pt x="5955665" y="27940"/>
                </a:lnTo>
                <a:lnTo>
                  <a:pt x="5955665" y="26670"/>
                </a:lnTo>
                <a:lnTo>
                  <a:pt x="5897753" y="26670"/>
                </a:lnTo>
                <a:lnTo>
                  <a:pt x="5897753" y="25400"/>
                </a:lnTo>
                <a:lnTo>
                  <a:pt x="5608701" y="25400"/>
                </a:lnTo>
                <a:lnTo>
                  <a:pt x="5608701" y="22860"/>
                </a:lnTo>
                <a:lnTo>
                  <a:pt x="5493004" y="22860"/>
                </a:lnTo>
                <a:lnTo>
                  <a:pt x="5493004" y="21590"/>
                </a:lnTo>
                <a:lnTo>
                  <a:pt x="4567936" y="21590"/>
                </a:lnTo>
                <a:lnTo>
                  <a:pt x="4567936" y="20320"/>
                </a:lnTo>
                <a:lnTo>
                  <a:pt x="4394454" y="20320"/>
                </a:lnTo>
                <a:lnTo>
                  <a:pt x="4394454" y="17780"/>
                </a:lnTo>
                <a:lnTo>
                  <a:pt x="4163187" y="17780"/>
                </a:lnTo>
                <a:lnTo>
                  <a:pt x="4163187" y="16510"/>
                </a:lnTo>
                <a:lnTo>
                  <a:pt x="3989705" y="16510"/>
                </a:lnTo>
                <a:lnTo>
                  <a:pt x="3989705" y="13970"/>
                </a:lnTo>
                <a:lnTo>
                  <a:pt x="3527171" y="13970"/>
                </a:lnTo>
                <a:lnTo>
                  <a:pt x="3527171" y="12700"/>
                </a:lnTo>
                <a:lnTo>
                  <a:pt x="3353689" y="12700"/>
                </a:lnTo>
                <a:lnTo>
                  <a:pt x="3353689" y="11430"/>
                </a:lnTo>
                <a:lnTo>
                  <a:pt x="3237992" y="11430"/>
                </a:lnTo>
                <a:lnTo>
                  <a:pt x="3237992" y="8890"/>
                </a:lnTo>
                <a:lnTo>
                  <a:pt x="2370709" y="8890"/>
                </a:lnTo>
                <a:lnTo>
                  <a:pt x="2370709" y="7620"/>
                </a:lnTo>
                <a:lnTo>
                  <a:pt x="2081657" y="7620"/>
                </a:lnTo>
                <a:lnTo>
                  <a:pt x="2081657" y="5080"/>
                </a:lnTo>
                <a:lnTo>
                  <a:pt x="2023745" y="5080"/>
                </a:lnTo>
                <a:lnTo>
                  <a:pt x="2023745" y="3810"/>
                </a:lnTo>
                <a:lnTo>
                  <a:pt x="1734693" y="3810"/>
                </a:lnTo>
                <a:lnTo>
                  <a:pt x="1734693" y="2540"/>
                </a:lnTo>
                <a:lnTo>
                  <a:pt x="751713" y="2540"/>
                </a:lnTo>
                <a:lnTo>
                  <a:pt x="751713" y="1270"/>
                </a:lnTo>
                <a:lnTo>
                  <a:pt x="636016" y="1270"/>
                </a:lnTo>
                <a:lnTo>
                  <a:pt x="636016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0" y="3810"/>
                </a:lnTo>
                <a:lnTo>
                  <a:pt x="173482" y="3810"/>
                </a:lnTo>
                <a:lnTo>
                  <a:pt x="173482" y="5080"/>
                </a:lnTo>
                <a:lnTo>
                  <a:pt x="173482" y="7620"/>
                </a:lnTo>
                <a:lnTo>
                  <a:pt x="520446" y="7620"/>
                </a:lnTo>
                <a:lnTo>
                  <a:pt x="520446" y="8890"/>
                </a:lnTo>
                <a:lnTo>
                  <a:pt x="578231" y="8890"/>
                </a:lnTo>
                <a:lnTo>
                  <a:pt x="578231" y="11430"/>
                </a:lnTo>
                <a:lnTo>
                  <a:pt x="636016" y="11430"/>
                </a:lnTo>
                <a:lnTo>
                  <a:pt x="636016" y="12700"/>
                </a:lnTo>
                <a:lnTo>
                  <a:pt x="636016" y="13970"/>
                </a:lnTo>
                <a:lnTo>
                  <a:pt x="751713" y="13970"/>
                </a:lnTo>
                <a:lnTo>
                  <a:pt x="751713" y="16510"/>
                </a:lnTo>
                <a:lnTo>
                  <a:pt x="982980" y="16510"/>
                </a:lnTo>
                <a:lnTo>
                  <a:pt x="982980" y="17780"/>
                </a:lnTo>
                <a:lnTo>
                  <a:pt x="1734693" y="17780"/>
                </a:lnTo>
                <a:lnTo>
                  <a:pt x="1734693" y="20320"/>
                </a:lnTo>
                <a:lnTo>
                  <a:pt x="2023745" y="20320"/>
                </a:lnTo>
                <a:lnTo>
                  <a:pt x="2023745" y="21590"/>
                </a:lnTo>
                <a:lnTo>
                  <a:pt x="2023745" y="22860"/>
                </a:lnTo>
                <a:lnTo>
                  <a:pt x="2081657" y="22860"/>
                </a:lnTo>
                <a:lnTo>
                  <a:pt x="2081657" y="25400"/>
                </a:lnTo>
                <a:lnTo>
                  <a:pt x="2081657" y="26670"/>
                </a:lnTo>
                <a:lnTo>
                  <a:pt x="2081657" y="27940"/>
                </a:lnTo>
                <a:lnTo>
                  <a:pt x="2370709" y="27940"/>
                </a:lnTo>
                <a:lnTo>
                  <a:pt x="2370709" y="29210"/>
                </a:lnTo>
                <a:lnTo>
                  <a:pt x="3237992" y="29210"/>
                </a:lnTo>
                <a:lnTo>
                  <a:pt x="3237992" y="30480"/>
                </a:lnTo>
                <a:lnTo>
                  <a:pt x="3237992" y="33020"/>
                </a:lnTo>
                <a:lnTo>
                  <a:pt x="3237992" y="34290"/>
                </a:lnTo>
                <a:lnTo>
                  <a:pt x="3353689" y="34290"/>
                </a:lnTo>
                <a:lnTo>
                  <a:pt x="3353689" y="35560"/>
                </a:lnTo>
                <a:lnTo>
                  <a:pt x="3353689" y="36830"/>
                </a:lnTo>
                <a:lnTo>
                  <a:pt x="3527171" y="36830"/>
                </a:lnTo>
                <a:lnTo>
                  <a:pt x="3527171" y="39370"/>
                </a:lnTo>
                <a:lnTo>
                  <a:pt x="3989705" y="39370"/>
                </a:lnTo>
                <a:lnTo>
                  <a:pt x="3989705" y="41910"/>
                </a:lnTo>
                <a:lnTo>
                  <a:pt x="3989705" y="45720"/>
                </a:lnTo>
                <a:lnTo>
                  <a:pt x="4163187" y="45720"/>
                </a:lnTo>
                <a:lnTo>
                  <a:pt x="4163187" y="48260"/>
                </a:lnTo>
                <a:lnTo>
                  <a:pt x="4394454" y="48260"/>
                </a:lnTo>
                <a:lnTo>
                  <a:pt x="4394454" y="50800"/>
                </a:lnTo>
                <a:lnTo>
                  <a:pt x="4567936" y="50800"/>
                </a:lnTo>
                <a:lnTo>
                  <a:pt x="4567936" y="53340"/>
                </a:lnTo>
                <a:lnTo>
                  <a:pt x="5493004" y="53340"/>
                </a:lnTo>
                <a:lnTo>
                  <a:pt x="5493004" y="55880"/>
                </a:lnTo>
                <a:lnTo>
                  <a:pt x="5493004" y="57150"/>
                </a:lnTo>
                <a:lnTo>
                  <a:pt x="5608701" y="57150"/>
                </a:lnTo>
                <a:lnTo>
                  <a:pt x="5608701" y="59690"/>
                </a:lnTo>
                <a:lnTo>
                  <a:pt x="5897753" y="59690"/>
                </a:lnTo>
                <a:lnTo>
                  <a:pt x="5897753" y="63500"/>
                </a:lnTo>
                <a:lnTo>
                  <a:pt x="5955665" y="63500"/>
                </a:lnTo>
                <a:lnTo>
                  <a:pt x="5955665" y="64770"/>
                </a:lnTo>
                <a:lnTo>
                  <a:pt x="5955665" y="67310"/>
                </a:lnTo>
                <a:lnTo>
                  <a:pt x="6071235" y="67310"/>
                </a:lnTo>
                <a:lnTo>
                  <a:pt x="6071235" y="69850"/>
                </a:lnTo>
                <a:lnTo>
                  <a:pt x="6418199" y="69850"/>
                </a:lnTo>
                <a:lnTo>
                  <a:pt x="6418199" y="71120"/>
                </a:lnTo>
                <a:lnTo>
                  <a:pt x="6418199" y="73660"/>
                </a:lnTo>
                <a:lnTo>
                  <a:pt x="6475984" y="73660"/>
                </a:lnTo>
                <a:lnTo>
                  <a:pt x="6475984" y="74930"/>
                </a:lnTo>
                <a:lnTo>
                  <a:pt x="6475984" y="77470"/>
                </a:lnTo>
                <a:lnTo>
                  <a:pt x="6591681" y="77470"/>
                </a:lnTo>
                <a:lnTo>
                  <a:pt x="6591681" y="81280"/>
                </a:lnTo>
                <a:lnTo>
                  <a:pt x="6938645" y="81280"/>
                </a:lnTo>
                <a:lnTo>
                  <a:pt x="6938645" y="85090"/>
                </a:lnTo>
                <a:lnTo>
                  <a:pt x="6996430" y="85090"/>
                </a:lnTo>
                <a:lnTo>
                  <a:pt x="6996430" y="88900"/>
                </a:lnTo>
                <a:lnTo>
                  <a:pt x="7054215" y="88900"/>
                </a:lnTo>
                <a:lnTo>
                  <a:pt x="7054215" y="93980"/>
                </a:lnTo>
                <a:lnTo>
                  <a:pt x="7054215" y="96520"/>
                </a:lnTo>
                <a:lnTo>
                  <a:pt x="7169912" y="96520"/>
                </a:lnTo>
                <a:lnTo>
                  <a:pt x="7169912" y="99060"/>
                </a:lnTo>
                <a:lnTo>
                  <a:pt x="7169912" y="100330"/>
                </a:lnTo>
                <a:lnTo>
                  <a:pt x="7458964" y="100330"/>
                </a:lnTo>
                <a:lnTo>
                  <a:pt x="7458964" y="99060"/>
                </a:lnTo>
                <a:lnTo>
                  <a:pt x="11217402" y="99060"/>
                </a:lnTo>
                <a:lnTo>
                  <a:pt x="11217402" y="96520"/>
                </a:lnTo>
                <a:lnTo>
                  <a:pt x="11217402" y="93980"/>
                </a:lnTo>
                <a:close/>
              </a:path>
              <a:path w="13935075" h="203200">
                <a:moveTo>
                  <a:pt x="13934948" y="105410"/>
                </a:moveTo>
                <a:lnTo>
                  <a:pt x="11506454" y="105410"/>
                </a:lnTo>
                <a:lnTo>
                  <a:pt x="11506454" y="100330"/>
                </a:lnTo>
                <a:lnTo>
                  <a:pt x="7458964" y="100330"/>
                </a:lnTo>
                <a:lnTo>
                  <a:pt x="7458964" y="105410"/>
                </a:lnTo>
                <a:lnTo>
                  <a:pt x="7458964" y="107950"/>
                </a:lnTo>
                <a:lnTo>
                  <a:pt x="7805928" y="107950"/>
                </a:lnTo>
                <a:lnTo>
                  <a:pt x="7805928" y="111760"/>
                </a:lnTo>
                <a:lnTo>
                  <a:pt x="7863713" y="111760"/>
                </a:lnTo>
                <a:lnTo>
                  <a:pt x="7863713" y="116840"/>
                </a:lnTo>
                <a:lnTo>
                  <a:pt x="8152892" y="116840"/>
                </a:lnTo>
                <a:lnTo>
                  <a:pt x="8152892" y="125730"/>
                </a:lnTo>
                <a:lnTo>
                  <a:pt x="8384159" y="125730"/>
                </a:lnTo>
                <a:lnTo>
                  <a:pt x="8384159" y="130810"/>
                </a:lnTo>
                <a:lnTo>
                  <a:pt x="8499729" y="130810"/>
                </a:lnTo>
                <a:lnTo>
                  <a:pt x="8499729" y="135890"/>
                </a:lnTo>
                <a:lnTo>
                  <a:pt x="9077960" y="135890"/>
                </a:lnTo>
                <a:lnTo>
                  <a:pt x="9077960" y="140970"/>
                </a:lnTo>
                <a:lnTo>
                  <a:pt x="9135872" y="140970"/>
                </a:lnTo>
                <a:lnTo>
                  <a:pt x="9135872" y="147320"/>
                </a:lnTo>
                <a:lnTo>
                  <a:pt x="9193657" y="147320"/>
                </a:lnTo>
                <a:lnTo>
                  <a:pt x="9193657" y="153670"/>
                </a:lnTo>
                <a:lnTo>
                  <a:pt x="9309227" y="153670"/>
                </a:lnTo>
                <a:lnTo>
                  <a:pt x="9309227" y="160020"/>
                </a:lnTo>
                <a:lnTo>
                  <a:pt x="9367139" y="160020"/>
                </a:lnTo>
                <a:lnTo>
                  <a:pt x="9367139" y="166370"/>
                </a:lnTo>
                <a:lnTo>
                  <a:pt x="10176637" y="166370"/>
                </a:lnTo>
                <a:lnTo>
                  <a:pt x="10176637" y="175260"/>
                </a:lnTo>
                <a:lnTo>
                  <a:pt x="11217402" y="175260"/>
                </a:lnTo>
                <a:lnTo>
                  <a:pt x="11217402" y="189230"/>
                </a:lnTo>
                <a:lnTo>
                  <a:pt x="11506454" y="189230"/>
                </a:lnTo>
                <a:lnTo>
                  <a:pt x="11506454" y="203200"/>
                </a:lnTo>
                <a:lnTo>
                  <a:pt x="13934948" y="203200"/>
                </a:lnTo>
                <a:lnTo>
                  <a:pt x="13934948" y="189230"/>
                </a:lnTo>
                <a:lnTo>
                  <a:pt x="13934948" y="175260"/>
                </a:lnTo>
                <a:lnTo>
                  <a:pt x="13934948" y="107950"/>
                </a:lnTo>
                <a:lnTo>
                  <a:pt x="13934948" y="105410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7" name="bg object 27"/>
          <p:cNvSpPr/>
          <p:nvPr/>
        </p:nvSpPr>
        <p:spPr>
          <a:xfrm>
            <a:off x="9017381" y="1036319"/>
            <a:ext cx="6591934" cy="330200"/>
          </a:xfrm>
          <a:custGeom>
            <a:avLst/>
            <a:gdLst/>
            <a:ahLst/>
            <a:cxnLst/>
            <a:rect l="l" t="t" r="r" b="b"/>
            <a:pathLst>
              <a:path w="6591934" h="330200">
                <a:moveTo>
                  <a:pt x="6591681" y="144780"/>
                </a:moveTo>
                <a:lnTo>
                  <a:pt x="5666486" y="144780"/>
                </a:lnTo>
                <a:lnTo>
                  <a:pt x="5666486" y="143510"/>
                </a:lnTo>
                <a:lnTo>
                  <a:pt x="5666486" y="138430"/>
                </a:lnTo>
                <a:lnTo>
                  <a:pt x="5666486" y="134620"/>
                </a:lnTo>
                <a:lnTo>
                  <a:pt x="5666486" y="133350"/>
                </a:lnTo>
                <a:lnTo>
                  <a:pt x="5493004" y="133350"/>
                </a:lnTo>
                <a:lnTo>
                  <a:pt x="5493004" y="129540"/>
                </a:lnTo>
                <a:lnTo>
                  <a:pt x="5493004" y="125730"/>
                </a:lnTo>
                <a:lnTo>
                  <a:pt x="5493004" y="123190"/>
                </a:lnTo>
                <a:lnTo>
                  <a:pt x="4914773" y="123190"/>
                </a:lnTo>
                <a:lnTo>
                  <a:pt x="4914773" y="120650"/>
                </a:lnTo>
                <a:lnTo>
                  <a:pt x="4914773" y="116840"/>
                </a:lnTo>
                <a:lnTo>
                  <a:pt x="4914773" y="115570"/>
                </a:lnTo>
                <a:lnTo>
                  <a:pt x="4683506" y="115570"/>
                </a:lnTo>
                <a:lnTo>
                  <a:pt x="4683506" y="113030"/>
                </a:lnTo>
                <a:lnTo>
                  <a:pt x="4683506" y="109220"/>
                </a:lnTo>
                <a:lnTo>
                  <a:pt x="4336542" y="109220"/>
                </a:lnTo>
                <a:lnTo>
                  <a:pt x="4336542" y="102870"/>
                </a:lnTo>
                <a:lnTo>
                  <a:pt x="4047490" y="102870"/>
                </a:lnTo>
                <a:lnTo>
                  <a:pt x="4047490" y="99060"/>
                </a:lnTo>
                <a:lnTo>
                  <a:pt x="4047490" y="97790"/>
                </a:lnTo>
                <a:lnTo>
                  <a:pt x="3931793" y="97790"/>
                </a:lnTo>
                <a:lnTo>
                  <a:pt x="3931793" y="95250"/>
                </a:lnTo>
                <a:lnTo>
                  <a:pt x="3931793" y="92710"/>
                </a:lnTo>
                <a:lnTo>
                  <a:pt x="3758438" y="92710"/>
                </a:lnTo>
                <a:lnTo>
                  <a:pt x="3758438" y="88900"/>
                </a:lnTo>
                <a:lnTo>
                  <a:pt x="3758438" y="87630"/>
                </a:lnTo>
                <a:lnTo>
                  <a:pt x="3700526" y="87630"/>
                </a:lnTo>
                <a:lnTo>
                  <a:pt x="3700526" y="86360"/>
                </a:lnTo>
                <a:lnTo>
                  <a:pt x="3700526" y="83820"/>
                </a:lnTo>
                <a:lnTo>
                  <a:pt x="3700526" y="78740"/>
                </a:lnTo>
                <a:lnTo>
                  <a:pt x="3584956" y="78740"/>
                </a:lnTo>
                <a:lnTo>
                  <a:pt x="3584956" y="74930"/>
                </a:lnTo>
                <a:lnTo>
                  <a:pt x="3469259" y="74930"/>
                </a:lnTo>
                <a:lnTo>
                  <a:pt x="3469259" y="72390"/>
                </a:lnTo>
                <a:lnTo>
                  <a:pt x="3469259" y="69850"/>
                </a:lnTo>
                <a:lnTo>
                  <a:pt x="3295777" y="69850"/>
                </a:lnTo>
                <a:lnTo>
                  <a:pt x="3295777" y="66040"/>
                </a:lnTo>
                <a:lnTo>
                  <a:pt x="3122295" y="66040"/>
                </a:lnTo>
                <a:lnTo>
                  <a:pt x="3122295" y="63500"/>
                </a:lnTo>
                <a:lnTo>
                  <a:pt x="3122295" y="62230"/>
                </a:lnTo>
                <a:lnTo>
                  <a:pt x="3064510" y="62230"/>
                </a:lnTo>
                <a:lnTo>
                  <a:pt x="3064510" y="58420"/>
                </a:lnTo>
                <a:lnTo>
                  <a:pt x="3006725" y="58420"/>
                </a:lnTo>
                <a:lnTo>
                  <a:pt x="3006725" y="55880"/>
                </a:lnTo>
                <a:lnTo>
                  <a:pt x="3006725" y="54610"/>
                </a:lnTo>
                <a:lnTo>
                  <a:pt x="2891028" y="54610"/>
                </a:lnTo>
                <a:lnTo>
                  <a:pt x="2891028" y="50800"/>
                </a:lnTo>
                <a:lnTo>
                  <a:pt x="2833243" y="50800"/>
                </a:lnTo>
                <a:lnTo>
                  <a:pt x="2833243" y="48260"/>
                </a:lnTo>
                <a:lnTo>
                  <a:pt x="2833243" y="46990"/>
                </a:lnTo>
                <a:lnTo>
                  <a:pt x="2775458" y="46990"/>
                </a:lnTo>
                <a:lnTo>
                  <a:pt x="2775458" y="43180"/>
                </a:lnTo>
                <a:lnTo>
                  <a:pt x="2659761" y="43180"/>
                </a:lnTo>
                <a:lnTo>
                  <a:pt x="2659761" y="40640"/>
                </a:lnTo>
                <a:lnTo>
                  <a:pt x="2544191" y="40640"/>
                </a:lnTo>
                <a:lnTo>
                  <a:pt x="2544191" y="38100"/>
                </a:lnTo>
                <a:lnTo>
                  <a:pt x="2544191" y="36830"/>
                </a:lnTo>
                <a:lnTo>
                  <a:pt x="2486279" y="36830"/>
                </a:lnTo>
                <a:lnTo>
                  <a:pt x="2486279" y="35560"/>
                </a:lnTo>
                <a:lnTo>
                  <a:pt x="2486279" y="34290"/>
                </a:lnTo>
                <a:lnTo>
                  <a:pt x="2428494" y="34290"/>
                </a:lnTo>
                <a:lnTo>
                  <a:pt x="2428494" y="31750"/>
                </a:lnTo>
                <a:lnTo>
                  <a:pt x="2428494" y="30480"/>
                </a:lnTo>
                <a:lnTo>
                  <a:pt x="2370709" y="30480"/>
                </a:lnTo>
                <a:lnTo>
                  <a:pt x="2370709" y="27940"/>
                </a:lnTo>
                <a:lnTo>
                  <a:pt x="2255012" y="27940"/>
                </a:lnTo>
                <a:lnTo>
                  <a:pt x="2255012" y="24130"/>
                </a:lnTo>
                <a:lnTo>
                  <a:pt x="2023745" y="24130"/>
                </a:lnTo>
                <a:lnTo>
                  <a:pt x="2023745" y="22860"/>
                </a:lnTo>
                <a:lnTo>
                  <a:pt x="2023745" y="17780"/>
                </a:lnTo>
                <a:lnTo>
                  <a:pt x="2023745" y="16510"/>
                </a:lnTo>
                <a:lnTo>
                  <a:pt x="1908048" y="16510"/>
                </a:lnTo>
                <a:lnTo>
                  <a:pt x="1908048" y="12700"/>
                </a:lnTo>
                <a:lnTo>
                  <a:pt x="1734693" y="12700"/>
                </a:lnTo>
                <a:lnTo>
                  <a:pt x="1734693" y="11430"/>
                </a:lnTo>
                <a:lnTo>
                  <a:pt x="1618996" y="11430"/>
                </a:lnTo>
                <a:lnTo>
                  <a:pt x="1618996" y="6350"/>
                </a:lnTo>
                <a:lnTo>
                  <a:pt x="1618996" y="5080"/>
                </a:lnTo>
                <a:lnTo>
                  <a:pt x="1445514" y="5080"/>
                </a:lnTo>
                <a:lnTo>
                  <a:pt x="1445514" y="3810"/>
                </a:lnTo>
                <a:lnTo>
                  <a:pt x="1329944" y="3810"/>
                </a:lnTo>
                <a:lnTo>
                  <a:pt x="1329944" y="1270"/>
                </a:lnTo>
                <a:lnTo>
                  <a:pt x="1214247" y="1270"/>
                </a:lnTo>
                <a:lnTo>
                  <a:pt x="1214247" y="0"/>
                </a:lnTo>
                <a:lnTo>
                  <a:pt x="0" y="0"/>
                </a:lnTo>
                <a:lnTo>
                  <a:pt x="0" y="1270"/>
                </a:lnTo>
                <a:lnTo>
                  <a:pt x="0" y="3810"/>
                </a:lnTo>
                <a:lnTo>
                  <a:pt x="0" y="5080"/>
                </a:lnTo>
                <a:lnTo>
                  <a:pt x="57785" y="5080"/>
                </a:lnTo>
                <a:lnTo>
                  <a:pt x="57785" y="6350"/>
                </a:lnTo>
                <a:lnTo>
                  <a:pt x="231267" y="6350"/>
                </a:lnTo>
                <a:lnTo>
                  <a:pt x="231267" y="11430"/>
                </a:lnTo>
                <a:lnTo>
                  <a:pt x="289052" y="11430"/>
                </a:lnTo>
                <a:lnTo>
                  <a:pt x="289052" y="12700"/>
                </a:lnTo>
                <a:lnTo>
                  <a:pt x="289052" y="16510"/>
                </a:lnTo>
                <a:lnTo>
                  <a:pt x="289052" y="17780"/>
                </a:lnTo>
                <a:lnTo>
                  <a:pt x="346964" y="17780"/>
                </a:lnTo>
                <a:lnTo>
                  <a:pt x="346964" y="22860"/>
                </a:lnTo>
                <a:lnTo>
                  <a:pt x="404749" y="22860"/>
                </a:lnTo>
                <a:lnTo>
                  <a:pt x="404749" y="24130"/>
                </a:lnTo>
                <a:lnTo>
                  <a:pt x="462534" y="24130"/>
                </a:lnTo>
                <a:lnTo>
                  <a:pt x="462534" y="27940"/>
                </a:lnTo>
                <a:lnTo>
                  <a:pt x="462534" y="30480"/>
                </a:lnTo>
                <a:lnTo>
                  <a:pt x="462534" y="31750"/>
                </a:lnTo>
                <a:lnTo>
                  <a:pt x="520446" y="31750"/>
                </a:lnTo>
                <a:lnTo>
                  <a:pt x="520446" y="34290"/>
                </a:lnTo>
                <a:lnTo>
                  <a:pt x="520446" y="35560"/>
                </a:lnTo>
                <a:lnTo>
                  <a:pt x="636016" y="35560"/>
                </a:lnTo>
                <a:lnTo>
                  <a:pt x="636016" y="36830"/>
                </a:lnTo>
                <a:lnTo>
                  <a:pt x="636016" y="38100"/>
                </a:lnTo>
                <a:lnTo>
                  <a:pt x="751713" y="38100"/>
                </a:lnTo>
                <a:lnTo>
                  <a:pt x="751713" y="40640"/>
                </a:lnTo>
                <a:lnTo>
                  <a:pt x="809498" y="40640"/>
                </a:lnTo>
                <a:lnTo>
                  <a:pt x="809498" y="43180"/>
                </a:lnTo>
                <a:lnTo>
                  <a:pt x="809498" y="46990"/>
                </a:lnTo>
                <a:lnTo>
                  <a:pt x="809498" y="48260"/>
                </a:lnTo>
                <a:lnTo>
                  <a:pt x="867283" y="48260"/>
                </a:lnTo>
                <a:lnTo>
                  <a:pt x="867283" y="50800"/>
                </a:lnTo>
                <a:lnTo>
                  <a:pt x="867283" y="54610"/>
                </a:lnTo>
                <a:lnTo>
                  <a:pt x="867283" y="55880"/>
                </a:lnTo>
                <a:lnTo>
                  <a:pt x="925195" y="55880"/>
                </a:lnTo>
                <a:lnTo>
                  <a:pt x="925195" y="58420"/>
                </a:lnTo>
                <a:lnTo>
                  <a:pt x="925195" y="62230"/>
                </a:lnTo>
                <a:lnTo>
                  <a:pt x="925195" y="63500"/>
                </a:lnTo>
                <a:lnTo>
                  <a:pt x="1040765" y="63500"/>
                </a:lnTo>
                <a:lnTo>
                  <a:pt x="1040765" y="66040"/>
                </a:lnTo>
                <a:lnTo>
                  <a:pt x="1040765" y="69850"/>
                </a:lnTo>
                <a:lnTo>
                  <a:pt x="1040765" y="72390"/>
                </a:lnTo>
                <a:lnTo>
                  <a:pt x="1214247" y="72390"/>
                </a:lnTo>
                <a:lnTo>
                  <a:pt x="1214247" y="74930"/>
                </a:lnTo>
                <a:lnTo>
                  <a:pt x="1214247" y="78740"/>
                </a:lnTo>
                <a:lnTo>
                  <a:pt x="1214247" y="83820"/>
                </a:lnTo>
                <a:lnTo>
                  <a:pt x="1329944" y="83820"/>
                </a:lnTo>
                <a:lnTo>
                  <a:pt x="1329944" y="86360"/>
                </a:lnTo>
                <a:lnTo>
                  <a:pt x="1445514" y="86360"/>
                </a:lnTo>
                <a:lnTo>
                  <a:pt x="1445514" y="87630"/>
                </a:lnTo>
                <a:lnTo>
                  <a:pt x="1445514" y="88900"/>
                </a:lnTo>
                <a:lnTo>
                  <a:pt x="1618996" y="88900"/>
                </a:lnTo>
                <a:lnTo>
                  <a:pt x="1618996" y="92710"/>
                </a:lnTo>
                <a:lnTo>
                  <a:pt x="1618996" y="95250"/>
                </a:lnTo>
                <a:lnTo>
                  <a:pt x="1734693" y="95250"/>
                </a:lnTo>
                <a:lnTo>
                  <a:pt x="1734693" y="97790"/>
                </a:lnTo>
                <a:lnTo>
                  <a:pt x="1734693" y="99060"/>
                </a:lnTo>
                <a:lnTo>
                  <a:pt x="1908048" y="99060"/>
                </a:lnTo>
                <a:lnTo>
                  <a:pt x="1908048" y="102870"/>
                </a:lnTo>
                <a:lnTo>
                  <a:pt x="2023745" y="102870"/>
                </a:lnTo>
                <a:lnTo>
                  <a:pt x="2023745" y="109220"/>
                </a:lnTo>
                <a:lnTo>
                  <a:pt x="2023745" y="113030"/>
                </a:lnTo>
                <a:lnTo>
                  <a:pt x="2255012" y="113030"/>
                </a:lnTo>
                <a:lnTo>
                  <a:pt x="2255012" y="115570"/>
                </a:lnTo>
                <a:lnTo>
                  <a:pt x="2255012" y="116840"/>
                </a:lnTo>
                <a:lnTo>
                  <a:pt x="2370709" y="116840"/>
                </a:lnTo>
                <a:lnTo>
                  <a:pt x="2370709" y="120650"/>
                </a:lnTo>
                <a:lnTo>
                  <a:pt x="2428494" y="120650"/>
                </a:lnTo>
                <a:lnTo>
                  <a:pt x="2428494" y="123190"/>
                </a:lnTo>
                <a:lnTo>
                  <a:pt x="2428494" y="125730"/>
                </a:lnTo>
                <a:lnTo>
                  <a:pt x="2486279" y="125730"/>
                </a:lnTo>
                <a:lnTo>
                  <a:pt x="2486279" y="129540"/>
                </a:lnTo>
                <a:lnTo>
                  <a:pt x="2544191" y="129540"/>
                </a:lnTo>
                <a:lnTo>
                  <a:pt x="2544191" y="133350"/>
                </a:lnTo>
                <a:lnTo>
                  <a:pt x="2544191" y="134620"/>
                </a:lnTo>
                <a:lnTo>
                  <a:pt x="2659761" y="134620"/>
                </a:lnTo>
                <a:lnTo>
                  <a:pt x="2659761" y="138430"/>
                </a:lnTo>
                <a:lnTo>
                  <a:pt x="2775458" y="138430"/>
                </a:lnTo>
                <a:lnTo>
                  <a:pt x="2775458" y="143510"/>
                </a:lnTo>
                <a:lnTo>
                  <a:pt x="2833243" y="143510"/>
                </a:lnTo>
                <a:lnTo>
                  <a:pt x="2833243" y="144780"/>
                </a:lnTo>
                <a:lnTo>
                  <a:pt x="2833243" y="148590"/>
                </a:lnTo>
                <a:lnTo>
                  <a:pt x="2891028" y="148590"/>
                </a:lnTo>
                <a:lnTo>
                  <a:pt x="2891028" y="153670"/>
                </a:lnTo>
                <a:lnTo>
                  <a:pt x="3006725" y="153670"/>
                </a:lnTo>
                <a:lnTo>
                  <a:pt x="3006725" y="158750"/>
                </a:lnTo>
                <a:lnTo>
                  <a:pt x="3064510" y="158750"/>
                </a:lnTo>
                <a:lnTo>
                  <a:pt x="3064510" y="163830"/>
                </a:lnTo>
                <a:lnTo>
                  <a:pt x="3122295" y="163830"/>
                </a:lnTo>
                <a:lnTo>
                  <a:pt x="3122295" y="168910"/>
                </a:lnTo>
                <a:lnTo>
                  <a:pt x="3295777" y="168910"/>
                </a:lnTo>
                <a:lnTo>
                  <a:pt x="3295777" y="175260"/>
                </a:lnTo>
                <a:lnTo>
                  <a:pt x="3469259" y="175260"/>
                </a:lnTo>
                <a:lnTo>
                  <a:pt x="3469259" y="180340"/>
                </a:lnTo>
                <a:lnTo>
                  <a:pt x="3584956" y="180340"/>
                </a:lnTo>
                <a:lnTo>
                  <a:pt x="3584956" y="186690"/>
                </a:lnTo>
                <a:lnTo>
                  <a:pt x="3700526" y="186690"/>
                </a:lnTo>
                <a:lnTo>
                  <a:pt x="3700526" y="200660"/>
                </a:lnTo>
                <a:lnTo>
                  <a:pt x="3758438" y="200660"/>
                </a:lnTo>
                <a:lnTo>
                  <a:pt x="3758438" y="207010"/>
                </a:lnTo>
                <a:lnTo>
                  <a:pt x="3931793" y="207010"/>
                </a:lnTo>
                <a:lnTo>
                  <a:pt x="3931793" y="214630"/>
                </a:lnTo>
                <a:lnTo>
                  <a:pt x="4047490" y="214630"/>
                </a:lnTo>
                <a:lnTo>
                  <a:pt x="4047490" y="222250"/>
                </a:lnTo>
                <a:lnTo>
                  <a:pt x="4336542" y="222250"/>
                </a:lnTo>
                <a:lnTo>
                  <a:pt x="4336542" y="231140"/>
                </a:lnTo>
                <a:lnTo>
                  <a:pt x="4683506" y="231140"/>
                </a:lnTo>
                <a:lnTo>
                  <a:pt x="4683506" y="242570"/>
                </a:lnTo>
                <a:lnTo>
                  <a:pt x="4914773" y="242570"/>
                </a:lnTo>
                <a:lnTo>
                  <a:pt x="4914773" y="257810"/>
                </a:lnTo>
                <a:lnTo>
                  <a:pt x="5493004" y="257810"/>
                </a:lnTo>
                <a:lnTo>
                  <a:pt x="5493004" y="290830"/>
                </a:lnTo>
                <a:lnTo>
                  <a:pt x="5666486" y="290830"/>
                </a:lnTo>
                <a:lnTo>
                  <a:pt x="5666486" y="330200"/>
                </a:lnTo>
                <a:lnTo>
                  <a:pt x="6591681" y="330200"/>
                </a:lnTo>
                <a:lnTo>
                  <a:pt x="6591681" y="290830"/>
                </a:lnTo>
                <a:lnTo>
                  <a:pt x="6591681" y="257810"/>
                </a:lnTo>
                <a:lnTo>
                  <a:pt x="6591681" y="148590"/>
                </a:lnTo>
                <a:lnTo>
                  <a:pt x="6591681" y="14478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8" name="bg object 28"/>
          <p:cNvSpPr/>
          <p:nvPr/>
        </p:nvSpPr>
        <p:spPr>
          <a:xfrm>
            <a:off x="5663692" y="888999"/>
            <a:ext cx="4568190" cy="148590"/>
          </a:xfrm>
          <a:custGeom>
            <a:avLst/>
            <a:gdLst/>
            <a:ahLst/>
            <a:cxnLst/>
            <a:rect l="l" t="t" r="r" b="b"/>
            <a:pathLst>
              <a:path w="4568190" h="148590">
                <a:moveTo>
                  <a:pt x="1387729" y="2540"/>
                </a:moveTo>
                <a:lnTo>
                  <a:pt x="1329944" y="2540"/>
                </a:lnTo>
                <a:lnTo>
                  <a:pt x="1329944" y="1270"/>
                </a:lnTo>
                <a:lnTo>
                  <a:pt x="1329944" y="0"/>
                </a:lnTo>
                <a:lnTo>
                  <a:pt x="0" y="0"/>
                </a:lnTo>
                <a:lnTo>
                  <a:pt x="0" y="1270"/>
                </a:lnTo>
                <a:lnTo>
                  <a:pt x="57912" y="1270"/>
                </a:lnTo>
                <a:lnTo>
                  <a:pt x="57912" y="2540"/>
                </a:lnTo>
                <a:lnTo>
                  <a:pt x="57912" y="5080"/>
                </a:lnTo>
                <a:lnTo>
                  <a:pt x="1387729" y="5080"/>
                </a:lnTo>
                <a:lnTo>
                  <a:pt x="1387729" y="2540"/>
                </a:lnTo>
                <a:close/>
              </a:path>
              <a:path w="4568190" h="148590">
                <a:moveTo>
                  <a:pt x="1850263" y="13970"/>
                </a:moveTo>
                <a:lnTo>
                  <a:pt x="1734693" y="13970"/>
                </a:lnTo>
                <a:lnTo>
                  <a:pt x="1734693" y="12700"/>
                </a:lnTo>
                <a:lnTo>
                  <a:pt x="1676908" y="12700"/>
                </a:lnTo>
                <a:lnTo>
                  <a:pt x="1676908" y="11938"/>
                </a:lnTo>
                <a:lnTo>
                  <a:pt x="1618996" y="11938"/>
                </a:lnTo>
                <a:lnTo>
                  <a:pt x="1618996" y="10668"/>
                </a:lnTo>
                <a:lnTo>
                  <a:pt x="1561211" y="10668"/>
                </a:lnTo>
                <a:lnTo>
                  <a:pt x="1561211" y="9398"/>
                </a:lnTo>
                <a:lnTo>
                  <a:pt x="1503426" y="9398"/>
                </a:lnTo>
                <a:lnTo>
                  <a:pt x="1503426" y="6858"/>
                </a:lnTo>
                <a:lnTo>
                  <a:pt x="1445514" y="6858"/>
                </a:lnTo>
                <a:lnTo>
                  <a:pt x="1445514" y="5588"/>
                </a:lnTo>
                <a:lnTo>
                  <a:pt x="115697" y="5588"/>
                </a:lnTo>
                <a:lnTo>
                  <a:pt x="115697" y="6858"/>
                </a:lnTo>
                <a:lnTo>
                  <a:pt x="173482" y="6858"/>
                </a:lnTo>
                <a:lnTo>
                  <a:pt x="173482" y="9398"/>
                </a:lnTo>
                <a:lnTo>
                  <a:pt x="231267" y="9398"/>
                </a:lnTo>
                <a:lnTo>
                  <a:pt x="231267" y="10668"/>
                </a:lnTo>
                <a:lnTo>
                  <a:pt x="289179" y="10668"/>
                </a:lnTo>
                <a:lnTo>
                  <a:pt x="289179" y="11938"/>
                </a:lnTo>
                <a:lnTo>
                  <a:pt x="346964" y="11938"/>
                </a:lnTo>
                <a:lnTo>
                  <a:pt x="346964" y="13208"/>
                </a:lnTo>
                <a:lnTo>
                  <a:pt x="404749" y="13208"/>
                </a:lnTo>
                <a:lnTo>
                  <a:pt x="404749" y="13970"/>
                </a:lnTo>
                <a:lnTo>
                  <a:pt x="404749" y="15240"/>
                </a:lnTo>
                <a:lnTo>
                  <a:pt x="1850263" y="15240"/>
                </a:lnTo>
                <a:lnTo>
                  <a:pt x="1850263" y="13970"/>
                </a:lnTo>
                <a:close/>
              </a:path>
              <a:path w="4568190" h="148590">
                <a:moveTo>
                  <a:pt x="2370709" y="35560"/>
                </a:moveTo>
                <a:lnTo>
                  <a:pt x="2312924" y="35560"/>
                </a:lnTo>
                <a:lnTo>
                  <a:pt x="2312924" y="34290"/>
                </a:lnTo>
                <a:lnTo>
                  <a:pt x="2255012" y="34290"/>
                </a:lnTo>
                <a:lnTo>
                  <a:pt x="2255012" y="33020"/>
                </a:lnTo>
                <a:lnTo>
                  <a:pt x="2197227" y="33020"/>
                </a:lnTo>
                <a:lnTo>
                  <a:pt x="2197227" y="30480"/>
                </a:lnTo>
                <a:lnTo>
                  <a:pt x="2197227" y="26670"/>
                </a:lnTo>
                <a:lnTo>
                  <a:pt x="2139442" y="26670"/>
                </a:lnTo>
                <a:lnTo>
                  <a:pt x="2139442" y="25400"/>
                </a:lnTo>
                <a:lnTo>
                  <a:pt x="2139442" y="22860"/>
                </a:lnTo>
                <a:lnTo>
                  <a:pt x="2139442" y="20320"/>
                </a:lnTo>
                <a:lnTo>
                  <a:pt x="2081657" y="20320"/>
                </a:lnTo>
                <a:lnTo>
                  <a:pt x="2081657" y="17780"/>
                </a:lnTo>
                <a:lnTo>
                  <a:pt x="1965960" y="17780"/>
                </a:lnTo>
                <a:lnTo>
                  <a:pt x="1965960" y="16510"/>
                </a:lnTo>
                <a:lnTo>
                  <a:pt x="1908175" y="16510"/>
                </a:lnTo>
                <a:lnTo>
                  <a:pt x="1908175" y="15748"/>
                </a:lnTo>
                <a:lnTo>
                  <a:pt x="462661" y="15748"/>
                </a:lnTo>
                <a:lnTo>
                  <a:pt x="462661" y="17018"/>
                </a:lnTo>
                <a:lnTo>
                  <a:pt x="520446" y="17018"/>
                </a:lnTo>
                <a:lnTo>
                  <a:pt x="520446" y="17780"/>
                </a:lnTo>
                <a:lnTo>
                  <a:pt x="520446" y="20320"/>
                </a:lnTo>
                <a:lnTo>
                  <a:pt x="578231" y="20320"/>
                </a:lnTo>
                <a:lnTo>
                  <a:pt x="578231" y="22860"/>
                </a:lnTo>
                <a:lnTo>
                  <a:pt x="693928" y="22860"/>
                </a:lnTo>
                <a:lnTo>
                  <a:pt x="693928" y="25400"/>
                </a:lnTo>
                <a:lnTo>
                  <a:pt x="809498" y="25400"/>
                </a:lnTo>
                <a:lnTo>
                  <a:pt x="809498" y="26670"/>
                </a:lnTo>
                <a:lnTo>
                  <a:pt x="867410" y="26670"/>
                </a:lnTo>
                <a:lnTo>
                  <a:pt x="867410" y="30480"/>
                </a:lnTo>
                <a:lnTo>
                  <a:pt x="925182" y="30480"/>
                </a:lnTo>
                <a:lnTo>
                  <a:pt x="925182" y="33020"/>
                </a:lnTo>
                <a:lnTo>
                  <a:pt x="925182" y="34290"/>
                </a:lnTo>
                <a:lnTo>
                  <a:pt x="982980" y="34290"/>
                </a:lnTo>
                <a:lnTo>
                  <a:pt x="982980" y="35560"/>
                </a:lnTo>
                <a:lnTo>
                  <a:pt x="982980" y="36830"/>
                </a:lnTo>
                <a:lnTo>
                  <a:pt x="2370709" y="36830"/>
                </a:lnTo>
                <a:lnTo>
                  <a:pt x="2370709" y="35560"/>
                </a:lnTo>
                <a:close/>
              </a:path>
              <a:path w="4568190" h="148590">
                <a:moveTo>
                  <a:pt x="2659761" y="55880"/>
                </a:moveTo>
                <a:lnTo>
                  <a:pt x="2601976" y="55880"/>
                </a:lnTo>
                <a:lnTo>
                  <a:pt x="2601976" y="54610"/>
                </a:lnTo>
                <a:lnTo>
                  <a:pt x="2601976" y="49530"/>
                </a:lnTo>
                <a:lnTo>
                  <a:pt x="2601976" y="48260"/>
                </a:lnTo>
                <a:lnTo>
                  <a:pt x="2601976" y="46990"/>
                </a:lnTo>
                <a:lnTo>
                  <a:pt x="2544191" y="46990"/>
                </a:lnTo>
                <a:lnTo>
                  <a:pt x="2544191" y="45720"/>
                </a:lnTo>
                <a:lnTo>
                  <a:pt x="2544191" y="44450"/>
                </a:lnTo>
                <a:lnTo>
                  <a:pt x="2486406" y="44450"/>
                </a:lnTo>
                <a:lnTo>
                  <a:pt x="2486406" y="43180"/>
                </a:lnTo>
                <a:lnTo>
                  <a:pt x="2486406" y="38100"/>
                </a:lnTo>
                <a:lnTo>
                  <a:pt x="2428494" y="38100"/>
                </a:lnTo>
                <a:lnTo>
                  <a:pt x="2428494" y="37338"/>
                </a:lnTo>
                <a:lnTo>
                  <a:pt x="1040765" y="37338"/>
                </a:lnTo>
                <a:lnTo>
                  <a:pt x="1040765" y="38608"/>
                </a:lnTo>
                <a:lnTo>
                  <a:pt x="1098677" y="38608"/>
                </a:lnTo>
                <a:lnTo>
                  <a:pt x="1098677" y="43180"/>
                </a:lnTo>
                <a:lnTo>
                  <a:pt x="1156462" y="43180"/>
                </a:lnTo>
                <a:lnTo>
                  <a:pt x="1156462" y="44450"/>
                </a:lnTo>
                <a:lnTo>
                  <a:pt x="1156462" y="45720"/>
                </a:lnTo>
                <a:lnTo>
                  <a:pt x="1214247" y="45720"/>
                </a:lnTo>
                <a:lnTo>
                  <a:pt x="1214247" y="46990"/>
                </a:lnTo>
                <a:lnTo>
                  <a:pt x="1214247" y="48260"/>
                </a:lnTo>
                <a:lnTo>
                  <a:pt x="1272159" y="48260"/>
                </a:lnTo>
                <a:lnTo>
                  <a:pt x="1272159" y="49530"/>
                </a:lnTo>
                <a:lnTo>
                  <a:pt x="1329944" y="49530"/>
                </a:lnTo>
                <a:lnTo>
                  <a:pt x="1329944" y="54610"/>
                </a:lnTo>
                <a:lnTo>
                  <a:pt x="1387729" y="54610"/>
                </a:lnTo>
                <a:lnTo>
                  <a:pt x="1387729" y="55880"/>
                </a:lnTo>
                <a:lnTo>
                  <a:pt x="1387729" y="57150"/>
                </a:lnTo>
                <a:lnTo>
                  <a:pt x="2659761" y="57150"/>
                </a:lnTo>
                <a:lnTo>
                  <a:pt x="2659761" y="55880"/>
                </a:lnTo>
                <a:close/>
              </a:path>
              <a:path w="4568190" h="148590">
                <a:moveTo>
                  <a:pt x="4567936" y="139700"/>
                </a:moveTo>
                <a:lnTo>
                  <a:pt x="4394454" y="139700"/>
                </a:lnTo>
                <a:lnTo>
                  <a:pt x="4394454" y="138430"/>
                </a:lnTo>
                <a:lnTo>
                  <a:pt x="4394454" y="135890"/>
                </a:lnTo>
                <a:lnTo>
                  <a:pt x="4394454" y="133350"/>
                </a:lnTo>
                <a:lnTo>
                  <a:pt x="4278884" y="133350"/>
                </a:lnTo>
                <a:lnTo>
                  <a:pt x="4278884" y="132080"/>
                </a:lnTo>
                <a:lnTo>
                  <a:pt x="4278884" y="128270"/>
                </a:lnTo>
                <a:lnTo>
                  <a:pt x="4278884" y="127000"/>
                </a:lnTo>
                <a:lnTo>
                  <a:pt x="4220972" y="127000"/>
                </a:lnTo>
                <a:lnTo>
                  <a:pt x="4220972" y="120650"/>
                </a:lnTo>
                <a:lnTo>
                  <a:pt x="4163187" y="120650"/>
                </a:lnTo>
                <a:lnTo>
                  <a:pt x="4163187" y="119380"/>
                </a:lnTo>
                <a:lnTo>
                  <a:pt x="4163187" y="118110"/>
                </a:lnTo>
                <a:lnTo>
                  <a:pt x="4163187" y="114300"/>
                </a:lnTo>
                <a:lnTo>
                  <a:pt x="4105402" y="114300"/>
                </a:lnTo>
                <a:lnTo>
                  <a:pt x="4105402" y="111760"/>
                </a:lnTo>
                <a:lnTo>
                  <a:pt x="3989705" y="111760"/>
                </a:lnTo>
                <a:lnTo>
                  <a:pt x="3989705" y="110490"/>
                </a:lnTo>
                <a:lnTo>
                  <a:pt x="3874135" y="110490"/>
                </a:lnTo>
                <a:lnTo>
                  <a:pt x="3874135" y="106680"/>
                </a:lnTo>
                <a:lnTo>
                  <a:pt x="3816223" y="106680"/>
                </a:lnTo>
                <a:lnTo>
                  <a:pt x="3816223" y="102870"/>
                </a:lnTo>
                <a:lnTo>
                  <a:pt x="3816223" y="100330"/>
                </a:lnTo>
                <a:lnTo>
                  <a:pt x="3758438" y="100330"/>
                </a:lnTo>
                <a:lnTo>
                  <a:pt x="3758438" y="99060"/>
                </a:lnTo>
                <a:lnTo>
                  <a:pt x="3700653" y="99060"/>
                </a:lnTo>
                <a:lnTo>
                  <a:pt x="3700653" y="96520"/>
                </a:lnTo>
                <a:lnTo>
                  <a:pt x="3700653" y="95250"/>
                </a:lnTo>
                <a:lnTo>
                  <a:pt x="3642741" y="95250"/>
                </a:lnTo>
                <a:lnTo>
                  <a:pt x="3642741" y="92710"/>
                </a:lnTo>
                <a:lnTo>
                  <a:pt x="3642741" y="91440"/>
                </a:lnTo>
                <a:lnTo>
                  <a:pt x="3642741" y="90170"/>
                </a:lnTo>
                <a:lnTo>
                  <a:pt x="3584956" y="90170"/>
                </a:lnTo>
                <a:lnTo>
                  <a:pt x="3584956" y="86360"/>
                </a:lnTo>
                <a:lnTo>
                  <a:pt x="3411474" y="86360"/>
                </a:lnTo>
                <a:lnTo>
                  <a:pt x="3411474" y="83820"/>
                </a:lnTo>
                <a:lnTo>
                  <a:pt x="3353689" y="83820"/>
                </a:lnTo>
                <a:lnTo>
                  <a:pt x="3353689" y="81280"/>
                </a:lnTo>
                <a:lnTo>
                  <a:pt x="3295904" y="81280"/>
                </a:lnTo>
                <a:lnTo>
                  <a:pt x="3295904" y="76200"/>
                </a:lnTo>
                <a:lnTo>
                  <a:pt x="3180207" y="76200"/>
                </a:lnTo>
                <a:lnTo>
                  <a:pt x="3180207" y="74930"/>
                </a:lnTo>
                <a:lnTo>
                  <a:pt x="3180207" y="72390"/>
                </a:lnTo>
                <a:lnTo>
                  <a:pt x="3064510" y="72390"/>
                </a:lnTo>
                <a:lnTo>
                  <a:pt x="3064510" y="71120"/>
                </a:lnTo>
                <a:lnTo>
                  <a:pt x="3006725" y="71120"/>
                </a:lnTo>
                <a:lnTo>
                  <a:pt x="3006725" y="69850"/>
                </a:lnTo>
                <a:lnTo>
                  <a:pt x="2948940" y="69850"/>
                </a:lnTo>
                <a:lnTo>
                  <a:pt x="2948940" y="68580"/>
                </a:lnTo>
                <a:lnTo>
                  <a:pt x="2948940" y="67310"/>
                </a:lnTo>
                <a:lnTo>
                  <a:pt x="2833243" y="67310"/>
                </a:lnTo>
                <a:lnTo>
                  <a:pt x="2833243" y="66040"/>
                </a:lnTo>
                <a:lnTo>
                  <a:pt x="2833243" y="64770"/>
                </a:lnTo>
                <a:lnTo>
                  <a:pt x="2775458" y="64770"/>
                </a:lnTo>
                <a:lnTo>
                  <a:pt x="2775458" y="62230"/>
                </a:lnTo>
                <a:lnTo>
                  <a:pt x="2775458" y="60960"/>
                </a:lnTo>
                <a:lnTo>
                  <a:pt x="2775458" y="58420"/>
                </a:lnTo>
                <a:lnTo>
                  <a:pt x="2717673" y="58420"/>
                </a:lnTo>
                <a:lnTo>
                  <a:pt x="2717673" y="57658"/>
                </a:lnTo>
                <a:lnTo>
                  <a:pt x="1445514" y="57658"/>
                </a:lnTo>
                <a:lnTo>
                  <a:pt x="1445514" y="58928"/>
                </a:lnTo>
                <a:lnTo>
                  <a:pt x="1503426" y="58928"/>
                </a:lnTo>
                <a:lnTo>
                  <a:pt x="1503426" y="60960"/>
                </a:lnTo>
                <a:lnTo>
                  <a:pt x="1561211" y="60960"/>
                </a:lnTo>
                <a:lnTo>
                  <a:pt x="1561211" y="62230"/>
                </a:lnTo>
                <a:lnTo>
                  <a:pt x="1618996" y="62230"/>
                </a:lnTo>
                <a:lnTo>
                  <a:pt x="1618996" y="64770"/>
                </a:lnTo>
                <a:lnTo>
                  <a:pt x="1676908" y="64770"/>
                </a:lnTo>
                <a:lnTo>
                  <a:pt x="1676908" y="66040"/>
                </a:lnTo>
                <a:lnTo>
                  <a:pt x="1734693" y="66040"/>
                </a:lnTo>
                <a:lnTo>
                  <a:pt x="1734693" y="67310"/>
                </a:lnTo>
                <a:lnTo>
                  <a:pt x="1850263" y="67310"/>
                </a:lnTo>
                <a:lnTo>
                  <a:pt x="1850263" y="68580"/>
                </a:lnTo>
                <a:lnTo>
                  <a:pt x="1908175" y="68580"/>
                </a:lnTo>
                <a:lnTo>
                  <a:pt x="1908175" y="69850"/>
                </a:lnTo>
                <a:lnTo>
                  <a:pt x="1965960" y="69850"/>
                </a:lnTo>
                <a:lnTo>
                  <a:pt x="1965960" y="71120"/>
                </a:lnTo>
                <a:lnTo>
                  <a:pt x="1965960" y="72390"/>
                </a:lnTo>
                <a:lnTo>
                  <a:pt x="2081657" y="72390"/>
                </a:lnTo>
                <a:lnTo>
                  <a:pt x="2081657" y="74930"/>
                </a:lnTo>
                <a:lnTo>
                  <a:pt x="2139442" y="74930"/>
                </a:lnTo>
                <a:lnTo>
                  <a:pt x="2139442" y="76200"/>
                </a:lnTo>
                <a:lnTo>
                  <a:pt x="2139442" y="81280"/>
                </a:lnTo>
                <a:lnTo>
                  <a:pt x="2139442" y="83820"/>
                </a:lnTo>
                <a:lnTo>
                  <a:pt x="2197227" y="83820"/>
                </a:lnTo>
                <a:lnTo>
                  <a:pt x="2197227" y="86360"/>
                </a:lnTo>
                <a:lnTo>
                  <a:pt x="2197227" y="90170"/>
                </a:lnTo>
                <a:lnTo>
                  <a:pt x="2255012" y="90170"/>
                </a:lnTo>
                <a:lnTo>
                  <a:pt x="2255012" y="91440"/>
                </a:lnTo>
                <a:lnTo>
                  <a:pt x="2312924" y="91440"/>
                </a:lnTo>
                <a:lnTo>
                  <a:pt x="2312924" y="92710"/>
                </a:lnTo>
                <a:lnTo>
                  <a:pt x="2370709" y="92710"/>
                </a:lnTo>
                <a:lnTo>
                  <a:pt x="2370709" y="95250"/>
                </a:lnTo>
                <a:lnTo>
                  <a:pt x="2428494" y="95250"/>
                </a:lnTo>
                <a:lnTo>
                  <a:pt x="2428494" y="96520"/>
                </a:lnTo>
                <a:lnTo>
                  <a:pt x="2486406" y="96520"/>
                </a:lnTo>
                <a:lnTo>
                  <a:pt x="2486406" y="99060"/>
                </a:lnTo>
                <a:lnTo>
                  <a:pt x="2486406" y="100330"/>
                </a:lnTo>
                <a:lnTo>
                  <a:pt x="2486406" y="102870"/>
                </a:lnTo>
                <a:lnTo>
                  <a:pt x="2544191" y="102870"/>
                </a:lnTo>
                <a:lnTo>
                  <a:pt x="2544191" y="106680"/>
                </a:lnTo>
                <a:lnTo>
                  <a:pt x="2601976" y="106680"/>
                </a:lnTo>
                <a:lnTo>
                  <a:pt x="2601976" y="110490"/>
                </a:lnTo>
                <a:lnTo>
                  <a:pt x="2601976" y="111760"/>
                </a:lnTo>
                <a:lnTo>
                  <a:pt x="2601976" y="114300"/>
                </a:lnTo>
                <a:lnTo>
                  <a:pt x="2601976" y="118110"/>
                </a:lnTo>
                <a:lnTo>
                  <a:pt x="2659761" y="118110"/>
                </a:lnTo>
                <a:lnTo>
                  <a:pt x="2659761" y="119380"/>
                </a:lnTo>
                <a:lnTo>
                  <a:pt x="2717673" y="119380"/>
                </a:lnTo>
                <a:lnTo>
                  <a:pt x="2717673" y="120650"/>
                </a:lnTo>
                <a:lnTo>
                  <a:pt x="2775458" y="120650"/>
                </a:lnTo>
                <a:lnTo>
                  <a:pt x="2775458" y="127000"/>
                </a:lnTo>
                <a:lnTo>
                  <a:pt x="2775458" y="128270"/>
                </a:lnTo>
                <a:lnTo>
                  <a:pt x="2833243" y="128270"/>
                </a:lnTo>
                <a:lnTo>
                  <a:pt x="2833243" y="132080"/>
                </a:lnTo>
                <a:lnTo>
                  <a:pt x="2948940" y="132080"/>
                </a:lnTo>
                <a:lnTo>
                  <a:pt x="2948940" y="133350"/>
                </a:lnTo>
                <a:lnTo>
                  <a:pt x="3006725" y="133350"/>
                </a:lnTo>
                <a:lnTo>
                  <a:pt x="3006725" y="135890"/>
                </a:lnTo>
                <a:lnTo>
                  <a:pt x="3064510" y="135890"/>
                </a:lnTo>
                <a:lnTo>
                  <a:pt x="3064510" y="138430"/>
                </a:lnTo>
                <a:lnTo>
                  <a:pt x="3180207" y="138430"/>
                </a:lnTo>
                <a:lnTo>
                  <a:pt x="3180207" y="139700"/>
                </a:lnTo>
                <a:lnTo>
                  <a:pt x="3180207" y="142240"/>
                </a:lnTo>
                <a:lnTo>
                  <a:pt x="3295904" y="142240"/>
                </a:lnTo>
                <a:lnTo>
                  <a:pt x="3295904" y="147320"/>
                </a:lnTo>
                <a:lnTo>
                  <a:pt x="3353689" y="147320"/>
                </a:lnTo>
                <a:lnTo>
                  <a:pt x="3353689" y="148590"/>
                </a:lnTo>
                <a:lnTo>
                  <a:pt x="4567936" y="148590"/>
                </a:lnTo>
                <a:lnTo>
                  <a:pt x="4567936" y="147320"/>
                </a:lnTo>
                <a:lnTo>
                  <a:pt x="4567936" y="142240"/>
                </a:lnTo>
                <a:lnTo>
                  <a:pt x="4567936" y="13970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9" name="bg object 29"/>
          <p:cNvSpPr/>
          <p:nvPr/>
        </p:nvSpPr>
        <p:spPr>
          <a:xfrm>
            <a:off x="2772664" y="768349"/>
            <a:ext cx="4221480" cy="121920"/>
          </a:xfrm>
          <a:custGeom>
            <a:avLst/>
            <a:gdLst/>
            <a:ahLst/>
            <a:cxnLst/>
            <a:rect l="l" t="t" r="r" b="b"/>
            <a:pathLst>
              <a:path w="4221480" h="121919">
                <a:moveTo>
                  <a:pt x="1040765" y="7620"/>
                </a:moveTo>
                <a:lnTo>
                  <a:pt x="982980" y="7620"/>
                </a:lnTo>
                <a:lnTo>
                  <a:pt x="982980" y="6350"/>
                </a:lnTo>
                <a:lnTo>
                  <a:pt x="982980" y="5080"/>
                </a:lnTo>
                <a:lnTo>
                  <a:pt x="925195" y="5080"/>
                </a:lnTo>
                <a:lnTo>
                  <a:pt x="925195" y="2540"/>
                </a:lnTo>
                <a:lnTo>
                  <a:pt x="925195" y="1270"/>
                </a:lnTo>
                <a:lnTo>
                  <a:pt x="867283" y="1270"/>
                </a:lnTo>
                <a:lnTo>
                  <a:pt x="867283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57785" y="2540"/>
                </a:lnTo>
                <a:lnTo>
                  <a:pt x="57785" y="5080"/>
                </a:lnTo>
                <a:lnTo>
                  <a:pt x="57785" y="6350"/>
                </a:lnTo>
                <a:lnTo>
                  <a:pt x="115570" y="6350"/>
                </a:lnTo>
                <a:lnTo>
                  <a:pt x="115570" y="7620"/>
                </a:lnTo>
                <a:lnTo>
                  <a:pt x="115570" y="10160"/>
                </a:lnTo>
                <a:lnTo>
                  <a:pt x="1040765" y="10160"/>
                </a:lnTo>
                <a:lnTo>
                  <a:pt x="1040765" y="7620"/>
                </a:lnTo>
                <a:close/>
              </a:path>
              <a:path w="4221480" h="121919">
                <a:moveTo>
                  <a:pt x="1676781" y="30480"/>
                </a:moveTo>
                <a:lnTo>
                  <a:pt x="1618996" y="30480"/>
                </a:lnTo>
                <a:lnTo>
                  <a:pt x="1618996" y="26670"/>
                </a:lnTo>
                <a:lnTo>
                  <a:pt x="1561211" y="26670"/>
                </a:lnTo>
                <a:lnTo>
                  <a:pt x="1561211" y="25400"/>
                </a:lnTo>
                <a:lnTo>
                  <a:pt x="1561211" y="24130"/>
                </a:lnTo>
                <a:lnTo>
                  <a:pt x="1503299" y="24130"/>
                </a:lnTo>
                <a:lnTo>
                  <a:pt x="1503299" y="22860"/>
                </a:lnTo>
                <a:lnTo>
                  <a:pt x="1445514" y="22860"/>
                </a:lnTo>
                <a:lnTo>
                  <a:pt x="1445514" y="21590"/>
                </a:lnTo>
                <a:lnTo>
                  <a:pt x="1445514" y="19050"/>
                </a:lnTo>
                <a:lnTo>
                  <a:pt x="1387729" y="19050"/>
                </a:lnTo>
                <a:lnTo>
                  <a:pt x="1387729" y="17780"/>
                </a:lnTo>
                <a:lnTo>
                  <a:pt x="1387729" y="16510"/>
                </a:lnTo>
                <a:lnTo>
                  <a:pt x="1329944" y="16510"/>
                </a:lnTo>
                <a:lnTo>
                  <a:pt x="1329944" y="15240"/>
                </a:lnTo>
                <a:lnTo>
                  <a:pt x="1272032" y="15240"/>
                </a:lnTo>
                <a:lnTo>
                  <a:pt x="1272032" y="13970"/>
                </a:lnTo>
                <a:lnTo>
                  <a:pt x="1272032" y="12700"/>
                </a:lnTo>
                <a:lnTo>
                  <a:pt x="1214247" y="12700"/>
                </a:lnTo>
                <a:lnTo>
                  <a:pt x="1214247" y="11430"/>
                </a:lnTo>
                <a:lnTo>
                  <a:pt x="1098550" y="11430"/>
                </a:lnTo>
                <a:lnTo>
                  <a:pt x="1098550" y="10668"/>
                </a:lnTo>
                <a:lnTo>
                  <a:pt x="289052" y="10668"/>
                </a:lnTo>
                <a:lnTo>
                  <a:pt x="289052" y="11938"/>
                </a:lnTo>
                <a:lnTo>
                  <a:pt x="404749" y="11938"/>
                </a:lnTo>
                <a:lnTo>
                  <a:pt x="404749" y="12700"/>
                </a:lnTo>
                <a:lnTo>
                  <a:pt x="404749" y="13970"/>
                </a:lnTo>
                <a:lnTo>
                  <a:pt x="520319" y="13970"/>
                </a:lnTo>
                <a:lnTo>
                  <a:pt x="520319" y="15240"/>
                </a:lnTo>
                <a:lnTo>
                  <a:pt x="578231" y="15240"/>
                </a:lnTo>
                <a:lnTo>
                  <a:pt x="578231" y="16510"/>
                </a:lnTo>
                <a:lnTo>
                  <a:pt x="578231" y="17780"/>
                </a:lnTo>
                <a:lnTo>
                  <a:pt x="636016" y="17780"/>
                </a:lnTo>
                <a:lnTo>
                  <a:pt x="636016" y="19050"/>
                </a:lnTo>
                <a:lnTo>
                  <a:pt x="693801" y="19050"/>
                </a:lnTo>
                <a:lnTo>
                  <a:pt x="693801" y="21590"/>
                </a:lnTo>
                <a:lnTo>
                  <a:pt x="751713" y="21590"/>
                </a:lnTo>
                <a:lnTo>
                  <a:pt x="751713" y="22860"/>
                </a:lnTo>
                <a:lnTo>
                  <a:pt x="809498" y="22860"/>
                </a:lnTo>
                <a:lnTo>
                  <a:pt x="809498" y="24130"/>
                </a:lnTo>
                <a:lnTo>
                  <a:pt x="809498" y="25400"/>
                </a:lnTo>
                <a:lnTo>
                  <a:pt x="925195" y="25400"/>
                </a:lnTo>
                <a:lnTo>
                  <a:pt x="925195" y="26670"/>
                </a:lnTo>
                <a:lnTo>
                  <a:pt x="925195" y="30480"/>
                </a:lnTo>
                <a:lnTo>
                  <a:pt x="925195" y="31750"/>
                </a:lnTo>
                <a:lnTo>
                  <a:pt x="982980" y="31750"/>
                </a:lnTo>
                <a:lnTo>
                  <a:pt x="982980" y="35560"/>
                </a:lnTo>
                <a:lnTo>
                  <a:pt x="1676781" y="35560"/>
                </a:lnTo>
                <a:lnTo>
                  <a:pt x="1676781" y="31750"/>
                </a:lnTo>
                <a:lnTo>
                  <a:pt x="1676781" y="30480"/>
                </a:lnTo>
                <a:close/>
              </a:path>
              <a:path w="4221480" h="121919">
                <a:moveTo>
                  <a:pt x="1792478" y="36830"/>
                </a:moveTo>
                <a:lnTo>
                  <a:pt x="1734693" y="36830"/>
                </a:lnTo>
                <a:lnTo>
                  <a:pt x="1734693" y="36068"/>
                </a:lnTo>
                <a:lnTo>
                  <a:pt x="1040765" y="36068"/>
                </a:lnTo>
                <a:lnTo>
                  <a:pt x="1040765" y="37338"/>
                </a:lnTo>
                <a:lnTo>
                  <a:pt x="1098550" y="37338"/>
                </a:lnTo>
                <a:lnTo>
                  <a:pt x="1098550" y="38100"/>
                </a:lnTo>
                <a:lnTo>
                  <a:pt x="1156462" y="38100"/>
                </a:lnTo>
                <a:lnTo>
                  <a:pt x="1156462" y="39370"/>
                </a:lnTo>
                <a:lnTo>
                  <a:pt x="1214247" y="39370"/>
                </a:lnTo>
                <a:lnTo>
                  <a:pt x="1214247" y="41910"/>
                </a:lnTo>
                <a:lnTo>
                  <a:pt x="1792478" y="41910"/>
                </a:lnTo>
                <a:lnTo>
                  <a:pt x="1792478" y="39370"/>
                </a:lnTo>
                <a:lnTo>
                  <a:pt x="1792478" y="38100"/>
                </a:lnTo>
                <a:lnTo>
                  <a:pt x="1792478" y="36830"/>
                </a:lnTo>
                <a:close/>
              </a:path>
              <a:path w="4221480" h="121919">
                <a:moveTo>
                  <a:pt x="2948940" y="80010"/>
                </a:moveTo>
                <a:lnTo>
                  <a:pt x="2891028" y="80010"/>
                </a:lnTo>
                <a:lnTo>
                  <a:pt x="2891028" y="78740"/>
                </a:lnTo>
                <a:lnTo>
                  <a:pt x="2891028" y="76200"/>
                </a:lnTo>
                <a:lnTo>
                  <a:pt x="2833243" y="76200"/>
                </a:lnTo>
                <a:lnTo>
                  <a:pt x="2833243" y="73660"/>
                </a:lnTo>
                <a:lnTo>
                  <a:pt x="2775458" y="73660"/>
                </a:lnTo>
                <a:lnTo>
                  <a:pt x="2775458" y="72390"/>
                </a:lnTo>
                <a:lnTo>
                  <a:pt x="2717546" y="72390"/>
                </a:lnTo>
                <a:lnTo>
                  <a:pt x="2717546" y="69850"/>
                </a:lnTo>
                <a:lnTo>
                  <a:pt x="2659761" y="69850"/>
                </a:lnTo>
                <a:lnTo>
                  <a:pt x="2659761" y="68580"/>
                </a:lnTo>
                <a:lnTo>
                  <a:pt x="2659761" y="67310"/>
                </a:lnTo>
                <a:lnTo>
                  <a:pt x="2601976" y="67310"/>
                </a:lnTo>
                <a:lnTo>
                  <a:pt x="2601976" y="64770"/>
                </a:lnTo>
                <a:lnTo>
                  <a:pt x="2544191" y="64770"/>
                </a:lnTo>
                <a:lnTo>
                  <a:pt x="2544191" y="63500"/>
                </a:lnTo>
                <a:lnTo>
                  <a:pt x="2486279" y="63500"/>
                </a:lnTo>
                <a:lnTo>
                  <a:pt x="2486279" y="62230"/>
                </a:lnTo>
                <a:lnTo>
                  <a:pt x="2428494" y="62230"/>
                </a:lnTo>
                <a:lnTo>
                  <a:pt x="2428494" y="59690"/>
                </a:lnTo>
                <a:lnTo>
                  <a:pt x="2370709" y="59690"/>
                </a:lnTo>
                <a:lnTo>
                  <a:pt x="2370709" y="58420"/>
                </a:lnTo>
                <a:lnTo>
                  <a:pt x="2370709" y="57150"/>
                </a:lnTo>
                <a:lnTo>
                  <a:pt x="2312797" y="57150"/>
                </a:lnTo>
                <a:lnTo>
                  <a:pt x="2312797" y="54610"/>
                </a:lnTo>
                <a:lnTo>
                  <a:pt x="2197227" y="54610"/>
                </a:lnTo>
                <a:lnTo>
                  <a:pt x="2197227" y="52070"/>
                </a:lnTo>
                <a:lnTo>
                  <a:pt x="2197227" y="50800"/>
                </a:lnTo>
                <a:lnTo>
                  <a:pt x="2139442" y="50800"/>
                </a:lnTo>
                <a:lnTo>
                  <a:pt x="2139442" y="49530"/>
                </a:lnTo>
                <a:lnTo>
                  <a:pt x="2139442" y="48260"/>
                </a:lnTo>
                <a:lnTo>
                  <a:pt x="2081530" y="48260"/>
                </a:lnTo>
                <a:lnTo>
                  <a:pt x="2081530" y="46990"/>
                </a:lnTo>
                <a:lnTo>
                  <a:pt x="2023745" y="46990"/>
                </a:lnTo>
                <a:lnTo>
                  <a:pt x="2023745" y="45720"/>
                </a:lnTo>
                <a:lnTo>
                  <a:pt x="1965960" y="45720"/>
                </a:lnTo>
                <a:lnTo>
                  <a:pt x="1965960" y="44958"/>
                </a:lnTo>
                <a:lnTo>
                  <a:pt x="1850263" y="44958"/>
                </a:lnTo>
                <a:lnTo>
                  <a:pt x="1850263" y="42418"/>
                </a:lnTo>
                <a:lnTo>
                  <a:pt x="1272032" y="42418"/>
                </a:lnTo>
                <a:lnTo>
                  <a:pt x="1272032" y="44958"/>
                </a:lnTo>
                <a:lnTo>
                  <a:pt x="1329944" y="44958"/>
                </a:lnTo>
                <a:lnTo>
                  <a:pt x="1329944" y="46228"/>
                </a:lnTo>
                <a:lnTo>
                  <a:pt x="1387729" y="46228"/>
                </a:lnTo>
                <a:lnTo>
                  <a:pt x="1387729" y="46990"/>
                </a:lnTo>
                <a:lnTo>
                  <a:pt x="1387729" y="48260"/>
                </a:lnTo>
                <a:lnTo>
                  <a:pt x="1387729" y="49530"/>
                </a:lnTo>
                <a:lnTo>
                  <a:pt x="1445514" y="49530"/>
                </a:lnTo>
                <a:lnTo>
                  <a:pt x="1445514" y="50800"/>
                </a:lnTo>
                <a:lnTo>
                  <a:pt x="1445514" y="52070"/>
                </a:lnTo>
                <a:lnTo>
                  <a:pt x="1503299" y="52070"/>
                </a:lnTo>
                <a:lnTo>
                  <a:pt x="1503299" y="54610"/>
                </a:lnTo>
                <a:lnTo>
                  <a:pt x="1561211" y="54610"/>
                </a:lnTo>
                <a:lnTo>
                  <a:pt x="1561211" y="57150"/>
                </a:lnTo>
                <a:lnTo>
                  <a:pt x="1561211" y="58420"/>
                </a:lnTo>
                <a:lnTo>
                  <a:pt x="1618996" y="58420"/>
                </a:lnTo>
                <a:lnTo>
                  <a:pt x="1618996" y="59690"/>
                </a:lnTo>
                <a:lnTo>
                  <a:pt x="1618996" y="62230"/>
                </a:lnTo>
                <a:lnTo>
                  <a:pt x="1676781" y="62230"/>
                </a:lnTo>
                <a:lnTo>
                  <a:pt x="1676781" y="63500"/>
                </a:lnTo>
                <a:lnTo>
                  <a:pt x="1676781" y="64770"/>
                </a:lnTo>
                <a:lnTo>
                  <a:pt x="1676781" y="67310"/>
                </a:lnTo>
                <a:lnTo>
                  <a:pt x="1676781" y="68580"/>
                </a:lnTo>
                <a:lnTo>
                  <a:pt x="1734693" y="68580"/>
                </a:lnTo>
                <a:lnTo>
                  <a:pt x="1734693" y="69850"/>
                </a:lnTo>
                <a:lnTo>
                  <a:pt x="1792478" y="69850"/>
                </a:lnTo>
                <a:lnTo>
                  <a:pt x="1792478" y="72390"/>
                </a:lnTo>
                <a:lnTo>
                  <a:pt x="1792478" y="73660"/>
                </a:lnTo>
                <a:lnTo>
                  <a:pt x="1792478" y="76200"/>
                </a:lnTo>
                <a:lnTo>
                  <a:pt x="1850263" y="76200"/>
                </a:lnTo>
                <a:lnTo>
                  <a:pt x="1850263" y="78740"/>
                </a:lnTo>
                <a:lnTo>
                  <a:pt x="1965960" y="78740"/>
                </a:lnTo>
                <a:lnTo>
                  <a:pt x="1965960" y="80010"/>
                </a:lnTo>
                <a:lnTo>
                  <a:pt x="1965960" y="81280"/>
                </a:lnTo>
                <a:lnTo>
                  <a:pt x="2023745" y="81280"/>
                </a:lnTo>
                <a:lnTo>
                  <a:pt x="2023745" y="82550"/>
                </a:lnTo>
                <a:lnTo>
                  <a:pt x="2948940" y="82550"/>
                </a:lnTo>
                <a:lnTo>
                  <a:pt x="2948940" y="81280"/>
                </a:lnTo>
                <a:lnTo>
                  <a:pt x="2948940" y="80010"/>
                </a:lnTo>
                <a:close/>
              </a:path>
              <a:path w="4221480" h="121919">
                <a:moveTo>
                  <a:pt x="3411474" y="92710"/>
                </a:moveTo>
                <a:lnTo>
                  <a:pt x="3353689" y="92710"/>
                </a:lnTo>
                <a:lnTo>
                  <a:pt x="3353689" y="91440"/>
                </a:lnTo>
                <a:lnTo>
                  <a:pt x="3295777" y="91440"/>
                </a:lnTo>
                <a:lnTo>
                  <a:pt x="3295777" y="88900"/>
                </a:lnTo>
                <a:lnTo>
                  <a:pt x="3237992" y="88900"/>
                </a:lnTo>
                <a:lnTo>
                  <a:pt x="3237992" y="87630"/>
                </a:lnTo>
                <a:lnTo>
                  <a:pt x="3180207" y="87630"/>
                </a:lnTo>
                <a:lnTo>
                  <a:pt x="3180207" y="86360"/>
                </a:lnTo>
                <a:lnTo>
                  <a:pt x="3122295" y="86360"/>
                </a:lnTo>
                <a:lnTo>
                  <a:pt x="3122295" y="85090"/>
                </a:lnTo>
                <a:lnTo>
                  <a:pt x="3064510" y="85090"/>
                </a:lnTo>
                <a:lnTo>
                  <a:pt x="3064510" y="83820"/>
                </a:lnTo>
                <a:lnTo>
                  <a:pt x="3006725" y="83820"/>
                </a:lnTo>
                <a:lnTo>
                  <a:pt x="3006725" y="83058"/>
                </a:lnTo>
                <a:lnTo>
                  <a:pt x="2081530" y="83058"/>
                </a:lnTo>
                <a:lnTo>
                  <a:pt x="2081530" y="84328"/>
                </a:lnTo>
                <a:lnTo>
                  <a:pt x="2139442" y="84328"/>
                </a:lnTo>
                <a:lnTo>
                  <a:pt x="2139442" y="85090"/>
                </a:lnTo>
                <a:lnTo>
                  <a:pt x="2139442" y="86360"/>
                </a:lnTo>
                <a:lnTo>
                  <a:pt x="2139442" y="87630"/>
                </a:lnTo>
                <a:lnTo>
                  <a:pt x="2197227" y="87630"/>
                </a:lnTo>
                <a:lnTo>
                  <a:pt x="2197227" y="88900"/>
                </a:lnTo>
                <a:lnTo>
                  <a:pt x="2197227" y="91440"/>
                </a:lnTo>
                <a:lnTo>
                  <a:pt x="2312797" y="91440"/>
                </a:lnTo>
                <a:lnTo>
                  <a:pt x="2312797" y="92710"/>
                </a:lnTo>
                <a:lnTo>
                  <a:pt x="2312797" y="95250"/>
                </a:lnTo>
                <a:lnTo>
                  <a:pt x="3411474" y="95250"/>
                </a:lnTo>
                <a:lnTo>
                  <a:pt x="3411474" y="92710"/>
                </a:lnTo>
                <a:close/>
              </a:path>
              <a:path w="4221480" h="121919">
                <a:moveTo>
                  <a:pt x="3758438" y="101600"/>
                </a:moveTo>
                <a:lnTo>
                  <a:pt x="3700526" y="101600"/>
                </a:lnTo>
                <a:lnTo>
                  <a:pt x="3700526" y="100330"/>
                </a:lnTo>
                <a:lnTo>
                  <a:pt x="3584956" y="100330"/>
                </a:lnTo>
                <a:lnTo>
                  <a:pt x="3584956" y="97790"/>
                </a:lnTo>
                <a:lnTo>
                  <a:pt x="3469259" y="97790"/>
                </a:lnTo>
                <a:lnTo>
                  <a:pt x="3469259" y="95758"/>
                </a:lnTo>
                <a:lnTo>
                  <a:pt x="2370709" y="95758"/>
                </a:lnTo>
                <a:lnTo>
                  <a:pt x="2370709" y="98298"/>
                </a:lnTo>
                <a:lnTo>
                  <a:pt x="2428494" y="98298"/>
                </a:lnTo>
                <a:lnTo>
                  <a:pt x="2428494" y="100330"/>
                </a:lnTo>
                <a:lnTo>
                  <a:pt x="2428494" y="101600"/>
                </a:lnTo>
                <a:lnTo>
                  <a:pt x="2486279" y="101600"/>
                </a:lnTo>
                <a:lnTo>
                  <a:pt x="2486279" y="102870"/>
                </a:lnTo>
                <a:lnTo>
                  <a:pt x="2544191" y="102870"/>
                </a:lnTo>
                <a:lnTo>
                  <a:pt x="2544191" y="104140"/>
                </a:lnTo>
                <a:lnTo>
                  <a:pt x="3758438" y="104140"/>
                </a:lnTo>
                <a:lnTo>
                  <a:pt x="3758438" y="102870"/>
                </a:lnTo>
                <a:lnTo>
                  <a:pt x="3758438" y="101600"/>
                </a:lnTo>
                <a:close/>
              </a:path>
              <a:path w="4221480" h="121919">
                <a:moveTo>
                  <a:pt x="4220972" y="120650"/>
                </a:moveTo>
                <a:lnTo>
                  <a:pt x="4163187" y="120650"/>
                </a:lnTo>
                <a:lnTo>
                  <a:pt x="4163187" y="119380"/>
                </a:lnTo>
                <a:lnTo>
                  <a:pt x="4105275" y="119380"/>
                </a:lnTo>
                <a:lnTo>
                  <a:pt x="4105275" y="118110"/>
                </a:lnTo>
                <a:lnTo>
                  <a:pt x="4105275" y="116840"/>
                </a:lnTo>
                <a:lnTo>
                  <a:pt x="4047490" y="116840"/>
                </a:lnTo>
                <a:lnTo>
                  <a:pt x="4047490" y="114300"/>
                </a:lnTo>
                <a:lnTo>
                  <a:pt x="3989705" y="114300"/>
                </a:lnTo>
                <a:lnTo>
                  <a:pt x="3989705" y="113030"/>
                </a:lnTo>
                <a:lnTo>
                  <a:pt x="3989705" y="109220"/>
                </a:lnTo>
                <a:lnTo>
                  <a:pt x="3874008" y="109220"/>
                </a:lnTo>
                <a:lnTo>
                  <a:pt x="3874008" y="108458"/>
                </a:lnTo>
                <a:lnTo>
                  <a:pt x="3816210" y="108458"/>
                </a:lnTo>
                <a:lnTo>
                  <a:pt x="3816210" y="104648"/>
                </a:lnTo>
                <a:lnTo>
                  <a:pt x="2601976" y="104648"/>
                </a:lnTo>
                <a:lnTo>
                  <a:pt x="2601976" y="108458"/>
                </a:lnTo>
                <a:lnTo>
                  <a:pt x="2659761" y="108458"/>
                </a:lnTo>
                <a:lnTo>
                  <a:pt x="2659761" y="109728"/>
                </a:lnTo>
                <a:lnTo>
                  <a:pt x="2717546" y="109728"/>
                </a:lnTo>
                <a:lnTo>
                  <a:pt x="2717546" y="113030"/>
                </a:lnTo>
                <a:lnTo>
                  <a:pt x="2775458" y="113030"/>
                </a:lnTo>
                <a:lnTo>
                  <a:pt x="2775458" y="114300"/>
                </a:lnTo>
                <a:lnTo>
                  <a:pt x="2833243" y="114300"/>
                </a:lnTo>
                <a:lnTo>
                  <a:pt x="2833243" y="116840"/>
                </a:lnTo>
                <a:lnTo>
                  <a:pt x="2833243" y="118110"/>
                </a:lnTo>
                <a:lnTo>
                  <a:pt x="2891028" y="118110"/>
                </a:lnTo>
                <a:lnTo>
                  <a:pt x="2891028" y="119380"/>
                </a:lnTo>
                <a:lnTo>
                  <a:pt x="2891028" y="120650"/>
                </a:lnTo>
                <a:lnTo>
                  <a:pt x="2891028" y="121920"/>
                </a:lnTo>
                <a:lnTo>
                  <a:pt x="4220972" y="121920"/>
                </a:lnTo>
                <a:lnTo>
                  <a:pt x="4220972" y="12065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bg object 30"/>
          <p:cNvSpPr/>
          <p:nvPr/>
        </p:nvSpPr>
        <p:spPr>
          <a:xfrm>
            <a:off x="1269238" y="722629"/>
            <a:ext cx="2371090" cy="46990"/>
          </a:xfrm>
          <a:custGeom>
            <a:avLst/>
            <a:gdLst/>
            <a:ahLst/>
            <a:cxnLst/>
            <a:rect l="l" t="t" r="r" b="b"/>
            <a:pathLst>
              <a:path w="2371090" h="46990">
                <a:moveTo>
                  <a:pt x="636143" y="7620"/>
                </a:moveTo>
                <a:lnTo>
                  <a:pt x="520446" y="7620"/>
                </a:lnTo>
                <a:lnTo>
                  <a:pt x="520446" y="6350"/>
                </a:lnTo>
                <a:lnTo>
                  <a:pt x="520446" y="5080"/>
                </a:lnTo>
                <a:lnTo>
                  <a:pt x="462661" y="5080"/>
                </a:lnTo>
                <a:lnTo>
                  <a:pt x="462661" y="3810"/>
                </a:lnTo>
                <a:lnTo>
                  <a:pt x="462661" y="2540"/>
                </a:lnTo>
                <a:lnTo>
                  <a:pt x="346964" y="2540"/>
                </a:lnTo>
                <a:lnTo>
                  <a:pt x="346964" y="1270"/>
                </a:lnTo>
                <a:lnTo>
                  <a:pt x="231394" y="1270"/>
                </a:lnTo>
                <a:lnTo>
                  <a:pt x="231394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57912" y="2540"/>
                </a:lnTo>
                <a:lnTo>
                  <a:pt x="57912" y="3810"/>
                </a:lnTo>
                <a:lnTo>
                  <a:pt x="173482" y="3810"/>
                </a:lnTo>
                <a:lnTo>
                  <a:pt x="173482" y="5080"/>
                </a:lnTo>
                <a:lnTo>
                  <a:pt x="231394" y="5080"/>
                </a:lnTo>
                <a:lnTo>
                  <a:pt x="231394" y="6350"/>
                </a:lnTo>
                <a:lnTo>
                  <a:pt x="289179" y="6350"/>
                </a:lnTo>
                <a:lnTo>
                  <a:pt x="289179" y="7620"/>
                </a:lnTo>
                <a:lnTo>
                  <a:pt x="289179" y="8890"/>
                </a:lnTo>
                <a:lnTo>
                  <a:pt x="636143" y="8890"/>
                </a:lnTo>
                <a:lnTo>
                  <a:pt x="636143" y="7620"/>
                </a:lnTo>
                <a:close/>
              </a:path>
              <a:path w="2371090" h="46990">
                <a:moveTo>
                  <a:pt x="1214247" y="19050"/>
                </a:moveTo>
                <a:lnTo>
                  <a:pt x="1156462" y="19050"/>
                </a:lnTo>
                <a:lnTo>
                  <a:pt x="1156462" y="17780"/>
                </a:lnTo>
                <a:lnTo>
                  <a:pt x="982980" y="17780"/>
                </a:lnTo>
                <a:lnTo>
                  <a:pt x="982980" y="16510"/>
                </a:lnTo>
                <a:lnTo>
                  <a:pt x="867410" y="16510"/>
                </a:lnTo>
                <a:lnTo>
                  <a:pt x="867410" y="15240"/>
                </a:lnTo>
                <a:lnTo>
                  <a:pt x="867410" y="13970"/>
                </a:lnTo>
                <a:lnTo>
                  <a:pt x="809498" y="13970"/>
                </a:lnTo>
                <a:lnTo>
                  <a:pt x="809498" y="12700"/>
                </a:lnTo>
                <a:lnTo>
                  <a:pt x="751713" y="12700"/>
                </a:lnTo>
                <a:lnTo>
                  <a:pt x="751713" y="11430"/>
                </a:lnTo>
                <a:lnTo>
                  <a:pt x="693928" y="11430"/>
                </a:lnTo>
                <a:lnTo>
                  <a:pt x="693928" y="9398"/>
                </a:lnTo>
                <a:lnTo>
                  <a:pt x="346964" y="9398"/>
                </a:lnTo>
                <a:lnTo>
                  <a:pt x="346964" y="11938"/>
                </a:lnTo>
                <a:lnTo>
                  <a:pt x="462661" y="11938"/>
                </a:lnTo>
                <a:lnTo>
                  <a:pt x="462661" y="12700"/>
                </a:lnTo>
                <a:lnTo>
                  <a:pt x="462661" y="13970"/>
                </a:lnTo>
                <a:lnTo>
                  <a:pt x="462661" y="15240"/>
                </a:lnTo>
                <a:lnTo>
                  <a:pt x="520446" y="15240"/>
                </a:lnTo>
                <a:lnTo>
                  <a:pt x="520446" y="16510"/>
                </a:lnTo>
                <a:lnTo>
                  <a:pt x="520446" y="17780"/>
                </a:lnTo>
                <a:lnTo>
                  <a:pt x="578231" y="17780"/>
                </a:lnTo>
                <a:lnTo>
                  <a:pt x="578231" y="19050"/>
                </a:lnTo>
                <a:lnTo>
                  <a:pt x="578231" y="20320"/>
                </a:lnTo>
                <a:lnTo>
                  <a:pt x="636143" y="20320"/>
                </a:lnTo>
                <a:lnTo>
                  <a:pt x="636143" y="21590"/>
                </a:lnTo>
                <a:lnTo>
                  <a:pt x="1214247" y="21590"/>
                </a:lnTo>
                <a:lnTo>
                  <a:pt x="1214247" y="20320"/>
                </a:lnTo>
                <a:lnTo>
                  <a:pt x="1214247" y="19050"/>
                </a:lnTo>
                <a:close/>
              </a:path>
              <a:path w="2371090" h="46990">
                <a:moveTo>
                  <a:pt x="1618996" y="31750"/>
                </a:moveTo>
                <a:lnTo>
                  <a:pt x="1561211" y="31750"/>
                </a:lnTo>
                <a:lnTo>
                  <a:pt x="1561211" y="29210"/>
                </a:lnTo>
                <a:lnTo>
                  <a:pt x="1503426" y="29210"/>
                </a:lnTo>
                <a:lnTo>
                  <a:pt x="1503426" y="27940"/>
                </a:lnTo>
                <a:lnTo>
                  <a:pt x="1503426" y="26670"/>
                </a:lnTo>
                <a:lnTo>
                  <a:pt x="1503426" y="25400"/>
                </a:lnTo>
                <a:lnTo>
                  <a:pt x="1445641" y="25400"/>
                </a:lnTo>
                <a:lnTo>
                  <a:pt x="1445641" y="24130"/>
                </a:lnTo>
                <a:lnTo>
                  <a:pt x="1329944" y="24130"/>
                </a:lnTo>
                <a:lnTo>
                  <a:pt x="1329944" y="22098"/>
                </a:lnTo>
                <a:lnTo>
                  <a:pt x="693928" y="22098"/>
                </a:lnTo>
                <a:lnTo>
                  <a:pt x="693928" y="24638"/>
                </a:lnTo>
                <a:lnTo>
                  <a:pt x="751713" y="24638"/>
                </a:lnTo>
                <a:lnTo>
                  <a:pt x="751713" y="25400"/>
                </a:lnTo>
                <a:lnTo>
                  <a:pt x="751713" y="26670"/>
                </a:lnTo>
                <a:lnTo>
                  <a:pt x="809498" y="26670"/>
                </a:lnTo>
                <a:lnTo>
                  <a:pt x="809498" y="27940"/>
                </a:lnTo>
                <a:lnTo>
                  <a:pt x="867410" y="27940"/>
                </a:lnTo>
                <a:lnTo>
                  <a:pt x="867410" y="29210"/>
                </a:lnTo>
                <a:lnTo>
                  <a:pt x="867410" y="31750"/>
                </a:lnTo>
                <a:lnTo>
                  <a:pt x="925195" y="31750"/>
                </a:lnTo>
                <a:lnTo>
                  <a:pt x="925195" y="33020"/>
                </a:lnTo>
                <a:lnTo>
                  <a:pt x="982980" y="33020"/>
                </a:lnTo>
                <a:lnTo>
                  <a:pt x="982980" y="34290"/>
                </a:lnTo>
                <a:lnTo>
                  <a:pt x="1618996" y="34290"/>
                </a:lnTo>
                <a:lnTo>
                  <a:pt x="1618996" y="33020"/>
                </a:lnTo>
                <a:lnTo>
                  <a:pt x="1618996" y="31750"/>
                </a:lnTo>
                <a:close/>
              </a:path>
              <a:path w="2371090" h="46990">
                <a:moveTo>
                  <a:pt x="2197227" y="40640"/>
                </a:moveTo>
                <a:lnTo>
                  <a:pt x="2139442" y="40640"/>
                </a:lnTo>
                <a:lnTo>
                  <a:pt x="2139442" y="39370"/>
                </a:lnTo>
                <a:lnTo>
                  <a:pt x="2081657" y="39370"/>
                </a:lnTo>
                <a:lnTo>
                  <a:pt x="2081657" y="38100"/>
                </a:lnTo>
                <a:lnTo>
                  <a:pt x="2023745" y="38100"/>
                </a:lnTo>
                <a:lnTo>
                  <a:pt x="2023745" y="36830"/>
                </a:lnTo>
                <a:lnTo>
                  <a:pt x="1908175" y="36830"/>
                </a:lnTo>
                <a:lnTo>
                  <a:pt x="1908175" y="35560"/>
                </a:lnTo>
                <a:lnTo>
                  <a:pt x="1792478" y="35560"/>
                </a:lnTo>
                <a:lnTo>
                  <a:pt x="1792478" y="34798"/>
                </a:lnTo>
                <a:lnTo>
                  <a:pt x="1156462" y="34798"/>
                </a:lnTo>
                <a:lnTo>
                  <a:pt x="1156462" y="36068"/>
                </a:lnTo>
                <a:lnTo>
                  <a:pt x="1214247" y="36068"/>
                </a:lnTo>
                <a:lnTo>
                  <a:pt x="1214247" y="36830"/>
                </a:lnTo>
                <a:lnTo>
                  <a:pt x="1214247" y="38100"/>
                </a:lnTo>
                <a:lnTo>
                  <a:pt x="1214247" y="39370"/>
                </a:lnTo>
                <a:lnTo>
                  <a:pt x="1329944" y="39370"/>
                </a:lnTo>
                <a:lnTo>
                  <a:pt x="1329944" y="40640"/>
                </a:lnTo>
                <a:lnTo>
                  <a:pt x="1329944" y="41910"/>
                </a:lnTo>
                <a:lnTo>
                  <a:pt x="1387729" y="41910"/>
                </a:lnTo>
                <a:lnTo>
                  <a:pt x="1387729" y="43180"/>
                </a:lnTo>
                <a:lnTo>
                  <a:pt x="2197227" y="43180"/>
                </a:lnTo>
                <a:lnTo>
                  <a:pt x="2197227" y="41910"/>
                </a:lnTo>
                <a:lnTo>
                  <a:pt x="2197227" y="40640"/>
                </a:lnTo>
                <a:close/>
              </a:path>
              <a:path w="2371090" h="46990">
                <a:moveTo>
                  <a:pt x="2370709" y="45720"/>
                </a:moveTo>
                <a:lnTo>
                  <a:pt x="2312924" y="45720"/>
                </a:lnTo>
                <a:lnTo>
                  <a:pt x="2312924" y="44450"/>
                </a:lnTo>
                <a:lnTo>
                  <a:pt x="2255139" y="44450"/>
                </a:lnTo>
                <a:lnTo>
                  <a:pt x="2255139" y="43688"/>
                </a:lnTo>
                <a:lnTo>
                  <a:pt x="1445641" y="43688"/>
                </a:lnTo>
                <a:lnTo>
                  <a:pt x="1445641" y="44958"/>
                </a:lnTo>
                <a:lnTo>
                  <a:pt x="1503426" y="44958"/>
                </a:lnTo>
                <a:lnTo>
                  <a:pt x="1503426" y="45720"/>
                </a:lnTo>
                <a:lnTo>
                  <a:pt x="1503426" y="46990"/>
                </a:lnTo>
                <a:lnTo>
                  <a:pt x="2370709" y="46990"/>
                </a:lnTo>
                <a:lnTo>
                  <a:pt x="2370709" y="4572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1" name="bg object 31"/>
          <p:cNvSpPr/>
          <p:nvPr/>
        </p:nvSpPr>
        <p:spPr>
          <a:xfrm>
            <a:off x="3235198" y="833119"/>
            <a:ext cx="12374245" cy="1663700"/>
          </a:xfrm>
          <a:custGeom>
            <a:avLst/>
            <a:gdLst/>
            <a:ahLst/>
            <a:cxnLst/>
            <a:rect l="l" t="t" r="r" b="b"/>
            <a:pathLst>
              <a:path w="12374244" h="1663700">
                <a:moveTo>
                  <a:pt x="12373864" y="800100"/>
                </a:moveTo>
                <a:lnTo>
                  <a:pt x="11390884" y="800100"/>
                </a:lnTo>
                <a:lnTo>
                  <a:pt x="11390884" y="774700"/>
                </a:lnTo>
                <a:lnTo>
                  <a:pt x="11390884" y="762000"/>
                </a:lnTo>
                <a:lnTo>
                  <a:pt x="11390884" y="736600"/>
                </a:lnTo>
                <a:lnTo>
                  <a:pt x="11101705" y="736600"/>
                </a:lnTo>
                <a:lnTo>
                  <a:pt x="11101705" y="723900"/>
                </a:lnTo>
                <a:lnTo>
                  <a:pt x="11101705" y="711200"/>
                </a:lnTo>
                <a:lnTo>
                  <a:pt x="10581386" y="711200"/>
                </a:lnTo>
                <a:lnTo>
                  <a:pt x="10581386" y="698500"/>
                </a:lnTo>
                <a:lnTo>
                  <a:pt x="10581386" y="685800"/>
                </a:lnTo>
                <a:lnTo>
                  <a:pt x="10581386" y="673100"/>
                </a:lnTo>
                <a:lnTo>
                  <a:pt x="10176637" y="673100"/>
                </a:lnTo>
                <a:lnTo>
                  <a:pt x="10176637" y="660400"/>
                </a:lnTo>
                <a:lnTo>
                  <a:pt x="9887458" y="660400"/>
                </a:lnTo>
                <a:lnTo>
                  <a:pt x="9887458" y="647700"/>
                </a:lnTo>
                <a:lnTo>
                  <a:pt x="9887458" y="635000"/>
                </a:lnTo>
                <a:lnTo>
                  <a:pt x="9887458" y="622300"/>
                </a:lnTo>
                <a:lnTo>
                  <a:pt x="9713976" y="622300"/>
                </a:lnTo>
                <a:lnTo>
                  <a:pt x="9713976" y="609600"/>
                </a:lnTo>
                <a:lnTo>
                  <a:pt x="9656191" y="609600"/>
                </a:lnTo>
                <a:lnTo>
                  <a:pt x="9656191" y="596900"/>
                </a:lnTo>
                <a:lnTo>
                  <a:pt x="9482709" y="596900"/>
                </a:lnTo>
                <a:lnTo>
                  <a:pt x="9482709" y="584200"/>
                </a:lnTo>
                <a:lnTo>
                  <a:pt x="9367139" y="584200"/>
                </a:lnTo>
                <a:lnTo>
                  <a:pt x="9367139" y="571500"/>
                </a:lnTo>
                <a:lnTo>
                  <a:pt x="9367139" y="558800"/>
                </a:lnTo>
                <a:lnTo>
                  <a:pt x="8615426" y="558800"/>
                </a:lnTo>
                <a:lnTo>
                  <a:pt x="8615426" y="546100"/>
                </a:lnTo>
                <a:lnTo>
                  <a:pt x="8615426" y="533400"/>
                </a:lnTo>
                <a:lnTo>
                  <a:pt x="8441944" y="533400"/>
                </a:lnTo>
                <a:lnTo>
                  <a:pt x="8441944" y="520700"/>
                </a:lnTo>
                <a:lnTo>
                  <a:pt x="7921625" y="520700"/>
                </a:lnTo>
                <a:lnTo>
                  <a:pt x="7921625" y="508000"/>
                </a:lnTo>
                <a:lnTo>
                  <a:pt x="7748143" y="508000"/>
                </a:lnTo>
                <a:lnTo>
                  <a:pt x="7748143" y="495300"/>
                </a:lnTo>
                <a:lnTo>
                  <a:pt x="7632446" y="495300"/>
                </a:lnTo>
                <a:lnTo>
                  <a:pt x="7632446" y="482600"/>
                </a:lnTo>
                <a:lnTo>
                  <a:pt x="7632446" y="469900"/>
                </a:lnTo>
                <a:lnTo>
                  <a:pt x="7458964" y="469900"/>
                </a:lnTo>
                <a:lnTo>
                  <a:pt x="7458964" y="457200"/>
                </a:lnTo>
                <a:lnTo>
                  <a:pt x="7343394" y="457200"/>
                </a:lnTo>
                <a:lnTo>
                  <a:pt x="7343394" y="444500"/>
                </a:lnTo>
                <a:lnTo>
                  <a:pt x="7169912" y="444500"/>
                </a:lnTo>
                <a:lnTo>
                  <a:pt x="7169912" y="431800"/>
                </a:lnTo>
                <a:lnTo>
                  <a:pt x="7054215" y="431800"/>
                </a:lnTo>
                <a:lnTo>
                  <a:pt x="7054215" y="419100"/>
                </a:lnTo>
                <a:lnTo>
                  <a:pt x="6822948" y="419100"/>
                </a:lnTo>
                <a:lnTo>
                  <a:pt x="6822948" y="406400"/>
                </a:lnTo>
                <a:lnTo>
                  <a:pt x="6707378" y="406400"/>
                </a:lnTo>
                <a:lnTo>
                  <a:pt x="6707378" y="393700"/>
                </a:lnTo>
                <a:lnTo>
                  <a:pt x="6649466" y="393700"/>
                </a:lnTo>
                <a:lnTo>
                  <a:pt x="6649466" y="381000"/>
                </a:lnTo>
                <a:lnTo>
                  <a:pt x="6302629" y="381000"/>
                </a:lnTo>
                <a:lnTo>
                  <a:pt x="6302629" y="368300"/>
                </a:lnTo>
                <a:lnTo>
                  <a:pt x="6129147" y="368300"/>
                </a:lnTo>
                <a:lnTo>
                  <a:pt x="6129147" y="355600"/>
                </a:lnTo>
                <a:lnTo>
                  <a:pt x="6071235" y="355600"/>
                </a:lnTo>
                <a:lnTo>
                  <a:pt x="6071235" y="342900"/>
                </a:lnTo>
                <a:lnTo>
                  <a:pt x="5608701" y="342900"/>
                </a:lnTo>
                <a:lnTo>
                  <a:pt x="5608701" y="330200"/>
                </a:lnTo>
                <a:lnTo>
                  <a:pt x="5377434" y="330200"/>
                </a:lnTo>
                <a:lnTo>
                  <a:pt x="5377434" y="317500"/>
                </a:lnTo>
                <a:lnTo>
                  <a:pt x="5030470" y="317500"/>
                </a:lnTo>
                <a:lnTo>
                  <a:pt x="5030470" y="304800"/>
                </a:lnTo>
                <a:lnTo>
                  <a:pt x="4972685" y="304800"/>
                </a:lnTo>
                <a:lnTo>
                  <a:pt x="4972685" y="292100"/>
                </a:lnTo>
                <a:lnTo>
                  <a:pt x="4856988" y="292100"/>
                </a:lnTo>
                <a:lnTo>
                  <a:pt x="4856988" y="279400"/>
                </a:lnTo>
                <a:lnTo>
                  <a:pt x="4625721" y="279400"/>
                </a:lnTo>
                <a:lnTo>
                  <a:pt x="4625721" y="266700"/>
                </a:lnTo>
                <a:lnTo>
                  <a:pt x="4510151" y="266700"/>
                </a:lnTo>
                <a:lnTo>
                  <a:pt x="4510151" y="254000"/>
                </a:lnTo>
                <a:lnTo>
                  <a:pt x="4336669" y="254000"/>
                </a:lnTo>
                <a:lnTo>
                  <a:pt x="4336669" y="241300"/>
                </a:lnTo>
                <a:lnTo>
                  <a:pt x="4163187" y="241300"/>
                </a:lnTo>
                <a:lnTo>
                  <a:pt x="4163187" y="228600"/>
                </a:lnTo>
                <a:lnTo>
                  <a:pt x="3931920" y="228600"/>
                </a:lnTo>
                <a:lnTo>
                  <a:pt x="3931920" y="215900"/>
                </a:lnTo>
                <a:lnTo>
                  <a:pt x="3642741" y="215900"/>
                </a:lnTo>
                <a:lnTo>
                  <a:pt x="3642741" y="203200"/>
                </a:lnTo>
                <a:lnTo>
                  <a:pt x="3584956" y="203200"/>
                </a:lnTo>
                <a:lnTo>
                  <a:pt x="3584956" y="190500"/>
                </a:lnTo>
                <a:lnTo>
                  <a:pt x="3469259" y="190500"/>
                </a:lnTo>
                <a:lnTo>
                  <a:pt x="3469259" y="177800"/>
                </a:lnTo>
                <a:lnTo>
                  <a:pt x="3180207" y="177800"/>
                </a:lnTo>
                <a:lnTo>
                  <a:pt x="3180207" y="165100"/>
                </a:lnTo>
                <a:lnTo>
                  <a:pt x="2891155" y="165100"/>
                </a:lnTo>
                <a:lnTo>
                  <a:pt x="2891155" y="152400"/>
                </a:lnTo>
                <a:lnTo>
                  <a:pt x="2775458" y="152400"/>
                </a:lnTo>
                <a:lnTo>
                  <a:pt x="2775458" y="139700"/>
                </a:lnTo>
                <a:lnTo>
                  <a:pt x="2486406" y="139700"/>
                </a:lnTo>
                <a:lnTo>
                  <a:pt x="2486406" y="127000"/>
                </a:lnTo>
                <a:lnTo>
                  <a:pt x="2370709" y="127000"/>
                </a:lnTo>
                <a:lnTo>
                  <a:pt x="2370709" y="114300"/>
                </a:lnTo>
                <a:lnTo>
                  <a:pt x="2081657" y="114300"/>
                </a:lnTo>
                <a:lnTo>
                  <a:pt x="2081657" y="101600"/>
                </a:lnTo>
                <a:lnTo>
                  <a:pt x="1965960" y="101600"/>
                </a:lnTo>
                <a:lnTo>
                  <a:pt x="1965960" y="88900"/>
                </a:lnTo>
                <a:lnTo>
                  <a:pt x="1792478" y="88900"/>
                </a:lnTo>
                <a:lnTo>
                  <a:pt x="1792478" y="76200"/>
                </a:lnTo>
                <a:lnTo>
                  <a:pt x="1618996" y="76200"/>
                </a:lnTo>
                <a:lnTo>
                  <a:pt x="1618996" y="63500"/>
                </a:lnTo>
                <a:lnTo>
                  <a:pt x="1329944" y="63500"/>
                </a:lnTo>
                <a:lnTo>
                  <a:pt x="1329944" y="50800"/>
                </a:lnTo>
                <a:lnTo>
                  <a:pt x="1098677" y="50800"/>
                </a:lnTo>
                <a:lnTo>
                  <a:pt x="1098677" y="38100"/>
                </a:lnTo>
                <a:lnTo>
                  <a:pt x="925195" y="38100"/>
                </a:lnTo>
                <a:lnTo>
                  <a:pt x="925195" y="25400"/>
                </a:lnTo>
                <a:lnTo>
                  <a:pt x="636016" y="25400"/>
                </a:lnTo>
                <a:lnTo>
                  <a:pt x="636016" y="12700"/>
                </a:lnTo>
                <a:lnTo>
                  <a:pt x="462661" y="12700"/>
                </a:lnTo>
                <a:lnTo>
                  <a:pt x="462661" y="0"/>
                </a:lnTo>
                <a:lnTo>
                  <a:pt x="0" y="0"/>
                </a:lnTo>
                <a:lnTo>
                  <a:pt x="0" y="12700"/>
                </a:lnTo>
                <a:lnTo>
                  <a:pt x="57785" y="12700"/>
                </a:lnTo>
                <a:lnTo>
                  <a:pt x="57785" y="25400"/>
                </a:lnTo>
                <a:lnTo>
                  <a:pt x="115697" y="25400"/>
                </a:lnTo>
                <a:lnTo>
                  <a:pt x="115697" y="38100"/>
                </a:lnTo>
                <a:lnTo>
                  <a:pt x="289179" y="38100"/>
                </a:lnTo>
                <a:lnTo>
                  <a:pt x="289179" y="50800"/>
                </a:lnTo>
                <a:lnTo>
                  <a:pt x="462661" y="50800"/>
                </a:lnTo>
                <a:lnTo>
                  <a:pt x="462661" y="63500"/>
                </a:lnTo>
                <a:lnTo>
                  <a:pt x="578231" y="63500"/>
                </a:lnTo>
                <a:lnTo>
                  <a:pt x="578231" y="76200"/>
                </a:lnTo>
                <a:lnTo>
                  <a:pt x="636016" y="76200"/>
                </a:lnTo>
                <a:lnTo>
                  <a:pt x="636016" y="88900"/>
                </a:lnTo>
                <a:lnTo>
                  <a:pt x="925195" y="88900"/>
                </a:lnTo>
                <a:lnTo>
                  <a:pt x="925195" y="101600"/>
                </a:lnTo>
                <a:lnTo>
                  <a:pt x="1098677" y="101600"/>
                </a:lnTo>
                <a:lnTo>
                  <a:pt x="1098677" y="114300"/>
                </a:lnTo>
                <a:lnTo>
                  <a:pt x="1214247" y="114300"/>
                </a:lnTo>
                <a:lnTo>
                  <a:pt x="1214247" y="127000"/>
                </a:lnTo>
                <a:lnTo>
                  <a:pt x="1445514" y="127000"/>
                </a:lnTo>
                <a:lnTo>
                  <a:pt x="1445514" y="139700"/>
                </a:lnTo>
                <a:lnTo>
                  <a:pt x="1618996" y="139700"/>
                </a:lnTo>
                <a:lnTo>
                  <a:pt x="1618996" y="152400"/>
                </a:lnTo>
                <a:lnTo>
                  <a:pt x="1792478" y="152400"/>
                </a:lnTo>
                <a:lnTo>
                  <a:pt x="1792478" y="165100"/>
                </a:lnTo>
                <a:lnTo>
                  <a:pt x="1908175" y="165100"/>
                </a:lnTo>
                <a:lnTo>
                  <a:pt x="1908175" y="177800"/>
                </a:lnTo>
                <a:lnTo>
                  <a:pt x="2081657" y="177800"/>
                </a:lnTo>
                <a:lnTo>
                  <a:pt x="2081657" y="190500"/>
                </a:lnTo>
                <a:lnTo>
                  <a:pt x="2197227" y="190500"/>
                </a:lnTo>
                <a:lnTo>
                  <a:pt x="2197227" y="203200"/>
                </a:lnTo>
                <a:lnTo>
                  <a:pt x="2428494" y="203200"/>
                </a:lnTo>
                <a:lnTo>
                  <a:pt x="2428494" y="215900"/>
                </a:lnTo>
                <a:lnTo>
                  <a:pt x="2486406" y="215900"/>
                </a:lnTo>
                <a:lnTo>
                  <a:pt x="2486406" y="228600"/>
                </a:lnTo>
                <a:lnTo>
                  <a:pt x="2775458" y="228600"/>
                </a:lnTo>
                <a:lnTo>
                  <a:pt x="2775458" y="241300"/>
                </a:lnTo>
                <a:lnTo>
                  <a:pt x="2833243" y="241300"/>
                </a:lnTo>
                <a:lnTo>
                  <a:pt x="2833243" y="254000"/>
                </a:lnTo>
                <a:lnTo>
                  <a:pt x="3122422" y="254000"/>
                </a:lnTo>
                <a:lnTo>
                  <a:pt x="3122422" y="266700"/>
                </a:lnTo>
                <a:lnTo>
                  <a:pt x="3180207" y="266700"/>
                </a:lnTo>
                <a:lnTo>
                  <a:pt x="3180207" y="279400"/>
                </a:lnTo>
                <a:lnTo>
                  <a:pt x="3469259" y="279400"/>
                </a:lnTo>
                <a:lnTo>
                  <a:pt x="3469259" y="292100"/>
                </a:lnTo>
                <a:lnTo>
                  <a:pt x="3584956" y="292100"/>
                </a:lnTo>
                <a:lnTo>
                  <a:pt x="3584956" y="304800"/>
                </a:lnTo>
                <a:lnTo>
                  <a:pt x="3642741" y="304800"/>
                </a:lnTo>
                <a:lnTo>
                  <a:pt x="3642741" y="317500"/>
                </a:lnTo>
                <a:lnTo>
                  <a:pt x="3874008" y="317500"/>
                </a:lnTo>
                <a:lnTo>
                  <a:pt x="3874008" y="330200"/>
                </a:lnTo>
                <a:lnTo>
                  <a:pt x="4163187" y="330200"/>
                </a:lnTo>
                <a:lnTo>
                  <a:pt x="4163187" y="342900"/>
                </a:lnTo>
                <a:lnTo>
                  <a:pt x="4336669" y="342900"/>
                </a:lnTo>
                <a:lnTo>
                  <a:pt x="4336669" y="355600"/>
                </a:lnTo>
                <a:lnTo>
                  <a:pt x="4336669" y="368300"/>
                </a:lnTo>
                <a:lnTo>
                  <a:pt x="4510151" y="368300"/>
                </a:lnTo>
                <a:lnTo>
                  <a:pt x="4510151" y="381000"/>
                </a:lnTo>
                <a:lnTo>
                  <a:pt x="4625721" y="381000"/>
                </a:lnTo>
                <a:lnTo>
                  <a:pt x="4625721" y="393700"/>
                </a:lnTo>
                <a:lnTo>
                  <a:pt x="4683506" y="393700"/>
                </a:lnTo>
                <a:lnTo>
                  <a:pt x="4683506" y="406400"/>
                </a:lnTo>
                <a:lnTo>
                  <a:pt x="4914900" y="406400"/>
                </a:lnTo>
                <a:lnTo>
                  <a:pt x="4914900" y="419100"/>
                </a:lnTo>
                <a:lnTo>
                  <a:pt x="4972685" y="419100"/>
                </a:lnTo>
                <a:lnTo>
                  <a:pt x="4972685" y="431800"/>
                </a:lnTo>
                <a:lnTo>
                  <a:pt x="5030470" y="431800"/>
                </a:lnTo>
                <a:lnTo>
                  <a:pt x="5030470" y="444500"/>
                </a:lnTo>
                <a:lnTo>
                  <a:pt x="5319649" y="444500"/>
                </a:lnTo>
                <a:lnTo>
                  <a:pt x="5319649" y="457200"/>
                </a:lnTo>
                <a:lnTo>
                  <a:pt x="5608701" y="457200"/>
                </a:lnTo>
                <a:lnTo>
                  <a:pt x="5608701" y="469900"/>
                </a:lnTo>
                <a:lnTo>
                  <a:pt x="5955665" y="469900"/>
                </a:lnTo>
                <a:lnTo>
                  <a:pt x="5955665" y="482600"/>
                </a:lnTo>
                <a:lnTo>
                  <a:pt x="6071235" y="482600"/>
                </a:lnTo>
                <a:lnTo>
                  <a:pt x="6071235" y="495300"/>
                </a:lnTo>
                <a:lnTo>
                  <a:pt x="6129147" y="495300"/>
                </a:lnTo>
                <a:lnTo>
                  <a:pt x="6129147" y="508000"/>
                </a:lnTo>
                <a:lnTo>
                  <a:pt x="6186932" y="508000"/>
                </a:lnTo>
                <a:lnTo>
                  <a:pt x="6186932" y="520700"/>
                </a:lnTo>
                <a:lnTo>
                  <a:pt x="6418199" y="520700"/>
                </a:lnTo>
                <a:lnTo>
                  <a:pt x="6418199" y="533400"/>
                </a:lnTo>
                <a:lnTo>
                  <a:pt x="6649466" y="533400"/>
                </a:lnTo>
                <a:lnTo>
                  <a:pt x="6649466" y="546100"/>
                </a:lnTo>
                <a:lnTo>
                  <a:pt x="6707378" y="546100"/>
                </a:lnTo>
                <a:lnTo>
                  <a:pt x="6707378" y="558800"/>
                </a:lnTo>
                <a:lnTo>
                  <a:pt x="6822948" y="558800"/>
                </a:lnTo>
                <a:lnTo>
                  <a:pt x="6822948" y="571500"/>
                </a:lnTo>
                <a:lnTo>
                  <a:pt x="6996430" y="571500"/>
                </a:lnTo>
                <a:lnTo>
                  <a:pt x="6996430" y="584200"/>
                </a:lnTo>
                <a:lnTo>
                  <a:pt x="7054215" y="584200"/>
                </a:lnTo>
                <a:lnTo>
                  <a:pt x="7054215" y="596900"/>
                </a:lnTo>
                <a:lnTo>
                  <a:pt x="7169912" y="596900"/>
                </a:lnTo>
                <a:lnTo>
                  <a:pt x="7169912" y="609600"/>
                </a:lnTo>
                <a:lnTo>
                  <a:pt x="7343394" y="609600"/>
                </a:lnTo>
                <a:lnTo>
                  <a:pt x="7343394" y="622300"/>
                </a:lnTo>
                <a:lnTo>
                  <a:pt x="7343394" y="635000"/>
                </a:lnTo>
                <a:lnTo>
                  <a:pt x="7516876" y="635000"/>
                </a:lnTo>
                <a:lnTo>
                  <a:pt x="7516876" y="647700"/>
                </a:lnTo>
                <a:lnTo>
                  <a:pt x="7632446" y="647700"/>
                </a:lnTo>
                <a:lnTo>
                  <a:pt x="7632446" y="660400"/>
                </a:lnTo>
                <a:lnTo>
                  <a:pt x="7632446" y="673100"/>
                </a:lnTo>
                <a:lnTo>
                  <a:pt x="7748143" y="673100"/>
                </a:lnTo>
                <a:lnTo>
                  <a:pt x="7748143" y="685800"/>
                </a:lnTo>
                <a:lnTo>
                  <a:pt x="7805928" y="685800"/>
                </a:lnTo>
                <a:lnTo>
                  <a:pt x="7805928" y="698500"/>
                </a:lnTo>
                <a:lnTo>
                  <a:pt x="7921625" y="698500"/>
                </a:lnTo>
                <a:lnTo>
                  <a:pt x="7921625" y="711200"/>
                </a:lnTo>
                <a:lnTo>
                  <a:pt x="8441944" y="711200"/>
                </a:lnTo>
                <a:lnTo>
                  <a:pt x="8441944" y="723900"/>
                </a:lnTo>
                <a:lnTo>
                  <a:pt x="8615426" y="723900"/>
                </a:lnTo>
                <a:lnTo>
                  <a:pt x="8615426" y="736600"/>
                </a:lnTo>
                <a:lnTo>
                  <a:pt x="8615426" y="762000"/>
                </a:lnTo>
                <a:lnTo>
                  <a:pt x="9020175" y="762000"/>
                </a:lnTo>
                <a:lnTo>
                  <a:pt x="9020175" y="774700"/>
                </a:lnTo>
                <a:lnTo>
                  <a:pt x="9367139" y="774700"/>
                </a:lnTo>
                <a:lnTo>
                  <a:pt x="9367139" y="800100"/>
                </a:lnTo>
                <a:lnTo>
                  <a:pt x="9367139" y="812800"/>
                </a:lnTo>
                <a:lnTo>
                  <a:pt x="9482709" y="812800"/>
                </a:lnTo>
                <a:lnTo>
                  <a:pt x="9482709" y="825500"/>
                </a:lnTo>
                <a:lnTo>
                  <a:pt x="9656191" y="825500"/>
                </a:lnTo>
                <a:lnTo>
                  <a:pt x="9656191" y="850900"/>
                </a:lnTo>
                <a:lnTo>
                  <a:pt x="9713976" y="850900"/>
                </a:lnTo>
                <a:lnTo>
                  <a:pt x="9713976" y="876300"/>
                </a:lnTo>
                <a:lnTo>
                  <a:pt x="9887458" y="876300"/>
                </a:lnTo>
                <a:lnTo>
                  <a:pt x="9887458" y="927100"/>
                </a:lnTo>
                <a:lnTo>
                  <a:pt x="10176637" y="927100"/>
                </a:lnTo>
                <a:lnTo>
                  <a:pt x="10176637" y="952500"/>
                </a:lnTo>
                <a:lnTo>
                  <a:pt x="10581386" y="952500"/>
                </a:lnTo>
                <a:lnTo>
                  <a:pt x="10581386" y="1041400"/>
                </a:lnTo>
                <a:lnTo>
                  <a:pt x="11101705" y="1041400"/>
                </a:lnTo>
                <a:lnTo>
                  <a:pt x="11101705" y="1143000"/>
                </a:lnTo>
                <a:lnTo>
                  <a:pt x="11390884" y="1143000"/>
                </a:lnTo>
                <a:lnTo>
                  <a:pt x="11390884" y="1358900"/>
                </a:lnTo>
                <a:lnTo>
                  <a:pt x="12084685" y="1358900"/>
                </a:lnTo>
                <a:lnTo>
                  <a:pt x="12084685" y="1663700"/>
                </a:lnTo>
                <a:lnTo>
                  <a:pt x="12373864" y="1663700"/>
                </a:lnTo>
                <a:lnTo>
                  <a:pt x="12373864" y="1358900"/>
                </a:lnTo>
                <a:lnTo>
                  <a:pt x="12373864" y="1143000"/>
                </a:lnTo>
                <a:lnTo>
                  <a:pt x="12373864" y="812800"/>
                </a:lnTo>
                <a:lnTo>
                  <a:pt x="12373864" y="80010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2" name="bg object 32"/>
          <p:cNvSpPr/>
          <p:nvPr/>
        </p:nvSpPr>
        <p:spPr>
          <a:xfrm>
            <a:off x="1327150" y="731519"/>
            <a:ext cx="2371090" cy="114300"/>
          </a:xfrm>
          <a:custGeom>
            <a:avLst/>
            <a:gdLst/>
            <a:ahLst/>
            <a:cxnLst/>
            <a:rect l="l" t="t" r="r" b="b"/>
            <a:pathLst>
              <a:path w="2371090" h="114300">
                <a:moveTo>
                  <a:pt x="2370709" y="101600"/>
                </a:moveTo>
                <a:lnTo>
                  <a:pt x="2255012" y="101600"/>
                </a:lnTo>
                <a:lnTo>
                  <a:pt x="2255012" y="88900"/>
                </a:lnTo>
                <a:lnTo>
                  <a:pt x="2023745" y="88900"/>
                </a:lnTo>
                <a:lnTo>
                  <a:pt x="2023745" y="76200"/>
                </a:lnTo>
                <a:lnTo>
                  <a:pt x="1965833" y="76200"/>
                </a:lnTo>
                <a:lnTo>
                  <a:pt x="1965833" y="63500"/>
                </a:lnTo>
                <a:lnTo>
                  <a:pt x="1734566" y="63500"/>
                </a:lnTo>
                <a:lnTo>
                  <a:pt x="1734566" y="50800"/>
                </a:lnTo>
                <a:lnTo>
                  <a:pt x="1503299" y="50800"/>
                </a:lnTo>
                <a:lnTo>
                  <a:pt x="1503299" y="38100"/>
                </a:lnTo>
                <a:lnTo>
                  <a:pt x="1214247" y="38100"/>
                </a:lnTo>
                <a:lnTo>
                  <a:pt x="1214247" y="25400"/>
                </a:lnTo>
                <a:lnTo>
                  <a:pt x="636016" y="25400"/>
                </a:lnTo>
                <a:lnTo>
                  <a:pt x="636016" y="12700"/>
                </a:lnTo>
                <a:lnTo>
                  <a:pt x="289052" y="12700"/>
                </a:lnTo>
                <a:lnTo>
                  <a:pt x="289052" y="0"/>
                </a:lnTo>
                <a:lnTo>
                  <a:pt x="0" y="0"/>
                </a:lnTo>
                <a:lnTo>
                  <a:pt x="0" y="12700"/>
                </a:lnTo>
                <a:lnTo>
                  <a:pt x="115570" y="12700"/>
                </a:lnTo>
                <a:lnTo>
                  <a:pt x="115570" y="25400"/>
                </a:lnTo>
                <a:lnTo>
                  <a:pt x="289052" y="25400"/>
                </a:lnTo>
                <a:lnTo>
                  <a:pt x="289052" y="38100"/>
                </a:lnTo>
                <a:lnTo>
                  <a:pt x="520319" y="38100"/>
                </a:lnTo>
                <a:lnTo>
                  <a:pt x="520319" y="50800"/>
                </a:lnTo>
                <a:lnTo>
                  <a:pt x="867283" y="50800"/>
                </a:lnTo>
                <a:lnTo>
                  <a:pt x="867283" y="63500"/>
                </a:lnTo>
                <a:lnTo>
                  <a:pt x="1272032" y="63500"/>
                </a:lnTo>
                <a:lnTo>
                  <a:pt x="1272032" y="76200"/>
                </a:lnTo>
                <a:lnTo>
                  <a:pt x="1503299" y="76200"/>
                </a:lnTo>
                <a:lnTo>
                  <a:pt x="1503299" y="88900"/>
                </a:lnTo>
                <a:lnTo>
                  <a:pt x="1676781" y="88900"/>
                </a:lnTo>
                <a:lnTo>
                  <a:pt x="1676781" y="101600"/>
                </a:lnTo>
                <a:lnTo>
                  <a:pt x="1908048" y="101600"/>
                </a:lnTo>
                <a:lnTo>
                  <a:pt x="1908048" y="114300"/>
                </a:lnTo>
                <a:lnTo>
                  <a:pt x="2370709" y="114300"/>
                </a:lnTo>
                <a:lnTo>
                  <a:pt x="2370709" y="10160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3" name="bg object 33"/>
          <p:cNvSpPr/>
          <p:nvPr/>
        </p:nvSpPr>
        <p:spPr>
          <a:xfrm>
            <a:off x="2772664" y="875029"/>
            <a:ext cx="12605385" cy="1270000"/>
          </a:xfrm>
          <a:custGeom>
            <a:avLst/>
            <a:gdLst/>
            <a:ahLst/>
            <a:cxnLst/>
            <a:rect l="l" t="t" r="r" b="b"/>
            <a:pathLst>
              <a:path w="12605385" h="1270000">
                <a:moveTo>
                  <a:pt x="12605131" y="787400"/>
                </a:moveTo>
                <a:lnTo>
                  <a:pt x="10465689" y="787400"/>
                </a:lnTo>
                <a:lnTo>
                  <a:pt x="10465689" y="774700"/>
                </a:lnTo>
                <a:lnTo>
                  <a:pt x="10465689" y="749300"/>
                </a:lnTo>
                <a:lnTo>
                  <a:pt x="10060940" y="749300"/>
                </a:lnTo>
                <a:lnTo>
                  <a:pt x="10060940" y="723900"/>
                </a:lnTo>
                <a:lnTo>
                  <a:pt x="9945243" y="723900"/>
                </a:lnTo>
                <a:lnTo>
                  <a:pt x="9945243" y="711200"/>
                </a:lnTo>
                <a:lnTo>
                  <a:pt x="9945243" y="698500"/>
                </a:lnTo>
                <a:lnTo>
                  <a:pt x="9656191" y="698500"/>
                </a:lnTo>
                <a:lnTo>
                  <a:pt x="9656191" y="685800"/>
                </a:lnTo>
                <a:lnTo>
                  <a:pt x="9656191" y="673100"/>
                </a:lnTo>
                <a:lnTo>
                  <a:pt x="9424924" y="673100"/>
                </a:lnTo>
                <a:lnTo>
                  <a:pt x="9424924" y="660400"/>
                </a:lnTo>
                <a:lnTo>
                  <a:pt x="9424924" y="647700"/>
                </a:lnTo>
                <a:lnTo>
                  <a:pt x="9309227" y="647700"/>
                </a:lnTo>
                <a:lnTo>
                  <a:pt x="9309227" y="622300"/>
                </a:lnTo>
                <a:lnTo>
                  <a:pt x="9020175" y="622300"/>
                </a:lnTo>
                <a:lnTo>
                  <a:pt x="9020175" y="609600"/>
                </a:lnTo>
                <a:lnTo>
                  <a:pt x="9020175" y="596900"/>
                </a:lnTo>
                <a:lnTo>
                  <a:pt x="8904478" y="596900"/>
                </a:lnTo>
                <a:lnTo>
                  <a:pt x="8904478" y="584200"/>
                </a:lnTo>
                <a:lnTo>
                  <a:pt x="8557514" y="584200"/>
                </a:lnTo>
                <a:lnTo>
                  <a:pt x="8557514" y="571500"/>
                </a:lnTo>
                <a:lnTo>
                  <a:pt x="8557514" y="558800"/>
                </a:lnTo>
                <a:lnTo>
                  <a:pt x="8499729" y="558800"/>
                </a:lnTo>
                <a:lnTo>
                  <a:pt x="8499729" y="546100"/>
                </a:lnTo>
                <a:lnTo>
                  <a:pt x="8210677" y="546100"/>
                </a:lnTo>
                <a:lnTo>
                  <a:pt x="8210677" y="533400"/>
                </a:lnTo>
                <a:lnTo>
                  <a:pt x="8152765" y="533400"/>
                </a:lnTo>
                <a:lnTo>
                  <a:pt x="8152765" y="520700"/>
                </a:lnTo>
                <a:lnTo>
                  <a:pt x="8037195" y="520700"/>
                </a:lnTo>
                <a:lnTo>
                  <a:pt x="8037195" y="495300"/>
                </a:lnTo>
                <a:lnTo>
                  <a:pt x="7979410" y="495300"/>
                </a:lnTo>
                <a:lnTo>
                  <a:pt x="7979410" y="482600"/>
                </a:lnTo>
                <a:lnTo>
                  <a:pt x="7574661" y="482600"/>
                </a:lnTo>
                <a:lnTo>
                  <a:pt x="7574661" y="469900"/>
                </a:lnTo>
                <a:lnTo>
                  <a:pt x="7574661" y="457200"/>
                </a:lnTo>
                <a:lnTo>
                  <a:pt x="7458964" y="457200"/>
                </a:lnTo>
                <a:lnTo>
                  <a:pt x="7458964" y="444500"/>
                </a:lnTo>
                <a:lnTo>
                  <a:pt x="7169912" y="444500"/>
                </a:lnTo>
                <a:lnTo>
                  <a:pt x="7169912" y="431800"/>
                </a:lnTo>
                <a:lnTo>
                  <a:pt x="6822948" y="431800"/>
                </a:lnTo>
                <a:lnTo>
                  <a:pt x="6822948" y="419100"/>
                </a:lnTo>
                <a:lnTo>
                  <a:pt x="6418199" y="419100"/>
                </a:lnTo>
                <a:lnTo>
                  <a:pt x="6418199" y="406400"/>
                </a:lnTo>
                <a:lnTo>
                  <a:pt x="6418199" y="393700"/>
                </a:lnTo>
                <a:lnTo>
                  <a:pt x="6129020" y="393700"/>
                </a:lnTo>
                <a:lnTo>
                  <a:pt x="6129020" y="381000"/>
                </a:lnTo>
                <a:lnTo>
                  <a:pt x="5897753" y="381000"/>
                </a:lnTo>
                <a:lnTo>
                  <a:pt x="5897753" y="368300"/>
                </a:lnTo>
                <a:lnTo>
                  <a:pt x="5839968" y="368300"/>
                </a:lnTo>
                <a:lnTo>
                  <a:pt x="5839968" y="355600"/>
                </a:lnTo>
                <a:lnTo>
                  <a:pt x="5493004" y="355600"/>
                </a:lnTo>
                <a:lnTo>
                  <a:pt x="5493004" y="342900"/>
                </a:lnTo>
                <a:lnTo>
                  <a:pt x="5261737" y="342900"/>
                </a:lnTo>
                <a:lnTo>
                  <a:pt x="5261737" y="330200"/>
                </a:lnTo>
                <a:lnTo>
                  <a:pt x="5088255" y="330200"/>
                </a:lnTo>
                <a:lnTo>
                  <a:pt x="5088255" y="317500"/>
                </a:lnTo>
                <a:lnTo>
                  <a:pt x="4972685" y="317500"/>
                </a:lnTo>
                <a:lnTo>
                  <a:pt x="4972685" y="304800"/>
                </a:lnTo>
                <a:lnTo>
                  <a:pt x="4914773" y="304800"/>
                </a:lnTo>
                <a:lnTo>
                  <a:pt x="4914773" y="292100"/>
                </a:lnTo>
                <a:lnTo>
                  <a:pt x="4625721" y="292100"/>
                </a:lnTo>
                <a:lnTo>
                  <a:pt x="4625721" y="279400"/>
                </a:lnTo>
                <a:lnTo>
                  <a:pt x="4394454" y="279400"/>
                </a:lnTo>
                <a:lnTo>
                  <a:pt x="4394454" y="266700"/>
                </a:lnTo>
                <a:lnTo>
                  <a:pt x="4278757" y="266700"/>
                </a:lnTo>
                <a:lnTo>
                  <a:pt x="4278757" y="254000"/>
                </a:lnTo>
                <a:lnTo>
                  <a:pt x="4047490" y="254000"/>
                </a:lnTo>
                <a:lnTo>
                  <a:pt x="4047490" y="241300"/>
                </a:lnTo>
                <a:lnTo>
                  <a:pt x="3989705" y="241300"/>
                </a:lnTo>
                <a:lnTo>
                  <a:pt x="3989705" y="228600"/>
                </a:lnTo>
                <a:lnTo>
                  <a:pt x="3931793" y="228600"/>
                </a:lnTo>
                <a:lnTo>
                  <a:pt x="3931793" y="215900"/>
                </a:lnTo>
                <a:lnTo>
                  <a:pt x="3816210" y="215900"/>
                </a:lnTo>
                <a:lnTo>
                  <a:pt x="3816210" y="203200"/>
                </a:lnTo>
                <a:lnTo>
                  <a:pt x="3758438" y="203200"/>
                </a:lnTo>
                <a:lnTo>
                  <a:pt x="3758438" y="190500"/>
                </a:lnTo>
                <a:lnTo>
                  <a:pt x="3353689" y="190500"/>
                </a:lnTo>
                <a:lnTo>
                  <a:pt x="3353689" y="177800"/>
                </a:lnTo>
                <a:lnTo>
                  <a:pt x="3295777" y="177800"/>
                </a:lnTo>
                <a:lnTo>
                  <a:pt x="3295777" y="165100"/>
                </a:lnTo>
                <a:lnTo>
                  <a:pt x="3064510" y="165100"/>
                </a:lnTo>
                <a:lnTo>
                  <a:pt x="3064510" y="152400"/>
                </a:lnTo>
                <a:lnTo>
                  <a:pt x="3006725" y="152400"/>
                </a:lnTo>
                <a:lnTo>
                  <a:pt x="3006725" y="139700"/>
                </a:lnTo>
                <a:lnTo>
                  <a:pt x="2833243" y="139700"/>
                </a:lnTo>
                <a:lnTo>
                  <a:pt x="2833243" y="127000"/>
                </a:lnTo>
                <a:lnTo>
                  <a:pt x="2659761" y="127000"/>
                </a:lnTo>
                <a:lnTo>
                  <a:pt x="2659761" y="114300"/>
                </a:lnTo>
                <a:lnTo>
                  <a:pt x="2544191" y="114300"/>
                </a:lnTo>
                <a:lnTo>
                  <a:pt x="2544191" y="101600"/>
                </a:lnTo>
                <a:lnTo>
                  <a:pt x="2486279" y="101600"/>
                </a:lnTo>
                <a:lnTo>
                  <a:pt x="2486279" y="88900"/>
                </a:lnTo>
                <a:lnTo>
                  <a:pt x="2312797" y="88900"/>
                </a:lnTo>
                <a:lnTo>
                  <a:pt x="2312797" y="76200"/>
                </a:lnTo>
                <a:lnTo>
                  <a:pt x="2197227" y="76200"/>
                </a:lnTo>
                <a:lnTo>
                  <a:pt x="2197227" y="63500"/>
                </a:lnTo>
                <a:lnTo>
                  <a:pt x="2081530" y="63500"/>
                </a:lnTo>
                <a:lnTo>
                  <a:pt x="2081530" y="50800"/>
                </a:lnTo>
                <a:lnTo>
                  <a:pt x="1850263" y="50800"/>
                </a:lnTo>
                <a:lnTo>
                  <a:pt x="1850263" y="38100"/>
                </a:lnTo>
                <a:lnTo>
                  <a:pt x="1561211" y="38100"/>
                </a:lnTo>
                <a:lnTo>
                  <a:pt x="1561211" y="25400"/>
                </a:lnTo>
                <a:lnTo>
                  <a:pt x="1214247" y="25400"/>
                </a:lnTo>
                <a:lnTo>
                  <a:pt x="1214247" y="12700"/>
                </a:lnTo>
                <a:lnTo>
                  <a:pt x="1156462" y="12700"/>
                </a:lnTo>
                <a:lnTo>
                  <a:pt x="1156462" y="0"/>
                </a:lnTo>
                <a:lnTo>
                  <a:pt x="0" y="0"/>
                </a:lnTo>
                <a:lnTo>
                  <a:pt x="0" y="12700"/>
                </a:lnTo>
                <a:lnTo>
                  <a:pt x="57785" y="12700"/>
                </a:lnTo>
                <a:lnTo>
                  <a:pt x="57785" y="25400"/>
                </a:lnTo>
                <a:lnTo>
                  <a:pt x="289052" y="25400"/>
                </a:lnTo>
                <a:lnTo>
                  <a:pt x="289052" y="38100"/>
                </a:lnTo>
                <a:lnTo>
                  <a:pt x="578231" y="38100"/>
                </a:lnTo>
                <a:lnTo>
                  <a:pt x="578231" y="50800"/>
                </a:lnTo>
                <a:lnTo>
                  <a:pt x="751713" y="50800"/>
                </a:lnTo>
                <a:lnTo>
                  <a:pt x="751713" y="63500"/>
                </a:lnTo>
                <a:lnTo>
                  <a:pt x="751713" y="76200"/>
                </a:lnTo>
                <a:lnTo>
                  <a:pt x="867283" y="76200"/>
                </a:lnTo>
                <a:lnTo>
                  <a:pt x="867283" y="88900"/>
                </a:lnTo>
                <a:lnTo>
                  <a:pt x="1098550" y="88900"/>
                </a:lnTo>
                <a:lnTo>
                  <a:pt x="1098550" y="101600"/>
                </a:lnTo>
                <a:lnTo>
                  <a:pt x="1156462" y="101600"/>
                </a:lnTo>
                <a:lnTo>
                  <a:pt x="1156462" y="114300"/>
                </a:lnTo>
                <a:lnTo>
                  <a:pt x="1214247" y="114300"/>
                </a:lnTo>
                <a:lnTo>
                  <a:pt x="1214247" y="127000"/>
                </a:lnTo>
                <a:lnTo>
                  <a:pt x="1387729" y="127000"/>
                </a:lnTo>
                <a:lnTo>
                  <a:pt x="1387729" y="139700"/>
                </a:lnTo>
                <a:lnTo>
                  <a:pt x="1676781" y="139700"/>
                </a:lnTo>
                <a:lnTo>
                  <a:pt x="1676781" y="152400"/>
                </a:lnTo>
                <a:lnTo>
                  <a:pt x="1850263" y="152400"/>
                </a:lnTo>
                <a:lnTo>
                  <a:pt x="1850263" y="165100"/>
                </a:lnTo>
                <a:lnTo>
                  <a:pt x="1850263" y="177800"/>
                </a:lnTo>
                <a:lnTo>
                  <a:pt x="2139442" y="177800"/>
                </a:lnTo>
                <a:lnTo>
                  <a:pt x="2139442" y="190500"/>
                </a:lnTo>
                <a:lnTo>
                  <a:pt x="2255012" y="190500"/>
                </a:lnTo>
                <a:lnTo>
                  <a:pt x="2255012" y="203200"/>
                </a:lnTo>
                <a:lnTo>
                  <a:pt x="2312797" y="203200"/>
                </a:lnTo>
                <a:lnTo>
                  <a:pt x="2312797" y="215900"/>
                </a:lnTo>
                <a:lnTo>
                  <a:pt x="2486279" y="215900"/>
                </a:lnTo>
                <a:lnTo>
                  <a:pt x="2486279" y="228600"/>
                </a:lnTo>
                <a:lnTo>
                  <a:pt x="2486279" y="241300"/>
                </a:lnTo>
                <a:lnTo>
                  <a:pt x="2544191" y="241300"/>
                </a:lnTo>
                <a:lnTo>
                  <a:pt x="2544191" y="254000"/>
                </a:lnTo>
                <a:lnTo>
                  <a:pt x="2717546" y="254000"/>
                </a:lnTo>
                <a:lnTo>
                  <a:pt x="2717546" y="266700"/>
                </a:lnTo>
                <a:lnTo>
                  <a:pt x="2833243" y="266700"/>
                </a:lnTo>
                <a:lnTo>
                  <a:pt x="2833243" y="279400"/>
                </a:lnTo>
                <a:lnTo>
                  <a:pt x="3006725" y="279400"/>
                </a:lnTo>
                <a:lnTo>
                  <a:pt x="3006725" y="292100"/>
                </a:lnTo>
                <a:lnTo>
                  <a:pt x="3006725" y="304800"/>
                </a:lnTo>
                <a:lnTo>
                  <a:pt x="3122295" y="304800"/>
                </a:lnTo>
                <a:lnTo>
                  <a:pt x="3122295" y="317500"/>
                </a:lnTo>
                <a:lnTo>
                  <a:pt x="3295777" y="317500"/>
                </a:lnTo>
                <a:lnTo>
                  <a:pt x="3295777" y="330200"/>
                </a:lnTo>
                <a:lnTo>
                  <a:pt x="3353689" y="330200"/>
                </a:lnTo>
                <a:lnTo>
                  <a:pt x="3353689" y="342900"/>
                </a:lnTo>
                <a:lnTo>
                  <a:pt x="3758438" y="342900"/>
                </a:lnTo>
                <a:lnTo>
                  <a:pt x="3758438" y="355600"/>
                </a:lnTo>
                <a:lnTo>
                  <a:pt x="3816210" y="355600"/>
                </a:lnTo>
                <a:lnTo>
                  <a:pt x="3816210" y="368300"/>
                </a:lnTo>
                <a:lnTo>
                  <a:pt x="3816210" y="381000"/>
                </a:lnTo>
                <a:lnTo>
                  <a:pt x="3931793" y="381000"/>
                </a:lnTo>
                <a:lnTo>
                  <a:pt x="3931793" y="393700"/>
                </a:lnTo>
                <a:lnTo>
                  <a:pt x="3989705" y="393700"/>
                </a:lnTo>
                <a:lnTo>
                  <a:pt x="3989705" y="406400"/>
                </a:lnTo>
                <a:lnTo>
                  <a:pt x="4047490" y="406400"/>
                </a:lnTo>
                <a:lnTo>
                  <a:pt x="4047490" y="419100"/>
                </a:lnTo>
                <a:lnTo>
                  <a:pt x="4163187" y="419100"/>
                </a:lnTo>
                <a:lnTo>
                  <a:pt x="4163187" y="431800"/>
                </a:lnTo>
                <a:lnTo>
                  <a:pt x="4278757" y="431800"/>
                </a:lnTo>
                <a:lnTo>
                  <a:pt x="4278757" y="444500"/>
                </a:lnTo>
                <a:lnTo>
                  <a:pt x="4336542" y="444500"/>
                </a:lnTo>
                <a:lnTo>
                  <a:pt x="4336542" y="457200"/>
                </a:lnTo>
                <a:lnTo>
                  <a:pt x="4452239" y="457200"/>
                </a:lnTo>
                <a:lnTo>
                  <a:pt x="4452239" y="469900"/>
                </a:lnTo>
                <a:lnTo>
                  <a:pt x="4625721" y="469900"/>
                </a:lnTo>
                <a:lnTo>
                  <a:pt x="4625721" y="482600"/>
                </a:lnTo>
                <a:lnTo>
                  <a:pt x="4914773" y="482600"/>
                </a:lnTo>
                <a:lnTo>
                  <a:pt x="4914773" y="495300"/>
                </a:lnTo>
                <a:lnTo>
                  <a:pt x="4972685" y="495300"/>
                </a:lnTo>
                <a:lnTo>
                  <a:pt x="4972685" y="520700"/>
                </a:lnTo>
                <a:lnTo>
                  <a:pt x="5146040" y="520700"/>
                </a:lnTo>
                <a:lnTo>
                  <a:pt x="5146040" y="533400"/>
                </a:lnTo>
                <a:lnTo>
                  <a:pt x="5261737" y="533400"/>
                </a:lnTo>
                <a:lnTo>
                  <a:pt x="5261737" y="546100"/>
                </a:lnTo>
                <a:lnTo>
                  <a:pt x="5493004" y="546100"/>
                </a:lnTo>
                <a:lnTo>
                  <a:pt x="5493004" y="558800"/>
                </a:lnTo>
                <a:lnTo>
                  <a:pt x="5839968" y="558800"/>
                </a:lnTo>
                <a:lnTo>
                  <a:pt x="5839968" y="571500"/>
                </a:lnTo>
                <a:lnTo>
                  <a:pt x="5897753" y="571500"/>
                </a:lnTo>
                <a:lnTo>
                  <a:pt x="5897753" y="584200"/>
                </a:lnTo>
                <a:lnTo>
                  <a:pt x="6013450" y="584200"/>
                </a:lnTo>
                <a:lnTo>
                  <a:pt x="6013450" y="596900"/>
                </a:lnTo>
                <a:lnTo>
                  <a:pt x="6129020" y="596900"/>
                </a:lnTo>
                <a:lnTo>
                  <a:pt x="6129020" y="609600"/>
                </a:lnTo>
                <a:lnTo>
                  <a:pt x="6418199" y="609600"/>
                </a:lnTo>
                <a:lnTo>
                  <a:pt x="6418199" y="622300"/>
                </a:lnTo>
                <a:lnTo>
                  <a:pt x="6418199" y="647700"/>
                </a:lnTo>
                <a:lnTo>
                  <a:pt x="6649466" y="647700"/>
                </a:lnTo>
                <a:lnTo>
                  <a:pt x="6649466" y="660400"/>
                </a:lnTo>
                <a:lnTo>
                  <a:pt x="6822948" y="660400"/>
                </a:lnTo>
                <a:lnTo>
                  <a:pt x="6822948" y="673100"/>
                </a:lnTo>
                <a:lnTo>
                  <a:pt x="7169912" y="673100"/>
                </a:lnTo>
                <a:lnTo>
                  <a:pt x="7169912" y="685800"/>
                </a:lnTo>
                <a:lnTo>
                  <a:pt x="7458964" y="685800"/>
                </a:lnTo>
                <a:lnTo>
                  <a:pt x="7458964" y="698500"/>
                </a:lnTo>
                <a:lnTo>
                  <a:pt x="7458964" y="711200"/>
                </a:lnTo>
                <a:lnTo>
                  <a:pt x="7574661" y="711200"/>
                </a:lnTo>
                <a:lnTo>
                  <a:pt x="7574661" y="723900"/>
                </a:lnTo>
                <a:lnTo>
                  <a:pt x="7574661" y="749300"/>
                </a:lnTo>
                <a:lnTo>
                  <a:pt x="7979410" y="749300"/>
                </a:lnTo>
                <a:lnTo>
                  <a:pt x="7979410" y="774700"/>
                </a:lnTo>
                <a:lnTo>
                  <a:pt x="8037195" y="774700"/>
                </a:lnTo>
                <a:lnTo>
                  <a:pt x="8037195" y="787400"/>
                </a:lnTo>
                <a:lnTo>
                  <a:pt x="8037195" y="800100"/>
                </a:lnTo>
                <a:lnTo>
                  <a:pt x="8152765" y="800100"/>
                </a:lnTo>
                <a:lnTo>
                  <a:pt x="8152765" y="812800"/>
                </a:lnTo>
                <a:lnTo>
                  <a:pt x="8210677" y="812800"/>
                </a:lnTo>
                <a:lnTo>
                  <a:pt x="8210677" y="838200"/>
                </a:lnTo>
                <a:lnTo>
                  <a:pt x="8499729" y="838200"/>
                </a:lnTo>
                <a:lnTo>
                  <a:pt x="8499729" y="863600"/>
                </a:lnTo>
                <a:lnTo>
                  <a:pt x="8557514" y="863600"/>
                </a:lnTo>
                <a:lnTo>
                  <a:pt x="8557514" y="901700"/>
                </a:lnTo>
                <a:lnTo>
                  <a:pt x="8904478" y="901700"/>
                </a:lnTo>
                <a:lnTo>
                  <a:pt x="8904478" y="927100"/>
                </a:lnTo>
                <a:lnTo>
                  <a:pt x="9020175" y="927100"/>
                </a:lnTo>
                <a:lnTo>
                  <a:pt x="9020175" y="965200"/>
                </a:lnTo>
                <a:lnTo>
                  <a:pt x="9309227" y="965200"/>
                </a:lnTo>
                <a:lnTo>
                  <a:pt x="9309227" y="1003300"/>
                </a:lnTo>
                <a:lnTo>
                  <a:pt x="9424924" y="1003300"/>
                </a:lnTo>
                <a:lnTo>
                  <a:pt x="9424924" y="1054100"/>
                </a:lnTo>
                <a:lnTo>
                  <a:pt x="9656191" y="1054100"/>
                </a:lnTo>
                <a:lnTo>
                  <a:pt x="9656191" y="1092200"/>
                </a:lnTo>
                <a:lnTo>
                  <a:pt x="9945243" y="1092200"/>
                </a:lnTo>
                <a:lnTo>
                  <a:pt x="9945243" y="1143000"/>
                </a:lnTo>
                <a:lnTo>
                  <a:pt x="10060940" y="1143000"/>
                </a:lnTo>
                <a:lnTo>
                  <a:pt x="10060940" y="1206500"/>
                </a:lnTo>
                <a:lnTo>
                  <a:pt x="10465689" y="1206500"/>
                </a:lnTo>
                <a:lnTo>
                  <a:pt x="10465689" y="1270000"/>
                </a:lnTo>
                <a:lnTo>
                  <a:pt x="12605131" y="1270000"/>
                </a:lnTo>
                <a:lnTo>
                  <a:pt x="12605131" y="1206500"/>
                </a:lnTo>
                <a:lnTo>
                  <a:pt x="12605131" y="1143000"/>
                </a:lnTo>
                <a:lnTo>
                  <a:pt x="12605131" y="800100"/>
                </a:lnTo>
                <a:lnTo>
                  <a:pt x="12605131" y="787400"/>
                </a:lnTo>
                <a:close/>
              </a:path>
            </a:pathLst>
          </a:custGeom>
          <a:solidFill>
            <a:srgbClr val="4DCE6B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4" name="bg object 34"/>
          <p:cNvSpPr/>
          <p:nvPr/>
        </p:nvSpPr>
        <p:spPr>
          <a:xfrm>
            <a:off x="1211453" y="735329"/>
            <a:ext cx="2717800" cy="152400"/>
          </a:xfrm>
          <a:custGeom>
            <a:avLst/>
            <a:gdLst/>
            <a:ahLst/>
            <a:cxnLst/>
            <a:rect l="l" t="t" r="r" b="b"/>
            <a:pathLst>
              <a:path w="2717800" h="152400">
                <a:moveTo>
                  <a:pt x="2717673" y="139700"/>
                </a:moveTo>
                <a:lnTo>
                  <a:pt x="2601976" y="139700"/>
                </a:lnTo>
                <a:lnTo>
                  <a:pt x="2601976" y="127000"/>
                </a:lnTo>
                <a:lnTo>
                  <a:pt x="2370709" y="127000"/>
                </a:lnTo>
                <a:lnTo>
                  <a:pt x="2370709" y="114300"/>
                </a:lnTo>
                <a:lnTo>
                  <a:pt x="2312924" y="114300"/>
                </a:lnTo>
                <a:lnTo>
                  <a:pt x="2312924" y="101600"/>
                </a:lnTo>
                <a:lnTo>
                  <a:pt x="1908175" y="101600"/>
                </a:lnTo>
                <a:lnTo>
                  <a:pt x="1908175" y="88900"/>
                </a:lnTo>
                <a:lnTo>
                  <a:pt x="1676781" y="88900"/>
                </a:lnTo>
                <a:lnTo>
                  <a:pt x="1676781" y="76200"/>
                </a:lnTo>
                <a:lnTo>
                  <a:pt x="1561211" y="76200"/>
                </a:lnTo>
                <a:lnTo>
                  <a:pt x="1561211" y="63500"/>
                </a:lnTo>
                <a:lnTo>
                  <a:pt x="1445514" y="63500"/>
                </a:lnTo>
                <a:lnTo>
                  <a:pt x="1445514" y="50800"/>
                </a:lnTo>
                <a:lnTo>
                  <a:pt x="1272032" y="50800"/>
                </a:lnTo>
                <a:lnTo>
                  <a:pt x="1272032" y="38100"/>
                </a:lnTo>
                <a:lnTo>
                  <a:pt x="1098677" y="38100"/>
                </a:lnTo>
                <a:lnTo>
                  <a:pt x="1098677" y="25400"/>
                </a:lnTo>
                <a:lnTo>
                  <a:pt x="867283" y="25400"/>
                </a:lnTo>
                <a:lnTo>
                  <a:pt x="867283" y="12700"/>
                </a:lnTo>
                <a:lnTo>
                  <a:pt x="578231" y="12700"/>
                </a:lnTo>
                <a:lnTo>
                  <a:pt x="578231" y="0"/>
                </a:lnTo>
                <a:lnTo>
                  <a:pt x="0" y="0"/>
                </a:lnTo>
                <a:lnTo>
                  <a:pt x="0" y="12700"/>
                </a:lnTo>
                <a:lnTo>
                  <a:pt x="404749" y="12700"/>
                </a:lnTo>
                <a:lnTo>
                  <a:pt x="404749" y="25400"/>
                </a:lnTo>
                <a:lnTo>
                  <a:pt x="520446" y="25400"/>
                </a:lnTo>
                <a:lnTo>
                  <a:pt x="520446" y="38100"/>
                </a:lnTo>
                <a:lnTo>
                  <a:pt x="578231" y="38100"/>
                </a:lnTo>
                <a:lnTo>
                  <a:pt x="578231" y="50800"/>
                </a:lnTo>
                <a:lnTo>
                  <a:pt x="693928" y="50800"/>
                </a:lnTo>
                <a:lnTo>
                  <a:pt x="693928" y="63500"/>
                </a:lnTo>
                <a:lnTo>
                  <a:pt x="867283" y="63500"/>
                </a:lnTo>
                <a:lnTo>
                  <a:pt x="867283" y="76200"/>
                </a:lnTo>
                <a:lnTo>
                  <a:pt x="1040765" y="76200"/>
                </a:lnTo>
                <a:lnTo>
                  <a:pt x="1040765" y="88900"/>
                </a:lnTo>
                <a:lnTo>
                  <a:pt x="1098677" y="88900"/>
                </a:lnTo>
                <a:lnTo>
                  <a:pt x="1098677" y="101600"/>
                </a:lnTo>
                <a:lnTo>
                  <a:pt x="1272032" y="101600"/>
                </a:lnTo>
                <a:lnTo>
                  <a:pt x="1272032" y="114300"/>
                </a:lnTo>
                <a:lnTo>
                  <a:pt x="1387729" y="114300"/>
                </a:lnTo>
                <a:lnTo>
                  <a:pt x="1387729" y="127000"/>
                </a:lnTo>
                <a:lnTo>
                  <a:pt x="1503426" y="127000"/>
                </a:lnTo>
                <a:lnTo>
                  <a:pt x="1503426" y="139700"/>
                </a:lnTo>
                <a:lnTo>
                  <a:pt x="1561211" y="139700"/>
                </a:lnTo>
                <a:lnTo>
                  <a:pt x="1561211" y="152400"/>
                </a:lnTo>
                <a:lnTo>
                  <a:pt x="2717673" y="152400"/>
                </a:lnTo>
                <a:lnTo>
                  <a:pt x="2717673" y="139700"/>
                </a:lnTo>
                <a:close/>
              </a:path>
            </a:pathLst>
          </a:custGeom>
          <a:solidFill>
            <a:srgbClr val="4DCE6B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5" name="bg object 35"/>
          <p:cNvSpPr/>
          <p:nvPr/>
        </p:nvSpPr>
        <p:spPr>
          <a:xfrm>
            <a:off x="5952871" y="1210436"/>
            <a:ext cx="9598660" cy="1397000"/>
          </a:xfrm>
          <a:custGeom>
            <a:avLst/>
            <a:gdLst/>
            <a:ahLst/>
            <a:cxnLst/>
            <a:rect l="l" t="t" r="r" b="b"/>
            <a:pathLst>
              <a:path w="9598660" h="1397000">
                <a:moveTo>
                  <a:pt x="1618996" y="88773"/>
                </a:moveTo>
                <a:lnTo>
                  <a:pt x="1561084" y="88773"/>
                </a:lnTo>
                <a:lnTo>
                  <a:pt x="1561084" y="76073"/>
                </a:lnTo>
                <a:lnTo>
                  <a:pt x="1387729" y="76073"/>
                </a:lnTo>
                <a:lnTo>
                  <a:pt x="1387729" y="63500"/>
                </a:lnTo>
                <a:lnTo>
                  <a:pt x="1329817" y="63500"/>
                </a:lnTo>
                <a:lnTo>
                  <a:pt x="1329817" y="50800"/>
                </a:lnTo>
                <a:lnTo>
                  <a:pt x="1272032" y="50800"/>
                </a:lnTo>
                <a:lnTo>
                  <a:pt x="1272032" y="38100"/>
                </a:lnTo>
                <a:lnTo>
                  <a:pt x="1214247" y="38100"/>
                </a:lnTo>
                <a:lnTo>
                  <a:pt x="1214247" y="25400"/>
                </a:lnTo>
                <a:lnTo>
                  <a:pt x="982980" y="25400"/>
                </a:lnTo>
                <a:lnTo>
                  <a:pt x="982980" y="12700"/>
                </a:lnTo>
                <a:lnTo>
                  <a:pt x="867283" y="12700"/>
                </a:lnTo>
                <a:lnTo>
                  <a:pt x="867283" y="0"/>
                </a:lnTo>
                <a:lnTo>
                  <a:pt x="0" y="0"/>
                </a:lnTo>
                <a:lnTo>
                  <a:pt x="0" y="12700"/>
                </a:lnTo>
                <a:lnTo>
                  <a:pt x="115570" y="12700"/>
                </a:lnTo>
                <a:lnTo>
                  <a:pt x="115570" y="25400"/>
                </a:lnTo>
                <a:lnTo>
                  <a:pt x="231267" y="25400"/>
                </a:lnTo>
                <a:lnTo>
                  <a:pt x="231267" y="38100"/>
                </a:lnTo>
                <a:lnTo>
                  <a:pt x="289052" y="38100"/>
                </a:lnTo>
                <a:lnTo>
                  <a:pt x="289052" y="50800"/>
                </a:lnTo>
                <a:lnTo>
                  <a:pt x="346837" y="50800"/>
                </a:lnTo>
                <a:lnTo>
                  <a:pt x="346837" y="63500"/>
                </a:lnTo>
                <a:lnTo>
                  <a:pt x="462534" y="63500"/>
                </a:lnTo>
                <a:lnTo>
                  <a:pt x="462534" y="76200"/>
                </a:lnTo>
                <a:lnTo>
                  <a:pt x="520319" y="76200"/>
                </a:lnTo>
                <a:lnTo>
                  <a:pt x="520319" y="88773"/>
                </a:lnTo>
                <a:lnTo>
                  <a:pt x="520319" y="101473"/>
                </a:lnTo>
                <a:lnTo>
                  <a:pt x="1618996" y="101473"/>
                </a:lnTo>
                <a:lnTo>
                  <a:pt x="1618996" y="88773"/>
                </a:lnTo>
                <a:close/>
              </a:path>
              <a:path w="9598660" h="1397000">
                <a:moveTo>
                  <a:pt x="2370582" y="152273"/>
                </a:moveTo>
                <a:lnTo>
                  <a:pt x="2255012" y="152273"/>
                </a:lnTo>
                <a:lnTo>
                  <a:pt x="2255012" y="139573"/>
                </a:lnTo>
                <a:lnTo>
                  <a:pt x="2139315" y="139573"/>
                </a:lnTo>
                <a:lnTo>
                  <a:pt x="2139315" y="127000"/>
                </a:lnTo>
                <a:lnTo>
                  <a:pt x="2023745" y="127000"/>
                </a:lnTo>
                <a:lnTo>
                  <a:pt x="2023745" y="114300"/>
                </a:lnTo>
                <a:lnTo>
                  <a:pt x="1792478" y="114300"/>
                </a:lnTo>
                <a:lnTo>
                  <a:pt x="1792478" y="101600"/>
                </a:lnTo>
                <a:lnTo>
                  <a:pt x="636003" y="101600"/>
                </a:lnTo>
                <a:lnTo>
                  <a:pt x="636003" y="114300"/>
                </a:lnTo>
                <a:lnTo>
                  <a:pt x="693801" y="114300"/>
                </a:lnTo>
                <a:lnTo>
                  <a:pt x="693801" y="127000"/>
                </a:lnTo>
                <a:lnTo>
                  <a:pt x="751586" y="127000"/>
                </a:lnTo>
                <a:lnTo>
                  <a:pt x="751586" y="139700"/>
                </a:lnTo>
                <a:lnTo>
                  <a:pt x="982980" y="139700"/>
                </a:lnTo>
                <a:lnTo>
                  <a:pt x="982980" y="152273"/>
                </a:lnTo>
                <a:lnTo>
                  <a:pt x="982980" y="164973"/>
                </a:lnTo>
                <a:lnTo>
                  <a:pt x="2370582" y="164973"/>
                </a:lnTo>
                <a:lnTo>
                  <a:pt x="2370582" y="152273"/>
                </a:lnTo>
                <a:close/>
              </a:path>
              <a:path w="9598660" h="1397000">
                <a:moveTo>
                  <a:pt x="3642741" y="279273"/>
                </a:moveTo>
                <a:lnTo>
                  <a:pt x="3527044" y="279273"/>
                </a:lnTo>
                <a:lnTo>
                  <a:pt x="3527044" y="266700"/>
                </a:lnTo>
                <a:lnTo>
                  <a:pt x="3237992" y="266700"/>
                </a:lnTo>
                <a:lnTo>
                  <a:pt x="3237992" y="254000"/>
                </a:lnTo>
                <a:lnTo>
                  <a:pt x="3122295" y="254000"/>
                </a:lnTo>
                <a:lnTo>
                  <a:pt x="3122295" y="241300"/>
                </a:lnTo>
                <a:lnTo>
                  <a:pt x="3064510" y="241300"/>
                </a:lnTo>
                <a:lnTo>
                  <a:pt x="3064510" y="228600"/>
                </a:lnTo>
                <a:lnTo>
                  <a:pt x="2891028" y="228600"/>
                </a:lnTo>
                <a:lnTo>
                  <a:pt x="2891028" y="215900"/>
                </a:lnTo>
                <a:lnTo>
                  <a:pt x="2659761" y="215900"/>
                </a:lnTo>
                <a:lnTo>
                  <a:pt x="2659761" y="203200"/>
                </a:lnTo>
                <a:lnTo>
                  <a:pt x="2601976" y="203200"/>
                </a:lnTo>
                <a:lnTo>
                  <a:pt x="2601976" y="190500"/>
                </a:lnTo>
                <a:lnTo>
                  <a:pt x="2544064" y="190500"/>
                </a:lnTo>
                <a:lnTo>
                  <a:pt x="2544064" y="177800"/>
                </a:lnTo>
                <a:lnTo>
                  <a:pt x="2428494" y="177800"/>
                </a:lnTo>
                <a:lnTo>
                  <a:pt x="2428494" y="165100"/>
                </a:lnTo>
                <a:lnTo>
                  <a:pt x="1214247" y="165100"/>
                </a:lnTo>
                <a:lnTo>
                  <a:pt x="1214247" y="177800"/>
                </a:lnTo>
                <a:lnTo>
                  <a:pt x="1272032" y="177800"/>
                </a:lnTo>
                <a:lnTo>
                  <a:pt x="1272032" y="190500"/>
                </a:lnTo>
                <a:lnTo>
                  <a:pt x="1329817" y="190500"/>
                </a:lnTo>
                <a:lnTo>
                  <a:pt x="1329817" y="203200"/>
                </a:lnTo>
                <a:lnTo>
                  <a:pt x="1387729" y="203200"/>
                </a:lnTo>
                <a:lnTo>
                  <a:pt x="1387729" y="215900"/>
                </a:lnTo>
                <a:lnTo>
                  <a:pt x="1445514" y="215900"/>
                </a:lnTo>
                <a:lnTo>
                  <a:pt x="1445514" y="228600"/>
                </a:lnTo>
                <a:lnTo>
                  <a:pt x="1561084" y="228600"/>
                </a:lnTo>
                <a:lnTo>
                  <a:pt x="1561084" y="241300"/>
                </a:lnTo>
                <a:lnTo>
                  <a:pt x="1618996" y="241300"/>
                </a:lnTo>
                <a:lnTo>
                  <a:pt x="1618996" y="254000"/>
                </a:lnTo>
                <a:lnTo>
                  <a:pt x="1792478" y="254000"/>
                </a:lnTo>
                <a:lnTo>
                  <a:pt x="1792478" y="266700"/>
                </a:lnTo>
                <a:lnTo>
                  <a:pt x="2023745" y="266700"/>
                </a:lnTo>
                <a:lnTo>
                  <a:pt x="2023745" y="279400"/>
                </a:lnTo>
                <a:lnTo>
                  <a:pt x="2081530" y="279400"/>
                </a:lnTo>
                <a:lnTo>
                  <a:pt x="2081530" y="291973"/>
                </a:lnTo>
                <a:lnTo>
                  <a:pt x="2197227" y="291973"/>
                </a:lnTo>
                <a:lnTo>
                  <a:pt x="2197227" y="304673"/>
                </a:lnTo>
                <a:lnTo>
                  <a:pt x="3642741" y="304673"/>
                </a:lnTo>
                <a:lnTo>
                  <a:pt x="3642741" y="291973"/>
                </a:lnTo>
                <a:lnTo>
                  <a:pt x="3642741" y="279273"/>
                </a:lnTo>
                <a:close/>
              </a:path>
              <a:path w="9598660" h="1397000">
                <a:moveTo>
                  <a:pt x="3989705" y="330073"/>
                </a:moveTo>
                <a:lnTo>
                  <a:pt x="3874008" y="330073"/>
                </a:lnTo>
                <a:lnTo>
                  <a:pt x="3874008" y="317500"/>
                </a:lnTo>
                <a:lnTo>
                  <a:pt x="3758311" y="317500"/>
                </a:lnTo>
                <a:lnTo>
                  <a:pt x="3758311" y="304800"/>
                </a:lnTo>
                <a:lnTo>
                  <a:pt x="2255012" y="304800"/>
                </a:lnTo>
                <a:lnTo>
                  <a:pt x="2255012" y="317500"/>
                </a:lnTo>
                <a:lnTo>
                  <a:pt x="2370582" y="317500"/>
                </a:lnTo>
                <a:lnTo>
                  <a:pt x="2370582" y="330200"/>
                </a:lnTo>
                <a:lnTo>
                  <a:pt x="2486279" y="330200"/>
                </a:lnTo>
                <a:lnTo>
                  <a:pt x="2486279" y="342773"/>
                </a:lnTo>
                <a:lnTo>
                  <a:pt x="2544064" y="342773"/>
                </a:lnTo>
                <a:lnTo>
                  <a:pt x="2544064" y="355473"/>
                </a:lnTo>
                <a:lnTo>
                  <a:pt x="3989705" y="355473"/>
                </a:lnTo>
                <a:lnTo>
                  <a:pt x="3989705" y="342773"/>
                </a:lnTo>
                <a:lnTo>
                  <a:pt x="3989705" y="330073"/>
                </a:lnTo>
                <a:close/>
              </a:path>
              <a:path w="9598660" h="1397000">
                <a:moveTo>
                  <a:pt x="5319522" y="482473"/>
                </a:moveTo>
                <a:lnTo>
                  <a:pt x="5146040" y="482473"/>
                </a:lnTo>
                <a:lnTo>
                  <a:pt x="5146040" y="469773"/>
                </a:lnTo>
                <a:lnTo>
                  <a:pt x="5088255" y="469773"/>
                </a:lnTo>
                <a:lnTo>
                  <a:pt x="5088255" y="457073"/>
                </a:lnTo>
                <a:lnTo>
                  <a:pt x="4799203" y="457073"/>
                </a:lnTo>
                <a:lnTo>
                  <a:pt x="4799203" y="444373"/>
                </a:lnTo>
                <a:lnTo>
                  <a:pt x="4799203" y="431673"/>
                </a:lnTo>
                <a:lnTo>
                  <a:pt x="4799203" y="418973"/>
                </a:lnTo>
                <a:lnTo>
                  <a:pt x="4625721" y="418973"/>
                </a:lnTo>
                <a:lnTo>
                  <a:pt x="4625721" y="406273"/>
                </a:lnTo>
                <a:lnTo>
                  <a:pt x="4625721" y="393573"/>
                </a:lnTo>
                <a:lnTo>
                  <a:pt x="4452239" y="393573"/>
                </a:lnTo>
                <a:lnTo>
                  <a:pt x="4452239" y="380873"/>
                </a:lnTo>
                <a:lnTo>
                  <a:pt x="4278757" y="380873"/>
                </a:lnTo>
                <a:lnTo>
                  <a:pt x="4278757" y="368173"/>
                </a:lnTo>
                <a:lnTo>
                  <a:pt x="4220972" y="368173"/>
                </a:lnTo>
                <a:lnTo>
                  <a:pt x="4220972" y="355600"/>
                </a:lnTo>
                <a:lnTo>
                  <a:pt x="2601976" y="355600"/>
                </a:lnTo>
                <a:lnTo>
                  <a:pt x="2601976" y="368300"/>
                </a:lnTo>
                <a:lnTo>
                  <a:pt x="2659761" y="368300"/>
                </a:lnTo>
                <a:lnTo>
                  <a:pt x="2659761" y="380873"/>
                </a:lnTo>
                <a:lnTo>
                  <a:pt x="2659761" y="393573"/>
                </a:lnTo>
                <a:lnTo>
                  <a:pt x="2891028" y="393573"/>
                </a:lnTo>
                <a:lnTo>
                  <a:pt x="2891028" y="406273"/>
                </a:lnTo>
                <a:lnTo>
                  <a:pt x="3064510" y="406273"/>
                </a:lnTo>
                <a:lnTo>
                  <a:pt x="3064510" y="418973"/>
                </a:lnTo>
                <a:lnTo>
                  <a:pt x="3122295" y="418973"/>
                </a:lnTo>
                <a:lnTo>
                  <a:pt x="3122295" y="431673"/>
                </a:lnTo>
                <a:lnTo>
                  <a:pt x="3237992" y="431673"/>
                </a:lnTo>
                <a:lnTo>
                  <a:pt x="3237992" y="444373"/>
                </a:lnTo>
                <a:lnTo>
                  <a:pt x="3295777" y="444373"/>
                </a:lnTo>
                <a:lnTo>
                  <a:pt x="3295777" y="457073"/>
                </a:lnTo>
                <a:lnTo>
                  <a:pt x="3642741" y="457073"/>
                </a:lnTo>
                <a:lnTo>
                  <a:pt x="3642741" y="469773"/>
                </a:lnTo>
                <a:lnTo>
                  <a:pt x="3642741" y="482473"/>
                </a:lnTo>
                <a:lnTo>
                  <a:pt x="3642741" y="495173"/>
                </a:lnTo>
                <a:lnTo>
                  <a:pt x="5319522" y="495173"/>
                </a:lnTo>
                <a:lnTo>
                  <a:pt x="5319522" y="482473"/>
                </a:lnTo>
                <a:close/>
              </a:path>
              <a:path w="9598660" h="1397000">
                <a:moveTo>
                  <a:pt x="5724271" y="545973"/>
                </a:moveTo>
                <a:lnTo>
                  <a:pt x="5666486" y="545973"/>
                </a:lnTo>
                <a:lnTo>
                  <a:pt x="5666486" y="533273"/>
                </a:lnTo>
                <a:lnTo>
                  <a:pt x="5493004" y="533273"/>
                </a:lnTo>
                <a:lnTo>
                  <a:pt x="5493004" y="520700"/>
                </a:lnTo>
                <a:lnTo>
                  <a:pt x="5377307" y="520700"/>
                </a:lnTo>
                <a:lnTo>
                  <a:pt x="5377307" y="495300"/>
                </a:lnTo>
                <a:lnTo>
                  <a:pt x="3758311" y="495300"/>
                </a:lnTo>
                <a:lnTo>
                  <a:pt x="3758311" y="520700"/>
                </a:lnTo>
                <a:lnTo>
                  <a:pt x="3874008" y="520700"/>
                </a:lnTo>
                <a:lnTo>
                  <a:pt x="3874008" y="533400"/>
                </a:lnTo>
                <a:lnTo>
                  <a:pt x="3989705" y="533400"/>
                </a:lnTo>
                <a:lnTo>
                  <a:pt x="3989705" y="545973"/>
                </a:lnTo>
                <a:lnTo>
                  <a:pt x="3989705" y="558673"/>
                </a:lnTo>
                <a:lnTo>
                  <a:pt x="5724271" y="558673"/>
                </a:lnTo>
                <a:lnTo>
                  <a:pt x="5724271" y="545973"/>
                </a:lnTo>
                <a:close/>
              </a:path>
              <a:path w="9598660" h="1397000">
                <a:moveTo>
                  <a:pt x="6186805" y="584073"/>
                </a:moveTo>
                <a:lnTo>
                  <a:pt x="6071235" y="584073"/>
                </a:lnTo>
                <a:lnTo>
                  <a:pt x="6071235" y="571373"/>
                </a:lnTo>
                <a:lnTo>
                  <a:pt x="5955538" y="571373"/>
                </a:lnTo>
                <a:lnTo>
                  <a:pt x="5955538" y="558800"/>
                </a:lnTo>
                <a:lnTo>
                  <a:pt x="4105275" y="558800"/>
                </a:lnTo>
                <a:lnTo>
                  <a:pt x="4105275" y="571500"/>
                </a:lnTo>
                <a:lnTo>
                  <a:pt x="4278757" y="571500"/>
                </a:lnTo>
                <a:lnTo>
                  <a:pt x="4278757" y="584073"/>
                </a:lnTo>
                <a:lnTo>
                  <a:pt x="4278757" y="596773"/>
                </a:lnTo>
                <a:lnTo>
                  <a:pt x="4452239" y="596773"/>
                </a:lnTo>
                <a:lnTo>
                  <a:pt x="4452239" y="609473"/>
                </a:lnTo>
                <a:lnTo>
                  <a:pt x="6186805" y="609473"/>
                </a:lnTo>
                <a:lnTo>
                  <a:pt x="6186805" y="596773"/>
                </a:lnTo>
                <a:lnTo>
                  <a:pt x="6186805" y="584073"/>
                </a:lnTo>
                <a:close/>
              </a:path>
              <a:path w="9598660" h="1397000">
                <a:moveTo>
                  <a:pt x="9598279" y="609600"/>
                </a:moveTo>
                <a:lnTo>
                  <a:pt x="8441944" y="609600"/>
                </a:lnTo>
                <a:lnTo>
                  <a:pt x="8441944" y="672973"/>
                </a:lnTo>
                <a:lnTo>
                  <a:pt x="7401052" y="672973"/>
                </a:lnTo>
                <a:lnTo>
                  <a:pt x="7401052" y="660273"/>
                </a:lnTo>
                <a:lnTo>
                  <a:pt x="6938518" y="660273"/>
                </a:lnTo>
                <a:lnTo>
                  <a:pt x="6938518" y="647573"/>
                </a:lnTo>
                <a:lnTo>
                  <a:pt x="6938518" y="634873"/>
                </a:lnTo>
                <a:lnTo>
                  <a:pt x="6533769" y="634873"/>
                </a:lnTo>
                <a:lnTo>
                  <a:pt x="6533769" y="622173"/>
                </a:lnTo>
                <a:lnTo>
                  <a:pt x="6302502" y="622173"/>
                </a:lnTo>
                <a:lnTo>
                  <a:pt x="6302502" y="609600"/>
                </a:lnTo>
                <a:lnTo>
                  <a:pt x="4510024" y="609600"/>
                </a:lnTo>
                <a:lnTo>
                  <a:pt x="4510024" y="622300"/>
                </a:lnTo>
                <a:lnTo>
                  <a:pt x="4625721" y="622300"/>
                </a:lnTo>
                <a:lnTo>
                  <a:pt x="4625721" y="634873"/>
                </a:lnTo>
                <a:lnTo>
                  <a:pt x="4625721" y="647573"/>
                </a:lnTo>
                <a:lnTo>
                  <a:pt x="4799203" y="647573"/>
                </a:lnTo>
                <a:lnTo>
                  <a:pt x="4799203" y="660273"/>
                </a:lnTo>
                <a:lnTo>
                  <a:pt x="4799203" y="672973"/>
                </a:lnTo>
                <a:lnTo>
                  <a:pt x="4799203" y="685673"/>
                </a:lnTo>
                <a:lnTo>
                  <a:pt x="5030470" y="685673"/>
                </a:lnTo>
                <a:lnTo>
                  <a:pt x="5030470" y="698373"/>
                </a:lnTo>
                <a:lnTo>
                  <a:pt x="5088255" y="698373"/>
                </a:lnTo>
                <a:lnTo>
                  <a:pt x="5088255" y="711073"/>
                </a:lnTo>
                <a:lnTo>
                  <a:pt x="5146040" y="711073"/>
                </a:lnTo>
                <a:lnTo>
                  <a:pt x="5146040" y="723773"/>
                </a:lnTo>
                <a:lnTo>
                  <a:pt x="5319522" y="723773"/>
                </a:lnTo>
                <a:lnTo>
                  <a:pt x="5319522" y="736473"/>
                </a:lnTo>
                <a:lnTo>
                  <a:pt x="5377307" y="736473"/>
                </a:lnTo>
                <a:lnTo>
                  <a:pt x="5377307" y="774573"/>
                </a:lnTo>
                <a:lnTo>
                  <a:pt x="5435219" y="774573"/>
                </a:lnTo>
                <a:lnTo>
                  <a:pt x="5435219" y="787273"/>
                </a:lnTo>
                <a:lnTo>
                  <a:pt x="5493004" y="787273"/>
                </a:lnTo>
                <a:lnTo>
                  <a:pt x="5493004" y="799973"/>
                </a:lnTo>
                <a:lnTo>
                  <a:pt x="5666486" y="799973"/>
                </a:lnTo>
                <a:lnTo>
                  <a:pt x="5666486" y="812673"/>
                </a:lnTo>
                <a:lnTo>
                  <a:pt x="5724271" y="812673"/>
                </a:lnTo>
                <a:lnTo>
                  <a:pt x="5724271" y="838073"/>
                </a:lnTo>
                <a:lnTo>
                  <a:pt x="5955538" y="838073"/>
                </a:lnTo>
                <a:lnTo>
                  <a:pt x="5955538" y="850773"/>
                </a:lnTo>
                <a:lnTo>
                  <a:pt x="6071235" y="850773"/>
                </a:lnTo>
                <a:lnTo>
                  <a:pt x="6071235" y="876173"/>
                </a:lnTo>
                <a:lnTo>
                  <a:pt x="6186805" y="876173"/>
                </a:lnTo>
                <a:lnTo>
                  <a:pt x="6186805" y="888873"/>
                </a:lnTo>
                <a:lnTo>
                  <a:pt x="6302502" y="888873"/>
                </a:lnTo>
                <a:lnTo>
                  <a:pt x="6302502" y="914273"/>
                </a:lnTo>
                <a:lnTo>
                  <a:pt x="6533769" y="914273"/>
                </a:lnTo>
                <a:lnTo>
                  <a:pt x="6533769" y="939673"/>
                </a:lnTo>
                <a:lnTo>
                  <a:pt x="6938518" y="939673"/>
                </a:lnTo>
                <a:lnTo>
                  <a:pt x="6938518" y="965073"/>
                </a:lnTo>
                <a:lnTo>
                  <a:pt x="7401052" y="965073"/>
                </a:lnTo>
                <a:lnTo>
                  <a:pt x="7401052" y="1028573"/>
                </a:lnTo>
                <a:lnTo>
                  <a:pt x="8441944" y="1028573"/>
                </a:lnTo>
                <a:lnTo>
                  <a:pt x="8441944" y="1396873"/>
                </a:lnTo>
                <a:lnTo>
                  <a:pt x="9598279" y="1396873"/>
                </a:lnTo>
                <a:lnTo>
                  <a:pt x="9598279" y="1028573"/>
                </a:lnTo>
                <a:lnTo>
                  <a:pt x="9598279" y="965073"/>
                </a:lnTo>
                <a:lnTo>
                  <a:pt x="9598279" y="672973"/>
                </a:lnTo>
                <a:lnTo>
                  <a:pt x="9598279" y="60960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6" name="bg object 36"/>
          <p:cNvSpPr/>
          <p:nvPr/>
        </p:nvSpPr>
        <p:spPr>
          <a:xfrm>
            <a:off x="1269238" y="727836"/>
            <a:ext cx="5551170" cy="495300"/>
          </a:xfrm>
          <a:custGeom>
            <a:avLst/>
            <a:gdLst/>
            <a:ahLst/>
            <a:cxnLst/>
            <a:rect l="l" t="t" r="r" b="b"/>
            <a:pathLst>
              <a:path w="5551170" h="495300">
                <a:moveTo>
                  <a:pt x="5203952" y="431673"/>
                </a:moveTo>
                <a:lnTo>
                  <a:pt x="5146167" y="431673"/>
                </a:lnTo>
                <a:lnTo>
                  <a:pt x="5146167" y="419100"/>
                </a:lnTo>
                <a:lnTo>
                  <a:pt x="5030470" y="419100"/>
                </a:lnTo>
                <a:lnTo>
                  <a:pt x="5030470" y="406400"/>
                </a:lnTo>
                <a:lnTo>
                  <a:pt x="4914900" y="406400"/>
                </a:lnTo>
                <a:lnTo>
                  <a:pt x="4914900" y="393700"/>
                </a:lnTo>
                <a:lnTo>
                  <a:pt x="4741418" y="393700"/>
                </a:lnTo>
                <a:lnTo>
                  <a:pt x="4741418" y="381000"/>
                </a:lnTo>
                <a:lnTo>
                  <a:pt x="4567936" y="381000"/>
                </a:lnTo>
                <a:lnTo>
                  <a:pt x="4567936" y="368300"/>
                </a:lnTo>
                <a:lnTo>
                  <a:pt x="4452366" y="368300"/>
                </a:lnTo>
                <a:lnTo>
                  <a:pt x="4452366" y="355600"/>
                </a:lnTo>
                <a:lnTo>
                  <a:pt x="4220972" y="355600"/>
                </a:lnTo>
                <a:lnTo>
                  <a:pt x="4220972" y="342900"/>
                </a:lnTo>
                <a:lnTo>
                  <a:pt x="4105402" y="342900"/>
                </a:lnTo>
                <a:lnTo>
                  <a:pt x="4105402" y="330200"/>
                </a:lnTo>
                <a:lnTo>
                  <a:pt x="3989705" y="330200"/>
                </a:lnTo>
                <a:lnTo>
                  <a:pt x="3989705" y="317500"/>
                </a:lnTo>
                <a:lnTo>
                  <a:pt x="3758438" y="317500"/>
                </a:lnTo>
                <a:lnTo>
                  <a:pt x="3758438" y="304800"/>
                </a:lnTo>
                <a:lnTo>
                  <a:pt x="3584956" y="304800"/>
                </a:lnTo>
                <a:lnTo>
                  <a:pt x="3584956" y="292100"/>
                </a:lnTo>
                <a:lnTo>
                  <a:pt x="3411474" y="292100"/>
                </a:lnTo>
                <a:lnTo>
                  <a:pt x="3411474" y="279400"/>
                </a:lnTo>
                <a:lnTo>
                  <a:pt x="3353689" y="279400"/>
                </a:lnTo>
                <a:lnTo>
                  <a:pt x="3353689" y="266700"/>
                </a:lnTo>
                <a:lnTo>
                  <a:pt x="3180207" y="266700"/>
                </a:lnTo>
                <a:lnTo>
                  <a:pt x="3180207" y="254000"/>
                </a:lnTo>
                <a:lnTo>
                  <a:pt x="3006725" y="254000"/>
                </a:lnTo>
                <a:lnTo>
                  <a:pt x="3006725" y="241300"/>
                </a:lnTo>
                <a:lnTo>
                  <a:pt x="2948940" y="241300"/>
                </a:lnTo>
                <a:lnTo>
                  <a:pt x="2948940" y="228600"/>
                </a:lnTo>
                <a:lnTo>
                  <a:pt x="2833370" y="228600"/>
                </a:lnTo>
                <a:lnTo>
                  <a:pt x="2833370" y="215900"/>
                </a:lnTo>
                <a:lnTo>
                  <a:pt x="2717673" y="215900"/>
                </a:lnTo>
                <a:lnTo>
                  <a:pt x="2717673" y="203200"/>
                </a:lnTo>
                <a:lnTo>
                  <a:pt x="2544191" y="203200"/>
                </a:lnTo>
                <a:lnTo>
                  <a:pt x="2544191" y="190500"/>
                </a:lnTo>
                <a:lnTo>
                  <a:pt x="2428621" y="190500"/>
                </a:lnTo>
                <a:lnTo>
                  <a:pt x="2428621" y="177800"/>
                </a:lnTo>
                <a:lnTo>
                  <a:pt x="2312924" y="177800"/>
                </a:lnTo>
                <a:lnTo>
                  <a:pt x="2312924" y="165100"/>
                </a:lnTo>
                <a:lnTo>
                  <a:pt x="2139442" y="165100"/>
                </a:lnTo>
                <a:lnTo>
                  <a:pt x="2139442" y="152400"/>
                </a:lnTo>
                <a:lnTo>
                  <a:pt x="1908175" y="152400"/>
                </a:lnTo>
                <a:lnTo>
                  <a:pt x="1908175" y="139700"/>
                </a:lnTo>
                <a:lnTo>
                  <a:pt x="1792478" y="139700"/>
                </a:lnTo>
                <a:lnTo>
                  <a:pt x="1792478" y="127000"/>
                </a:lnTo>
                <a:lnTo>
                  <a:pt x="1676908" y="127000"/>
                </a:lnTo>
                <a:lnTo>
                  <a:pt x="1676908" y="114300"/>
                </a:lnTo>
                <a:lnTo>
                  <a:pt x="1618996" y="114300"/>
                </a:lnTo>
                <a:lnTo>
                  <a:pt x="1618996" y="101600"/>
                </a:lnTo>
                <a:lnTo>
                  <a:pt x="1329944" y="101600"/>
                </a:lnTo>
                <a:lnTo>
                  <a:pt x="1329944" y="88900"/>
                </a:lnTo>
                <a:lnTo>
                  <a:pt x="1214247" y="88900"/>
                </a:lnTo>
                <a:lnTo>
                  <a:pt x="1214247" y="76200"/>
                </a:lnTo>
                <a:lnTo>
                  <a:pt x="1040892" y="76200"/>
                </a:lnTo>
                <a:lnTo>
                  <a:pt x="1040892" y="63500"/>
                </a:lnTo>
                <a:lnTo>
                  <a:pt x="925195" y="63500"/>
                </a:lnTo>
                <a:lnTo>
                  <a:pt x="925195" y="50800"/>
                </a:lnTo>
                <a:lnTo>
                  <a:pt x="809498" y="50800"/>
                </a:lnTo>
                <a:lnTo>
                  <a:pt x="809498" y="38100"/>
                </a:lnTo>
                <a:lnTo>
                  <a:pt x="578231" y="38100"/>
                </a:lnTo>
                <a:lnTo>
                  <a:pt x="578231" y="25400"/>
                </a:lnTo>
                <a:lnTo>
                  <a:pt x="404749" y="25400"/>
                </a:lnTo>
                <a:lnTo>
                  <a:pt x="404749" y="12700"/>
                </a:lnTo>
                <a:lnTo>
                  <a:pt x="231394" y="12700"/>
                </a:lnTo>
                <a:lnTo>
                  <a:pt x="231394" y="0"/>
                </a:lnTo>
                <a:lnTo>
                  <a:pt x="0" y="0"/>
                </a:lnTo>
                <a:lnTo>
                  <a:pt x="0" y="12700"/>
                </a:lnTo>
                <a:lnTo>
                  <a:pt x="173482" y="12700"/>
                </a:lnTo>
                <a:lnTo>
                  <a:pt x="173482" y="25400"/>
                </a:lnTo>
                <a:lnTo>
                  <a:pt x="289179" y="25400"/>
                </a:lnTo>
                <a:lnTo>
                  <a:pt x="289179" y="38100"/>
                </a:lnTo>
                <a:lnTo>
                  <a:pt x="404749" y="38100"/>
                </a:lnTo>
                <a:lnTo>
                  <a:pt x="404749" y="50800"/>
                </a:lnTo>
                <a:lnTo>
                  <a:pt x="462661" y="50800"/>
                </a:lnTo>
                <a:lnTo>
                  <a:pt x="462661" y="63500"/>
                </a:lnTo>
                <a:lnTo>
                  <a:pt x="636143" y="63500"/>
                </a:lnTo>
                <a:lnTo>
                  <a:pt x="636143" y="76200"/>
                </a:lnTo>
                <a:lnTo>
                  <a:pt x="809498" y="76200"/>
                </a:lnTo>
                <a:lnTo>
                  <a:pt x="809498" y="88900"/>
                </a:lnTo>
                <a:lnTo>
                  <a:pt x="867410" y="88900"/>
                </a:lnTo>
                <a:lnTo>
                  <a:pt x="867410" y="101600"/>
                </a:lnTo>
                <a:lnTo>
                  <a:pt x="982980" y="101600"/>
                </a:lnTo>
                <a:lnTo>
                  <a:pt x="982980" y="114300"/>
                </a:lnTo>
                <a:lnTo>
                  <a:pt x="1040892" y="114300"/>
                </a:lnTo>
                <a:lnTo>
                  <a:pt x="1040892" y="127000"/>
                </a:lnTo>
                <a:lnTo>
                  <a:pt x="1214247" y="127000"/>
                </a:lnTo>
                <a:lnTo>
                  <a:pt x="1214247" y="139700"/>
                </a:lnTo>
                <a:lnTo>
                  <a:pt x="1272159" y="139700"/>
                </a:lnTo>
                <a:lnTo>
                  <a:pt x="1272159" y="152400"/>
                </a:lnTo>
                <a:lnTo>
                  <a:pt x="1445641" y="152400"/>
                </a:lnTo>
                <a:lnTo>
                  <a:pt x="1445641" y="165100"/>
                </a:lnTo>
                <a:lnTo>
                  <a:pt x="1618996" y="165100"/>
                </a:lnTo>
                <a:lnTo>
                  <a:pt x="1618996" y="177800"/>
                </a:lnTo>
                <a:lnTo>
                  <a:pt x="1676908" y="177800"/>
                </a:lnTo>
                <a:lnTo>
                  <a:pt x="1676908" y="190500"/>
                </a:lnTo>
                <a:lnTo>
                  <a:pt x="1792478" y="190500"/>
                </a:lnTo>
                <a:lnTo>
                  <a:pt x="1792478" y="203200"/>
                </a:lnTo>
                <a:lnTo>
                  <a:pt x="1908175" y="203200"/>
                </a:lnTo>
                <a:lnTo>
                  <a:pt x="1908175" y="215900"/>
                </a:lnTo>
                <a:lnTo>
                  <a:pt x="2023745" y="215900"/>
                </a:lnTo>
                <a:lnTo>
                  <a:pt x="2023745" y="228600"/>
                </a:lnTo>
                <a:lnTo>
                  <a:pt x="2139442" y="228600"/>
                </a:lnTo>
                <a:lnTo>
                  <a:pt x="2139442" y="241300"/>
                </a:lnTo>
                <a:lnTo>
                  <a:pt x="2312924" y="241300"/>
                </a:lnTo>
                <a:lnTo>
                  <a:pt x="2312924" y="254000"/>
                </a:lnTo>
                <a:lnTo>
                  <a:pt x="2428621" y="254000"/>
                </a:lnTo>
                <a:lnTo>
                  <a:pt x="2428621" y="266700"/>
                </a:lnTo>
                <a:lnTo>
                  <a:pt x="2544191" y="266700"/>
                </a:lnTo>
                <a:lnTo>
                  <a:pt x="2544191" y="279400"/>
                </a:lnTo>
                <a:lnTo>
                  <a:pt x="2659888" y="279400"/>
                </a:lnTo>
                <a:lnTo>
                  <a:pt x="2659888" y="292100"/>
                </a:lnTo>
                <a:lnTo>
                  <a:pt x="2775458" y="292100"/>
                </a:lnTo>
                <a:lnTo>
                  <a:pt x="2775458" y="304800"/>
                </a:lnTo>
                <a:lnTo>
                  <a:pt x="2891155" y="304800"/>
                </a:lnTo>
                <a:lnTo>
                  <a:pt x="2891155" y="317500"/>
                </a:lnTo>
                <a:lnTo>
                  <a:pt x="2948940" y="317500"/>
                </a:lnTo>
                <a:lnTo>
                  <a:pt x="2948940" y="330200"/>
                </a:lnTo>
                <a:lnTo>
                  <a:pt x="3006725" y="330200"/>
                </a:lnTo>
                <a:lnTo>
                  <a:pt x="3006725" y="342900"/>
                </a:lnTo>
                <a:lnTo>
                  <a:pt x="3122422" y="342900"/>
                </a:lnTo>
                <a:lnTo>
                  <a:pt x="3122422" y="355600"/>
                </a:lnTo>
                <a:lnTo>
                  <a:pt x="3295904" y="355600"/>
                </a:lnTo>
                <a:lnTo>
                  <a:pt x="3295904" y="368300"/>
                </a:lnTo>
                <a:lnTo>
                  <a:pt x="3411474" y="368300"/>
                </a:lnTo>
                <a:lnTo>
                  <a:pt x="3411474" y="381000"/>
                </a:lnTo>
                <a:lnTo>
                  <a:pt x="3469386" y="381000"/>
                </a:lnTo>
                <a:lnTo>
                  <a:pt x="3469386" y="393700"/>
                </a:lnTo>
                <a:lnTo>
                  <a:pt x="3584956" y="393700"/>
                </a:lnTo>
                <a:lnTo>
                  <a:pt x="3584956" y="406400"/>
                </a:lnTo>
                <a:lnTo>
                  <a:pt x="3816223" y="406400"/>
                </a:lnTo>
                <a:lnTo>
                  <a:pt x="3816223" y="419100"/>
                </a:lnTo>
                <a:lnTo>
                  <a:pt x="3989705" y="419100"/>
                </a:lnTo>
                <a:lnTo>
                  <a:pt x="3989705" y="431800"/>
                </a:lnTo>
                <a:lnTo>
                  <a:pt x="4105402" y="431800"/>
                </a:lnTo>
                <a:lnTo>
                  <a:pt x="4105402" y="444373"/>
                </a:lnTo>
                <a:lnTo>
                  <a:pt x="4163187" y="444373"/>
                </a:lnTo>
                <a:lnTo>
                  <a:pt x="4163187" y="457073"/>
                </a:lnTo>
                <a:lnTo>
                  <a:pt x="5203952" y="457073"/>
                </a:lnTo>
                <a:lnTo>
                  <a:pt x="5203952" y="444373"/>
                </a:lnTo>
                <a:lnTo>
                  <a:pt x="5203952" y="431673"/>
                </a:lnTo>
                <a:close/>
              </a:path>
              <a:path w="5551170" h="495300">
                <a:moveTo>
                  <a:pt x="5550916" y="482600"/>
                </a:moveTo>
                <a:lnTo>
                  <a:pt x="5435219" y="482600"/>
                </a:lnTo>
                <a:lnTo>
                  <a:pt x="5435219" y="469900"/>
                </a:lnTo>
                <a:lnTo>
                  <a:pt x="5319636" y="469900"/>
                </a:lnTo>
                <a:lnTo>
                  <a:pt x="5319636" y="457200"/>
                </a:lnTo>
                <a:lnTo>
                  <a:pt x="4278884" y="457200"/>
                </a:lnTo>
                <a:lnTo>
                  <a:pt x="4278884" y="469900"/>
                </a:lnTo>
                <a:lnTo>
                  <a:pt x="4510151" y="469900"/>
                </a:lnTo>
                <a:lnTo>
                  <a:pt x="4510151" y="482600"/>
                </a:lnTo>
                <a:lnTo>
                  <a:pt x="4683633" y="482600"/>
                </a:lnTo>
                <a:lnTo>
                  <a:pt x="4683633" y="495300"/>
                </a:lnTo>
                <a:lnTo>
                  <a:pt x="5550916" y="495300"/>
                </a:lnTo>
                <a:lnTo>
                  <a:pt x="5550916" y="48260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822960" y="365760"/>
            <a:ext cx="1481328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822960" y="2103120"/>
            <a:ext cx="1481328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5596128" y="8503920"/>
            <a:ext cx="5266944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822960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11850624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 descr=""/>
          <p:cNvSpPr txBox="1"/>
          <p:nvPr/>
        </p:nvSpPr>
        <p:spPr>
          <a:xfrm>
            <a:off x="13058139" y="731773"/>
            <a:ext cx="255778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370">
                <a:solidFill>
                  <a:srgbClr val="E95359"/>
                </a:solidFill>
                <a:latin typeface="Arial"/>
                <a:cs typeface="Arial"/>
              </a:rPr>
              <a:t>+++++++++++++++++++++++++++++++++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 descr=""/>
          <p:cNvSpPr txBox="1"/>
          <p:nvPr/>
        </p:nvSpPr>
        <p:spPr>
          <a:xfrm>
            <a:off x="8060055" y="950086"/>
            <a:ext cx="42856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41666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39682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37698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35714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33730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31746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29761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27777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25793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23809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21825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9841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7857" sz="2100" spc="-555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15873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3888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9920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7936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5952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3968" sz="2100" spc="-555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1984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sz="1400" spc="-370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-3968" sz="2100" spc="-555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-5952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7936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-9920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1904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3888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5873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-17857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endParaRPr baseline="-17857" sz="2100">
              <a:latin typeface="Arial"/>
              <a:cs typeface="Arial"/>
            </a:endParaRPr>
          </a:p>
        </p:txBody>
      </p:sp>
      <p:sp>
        <p:nvSpPr>
          <p:cNvPr id="4" name="object 4" descr=""/>
          <p:cNvSpPr txBox="1"/>
          <p:nvPr/>
        </p:nvSpPr>
        <p:spPr>
          <a:xfrm>
            <a:off x="12223242" y="1082167"/>
            <a:ext cx="23196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1825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19841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7857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3888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1904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9920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7936" sz="2100" spc="-555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5952" sz="2100" spc="-555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3968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sz="1400" spc="-370">
                <a:solidFill>
                  <a:srgbClr val="41A3FF"/>
                </a:solidFill>
                <a:latin typeface="Arial"/>
                <a:cs typeface="Arial"/>
              </a:rPr>
              <a:t>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5" name="object 5" descr=""/>
          <p:cNvSpPr txBox="1"/>
          <p:nvPr/>
        </p:nvSpPr>
        <p:spPr>
          <a:xfrm>
            <a:off x="14420341" y="1129792"/>
            <a:ext cx="127889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7936" sz="2100" spc="-540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sz="1400" spc="-360">
                <a:solidFill>
                  <a:srgbClr val="41A3FF"/>
                </a:solidFill>
                <a:latin typeface="Arial"/>
                <a:cs typeface="Arial"/>
              </a:rPr>
              <a:t>+++++++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 descr=""/>
          <p:cNvSpPr txBox="1"/>
          <p:nvPr/>
        </p:nvSpPr>
        <p:spPr>
          <a:xfrm>
            <a:off x="7770876" y="1093596"/>
            <a:ext cx="15678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3809" sz="2100" spc="-547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21825" sz="2100" spc="-547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19841" sz="2100" spc="-547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7857" sz="2100" spc="-547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3888" sz="2100" spc="-547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9920" sz="2100" spc="-547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7936" sz="2100" spc="-547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5952" sz="2100" spc="-547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3968" sz="2100" spc="-547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1984" sz="2100" spc="-547">
                <a:solidFill>
                  <a:srgbClr val="DFD625"/>
                </a:solidFill>
                <a:latin typeface="Arial"/>
                <a:cs typeface="Arial"/>
              </a:rPr>
              <a:t>++++++</a:t>
            </a:r>
            <a:r>
              <a:rPr dirty="0" sz="1400" spc="-365">
                <a:solidFill>
                  <a:srgbClr val="DFD625"/>
                </a:solidFill>
                <a:latin typeface="Arial"/>
                <a:cs typeface="Arial"/>
              </a:rPr>
              <a:t>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7" name="object 7" descr=""/>
          <p:cNvSpPr txBox="1"/>
          <p:nvPr/>
        </p:nvSpPr>
        <p:spPr>
          <a:xfrm>
            <a:off x="9216517" y="1131189"/>
            <a:ext cx="122110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7936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984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sz="1400" spc="-36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984" sz="2100" spc="-540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3968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5952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1904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3888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5873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7857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21825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endParaRPr baseline="-21825" sz="2100">
              <a:latin typeface="Arial"/>
              <a:cs typeface="Arial"/>
            </a:endParaRPr>
          </a:p>
        </p:txBody>
      </p:sp>
      <p:sp>
        <p:nvSpPr>
          <p:cNvPr id="8" name="object 8" descr=""/>
          <p:cNvSpPr txBox="1"/>
          <p:nvPr/>
        </p:nvSpPr>
        <p:spPr>
          <a:xfrm>
            <a:off x="12165330" y="1351153"/>
            <a:ext cx="168402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1400" spc="-325">
                <a:solidFill>
                  <a:srgbClr val="DFD625"/>
                </a:solidFill>
                <a:latin typeface="Arial"/>
                <a:cs typeface="Arial"/>
              </a:rPr>
              <a:t>++++++</a:t>
            </a:r>
            <a:r>
              <a:rPr dirty="0" baseline="-9920" sz="2100" spc="-487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5873" sz="2100" spc="-487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19841" sz="2100" spc="-487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25793" sz="2100" spc="-487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39682" sz="2100" spc="-487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-47619" sz="2100" spc="-487">
                <a:solidFill>
                  <a:srgbClr val="DFD625"/>
                </a:solidFill>
                <a:latin typeface="Arial"/>
                <a:cs typeface="Arial"/>
              </a:rPr>
              <a:t>++++++</a:t>
            </a:r>
            <a:endParaRPr baseline="-47619" sz="2100">
              <a:latin typeface="Arial"/>
              <a:cs typeface="Arial"/>
            </a:endParaRPr>
          </a:p>
        </p:txBody>
      </p:sp>
      <p:sp>
        <p:nvSpPr>
          <p:cNvPr id="9" name="object 9" descr=""/>
          <p:cNvSpPr txBox="1"/>
          <p:nvPr/>
        </p:nvSpPr>
        <p:spPr>
          <a:xfrm>
            <a:off x="13726540" y="1567942"/>
            <a:ext cx="93218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1400" spc="-315">
                <a:solidFill>
                  <a:srgbClr val="DFD625"/>
                </a:solidFill>
                <a:latin typeface="Arial"/>
                <a:cs typeface="Arial"/>
              </a:rPr>
              <a:t>+++++++++</a:t>
            </a:r>
            <a:r>
              <a:rPr dirty="0" baseline="-19841" sz="2100" spc="-472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endParaRPr baseline="-19841" sz="2100">
              <a:latin typeface="Arial"/>
              <a:cs typeface="Arial"/>
            </a:endParaRPr>
          </a:p>
        </p:txBody>
      </p:sp>
      <p:sp>
        <p:nvSpPr>
          <p:cNvPr id="10" name="object 10" descr=""/>
          <p:cNvSpPr txBox="1"/>
          <p:nvPr/>
        </p:nvSpPr>
        <p:spPr>
          <a:xfrm>
            <a:off x="15255239" y="1966848"/>
            <a:ext cx="41846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240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sz="1400" spc="145">
                <a:solidFill>
                  <a:srgbClr val="DFD625"/>
                </a:solidFill>
                <a:latin typeface="Arial"/>
                <a:cs typeface="Arial"/>
              </a:rPr>
              <a:t> </a:t>
            </a:r>
            <a:r>
              <a:rPr dirty="0" sz="1400" spc="-50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11" name="object 11" descr=""/>
          <p:cNvSpPr txBox="1"/>
          <p:nvPr/>
        </p:nvSpPr>
        <p:spPr>
          <a:xfrm>
            <a:off x="11991847" y="1714372"/>
            <a:ext cx="127889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49603" sz="2100" spc="-2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37698" sz="2100" spc="-262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27777" sz="2100" spc="-2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27777" sz="2100" spc="150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baseline="13888" sz="2100" spc="-41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sz="1400" spc="-275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12" name="object 12" descr=""/>
          <p:cNvSpPr txBox="1"/>
          <p:nvPr/>
        </p:nvSpPr>
        <p:spPr>
          <a:xfrm>
            <a:off x="1121410" y="622172"/>
            <a:ext cx="1203388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13888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1904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9920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968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984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968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5952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7936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9920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1904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3888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5873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9841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3888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15873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19841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5952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9920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11904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3888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5873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7857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984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3968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-5952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7936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-9920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-11904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3888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5873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-17857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9841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-21825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23809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5952" sz="2100" spc="-562">
                <a:solidFill>
                  <a:srgbClr val="E95359"/>
                </a:solidFill>
                <a:latin typeface="Arial"/>
                <a:cs typeface="Arial"/>
              </a:rPr>
              <a:t>++++++++</a:t>
            </a:r>
            <a:r>
              <a:rPr dirty="0" baseline="3968" sz="2100" spc="-562">
                <a:solidFill>
                  <a:srgbClr val="E95359"/>
                </a:solidFill>
                <a:latin typeface="Arial"/>
                <a:cs typeface="Arial"/>
              </a:rPr>
              <a:t>++++++++++</a:t>
            </a:r>
            <a:r>
              <a:rPr dirty="0" baseline="1984" sz="2100" spc="-562">
                <a:solidFill>
                  <a:srgbClr val="E95359"/>
                </a:solidFill>
                <a:latin typeface="Arial"/>
                <a:cs typeface="Arial"/>
              </a:rPr>
              <a:t>++++++++++++++++++</a:t>
            </a:r>
            <a:r>
              <a:rPr dirty="0" sz="1400" spc="-375">
                <a:solidFill>
                  <a:srgbClr val="E95359"/>
                </a:solidFill>
                <a:latin typeface="Arial"/>
                <a:cs typeface="Arial"/>
              </a:rPr>
              <a:t>++++++++</a:t>
            </a:r>
            <a:r>
              <a:rPr dirty="0" baseline="-1984" sz="2100" spc="-562">
                <a:solidFill>
                  <a:srgbClr val="E95359"/>
                </a:solidFill>
                <a:latin typeface="Arial"/>
                <a:cs typeface="Arial"/>
              </a:rPr>
              <a:t>+++++++</a:t>
            </a:r>
            <a:r>
              <a:rPr dirty="0" baseline="-3968" sz="2100" spc="-562">
                <a:solidFill>
                  <a:srgbClr val="E95359"/>
                </a:solidFill>
                <a:latin typeface="Arial"/>
                <a:cs typeface="Arial"/>
              </a:rPr>
              <a:t>++++++++</a:t>
            </a:r>
            <a:r>
              <a:rPr dirty="0" baseline="-5952" sz="2100" spc="-562">
                <a:solidFill>
                  <a:srgbClr val="E95359"/>
                </a:solidFill>
                <a:latin typeface="Arial"/>
                <a:cs typeface="Arial"/>
              </a:rPr>
              <a:t>++</a:t>
            </a:r>
            <a:r>
              <a:rPr dirty="0" baseline="-7936" sz="2100" spc="-562">
                <a:solidFill>
                  <a:srgbClr val="E95359"/>
                </a:solidFill>
                <a:latin typeface="Arial"/>
                <a:cs typeface="Arial"/>
              </a:rPr>
              <a:t>++</a:t>
            </a:r>
            <a:r>
              <a:rPr dirty="0" baseline="-9920" sz="2100" spc="-562">
                <a:solidFill>
                  <a:srgbClr val="E95359"/>
                </a:solidFill>
                <a:latin typeface="Arial"/>
                <a:cs typeface="Arial"/>
              </a:rPr>
              <a:t>+++++</a:t>
            </a:r>
            <a:r>
              <a:rPr dirty="0" baseline="-11904" sz="2100" spc="-562">
                <a:solidFill>
                  <a:srgbClr val="E95359"/>
                </a:solidFill>
                <a:latin typeface="Arial"/>
                <a:cs typeface="Arial"/>
              </a:rPr>
              <a:t>+++++++</a:t>
            </a:r>
            <a:r>
              <a:rPr dirty="0" baseline="-13888" sz="2100" spc="-562">
                <a:solidFill>
                  <a:srgbClr val="E95359"/>
                </a:solidFill>
                <a:latin typeface="Arial"/>
                <a:cs typeface="Arial"/>
              </a:rPr>
              <a:t>+++++</a:t>
            </a:r>
            <a:r>
              <a:rPr dirty="0" baseline="-15873" sz="2100" spc="-562">
                <a:solidFill>
                  <a:srgbClr val="E95359"/>
                </a:solidFill>
                <a:latin typeface="Arial"/>
                <a:cs typeface="Arial"/>
              </a:rPr>
              <a:t>++++</a:t>
            </a:r>
            <a:r>
              <a:rPr dirty="0" baseline="-17857" sz="2100" spc="-562">
                <a:solidFill>
                  <a:srgbClr val="E95359"/>
                </a:solidFill>
                <a:latin typeface="Arial"/>
                <a:cs typeface="Arial"/>
              </a:rPr>
              <a:t>++++++++++++</a:t>
            </a:r>
            <a:r>
              <a:rPr dirty="0" baseline="-19841" sz="2100" spc="-562">
                <a:solidFill>
                  <a:srgbClr val="E95359"/>
                </a:solidFill>
                <a:latin typeface="Arial"/>
                <a:cs typeface="Arial"/>
              </a:rPr>
              <a:t>+</a:t>
            </a:r>
            <a:r>
              <a:rPr dirty="0" baseline="-21825" sz="2100" spc="-562">
                <a:solidFill>
                  <a:srgbClr val="E95359"/>
                </a:solidFill>
                <a:latin typeface="Arial"/>
                <a:cs typeface="Arial"/>
              </a:rPr>
              <a:t>+++</a:t>
            </a:r>
            <a:r>
              <a:rPr dirty="0" baseline="-23809" sz="2100" spc="-562">
                <a:solidFill>
                  <a:srgbClr val="E95359"/>
                </a:solidFill>
                <a:latin typeface="Arial"/>
                <a:cs typeface="Arial"/>
              </a:rPr>
              <a:t>+</a:t>
            </a:r>
            <a:r>
              <a:rPr dirty="0" baseline="-25793" sz="2100" spc="-562">
                <a:solidFill>
                  <a:srgbClr val="E95359"/>
                </a:solidFill>
                <a:latin typeface="Arial"/>
                <a:cs typeface="Arial"/>
              </a:rPr>
              <a:t>++++++++++++++</a:t>
            </a:r>
            <a:r>
              <a:rPr dirty="0" baseline="-27777" sz="2100" spc="-562">
                <a:solidFill>
                  <a:srgbClr val="E95359"/>
                </a:solidFill>
                <a:latin typeface="Arial"/>
                <a:cs typeface="Arial"/>
              </a:rPr>
              <a:t>++++++++++++++++++</a:t>
            </a:r>
            <a:r>
              <a:rPr dirty="0" baseline="-31746" sz="2100" spc="-562">
                <a:solidFill>
                  <a:srgbClr val="E95359"/>
                </a:solidFill>
                <a:latin typeface="Arial"/>
                <a:cs typeface="Arial"/>
              </a:rPr>
              <a:t>+++++</a:t>
            </a:r>
            <a:endParaRPr baseline="-31746" sz="2100">
              <a:latin typeface="Arial"/>
              <a:cs typeface="Arial"/>
            </a:endParaRPr>
          </a:p>
        </p:txBody>
      </p:sp>
      <p:sp>
        <p:nvSpPr>
          <p:cNvPr id="13" name="object 13" descr=""/>
          <p:cNvSpPr txBox="1"/>
          <p:nvPr/>
        </p:nvSpPr>
        <p:spPr>
          <a:xfrm>
            <a:off x="2393569" y="810894"/>
            <a:ext cx="578929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39682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5714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3730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1746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1746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7777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5793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3809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1825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3888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9920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7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9920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5952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984" sz="2100" spc="-555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sz="1400" spc="-370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3888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1904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9920" sz="2100" spc="-555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7936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5952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sz="1400" spc="-37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3730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31746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29761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27777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25793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23809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21825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19841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17857" sz="2100" spc="-555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15873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3888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11904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9920" sz="2100" spc="-555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7936" sz="2100" spc="-555">
                <a:solidFill>
                  <a:srgbClr val="41A3FF"/>
                </a:solidFill>
                <a:latin typeface="Arial"/>
                <a:cs typeface="Arial"/>
              </a:rPr>
              <a:t>+++++++</a:t>
            </a:r>
            <a:r>
              <a:rPr dirty="0" baseline="5952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984" sz="2100" spc="-55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sz="1400" spc="-370">
                <a:solidFill>
                  <a:srgbClr val="41A3FF"/>
                </a:solidFill>
                <a:latin typeface="Arial"/>
                <a:cs typeface="Arial"/>
              </a:rPr>
              <a:t>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14" name="object 14" descr=""/>
          <p:cNvSpPr txBox="1"/>
          <p:nvPr/>
        </p:nvSpPr>
        <p:spPr>
          <a:xfrm>
            <a:off x="3723385" y="918464"/>
            <a:ext cx="417004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31746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9761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7777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5793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3809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1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1904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9920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70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3968" sz="2100" spc="-5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5952" sz="2100" spc="-5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3888" sz="2100" spc="-555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1904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5952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984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sz="1400" spc="-370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984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5952" sz="2100" spc="-555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-9920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1904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3888" sz="2100" spc="-555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9920" sz="2100" spc="-555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7936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5952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23809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27777" sz="2100" spc="-55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984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sz="1400" spc="-37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3968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7936" sz="2100" spc="-555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9920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1904" sz="2100" spc="-555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baseline="-15873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7857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21825" sz="2100" spc="-55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23809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25793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endParaRPr baseline="-25793" sz="2100">
              <a:latin typeface="Arial"/>
              <a:cs typeface="Arial"/>
            </a:endParaRPr>
          </a:p>
        </p:txBody>
      </p:sp>
      <p:sp>
        <p:nvSpPr>
          <p:cNvPr id="15" name="object 15" descr=""/>
          <p:cNvSpPr txBox="1"/>
          <p:nvPr/>
        </p:nvSpPr>
        <p:spPr>
          <a:xfrm>
            <a:off x="4937633" y="1018920"/>
            <a:ext cx="226187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5793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1825" sz="2100" spc="-53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1785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190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9920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5952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98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984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5952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793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190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3888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785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7857" sz="2100" spc="390">
                <a:solidFill>
                  <a:srgbClr val="BCA7E8"/>
                </a:solidFill>
                <a:latin typeface="Arial"/>
                <a:cs typeface="Arial"/>
              </a:rPr>
              <a:t> </a:t>
            </a:r>
            <a:r>
              <a:rPr dirty="0" sz="1400" spc="-340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3968" sz="2100" spc="-509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7936" sz="2100" spc="-509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1904" sz="2100" spc="-509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15873" sz="2100" spc="-509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19841" sz="2100" spc="-509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21825" sz="2100" spc="-509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baseline="-21825" sz="2100">
              <a:latin typeface="Arial"/>
              <a:cs typeface="Arial"/>
            </a:endParaRPr>
          </a:p>
        </p:txBody>
      </p:sp>
      <p:sp>
        <p:nvSpPr>
          <p:cNvPr id="16" name="object 16" descr=""/>
          <p:cNvSpPr txBox="1"/>
          <p:nvPr/>
        </p:nvSpPr>
        <p:spPr>
          <a:xfrm>
            <a:off x="6383146" y="1168654"/>
            <a:ext cx="23196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3809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1825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1904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9920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5952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3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sz="1400" spc="-35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968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793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1825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7857" sz="2100" spc="-532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13888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7936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5952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984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sz="1400" spc="-355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-1984" sz="2100" spc="-532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baseline="-9920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baseline="-9920" sz="2100">
              <a:latin typeface="Arial"/>
              <a:cs typeface="Arial"/>
            </a:endParaRPr>
          </a:p>
        </p:txBody>
      </p:sp>
      <p:sp>
        <p:nvSpPr>
          <p:cNvPr id="17" name="object 17" descr=""/>
          <p:cNvSpPr txBox="1"/>
          <p:nvPr/>
        </p:nvSpPr>
        <p:spPr>
          <a:xfrm>
            <a:off x="7250556" y="1294892"/>
            <a:ext cx="50374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7777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5793" sz="2100" spc="-540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1825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40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3888" sz="2100" spc="-540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1904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9920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60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984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5952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9920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1904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5873" sz="2100" spc="-54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7777" sz="2100" spc="-540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23809" sz="2100" spc="-540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9841" sz="2100" spc="-540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11904" sz="2100" spc="-540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7936" sz="2100" spc="-540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3968" sz="2100" spc="-540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sz="1400" spc="-360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-3968" sz="2100" spc="-540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27777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25793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19841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17857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5873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7936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5952" sz="2100" spc="-540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984" sz="2100" spc="-540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sz="1400" spc="-360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-3968" sz="2100" spc="-540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baseline="-5952" sz="2100" spc="-540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13888" sz="2100" spc="-540">
                <a:solidFill>
                  <a:srgbClr val="DFD625"/>
                </a:solidFill>
                <a:latin typeface="Arial"/>
                <a:cs typeface="Arial"/>
              </a:rPr>
              <a:t>+++++++</a:t>
            </a:r>
            <a:endParaRPr baseline="-13888" sz="2100">
              <a:latin typeface="Arial"/>
              <a:cs typeface="Arial"/>
            </a:endParaRPr>
          </a:p>
        </p:txBody>
      </p:sp>
      <p:sp>
        <p:nvSpPr>
          <p:cNvPr id="18" name="object 18" descr=""/>
          <p:cNvSpPr txBox="1"/>
          <p:nvPr/>
        </p:nvSpPr>
        <p:spPr>
          <a:xfrm>
            <a:off x="8522589" y="1426718"/>
            <a:ext cx="359156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19841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7857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5873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3888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9920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0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sz="1400" spc="-33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9920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7857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9841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27777" sz="2100" spc="-50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29761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3730" sz="2100" spc="-50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3730" sz="2100" spc="247">
                <a:solidFill>
                  <a:srgbClr val="BCA7E8"/>
                </a:solidFill>
                <a:latin typeface="Arial"/>
                <a:cs typeface="Arial"/>
              </a:rPr>
              <a:t> </a:t>
            </a:r>
            <a:r>
              <a:rPr dirty="0" baseline="25793" sz="2100" spc="-405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baseline="19841" sz="2100" spc="-40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3888" sz="2100" spc="-405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984" sz="2100" spc="-405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-5952" sz="2100" spc="-40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1904" sz="2100" spc="-405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baseline="-21825" sz="2100" spc="-405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31746" sz="2100" spc="-405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endParaRPr baseline="-31746" sz="2100">
              <a:latin typeface="Arial"/>
              <a:cs typeface="Arial"/>
            </a:endParaRPr>
          </a:p>
        </p:txBody>
      </p:sp>
      <p:sp>
        <p:nvSpPr>
          <p:cNvPr id="19" name="object 19" descr=""/>
          <p:cNvSpPr txBox="1"/>
          <p:nvPr/>
        </p:nvSpPr>
        <p:spPr>
          <a:xfrm>
            <a:off x="10141584" y="1632711"/>
            <a:ext cx="15678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5793" sz="2100" spc="-547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23809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1" sz="2100" spc="-547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9920" sz="2100" spc="-547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sz="1400" spc="-365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-3968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7936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1904" sz="2100" spc="-547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15873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23809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27777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1746" sz="2100" spc="-547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35714" sz="2100" spc="-547">
                <a:solidFill>
                  <a:srgbClr val="BCA7E8"/>
                </a:solidFill>
                <a:latin typeface="Arial"/>
                <a:cs typeface="Arial"/>
              </a:rPr>
              <a:t>+</a:t>
            </a:r>
            <a:endParaRPr baseline="-35714" sz="2100">
              <a:latin typeface="Arial"/>
              <a:cs typeface="Arial"/>
            </a:endParaRPr>
          </a:p>
        </p:txBody>
      </p:sp>
      <p:sp>
        <p:nvSpPr>
          <p:cNvPr id="20" name="object 20" descr=""/>
          <p:cNvSpPr txBox="1"/>
          <p:nvPr/>
        </p:nvSpPr>
        <p:spPr>
          <a:xfrm>
            <a:off x="11587098" y="1778889"/>
            <a:ext cx="388112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5952" sz="2100" spc="-457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sz="1400" spc="-30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3968" sz="2100" spc="-457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9920" sz="2100" spc="-457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5873" sz="2100" spc="-457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-21825" sz="2100" spc="-457">
                <a:solidFill>
                  <a:srgbClr val="BCA7E8"/>
                </a:solidFill>
                <a:latin typeface="Arial"/>
                <a:cs typeface="Arial"/>
              </a:rPr>
              <a:t>+++++++</a:t>
            </a:r>
            <a:r>
              <a:rPr dirty="0" baseline="-31746" sz="2100" spc="-457">
                <a:solidFill>
                  <a:srgbClr val="BCA7E8"/>
                </a:solidFill>
                <a:latin typeface="Arial"/>
                <a:cs typeface="Arial"/>
              </a:rPr>
              <a:t>+++++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++++++++++++++++++</a:t>
            </a:r>
            <a:r>
              <a:rPr dirty="0" sz="1400" spc="-30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sz="1400" spc="-305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3968" sz="2100" spc="-457">
                <a:solidFill>
                  <a:srgbClr val="4DCE6B"/>
                </a:solidFill>
                <a:latin typeface="Arial"/>
                <a:cs typeface="Arial"/>
              </a:rPr>
              <a:t>++</a:t>
            </a:r>
            <a:endParaRPr baseline="3968" sz="2100">
              <a:latin typeface="Arial"/>
              <a:cs typeface="Arial"/>
            </a:endParaRPr>
          </a:p>
        </p:txBody>
      </p:sp>
      <p:sp>
        <p:nvSpPr>
          <p:cNvPr id="21" name="object 21" descr=""/>
          <p:cNvSpPr txBox="1"/>
          <p:nvPr/>
        </p:nvSpPr>
        <p:spPr>
          <a:xfrm>
            <a:off x="13289407" y="1918843"/>
            <a:ext cx="105473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240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sz="1400" spc="135">
                <a:solidFill>
                  <a:srgbClr val="BCA7E8"/>
                </a:solidFill>
                <a:latin typeface="Arial"/>
                <a:cs typeface="Arial"/>
              </a:rPr>
              <a:t> </a:t>
            </a:r>
            <a:r>
              <a:rPr dirty="0" sz="1400" spc="-305">
                <a:solidFill>
                  <a:srgbClr val="BCA7E8"/>
                </a:solidFill>
                <a:latin typeface="Arial"/>
                <a:cs typeface="Arial"/>
              </a:rPr>
              <a:t>+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22" name="object 22" descr=""/>
          <p:cNvSpPr txBox="1"/>
          <p:nvPr/>
        </p:nvSpPr>
        <p:spPr>
          <a:xfrm>
            <a:off x="14445741" y="2111629"/>
            <a:ext cx="47625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5">
                <a:solidFill>
                  <a:srgbClr val="BCA7E8"/>
                </a:solidFill>
                <a:latin typeface="Arial"/>
                <a:cs typeface="Arial"/>
              </a:rPr>
              <a:t>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23" name="object 23" descr=""/>
          <p:cNvSpPr txBox="1"/>
          <p:nvPr/>
        </p:nvSpPr>
        <p:spPr>
          <a:xfrm>
            <a:off x="15428721" y="2111629"/>
            <a:ext cx="18732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65">
                <a:solidFill>
                  <a:srgbClr val="BCA7E8"/>
                </a:solidFill>
                <a:latin typeface="Arial"/>
                <a:cs typeface="Arial"/>
              </a:rPr>
              <a:t>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24" name="object 24" descr=""/>
          <p:cNvSpPr txBox="1"/>
          <p:nvPr/>
        </p:nvSpPr>
        <p:spPr>
          <a:xfrm>
            <a:off x="1776983" y="3374897"/>
            <a:ext cx="87121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latin typeface="Arial"/>
                <a:cs typeface="Arial"/>
              </a:rPr>
              <a:t>p &lt; </a:t>
            </a:r>
            <a:r>
              <a:rPr dirty="0" sz="1400" spc="-10">
                <a:latin typeface="Arial"/>
                <a:cs typeface="Arial"/>
              </a:rPr>
              <a:t>0.0001</a:t>
            </a:r>
            <a:endParaRPr sz="1400">
              <a:latin typeface="Arial"/>
              <a:cs typeface="Arial"/>
            </a:endParaRPr>
          </a:p>
        </p:txBody>
      </p:sp>
      <p:sp>
        <p:nvSpPr>
          <p:cNvPr id="25" name="object 25" descr=""/>
          <p:cNvSpPr txBox="1"/>
          <p:nvPr/>
        </p:nvSpPr>
        <p:spPr>
          <a:xfrm>
            <a:off x="1776983" y="3048000"/>
            <a:ext cx="7702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">
                <a:latin typeface="Arial"/>
                <a:cs typeface="Arial"/>
              </a:rPr>
              <a:t>Log−rank</a:t>
            </a:r>
            <a:endParaRPr sz="1400">
              <a:latin typeface="Arial"/>
              <a:cs typeface="Arial"/>
            </a:endParaRPr>
          </a:p>
        </p:txBody>
      </p:sp>
      <p:sp>
        <p:nvSpPr>
          <p:cNvPr id="26" name="object 26" descr=""/>
          <p:cNvSpPr txBox="1"/>
          <p:nvPr/>
        </p:nvSpPr>
        <p:spPr>
          <a:xfrm>
            <a:off x="286258" y="3088766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</a:t>
            </a:r>
            <a:endParaRPr sz="900">
              <a:latin typeface="Arial"/>
              <a:cs typeface="Arial"/>
            </a:endParaRPr>
          </a:p>
        </p:txBody>
      </p:sp>
      <p:sp>
        <p:nvSpPr>
          <p:cNvPr id="27" name="object 27" descr=""/>
          <p:cNvSpPr txBox="1"/>
          <p:nvPr/>
        </p:nvSpPr>
        <p:spPr>
          <a:xfrm>
            <a:off x="286258" y="2271394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28" name="object 28" descr=""/>
          <p:cNvSpPr txBox="1"/>
          <p:nvPr/>
        </p:nvSpPr>
        <p:spPr>
          <a:xfrm>
            <a:off x="286258" y="1454022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75</a:t>
            </a:r>
            <a:endParaRPr sz="900">
              <a:latin typeface="Arial"/>
              <a:cs typeface="Arial"/>
            </a:endParaRPr>
          </a:p>
        </p:txBody>
      </p:sp>
      <p:sp>
        <p:nvSpPr>
          <p:cNvPr id="29" name="object 29" descr=""/>
          <p:cNvSpPr txBox="1"/>
          <p:nvPr/>
        </p:nvSpPr>
        <p:spPr>
          <a:xfrm>
            <a:off x="222758" y="636778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30" name="object 30" descr=""/>
          <p:cNvSpPr/>
          <p:nvPr/>
        </p:nvSpPr>
        <p:spPr>
          <a:xfrm>
            <a:off x="453898" y="722756"/>
            <a:ext cx="15213330" cy="3296285"/>
          </a:xfrm>
          <a:custGeom>
            <a:avLst/>
            <a:gdLst/>
            <a:ahLst/>
            <a:cxnLst/>
            <a:rect l="l" t="t" r="r" b="b"/>
            <a:pathLst>
              <a:path w="15213330" h="3296285">
                <a:moveTo>
                  <a:pt x="0" y="2451989"/>
                </a:moveTo>
                <a:lnTo>
                  <a:pt x="34797" y="2451989"/>
                </a:lnTo>
              </a:path>
              <a:path w="15213330" h="3296285">
                <a:moveTo>
                  <a:pt x="0" y="1634617"/>
                </a:moveTo>
                <a:lnTo>
                  <a:pt x="34797" y="1634617"/>
                </a:lnTo>
              </a:path>
              <a:path w="15213330" h="3296285">
                <a:moveTo>
                  <a:pt x="0" y="817245"/>
                </a:moveTo>
                <a:lnTo>
                  <a:pt x="34797" y="817245"/>
                </a:lnTo>
              </a:path>
              <a:path w="15213330" h="3296285">
                <a:moveTo>
                  <a:pt x="0" y="0"/>
                </a:moveTo>
                <a:lnTo>
                  <a:pt x="34797" y="0"/>
                </a:lnTo>
              </a:path>
              <a:path w="15213330" h="3296285">
                <a:moveTo>
                  <a:pt x="757555" y="3295904"/>
                </a:moveTo>
                <a:lnTo>
                  <a:pt x="757555" y="3261106"/>
                </a:lnTo>
              </a:path>
              <a:path w="15213330" h="3296285">
                <a:moveTo>
                  <a:pt x="3648710" y="3295904"/>
                </a:moveTo>
                <a:lnTo>
                  <a:pt x="3648710" y="3261106"/>
                </a:lnTo>
              </a:path>
              <a:path w="15213330" h="3296285">
                <a:moveTo>
                  <a:pt x="6539737" y="3295904"/>
                </a:moveTo>
                <a:lnTo>
                  <a:pt x="6539737" y="3261106"/>
                </a:lnTo>
              </a:path>
              <a:path w="15213330" h="3296285">
                <a:moveTo>
                  <a:pt x="9430766" y="3295904"/>
                </a:moveTo>
                <a:lnTo>
                  <a:pt x="9430766" y="3261106"/>
                </a:lnTo>
              </a:path>
              <a:path w="15213330" h="3296285">
                <a:moveTo>
                  <a:pt x="12321921" y="3295904"/>
                </a:moveTo>
                <a:lnTo>
                  <a:pt x="12321921" y="3261106"/>
                </a:lnTo>
              </a:path>
              <a:path w="15213330" h="3296285">
                <a:moveTo>
                  <a:pt x="15212948" y="3295904"/>
                </a:moveTo>
                <a:lnTo>
                  <a:pt x="15212948" y="3261106"/>
                </a:lnTo>
              </a:path>
            </a:pathLst>
          </a:custGeom>
          <a:ln w="13589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" name="object 31" descr=""/>
          <p:cNvSpPr txBox="1"/>
          <p:nvPr/>
        </p:nvSpPr>
        <p:spPr>
          <a:xfrm>
            <a:off x="1167002" y="400151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32" name="object 32" descr=""/>
          <p:cNvSpPr txBox="1"/>
          <p:nvPr/>
        </p:nvSpPr>
        <p:spPr>
          <a:xfrm>
            <a:off x="4026280" y="400151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33" name="object 33" descr=""/>
          <p:cNvSpPr txBox="1"/>
          <p:nvPr/>
        </p:nvSpPr>
        <p:spPr>
          <a:xfrm>
            <a:off x="6885558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34" name="object 34" descr=""/>
          <p:cNvSpPr txBox="1"/>
          <p:nvPr/>
        </p:nvSpPr>
        <p:spPr>
          <a:xfrm>
            <a:off x="9776714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35" name="object 35" descr=""/>
          <p:cNvSpPr txBox="1"/>
          <p:nvPr/>
        </p:nvSpPr>
        <p:spPr>
          <a:xfrm>
            <a:off x="12667742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36" name="object 36" descr=""/>
          <p:cNvSpPr txBox="1"/>
          <p:nvPr/>
        </p:nvSpPr>
        <p:spPr>
          <a:xfrm>
            <a:off x="15558769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37" name="object 37" descr=""/>
          <p:cNvSpPr txBox="1"/>
          <p:nvPr/>
        </p:nvSpPr>
        <p:spPr>
          <a:xfrm>
            <a:off x="8271256" y="413639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38" name="object 38" descr=""/>
          <p:cNvSpPr txBox="1"/>
          <p:nvPr/>
        </p:nvSpPr>
        <p:spPr>
          <a:xfrm>
            <a:off x="30759" y="1548175"/>
            <a:ext cx="181610" cy="145478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>
                <a:latin typeface="Arial"/>
                <a:cs typeface="Arial"/>
              </a:rPr>
              <a:t>Survival probability </a:t>
            </a:r>
            <a:r>
              <a:rPr dirty="0" sz="1100" spc="-25">
                <a:latin typeface="Arial"/>
                <a:cs typeface="Arial"/>
              </a:rPr>
              <a:t>(%)</a:t>
            </a:r>
            <a:endParaRPr sz="1100">
              <a:latin typeface="Arial"/>
              <a:cs typeface="Arial"/>
            </a:endParaRPr>
          </a:p>
        </p:txBody>
      </p:sp>
      <p:sp>
        <p:nvSpPr>
          <p:cNvPr id="39" name="object 39" descr=""/>
          <p:cNvSpPr txBox="1"/>
          <p:nvPr/>
        </p:nvSpPr>
        <p:spPr>
          <a:xfrm>
            <a:off x="5242178" y="146684"/>
            <a:ext cx="77787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eeth</a:t>
            </a:r>
            <a:r>
              <a:rPr dirty="0" sz="1100" spc="-35">
                <a:latin typeface="Arial"/>
                <a:cs typeface="Arial"/>
              </a:rPr>
              <a:t> </a:t>
            </a:r>
            <a:r>
              <a:rPr dirty="0" sz="1100" spc="-10">
                <a:latin typeface="Arial"/>
                <a:cs typeface="Arial"/>
              </a:rPr>
              <a:t>status</a:t>
            </a:r>
            <a:endParaRPr sz="1100">
              <a:latin typeface="Arial"/>
              <a:cs typeface="Arial"/>
            </a:endParaRPr>
          </a:p>
        </p:txBody>
      </p:sp>
      <p:sp>
        <p:nvSpPr>
          <p:cNvPr id="40" name="object 40" descr=""/>
          <p:cNvSpPr/>
          <p:nvPr/>
        </p:nvSpPr>
        <p:spPr>
          <a:xfrm>
            <a:off x="6085459" y="148209"/>
            <a:ext cx="201930" cy="201930"/>
          </a:xfrm>
          <a:custGeom>
            <a:avLst/>
            <a:gdLst/>
            <a:ahLst/>
            <a:cxnLst/>
            <a:rect l="l" t="t" r="r" b="b"/>
            <a:pathLst>
              <a:path w="201929" h="201929">
                <a:moveTo>
                  <a:pt x="201422" y="0"/>
                </a:moveTo>
                <a:lnTo>
                  <a:pt x="0" y="0"/>
                </a:lnTo>
                <a:lnTo>
                  <a:pt x="0" y="201422"/>
                </a:lnTo>
                <a:lnTo>
                  <a:pt x="201422" y="201422"/>
                </a:lnTo>
                <a:lnTo>
                  <a:pt x="201422" y="0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grpSp>
        <p:nvGrpSpPr>
          <p:cNvPr id="41" name="object 41" descr=""/>
          <p:cNvGrpSpPr/>
          <p:nvPr/>
        </p:nvGrpSpPr>
        <p:grpSpPr>
          <a:xfrm>
            <a:off x="7396988" y="148209"/>
            <a:ext cx="201930" cy="201930"/>
            <a:chOff x="7396988" y="148209"/>
            <a:chExt cx="201930" cy="201930"/>
          </a:xfrm>
        </p:grpSpPr>
        <p:sp>
          <p:nvSpPr>
            <p:cNvPr id="42" name="object 42" descr=""/>
            <p:cNvSpPr/>
            <p:nvPr/>
          </p:nvSpPr>
          <p:spPr>
            <a:xfrm>
              <a:off x="740994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41A3FF"/>
              </a:solidFill>
              <a:prstDash val="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3" name="object 43" descr=""/>
            <p:cNvSpPr/>
            <p:nvPr/>
          </p:nvSpPr>
          <p:spPr>
            <a:xfrm>
              <a:off x="739698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1A3FF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44" name="object 44" descr=""/>
          <p:cNvGrpSpPr/>
          <p:nvPr/>
        </p:nvGrpSpPr>
        <p:grpSpPr>
          <a:xfrm>
            <a:off x="8269223" y="148209"/>
            <a:ext cx="201930" cy="201930"/>
            <a:chOff x="8269223" y="148209"/>
            <a:chExt cx="201930" cy="201930"/>
          </a:xfrm>
        </p:grpSpPr>
        <p:sp>
          <p:nvSpPr>
            <p:cNvPr id="45" name="object 45" descr=""/>
            <p:cNvSpPr/>
            <p:nvPr/>
          </p:nvSpPr>
          <p:spPr>
            <a:xfrm>
              <a:off x="828217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DFD625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6" name="object 46" descr=""/>
            <p:cNvSpPr/>
            <p:nvPr/>
          </p:nvSpPr>
          <p:spPr>
            <a:xfrm>
              <a:off x="826922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DFD625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47" name="object 47" descr=""/>
          <p:cNvGrpSpPr/>
          <p:nvPr/>
        </p:nvGrpSpPr>
        <p:grpSpPr>
          <a:xfrm>
            <a:off x="9542653" y="148209"/>
            <a:ext cx="201930" cy="201930"/>
            <a:chOff x="9542653" y="148209"/>
            <a:chExt cx="201930" cy="201930"/>
          </a:xfrm>
        </p:grpSpPr>
        <p:sp>
          <p:nvSpPr>
            <p:cNvPr id="48" name="object 48" descr=""/>
            <p:cNvSpPr/>
            <p:nvPr/>
          </p:nvSpPr>
          <p:spPr>
            <a:xfrm>
              <a:off x="955560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4DCE6B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9" name="object 49" descr=""/>
            <p:cNvSpPr/>
            <p:nvPr/>
          </p:nvSpPr>
          <p:spPr>
            <a:xfrm>
              <a:off x="954265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DCE6B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50" name="object 50" descr=""/>
          <p:cNvGrpSpPr/>
          <p:nvPr/>
        </p:nvGrpSpPr>
        <p:grpSpPr>
          <a:xfrm>
            <a:off x="10778108" y="148209"/>
            <a:ext cx="201930" cy="201930"/>
            <a:chOff x="10778108" y="148209"/>
            <a:chExt cx="201930" cy="201930"/>
          </a:xfrm>
        </p:grpSpPr>
        <p:sp>
          <p:nvSpPr>
            <p:cNvPr id="51" name="object 51" descr=""/>
            <p:cNvSpPr/>
            <p:nvPr/>
          </p:nvSpPr>
          <p:spPr>
            <a:xfrm>
              <a:off x="1079106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BCA7E8"/>
              </a:solidFill>
              <a:prstDash val="sys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2" name="object 52" descr=""/>
            <p:cNvSpPr/>
            <p:nvPr/>
          </p:nvSpPr>
          <p:spPr>
            <a:xfrm>
              <a:off x="1077810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BCA7E8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53" name="object 53" descr=""/>
          <p:cNvSpPr txBox="1"/>
          <p:nvPr/>
        </p:nvSpPr>
        <p:spPr>
          <a:xfrm>
            <a:off x="6085713" y="103251"/>
            <a:ext cx="485775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279400" algn="l"/>
                <a:tab pos="1359535" algn="l"/>
                <a:tab pos="1590675" algn="l"/>
                <a:tab pos="2232025" algn="l"/>
                <a:tab pos="2463165" algn="l"/>
                <a:tab pos="3505200" algn="l"/>
                <a:tab pos="3736340" algn="l"/>
                <a:tab pos="4740910" algn="l"/>
              </a:tabLst>
            </a:pPr>
            <a:r>
              <a:rPr dirty="0" sz="1400" spc="-110" strike="sngStrike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sz="1400" spc="-50" strike="sngStrike">
                <a:solidFill>
                  <a:srgbClr val="E95359"/>
                </a:solidFill>
                <a:latin typeface="Arial"/>
                <a:cs typeface="Arial"/>
              </a:rPr>
              <a:t>+</a:t>
            </a:r>
            <a:r>
              <a:rPr dirty="0" sz="1400" strike="noStrike">
                <a:solidFill>
                  <a:srgbClr val="E95359"/>
                </a:solidFill>
                <a:latin typeface="Arial"/>
                <a:cs typeface="Arial"/>
              </a:rPr>
              <a:t>	</a:t>
            </a:r>
            <a:r>
              <a:rPr dirty="0" baseline="3086" sz="1350" strike="noStrike">
                <a:latin typeface="Arial"/>
                <a:cs typeface="Arial"/>
              </a:rPr>
              <a:t>Complete </a:t>
            </a:r>
            <a:r>
              <a:rPr dirty="0" baseline="3086" sz="1350" spc="-15" strike="noStrike">
                <a:latin typeface="Arial"/>
                <a:cs typeface="Arial"/>
              </a:rPr>
              <a:t>dentition</a:t>
            </a:r>
            <a:r>
              <a:rPr dirty="0" baseline="3086" sz="1350" strike="noStrike">
                <a:latin typeface="Arial"/>
                <a:cs typeface="Arial"/>
              </a:rPr>
              <a:t>	</a:t>
            </a:r>
            <a:r>
              <a:rPr dirty="0" sz="1400" spc="-50" strike="noStrike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sz="1400" strike="noStrike">
                <a:solidFill>
                  <a:srgbClr val="41A3FF"/>
                </a:solidFill>
                <a:latin typeface="Arial"/>
                <a:cs typeface="Arial"/>
              </a:rPr>
              <a:t>	</a:t>
            </a:r>
            <a:r>
              <a:rPr dirty="0" baseline="3086" sz="1350" spc="-30" strike="noStrike">
                <a:latin typeface="Arial"/>
                <a:cs typeface="Arial"/>
              </a:rPr>
              <a:t>Tooth</a:t>
            </a:r>
            <a:r>
              <a:rPr dirty="0" baseline="3086" sz="1350" spc="-15" strike="noStrike">
                <a:latin typeface="Arial"/>
                <a:cs typeface="Arial"/>
              </a:rPr>
              <a:t> </a:t>
            </a:r>
            <a:r>
              <a:rPr dirty="0" baseline="3086" sz="1350" spc="-30" strike="noStrike">
                <a:latin typeface="Arial"/>
                <a:cs typeface="Arial"/>
              </a:rPr>
              <a:t>loss</a:t>
            </a:r>
            <a:r>
              <a:rPr dirty="0" baseline="3086" sz="1350" strike="noStrike">
                <a:latin typeface="Arial"/>
                <a:cs typeface="Arial"/>
              </a:rPr>
              <a:t>	</a:t>
            </a:r>
            <a:r>
              <a:rPr dirty="0" sz="1400" spc="-50" strike="noStrike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sz="1400" strike="noStrike">
                <a:solidFill>
                  <a:srgbClr val="DFD625"/>
                </a:solidFill>
                <a:latin typeface="Arial"/>
                <a:cs typeface="Arial"/>
              </a:rPr>
              <a:t>	</a:t>
            </a:r>
            <a:r>
              <a:rPr dirty="0" baseline="3086" sz="1350" strike="noStrike">
                <a:latin typeface="Arial"/>
                <a:cs typeface="Arial"/>
              </a:rPr>
              <a:t>Lacking </a:t>
            </a:r>
            <a:r>
              <a:rPr dirty="0" baseline="3086" sz="1350" spc="-15" strike="noStrike">
                <a:latin typeface="Arial"/>
                <a:cs typeface="Arial"/>
              </a:rPr>
              <a:t>functional</a:t>
            </a:r>
            <a:r>
              <a:rPr dirty="0" baseline="3086" sz="1350" strike="noStrike">
                <a:latin typeface="Arial"/>
                <a:cs typeface="Arial"/>
              </a:rPr>
              <a:t>	</a:t>
            </a:r>
            <a:r>
              <a:rPr dirty="0" sz="1400" spc="-50" strike="noStrike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sz="1400" strike="noStrike">
                <a:solidFill>
                  <a:srgbClr val="4DCE6B"/>
                </a:solidFill>
                <a:latin typeface="Arial"/>
                <a:cs typeface="Arial"/>
              </a:rPr>
              <a:t>	</a:t>
            </a:r>
            <a:r>
              <a:rPr dirty="0" baseline="3086" sz="1350" strike="noStrike">
                <a:latin typeface="Arial"/>
                <a:cs typeface="Arial"/>
              </a:rPr>
              <a:t>Severe</a:t>
            </a:r>
            <a:r>
              <a:rPr dirty="0" baseline="3086" sz="1350" spc="-60" strike="noStrike">
                <a:latin typeface="Arial"/>
                <a:cs typeface="Arial"/>
              </a:rPr>
              <a:t> </a:t>
            </a:r>
            <a:r>
              <a:rPr dirty="0" baseline="3086" sz="1350" strike="noStrike">
                <a:latin typeface="Arial"/>
                <a:cs typeface="Arial"/>
              </a:rPr>
              <a:t>tooth</a:t>
            </a:r>
            <a:r>
              <a:rPr dirty="0" baseline="3086" sz="1350" spc="-37" strike="noStrike">
                <a:latin typeface="Arial"/>
                <a:cs typeface="Arial"/>
              </a:rPr>
              <a:t> </a:t>
            </a:r>
            <a:r>
              <a:rPr dirty="0" baseline="3086" sz="1350" spc="-30" strike="noStrike">
                <a:latin typeface="Arial"/>
                <a:cs typeface="Arial"/>
              </a:rPr>
              <a:t>loss</a:t>
            </a:r>
            <a:r>
              <a:rPr dirty="0" baseline="3086" sz="1350" strike="noStrike">
                <a:latin typeface="Arial"/>
                <a:cs typeface="Arial"/>
              </a:rPr>
              <a:t>	</a:t>
            </a:r>
            <a:r>
              <a:rPr dirty="0" sz="1400" spc="-50" strike="noStrike">
                <a:solidFill>
                  <a:srgbClr val="BCA7E8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54" name="object 54" descr=""/>
          <p:cNvSpPr txBox="1"/>
          <p:nvPr/>
        </p:nvSpPr>
        <p:spPr>
          <a:xfrm>
            <a:off x="11045443" y="162941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55" name="object 55" descr=""/>
          <p:cNvGrpSpPr/>
          <p:nvPr/>
        </p:nvGrpSpPr>
        <p:grpSpPr>
          <a:xfrm>
            <a:off x="1250950" y="4683125"/>
            <a:ext cx="15139035" cy="1678305"/>
            <a:chOff x="1250950" y="4683125"/>
            <a:chExt cx="15139035" cy="1678305"/>
          </a:xfrm>
        </p:grpSpPr>
        <p:sp>
          <p:nvSpPr>
            <p:cNvPr id="56" name="object 56" descr=""/>
            <p:cNvSpPr/>
            <p:nvPr/>
          </p:nvSpPr>
          <p:spPr>
            <a:xfrm>
              <a:off x="3315335" y="4683125"/>
              <a:ext cx="11010265" cy="1678305"/>
            </a:xfrm>
            <a:custGeom>
              <a:avLst/>
              <a:gdLst/>
              <a:ahLst/>
              <a:cxnLst/>
              <a:rect l="l" t="t" r="r" b="b"/>
              <a:pathLst>
                <a:path w="11010265" h="1678304">
                  <a:moveTo>
                    <a:pt x="0" y="1678177"/>
                  </a:moveTo>
                  <a:lnTo>
                    <a:pt x="0" y="0"/>
                  </a:lnTo>
                </a:path>
                <a:path w="11010265" h="1678304">
                  <a:moveTo>
                    <a:pt x="2752470" y="1678177"/>
                  </a:moveTo>
                  <a:lnTo>
                    <a:pt x="2752470" y="0"/>
                  </a:lnTo>
                </a:path>
                <a:path w="11010265" h="1678304">
                  <a:moveTo>
                    <a:pt x="5504942" y="1678177"/>
                  </a:moveTo>
                  <a:lnTo>
                    <a:pt x="5504942" y="0"/>
                  </a:lnTo>
                </a:path>
                <a:path w="11010265" h="1678304">
                  <a:moveTo>
                    <a:pt x="8257413" y="1678177"/>
                  </a:moveTo>
                  <a:lnTo>
                    <a:pt x="8257413" y="0"/>
                  </a:lnTo>
                </a:path>
                <a:path w="11010265" h="1678304">
                  <a:moveTo>
                    <a:pt x="11009884" y="1678177"/>
                  </a:moveTo>
                  <a:lnTo>
                    <a:pt x="11009884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7" name="object 57" descr=""/>
            <p:cNvSpPr/>
            <p:nvPr/>
          </p:nvSpPr>
          <p:spPr>
            <a:xfrm>
              <a:off x="1250950" y="4683125"/>
              <a:ext cx="15139035" cy="1678305"/>
            </a:xfrm>
            <a:custGeom>
              <a:avLst/>
              <a:gdLst/>
              <a:ahLst/>
              <a:cxnLst/>
              <a:rect l="l" t="t" r="r" b="b"/>
              <a:pathLst>
                <a:path w="15139035" h="1678304">
                  <a:moveTo>
                    <a:pt x="0" y="1484502"/>
                  </a:moveTo>
                  <a:lnTo>
                    <a:pt x="15138654" y="1484502"/>
                  </a:lnTo>
                </a:path>
                <a:path w="15139035" h="1678304">
                  <a:moveTo>
                    <a:pt x="0" y="1161796"/>
                  </a:moveTo>
                  <a:lnTo>
                    <a:pt x="15138654" y="1161796"/>
                  </a:lnTo>
                </a:path>
                <a:path w="15139035" h="1678304">
                  <a:moveTo>
                    <a:pt x="0" y="839088"/>
                  </a:moveTo>
                  <a:lnTo>
                    <a:pt x="15138654" y="839088"/>
                  </a:lnTo>
                </a:path>
                <a:path w="15139035" h="1678304">
                  <a:moveTo>
                    <a:pt x="0" y="516382"/>
                  </a:moveTo>
                  <a:lnTo>
                    <a:pt x="15138654" y="516382"/>
                  </a:lnTo>
                </a:path>
                <a:path w="15139035" h="1678304">
                  <a:moveTo>
                    <a:pt x="0" y="193675"/>
                  </a:moveTo>
                  <a:lnTo>
                    <a:pt x="15138654" y="193675"/>
                  </a:lnTo>
                </a:path>
                <a:path w="15139035" h="1678304">
                  <a:moveTo>
                    <a:pt x="688086" y="1678177"/>
                  </a:moveTo>
                  <a:lnTo>
                    <a:pt x="688086" y="0"/>
                  </a:lnTo>
                </a:path>
                <a:path w="15139035" h="1678304">
                  <a:moveTo>
                    <a:pt x="3440684" y="1678177"/>
                  </a:moveTo>
                  <a:lnTo>
                    <a:pt x="3440684" y="0"/>
                  </a:lnTo>
                </a:path>
                <a:path w="15139035" h="1678304">
                  <a:moveTo>
                    <a:pt x="6193155" y="1678177"/>
                  </a:moveTo>
                  <a:lnTo>
                    <a:pt x="6193155" y="0"/>
                  </a:lnTo>
                </a:path>
                <a:path w="15139035" h="1678304">
                  <a:moveTo>
                    <a:pt x="8945626" y="1678177"/>
                  </a:moveTo>
                  <a:lnTo>
                    <a:pt x="8945626" y="0"/>
                  </a:lnTo>
                </a:path>
                <a:path w="15139035" h="1678304">
                  <a:moveTo>
                    <a:pt x="11698097" y="1678177"/>
                  </a:moveTo>
                  <a:lnTo>
                    <a:pt x="11698097" y="0"/>
                  </a:lnTo>
                </a:path>
                <a:path w="15139035" h="1678304">
                  <a:moveTo>
                    <a:pt x="14450567" y="1678177"/>
                  </a:moveTo>
                  <a:lnTo>
                    <a:pt x="14450567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58" name="object 58" descr=""/>
          <p:cNvSpPr txBox="1"/>
          <p:nvPr/>
        </p:nvSpPr>
        <p:spPr>
          <a:xfrm>
            <a:off x="1619250" y="4782692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2245 </a:t>
            </a:r>
            <a:r>
              <a:rPr dirty="0" sz="1000" spc="-10">
                <a:solidFill>
                  <a:srgbClr val="E95359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9" name="object 59" descr=""/>
          <p:cNvSpPr txBox="1"/>
          <p:nvPr/>
        </p:nvSpPr>
        <p:spPr>
          <a:xfrm>
            <a:off x="4407153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838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82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0" name="object 60" descr=""/>
          <p:cNvSpPr txBox="1"/>
          <p:nvPr/>
        </p:nvSpPr>
        <p:spPr>
          <a:xfrm>
            <a:off x="7159625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31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58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1" name="object 61" descr=""/>
          <p:cNvSpPr txBox="1"/>
          <p:nvPr/>
        </p:nvSpPr>
        <p:spPr>
          <a:xfrm>
            <a:off x="994740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82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2" name="object 62" descr=""/>
          <p:cNvSpPr txBox="1"/>
          <p:nvPr/>
        </p:nvSpPr>
        <p:spPr>
          <a:xfrm>
            <a:off x="1269987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333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1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3" name="object 63" descr=""/>
          <p:cNvSpPr txBox="1"/>
          <p:nvPr/>
        </p:nvSpPr>
        <p:spPr>
          <a:xfrm>
            <a:off x="15558262" y="4782692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E95359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4" name="object 64" descr=""/>
          <p:cNvSpPr txBox="1"/>
          <p:nvPr/>
        </p:nvSpPr>
        <p:spPr>
          <a:xfrm>
            <a:off x="1619250" y="510540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5029 </a:t>
            </a:r>
            <a:r>
              <a:rPr dirty="0" sz="1000" spc="-10">
                <a:solidFill>
                  <a:srgbClr val="41A3FF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5" name="object 65" descr=""/>
          <p:cNvSpPr txBox="1"/>
          <p:nvPr/>
        </p:nvSpPr>
        <p:spPr>
          <a:xfrm>
            <a:off x="4407153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3760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7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6" name="object 66" descr=""/>
          <p:cNvSpPr txBox="1"/>
          <p:nvPr/>
        </p:nvSpPr>
        <p:spPr>
          <a:xfrm>
            <a:off x="715962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2369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4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7" name="object 67" descr=""/>
          <p:cNvSpPr txBox="1"/>
          <p:nvPr/>
        </p:nvSpPr>
        <p:spPr>
          <a:xfrm>
            <a:off x="991209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1254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2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8" name="object 68" descr=""/>
          <p:cNvSpPr txBox="1"/>
          <p:nvPr/>
        </p:nvSpPr>
        <p:spPr>
          <a:xfrm>
            <a:off x="12735179" y="5105400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474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9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9" name="object 69" descr=""/>
          <p:cNvSpPr txBox="1"/>
          <p:nvPr/>
        </p:nvSpPr>
        <p:spPr>
          <a:xfrm>
            <a:off x="15558262" y="510540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0" name="object 70" descr=""/>
          <p:cNvSpPr txBox="1"/>
          <p:nvPr/>
        </p:nvSpPr>
        <p:spPr>
          <a:xfrm>
            <a:off x="1619250" y="5428107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2246 </a:t>
            </a:r>
            <a:r>
              <a:rPr dirty="0" sz="1000" spc="-10">
                <a:solidFill>
                  <a:srgbClr val="DFD625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1" name="object 71" descr=""/>
          <p:cNvSpPr txBox="1"/>
          <p:nvPr/>
        </p:nvSpPr>
        <p:spPr>
          <a:xfrm>
            <a:off x="4407153" y="5428107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59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7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2" name="object 72" descr=""/>
          <p:cNvSpPr txBox="1"/>
          <p:nvPr/>
        </p:nvSpPr>
        <p:spPr>
          <a:xfrm>
            <a:off x="7194931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922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4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3" name="object 73" descr=""/>
          <p:cNvSpPr txBox="1"/>
          <p:nvPr/>
        </p:nvSpPr>
        <p:spPr>
          <a:xfrm>
            <a:off x="9947402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44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2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4" name="object 74" descr=""/>
          <p:cNvSpPr txBox="1"/>
          <p:nvPr/>
        </p:nvSpPr>
        <p:spPr>
          <a:xfrm>
            <a:off x="12735179" y="5428107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39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5" name="object 75" descr=""/>
          <p:cNvSpPr txBox="1"/>
          <p:nvPr/>
        </p:nvSpPr>
        <p:spPr>
          <a:xfrm>
            <a:off x="15558262" y="5428107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6" name="object 76" descr=""/>
          <p:cNvSpPr txBox="1"/>
          <p:nvPr/>
        </p:nvSpPr>
        <p:spPr>
          <a:xfrm>
            <a:off x="1619250" y="5750814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073 </a:t>
            </a:r>
            <a:r>
              <a:rPr dirty="0" sz="1000" spc="-10">
                <a:solidFill>
                  <a:srgbClr val="4DCE6B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7" name="object 77" descr=""/>
          <p:cNvSpPr txBox="1"/>
          <p:nvPr/>
        </p:nvSpPr>
        <p:spPr>
          <a:xfrm>
            <a:off x="4442459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718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6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8" name="object 78" descr=""/>
          <p:cNvSpPr txBox="1"/>
          <p:nvPr/>
        </p:nvSpPr>
        <p:spPr>
          <a:xfrm>
            <a:off x="7194931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397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9" name="object 79" descr=""/>
          <p:cNvSpPr txBox="1"/>
          <p:nvPr/>
        </p:nvSpPr>
        <p:spPr>
          <a:xfrm>
            <a:off x="9947402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75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1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0" name="object 80" descr=""/>
          <p:cNvSpPr txBox="1"/>
          <p:nvPr/>
        </p:nvSpPr>
        <p:spPr>
          <a:xfrm>
            <a:off x="12770484" y="5750814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49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1" name="object 81" descr=""/>
          <p:cNvSpPr txBox="1"/>
          <p:nvPr/>
        </p:nvSpPr>
        <p:spPr>
          <a:xfrm>
            <a:off x="15558262" y="5750814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2" name="object 82" descr=""/>
          <p:cNvSpPr txBox="1"/>
          <p:nvPr/>
        </p:nvSpPr>
        <p:spPr>
          <a:xfrm>
            <a:off x="1619250" y="607352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046 </a:t>
            </a:r>
            <a:r>
              <a:rPr dirty="0" sz="1000" spc="-10">
                <a:solidFill>
                  <a:srgbClr val="BCA7E8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3" name="object 83" descr=""/>
          <p:cNvSpPr txBox="1"/>
          <p:nvPr/>
        </p:nvSpPr>
        <p:spPr>
          <a:xfrm>
            <a:off x="4407153" y="607352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1349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6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4" name="object 84" descr=""/>
          <p:cNvSpPr txBox="1"/>
          <p:nvPr/>
        </p:nvSpPr>
        <p:spPr>
          <a:xfrm>
            <a:off x="7194931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691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3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5" name="object 85" descr=""/>
          <p:cNvSpPr txBox="1"/>
          <p:nvPr/>
        </p:nvSpPr>
        <p:spPr>
          <a:xfrm>
            <a:off x="9947402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83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1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6" name="object 86" descr=""/>
          <p:cNvSpPr txBox="1"/>
          <p:nvPr/>
        </p:nvSpPr>
        <p:spPr>
          <a:xfrm>
            <a:off x="12770484" y="6073520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76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7" name="object 87" descr=""/>
          <p:cNvSpPr txBox="1"/>
          <p:nvPr/>
        </p:nvSpPr>
        <p:spPr>
          <a:xfrm>
            <a:off x="15558262" y="607352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8" name="object 88" descr=""/>
          <p:cNvSpPr txBox="1"/>
          <p:nvPr/>
        </p:nvSpPr>
        <p:spPr>
          <a:xfrm>
            <a:off x="610362" y="6069076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solidFill>
                  <a:srgbClr val="BCA7E8"/>
                </a:solidFill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sp>
        <p:nvSpPr>
          <p:cNvPr id="89" name="object 89" descr=""/>
          <p:cNvSpPr txBox="1"/>
          <p:nvPr/>
        </p:nvSpPr>
        <p:spPr>
          <a:xfrm>
            <a:off x="298831" y="5746369"/>
            <a:ext cx="902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Severe</a:t>
            </a:r>
            <a:r>
              <a:rPr dirty="0" sz="900" spc="-3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tooth</a:t>
            </a:r>
            <a:r>
              <a:rPr dirty="0" sz="900" spc="-2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DCE6B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90" name="object 90" descr=""/>
          <p:cNvSpPr txBox="1"/>
          <p:nvPr/>
        </p:nvSpPr>
        <p:spPr>
          <a:xfrm>
            <a:off x="260731" y="5423661"/>
            <a:ext cx="9404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DFD625"/>
                </a:solidFill>
                <a:latin typeface="Arial"/>
                <a:cs typeface="Arial"/>
              </a:rPr>
              <a:t>Lacking</a:t>
            </a:r>
            <a:r>
              <a:rPr dirty="0" sz="900" spc="-5">
                <a:solidFill>
                  <a:srgbClr val="DFD625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DFD625"/>
                </a:solidFill>
                <a:latin typeface="Arial"/>
                <a:cs typeface="Arial"/>
              </a:rPr>
              <a:t>functional</a:t>
            </a:r>
            <a:endParaRPr sz="900">
              <a:latin typeface="Arial"/>
              <a:cs typeface="Arial"/>
            </a:endParaRPr>
          </a:p>
        </p:txBody>
      </p:sp>
      <p:sp>
        <p:nvSpPr>
          <p:cNvPr id="91" name="object 91" descr=""/>
          <p:cNvSpPr txBox="1"/>
          <p:nvPr/>
        </p:nvSpPr>
        <p:spPr>
          <a:xfrm>
            <a:off x="662051" y="5100954"/>
            <a:ext cx="53911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Tooth</a:t>
            </a:r>
            <a:r>
              <a:rPr dirty="0" sz="900" spc="-10">
                <a:solidFill>
                  <a:srgbClr val="41A3FF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92" name="object 92" descr=""/>
          <p:cNvSpPr txBox="1"/>
          <p:nvPr/>
        </p:nvSpPr>
        <p:spPr>
          <a:xfrm>
            <a:off x="222758" y="4778247"/>
            <a:ext cx="978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E95359"/>
                </a:solidFill>
                <a:latin typeface="Arial"/>
                <a:cs typeface="Arial"/>
              </a:rPr>
              <a:t>Complete</a:t>
            </a:r>
            <a:r>
              <a:rPr dirty="0" sz="900" spc="-5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E95359"/>
                </a:solidFill>
                <a:latin typeface="Arial"/>
                <a:cs typeface="Arial"/>
              </a:rPr>
              <a:t>denti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93" name="object 93" descr=""/>
          <p:cNvSpPr txBox="1"/>
          <p:nvPr/>
        </p:nvSpPr>
        <p:spPr>
          <a:xfrm>
            <a:off x="1894585" y="637895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94" name="object 94" descr=""/>
          <p:cNvSpPr txBox="1"/>
          <p:nvPr/>
        </p:nvSpPr>
        <p:spPr>
          <a:xfrm>
            <a:off x="4615307" y="637895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5" name="object 95" descr=""/>
          <p:cNvSpPr txBox="1"/>
          <p:nvPr/>
        </p:nvSpPr>
        <p:spPr>
          <a:xfrm>
            <a:off x="733602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96" name="object 96" descr=""/>
          <p:cNvSpPr txBox="1"/>
          <p:nvPr/>
        </p:nvSpPr>
        <p:spPr>
          <a:xfrm>
            <a:off x="1008849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7" name="object 97" descr=""/>
          <p:cNvSpPr txBox="1"/>
          <p:nvPr/>
        </p:nvSpPr>
        <p:spPr>
          <a:xfrm>
            <a:off x="12840969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98" name="object 98" descr=""/>
          <p:cNvSpPr txBox="1"/>
          <p:nvPr/>
        </p:nvSpPr>
        <p:spPr>
          <a:xfrm>
            <a:off x="15593440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9" name="object 99" descr=""/>
          <p:cNvSpPr txBox="1"/>
          <p:nvPr/>
        </p:nvSpPr>
        <p:spPr>
          <a:xfrm>
            <a:off x="8652382" y="651383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00" name="object 100" descr=""/>
          <p:cNvSpPr txBox="1"/>
          <p:nvPr/>
        </p:nvSpPr>
        <p:spPr>
          <a:xfrm>
            <a:off x="30759" y="5133565"/>
            <a:ext cx="181610" cy="77787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20">
                <a:latin typeface="Arial"/>
                <a:cs typeface="Arial"/>
              </a:rPr>
              <a:t>Teeth</a:t>
            </a:r>
            <a:r>
              <a:rPr dirty="0" sz="1100" spc="-35">
                <a:latin typeface="Arial"/>
                <a:cs typeface="Arial"/>
              </a:rPr>
              <a:t> </a:t>
            </a:r>
            <a:r>
              <a:rPr dirty="0" sz="1100" spc="-10">
                <a:latin typeface="Arial"/>
                <a:cs typeface="Arial"/>
              </a:rPr>
              <a:t>status</a:t>
            </a:r>
            <a:endParaRPr sz="1100">
              <a:latin typeface="Arial"/>
              <a:cs typeface="Arial"/>
            </a:endParaRPr>
          </a:p>
        </p:txBody>
      </p:sp>
      <p:sp>
        <p:nvSpPr>
          <p:cNvPr id="101" name="object 101" descr=""/>
          <p:cNvSpPr txBox="1"/>
          <p:nvPr/>
        </p:nvSpPr>
        <p:spPr>
          <a:xfrm>
            <a:off x="1238250" y="4399407"/>
            <a:ext cx="1587500" cy="22352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300">
                <a:latin typeface="Arial"/>
                <a:cs typeface="Arial"/>
              </a:rPr>
              <a:t>Number at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risk: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n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 spc="-25">
                <a:latin typeface="Arial"/>
                <a:cs typeface="Arial"/>
              </a:rPr>
              <a:t>(%)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102" name="object 102" descr=""/>
          <p:cNvGrpSpPr/>
          <p:nvPr/>
        </p:nvGrpSpPr>
        <p:grpSpPr>
          <a:xfrm>
            <a:off x="425195" y="7060565"/>
            <a:ext cx="15964535" cy="1678305"/>
            <a:chOff x="425195" y="7060565"/>
            <a:chExt cx="15964535" cy="1678305"/>
          </a:xfrm>
        </p:grpSpPr>
        <p:sp>
          <p:nvSpPr>
            <p:cNvPr id="103" name="object 103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33727"/>
                  </a:moveTo>
                  <a:lnTo>
                    <a:pt x="15964408" y="1633727"/>
                  </a:lnTo>
                </a:path>
                <a:path w="15964535" h="1678304">
                  <a:moveTo>
                    <a:pt x="0" y="1617725"/>
                  </a:moveTo>
                  <a:lnTo>
                    <a:pt x="15964408" y="1617725"/>
                  </a:lnTo>
                </a:path>
                <a:path w="15964535" h="1678304">
                  <a:moveTo>
                    <a:pt x="0" y="1585975"/>
                  </a:moveTo>
                  <a:lnTo>
                    <a:pt x="15964408" y="1585975"/>
                  </a:lnTo>
                </a:path>
                <a:path w="15964535" h="1678304">
                  <a:moveTo>
                    <a:pt x="0" y="1554225"/>
                  </a:moveTo>
                  <a:lnTo>
                    <a:pt x="15964408" y="1554225"/>
                  </a:lnTo>
                </a:path>
                <a:path w="15964535" h="1678304">
                  <a:moveTo>
                    <a:pt x="0" y="1522475"/>
                  </a:moveTo>
                  <a:lnTo>
                    <a:pt x="15964408" y="1522475"/>
                  </a:lnTo>
                </a:path>
                <a:path w="15964535" h="1678304">
                  <a:moveTo>
                    <a:pt x="0" y="1490598"/>
                  </a:moveTo>
                  <a:lnTo>
                    <a:pt x="15964408" y="1490598"/>
                  </a:lnTo>
                </a:path>
                <a:path w="15964535" h="1678304">
                  <a:moveTo>
                    <a:pt x="0" y="1458848"/>
                  </a:moveTo>
                  <a:lnTo>
                    <a:pt x="15964408" y="1458848"/>
                  </a:lnTo>
                </a:path>
                <a:path w="15964535" h="1678304">
                  <a:moveTo>
                    <a:pt x="0" y="1427098"/>
                  </a:moveTo>
                  <a:lnTo>
                    <a:pt x="15964408" y="1427098"/>
                  </a:lnTo>
                </a:path>
                <a:path w="15964535" h="1678304">
                  <a:moveTo>
                    <a:pt x="0" y="1395348"/>
                  </a:moveTo>
                  <a:lnTo>
                    <a:pt x="15964408" y="1395348"/>
                  </a:lnTo>
                </a:path>
                <a:path w="15964535" h="1678304">
                  <a:moveTo>
                    <a:pt x="0" y="1363471"/>
                  </a:moveTo>
                  <a:lnTo>
                    <a:pt x="15964408" y="1363471"/>
                  </a:lnTo>
                </a:path>
                <a:path w="15964535" h="1678304">
                  <a:moveTo>
                    <a:pt x="0" y="1331721"/>
                  </a:moveTo>
                  <a:lnTo>
                    <a:pt x="15964408" y="1331721"/>
                  </a:lnTo>
                </a:path>
                <a:path w="15964535" h="1678304">
                  <a:moveTo>
                    <a:pt x="0" y="1299971"/>
                  </a:moveTo>
                  <a:lnTo>
                    <a:pt x="15964408" y="1299971"/>
                  </a:lnTo>
                </a:path>
                <a:path w="15964535" h="1678304">
                  <a:moveTo>
                    <a:pt x="0" y="1268221"/>
                  </a:moveTo>
                  <a:lnTo>
                    <a:pt x="15964408" y="1268221"/>
                  </a:lnTo>
                </a:path>
                <a:path w="15964535" h="1678304">
                  <a:moveTo>
                    <a:pt x="0" y="1236344"/>
                  </a:moveTo>
                  <a:lnTo>
                    <a:pt x="15964408" y="1236344"/>
                  </a:lnTo>
                </a:path>
                <a:path w="15964535" h="1678304">
                  <a:moveTo>
                    <a:pt x="0" y="1204594"/>
                  </a:moveTo>
                  <a:lnTo>
                    <a:pt x="15964408" y="1204594"/>
                  </a:lnTo>
                </a:path>
                <a:path w="15964535" h="1678304">
                  <a:moveTo>
                    <a:pt x="0" y="1172844"/>
                  </a:moveTo>
                  <a:lnTo>
                    <a:pt x="15964408" y="1172844"/>
                  </a:lnTo>
                </a:path>
                <a:path w="15964535" h="1678304">
                  <a:moveTo>
                    <a:pt x="0" y="1141094"/>
                  </a:moveTo>
                  <a:lnTo>
                    <a:pt x="15964408" y="1141094"/>
                  </a:lnTo>
                </a:path>
                <a:path w="15964535" h="1678304">
                  <a:moveTo>
                    <a:pt x="0" y="1109217"/>
                  </a:moveTo>
                  <a:lnTo>
                    <a:pt x="15964408" y="1109217"/>
                  </a:lnTo>
                </a:path>
                <a:path w="15964535" h="1678304">
                  <a:moveTo>
                    <a:pt x="0" y="1077467"/>
                  </a:moveTo>
                  <a:lnTo>
                    <a:pt x="15964408" y="1077467"/>
                  </a:lnTo>
                </a:path>
                <a:path w="15964535" h="1678304">
                  <a:moveTo>
                    <a:pt x="0" y="1045717"/>
                  </a:moveTo>
                  <a:lnTo>
                    <a:pt x="15964408" y="1045717"/>
                  </a:lnTo>
                </a:path>
                <a:path w="15964535" h="1678304">
                  <a:moveTo>
                    <a:pt x="0" y="1013967"/>
                  </a:moveTo>
                  <a:lnTo>
                    <a:pt x="15964408" y="1013967"/>
                  </a:lnTo>
                </a:path>
                <a:path w="15964535" h="1678304">
                  <a:moveTo>
                    <a:pt x="0" y="982090"/>
                  </a:moveTo>
                  <a:lnTo>
                    <a:pt x="15964408" y="982090"/>
                  </a:lnTo>
                </a:path>
                <a:path w="15964535" h="1678304">
                  <a:moveTo>
                    <a:pt x="0" y="950340"/>
                  </a:moveTo>
                  <a:lnTo>
                    <a:pt x="15964408" y="950340"/>
                  </a:lnTo>
                </a:path>
                <a:path w="15964535" h="1678304">
                  <a:moveTo>
                    <a:pt x="0" y="918590"/>
                  </a:moveTo>
                  <a:lnTo>
                    <a:pt x="15964408" y="918590"/>
                  </a:lnTo>
                </a:path>
                <a:path w="15964535" h="1678304">
                  <a:moveTo>
                    <a:pt x="0" y="886713"/>
                  </a:moveTo>
                  <a:lnTo>
                    <a:pt x="15964408" y="886713"/>
                  </a:lnTo>
                </a:path>
                <a:path w="15964535" h="1678304">
                  <a:moveTo>
                    <a:pt x="0" y="854963"/>
                  </a:moveTo>
                  <a:lnTo>
                    <a:pt x="15964408" y="854963"/>
                  </a:lnTo>
                </a:path>
                <a:path w="15964535" h="1678304">
                  <a:moveTo>
                    <a:pt x="0" y="823213"/>
                  </a:moveTo>
                  <a:lnTo>
                    <a:pt x="15964408" y="823213"/>
                  </a:lnTo>
                </a:path>
                <a:path w="15964535" h="1678304">
                  <a:moveTo>
                    <a:pt x="0" y="791463"/>
                  </a:moveTo>
                  <a:lnTo>
                    <a:pt x="15964408" y="791463"/>
                  </a:lnTo>
                </a:path>
                <a:path w="15964535" h="1678304">
                  <a:moveTo>
                    <a:pt x="0" y="759586"/>
                  </a:moveTo>
                  <a:lnTo>
                    <a:pt x="15964408" y="759586"/>
                  </a:lnTo>
                </a:path>
                <a:path w="15964535" h="1678304">
                  <a:moveTo>
                    <a:pt x="0" y="727836"/>
                  </a:moveTo>
                  <a:lnTo>
                    <a:pt x="15964408" y="727836"/>
                  </a:lnTo>
                </a:path>
                <a:path w="15964535" h="1678304">
                  <a:moveTo>
                    <a:pt x="0" y="696086"/>
                  </a:moveTo>
                  <a:lnTo>
                    <a:pt x="15964408" y="696086"/>
                  </a:lnTo>
                </a:path>
                <a:path w="15964535" h="1678304">
                  <a:moveTo>
                    <a:pt x="0" y="664336"/>
                  </a:moveTo>
                  <a:lnTo>
                    <a:pt x="15964408" y="664336"/>
                  </a:lnTo>
                </a:path>
                <a:path w="15964535" h="1678304">
                  <a:moveTo>
                    <a:pt x="0" y="632459"/>
                  </a:moveTo>
                  <a:lnTo>
                    <a:pt x="15964408" y="632459"/>
                  </a:lnTo>
                </a:path>
                <a:path w="15964535" h="1678304">
                  <a:moveTo>
                    <a:pt x="0" y="600709"/>
                  </a:moveTo>
                  <a:lnTo>
                    <a:pt x="15964408" y="600709"/>
                  </a:lnTo>
                </a:path>
                <a:path w="15964535" h="1678304">
                  <a:moveTo>
                    <a:pt x="0" y="568959"/>
                  </a:moveTo>
                  <a:lnTo>
                    <a:pt x="15964408" y="568959"/>
                  </a:lnTo>
                </a:path>
                <a:path w="15964535" h="1678304">
                  <a:moveTo>
                    <a:pt x="0" y="537209"/>
                  </a:moveTo>
                  <a:lnTo>
                    <a:pt x="15964408" y="537209"/>
                  </a:lnTo>
                </a:path>
                <a:path w="15964535" h="1678304">
                  <a:moveTo>
                    <a:pt x="0" y="505332"/>
                  </a:moveTo>
                  <a:lnTo>
                    <a:pt x="15964408" y="505332"/>
                  </a:lnTo>
                </a:path>
                <a:path w="15964535" h="1678304">
                  <a:moveTo>
                    <a:pt x="0" y="473582"/>
                  </a:moveTo>
                  <a:lnTo>
                    <a:pt x="15964408" y="473582"/>
                  </a:lnTo>
                </a:path>
                <a:path w="15964535" h="1678304">
                  <a:moveTo>
                    <a:pt x="0" y="441832"/>
                  </a:moveTo>
                  <a:lnTo>
                    <a:pt x="15964408" y="441832"/>
                  </a:lnTo>
                </a:path>
                <a:path w="15964535" h="1678304">
                  <a:moveTo>
                    <a:pt x="0" y="410082"/>
                  </a:moveTo>
                  <a:lnTo>
                    <a:pt x="15964408" y="410082"/>
                  </a:lnTo>
                </a:path>
                <a:path w="15964535" h="1678304">
                  <a:moveTo>
                    <a:pt x="0" y="378205"/>
                  </a:moveTo>
                  <a:lnTo>
                    <a:pt x="15964408" y="378205"/>
                  </a:lnTo>
                </a:path>
                <a:path w="15964535" h="1678304">
                  <a:moveTo>
                    <a:pt x="0" y="346455"/>
                  </a:moveTo>
                  <a:lnTo>
                    <a:pt x="15964408" y="346455"/>
                  </a:lnTo>
                </a:path>
                <a:path w="15964535" h="1678304">
                  <a:moveTo>
                    <a:pt x="0" y="298830"/>
                  </a:moveTo>
                  <a:lnTo>
                    <a:pt x="15964408" y="298830"/>
                  </a:lnTo>
                </a:path>
                <a:path w="15964535" h="1678304">
                  <a:moveTo>
                    <a:pt x="0" y="171703"/>
                  </a:moveTo>
                  <a:lnTo>
                    <a:pt x="15964408" y="171703"/>
                  </a:lnTo>
                </a:path>
                <a:path w="15964535" h="1678304">
                  <a:moveTo>
                    <a:pt x="0" y="60451"/>
                  </a:moveTo>
                  <a:lnTo>
                    <a:pt x="15964408" y="60451"/>
                  </a:lnTo>
                </a:path>
                <a:path w="15964535" h="1678304">
                  <a:moveTo>
                    <a:pt x="0" y="44576"/>
                  </a:moveTo>
                  <a:lnTo>
                    <a:pt x="15964408" y="44576"/>
                  </a:lnTo>
                </a:path>
                <a:path w="15964535" h="1678304">
                  <a:moveTo>
                    <a:pt x="2176907" y="1678177"/>
                  </a:moveTo>
                  <a:lnTo>
                    <a:pt x="2176907" y="0"/>
                  </a:lnTo>
                </a:path>
                <a:path w="15964535" h="1678304">
                  <a:moveTo>
                    <a:pt x="5079619" y="1678177"/>
                  </a:moveTo>
                  <a:lnTo>
                    <a:pt x="5079619" y="0"/>
                  </a:lnTo>
                </a:path>
                <a:path w="15964535" h="1678304">
                  <a:moveTo>
                    <a:pt x="7982204" y="1678177"/>
                  </a:moveTo>
                  <a:lnTo>
                    <a:pt x="7982204" y="0"/>
                  </a:lnTo>
                </a:path>
                <a:path w="15964535" h="1678304">
                  <a:moveTo>
                    <a:pt x="10884789" y="1678177"/>
                  </a:moveTo>
                  <a:lnTo>
                    <a:pt x="10884789" y="0"/>
                  </a:lnTo>
                </a:path>
                <a:path w="15964535" h="1678304">
                  <a:moveTo>
                    <a:pt x="13787500" y="1678177"/>
                  </a:moveTo>
                  <a:lnTo>
                    <a:pt x="13787500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04" name="object 104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01850"/>
                  </a:moveTo>
                  <a:lnTo>
                    <a:pt x="15964408" y="1601850"/>
                  </a:lnTo>
                </a:path>
                <a:path w="15964535" h="1678304">
                  <a:moveTo>
                    <a:pt x="0" y="1570100"/>
                  </a:moveTo>
                  <a:lnTo>
                    <a:pt x="15964408" y="1570100"/>
                  </a:lnTo>
                </a:path>
                <a:path w="15964535" h="1678304">
                  <a:moveTo>
                    <a:pt x="0" y="1538350"/>
                  </a:moveTo>
                  <a:lnTo>
                    <a:pt x="15964408" y="1538350"/>
                  </a:lnTo>
                </a:path>
                <a:path w="15964535" h="1678304">
                  <a:moveTo>
                    <a:pt x="0" y="1506600"/>
                  </a:moveTo>
                  <a:lnTo>
                    <a:pt x="15964408" y="1506600"/>
                  </a:lnTo>
                </a:path>
                <a:path w="15964535" h="1678304">
                  <a:moveTo>
                    <a:pt x="0" y="1474723"/>
                  </a:moveTo>
                  <a:lnTo>
                    <a:pt x="15964408" y="1474723"/>
                  </a:lnTo>
                </a:path>
                <a:path w="15964535" h="1678304">
                  <a:moveTo>
                    <a:pt x="0" y="1442973"/>
                  </a:moveTo>
                  <a:lnTo>
                    <a:pt x="15964408" y="1442973"/>
                  </a:lnTo>
                </a:path>
                <a:path w="15964535" h="1678304">
                  <a:moveTo>
                    <a:pt x="0" y="1411223"/>
                  </a:moveTo>
                  <a:lnTo>
                    <a:pt x="15964408" y="1411223"/>
                  </a:lnTo>
                </a:path>
                <a:path w="15964535" h="1678304">
                  <a:moveTo>
                    <a:pt x="0" y="1379473"/>
                  </a:moveTo>
                  <a:lnTo>
                    <a:pt x="15964408" y="1379473"/>
                  </a:lnTo>
                </a:path>
                <a:path w="15964535" h="1678304">
                  <a:moveTo>
                    <a:pt x="0" y="1347596"/>
                  </a:moveTo>
                  <a:lnTo>
                    <a:pt x="15964408" y="1347596"/>
                  </a:lnTo>
                </a:path>
                <a:path w="15964535" h="1678304">
                  <a:moveTo>
                    <a:pt x="0" y="1315846"/>
                  </a:moveTo>
                  <a:lnTo>
                    <a:pt x="15964408" y="1315846"/>
                  </a:lnTo>
                </a:path>
                <a:path w="15964535" h="1678304">
                  <a:moveTo>
                    <a:pt x="0" y="1284096"/>
                  </a:moveTo>
                  <a:lnTo>
                    <a:pt x="15964408" y="1284096"/>
                  </a:lnTo>
                </a:path>
                <a:path w="15964535" h="1678304">
                  <a:moveTo>
                    <a:pt x="0" y="1252219"/>
                  </a:moveTo>
                  <a:lnTo>
                    <a:pt x="15964408" y="1252219"/>
                  </a:lnTo>
                </a:path>
                <a:path w="15964535" h="1678304">
                  <a:moveTo>
                    <a:pt x="0" y="1220469"/>
                  </a:moveTo>
                  <a:lnTo>
                    <a:pt x="15964408" y="1220469"/>
                  </a:lnTo>
                </a:path>
                <a:path w="15964535" h="1678304">
                  <a:moveTo>
                    <a:pt x="0" y="1188719"/>
                  </a:moveTo>
                  <a:lnTo>
                    <a:pt x="15964408" y="1188719"/>
                  </a:lnTo>
                </a:path>
                <a:path w="15964535" h="1678304">
                  <a:moveTo>
                    <a:pt x="0" y="1156969"/>
                  </a:moveTo>
                  <a:lnTo>
                    <a:pt x="15964408" y="1156969"/>
                  </a:lnTo>
                </a:path>
                <a:path w="15964535" h="1678304">
                  <a:moveTo>
                    <a:pt x="0" y="1125092"/>
                  </a:moveTo>
                  <a:lnTo>
                    <a:pt x="15964408" y="1125092"/>
                  </a:lnTo>
                </a:path>
                <a:path w="15964535" h="1678304">
                  <a:moveTo>
                    <a:pt x="0" y="1093342"/>
                  </a:moveTo>
                  <a:lnTo>
                    <a:pt x="15964408" y="1093342"/>
                  </a:lnTo>
                </a:path>
                <a:path w="15964535" h="1678304">
                  <a:moveTo>
                    <a:pt x="0" y="1061592"/>
                  </a:moveTo>
                  <a:lnTo>
                    <a:pt x="15964408" y="1061592"/>
                  </a:lnTo>
                </a:path>
                <a:path w="15964535" h="1678304">
                  <a:moveTo>
                    <a:pt x="0" y="1029842"/>
                  </a:moveTo>
                  <a:lnTo>
                    <a:pt x="15964408" y="1029842"/>
                  </a:lnTo>
                </a:path>
                <a:path w="15964535" h="1678304">
                  <a:moveTo>
                    <a:pt x="0" y="997965"/>
                  </a:moveTo>
                  <a:lnTo>
                    <a:pt x="15964408" y="997965"/>
                  </a:lnTo>
                </a:path>
                <a:path w="15964535" h="1678304">
                  <a:moveTo>
                    <a:pt x="0" y="966215"/>
                  </a:moveTo>
                  <a:lnTo>
                    <a:pt x="15964408" y="966215"/>
                  </a:lnTo>
                </a:path>
                <a:path w="15964535" h="1678304">
                  <a:moveTo>
                    <a:pt x="0" y="934465"/>
                  </a:moveTo>
                  <a:lnTo>
                    <a:pt x="15964408" y="934465"/>
                  </a:lnTo>
                </a:path>
                <a:path w="15964535" h="1678304">
                  <a:moveTo>
                    <a:pt x="0" y="902715"/>
                  </a:moveTo>
                  <a:lnTo>
                    <a:pt x="15964408" y="902715"/>
                  </a:lnTo>
                </a:path>
                <a:path w="15964535" h="1678304">
                  <a:moveTo>
                    <a:pt x="0" y="870838"/>
                  </a:moveTo>
                  <a:lnTo>
                    <a:pt x="15964408" y="870838"/>
                  </a:lnTo>
                </a:path>
                <a:path w="15964535" h="1678304">
                  <a:moveTo>
                    <a:pt x="0" y="839088"/>
                  </a:moveTo>
                  <a:lnTo>
                    <a:pt x="15964408" y="839088"/>
                  </a:lnTo>
                </a:path>
                <a:path w="15964535" h="1678304">
                  <a:moveTo>
                    <a:pt x="0" y="807338"/>
                  </a:moveTo>
                  <a:lnTo>
                    <a:pt x="15964408" y="807338"/>
                  </a:lnTo>
                </a:path>
                <a:path w="15964535" h="1678304">
                  <a:moveTo>
                    <a:pt x="0" y="775588"/>
                  </a:moveTo>
                  <a:lnTo>
                    <a:pt x="15964408" y="775588"/>
                  </a:lnTo>
                </a:path>
                <a:path w="15964535" h="1678304">
                  <a:moveTo>
                    <a:pt x="0" y="743711"/>
                  </a:moveTo>
                  <a:lnTo>
                    <a:pt x="15964408" y="743711"/>
                  </a:lnTo>
                </a:path>
                <a:path w="15964535" h="1678304">
                  <a:moveTo>
                    <a:pt x="0" y="711961"/>
                  </a:moveTo>
                  <a:lnTo>
                    <a:pt x="15964408" y="711961"/>
                  </a:lnTo>
                </a:path>
                <a:path w="15964535" h="1678304">
                  <a:moveTo>
                    <a:pt x="0" y="680211"/>
                  </a:moveTo>
                  <a:lnTo>
                    <a:pt x="15964408" y="680211"/>
                  </a:lnTo>
                </a:path>
                <a:path w="15964535" h="1678304">
                  <a:moveTo>
                    <a:pt x="0" y="648461"/>
                  </a:moveTo>
                  <a:lnTo>
                    <a:pt x="15964408" y="648461"/>
                  </a:lnTo>
                </a:path>
                <a:path w="15964535" h="1678304">
                  <a:moveTo>
                    <a:pt x="0" y="616584"/>
                  </a:moveTo>
                  <a:lnTo>
                    <a:pt x="15964408" y="616584"/>
                  </a:lnTo>
                </a:path>
                <a:path w="15964535" h="1678304">
                  <a:moveTo>
                    <a:pt x="0" y="584834"/>
                  </a:moveTo>
                  <a:lnTo>
                    <a:pt x="15964408" y="584834"/>
                  </a:lnTo>
                </a:path>
                <a:path w="15964535" h="1678304">
                  <a:moveTo>
                    <a:pt x="0" y="553084"/>
                  </a:moveTo>
                  <a:lnTo>
                    <a:pt x="15964408" y="553084"/>
                  </a:lnTo>
                </a:path>
                <a:path w="15964535" h="1678304">
                  <a:moveTo>
                    <a:pt x="0" y="521334"/>
                  </a:moveTo>
                  <a:lnTo>
                    <a:pt x="15964408" y="521334"/>
                  </a:lnTo>
                </a:path>
                <a:path w="15964535" h="1678304">
                  <a:moveTo>
                    <a:pt x="0" y="489457"/>
                  </a:moveTo>
                  <a:lnTo>
                    <a:pt x="15964408" y="489457"/>
                  </a:lnTo>
                </a:path>
                <a:path w="15964535" h="1678304">
                  <a:moveTo>
                    <a:pt x="0" y="457707"/>
                  </a:moveTo>
                  <a:lnTo>
                    <a:pt x="15964408" y="457707"/>
                  </a:lnTo>
                </a:path>
                <a:path w="15964535" h="1678304">
                  <a:moveTo>
                    <a:pt x="0" y="425957"/>
                  </a:moveTo>
                  <a:lnTo>
                    <a:pt x="15964408" y="425957"/>
                  </a:lnTo>
                </a:path>
                <a:path w="15964535" h="1678304">
                  <a:moveTo>
                    <a:pt x="0" y="394080"/>
                  </a:moveTo>
                  <a:lnTo>
                    <a:pt x="15964408" y="394080"/>
                  </a:lnTo>
                </a:path>
                <a:path w="15964535" h="1678304">
                  <a:moveTo>
                    <a:pt x="0" y="362330"/>
                  </a:moveTo>
                  <a:lnTo>
                    <a:pt x="15964408" y="362330"/>
                  </a:lnTo>
                </a:path>
                <a:path w="15964535" h="1678304">
                  <a:moveTo>
                    <a:pt x="0" y="330580"/>
                  </a:moveTo>
                  <a:lnTo>
                    <a:pt x="15964408" y="330580"/>
                  </a:lnTo>
                </a:path>
                <a:path w="15964535" h="1678304">
                  <a:moveTo>
                    <a:pt x="0" y="266953"/>
                  </a:moveTo>
                  <a:lnTo>
                    <a:pt x="15964408" y="266953"/>
                  </a:lnTo>
                </a:path>
                <a:path w="15964535" h="1678304">
                  <a:moveTo>
                    <a:pt x="0" y="76326"/>
                  </a:moveTo>
                  <a:lnTo>
                    <a:pt x="15964408" y="76326"/>
                  </a:lnTo>
                </a:path>
                <a:path w="15964535" h="1678304">
                  <a:moveTo>
                    <a:pt x="725678" y="1678177"/>
                  </a:moveTo>
                  <a:lnTo>
                    <a:pt x="725678" y="0"/>
                  </a:lnTo>
                </a:path>
                <a:path w="15964535" h="1678304">
                  <a:moveTo>
                    <a:pt x="3628263" y="1678177"/>
                  </a:moveTo>
                  <a:lnTo>
                    <a:pt x="3628263" y="0"/>
                  </a:lnTo>
                </a:path>
                <a:path w="15964535" h="1678304">
                  <a:moveTo>
                    <a:pt x="6530848" y="1678177"/>
                  </a:moveTo>
                  <a:lnTo>
                    <a:pt x="6530848" y="0"/>
                  </a:lnTo>
                </a:path>
                <a:path w="15964535" h="1678304">
                  <a:moveTo>
                    <a:pt x="9433560" y="1678177"/>
                  </a:moveTo>
                  <a:lnTo>
                    <a:pt x="9433560" y="0"/>
                  </a:lnTo>
                </a:path>
                <a:path w="15964535" h="1678304">
                  <a:moveTo>
                    <a:pt x="12336145" y="1678177"/>
                  </a:moveTo>
                  <a:lnTo>
                    <a:pt x="12336145" y="0"/>
                  </a:lnTo>
                </a:path>
                <a:path w="15964535" h="1678304">
                  <a:moveTo>
                    <a:pt x="15238730" y="1678177"/>
                  </a:moveTo>
                  <a:lnTo>
                    <a:pt x="15238730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05" name="object 105" descr=""/>
            <p:cNvSpPr/>
            <p:nvPr/>
          </p:nvSpPr>
          <p:spPr>
            <a:xfrm>
              <a:off x="1531112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4" h="0">
                  <a:moveTo>
                    <a:pt x="10413" y="0"/>
                  </a:moveTo>
                  <a:lnTo>
                    <a:pt x="0" y="0"/>
                  </a:lnTo>
                  <a:lnTo>
                    <a:pt x="10413" y="0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6" name="object 106" descr=""/>
            <p:cNvSpPr/>
            <p:nvPr/>
          </p:nvSpPr>
          <p:spPr>
            <a:xfrm>
              <a:off x="1531112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4" h="0">
                  <a:moveTo>
                    <a:pt x="0" y="0"/>
                  </a:moveTo>
                  <a:lnTo>
                    <a:pt x="10413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E95359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07" name="object 107" descr=""/>
            <p:cNvSpPr/>
            <p:nvPr/>
          </p:nvSpPr>
          <p:spPr>
            <a:xfrm>
              <a:off x="1647177" y="7899654"/>
              <a:ext cx="4074160" cy="763270"/>
            </a:xfrm>
            <a:custGeom>
              <a:avLst/>
              <a:gdLst/>
              <a:ahLst/>
              <a:cxnLst/>
              <a:rect l="l" t="t" r="r" b="b"/>
              <a:pathLst>
                <a:path w="4074160" h="763270">
                  <a:moveTo>
                    <a:pt x="10414" y="731012"/>
                  </a:moveTo>
                  <a:lnTo>
                    <a:pt x="0" y="731012"/>
                  </a:lnTo>
                  <a:lnTo>
                    <a:pt x="0" y="762762"/>
                  </a:lnTo>
                  <a:lnTo>
                    <a:pt x="10414" y="762762"/>
                  </a:lnTo>
                  <a:lnTo>
                    <a:pt x="10414" y="731012"/>
                  </a:lnTo>
                  <a:close/>
                </a:path>
                <a:path w="4074160" h="763270">
                  <a:moveTo>
                    <a:pt x="68465" y="731012"/>
                  </a:moveTo>
                  <a:lnTo>
                    <a:pt x="58051" y="731012"/>
                  </a:lnTo>
                  <a:lnTo>
                    <a:pt x="58051" y="762762"/>
                  </a:lnTo>
                  <a:lnTo>
                    <a:pt x="68465" y="762762"/>
                  </a:lnTo>
                  <a:lnTo>
                    <a:pt x="68465" y="731012"/>
                  </a:lnTo>
                  <a:close/>
                </a:path>
                <a:path w="4074160" h="763270">
                  <a:moveTo>
                    <a:pt x="126504" y="731012"/>
                  </a:moveTo>
                  <a:lnTo>
                    <a:pt x="116090" y="731012"/>
                  </a:lnTo>
                  <a:lnTo>
                    <a:pt x="116090" y="762762"/>
                  </a:lnTo>
                  <a:lnTo>
                    <a:pt x="126504" y="762762"/>
                  </a:lnTo>
                  <a:lnTo>
                    <a:pt x="126504" y="731012"/>
                  </a:lnTo>
                  <a:close/>
                </a:path>
                <a:path w="4074160" h="763270">
                  <a:moveTo>
                    <a:pt x="184543" y="476758"/>
                  </a:moveTo>
                  <a:lnTo>
                    <a:pt x="174129" y="476758"/>
                  </a:lnTo>
                  <a:lnTo>
                    <a:pt x="174129" y="762762"/>
                  </a:lnTo>
                  <a:lnTo>
                    <a:pt x="184543" y="762762"/>
                  </a:lnTo>
                  <a:lnTo>
                    <a:pt x="184543" y="476758"/>
                  </a:lnTo>
                  <a:close/>
                </a:path>
                <a:path w="4074160" h="763270">
                  <a:moveTo>
                    <a:pt x="242570" y="444881"/>
                  </a:moveTo>
                  <a:lnTo>
                    <a:pt x="232168" y="444881"/>
                  </a:lnTo>
                  <a:lnTo>
                    <a:pt x="232168" y="762762"/>
                  </a:lnTo>
                  <a:lnTo>
                    <a:pt x="242570" y="762762"/>
                  </a:lnTo>
                  <a:lnTo>
                    <a:pt x="242570" y="444881"/>
                  </a:lnTo>
                  <a:close/>
                </a:path>
                <a:path w="4074160" h="763270">
                  <a:moveTo>
                    <a:pt x="300621" y="413131"/>
                  </a:moveTo>
                  <a:lnTo>
                    <a:pt x="290207" y="413131"/>
                  </a:lnTo>
                  <a:lnTo>
                    <a:pt x="290207" y="762762"/>
                  </a:lnTo>
                  <a:lnTo>
                    <a:pt x="300621" y="762762"/>
                  </a:lnTo>
                  <a:lnTo>
                    <a:pt x="300621" y="413131"/>
                  </a:lnTo>
                  <a:close/>
                </a:path>
                <a:path w="4074160" h="763270">
                  <a:moveTo>
                    <a:pt x="358660" y="158877"/>
                  </a:moveTo>
                  <a:lnTo>
                    <a:pt x="348246" y="158877"/>
                  </a:lnTo>
                  <a:lnTo>
                    <a:pt x="348246" y="762762"/>
                  </a:lnTo>
                  <a:lnTo>
                    <a:pt x="358660" y="762762"/>
                  </a:lnTo>
                  <a:lnTo>
                    <a:pt x="358660" y="158877"/>
                  </a:lnTo>
                  <a:close/>
                </a:path>
                <a:path w="4074160" h="763270">
                  <a:moveTo>
                    <a:pt x="416814" y="444881"/>
                  </a:moveTo>
                  <a:lnTo>
                    <a:pt x="406412" y="444881"/>
                  </a:lnTo>
                  <a:lnTo>
                    <a:pt x="406412" y="762762"/>
                  </a:lnTo>
                  <a:lnTo>
                    <a:pt x="416814" y="762762"/>
                  </a:lnTo>
                  <a:lnTo>
                    <a:pt x="416814" y="444881"/>
                  </a:lnTo>
                  <a:close/>
                </a:path>
                <a:path w="4074160" h="763270">
                  <a:moveTo>
                    <a:pt x="474865" y="540258"/>
                  </a:moveTo>
                  <a:lnTo>
                    <a:pt x="464451" y="540258"/>
                  </a:lnTo>
                  <a:lnTo>
                    <a:pt x="464451" y="762762"/>
                  </a:lnTo>
                  <a:lnTo>
                    <a:pt x="474865" y="762762"/>
                  </a:lnTo>
                  <a:lnTo>
                    <a:pt x="474865" y="540258"/>
                  </a:lnTo>
                  <a:close/>
                </a:path>
                <a:path w="4074160" h="763270">
                  <a:moveTo>
                    <a:pt x="532904" y="286004"/>
                  </a:moveTo>
                  <a:lnTo>
                    <a:pt x="522490" y="286004"/>
                  </a:lnTo>
                  <a:lnTo>
                    <a:pt x="522490" y="762762"/>
                  </a:lnTo>
                  <a:lnTo>
                    <a:pt x="532904" y="762762"/>
                  </a:lnTo>
                  <a:lnTo>
                    <a:pt x="532904" y="286004"/>
                  </a:lnTo>
                  <a:close/>
                </a:path>
                <a:path w="4074160" h="763270">
                  <a:moveTo>
                    <a:pt x="590943" y="540258"/>
                  </a:moveTo>
                  <a:lnTo>
                    <a:pt x="580529" y="540258"/>
                  </a:lnTo>
                  <a:lnTo>
                    <a:pt x="580529" y="762762"/>
                  </a:lnTo>
                  <a:lnTo>
                    <a:pt x="590943" y="762762"/>
                  </a:lnTo>
                  <a:lnTo>
                    <a:pt x="590943" y="540258"/>
                  </a:lnTo>
                  <a:close/>
                </a:path>
                <a:path w="4074160" h="763270">
                  <a:moveTo>
                    <a:pt x="648970" y="286004"/>
                  </a:moveTo>
                  <a:lnTo>
                    <a:pt x="638568" y="286004"/>
                  </a:lnTo>
                  <a:lnTo>
                    <a:pt x="638568" y="762762"/>
                  </a:lnTo>
                  <a:lnTo>
                    <a:pt x="648970" y="762762"/>
                  </a:lnTo>
                  <a:lnTo>
                    <a:pt x="648970" y="286004"/>
                  </a:lnTo>
                  <a:close/>
                </a:path>
                <a:path w="4074160" h="763270">
                  <a:moveTo>
                    <a:pt x="707021" y="603885"/>
                  </a:moveTo>
                  <a:lnTo>
                    <a:pt x="696607" y="603885"/>
                  </a:lnTo>
                  <a:lnTo>
                    <a:pt x="696607" y="762762"/>
                  </a:lnTo>
                  <a:lnTo>
                    <a:pt x="707021" y="762762"/>
                  </a:lnTo>
                  <a:lnTo>
                    <a:pt x="707021" y="603885"/>
                  </a:lnTo>
                  <a:close/>
                </a:path>
                <a:path w="4074160" h="763270">
                  <a:moveTo>
                    <a:pt x="765060" y="508508"/>
                  </a:moveTo>
                  <a:lnTo>
                    <a:pt x="754646" y="508508"/>
                  </a:lnTo>
                  <a:lnTo>
                    <a:pt x="754646" y="762762"/>
                  </a:lnTo>
                  <a:lnTo>
                    <a:pt x="765060" y="762762"/>
                  </a:lnTo>
                  <a:lnTo>
                    <a:pt x="765060" y="508508"/>
                  </a:lnTo>
                  <a:close/>
                </a:path>
                <a:path w="4074160" h="763270">
                  <a:moveTo>
                    <a:pt x="823099" y="476758"/>
                  </a:moveTo>
                  <a:lnTo>
                    <a:pt x="812685" y="476758"/>
                  </a:lnTo>
                  <a:lnTo>
                    <a:pt x="812685" y="762762"/>
                  </a:lnTo>
                  <a:lnTo>
                    <a:pt x="823099" y="762762"/>
                  </a:lnTo>
                  <a:lnTo>
                    <a:pt x="823099" y="476758"/>
                  </a:lnTo>
                  <a:close/>
                </a:path>
                <a:path w="4074160" h="763270">
                  <a:moveTo>
                    <a:pt x="881126" y="476758"/>
                  </a:moveTo>
                  <a:lnTo>
                    <a:pt x="870724" y="476758"/>
                  </a:lnTo>
                  <a:lnTo>
                    <a:pt x="870724" y="762762"/>
                  </a:lnTo>
                  <a:lnTo>
                    <a:pt x="881126" y="762762"/>
                  </a:lnTo>
                  <a:lnTo>
                    <a:pt x="881126" y="476758"/>
                  </a:lnTo>
                  <a:close/>
                </a:path>
                <a:path w="4074160" h="763270">
                  <a:moveTo>
                    <a:pt x="939177" y="381381"/>
                  </a:moveTo>
                  <a:lnTo>
                    <a:pt x="928763" y="381381"/>
                  </a:lnTo>
                  <a:lnTo>
                    <a:pt x="928763" y="762762"/>
                  </a:lnTo>
                  <a:lnTo>
                    <a:pt x="939177" y="762762"/>
                  </a:lnTo>
                  <a:lnTo>
                    <a:pt x="939177" y="381381"/>
                  </a:lnTo>
                  <a:close/>
                </a:path>
                <a:path w="4074160" h="763270">
                  <a:moveTo>
                    <a:pt x="997343" y="381381"/>
                  </a:moveTo>
                  <a:lnTo>
                    <a:pt x="986929" y="381381"/>
                  </a:lnTo>
                  <a:lnTo>
                    <a:pt x="986929" y="762762"/>
                  </a:lnTo>
                  <a:lnTo>
                    <a:pt x="997343" y="762762"/>
                  </a:lnTo>
                  <a:lnTo>
                    <a:pt x="997343" y="381381"/>
                  </a:lnTo>
                  <a:close/>
                </a:path>
                <a:path w="4074160" h="763270">
                  <a:moveTo>
                    <a:pt x="1055370" y="508508"/>
                  </a:moveTo>
                  <a:lnTo>
                    <a:pt x="1044968" y="508508"/>
                  </a:lnTo>
                  <a:lnTo>
                    <a:pt x="1044968" y="762762"/>
                  </a:lnTo>
                  <a:lnTo>
                    <a:pt x="1055370" y="762762"/>
                  </a:lnTo>
                  <a:lnTo>
                    <a:pt x="1055370" y="508508"/>
                  </a:lnTo>
                  <a:close/>
                </a:path>
                <a:path w="4074160" h="763270">
                  <a:moveTo>
                    <a:pt x="1113421" y="381381"/>
                  </a:moveTo>
                  <a:lnTo>
                    <a:pt x="1103007" y="381381"/>
                  </a:lnTo>
                  <a:lnTo>
                    <a:pt x="1103007" y="762762"/>
                  </a:lnTo>
                  <a:lnTo>
                    <a:pt x="1113421" y="762762"/>
                  </a:lnTo>
                  <a:lnTo>
                    <a:pt x="1113421" y="381381"/>
                  </a:lnTo>
                  <a:close/>
                </a:path>
                <a:path w="4074160" h="763270">
                  <a:moveTo>
                    <a:pt x="1171460" y="444881"/>
                  </a:moveTo>
                  <a:lnTo>
                    <a:pt x="1161046" y="444881"/>
                  </a:lnTo>
                  <a:lnTo>
                    <a:pt x="1161046" y="762762"/>
                  </a:lnTo>
                  <a:lnTo>
                    <a:pt x="1171460" y="762762"/>
                  </a:lnTo>
                  <a:lnTo>
                    <a:pt x="1171460" y="444881"/>
                  </a:lnTo>
                  <a:close/>
                </a:path>
                <a:path w="4074160" h="763270">
                  <a:moveTo>
                    <a:pt x="1229499" y="508508"/>
                  </a:moveTo>
                  <a:lnTo>
                    <a:pt x="1219085" y="508508"/>
                  </a:lnTo>
                  <a:lnTo>
                    <a:pt x="1219085" y="762762"/>
                  </a:lnTo>
                  <a:lnTo>
                    <a:pt x="1229499" y="762762"/>
                  </a:lnTo>
                  <a:lnTo>
                    <a:pt x="1229499" y="508508"/>
                  </a:lnTo>
                  <a:close/>
                </a:path>
                <a:path w="4074160" h="763270">
                  <a:moveTo>
                    <a:pt x="1287526" y="476758"/>
                  </a:moveTo>
                  <a:lnTo>
                    <a:pt x="1277124" y="476758"/>
                  </a:lnTo>
                  <a:lnTo>
                    <a:pt x="1277124" y="762762"/>
                  </a:lnTo>
                  <a:lnTo>
                    <a:pt x="1287526" y="762762"/>
                  </a:lnTo>
                  <a:lnTo>
                    <a:pt x="1287526" y="476758"/>
                  </a:lnTo>
                  <a:close/>
                </a:path>
                <a:path w="4074160" h="763270">
                  <a:moveTo>
                    <a:pt x="1345577" y="31750"/>
                  </a:moveTo>
                  <a:lnTo>
                    <a:pt x="1335163" y="31750"/>
                  </a:lnTo>
                  <a:lnTo>
                    <a:pt x="1335163" y="762762"/>
                  </a:lnTo>
                  <a:lnTo>
                    <a:pt x="1345577" y="762762"/>
                  </a:lnTo>
                  <a:lnTo>
                    <a:pt x="1345577" y="31750"/>
                  </a:lnTo>
                  <a:close/>
                </a:path>
                <a:path w="4074160" h="763270">
                  <a:moveTo>
                    <a:pt x="1403616" y="381381"/>
                  </a:moveTo>
                  <a:lnTo>
                    <a:pt x="1393202" y="381381"/>
                  </a:lnTo>
                  <a:lnTo>
                    <a:pt x="1393202" y="762762"/>
                  </a:lnTo>
                  <a:lnTo>
                    <a:pt x="1403616" y="762762"/>
                  </a:lnTo>
                  <a:lnTo>
                    <a:pt x="1403616" y="381381"/>
                  </a:lnTo>
                  <a:close/>
                </a:path>
                <a:path w="4074160" h="763270">
                  <a:moveTo>
                    <a:pt x="1461655" y="349631"/>
                  </a:moveTo>
                  <a:lnTo>
                    <a:pt x="1451241" y="349631"/>
                  </a:lnTo>
                  <a:lnTo>
                    <a:pt x="1451241" y="762762"/>
                  </a:lnTo>
                  <a:lnTo>
                    <a:pt x="1461655" y="762762"/>
                  </a:lnTo>
                  <a:lnTo>
                    <a:pt x="1461655" y="349631"/>
                  </a:lnTo>
                  <a:close/>
                </a:path>
                <a:path w="4074160" h="763270">
                  <a:moveTo>
                    <a:pt x="1519821" y="572008"/>
                  </a:moveTo>
                  <a:lnTo>
                    <a:pt x="1509407" y="572008"/>
                  </a:lnTo>
                  <a:lnTo>
                    <a:pt x="1509407" y="762762"/>
                  </a:lnTo>
                  <a:lnTo>
                    <a:pt x="1519821" y="762762"/>
                  </a:lnTo>
                  <a:lnTo>
                    <a:pt x="1519821" y="572008"/>
                  </a:lnTo>
                  <a:close/>
                </a:path>
                <a:path w="4074160" h="763270">
                  <a:moveTo>
                    <a:pt x="1577860" y="540258"/>
                  </a:moveTo>
                  <a:lnTo>
                    <a:pt x="1567446" y="540258"/>
                  </a:lnTo>
                  <a:lnTo>
                    <a:pt x="1567446" y="762762"/>
                  </a:lnTo>
                  <a:lnTo>
                    <a:pt x="1577860" y="762762"/>
                  </a:lnTo>
                  <a:lnTo>
                    <a:pt x="1577860" y="540258"/>
                  </a:lnTo>
                  <a:close/>
                </a:path>
                <a:path w="4074160" h="763270">
                  <a:moveTo>
                    <a:pt x="1635899" y="413131"/>
                  </a:moveTo>
                  <a:lnTo>
                    <a:pt x="1625485" y="413131"/>
                  </a:lnTo>
                  <a:lnTo>
                    <a:pt x="1625485" y="762762"/>
                  </a:lnTo>
                  <a:lnTo>
                    <a:pt x="1635899" y="762762"/>
                  </a:lnTo>
                  <a:lnTo>
                    <a:pt x="1635899" y="413131"/>
                  </a:lnTo>
                  <a:close/>
                </a:path>
                <a:path w="4074160" h="763270">
                  <a:moveTo>
                    <a:pt x="1693938" y="317754"/>
                  </a:moveTo>
                  <a:lnTo>
                    <a:pt x="1683524" y="317754"/>
                  </a:lnTo>
                  <a:lnTo>
                    <a:pt x="1683524" y="762762"/>
                  </a:lnTo>
                  <a:lnTo>
                    <a:pt x="1693938" y="762762"/>
                  </a:lnTo>
                  <a:lnTo>
                    <a:pt x="1693938" y="317754"/>
                  </a:lnTo>
                  <a:close/>
                </a:path>
                <a:path w="4074160" h="763270">
                  <a:moveTo>
                    <a:pt x="1751977" y="349631"/>
                  </a:moveTo>
                  <a:lnTo>
                    <a:pt x="1741563" y="349631"/>
                  </a:lnTo>
                  <a:lnTo>
                    <a:pt x="1741563" y="762762"/>
                  </a:lnTo>
                  <a:lnTo>
                    <a:pt x="1751977" y="762762"/>
                  </a:lnTo>
                  <a:lnTo>
                    <a:pt x="1751977" y="349631"/>
                  </a:lnTo>
                  <a:close/>
                </a:path>
                <a:path w="4074160" h="763270">
                  <a:moveTo>
                    <a:pt x="1810004" y="476758"/>
                  </a:moveTo>
                  <a:lnTo>
                    <a:pt x="1799602" y="476758"/>
                  </a:lnTo>
                  <a:lnTo>
                    <a:pt x="1799602" y="762762"/>
                  </a:lnTo>
                  <a:lnTo>
                    <a:pt x="1810004" y="762762"/>
                  </a:lnTo>
                  <a:lnTo>
                    <a:pt x="1810004" y="476758"/>
                  </a:lnTo>
                  <a:close/>
                </a:path>
                <a:path w="4074160" h="763270">
                  <a:moveTo>
                    <a:pt x="1868055" y="635635"/>
                  </a:moveTo>
                  <a:lnTo>
                    <a:pt x="1857641" y="635635"/>
                  </a:lnTo>
                  <a:lnTo>
                    <a:pt x="1857641" y="762762"/>
                  </a:lnTo>
                  <a:lnTo>
                    <a:pt x="1868055" y="762762"/>
                  </a:lnTo>
                  <a:lnTo>
                    <a:pt x="1868055" y="635635"/>
                  </a:lnTo>
                  <a:close/>
                </a:path>
                <a:path w="4074160" h="763270">
                  <a:moveTo>
                    <a:pt x="1926094" y="572008"/>
                  </a:moveTo>
                  <a:lnTo>
                    <a:pt x="1915680" y="572008"/>
                  </a:lnTo>
                  <a:lnTo>
                    <a:pt x="1915680" y="762762"/>
                  </a:lnTo>
                  <a:lnTo>
                    <a:pt x="1926094" y="762762"/>
                  </a:lnTo>
                  <a:lnTo>
                    <a:pt x="1926094" y="572008"/>
                  </a:lnTo>
                  <a:close/>
                </a:path>
                <a:path w="4074160" h="763270">
                  <a:moveTo>
                    <a:pt x="1984133" y="317754"/>
                  </a:moveTo>
                  <a:lnTo>
                    <a:pt x="1973719" y="317754"/>
                  </a:lnTo>
                  <a:lnTo>
                    <a:pt x="1973719" y="762762"/>
                  </a:lnTo>
                  <a:lnTo>
                    <a:pt x="1984133" y="762762"/>
                  </a:lnTo>
                  <a:lnTo>
                    <a:pt x="1984133" y="317754"/>
                  </a:lnTo>
                  <a:close/>
                </a:path>
                <a:path w="4074160" h="763270">
                  <a:moveTo>
                    <a:pt x="2042299" y="381381"/>
                  </a:moveTo>
                  <a:lnTo>
                    <a:pt x="2031885" y="381381"/>
                  </a:lnTo>
                  <a:lnTo>
                    <a:pt x="2031885" y="762762"/>
                  </a:lnTo>
                  <a:lnTo>
                    <a:pt x="2042299" y="762762"/>
                  </a:lnTo>
                  <a:lnTo>
                    <a:pt x="2042299" y="381381"/>
                  </a:lnTo>
                  <a:close/>
                </a:path>
                <a:path w="4074160" h="763270">
                  <a:moveTo>
                    <a:pt x="2100338" y="508508"/>
                  </a:moveTo>
                  <a:lnTo>
                    <a:pt x="2089924" y="508508"/>
                  </a:lnTo>
                  <a:lnTo>
                    <a:pt x="2089924" y="762762"/>
                  </a:lnTo>
                  <a:lnTo>
                    <a:pt x="2100338" y="762762"/>
                  </a:lnTo>
                  <a:lnTo>
                    <a:pt x="2100338" y="508508"/>
                  </a:lnTo>
                  <a:close/>
                </a:path>
                <a:path w="4074160" h="763270">
                  <a:moveTo>
                    <a:pt x="2158377" y="540258"/>
                  </a:moveTo>
                  <a:lnTo>
                    <a:pt x="2147963" y="540258"/>
                  </a:lnTo>
                  <a:lnTo>
                    <a:pt x="2147963" y="762762"/>
                  </a:lnTo>
                  <a:lnTo>
                    <a:pt x="2158377" y="762762"/>
                  </a:lnTo>
                  <a:lnTo>
                    <a:pt x="2158377" y="540258"/>
                  </a:lnTo>
                  <a:close/>
                </a:path>
                <a:path w="4074160" h="763270">
                  <a:moveTo>
                    <a:pt x="2216404" y="540258"/>
                  </a:moveTo>
                  <a:lnTo>
                    <a:pt x="2206002" y="540258"/>
                  </a:lnTo>
                  <a:lnTo>
                    <a:pt x="2206002" y="762762"/>
                  </a:lnTo>
                  <a:lnTo>
                    <a:pt x="2216404" y="762762"/>
                  </a:lnTo>
                  <a:lnTo>
                    <a:pt x="2216404" y="540258"/>
                  </a:lnTo>
                  <a:close/>
                </a:path>
                <a:path w="4074160" h="763270">
                  <a:moveTo>
                    <a:pt x="2274455" y="413131"/>
                  </a:moveTo>
                  <a:lnTo>
                    <a:pt x="2264041" y="413131"/>
                  </a:lnTo>
                  <a:lnTo>
                    <a:pt x="2264041" y="762762"/>
                  </a:lnTo>
                  <a:lnTo>
                    <a:pt x="2274455" y="762762"/>
                  </a:lnTo>
                  <a:lnTo>
                    <a:pt x="2274455" y="413131"/>
                  </a:lnTo>
                  <a:close/>
                </a:path>
                <a:path w="4074160" h="763270">
                  <a:moveTo>
                    <a:pt x="2332494" y="444881"/>
                  </a:moveTo>
                  <a:lnTo>
                    <a:pt x="2322080" y="444881"/>
                  </a:lnTo>
                  <a:lnTo>
                    <a:pt x="2322080" y="762762"/>
                  </a:lnTo>
                  <a:lnTo>
                    <a:pt x="2332494" y="762762"/>
                  </a:lnTo>
                  <a:lnTo>
                    <a:pt x="2332494" y="444881"/>
                  </a:lnTo>
                  <a:close/>
                </a:path>
                <a:path w="4074160" h="763270">
                  <a:moveTo>
                    <a:pt x="2390533" y="444881"/>
                  </a:moveTo>
                  <a:lnTo>
                    <a:pt x="2380119" y="444881"/>
                  </a:lnTo>
                  <a:lnTo>
                    <a:pt x="2380119" y="762762"/>
                  </a:lnTo>
                  <a:lnTo>
                    <a:pt x="2390533" y="762762"/>
                  </a:lnTo>
                  <a:lnTo>
                    <a:pt x="2390533" y="444881"/>
                  </a:lnTo>
                  <a:close/>
                </a:path>
                <a:path w="4074160" h="763270">
                  <a:moveTo>
                    <a:pt x="2448572" y="476758"/>
                  </a:moveTo>
                  <a:lnTo>
                    <a:pt x="2438158" y="476758"/>
                  </a:lnTo>
                  <a:lnTo>
                    <a:pt x="2438158" y="762762"/>
                  </a:lnTo>
                  <a:lnTo>
                    <a:pt x="2448572" y="762762"/>
                  </a:lnTo>
                  <a:lnTo>
                    <a:pt x="2448572" y="476758"/>
                  </a:lnTo>
                  <a:close/>
                </a:path>
                <a:path w="4074160" h="763270">
                  <a:moveTo>
                    <a:pt x="2506611" y="572008"/>
                  </a:moveTo>
                  <a:lnTo>
                    <a:pt x="2496197" y="572008"/>
                  </a:lnTo>
                  <a:lnTo>
                    <a:pt x="2496197" y="762762"/>
                  </a:lnTo>
                  <a:lnTo>
                    <a:pt x="2506611" y="762762"/>
                  </a:lnTo>
                  <a:lnTo>
                    <a:pt x="2506611" y="572008"/>
                  </a:lnTo>
                  <a:close/>
                </a:path>
                <a:path w="4074160" h="763270">
                  <a:moveTo>
                    <a:pt x="2564650" y="413131"/>
                  </a:moveTo>
                  <a:lnTo>
                    <a:pt x="2554236" y="413131"/>
                  </a:lnTo>
                  <a:lnTo>
                    <a:pt x="2554236" y="762762"/>
                  </a:lnTo>
                  <a:lnTo>
                    <a:pt x="2564650" y="762762"/>
                  </a:lnTo>
                  <a:lnTo>
                    <a:pt x="2564650" y="413131"/>
                  </a:lnTo>
                  <a:close/>
                </a:path>
                <a:path w="4074160" h="763270">
                  <a:moveTo>
                    <a:pt x="2622804" y="381381"/>
                  </a:moveTo>
                  <a:lnTo>
                    <a:pt x="2612402" y="381381"/>
                  </a:lnTo>
                  <a:lnTo>
                    <a:pt x="2612402" y="762762"/>
                  </a:lnTo>
                  <a:lnTo>
                    <a:pt x="2622804" y="762762"/>
                  </a:lnTo>
                  <a:lnTo>
                    <a:pt x="2622804" y="381381"/>
                  </a:lnTo>
                  <a:close/>
                </a:path>
                <a:path w="4074160" h="763270">
                  <a:moveTo>
                    <a:pt x="2680855" y="476758"/>
                  </a:moveTo>
                  <a:lnTo>
                    <a:pt x="2670441" y="476758"/>
                  </a:lnTo>
                  <a:lnTo>
                    <a:pt x="2670441" y="762762"/>
                  </a:lnTo>
                  <a:lnTo>
                    <a:pt x="2680855" y="762762"/>
                  </a:lnTo>
                  <a:lnTo>
                    <a:pt x="2680855" y="476758"/>
                  </a:lnTo>
                  <a:close/>
                </a:path>
                <a:path w="4074160" h="763270">
                  <a:moveTo>
                    <a:pt x="2738894" y="254254"/>
                  </a:moveTo>
                  <a:lnTo>
                    <a:pt x="2728480" y="254254"/>
                  </a:lnTo>
                  <a:lnTo>
                    <a:pt x="2728480" y="762762"/>
                  </a:lnTo>
                  <a:lnTo>
                    <a:pt x="2738894" y="762762"/>
                  </a:lnTo>
                  <a:lnTo>
                    <a:pt x="2738894" y="254254"/>
                  </a:lnTo>
                  <a:close/>
                </a:path>
                <a:path w="4074160" h="763270">
                  <a:moveTo>
                    <a:pt x="2796933" y="508508"/>
                  </a:moveTo>
                  <a:lnTo>
                    <a:pt x="2786519" y="508508"/>
                  </a:lnTo>
                  <a:lnTo>
                    <a:pt x="2786519" y="762762"/>
                  </a:lnTo>
                  <a:lnTo>
                    <a:pt x="2796933" y="762762"/>
                  </a:lnTo>
                  <a:lnTo>
                    <a:pt x="2796933" y="508508"/>
                  </a:lnTo>
                  <a:close/>
                </a:path>
                <a:path w="4074160" h="763270">
                  <a:moveTo>
                    <a:pt x="2854972" y="508508"/>
                  </a:moveTo>
                  <a:lnTo>
                    <a:pt x="2844558" y="508508"/>
                  </a:lnTo>
                  <a:lnTo>
                    <a:pt x="2844558" y="762762"/>
                  </a:lnTo>
                  <a:lnTo>
                    <a:pt x="2854972" y="762762"/>
                  </a:lnTo>
                  <a:lnTo>
                    <a:pt x="2854972" y="508508"/>
                  </a:lnTo>
                  <a:close/>
                </a:path>
                <a:path w="4074160" h="763270">
                  <a:moveTo>
                    <a:pt x="2913011" y="508508"/>
                  </a:moveTo>
                  <a:lnTo>
                    <a:pt x="2902597" y="508508"/>
                  </a:lnTo>
                  <a:lnTo>
                    <a:pt x="2902597" y="762762"/>
                  </a:lnTo>
                  <a:lnTo>
                    <a:pt x="2913011" y="762762"/>
                  </a:lnTo>
                  <a:lnTo>
                    <a:pt x="2913011" y="508508"/>
                  </a:lnTo>
                  <a:close/>
                </a:path>
                <a:path w="4074160" h="763270">
                  <a:moveTo>
                    <a:pt x="2971050" y="476758"/>
                  </a:moveTo>
                  <a:lnTo>
                    <a:pt x="2960636" y="476758"/>
                  </a:lnTo>
                  <a:lnTo>
                    <a:pt x="2960636" y="762762"/>
                  </a:lnTo>
                  <a:lnTo>
                    <a:pt x="2971050" y="762762"/>
                  </a:lnTo>
                  <a:lnTo>
                    <a:pt x="2971050" y="476758"/>
                  </a:lnTo>
                  <a:close/>
                </a:path>
                <a:path w="4074160" h="763270">
                  <a:moveTo>
                    <a:pt x="3029089" y="254254"/>
                  </a:moveTo>
                  <a:lnTo>
                    <a:pt x="3018675" y="254254"/>
                  </a:lnTo>
                  <a:lnTo>
                    <a:pt x="3018675" y="762762"/>
                  </a:lnTo>
                  <a:lnTo>
                    <a:pt x="3029089" y="762762"/>
                  </a:lnTo>
                  <a:lnTo>
                    <a:pt x="3029089" y="254254"/>
                  </a:lnTo>
                  <a:close/>
                </a:path>
                <a:path w="4074160" h="763270">
                  <a:moveTo>
                    <a:pt x="3087128" y="603885"/>
                  </a:moveTo>
                  <a:lnTo>
                    <a:pt x="3076714" y="603885"/>
                  </a:lnTo>
                  <a:lnTo>
                    <a:pt x="3076714" y="762762"/>
                  </a:lnTo>
                  <a:lnTo>
                    <a:pt x="3087128" y="762762"/>
                  </a:lnTo>
                  <a:lnTo>
                    <a:pt x="3087128" y="603885"/>
                  </a:lnTo>
                  <a:close/>
                </a:path>
                <a:path w="4074160" h="763270">
                  <a:moveTo>
                    <a:pt x="3145294" y="381381"/>
                  </a:moveTo>
                  <a:lnTo>
                    <a:pt x="3134880" y="381381"/>
                  </a:lnTo>
                  <a:lnTo>
                    <a:pt x="3134880" y="762762"/>
                  </a:lnTo>
                  <a:lnTo>
                    <a:pt x="3145294" y="762762"/>
                  </a:lnTo>
                  <a:lnTo>
                    <a:pt x="3145294" y="381381"/>
                  </a:lnTo>
                  <a:close/>
                </a:path>
                <a:path w="4074160" h="763270">
                  <a:moveTo>
                    <a:pt x="3203333" y="540258"/>
                  </a:moveTo>
                  <a:lnTo>
                    <a:pt x="3192919" y="540258"/>
                  </a:lnTo>
                  <a:lnTo>
                    <a:pt x="3192919" y="762762"/>
                  </a:lnTo>
                  <a:lnTo>
                    <a:pt x="3203333" y="762762"/>
                  </a:lnTo>
                  <a:lnTo>
                    <a:pt x="3203333" y="540258"/>
                  </a:lnTo>
                  <a:close/>
                </a:path>
                <a:path w="4074160" h="763270">
                  <a:moveTo>
                    <a:pt x="3261372" y="635635"/>
                  </a:moveTo>
                  <a:lnTo>
                    <a:pt x="3250958" y="635635"/>
                  </a:lnTo>
                  <a:lnTo>
                    <a:pt x="3250958" y="762762"/>
                  </a:lnTo>
                  <a:lnTo>
                    <a:pt x="3261372" y="762762"/>
                  </a:lnTo>
                  <a:lnTo>
                    <a:pt x="3261372" y="635635"/>
                  </a:lnTo>
                  <a:close/>
                </a:path>
                <a:path w="4074160" h="763270">
                  <a:moveTo>
                    <a:pt x="3319411" y="476758"/>
                  </a:moveTo>
                  <a:lnTo>
                    <a:pt x="3308997" y="476758"/>
                  </a:lnTo>
                  <a:lnTo>
                    <a:pt x="3308997" y="762762"/>
                  </a:lnTo>
                  <a:lnTo>
                    <a:pt x="3319411" y="762762"/>
                  </a:lnTo>
                  <a:lnTo>
                    <a:pt x="3319411" y="476758"/>
                  </a:lnTo>
                  <a:close/>
                </a:path>
                <a:path w="4074160" h="763270">
                  <a:moveTo>
                    <a:pt x="3377450" y="349631"/>
                  </a:moveTo>
                  <a:lnTo>
                    <a:pt x="3367036" y="349631"/>
                  </a:lnTo>
                  <a:lnTo>
                    <a:pt x="3367036" y="762762"/>
                  </a:lnTo>
                  <a:lnTo>
                    <a:pt x="3377450" y="762762"/>
                  </a:lnTo>
                  <a:lnTo>
                    <a:pt x="3377450" y="349631"/>
                  </a:lnTo>
                  <a:close/>
                </a:path>
                <a:path w="4074160" h="763270">
                  <a:moveTo>
                    <a:pt x="3435489" y="286004"/>
                  </a:moveTo>
                  <a:lnTo>
                    <a:pt x="3425075" y="286004"/>
                  </a:lnTo>
                  <a:lnTo>
                    <a:pt x="3425075" y="762762"/>
                  </a:lnTo>
                  <a:lnTo>
                    <a:pt x="3435489" y="762762"/>
                  </a:lnTo>
                  <a:lnTo>
                    <a:pt x="3435489" y="286004"/>
                  </a:lnTo>
                  <a:close/>
                </a:path>
                <a:path w="4074160" h="763270">
                  <a:moveTo>
                    <a:pt x="3493528" y="572008"/>
                  </a:moveTo>
                  <a:lnTo>
                    <a:pt x="3483114" y="572008"/>
                  </a:lnTo>
                  <a:lnTo>
                    <a:pt x="3483114" y="762762"/>
                  </a:lnTo>
                  <a:lnTo>
                    <a:pt x="3493528" y="762762"/>
                  </a:lnTo>
                  <a:lnTo>
                    <a:pt x="3493528" y="572008"/>
                  </a:lnTo>
                  <a:close/>
                </a:path>
                <a:path w="4074160" h="763270">
                  <a:moveTo>
                    <a:pt x="3551555" y="190627"/>
                  </a:moveTo>
                  <a:lnTo>
                    <a:pt x="3541153" y="190627"/>
                  </a:lnTo>
                  <a:lnTo>
                    <a:pt x="3541153" y="762762"/>
                  </a:lnTo>
                  <a:lnTo>
                    <a:pt x="3551555" y="762762"/>
                  </a:lnTo>
                  <a:lnTo>
                    <a:pt x="3551555" y="190627"/>
                  </a:lnTo>
                  <a:close/>
                </a:path>
                <a:path w="4074160" h="763270">
                  <a:moveTo>
                    <a:pt x="3609606" y="444881"/>
                  </a:moveTo>
                  <a:lnTo>
                    <a:pt x="3599192" y="444881"/>
                  </a:lnTo>
                  <a:lnTo>
                    <a:pt x="3599192" y="762762"/>
                  </a:lnTo>
                  <a:lnTo>
                    <a:pt x="3609606" y="762762"/>
                  </a:lnTo>
                  <a:lnTo>
                    <a:pt x="3609606" y="444881"/>
                  </a:lnTo>
                  <a:close/>
                </a:path>
                <a:path w="4074160" h="763270">
                  <a:moveTo>
                    <a:pt x="3667772" y="476758"/>
                  </a:moveTo>
                  <a:lnTo>
                    <a:pt x="3657358" y="476758"/>
                  </a:lnTo>
                  <a:lnTo>
                    <a:pt x="3657358" y="762762"/>
                  </a:lnTo>
                  <a:lnTo>
                    <a:pt x="3667772" y="762762"/>
                  </a:lnTo>
                  <a:lnTo>
                    <a:pt x="3667772" y="476758"/>
                  </a:lnTo>
                  <a:close/>
                </a:path>
                <a:path w="4074160" h="763270">
                  <a:moveTo>
                    <a:pt x="3725811" y="158877"/>
                  </a:moveTo>
                  <a:lnTo>
                    <a:pt x="3715397" y="158877"/>
                  </a:lnTo>
                  <a:lnTo>
                    <a:pt x="3715397" y="762762"/>
                  </a:lnTo>
                  <a:lnTo>
                    <a:pt x="3725811" y="762762"/>
                  </a:lnTo>
                  <a:lnTo>
                    <a:pt x="3725811" y="158877"/>
                  </a:lnTo>
                  <a:close/>
                </a:path>
                <a:path w="4074160" h="763270">
                  <a:moveTo>
                    <a:pt x="3783850" y="413131"/>
                  </a:moveTo>
                  <a:lnTo>
                    <a:pt x="3773436" y="413131"/>
                  </a:lnTo>
                  <a:lnTo>
                    <a:pt x="3773436" y="762762"/>
                  </a:lnTo>
                  <a:lnTo>
                    <a:pt x="3783850" y="762762"/>
                  </a:lnTo>
                  <a:lnTo>
                    <a:pt x="3783850" y="413131"/>
                  </a:lnTo>
                  <a:close/>
                </a:path>
                <a:path w="4074160" h="763270">
                  <a:moveTo>
                    <a:pt x="3841889" y="286004"/>
                  </a:moveTo>
                  <a:lnTo>
                    <a:pt x="3831475" y="286004"/>
                  </a:lnTo>
                  <a:lnTo>
                    <a:pt x="3831475" y="762762"/>
                  </a:lnTo>
                  <a:lnTo>
                    <a:pt x="3841889" y="762762"/>
                  </a:lnTo>
                  <a:lnTo>
                    <a:pt x="3841889" y="286004"/>
                  </a:lnTo>
                  <a:close/>
                </a:path>
                <a:path w="4074160" h="763270">
                  <a:moveTo>
                    <a:pt x="3899928" y="0"/>
                  </a:moveTo>
                  <a:lnTo>
                    <a:pt x="3889514" y="0"/>
                  </a:lnTo>
                  <a:lnTo>
                    <a:pt x="3889514" y="762762"/>
                  </a:lnTo>
                  <a:lnTo>
                    <a:pt x="3899928" y="762762"/>
                  </a:lnTo>
                  <a:lnTo>
                    <a:pt x="3899928" y="0"/>
                  </a:lnTo>
                  <a:close/>
                </a:path>
                <a:path w="4074160" h="763270">
                  <a:moveTo>
                    <a:pt x="3957955" y="508508"/>
                  </a:moveTo>
                  <a:lnTo>
                    <a:pt x="3947553" y="508508"/>
                  </a:lnTo>
                  <a:lnTo>
                    <a:pt x="3947553" y="762762"/>
                  </a:lnTo>
                  <a:lnTo>
                    <a:pt x="3957955" y="762762"/>
                  </a:lnTo>
                  <a:lnTo>
                    <a:pt x="3957955" y="508508"/>
                  </a:lnTo>
                  <a:close/>
                </a:path>
                <a:path w="4074160" h="763270">
                  <a:moveTo>
                    <a:pt x="4016006" y="444881"/>
                  </a:moveTo>
                  <a:lnTo>
                    <a:pt x="4005592" y="444881"/>
                  </a:lnTo>
                  <a:lnTo>
                    <a:pt x="4005592" y="762762"/>
                  </a:lnTo>
                  <a:lnTo>
                    <a:pt x="4016006" y="762762"/>
                  </a:lnTo>
                  <a:lnTo>
                    <a:pt x="4016006" y="444881"/>
                  </a:lnTo>
                  <a:close/>
                </a:path>
                <a:path w="4074160" h="763270">
                  <a:moveTo>
                    <a:pt x="4074045" y="381381"/>
                  </a:moveTo>
                  <a:lnTo>
                    <a:pt x="4063631" y="381381"/>
                  </a:lnTo>
                  <a:lnTo>
                    <a:pt x="4063631" y="762762"/>
                  </a:lnTo>
                  <a:lnTo>
                    <a:pt x="4074045" y="762762"/>
                  </a:lnTo>
                  <a:lnTo>
                    <a:pt x="4074045" y="381381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8" name="object 108" descr=""/>
            <p:cNvSpPr/>
            <p:nvPr/>
          </p:nvSpPr>
          <p:spPr>
            <a:xfrm>
              <a:off x="5710809" y="8026781"/>
              <a:ext cx="4074160" cy="635635"/>
            </a:xfrm>
            <a:custGeom>
              <a:avLst/>
              <a:gdLst/>
              <a:ahLst/>
              <a:cxnLst/>
              <a:rect l="l" t="t" r="r" b="b"/>
              <a:pathLst>
                <a:path w="4074159" h="635634">
                  <a:moveTo>
                    <a:pt x="10414" y="254254"/>
                  </a:moveTo>
                  <a:lnTo>
                    <a:pt x="0" y="254254"/>
                  </a:lnTo>
                  <a:lnTo>
                    <a:pt x="0" y="635635"/>
                  </a:lnTo>
                  <a:lnTo>
                    <a:pt x="10414" y="635635"/>
                  </a:lnTo>
                  <a:lnTo>
                    <a:pt x="10414" y="254254"/>
                  </a:lnTo>
                  <a:close/>
                </a:path>
                <a:path w="4074159" h="635634">
                  <a:moveTo>
                    <a:pt x="68453" y="317754"/>
                  </a:moveTo>
                  <a:lnTo>
                    <a:pt x="58039" y="317754"/>
                  </a:lnTo>
                  <a:lnTo>
                    <a:pt x="58039" y="635635"/>
                  </a:lnTo>
                  <a:lnTo>
                    <a:pt x="68453" y="635635"/>
                  </a:lnTo>
                  <a:lnTo>
                    <a:pt x="68453" y="317754"/>
                  </a:lnTo>
                  <a:close/>
                </a:path>
                <a:path w="4074159" h="635634">
                  <a:moveTo>
                    <a:pt x="126492" y="349631"/>
                  </a:moveTo>
                  <a:lnTo>
                    <a:pt x="116078" y="349631"/>
                  </a:lnTo>
                  <a:lnTo>
                    <a:pt x="116078" y="635635"/>
                  </a:lnTo>
                  <a:lnTo>
                    <a:pt x="126492" y="635635"/>
                  </a:lnTo>
                  <a:lnTo>
                    <a:pt x="126492" y="349631"/>
                  </a:lnTo>
                  <a:close/>
                </a:path>
                <a:path w="4074159" h="635634">
                  <a:moveTo>
                    <a:pt x="184658" y="254254"/>
                  </a:moveTo>
                  <a:lnTo>
                    <a:pt x="174244" y="254254"/>
                  </a:lnTo>
                  <a:lnTo>
                    <a:pt x="174244" y="635635"/>
                  </a:lnTo>
                  <a:lnTo>
                    <a:pt x="184658" y="635635"/>
                  </a:lnTo>
                  <a:lnTo>
                    <a:pt x="184658" y="254254"/>
                  </a:lnTo>
                  <a:close/>
                </a:path>
                <a:path w="4074159" h="635634">
                  <a:moveTo>
                    <a:pt x="242697" y="508508"/>
                  </a:moveTo>
                  <a:lnTo>
                    <a:pt x="232283" y="508508"/>
                  </a:lnTo>
                  <a:lnTo>
                    <a:pt x="232283" y="635635"/>
                  </a:lnTo>
                  <a:lnTo>
                    <a:pt x="242697" y="635635"/>
                  </a:lnTo>
                  <a:lnTo>
                    <a:pt x="242697" y="508508"/>
                  </a:lnTo>
                  <a:close/>
                </a:path>
                <a:path w="4074159" h="635634">
                  <a:moveTo>
                    <a:pt x="300723" y="127127"/>
                  </a:moveTo>
                  <a:lnTo>
                    <a:pt x="290322" y="127127"/>
                  </a:lnTo>
                  <a:lnTo>
                    <a:pt x="290322" y="635635"/>
                  </a:lnTo>
                  <a:lnTo>
                    <a:pt x="300723" y="635635"/>
                  </a:lnTo>
                  <a:lnTo>
                    <a:pt x="300723" y="127127"/>
                  </a:lnTo>
                  <a:close/>
                </a:path>
                <a:path w="4074159" h="635634">
                  <a:moveTo>
                    <a:pt x="358775" y="540258"/>
                  </a:moveTo>
                  <a:lnTo>
                    <a:pt x="348361" y="540258"/>
                  </a:lnTo>
                  <a:lnTo>
                    <a:pt x="348361" y="635635"/>
                  </a:lnTo>
                  <a:lnTo>
                    <a:pt x="358775" y="635635"/>
                  </a:lnTo>
                  <a:lnTo>
                    <a:pt x="358775" y="540258"/>
                  </a:lnTo>
                  <a:close/>
                </a:path>
                <a:path w="4074159" h="635634">
                  <a:moveTo>
                    <a:pt x="416814" y="317754"/>
                  </a:moveTo>
                  <a:lnTo>
                    <a:pt x="406400" y="317754"/>
                  </a:lnTo>
                  <a:lnTo>
                    <a:pt x="406400" y="635635"/>
                  </a:lnTo>
                  <a:lnTo>
                    <a:pt x="416814" y="635635"/>
                  </a:lnTo>
                  <a:lnTo>
                    <a:pt x="416814" y="317754"/>
                  </a:lnTo>
                  <a:close/>
                </a:path>
                <a:path w="4074159" h="635634">
                  <a:moveTo>
                    <a:pt x="474853" y="349631"/>
                  </a:moveTo>
                  <a:lnTo>
                    <a:pt x="464439" y="349631"/>
                  </a:lnTo>
                  <a:lnTo>
                    <a:pt x="464439" y="635635"/>
                  </a:lnTo>
                  <a:lnTo>
                    <a:pt x="474853" y="635635"/>
                  </a:lnTo>
                  <a:lnTo>
                    <a:pt x="474853" y="349631"/>
                  </a:lnTo>
                  <a:close/>
                </a:path>
                <a:path w="4074159" h="635634">
                  <a:moveTo>
                    <a:pt x="532892" y="381381"/>
                  </a:moveTo>
                  <a:lnTo>
                    <a:pt x="522478" y="381381"/>
                  </a:lnTo>
                  <a:lnTo>
                    <a:pt x="522478" y="635635"/>
                  </a:lnTo>
                  <a:lnTo>
                    <a:pt x="532892" y="635635"/>
                  </a:lnTo>
                  <a:lnTo>
                    <a:pt x="532892" y="381381"/>
                  </a:lnTo>
                  <a:close/>
                </a:path>
                <a:path w="4074159" h="635634">
                  <a:moveTo>
                    <a:pt x="590931" y="381381"/>
                  </a:moveTo>
                  <a:lnTo>
                    <a:pt x="580517" y="381381"/>
                  </a:lnTo>
                  <a:lnTo>
                    <a:pt x="580517" y="635635"/>
                  </a:lnTo>
                  <a:lnTo>
                    <a:pt x="590931" y="635635"/>
                  </a:lnTo>
                  <a:lnTo>
                    <a:pt x="590931" y="381381"/>
                  </a:lnTo>
                  <a:close/>
                </a:path>
                <a:path w="4074159" h="635634">
                  <a:moveTo>
                    <a:pt x="648970" y="508508"/>
                  </a:moveTo>
                  <a:lnTo>
                    <a:pt x="638556" y="508508"/>
                  </a:lnTo>
                  <a:lnTo>
                    <a:pt x="638556" y="635635"/>
                  </a:lnTo>
                  <a:lnTo>
                    <a:pt x="648970" y="635635"/>
                  </a:lnTo>
                  <a:lnTo>
                    <a:pt x="648970" y="508508"/>
                  </a:lnTo>
                  <a:close/>
                </a:path>
                <a:path w="4074159" h="635634">
                  <a:moveTo>
                    <a:pt x="707123" y="381381"/>
                  </a:moveTo>
                  <a:lnTo>
                    <a:pt x="696722" y="381381"/>
                  </a:lnTo>
                  <a:lnTo>
                    <a:pt x="696722" y="635635"/>
                  </a:lnTo>
                  <a:lnTo>
                    <a:pt x="707123" y="635635"/>
                  </a:lnTo>
                  <a:lnTo>
                    <a:pt x="707123" y="381381"/>
                  </a:lnTo>
                  <a:close/>
                </a:path>
                <a:path w="4074159" h="635634">
                  <a:moveTo>
                    <a:pt x="765175" y="508508"/>
                  </a:moveTo>
                  <a:lnTo>
                    <a:pt x="754761" y="508508"/>
                  </a:lnTo>
                  <a:lnTo>
                    <a:pt x="754761" y="635635"/>
                  </a:lnTo>
                  <a:lnTo>
                    <a:pt x="765175" y="635635"/>
                  </a:lnTo>
                  <a:lnTo>
                    <a:pt x="765175" y="508508"/>
                  </a:lnTo>
                  <a:close/>
                </a:path>
                <a:path w="4074159" h="635634">
                  <a:moveTo>
                    <a:pt x="823214" y="190627"/>
                  </a:moveTo>
                  <a:lnTo>
                    <a:pt x="812787" y="190627"/>
                  </a:lnTo>
                  <a:lnTo>
                    <a:pt x="812787" y="635635"/>
                  </a:lnTo>
                  <a:lnTo>
                    <a:pt x="823214" y="635635"/>
                  </a:lnTo>
                  <a:lnTo>
                    <a:pt x="823214" y="190627"/>
                  </a:lnTo>
                  <a:close/>
                </a:path>
                <a:path w="4074159" h="635634">
                  <a:moveTo>
                    <a:pt x="881253" y="190627"/>
                  </a:moveTo>
                  <a:lnTo>
                    <a:pt x="870839" y="190627"/>
                  </a:lnTo>
                  <a:lnTo>
                    <a:pt x="870839" y="635635"/>
                  </a:lnTo>
                  <a:lnTo>
                    <a:pt x="881253" y="635635"/>
                  </a:lnTo>
                  <a:lnTo>
                    <a:pt x="881253" y="190627"/>
                  </a:lnTo>
                  <a:close/>
                </a:path>
                <a:path w="4074159" h="635634">
                  <a:moveTo>
                    <a:pt x="939292" y="286004"/>
                  </a:moveTo>
                  <a:lnTo>
                    <a:pt x="928865" y="286004"/>
                  </a:lnTo>
                  <a:lnTo>
                    <a:pt x="928865" y="635635"/>
                  </a:lnTo>
                  <a:lnTo>
                    <a:pt x="939292" y="635635"/>
                  </a:lnTo>
                  <a:lnTo>
                    <a:pt x="939292" y="286004"/>
                  </a:lnTo>
                  <a:close/>
                </a:path>
                <a:path w="4074159" h="635634">
                  <a:moveTo>
                    <a:pt x="997331" y="444881"/>
                  </a:moveTo>
                  <a:lnTo>
                    <a:pt x="986917" y="444881"/>
                  </a:lnTo>
                  <a:lnTo>
                    <a:pt x="986917" y="635635"/>
                  </a:lnTo>
                  <a:lnTo>
                    <a:pt x="997331" y="635635"/>
                  </a:lnTo>
                  <a:lnTo>
                    <a:pt x="997331" y="444881"/>
                  </a:lnTo>
                  <a:close/>
                </a:path>
                <a:path w="4074159" h="635634">
                  <a:moveTo>
                    <a:pt x="1055370" y="158877"/>
                  </a:moveTo>
                  <a:lnTo>
                    <a:pt x="1044956" y="158877"/>
                  </a:lnTo>
                  <a:lnTo>
                    <a:pt x="1044956" y="635635"/>
                  </a:lnTo>
                  <a:lnTo>
                    <a:pt x="1055370" y="635635"/>
                  </a:lnTo>
                  <a:lnTo>
                    <a:pt x="1055370" y="158877"/>
                  </a:lnTo>
                  <a:close/>
                </a:path>
                <a:path w="4074159" h="635634">
                  <a:moveTo>
                    <a:pt x="1113409" y="349631"/>
                  </a:moveTo>
                  <a:lnTo>
                    <a:pt x="1102995" y="349631"/>
                  </a:lnTo>
                  <a:lnTo>
                    <a:pt x="1102995" y="635635"/>
                  </a:lnTo>
                  <a:lnTo>
                    <a:pt x="1113409" y="635635"/>
                  </a:lnTo>
                  <a:lnTo>
                    <a:pt x="1113409" y="349631"/>
                  </a:lnTo>
                  <a:close/>
                </a:path>
                <a:path w="4074159" h="635634">
                  <a:moveTo>
                    <a:pt x="1171448" y="158877"/>
                  </a:moveTo>
                  <a:lnTo>
                    <a:pt x="1161034" y="158877"/>
                  </a:lnTo>
                  <a:lnTo>
                    <a:pt x="1161034" y="635635"/>
                  </a:lnTo>
                  <a:lnTo>
                    <a:pt x="1171448" y="635635"/>
                  </a:lnTo>
                  <a:lnTo>
                    <a:pt x="1171448" y="158877"/>
                  </a:lnTo>
                  <a:close/>
                </a:path>
                <a:path w="4074159" h="635634">
                  <a:moveTo>
                    <a:pt x="1229487" y="381381"/>
                  </a:moveTo>
                  <a:lnTo>
                    <a:pt x="1219073" y="381381"/>
                  </a:lnTo>
                  <a:lnTo>
                    <a:pt x="1219073" y="635635"/>
                  </a:lnTo>
                  <a:lnTo>
                    <a:pt x="1229487" y="635635"/>
                  </a:lnTo>
                  <a:lnTo>
                    <a:pt x="1229487" y="381381"/>
                  </a:lnTo>
                  <a:close/>
                </a:path>
                <a:path w="4074159" h="635634">
                  <a:moveTo>
                    <a:pt x="1287653" y="286004"/>
                  </a:moveTo>
                  <a:lnTo>
                    <a:pt x="1277239" y="286004"/>
                  </a:lnTo>
                  <a:lnTo>
                    <a:pt x="1277239" y="635635"/>
                  </a:lnTo>
                  <a:lnTo>
                    <a:pt x="1287653" y="635635"/>
                  </a:lnTo>
                  <a:lnTo>
                    <a:pt x="1287653" y="286004"/>
                  </a:lnTo>
                  <a:close/>
                </a:path>
                <a:path w="4074159" h="635634">
                  <a:moveTo>
                    <a:pt x="1345692" y="317754"/>
                  </a:moveTo>
                  <a:lnTo>
                    <a:pt x="1335278" y="317754"/>
                  </a:lnTo>
                  <a:lnTo>
                    <a:pt x="1335278" y="635635"/>
                  </a:lnTo>
                  <a:lnTo>
                    <a:pt x="1345692" y="635635"/>
                  </a:lnTo>
                  <a:lnTo>
                    <a:pt x="1345692" y="317754"/>
                  </a:lnTo>
                  <a:close/>
                </a:path>
                <a:path w="4074159" h="635634">
                  <a:moveTo>
                    <a:pt x="1403731" y="286004"/>
                  </a:moveTo>
                  <a:lnTo>
                    <a:pt x="1393317" y="286004"/>
                  </a:lnTo>
                  <a:lnTo>
                    <a:pt x="1393317" y="635635"/>
                  </a:lnTo>
                  <a:lnTo>
                    <a:pt x="1403731" y="635635"/>
                  </a:lnTo>
                  <a:lnTo>
                    <a:pt x="1403731" y="286004"/>
                  </a:lnTo>
                  <a:close/>
                </a:path>
                <a:path w="4074159" h="635634">
                  <a:moveTo>
                    <a:pt x="1461770" y="381381"/>
                  </a:moveTo>
                  <a:lnTo>
                    <a:pt x="1451356" y="381381"/>
                  </a:lnTo>
                  <a:lnTo>
                    <a:pt x="1451356" y="635635"/>
                  </a:lnTo>
                  <a:lnTo>
                    <a:pt x="1461770" y="635635"/>
                  </a:lnTo>
                  <a:lnTo>
                    <a:pt x="1461770" y="381381"/>
                  </a:lnTo>
                  <a:close/>
                </a:path>
                <a:path w="4074159" h="635634">
                  <a:moveTo>
                    <a:pt x="1519809" y="190627"/>
                  </a:moveTo>
                  <a:lnTo>
                    <a:pt x="1509395" y="190627"/>
                  </a:lnTo>
                  <a:lnTo>
                    <a:pt x="1509395" y="635635"/>
                  </a:lnTo>
                  <a:lnTo>
                    <a:pt x="1519809" y="635635"/>
                  </a:lnTo>
                  <a:lnTo>
                    <a:pt x="1519809" y="190627"/>
                  </a:lnTo>
                  <a:close/>
                </a:path>
                <a:path w="4074159" h="635634">
                  <a:moveTo>
                    <a:pt x="1577848" y="317754"/>
                  </a:moveTo>
                  <a:lnTo>
                    <a:pt x="1567434" y="317754"/>
                  </a:lnTo>
                  <a:lnTo>
                    <a:pt x="1567434" y="635635"/>
                  </a:lnTo>
                  <a:lnTo>
                    <a:pt x="1577848" y="635635"/>
                  </a:lnTo>
                  <a:lnTo>
                    <a:pt x="1577848" y="317754"/>
                  </a:lnTo>
                  <a:close/>
                </a:path>
                <a:path w="4074159" h="635634">
                  <a:moveTo>
                    <a:pt x="1635887" y="413131"/>
                  </a:moveTo>
                  <a:lnTo>
                    <a:pt x="1625473" y="413131"/>
                  </a:lnTo>
                  <a:lnTo>
                    <a:pt x="1625473" y="635635"/>
                  </a:lnTo>
                  <a:lnTo>
                    <a:pt x="1635887" y="635635"/>
                  </a:lnTo>
                  <a:lnTo>
                    <a:pt x="1635887" y="413131"/>
                  </a:lnTo>
                  <a:close/>
                </a:path>
                <a:path w="4074159" h="635634">
                  <a:moveTo>
                    <a:pt x="1693926" y="254254"/>
                  </a:moveTo>
                  <a:lnTo>
                    <a:pt x="1683512" y="254254"/>
                  </a:lnTo>
                  <a:lnTo>
                    <a:pt x="1683512" y="635635"/>
                  </a:lnTo>
                  <a:lnTo>
                    <a:pt x="1693926" y="635635"/>
                  </a:lnTo>
                  <a:lnTo>
                    <a:pt x="1693926" y="254254"/>
                  </a:lnTo>
                  <a:close/>
                </a:path>
                <a:path w="4074159" h="635634">
                  <a:moveTo>
                    <a:pt x="1751965" y="413131"/>
                  </a:moveTo>
                  <a:lnTo>
                    <a:pt x="1741551" y="413131"/>
                  </a:lnTo>
                  <a:lnTo>
                    <a:pt x="1741551" y="635635"/>
                  </a:lnTo>
                  <a:lnTo>
                    <a:pt x="1751965" y="635635"/>
                  </a:lnTo>
                  <a:lnTo>
                    <a:pt x="1751965" y="413131"/>
                  </a:lnTo>
                  <a:close/>
                </a:path>
                <a:path w="4074159" h="635634">
                  <a:moveTo>
                    <a:pt x="1810131" y="286004"/>
                  </a:moveTo>
                  <a:lnTo>
                    <a:pt x="1799717" y="286004"/>
                  </a:lnTo>
                  <a:lnTo>
                    <a:pt x="1799717" y="635635"/>
                  </a:lnTo>
                  <a:lnTo>
                    <a:pt x="1810131" y="635635"/>
                  </a:lnTo>
                  <a:lnTo>
                    <a:pt x="1810131" y="286004"/>
                  </a:lnTo>
                  <a:close/>
                </a:path>
                <a:path w="4074159" h="635634">
                  <a:moveTo>
                    <a:pt x="1868170" y="444881"/>
                  </a:moveTo>
                  <a:lnTo>
                    <a:pt x="1857756" y="444881"/>
                  </a:lnTo>
                  <a:lnTo>
                    <a:pt x="1857756" y="635635"/>
                  </a:lnTo>
                  <a:lnTo>
                    <a:pt x="1868170" y="635635"/>
                  </a:lnTo>
                  <a:lnTo>
                    <a:pt x="1868170" y="444881"/>
                  </a:lnTo>
                  <a:close/>
                </a:path>
                <a:path w="4074159" h="635634">
                  <a:moveTo>
                    <a:pt x="1926209" y="572008"/>
                  </a:moveTo>
                  <a:lnTo>
                    <a:pt x="1915795" y="572008"/>
                  </a:lnTo>
                  <a:lnTo>
                    <a:pt x="1915795" y="635635"/>
                  </a:lnTo>
                  <a:lnTo>
                    <a:pt x="1926209" y="635635"/>
                  </a:lnTo>
                  <a:lnTo>
                    <a:pt x="1926209" y="572008"/>
                  </a:lnTo>
                  <a:close/>
                </a:path>
                <a:path w="4074159" h="635634">
                  <a:moveTo>
                    <a:pt x="1984248" y="540258"/>
                  </a:moveTo>
                  <a:lnTo>
                    <a:pt x="1973834" y="540258"/>
                  </a:lnTo>
                  <a:lnTo>
                    <a:pt x="1973834" y="635635"/>
                  </a:lnTo>
                  <a:lnTo>
                    <a:pt x="1984248" y="635635"/>
                  </a:lnTo>
                  <a:lnTo>
                    <a:pt x="1984248" y="540258"/>
                  </a:lnTo>
                  <a:close/>
                </a:path>
                <a:path w="4074159" h="635634">
                  <a:moveTo>
                    <a:pt x="2042287" y="381381"/>
                  </a:moveTo>
                  <a:lnTo>
                    <a:pt x="2031873" y="381381"/>
                  </a:lnTo>
                  <a:lnTo>
                    <a:pt x="2031873" y="635635"/>
                  </a:lnTo>
                  <a:lnTo>
                    <a:pt x="2042287" y="635635"/>
                  </a:lnTo>
                  <a:lnTo>
                    <a:pt x="2042287" y="381381"/>
                  </a:lnTo>
                  <a:close/>
                </a:path>
                <a:path w="4074159" h="635634">
                  <a:moveTo>
                    <a:pt x="2100326" y="317754"/>
                  </a:moveTo>
                  <a:lnTo>
                    <a:pt x="2089912" y="317754"/>
                  </a:lnTo>
                  <a:lnTo>
                    <a:pt x="2089912" y="635635"/>
                  </a:lnTo>
                  <a:lnTo>
                    <a:pt x="2100326" y="635635"/>
                  </a:lnTo>
                  <a:lnTo>
                    <a:pt x="2100326" y="317754"/>
                  </a:lnTo>
                  <a:close/>
                </a:path>
                <a:path w="4074159" h="635634">
                  <a:moveTo>
                    <a:pt x="2158365" y="444881"/>
                  </a:moveTo>
                  <a:lnTo>
                    <a:pt x="2147951" y="444881"/>
                  </a:lnTo>
                  <a:lnTo>
                    <a:pt x="2147951" y="635635"/>
                  </a:lnTo>
                  <a:lnTo>
                    <a:pt x="2158365" y="635635"/>
                  </a:lnTo>
                  <a:lnTo>
                    <a:pt x="2158365" y="444881"/>
                  </a:lnTo>
                  <a:close/>
                </a:path>
                <a:path w="4074159" h="635634">
                  <a:moveTo>
                    <a:pt x="2216404" y="317754"/>
                  </a:moveTo>
                  <a:lnTo>
                    <a:pt x="2205990" y="317754"/>
                  </a:lnTo>
                  <a:lnTo>
                    <a:pt x="2205990" y="635635"/>
                  </a:lnTo>
                  <a:lnTo>
                    <a:pt x="2216404" y="635635"/>
                  </a:lnTo>
                  <a:lnTo>
                    <a:pt x="2216404" y="317754"/>
                  </a:lnTo>
                  <a:close/>
                </a:path>
                <a:path w="4074159" h="635634">
                  <a:moveTo>
                    <a:pt x="2274443" y="254254"/>
                  </a:moveTo>
                  <a:lnTo>
                    <a:pt x="2264029" y="254254"/>
                  </a:lnTo>
                  <a:lnTo>
                    <a:pt x="2264029" y="635635"/>
                  </a:lnTo>
                  <a:lnTo>
                    <a:pt x="2274443" y="635635"/>
                  </a:lnTo>
                  <a:lnTo>
                    <a:pt x="2274443" y="254254"/>
                  </a:lnTo>
                  <a:close/>
                </a:path>
                <a:path w="4074159" h="635634">
                  <a:moveTo>
                    <a:pt x="2335276" y="381381"/>
                  </a:moveTo>
                  <a:lnTo>
                    <a:pt x="2322195" y="381381"/>
                  </a:lnTo>
                  <a:lnTo>
                    <a:pt x="2322195" y="635635"/>
                  </a:lnTo>
                  <a:lnTo>
                    <a:pt x="2335276" y="635635"/>
                  </a:lnTo>
                  <a:lnTo>
                    <a:pt x="2335276" y="381381"/>
                  </a:lnTo>
                  <a:close/>
                </a:path>
                <a:path w="4074159" h="635634">
                  <a:moveTo>
                    <a:pt x="2390648" y="254254"/>
                  </a:moveTo>
                  <a:lnTo>
                    <a:pt x="2380234" y="254254"/>
                  </a:lnTo>
                  <a:lnTo>
                    <a:pt x="2380234" y="635635"/>
                  </a:lnTo>
                  <a:lnTo>
                    <a:pt x="2390648" y="635635"/>
                  </a:lnTo>
                  <a:lnTo>
                    <a:pt x="2390648" y="254254"/>
                  </a:lnTo>
                  <a:close/>
                </a:path>
                <a:path w="4074159" h="635634">
                  <a:moveTo>
                    <a:pt x="2448687" y="286004"/>
                  </a:moveTo>
                  <a:lnTo>
                    <a:pt x="2438273" y="286004"/>
                  </a:lnTo>
                  <a:lnTo>
                    <a:pt x="2438273" y="635635"/>
                  </a:lnTo>
                  <a:lnTo>
                    <a:pt x="2448687" y="635635"/>
                  </a:lnTo>
                  <a:lnTo>
                    <a:pt x="2448687" y="286004"/>
                  </a:lnTo>
                  <a:close/>
                </a:path>
                <a:path w="4074159" h="635634">
                  <a:moveTo>
                    <a:pt x="2506726" y="381381"/>
                  </a:moveTo>
                  <a:lnTo>
                    <a:pt x="2496312" y="381381"/>
                  </a:lnTo>
                  <a:lnTo>
                    <a:pt x="2496312" y="635635"/>
                  </a:lnTo>
                  <a:lnTo>
                    <a:pt x="2506726" y="635635"/>
                  </a:lnTo>
                  <a:lnTo>
                    <a:pt x="2506726" y="381381"/>
                  </a:lnTo>
                  <a:close/>
                </a:path>
                <a:path w="4074159" h="635634">
                  <a:moveTo>
                    <a:pt x="2564765" y="222504"/>
                  </a:moveTo>
                  <a:lnTo>
                    <a:pt x="2554351" y="222504"/>
                  </a:lnTo>
                  <a:lnTo>
                    <a:pt x="2554351" y="635635"/>
                  </a:lnTo>
                  <a:lnTo>
                    <a:pt x="2564765" y="635635"/>
                  </a:lnTo>
                  <a:lnTo>
                    <a:pt x="2564765" y="222504"/>
                  </a:lnTo>
                  <a:close/>
                </a:path>
                <a:path w="4074159" h="635634">
                  <a:moveTo>
                    <a:pt x="2622804" y="381381"/>
                  </a:moveTo>
                  <a:lnTo>
                    <a:pt x="2612390" y="381381"/>
                  </a:lnTo>
                  <a:lnTo>
                    <a:pt x="2612390" y="635635"/>
                  </a:lnTo>
                  <a:lnTo>
                    <a:pt x="2622804" y="635635"/>
                  </a:lnTo>
                  <a:lnTo>
                    <a:pt x="2622804" y="381381"/>
                  </a:lnTo>
                  <a:close/>
                </a:path>
                <a:path w="4074159" h="635634">
                  <a:moveTo>
                    <a:pt x="2680843" y="508508"/>
                  </a:moveTo>
                  <a:lnTo>
                    <a:pt x="2670429" y="508508"/>
                  </a:lnTo>
                  <a:lnTo>
                    <a:pt x="2670429" y="635635"/>
                  </a:lnTo>
                  <a:lnTo>
                    <a:pt x="2680843" y="635635"/>
                  </a:lnTo>
                  <a:lnTo>
                    <a:pt x="2680843" y="508508"/>
                  </a:lnTo>
                  <a:close/>
                </a:path>
                <a:path w="4074159" h="635634">
                  <a:moveTo>
                    <a:pt x="2738882" y="508508"/>
                  </a:moveTo>
                  <a:lnTo>
                    <a:pt x="2728468" y="508508"/>
                  </a:lnTo>
                  <a:lnTo>
                    <a:pt x="2728468" y="635635"/>
                  </a:lnTo>
                  <a:lnTo>
                    <a:pt x="2738882" y="635635"/>
                  </a:lnTo>
                  <a:lnTo>
                    <a:pt x="2738882" y="508508"/>
                  </a:lnTo>
                  <a:close/>
                </a:path>
                <a:path w="4074159" h="635634">
                  <a:moveTo>
                    <a:pt x="2796921" y="286004"/>
                  </a:moveTo>
                  <a:lnTo>
                    <a:pt x="2786507" y="286004"/>
                  </a:lnTo>
                  <a:lnTo>
                    <a:pt x="2786507" y="635635"/>
                  </a:lnTo>
                  <a:lnTo>
                    <a:pt x="2796921" y="635635"/>
                  </a:lnTo>
                  <a:lnTo>
                    <a:pt x="2796921" y="286004"/>
                  </a:lnTo>
                  <a:close/>
                </a:path>
                <a:path w="4074159" h="635634">
                  <a:moveTo>
                    <a:pt x="2854960" y="413131"/>
                  </a:moveTo>
                  <a:lnTo>
                    <a:pt x="2844546" y="413131"/>
                  </a:lnTo>
                  <a:lnTo>
                    <a:pt x="2844546" y="635635"/>
                  </a:lnTo>
                  <a:lnTo>
                    <a:pt x="2854960" y="635635"/>
                  </a:lnTo>
                  <a:lnTo>
                    <a:pt x="2854960" y="413131"/>
                  </a:lnTo>
                  <a:close/>
                </a:path>
                <a:path w="4074159" h="635634">
                  <a:moveTo>
                    <a:pt x="2913126" y="508508"/>
                  </a:moveTo>
                  <a:lnTo>
                    <a:pt x="2902712" y="508508"/>
                  </a:lnTo>
                  <a:lnTo>
                    <a:pt x="2902712" y="635635"/>
                  </a:lnTo>
                  <a:lnTo>
                    <a:pt x="2913126" y="635635"/>
                  </a:lnTo>
                  <a:lnTo>
                    <a:pt x="2913126" y="508508"/>
                  </a:lnTo>
                  <a:close/>
                </a:path>
                <a:path w="4074159" h="635634">
                  <a:moveTo>
                    <a:pt x="2971165" y="222504"/>
                  </a:moveTo>
                  <a:lnTo>
                    <a:pt x="2960751" y="222504"/>
                  </a:lnTo>
                  <a:lnTo>
                    <a:pt x="2960751" y="635635"/>
                  </a:lnTo>
                  <a:lnTo>
                    <a:pt x="2971165" y="635635"/>
                  </a:lnTo>
                  <a:lnTo>
                    <a:pt x="2971165" y="222504"/>
                  </a:lnTo>
                  <a:close/>
                </a:path>
                <a:path w="4074159" h="635634">
                  <a:moveTo>
                    <a:pt x="3029204" y="540258"/>
                  </a:moveTo>
                  <a:lnTo>
                    <a:pt x="3018790" y="540258"/>
                  </a:lnTo>
                  <a:lnTo>
                    <a:pt x="3018790" y="635635"/>
                  </a:lnTo>
                  <a:lnTo>
                    <a:pt x="3029204" y="635635"/>
                  </a:lnTo>
                  <a:lnTo>
                    <a:pt x="3029204" y="540258"/>
                  </a:lnTo>
                  <a:close/>
                </a:path>
                <a:path w="4074159" h="635634">
                  <a:moveTo>
                    <a:pt x="3087243" y="349631"/>
                  </a:moveTo>
                  <a:lnTo>
                    <a:pt x="3076829" y="349631"/>
                  </a:lnTo>
                  <a:lnTo>
                    <a:pt x="3076829" y="635635"/>
                  </a:lnTo>
                  <a:lnTo>
                    <a:pt x="3087243" y="635635"/>
                  </a:lnTo>
                  <a:lnTo>
                    <a:pt x="3087243" y="349631"/>
                  </a:lnTo>
                  <a:close/>
                </a:path>
                <a:path w="4074159" h="635634">
                  <a:moveTo>
                    <a:pt x="3145282" y="349631"/>
                  </a:moveTo>
                  <a:lnTo>
                    <a:pt x="3134868" y="349631"/>
                  </a:lnTo>
                  <a:lnTo>
                    <a:pt x="3134868" y="635635"/>
                  </a:lnTo>
                  <a:lnTo>
                    <a:pt x="3145282" y="635635"/>
                  </a:lnTo>
                  <a:lnTo>
                    <a:pt x="3145282" y="349631"/>
                  </a:lnTo>
                  <a:close/>
                </a:path>
                <a:path w="4074159" h="635634">
                  <a:moveTo>
                    <a:pt x="3203321" y="95377"/>
                  </a:moveTo>
                  <a:lnTo>
                    <a:pt x="3192907" y="95377"/>
                  </a:lnTo>
                  <a:lnTo>
                    <a:pt x="3192907" y="635635"/>
                  </a:lnTo>
                  <a:lnTo>
                    <a:pt x="3203321" y="635635"/>
                  </a:lnTo>
                  <a:lnTo>
                    <a:pt x="3203321" y="95377"/>
                  </a:lnTo>
                  <a:close/>
                </a:path>
                <a:path w="4074159" h="635634">
                  <a:moveTo>
                    <a:pt x="3261360" y="254254"/>
                  </a:moveTo>
                  <a:lnTo>
                    <a:pt x="3250946" y="254254"/>
                  </a:lnTo>
                  <a:lnTo>
                    <a:pt x="3250946" y="635635"/>
                  </a:lnTo>
                  <a:lnTo>
                    <a:pt x="3261360" y="635635"/>
                  </a:lnTo>
                  <a:lnTo>
                    <a:pt x="3261360" y="254254"/>
                  </a:lnTo>
                  <a:close/>
                </a:path>
                <a:path w="4074159" h="635634">
                  <a:moveTo>
                    <a:pt x="3319399" y="286004"/>
                  </a:moveTo>
                  <a:lnTo>
                    <a:pt x="3308985" y="286004"/>
                  </a:lnTo>
                  <a:lnTo>
                    <a:pt x="3308985" y="635635"/>
                  </a:lnTo>
                  <a:lnTo>
                    <a:pt x="3319399" y="635635"/>
                  </a:lnTo>
                  <a:lnTo>
                    <a:pt x="3319399" y="286004"/>
                  </a:lnTo>
                  <a:close/>
                </a:path>
                <a:path w="4074159" h="635634">
                  <a:moveTo>
                    <a:pt x="3377438" y="95377"/>
                  </a:moveTo>
                  <a:lnTo>
                    <a:pt x="3367024" y="95377"/>
                  </a:lnTo>
                  <a:lnTo>
                    <a:pt x="3367024" y="635635"/>
                  </a:lnTo>
                  <a:lnTo>
                    <a:pt x="3377438" y="635635"/>
                  </a:lnTo>
                  <a:lnTo>
                    <a:pt x="3377438" y="95377"/>
                  </a:lnTo>
                  <a:close/>
                </a:path>
                <a:path w="4074159" h="635634">
                  <a:moveTo>
                    <a:pt x="3435604" y="349631"/>
                  </a:moveTo>
                  <a:lnTo>
                    <a:pt x="3425190" y="349631"/>
                  </a:lnTo>
                  <a:lnTo>
                    <a:pt x="3425190" y="635635"/>
                  </a:lnTo>
                  <a:lnTo>
                    <a:pt x="3435604" y="635635"/>
                  </a:lnTo>
                  <a:lnTo>
                    <a:pt x="3435604" y="349631"/>
                  </a:lnTo>
                  <a:close/>
                </a:path>
                <a:path w="4074159" h="635634">
                  <a:moveTo>
                    <a:pt x="3493643" y="190627"/>
                  </a:moveTo>
                  <a:lnTo>
                    <a:pt x="3483229" y="190627"/>
                  </a:lnTo>
                  <a:lnTo>
                    <a:pt x="3483229" y="635635"/>
                  </a:lnTo>
                  <a:lnTo>
                    <a:pt x="3493643" y="635635"/>
                  </a:lnTo>
                  <a:lnTo>
                    <a:pt x="3493643" y="190627"/>
                  </a:lnTo>
                  <a:close/>
                </a:path>
                <a:path w="4074159" h="635634">
                  <a:moveTo>
                    <a:pt x="3551682" y="413131"/>
                  </a:moveTo>
                  <a:lnTo>
                    <a:pt x="3541268" y="413131"/>
                  </a:lnTo>
                  <a:lnTo>
                    <a:pt x="3541268" y="635635"/>
                  </a:lnTo>
                  <a:lnTo>
                    <a:pt x="3551682" y="635635"/>
                  </a:lnTo>
                  <a:lnTo>
                    <a:pt x="3551682" y="413131"/>
                  </a:lnTo>
                  <a:close/>
                </a:path>
                <a:path w="4074159" h="635634">
                  <a:moveTo>
                    <a:pt x="3609721" y="476758"/>
                  </a:moveTo>
                  <a:lnTo>
                    <a:pt x="3599307" y="476758"/>
                  </a:lnTo>
                  <a:lnTo>
                    <a:pt x="3599307" y="635635"/>
                  </a:lnTo>
                  <a:lnTo>
                    <a:pt x="3609721" y="635635"/>
                  </a:lnTo>
                  <a:lnTo>
                    <a:pt x="3609721" y="476758"/>
                  </a:lnTo>
                  <a:close/>
                </a:path>
                <a:path w="4074159" h="635634">
                  <a:moveTo>
                    <a:pt x="3667760" y="444881"/>
                  </a:moveTo>
                  <a:lnTo>
                    <a:pt x="3657346" y="444881"/>
                  </a:lnTo>
                  <a:lnTo>
                    <a:pt x="3657346" y="635635"/>
                  </a:lnTo>
                  <a:lnTo>
                    <a:pt x="3667760" y="635635"/>
                  </a:lnTo>
                  <a:lnTo>
                    <a:pt x="3667760" y="444881"/>
                  </a:lnTo>
                  <a:close/>
                </a:path>
                <a:path w="4074159" h="635634">
                  <a:moveTo>
                    <a:pt x="3725799" y="222504"/>
                  </a:moveTo>
                  <a:lnTo>
                    <a:pt x="3715385" y="222504"/>
                  </a:lnTo>
                  <a:lnTo>
                    <a:pt x="3715385" y="635635"/>
                  </a:lnTo>
                  <a:lnTo>
                    <a:pt x="3725799" y="635635"/>
                  </a:lnTo>
                  <a:lnTo>
                    <a:pt x="3725799" y="222504"/>
                  </a:lnTo>
                  <a:close/>
                </a:path>
                <a:path w="4074159" h="635634">
                  <a:moveTo>
                    <a:pt x="3783838" y="286004"/>
                  </a:moveTo>
                  <a:lnTo>
                    <a:pt x="3773424" y="286004"/>
                  </a:lnTo>
                  <a:lnTo>
                    <a:pt x="3773424" y="635635"/>
                  </a:lnTo>
                  <a:lnTo>
                    <a:pt x="3783838" y="635635"/>
                  </a:lnTo>
                  <a:lnTo>
                    <a:pt x="3783838" y="286004"/>
                  </a:lnTo>
                  <a:close/>
                </a:path>
                <a:path w="4074159" h="635634">
                  <a:moveTo>
                    <a:pt x="3841877" y="381381"/>
                  </a:moveTo>
                  <a:lnTo>
                    <a:pt x="3831463" y="381381"/>
                  </a:lnTo>
                  <a:lnTo>
                    <a:pt x="3831463" y="635635"/>
                  </a:lnTo>
                  <a:lnTo>
                    <a:pt x="3841877" y="635635"/>
                  </a:lnTo>
                  <a:lnTo>
                    <a:pt x="3841877" y="381381"/>
                  </a:lnTo>
                  <a:close/>
                </a:path>
                <a:path w="4074159" h="635634">
                  <a:moveTo>
                    <a:pt x="3899916" y="95377"/>
                  </a:moveTo>
                  <a:lnTo>
                    <a:pt x="3889502" y="95377"/>
                  </a:lnTo>
                  <a:lnTo>
                    <a:pt x="3889502" y="635635"/>
                  </a:lnTo>
                  <a:lnTo>
                    <a:pt x="3899916" y="635635"/>
                  </a:lnTo>
                  <a:lnTo>
                    <a:pt x="3899916" y="95377"/>
                  </a:lnTo>
                  <a:close/>
                </a:path>
                <a:path w="4074159" h="635634">
                  <a:moveTo>
                    <a:pt x="3958082" y="0"/>
                  </a:moveTo>
                  <a:lnTo>
                    <a:pt x="3947668" y="0"/>
                  </a:lnTo>
                  <a:lnTo>
                    <a:pt x="3947668" y="635635"/>
                  </a:lnTo>
                  <a:lnTo>
                    <a:pt x="3958082" y="635635"/>
                  </a:lnTo>
                  <a:lnTo>
                    <a:pt x="3958082" y="0"/>
                  </a:lnTo>
                  <a:close/>
                </a:path>
                <a:path w="4074159" h="635634">
                  <a:moveTo>
                    <a:pt x="4016121" y="444881"/>
                  </a:moveTo>
                  <a:lnTo>
                    <a:pt x="4005707" y="444881"/>
                  </a:lnTo>
                  <a:lnTo>
                    <a:pt x="4005707" y="635635"/>
                  </a:lnTo>
                  <a:lnTo>
                    <a:pt x="4016121" y="635635"/>
                  </a:lnTo>
                  <a:lnTo>
                    <a:pt x="4016121" y="444881"/>
                  </a:lnTo>
                  <a:close/>
                </a:path>
                <a:path w="4074159" h="635634">
                  <a:moveTo>
                    <a:pt x="4074160" y="381381"/>
                  </a:moveTo>
                  <a:lnTo>
                    <a:pt x="4063746" y="381381"/>
                  </a:lnTo>
                  <a:lnTo>
                    <a:pt x="4063746" y="635635"/>
                  </a:lnTo>
                  <a:lnTo>
                    <a:pt x="4074160" y="635635"/>
                  </a:lnTo>
                  <a:lnTo>
                    <a:pt x="4074160" y="381381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9" name="object 109" descr=""/>
            <p:cNvSpPr/>
            <p:nvPr/>
          </p:nvSpPr>
          <p:spPr>
            <a:xfrm>
              <a:off x="9774555" y="7867904"/>
              <a:ext cx="4074160" cy="795020"/>
            </a:xfrm>
            <a:custGeom>
              <a:avLst/>
              <a:gdLst/>
              <a:ahLst/>
              <a:cxnLst/>
              <a:rect l="l" t="t" r="r" b="b"/>
              <a:pathLst>
                <a:path w="4074159" h="795020">
                  <a:moveTo>
                    <a:pt x="10414" y="540258"/>
                  </a:moveTo>
                  <a:lnTo>
                    <a:pt x="0" y="540258"/>
                  </a:lnTo>
                  <a:lnTo>
                    <a:pt x="0" y="794512"/>
                  </a:lnTo>
                  <a:lnTo>
                    <a:pt x="10414" y="794512"/>
                  </a:lnTo>
                  <a:lnTo>
                    <a:pt x="10414" y="540258"/>
                  </a:lnTo>
                  <a:close/>
                </a:path>
                <a:path w="4074159" h="795020">
                  <a:moveTo>
                    <a:pt x="68453" y="667385"/>
                  </a:moveTo>
                  <a:lnTo>
                    <a:pt x="58039" y="667385"/>
                  </a:lnTo>
                  <a:lnTo>
                    <a:pt x="58039" y="794512"/>
                  </a:lnTo>
                  <a:lnTo>
                    <a:pt x="68453" y="794512"/>
                  </a:lnTo>
                  <a:lnTo>
                    <a:pt x="68453" y="667385"/>
                  </a:lnTo>
                  <a:close/>
                </a:path>
                <a:path w="4074159" h="795020">
                  <a:moveTo>
                    <a:pt x="126492" y="572008"/>
                  </a:moveTo>
                  <a:lnTo>
                    <a:pt x="116078" y="572008"/>
                  </a:lnTo>
                  <a:lnTo>
                    <a:pt x="116078" y="794512"/>
                  </a:lnTo>
                  <a:lnTo>
                    <a:pt x="126492" y="794512"/>
                  </a:lnTo>
                  <a:lnTo>
                    <a:pt x="126492" y="572008"/>
                  </a:lnTo>
                  <a:close/>
                </a:path>
                <a:path w="4074159" h="795020">
                  <a:moveTo>
                    <a:pt x="184531" y="699135"/>
                  </a:moveTo>
                  <a:lnTo>
                    <a:pt x="174117" y="699135"/>
                  </a:lnTo>
                  <a:lnTo>
                    <a:pt x="174117" y="794512"/>
                  </a:lnTo>
                  <a:lnTo>
                    <a:pt x="184531" y="794512"/>
                  </a:lnTo>
                  <a:lnTo>
                    <a:pt x="184531" y="699135"/>
                  </a:lnTo>
                  <a:close/>
                </a:path>
                <a:path w="4074159" h="795020">
                  <a:moveTo>
                    <a:pt x="242570" y="413131"/>
                  </a:moveTo>
                  <a:lnTo>
                    <a:pt x="232156" y="413131"/>
                  </a:lnTo>
                  <a:lnTo>
                    <a:pt x="232156" y="794512"/>
                  </a:lnTo>
                  <a:lnTo>
                    <a:pt x="242570" y="794512"/>
                  </a:lnTo>
                  <a:lnTo>
                    <a:pt x="242570" y="413131"/>
                  </a:lnTo>
                  <a:close/>
                </a:path>
                <a:path w="4074159" h="795020">
                  <a:moveTo>
                    <a:pt x="303276" y="540258"/>
                  </a:moveTo>
                  <a:lnTo>
                    <a:pt x="290195" y="540258"/>
                  </a:lnTo>
                  <a:lnTo>
                    <a:pt x="290195" y="794512"/>
                  </a:lnTo>
                  <a:lnTo>
                    <a:pt x="303276" y="794512"/>
                  </a:lnTo>
                  <a:lnTo>
                    <a:pt x="303276" y="540258"/>
                  </a:lnTo>
                  <a:close/>
                </a:path>
                <a:path w="4074159" h="795020">
                  <a:moveTo>
                    <a:pt x="358648" y="572008"/>
                  </a:moveTo>
                  <a:lnTo>
                    <a:pt x="348234" y="572008"/>
                  </a:lnTo>
                  <a:lnTo>
                    <a:pt x="348234" y="794512"/>
                  </a:lnTo>
                  <a:lnTo>
                    <a:pt x="358648" y="794512"/>
                  </a:lnTo>
                  <a:lnTo>
                    <a:pt x="358648" y="572008"/>
                  </a:lnTo>
                  <a:close/>
                </a:path>
                <a:path w="4074159" h="795020">
                  <a:moveTo>
                    <a:pt x="416687" y="381381"/>
                  </a:moveTo>
                  <a:lnTo>
                    <a:pt x="406273" y="381381"/>
                  </a:lnTo>
                  <a:lnTo>
                    <a:pt x="406273" y="794512"/>
                  </a:lnTo>
                  <a:lnTo>
                    <a:pt x="416687" y="794512"/>
                  </a:lnTo>
                  <a:lnTo>
                    <a:pt x="416687" y="381381"/>
                  </a:lnTo>
                  <a:close/>
                </a:path>
                <a:path w="4074159" h="795020">
                  <a:moveTo>
                    <a:pt x="474853" y="508508"/>
                  </a:moveTo>
                  <a:lnTo>
                    <a:pt x="464439" y="508508"/>
                  </a:lnTo>
                  <a:lnTo>
                    <a:pt x="464439" y="794512"/>
                  </a:lnTo>
                  <a:lnTo>
                    <a:pt x="474853" y="794512"/>
                  </a:lnTo>
                  <a:lnTo>
                    <a:pt x="474853" y="508508"/>
                  </a:lnTo>
                  <a:close/>
                </a:path>
                <a:path w="4074159" h="795020">
                  <a:moveTo>
                    <a:pt x="532892" y="286004"/>
                  </a:moveTo>
                  <a:lnTo>
                    <a:pt x="522478" y="286004"/>
                  </a:lnTo>
                  <a:lnTo>
                    <a:pt x="522478" y="794512"/>
                  </a:lnTo>
                  <a:lnTo>
                    <a:pt x="532892" y="794512"/>
                  </a:lnTo>
                  <a:lnTo>
                    <a:pt x="532892" y="286004"/>
                  </a:lnTo>
                  <a:close/>
                </a:path>
                <a:path w="4074159" h="795020">
                  <a:moveTo>
                    <a:pt x="590931" y="476631"/>
                  </a:moveTo>
                  <a:lnTo>
                    <a:pt x="580517" y="476631"/>
                  </a:lnTo>
                  <a:lnTo>
                    <a:pt x="580517" y="794512"/>
                  </a:lnTo>
                  <a:lnTo>
                    <a:pt x="590931" y="794512"/>
                  </a:lnTo>
                  <a:lnTo>
                    <a:pt x="590931" y="476631"/>
                  </a:lnTo>
                  <a:close/>
                </a:path>
                <a:path w="4074159" h="795020">
                  <a:moveTo>
                    <a:pt x="648970" y="476631"/>
                  </a:moveTo>
                  <a:lnTo>
                    <a:pt x="638556" y="476631"/>
                  </a:lnTo>
                  <a:lnTo>
                    <a:pt x="638556" y="794512"/>
                  </a:lnTo>
                  <a:lnTo>
                    <a:pt x="648970" y="794512"/>
                  </a:lnTo>
                  <a:lnTo>
                    <a:pt x="648970" y="476631"/>
                  </a:lnTo>
                  <a:close/>
                </a:path>
                <a:path w="4074159" h="795020">
                  <a:moveTo>
                    <a:pt x="707009" y="572008"/>
                  </a:moveTo>
                  <a:lnTo>
                    <a:pt x="696595" y="572008"/>
                  </a:lnTo>
                  <a:lnTo>
                    <a:pt x="696595" y="794512"/>
                  </a:lnTo>
                  <a:lnTo>
                    <a:pt x="707009" y="794512"/>
                  </a:lnTo>
                  <a:lnTo>
                    <a:pt x="707009" y="572008"/>
                  </a:lnTo>
                  <a:close/>
                </a:path>
                <a:path w="4074159" h="795020">
                  <a:moveTo>
                    <a:pt x="767715" y="413131"/>
                  </a:moveTo>
                  <a:lnTo>
                    <a:pt x="754634" y="413131"/>
                  </a:lnTo>
                  <a:lnTo>
                    <a:pt x="754634" y="794512"/>
                  </a:lnTo>
                  <a:lnTo>
                    <a:pt x="767715" y="794512"/>
                  </a:lnTo>
                  <a:lnTo>
                    <a:pt x="767715" y="413131"/>
                  </a:lnTo>
                  <a:close/>
                </a:path>
                <a:path w="4074159" h="795020">
                  <a:moveTo>
                    <a:pt x="823087" y="0"/>
                  </a:moveTo>
                  <a:lnTo>
                    <a:pt x="812673" y="0"/>
                  </a:lnTo>
                  <a:lnTo>
                    <a:pt x="812673" y="794512"/>
                  </a:lnTo>
                  <a:lnTo>
                    <a:pt x="823087" y="794512"/>
                  </a:lnTo>
                  <a:lnTo>
                    <a:pt x="823087" y="0"/>
                  </a:lnTo>
                  <a:close/>
                </a:path>
                <a:path w="4074159" h="795020">
                  <a:moveTo>
                    <a:pt x="881126" y="286004"/>
                  </a:moveTo>
                  <a:lnTo>
                    <a:pt x="870712" y="286004"/>
                  </a:lnTo>
                  <a:lnTo>
                    <a:pt x="870712" y="794512"/>
                  </a:lnTo>
                  <a:lnTo>
                    <a:pt x="881126" y="794512"/>
                  </a:lnTo>
                  <a:lnTo>
                    <a:pt x="881126" y="286004"/>
                  </a:lnTo>
                  <a:close/>
                </a:path>
                <a:path w="4074159" h="795020">
                  <a:moveTo>
                    <a:pt x="939165" y="413131"/>
                  </a:moveTo>
                  <a:lnTo>
                    <a:pt x="928751" y="413131"/>
                  </a:lnTo>
                  <a:lnTo>
                    <a:pt x="928751" y="794512"/>
                  </a:lnTo>
                  <a:lnTo>
                    <a:pt x="939165" y="794512"/>
                  </a:lnTo>
                  <a:lnTo>
                    <a:pt x="939165" y="413131"/>
                  </a:lnTo>
                  <a:close/>
                </a:path>
                <a:path w="4074159" h="795020">
                  <a:moveTo>
                    <a:pt x="997331" y="413131"/>
                  </a:moveTo>
                  <a:lnTo>
                    <a:pt x="986917" y="413131"/>
                  </a:lnTo>
                  <a:lnTo>
                    <a:pt x="986917" y="794512"/>
                  </a:lnTo>
                  <a:lnTo>
                    <a:pt x="997331" y="794512"/>
                  </a:lnTo>
                  <a:lnTo>
                    <a:pt x="997331" y="413131"/>
                  </a:lnTo>
                  <a:close/>
                </a:path>
                <a:path w="4074159" h="795020">
                  <a:moveTo>
                    <a:pt x="1055370" y="381381"/>
                  </a:moveTo>
                  <a:lnTo>
                    <a:pt x="1044956" y="381381"/>
                  </a:lnTo>
                  <a:lnTo>
                    <a:pt x="1044956" y="794512"/>
                  </a:lnTo>
                  <a:lnTo>
                    <a:pt x="1055370" y="794512"/>
                  </a:lnTo>
                  <a:lnTo>
                    <a:pt x="1055370" y="381381"/>
                  </a:lnTo>
                  <a:close/>
                </a:path>
                <a:path w="4074159" h="795020">
                  <a:moveTo>
                    <a:pt x="1113409" y="444881"/>
                  </a:moveTo>
                  <a:lnTo>
                    <a:pt x="1102995" y="444881"/>
                  </a:lnTo>
                  <a:lnTo>
                    <a:pt x="1102995" y="794512"/>
                  </a:lnTo>
                  <a:lnTo>
                    <a:pt x="1113409" y="794512"/>
                  </a:lnTo>
                  <a:lnTo>
                    <a:pt x="1113409" y="444881"/>
                  </a:lnTo>
                  <a:close/>
                </a:path>
                <a:path w="4074159" h="795020">
                  <a:moveTo>
                    <a:pt x="1171448" y="349504"/>
                  </a:moveTo>
                  <a:lnTo>
                    <a:pt x="1161034" y="349504"/>
                  </a:lnTo>
                  <a:lnTo>
                    <a:pt x="1161034" y="794512"/>
                  </a:lnTo>
                  <a:lnTo>
                    <a:pt x="1171448" y="794512"/>
                  </a:lnTo>
                  <a:lnTo>
                    <a:pt x="1171448" y="349504"/>
                  </a:lnTo>
                  <a:close/>
                </a:path>
                <a:path w="4074159" h="795020">
                  <a:moveTo>
                    <a:pt x="1229487" y="349504"/>
                  </a:moveTo>
                  <a:lnTo>
                    <a:pt x="1219073" y="349504"/>
                  </a:lnTo>
                  <a:lnTo>
                    <a:pt x="1219073" y="794512"/>
                  </a:lnTo>
                  <a:lnTo>
                    <a:pt x="1229487" y="794512"/>
                  </a:lnTo>
                  <a:lnTo>
                    <a:pt x="1229487" y="349504"/>
                  </a:lnTo>
                  <a:close/>
                </a:path>
                <a:path w="4074159" h="795020">
                  <a:moveTo>
                    <a:pt x="1287526" y="286004"/>
                  </a:moveTo>
                  <a:lnTo>
                    <a:pt x="1277112" y="286004"/>
                  </a:lnTo>
                  <a:lnTo>
                    <a:pt x="1277112" y="794512"/>
                  </a:lnTo>
                  <a:lnTo>
                    <a:pt x="1287526" y="794512"/>
                  </a:lnTo>
                  <a:lnTo>
                    <a:pt x="1287526" y="286004"/>
                  </a:lnTo>
                  <a:close/>
                </a:path>
                <a:path w="4074159" h="795020">
                  <a:moveTo>
                    <a:pt x="1348232" y="381381"/>
                  </a:moveTo>
                  <a:lnTo>
                    <a:pt x="1335151" y="381381"/>
                  </a:lnTo>
                  <a:lnTo>
                    <a:pt x="1335151" y="794512"/>
                  </a:lnTo>
                  <a:lnTo>
                    <a:pt x="1348232" y="794512"/>
                  </a:lnTo>
                  <a:lnTo>
                    <a:pt x="1348232" y="381381"/>
                  </a:lnTo>
                  <a:close/>
                </a:path>
                <a:path w="4074159" h="795020">
                  <a:moveTo>
                    <a:pt x="1403604" y="603758"/>
                  </a:moveTo>
                  <a:lnTo>
                    <a:pt x="1393190" y="603758"/>
                  </a:lnTo>
                  <a:lnTo>
                    <a:pt x="1393190" y="794512"/>
                  </a:lnTo>
                  <a:lnTo>
                    <a:pt x="1403604" y="794512"/>
                  </a:lnTo>
                  <a:lnTo>
                    <a:pt x="1403604" y="603758"/>
                  </a:lnTo>
                  <a:close/>
                </a:path>
                <a:path w="4074159" h="795020">
                  <a:moveTo>
                    <a:pt x="1461643" y="508508"/>
                  </a:moveTo>
                  <a:lnTo>
                    <a:pt x="1451229" y="508508"/>
                  </a:lnTo>
                  <a:lnTo>
                    <a:pt x="1451229" y="794512"/>
                  </a:lnTo>
                  <a:lnTo>
                    <a:pt x="1461643" y="794512"/>
                  </a:lnTo>
                  <a:lnTo>
                    <a:pt x="1461643" y="508508"/>
                  </a:lnTo>
                  <a:close/>
                </a:path>
                <a:path w="4074159" h="795020">
                  <a:moveTo>
                    <a:pt x="1519809" y="381381"/>
                  </a:moveTo>
                  <a:lnTo>
                    <a:pt x="1509395" y="381381"/>
                  </a:lnTo>
                  <a:lnTo>
                    <a:pt x="1509395" y="794512"/>
                  </a:lnTo>
                  <a:lnTo>
                    <a:pt x="1519809" y="794512"/>
                  </a:lnTo>
                  <a:lnTo>
                    <a:pt x="1519809" y="381381"/>
                  </a:lnTo>
                  <a:close/>
                </a:path>
                <a:path w="4074159" h="795020">
                  <a:moveTo>
                    <a:pt x="1577848" y="572008"/>
                  </a:moveTo>
                  <a:lnTo>
                    <a:pt x="1567434" y="572008"/>
                  </a:lnTo>
                  <a:lnTo>
                    <a:pt x="1567434" y="794512"/>
                  </a:lnTo>
                  <a:lnTo>
                    <a:pt x="1577848" y="794512"/>
                  </a:lnTo>
                  <a:lnTo>
                    <a:pt x="1577848" y="572008"/>
                  </a:lnTo>
                  <a:close/>
                </a:path>
                <a:path w="4074159" h="795020">
                  <a:moveTo>
                    <a:pt x="1635887" y="540258"/>
                  </a:moveTo>
                  <a:lnTo>
                    <a:pt x="1625473" y="540258"/>
                  </a:lnTo>
                  <a:lnTo>
                    <a:pt x="1625473" y="794512"/>
                  </a:lnTo>
                  <a:lnTo>
                    <a:pt x="1635887" y="794512"/>
                  </a:lnTo>
                  <a:lnTo>
                    <a:pt x="1635887" y="540258"/>
                  </a:lnTo>
                  <a:close/>
                </a:path>
                <a:path w="4074159" h="795020">
                  <a:moveTo>
                    <a:pt x="1693926" y="540258"/>
                  </a:moveTo>
                  <a:lnTo>
                    <a:pt x="1683512" y="540258"/>
                  </a:lnTo>
                  <a:lnTo>
                    <a:pt x="1683512" y="794512"/>
                  </a:lnTo>
                  <a:lnTo>
                    <a:pt x="1693926" y="794512"/>
                  </a:lnTo>
                  <a:lnTo>
                    <a:pt x="1693926" y="540258"/>
                  </a:lnTo>
                  <a:close/>
                </a:path>
                <a:path w="4074159" h="795020">
                  <a:moveTo>
                    <a:pt x="1751965" y="413131"/>
                  </a:moveTo>
                  <a:lnTo>
                    <a:pt x="1741551" y="413131"/>
                  </a:lnTo>
                  <a:lnTo>
                    <a:pt x="1741551" y="794512"/>
                  </a:lnTo>
                  <a:lnTo>
                    <a:pt x="1751965" y="794512"/>
                  </a:lnTo>
                  <a:lnTo>
                    <a:pt x="1751965" y="413131"/>
                  </a:lnTo>
                  <a:close/>
                </a:path>
                <a:path w="4074159" h="795020">
                  <a:moveTo>
                    <a:pt x="1810004" y="540258"/>
                  </a:moveTo>
                  <a:lnTo>
                    <a:pt x="1799590" y="540258"/>
                  </a:lnTo>
                  <a:lnTo>
                    <a:pt x="1799590" y="794512"/>
                  </a:lnTo>
                  <a:lnTo>
                    <a:pt x="1810004" y="794512"/>
                  </a:lnTo>
                  <a:lnTo>
                    <a:pt x="1810004" y="540258"/>
                  </a:lnTo>
                  <a:close/>
                </a:path>
                <a:path w="4074159" h="795020">
                  <a:moveTo>
                    <a:pt x="1868043" y="444881"/>
                  </a:moveTo>
                  <a:lnTo>
                    <a:pt x="1857629" y="444881"/>
                  </a:lnTo>
                  <a:lnTo>
                    <a:pt x="1857629" y="794512"/>
                  </a:lnTo>
                  <a:lnTo>
                    <a:pt x="1868043" y="794512"/>
                  </a:lnTo>
                  <a:lnTo>
                    <a:pt x="1868043" y="444881"/>
                  </a:lnTo>
                  <a:close/>
                </a:path>
                <a:path w="4074159" h="795020">
                  <a:moveTo>
                    <a:pt x="1928749" y="540258"/>
                  </a:moveTo>
                  <a:lnTo>
                    <a:pt x="1915668" y="540258"/>
                  </a:lnTo>
                  <a:lnTo>
                    <a:pt x="1915668" y="794512"/>
                  </a:lnTo>
                  <a:lnTo>
                    <a:pt x="1928749" y="794512"/>
                  </a:lnTo>
                  <a:lnTo>
                    <a:pt x="1928749" y="540258"/>
                  </a:lnTo>
                  <a:close/>
                </a:path>
                <a:path w="4074159" h="795020">
                  <a:moveTo>
                    <a:pt x="1984121" y="444881"/>
                  </a:moveTo>
                  <a:lnTo>
                    <a:pt x="1973707" y="444881"/>
                  </a:lnTo>
                  <a:lnTo>
                    <a:pt x="1973707" y="794512"/>
                  </a:lnTo>
                  <a:lnTo>
                    <a:pt x="1984121" y="794512"/>
                  </a:lnTo>
                  <a:lnTo>
                    <a:pt x="1984121" y="444881"/>
                  </a:lnTo>
                  <a:close/>
                </a:path>
                <a:path w="4074159" h="795020">
                  <a:moveTo>
                    <a:pt x="2042160" y="572008"/>
                  </a:moveTo>
                  <a:lnTo>
                    <a:pt x="2031746" y="572008"/>
                  </a:lnTo>
                  <a:lnTo>
                    <a:pt x="2031746" y="794512"/>
                  </a:lnTo>
                  <a:lnTo>
                    <a:pt x="2042160" y="794512"/>
                  </a:lnTo>
                  <a:lnTo>
                    <a:pt x="2042160" y="572008"/>
                  </a:lnTo>
                  <a:close/>
                </a:path>
                <a:path w="4074159" h="795020">
                  <a:moveTo>
                    <a:pt x="2102993" y="635635"/>
                  </a:moveTo>
                  <a:lnTo>
                    <a:pt x="2089912" y="635635"/>
                  </a:lnTo>
                  <a:lnTo>
                    <a:pt x="2089912" y="794512"/>
                  </a:lnTo>
                  <a:lnTo>
                    <a:pt x="2102993" y="794512"/>
                  </a:lnTo>
                  <a:lnTo>
                    <a:pt x="2102993" y="635635"/>
                  </a:lnTo>
                  <a:close/>
                </a:path>
                <a:path w="4074159" h="795020">
                  <a:moveTo>
                    <a:pt x="2158365" y="572008"/>
                  </a:moveTo>
                  <a:lnTo>
                    <a:pt x="2147951" y="572008"/>
                  </a:lnTo>
                  <a:lnTo>
                    <a:pt x="2147951" y="794512"/>
                  </a:lnTo>
                  <a:lnTo>
                    <a:pt x="2158365" y="794512"/>
                  </a:lnTo>
                  <a:lnTo>
                    <a:pt x="2158365" y="572008"/>
                  </a:lnTo>
                  <a:close/>
                </a:path>
                <a:path w="4074159" h="795020">
                  <a:moveTo>
                    <a:pt x="2216404" y="667385"/>
                  </a:moveTo>
                  <a:lnTo>
                    <a:pt x="2205990" y="667385"/>
                  </a:lnTo>
                  <a:lnTo>
                    <a:pt x="2205990" y="794512"/>
                  </a:lnTo>
                  <a:lnTo>
                    <a:pt x="2216404" y="794512"/>
                  </a:lnTo>
                  <a:lnTo>
                    <a:pt x="2216404" y="667385"/>
                  </a:lnTo>
                  <a:close/>
                </a:path>
                <a:path w="4074159" h="795020">
                  <a:moveTo>
                    <a:pt x="2274443" y="572008"/>
                  </a:moveTo>
                  <a:lnTo>
                    <a:pt x="2264029" y="572008"/>
                  </a:lnTo>
                  <a:lnTo>
                    <a:pt x="2264029" y="794512"/>
                  </a:lnTo>
                  <a:lnTo>
                    <a:pt x="2274443" y="794512"/>
                  </a:lnTo>
                  <a:lnTo>
                    <a:pt x="2274443" y="572008"/>
                  </a:lnTo>
                  <a:close/>
                </a:path>
                <a:path w="4074159" h="795020">
                  <a:moveTo>
                    <a:pt x="2335149" y="476631"/>
                  </a:moveTo>
                  <a:lnTo>
                    <a:pt x="2322068" y="476631"/>
                  </a:lnTo>
                  <a:lnTo>
                    <a:pt x="2322068" y="794512"/>
                  </a:lnTo>
                  <a:lnTo>
                    <a:pt x="2335149" y="794512"/>
                  </a:lnTo>
                  <a:lnTo>
                    <a:pt x="2335149" y="476631"/>
                  </a:lnTo>
                  <a:close/>
                </a:path>
                <a:path w="4074159" h="795020">
                  <a:moveTo>
                    <a:pt x="2390521" y="476631"/>
                  </a:moveTo>
                  <a:lnTo>
                    <a:pt x="2380107" y="476631"/>
                  </a:lnTo>
                  <a:lnTo>
                    <a:pt x="2380107" y="794512"/>
                  </a:lnTo>
                  <a:lnTo>
                    <a:pt x="2390521" y="794512"/>
                  </a:lnTo>
                  <a:lnTo>
                    <a:pt x="2390521" y="476631"/>
                  </a:lnTo>
                  <a:close/>
                </a:path>
                <a:path w="4074159" h="795020">
                  <a:moveTo>
                    <a:pt x="2448560" y="540258"/>
                  </a:moveTo>
                  <a:lnTo>
                    <a:pt x="2438146" y="540258"/>
                  </a:lnTo>
                  <a:lnTo>
                    <a:pt x="2438146" y="794512"/>
                  </a:lnTo>
                  <a:lnTo>
                    <a:pt x="2448560" y="794512"/>
                  </a:lnTo>
                  <a:lnTo>
                    <a:pt x="2448560" y="540258"/>
                  </a:lnTo>
                  <a:close/>
                </a:path>
                <a:path w="4074159" h="795020">
                  <a:moveTo>
                    <a:pt x="2506599" y="540258"/>
                  </a:moveTo>
                  <a:lnTo>
                    <a:pt x="2496185" y="540258"/>
                  </a:lnTo>
                  <a:lnTo>
                    <a:pt x="2496185" y="794512"/>
                  </a:lnTo>
                  <a:lnTo>
                    <a:pt x="2506599" y="794512"/>
                  </a:lnTo>
                  <a:lnTo>
                    <a:pt x="2506599" y="540258"/>
                  </a:lnTo>
                  <a:close/>
                </a:path>
                <a:path w="4074159" h="795020">
                  <a:moveTo>
                    <a:pt x="2564638" y="572008"/>
                  </a:moveTo>
                  <a:lnTo>
                    <a:pt x="2554224" y="572008"/>
                  </a:lnTo>
                  <a:lnTo>
                    <a:pt x="2554224" y="794512"/>
                  </a:lnTo>
                  <a:lnTo>
                    <a:pt x="2564638" y="794512"/>
                  </a:lnTo>
                  <a:lnTo>
                    <a:pt x="2564638" y="572008"/>
                  </a:lnTo>
                  <a:close/>
                </a:path>
                <a:path w="4074159" h="795020">
                  <a:moveTo>
                    <a:pt x="2622804" y="635635"/>
                  </a:moveTo>
                  <a:lnTo>
                    <a:pt x="2612390" y="635635"/>
                  </a:lnTo>
                  <a:lnTo>
                    <a:pt x="2612390" y="794512"/>
                  </a:lnTo>
                  <a:lnTo>
                    <a:pt x="2622804" y="794512"/>
                  </a:lnTo>
                  <a:lnTo>
                    <a:pt x="2622804" y="635635"/>
                  </a:lnTo>
                  <a:close/>
                </a:path>
                <a:path w="4074159" h="795020">
                  <a:moveTo>
                    <a:pt x="2680843" y="540258"/>
                  </a:moveTo>
                  <a:lnTo>
                    <a:pt x="2670429" y="540258"/>
                  </a:lnTo>
                  <a:lnTo>
                    <a:pt x="2670429" y="794512"/>
                  </a:lnTo>
                  <a:lnTo>
                    <a:pt x="2680843" y="794512"/>
                  </a:lnTo>
                  <a:lnTo>
                    <a:pt x="2680843" y="540258"/>
                  </a:lnTo>
                  <a:close/>
                </a:path>
                <a:path w="4074159" h="795020">
                  <a:moveTo>
                    <a:pt x="2738882" y="635635"/>
                  </a:moveTo>
                  <a:lnTo>
                    <a:pt x="2728468" y="635635"/>
                  </a:lnTo>
                  <a:lnTo>
                    <a:pt x="2728468" y="794512"/>
                  </a:lnTo>
                  <a:lnTo>
                    <a:pt x="2738882" y="794512"/>
                  </a:lnTo>
                  <a:lnTo>
                    <a:pt x="2738882" y="635635"/>
                  </a:lnTo>
                  <a:close/>
                </a:path>
                <a:path w="4074159" h="795020">
                  <a:moveTo>
                    <a:pt x="2799575" y="667385"/>
                  </a:moveTo>
                  <a:lnTo>
                    <a:pt x="2786507" y="667385"/>
                  </a:lnTo>
                  <a:lnTo>
                    <a:pt x="2786507" y="794512"/>
                  </a:lnTo>
                  <a:lnTo>
                    <a:pt x="2799575" y="794512"/>
                  </a:lnTo>
                  <a:lnTo>
                    <a:pt x="2799575" y="667385"/>
                  </a:lnTo>
                  <a:close/>
                </a:path>
                <a:path w="4074159" h="795020">
                  <a:moveTo>
                    <a:pt x="2857627" y="572008"/>
                  </a:moveTo>
                  <a:lnTo>
                    <a:pt x="2844546" y="572008"/>
                  </a:lnTo>
                  <a:lnTo>
                    <a:pt x="2844546" y="794512"/>
                  </a:lnTo>
                  <a:lnTo>
                    <a:pt x="2857627" y="794512"/>
                  </a:lnTo>
                  <a:lnTo>
                    <a:pt x="2857627" y="572008"/>
                  </a:lnTo>
                  <a:close/>
                </a:path>
                <a:path w="4074159" h="795020">
                  <a:moveTo>
                    <a:pt x="2912999" y="381381"/>
                  </a:moveTo>
                  <a:lnTo>
                    <a:pt x="2902585" y="381381"/>
                  </a:lnTo>
                  <a:lnTo>
                    <a:pt x="2902585" y="794512"/>
                  </a:lnTo>
                  <a:lnTo>
                    <a:pt x="2912999" y="794512"/>
                  </a:lnTo>
                  <a:lnTo>
                    <a:pt x="2912999" y="381381"/>
                  </a:lnTo>
                  <a:close/>
                </a:path>
                <a:path w="4074159" h="795020">
                  <a:moveTo>
                    <a:pt x="2971038" y="603758"/>
                  </a:moveTo>
                  <a:lnTo>
                    <a:pt x="2960624" y="603758"/>
                  </a:lnTo>
                  <a:lnTo>
                    <a:pt x="2960624" y="794512"/>
                  </a:lnTo>
                  <a:lnTo>
                    <a:pt x="2971038" y="794512"/>
                  </a:lnTo>
                  <a:lnTo>
                    <a:pt x="2971038" y="603758"/>
                  </a:lnTo>
                  <a:close/>
                </a:path>
                <a:path w="4074159" h="795020">
                  <a:moveTo>
                    <a:pt x="3029077" y="572008"/>
                  </a:moveTo>
                  <a:lnTo>
                    <a:pt x="3018663" y="572008"/>
                  </a:lnTo>
                  <a:lnTo>
                    <a:pt x="3018663" y="794512"/>
                  </a:lnTo>
                  <a:lnTo>
                    <a:pt x="3029077" y="794512"/>
                  </a:lnTo>
                  <a:lnTo>
                    <a:pt x="3029077" y="572008"/>
                  </a:lnTo>
                  <a:close/>
                </a:path>
                <a:path w="4074159" h="795020">
                  <a:moveTo>
                    <a:pt x="3087116" y="603758"/>
                  </a:moveTo>
                  <a:lnTo>
                    <a:pt x="3076702" y="603758"/>
                  </a:lnTo>
                  <a:lnTo>
                    <a:pt x="3076702" y="794512"/>
                  </a:lnTo>
                  <a:lnTo>
                    <a:pt x="3087116" y="794512"/>
                  </a:lnTo>
                  <a:lnTo>
                    <a:pt x="3087116" y="603758"/>
                  </a:lnTo>
                  <a:close/>
                </a:path>
                <a:path w="4074159" h="795020">
                  <a:moveTo>
                    <a:pt x="3145155" y="730885"/>
                  </a:moveTo>
                  <a:lnTo>
                    <a:pt x="3134741" y="730885"/>
                  </a:lnTo>
                  <a:lnTo>
                    <a:pt x="3134741" y="794512"/>
                  </a:lnTo>
                  <a:lnTo>
                    <a:pt x="3145155" y="794512"/>
                  </a:lnTo>
                  <a:lnTo>
                    <a:pt x="3145155" y="730885"/>
                  </a:lnTo>
                  <a:close/>
                </a:path>
                <a:path w="4074159" h="795020">
                  <a:moveTo>
                    <a:pt x="3203321" y="667385"/>
                  </a:moveTo>
                  <a:lnTo>
                    <a:pt x="3192907" y="667385"/>
                  </a:lnTo>
                  <a:lnTo>
                    <a:pt x="3192907" y="794512"/>
                  </a:lnTo>
                  <a:lnTo>
                    <a:pt x="3203321" y="794512"/>
                  </a:lnTo>
                  <a:lnTo>
                    <a:pt x="3203321" y="667385"/>
                  </a:lnTo>
                  <a:close/>
                </a:path>
                <a:path w="4074159" h="795020">
                  <a:moveTo>
                    <a:pt x="3261360" y="572008"/>
                  </a:moveTo>
                  <a:lnTo>
                    <a:pt x="3250946" y="572008"/>
                  </a:lnTo>
                  <a:lnTo>
                    <a:pt x="3250946" y="794512"/>
                  </a:lnTo>
                  <a:lnTo>
                    <a:pt x="3261360" y="794512"/>
                  </a:lnTo>
                  <a:lnTo>
                    <a:pt x="3261360" y="572008"/>
                  </a:lnTo>
                  <a:close/>
                </a:path>
                <a:path w="4074159" h="795020">
                  <a:moveTo>
                    <a:pt x="3322066" y="572008"/>
                  </a:moveTo>
                  <a:lnTo>
                    <a:pt x="3308985" y="572008"/>
                  </a:lnTo>
                  <a:lnTo>
                    <a:pt x="3308985" y="794512"/>
                  </a:lnTo>
                  <a:lnTo>
                    <a:pt x="3322066" y="794512"/>
                  </a:lnTo>
                  <a:lnTo>
                    <a:pt x="3322066" y="572008"/>
                  </a:lnTo>
                  <a:close/>
                </a:path>
                <a:path w="4074159" h="795020">
                  <a:moveTo>
                    <a:pt x="3377425" y="572008"/>
                  </a:moveTo>
                  <a:lnTo>
                    <a:pt x="3367024" y="572008"/>
                  </a:lnTo>
                  <a:lnTo>
                    <a:pt x="3367024" y="794512"/>
                  </a:lnTo>
                  <a:lnTo>
                    <a:pt x="3377425" y="794512"/>
                  </a:lnTo>
                  <a:lnTo>
                    <a:pt x="3377425" y="572008"/>
                  </a:lnTo>
                  <a:close/>
                </a:path>
                <a:path w="4074159" h="795020">
                  <a:moveTo>
                    <a:pt x="3438131" y="508508"/>
                  </a:moveTo>
                  <a:lnTo>
                    <a:pt x="3425050" y="508508"/>
                  </a:lnTo>
                  <a:lnTo>
                    <a:pt x="3425050" y="794512"/>
                  </a:lnTo>
                  <a:lnTo>
                    <a:pt x="3438131" y="794512"/>
                  </a:lnTo>
                  <a:lnTo>
                    <a:pt x="3438131" y="508508"/>
                  </a:lnTo>
                  <a:close/>
                </a:path>
                <a:path w="4074159" h="795020">
                  <a:moveTo>
                    <a:pt x="3500501" y="572008"/>
                  </a:moveTo>
                  <a:lnTo>
                    <a:pt x="3483102" y="572008"/>
                  </a:lnTo>
                  <a:lnTo>
                    <a:pt x="3483102" y="794512"/>
                  </a:lnTo>
                  <a:lnTo>
                    <a:pt x="3500501" y="794512"/>
                  </a:lnTo>
                  <a:lnTo>
                    <a:pt x="3500501" y="572008"/>
                  </a:lnTo>
                  <a:close/>
                </a:path>
                <a:path w="4074159" h="795020">
                  <a:moveTo>
                    <a:pt x="3554222" y="444881"/>
                  </a:moveTo>
                  <a:lnTo>
                    <a:pt x="3541141" y="444881"/>
                  </a:lnTo>
                  <a:lnTo>
                    <a:pt x="3541141" y="794512"/>
                  </a:lnTo>
                  <a:lnTo>
                    <a:pt x="3554222" y="794512"/>
                  </a:lnTo>
                  <a:lnTo>
                    <a:pt x="3554222" y="444881"/>
                  </a:lnTo>
                  <a:close/>
                </a:path>
                <a:path w="4074159" h="795020">
                  <a:moveTo>
                    <a:pt x="3609594" y="540258"/>
                  </a:moveTo>
                  <a:lnTo>
                    <a:pt x="3599180" y="540258"/>
                  </a:lnTo>
                  <a:lnTo>
                    <a:pt x="3599180" y="794512"/>
                  </a:lnTo>
                  <a:lnTo>
                    <a:pt x="3609594" y="794512"/>
                  </a:lnTo>
                  <a:lnTo>
                    <a:pt x="3609594" y="540258"/>
                  </a:lnTo>
                  <a:close/>
                </a:path>
                <a:path w="4074159" h="795020">
                  <a:moveTo>
                    <a:pt x="3667620" y="444881"/>
                  </a:moveTo>
                  <a:lnTo>
                    <a:pt x="3657219" y="444881"/>
                  </a:lnTo>
                  <a:lnTo>
                    <a:pt x="3657219" y="794512"/>
                  </a:lnTo>
                  <a:lnTo>
                    <a:pt x="3667620" y="794512"/>
                  </a:lnTo>
                  <a:lnTo>
                    <a:pt x="3667620" y="444881"/>
                  </a:lnTo>
                  <a:close/>
                </a:path>
                <a:path w="4074159" h="795020">
                  <a:moveTo>
                    <a:pt x="3728466" y="508508"/>
                  </a:moveTo>
                  <a:lnTo>
                    <a:pt x="3715385" y="508508"/>
                  </a:lnTo>
                  <a:lnTo>
                    <a:pt x="3715385" y="794512"/>
                  </a:lnTo>
                  <a:lnTo>
                    <a:pt x="3728466" y="794512"/>
                  </a:lnTo>
                  <a:lnTo>
                    <a:pt x="3728466" y="508508"/>
                  </a:lnTo>
                  <a:close/>
                </a:path>
                <a:path w="4074159" h="795020">
                  <a:moveTo>
                    <a:pt x="3786505" y="572008"/>
                  </a:moveTo>
                  <a:lnTo>
                    <a:pt x="3773424" y="572008"/>
                  </a:lnTo>
                  <a:lnTo>
                    <a:pt x="3773424" y="794512"/>
                  </a:lnTo>
                  <a:lnTo>
                    <a:pt x="3786505" y="794512"/>
                  </a:lnTo>
                  <a:lnTo>
                    <a:pt x="3786505" y="572008"/>
                  </a:lnTo>
                  <a:close/>
                </a:path>
                <a:path w="4074159" h="795020">
                  <a:moveTo>
                    <a:pt x="3844544" y="667385"/>
                  </a:moveTo>
                  <a:lnTo>
                    <a:pt x="3831463" y="667385"/>
                  </a:lnTo>
                  <a:lnTo>
                    <a:pt x="3831463" y="794512"/>
                  </a:lnTo>
                  <a:lnTo>
                    <a:pt x="3844544" y="794512"/>
                  </a:lnTo>
                  <a:lnTo>
                    <a:pt x="3844544" y="667385"/>
                  </a:lnTo>
                  <a:close/>
                </a:path>
                <a:path w="4074159" h="795020">
                  <a:moveTo>
                    <a:pt x="3902583" y="476631"/>
                  </a:moveTo>
                  <a:lnTo>
                    <a:pt x="3889502" y="476631"/>
                  </a:lnTo>
                  <a:lnTo>
                    <a:pt x="3889502" y="794512"/>
                  </a:lnTo>
                  <a:lnTo>
                    <a:pt x="3902583" y="794512"/>
                  </a:lnTo>
                  <a:lnTo>
                    <a:pt x="3902583" y="476631"/>
                  </a:lnTo>
                  <a:close/>
                </a:path>
                <a:path w="4074159" h="795020">
                  <a:moveTo>
                    <a:pt x="3960622" y="572008"/>
                  </a:moveTo>
                  <a:lnTo>
                    <a:pt x="3947541" y="572008"/>
                  </a:lnTo>
                  <a:lnTo>
                    <a:pt x="3947541" y="794512"/>
                  </a:lnTo>
                  <a:lnTo>
                    <a:pt x="3960622" y="794512"/>
                  </a:lnTo>
                  <a:lnTo>
                    <a:pt x="3960622" y="572008"/>
                  </a:lnTo>
                  <a:close/>
                </a:path>
                <a:path w="4074159" h="795020">
                  <a:moveTo>
                    <a:pt x="4018661" y="476631"/>
                  </a:moveTo>
                  <a:lnTo>
                    <a:pt x="4005580" y="476631"/>
                  </a:lnTo>
                  <a:lnTo>
                    <a:pt x="4005580" y="794512"/>
                  </a:lnTo>
                  <a:lnTo>
                    <a:pt x="4018661" y="794512"/>
                  </a:lnTo>
                  <a:lnTo>
                    <a:pt x="4018661" y="476631"/>
                  </a:lnTo>
                  <a:close/>
                </a:path>
                <a:path w="4074159" h="795020">
                  <a:moveTo>
                    <a:pt x="4074020" y="540258"/>
                  </a:moveTo>
                  <a:lnTo>
                    <a:pt x="4063619" y="540258"/>
                  </a:lnTo>
                  <a:lnTo>
                    <a:pt x="4063619" y="794512"/>
                  </a:lnTo>
                  <a:lnTo>
                    <a:pt x="4074020" y="794512"/>
                  </a:lnTo>
                  <a:lnTo>
                    <a:pt x="4074020" y="540258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0" name="object 110" descr=""/>
            <p:cNvSpPr/>
            <p:nvPr/>
          </p:nvSpPr>
          <p:spPr>
            <a:xfrm>
              <a:off x="13838174" y="8058531"/>
              <a:ext cx="1701164" cy="603885"/>
            </a:xfrm>
            <a:custGeom>
              <a:avLst/>
              <a:gdLst/>
              <a:ahLst/>
              <a:cxnLst/>
              <a:rect l="l" t="t" r="r" b="b"/>
              <a:pathLst>
                <a:path w="1701165" h="603884">
                  <a:moveTo>
                    <a:pt x="10401" y="349631"/>
                  </a:moveTo>
                  <a:lnTo>
                    <a:pt x="0" y="349631"/>
                  </a:lnTo>
                  <a:lnTo>
                    <a:pt x="0" y="603885"/>
                  </a:lnTo>
                  <a:lnTo>
                    <a:pt x="10401" y="603885"/>
                  </a:lnTo>
                  <a:lnTo>
                    <a:pt x="10401" y="349631"/>
                  </a:lnTo>
                  <a:close/>
                </a:path>
                <a:path w="1701165" h="603884">
                  <a:moveTo>
                    <a:pt x="68453" y="381381"/>
                  </a:moveTo>
                  <a:lnTo>
                    <a:pt x="58039" y="381381"/>
                  </a:lnTo>
                  <a:lnTo>
                    <a:pt x="58039" y="603885"/>
                  </a:lnTo>
                  <a:lnTo>
                    <a:pt x="68453" y="603885"/>
                  </a:lnTo>
                  <a:lnTo>
                    <a:pt x="68453" y="381381"/>
                  </a:lnTo>
                  <a:close/>
                </a:path>
                <a:path w="1701165" h="603884">
                  <a:moveTo>
                    <a:pt x="126492" y="254254"/>
                  </a:moveTo>
                  <a:lnTo>
                    <a:pt x="116078" y="254254"/>
                  </a:lnTo>
                  <a:lnTo>
                    <a:pt x="116078" y="603885"/>
                  </a:lnTo>
                  <a:lnTo>
                    <a:pt x="126492" y="603885"/>
                  </a:lnTo>
                  <a:lnTo>
                    <a:pt x="126492" y="254254"/>
                  </a:lnTo>
                  <a:close/>
                </a:path>
                <a:path w="1701165" h="603884">
                  <a:moveTo>
                    <a:pt x="184645" y="349631"/>
                  </a:moveTo>
                  <a:lnTo>
                    <a:pt x="174244" y="349631"/>
                  </a:lnTo>
                  <a:lnTo>
                    <a:pt x="174244" y="603885"/>
                  </a:lnTo>
                  <a:lnTo>
                    <a:pt x="184645" y="603885"/>
                  </a:lnTo>
                  <a:lnTo>
                    <a:pt x="184645" y="349631"/>
                  </a:lnTo>
                  <a:close/>
                </a:path>
                <a:path w="1701165" h="603884">
                  <a:moveTo>
                    <a:pt x="242697" y="317881"/>
                  </a:moveTo>
                  <a:lnTo>
                    <a:pt x="232283" y="317881"/>
                  </a:lnTo>
                  <a:lnTo>
                    <a:pt x="232283" y="603885"/>
                  </a:lnTo>
                  <a:lnTo>
                    <a:pt x="242697" y="603885"/>
                  </a:lnTo>
                  <a:lnTo>
                    <a:pt x="242697" y="317881"/>
                  </a:lnTo>
                  <a:close/>
                </a:path>
                <a:path w="1701165" h="603884">
                  <a:moveTo>
                    <a:pt x="300736" y="254254"/>
                  </a:moveTo>
                  <a:lnTo>
                    <a:pt x="290322" y="254254"/>
                  </a:lnTo>
                  <a:lnTo>
                    <a:pt x="290322" y="603885"/>
                  </a:lnTo>
                  <a:lnTo>
                    <a:pt x="300736" y="603885"/>
                  </a:lnTo>
                  <a:lnTo>
                    <a:pt x="300736" y="254254"/>
                  </a:lnTo>
                  <a:close/>
                </a:path>
                <a:path w="1701165" h="603884">
                  <a:moveTo>
                    <a:pt x="358775" y="0"/>
                  </a:moveTo>
                  <a:lnTo>
                    <a:pt x="348361" y="0"/>
                  </a:lnTo>
                  <a:lnTo>
                    <a:pt x="348361" y="603885"/>
                  </a:lnTo>
                  <a:lnTo>
                    <a:pt x="358775" y="603885"/>
                  </a:lnTo>
                  <a:lnTo>
                    <a:pt x="358775" y="0"/>
                  </a:lnTo>
                  <a:close/>
                </a:path>
                <a:path w="1701165" h="603884">
                  <a:moveTo>
                    <a:pt x="416801" y="222504"/>
                  </a:moveTo>
                  <a:lnTo>
                    <a:pt x="406400" y="222504"/>
                  </a:lnTo>
                  <a:lnTo>
                    <a:pt x="406400" y="603885"/>
                  </a:lnTo>
                  <a:lnTo>
                    <a:pt x="416801" y="603885"/>
                  </a:lnTo>
                  <a:lnTo>
                    <a:pt x="416801" y="222504"/>
                  </a:lnTo>
                  <a:close/>
                </a:path>
                <a:path w="1701165" h="603884">
                  <a:moveTo>
                    <a:pt x="477520" y="445008"/>
                  </a:moveTo>
                  <a:lnTo>
                    <a:pt x="464439" y="445008"/>
                  </a:lnTo>
                  <a:lnTo>
                    <a:pt x="464439" y="603885"/>
                  </a:lnTo>
                  <a:lnTo>
                    <a:pt x="477520" y="603885"/>
                  </a:lnTo>
                  <a:lnTo>
                    <a:pt x="477520" y="445008"/>
                  </a:lnTo>
                  <a:close/>
                </a:path>
                <a:path w="1701165" h="603884">
                  <a:moveTo>
                    <a:pt x="539864" y="508508"/>
                  </a:moveTo>
                  <a:lnTo>
                    <a:pt x="522478" y="508508"/>
                  </a:lnTo>
                  <a:lnTo>
                    <a:pt x="522478" y="603885"/>
                  </a:lnTo>
                  <a:lnTo>
                    <a:pt x="539864" y="603885"/>
                  </a:lnTo>
                  <a:lnTo>
                    <a:pt x="539864" y="508508"/>
                  </a:lnTo>
                  <a:close/>
                </a:path>
                <a:path w="1701165" h="603884">
                  <a:moveTo>
                    <a:pt x="593598" y="413131"/>
                  </a:moveTo>
                  <a:lnTo>
                    <a:pt x="580517" y="413131"/>
                  </a:lnTo>
                  <a:lnTo>
                    <a:pt x="580517" y="603885"/>
                  </a:lnTo>
                  <a:lnTo>
                    <a:pt x="593598" y="603885"/>
                  </a:lnTo>
                  <a:lnTo>
                    <a:pt x="593598" y="413131"/>
                  </a:lnTo>
                  <a:close/>
                </a:path>
                <a:path w="1701165" h="603884">
                  <a:moveTo>
                    <a:pt x="648970" y="540258"/>
                  </a:moveTo>
                  <a:lnTo>
                    <a:pt x="638556" y="540258"/>
                  </a:lnTo>
                  <a:lnTo>
                    <a:pt x="638556" y="603885"/>
                  </a:lnTo>
                  <a:lnTo>
                    <a:pt x="648970" y="603885"/>
                  </a:lnTo>
                  <a:lnTo>
                    <a:pt x="648970" y="540258"/>
                  </a:lnTo>
                  <a:close/>
                </a:path>
                <a:path w="1701165" h="603884">
                  <a:moveTo>
                    <a:pt x="707009" y="317881"/>
                  </a:moveTo>
                  <a:lnTo>
                    <a:pt x="696595" y="317881"/>
                  </a:lnTo>
                  <a:lnTo>
                    <a:pt x="696595" y="603885"/>
                  </a:lnTo>
                  <a:lnTo>
                    <a:pt x="707009" y="603885"/>
                  </a:lnTo>
                  <a:lnTo>
                    <a:pt x="707009" y="317881"/>
                  </a:lnTo>
                  <a:close/>
                </a:path>
                <a:path w="1701165" h="603884">
                  <a:moveTo>
                    <a:pt x="772147" y="508508"/>
                  </a:moveTo>
                  <a:lnTo>
                    <a:pt x="754761" y="508508"/>
                  </a:lnTo>
                  <a:lnTo>
                    <a:pt x="754761" y="603885"/>
                  </a:lnTo>
                  <a:lnTo>
                    <a:pt x="772147" y="603885"/>
                  </a:lnTo>
                  <a:lnTo>
                    <a:pt x="772147" y="508508"/>
                  </a:lnTo>
                  <a:close/>
                </a:path>
                <a:path w="1701165" h="603884">
                  <a:moveTo>
                    <a:pt x="825868" y="445008"/>
                  </a:moveTo>
                  <a:lnTo>
                    <a:pt x="812800" y="445008"/>
                  </a:lnTo>
                  <a:lnTo>
                    <a:pt x="812800" y="603885"/>
                  </a:lnTo>
                  <a:lnTo>
                    <a:pt x="825868" y="603885"/>
                  </a:lnTo>
                  <a:lnTo>
                    <a:pt x="825868" y="445008"/>
                  </a:lnTo>
                  <a:close/>
                </a:path>
                <a:path w="1701165" h="603884">
                  <a:moveTo>
                    <a:pt x="881253" y="476758"/>
                  </a:moveTo>
                  <a:lnTo>
                    <a:pt x="870839" y="476758"/>
                  </a:lnTo>
                  <a:lnTo>
                    <a:pt x="870839" y="603885"/>
                  </a:lnTo>
                  <a:lnTo>
                    <a:pt x="881253" y="603885"/>
                  </a:lnTo>
                  <a:lnTo>
                    <a:pt x="881253" y="476758"/>
                  </a:lnTo>
                  <a:close/>
                </a:path>
                <a:path w="1701165" h="603884">
                  <a:moveTo>
                    <a:pt x="941959" y="445008"/>
                  </a:moveTo>
                  <a:lnTo>
                    <a:pt x="928878" y="445008"/>
                  </a:lnTo>
                  <a:lnTo>
                    <a:pt x="928878" y="603885"/>
                  </a:lnTo>
                  <a:lnTo>
                    <a:pt x="941959" y="603885"/>
                  </a:lnTo>
                  <a:lnTo>
                    <a:pt x="941959" y="445008"/>
                  </a:lnTo>
                  <a:close/>
                </a:path>
                <a:path w="1701165" h="603884">
                  <a:moveTo>
                    <a:pt x="997318" y="317881"/>
                  </a:moveTo>
                  <a:lnTo>
                    <a:pt x="986917" y="317881"/>
                  </a:lnTo>
                  <a:lnTo>
                    <a:pt x="986917" y="603885"/>
                  </a:lnTo>
                  <a:lnTo>
                    <a:pt x="997318" y="603885"/>
                  </a:lnTo>
                  <a:lnTo>
                    <a:pt x="997318" y="317881"/>
                  </a:lnTo>
                  <a:close/>
                </a:path>
                <a:path w="1701165" h="603884">
                  <a:moveTo>
                    <a:pt x="1062355" y="508508"/>
                  </a:moveTo>
                  <a:lnTo>
                    <a:pt x="1044956" y="508508"/>
                  </a:lnTo>
                  <a:lnTo>
                    <a:pt x="1044956" y="603885"/>
                  </a:lnTo>
                  <a:lnTo>
                    <a:pt x="1062355" y="603885"/>
                  </a:lnTo>
                  <a:lnTo>
                    <a:pt x="1062355" y="508508"/>
                  </a:lnTo>
                  <a:close/>
                </a:path>
                <a:path w="1701165" h="603884">
                  <a:moveTo>
                    <a:pt x="1116076" y="508508"/>
                  </a:moveTo>
                  <a:lnTo>
                    <a:pt x="1102995" y="508508"/>
                  </a:lnTo>
                  <a:lnTo>
                    <a:pt x="1102995" y="603885"/>
                  </a:lnTo>
                  <a:lnTo>
                    <a:pt x="1116076" y="603885"/>
                  </a:lnTo>
                  <a:lnTo>
                    <a:pt x="1116076" y="508508"/>
                  </a:lnTo>
                  <a:close/>
                </a:path>
                <a:path w="1701165" h="603884">
                  <a:moveTo>
                    <a:pt x="1174115" y="540258"/>
                  </a:moveTo>
                  <a:lnTo>
                    <a:pt x="1161034" y="540258"/>
                  </a:lnTo>
                  <a:lnTo>
                    <a:pt x="1161034" y="603885"/>
                  </a:lnTo>
                  <a:lnTo>
                    <a:pt x="1174115" y="603885"/>
                  </a:lnTo>
                  <a:lnTo>
                    <a:pt x="1174115" y="540258"/>
                  </a:lnTo>
                  <a:close/>
                </a:path>
                <a:path w="1701165" h="603884">
                  <a:moveTo>
                    <a:pt x="1236459" y="317881"/>
                  </a:moveTo>
                  <a:lnTo>
                    <a:pt x="1219073" y="317881"/>
                  </a:lnTo>
                  <a:lnTo>
                    <a:pt x="1219073" y="603885"/>
                  </a:lnTo>
                  <a:lnTo>
                    <a:pt x="1236459" y="603885"/>
                  </a:lnTo>
                  <a:lnTo>
                    <a:pt x="1236459" y="317881"/>
                  </a:lnTo>
                  <a:close/>
                </a:path>
                <a:path w="1701165" h="603884">
                  <a:moveTo>
                    <a:pt x="1290320" y="413131"/>
                  </a:moveTo>
                  <a:lnTo>
                    <a:pt x="1277239" y="413131"/>
                  </a:lnTo>
                  <a:lnTo>
                    <a:pt x="1277239" y="603885"/>
                  </a:lnTo>
                  <a:lnTo>
                    <a:pt x="1290320" y="603885"/>
                  </a:lnTo>
                  <a:lnTo>
                    <a:pt x="1290320" y="413131"/>
                  </a:lnTo>
                  <a:close/>
                </a:path>
                <a:path w="1701165" h="603884">
                  <a:moveTo>
                    <a:pt x="1348359" y="413131"/>
                  </a:moveTo>
                  <a:lnTo>
                    <a:pt x="1335278" y="413131"/>
                  </a:lnTo>
                  <a:lnTo>
                    <a:pt x="1335278" y="603885"/>
                  </a:lnTo>
                  <a:lnTo>
                    <a:pt x="1348359" y="603885"/>
                  </a:lnTo>
                  <a:lnTo>
                    <a:pt x="1348359" y="413131"/>
                  </a:lnTo>
                  <a:close/>
                </a:path>
                <a:path w="1701165" h="603884">
                  <a:moveTo>
                    <a:pt x="1419466" y="445008"/>
                  </a:moveTo>
                  <a:lnTo>
                    <a:pt x="1393317" y="445008"/>
                  </a:lnTo>
                  <a:lnTo>
                    <a:pt x="1393317" y="603885"/>
                  </a:lnTo>
                  <a:lnTo>
                    <a:pt x="1419466" y="603885"/>
                  </a:lnTo>
                  <a:lnTo>
                    <a:pt x="1419466" y="445008"/>
                  </a:lnTo>
                  <a:close/>
                </a:path>
                <a:path w="1701165" h="603884">
                  <a:moveTo>
                    <a:pt x="1464437" y="445008"/>
                  </a:moveTo>
                  <a:lnTo>
                    <a:pt x="1451356" y="445008"/>
                  </a:lnTo>
                  <a:lnTo>
                    <a:pt x="1451356" y="603885"/>
                  </a:lnTo>
                  <a:lnTo>
                    <a:pt x="1464437" y="603885"/>
                  </a:lnTo>
                  <a:lnTo>
                    <a:pt x="1464437" y="445008"/>
                  </a:lnTo>
                  <a:close/>
                </a:path>
                <a:path w="1701165" h="603884">
                  <a:moveTo>
                    <a:pt x="1522476" y="445008"/>
                  </a:moveTo>
                  <a:lnTo>
                    <a:pt x="1509395" y="445008"/>
                  </a:lnTo>
                  <a:lnTo>
                    <a:pt x="1509395" y="603885"/>
                  </a:lnTo>
                  <a:lnTo>
                    <a:pt x="1522476" y="603885"/>
                  </a:lnTo>
                  <a:lnTo>
                    <a:pt x="1522476" y="445008"/>
                  </a:lnTo>
                  <a:close/>
                </a:path>
                <a:path w="1701165" h="603884">
                  <a:moveTo>
                    <a:pt x="1584820" y="572135"/>
                  </a:moveTo>
                  <a:lnTo>
                    <a:pt x="1567434" y="572135"/>
                  </a:lnTo>
                  <a:lnTo>
                    <a:pt x="1567434" y="603885"/>
                  </a:lnTo>
                  <a:lnTo>
                    <a:pt x="1584820" y="603885"/>
                  </a:lnTo>
                  <a:lnTo>
                    <a:pt x="1584820" y="572135"/>
                  </a:lnTo>
                  <a:close/>
                </a:path>
                <a:path w="1701165" h="603884">
                  <a:moveTo>
                    <a:pt x="1642859" y="349631"/>
                  </a:moveTo>
                  <a:lnTo>
                    <a:pt x="1625473" y="349631"/>
                  </a:lnTo>
                  <a:lnTo>
                    <a:pt x="1625473" y="603885"/>
                  </a:lnTo>
                  <a:lnTo>
                    <a:pt x="1642859" y="603885"/>
                  </a:lnTo>
                  <a:lnTo>
                    <a:pt x="1642859" y="349631"/>
                  </a:lnTo>
                  <a:close/>
                </a:path>
                <a:path w="1701165" h="603884">
                  <a:moveTo>
                    <a:pt x="1700911" y="508508"/>
                  </a:moveTo>
                  <a:lnTo>
                    <a:pt x="1683512" y="508508"/>
                  </a:lnTo>
                  <a:lnTo>
                    <a:pt x="1683512" y="603885"/>
                  </a:lnTo>
                  <a:lnTo>
                    <a:pt x="1700911" y="603885"/>
                  </a:lnTo>
                  <a:lnTo>
                    <a:pt x="1700911" y="508508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1" name="object 111" descr=""/>
            <p:cNvSpPr/>
            <p:nvPr/>
          </p:nvSpPr>
          <p:spPr>
            <a:xfrm>
              <a:off x="1124712" y="7136892"/>
              <a:ext cx="4084954" cy="1525905"/>
            </a:xfrm>
            <a:custGeom>
              <a:avLst/>
              <a:gdLst/>
              <a:ahLst/>
              <a:cxnLst/>
              <a:rect l="l" t="t" r="r" b="b"/>
              <a:pathLst>
                <a:path w="4084954" h="1525904">
                  <a:moveTo>
                    <a:pt x="13081" y="1461897"/>
                  </a:moveTo>
                  <a:lnTo>
                    <a:pt x="0" y="1461897"/>
                  </a:lnTo>
                  <a:lnTo>
                    <a:pt x="0" y="1525524"/>
                  </a:lnTo>
                  <a:lnTo>
                    <a:pt x="13081" y="1525524"/>
                  </a:lnTo>
                  <a:lnTo>
                    <a:pt x="13081" y="1461897"/>
                  </a:lnTo>
                  <a:close/>
                </a:path>
                <a:path w="4084954" h="1525904">
                  <a:moveTo>
                    <a:pt x="71120" y="1461897"/>
                  </a:moveTo>
                  <a:lnTo>
                    <a:pt x="58039" y="1461897"/>
                  </a:lnTo>
                  <a:lnTo>
                    <a:pt x="58039" y="1525524"/>
                  </a:lnTo>
                  <a:lnTo>
                    <a:pt x="71120" y="1525524"/>
                  </a:lnTo>
                  <a:lnTo>
                    <a:pt x="71120" y="1461897"/>
                  </a:lnTo>
                  <a:close/>
                </a:path>
                <a:path w="4084954" h="1525904">
                  <a:moveTo>
                    <a:pt x="129159" y="1303020"/>
                  </a:moveTo>
                  <a:lnTo>
                    <a:pt x="116078" y="1303020"/>
                  </a:lnTo>
                  <a:lnTo>
                    <a:pt x="116078" y="1525524"/>
                  </a:lnTo>
                  <a:lnTo>
                    <a:pt x="129159" y="1525524"/>
                  </a:lnTo>
                  <a:lnTo>
                    <a:pt x="129159" y="1303020"/>
                  </a:lnTo>
                  <a:close/>
                </a:path>
                <a:path w="4084954" h="1525904">
                  <a:moveTo>
                    <a:pt x="187198" y="1461897"/>
                  </a:moveTo>
                  <a:lnTo>
                    <a:pt x="174117" y="1461897"/>
                  </a:lnTo>
                  <a:lnTo>
                    <a:pt x="174117" y="1525524"/>
                  </a:lnTo>
                  <a:lnTo>
                    <a:pt x="187198" y="1525524"/>
                  </a:lnTo>
                  <a:lnTo>
                    <a:pt x="187198" y="1461897"/>
                  </a:lnTo>
                  <a:close/>
                </a:path>
                <a:path w="4084954" h="1525904">
                  <a:moveTo>
                    <a:pt x="245237" y="1334770"/>
                  </a:moveTo>
                  <a:lnTo>
                    <a:pt x="232156" y="1334770"/>
                  </a:lnTo>
                  <a:lnTo>
                    <a:pt x="232156" y="1525524"/>
                  </a:lnTo>
                  <a:lnTo>
                    <a:pt x="245237" y="1525524"/>
                  </a:lnTo>
                  <a:lnTo>
                    <a:pt x="245237" y="1334770"/>
                  </a:lnTo>
                  <a:close/>
                </a:path>
                <a:path w="4084954" h="1525904">
                  <a:moveTo>
                    <a:pt x="303276" y="1493774"/>
                  </a:moveTo>
                  <a:lnTo>
                    <a:pt x="290195" y="1493774"/>
                  </a:lnTo>
                  <a:lnTo>
                    <a:pt x="290195" y="1525524"/>
                  </a:lnTo>
                  <a:lnTo>
                    <a:pt x="303276" y="1525524"/>
                  </a:lnTo>
                  <a:lnTo>
                    <a:pt x="303276" y="1493774"/>
                  </a:lnTo>
                  <a:close/>
                </a:path>
                <a:path w="4084954" h="1525904">
                  <a:moveTo>
                    <a:pt x="361315" y="1398397"/>
                  </a:moveTo>
                  <a:lnTo>
                    <a:pt x="348234" y="1398397"/>
                  </a:lnTo>
                  <a:lnTo>
                    <a:pt x="348234" y="1525524"/>
                  </a:lnTo>
                  <a:lnTo>
                    <a:pt x="361315" y="1525524"/>
                  </a:lnTo>
                  <a:lnTo>
                    <a:pt x="361315" y="1398397"/>
                  </a:lnTo>
                  <a:close/>
                </a:path>
                <a:path w="4084954" h="1525904">
                  <a:moveTo>
                    <a:pt x="427215" y="1398397"/>
                  </a:moveTo>
                  <a:lnTo>
                    <a:pt x="416814" y="1398397"/>
                  </a:lnTo>
                  <a:lnTo>
                    <a:pt x="416814" y="1525524"/>
                  </a:lnTo>
                  <a:lnTo>
                    <a:pt x="427215" y="1525524"/>
                  </a:lnTo>
                  <a:lnTo>
                    <a:pt x="427215" y="1398397"/>
                  </a:lnTo>
                  <a:close/>
                </a:path>
                <a:path w="4084954" h="1525904">
                  <a:moveTo>
                    <a:pt x="477520" y="1398397"/>
                  </a:moveTo>
                  <a:lnTo>
                    <a:pt x="464439" y="1398397"/>
                  </a:lnTo>
                  <a:lnTo>
                    <a:pt x="464439" y="1525524"/>
                  </a:lnTo>
                  <a:lnTo>
                    <a:pt x="477520" y="1525524"/>
                  </a:lnTo>
                  <a:lnTo>
                    <a:pt x="477520" y="1398397"/>
                  </a:lnTo>
                  <a:close/>
                </a:path>
                <a:path w="4084954" h="1525904">
                  <a:moveTo>
                    <a:pt x="543306" y="1398397"/>
                  </a:moveTo>
                  <a:lnTo>
                    <a:pt x="532892" y="1398397"/>
                  </a:lnTo>
                  <a:lnTo>
                    <a:pt x="532892" y="1525524"/>
                  </a:lnTo>
                  <a:lnTo>
                    <a:pt x="543306" y="1525524"/>
                  </a:lnTo>
                  <a:lnTo>
                    <a:pt x="543306" y="1398397"/>
                  </a:lnTo>
                  <a:close/>
                </a:path>
                <a:path w="4084954" h="1525904">
                  <a:moveTo>
                    <a:pt x="601345" y="1461897"/>
                  </a:moveTo>
                  <a:lnTo>
                    <a:pt x="590931" y="1461897"/>
                  </a:lnTo>
                  <a:lnTo>
                    <a:pt x="590931" y="1525524"/>
                  </a:lnTo>
                  <a:lnTo>
                    <a:pt x="601345" y="1525524"/>
                  </a:lnTo>
                  <a:lnTo>
                    <a:pt x="601345" y="1461897"/>
                  </a:lnTo>
                  <a:close/>
                </a:path>
                <a:path w="4084954" h="1525904">
                  <a:moveTo>
                    <a:pt x="659384" y="1175893"/>
                  </a:moveTo>
                  <a:lnTo>
                    <a:pt x="648970" y="1175893"/>
                  </a:lnTo>
                  <a:lnTo>
                    <a:pt x="648970" y="1525524"/>
                  </a:lnTo>
                  <a:lnTo>
                    <a:pt x="659384" y="1525524"/>
                  </a:lnTo>
                  <a:lnTo>
                    <a:pt x="659384" y="1175893"/>
                  </a:lnTo>
                  <a:close/>
                </a:path>
                <a:path w="4084954" h="1525904">
                  <a:moveTo>
                    <a:pt x="717410" y="667385"/>
                  </a:moveTo>
                  <a:lnTo>
                    <a:pt x="707009" y="667385"/>
                  </a:lnTo>
                  <a:lnTo>
                    <a:pt x="707009" y="1525524"/>
                  </a:lnTo>
                  <a:lnTo>
                    <a:pt x="717410" y="1525524"/>
                  </a:lnTo>
                  <a:lnTo>
                    <a:pt x="717410" y="667385"/>
                  </a:lnTo>
                  <a:close/>
                </a:path>
                <a:path w="4084954" h="1525904">
                  <a:moveTo>
                    <a:pt x="775462" y="635635"/>
                  </a:moveTo>
                  <a:lnTo>
                    <a:pt x="765048" y="635635"/>
                  </a:lnTo>
                  <a:lnTo>
                    <a:pt x="765048" y="1525524"/>
                  </a:lnTo>
                  <a:lnTo>
                    <a:pt x="775462" y="1525524"/>
                  </a:lnTo>
                  <a:lnTo>
                    <a:pt x="775462" y="635635"/>
                  </a:lnTo>
                  <a:close/>
                </a:path>
                <a:path w="4084954" h="1525904">
                  <a:moveTo>
                    <a:pt x="833628" y="762762"/>
                  </a:moveTo>
                  <a:lnTo>
                    <a:pt x="823214" y="762762"/>
                  </a:lnTo>
                  <a:lnTo>
                    <a:pt x="823214" y="1525524"/>
                  </a:lnTo>
                  <a:lnTo>
                    <a:pt x="833628" y="1525524"/>
                  </a:lnTo>
                  <a:lnTo>
                    <a:pt x="833628" y="762762"/>
                  </a:lnTo>
                  <a:close/>
                </a:path>
                <a:path w="4084954" h="1525904">
                  <a:moveTo>
                    <a:pt x="891654" y="413131"/>
                  </a:moveTo>
                  <a:lnTo>
                    <a:pt x="881253" y="413131"/>
                  </a:lnTo>
                  <a:lnTo>
                    <a:pt x="881253" y="1525524"/>
                  </a:lnTo>
                  <a:lnTo>
                    <a:pt x="891654" y="1525524"/>
                  </a:lnTo>
                  <a:lnTo>
                    <a:pt x="891654" y="413131"/>
                  </a:lnTo>
                  <a:close/>
                </a:path>
                <a:path w="4084954" h="1525904">
                  <a:moveTo>
                    <a:pt x="949706" y="889889"/>
                  </a:moveTo>
                  <a:lnTo>
                    <a:pt x="939292" y="889889"/>
                  </a:lnTo>
                  <a:lnTo>
                    <a:pt x="939292" y="1525524"/>
                  </a:lnTo>
                  <a:lnTo>
                    <a:pt x="949706" y="1525524"/>
                  </a:lnTo>
                  <a:lnTo>
                    <a:pt x="949706" y="889889"/>
                  </a:lnTo>
                  <a:close/>
                </a:path>
                <a:path w="4084954" h="1525904">
                  <a:moveTo>
                    <a:pt x="1007745" y="381393"/>
                  </a:moveTo>
                  <a:lnTo>
                    <a:pt x="997331" y="381393"/>
                  </a:lnTo>
                  <a:lnTo>
                    <a:pt x="997331" y="1525524"/>
                  </a:lnTo>
                  <a:lnTo>
                    <a:pt x="1007745" y="1525524"/>
                  </a:lnTo>
                  <a:lnTo>
                    <a:pt x="1007745" y="381393"/>
                  </a:lnTo>
                  <a:close/>
                </a:path>
                <a:path w="4084954" h="1525904">
                  <a:moveTo>
                    <a:pt x="1065784" y="699135"/>
                  </a:moveTo>
                  <a:lnTo>
                    <a:pt x="1055370" y="699135"/>
                  </a:lnTo>
                  <a:lnTo>
                    <a:pt x="1055370" y="1525524"/>
                  </a:lnTo>
                  <a:lnTo>
                    <a:pt x="1065784" y="1525524"/>
                  </a:lnTo>
                  <a:lnTo>
                    <a:pt x="1065784" y="699135"/>
                  </a:lnTo>
                  <a:close/>
                </a:path>
                <a:path w="4084954" h="1525904">
                  <a:moveTo>
                    <a:pt x="1123810" y="635635"/>
                  </a:moveTo>
                  <a:lnTo>
                    <a:pt x="1113409" y="635635"/>
                  </a:lnTo>
                  <a:lnTo>
                    <a:pt x="1113409" y="1525524"/>
                  </a:lnTo>
                  <a:lnTo>
                    <a:pt x="1123810" y="1525524"/>
                  </a:lnTo>
                  <a:lnTo>
                    <a:pt x="1123810" y="635635"/>
                  </a:lnTo>
                  <a:close/>
                </a:path>
                <a:path w="4084954" h="1525904">
                  <a:moveTo>
                    <a:pt x="1181862" y="349516"/>
                  </a:moveTo>
                  <a:lnTo>
                    <a:pt x="1171448" y="349516"/>
                  </a:lnTo>
                  <a:lnTo>
                    <a:pt x="1171448" y="1525524"/>
                  </a:lnTo>
                  <a:lnTo>
                    <a:pt x="1181862" y="1525524"/>
                  </a:lnTo>
                  <a:lnTo>
                    <a:pt x="1181862" y="349516"/>
                  </a:lnTo>
                  <a:close/>
                </a:path>
                <a:path w="4084954" h="1525904">
                  <a:moveTo>
                    <a:pt x="1239901" y="667385"/>
                  </a:moveTo>
                  <a:lnTo>
                    <a:pt x="1229487" y="667385"/>
                  </a:lnTo>
                  <a:lnTo>
                    <a:pt x="1229487" y="1525524"/>
                  </a:lnTo>
                  <a:lnTo>
                    <a:pt x="1239901" y="1525524"/>
                  </a:lnTo>
                  <a:lnTo>
                    <a:pt x="1239901" y="667385"/>
                  </a:lnTo>
                  <a:close/>
                </a:path>
                <a:path w="4084954" h="1525904">
                  <a:moveTo>
                    <a:pt x="1297940" y="254266"/>
                  </a:moveTo>
                  <a:lnTo>
                    <a:pt x="1287526" y="254266"/>
                  </a:lnTo>
                  <a:lnTo>
                    <a:pt x="1287526" y="1525524"/>
                  </a:lnTo>
                  <a:lnTo>
                    <a:pt x="1297940" y="1525524"/>
                  </a:lnTo>
                  <a:lnTo>
                    <a:pt x="1297940" y="254266"/>
                  </a:lnTo>
                  <a:close/>
                </a:path>
                <a:path w="4084954" h="1525904">
                  <a:moveTo>
                    <a:pt x="1356106" y="858139"/>
                  </a:moveTo>
                  <a:lnTo>
                    <a:pt x="1345692" y="858139"/>
                  </a:lnTo>
                  <a:lnTo>
                    <a:pt x="1345692" y="1525524"/>
                  </a:lnTo>
                  <a:lnTo>
                    <a:pt x="1356106" y="1525524"/>
                  </a:lnTo>
                  <a:lnTo>
                    <a:pt x="1356106" y="858139"/>
                  </a:lnTo>
                  <a:close/>
                </a:path>
                <a:path w="4084954" h="1525904">
                  <a:moveTo>
                    <a:pt x="1414145" y="731012"/>
                  </a:moveTo>
                  <a:lnTo>
                    <a:pt x="1403731" y="731012"/>
                  </a:lnTo>
                  <a:lnTo>
                    <a:pt x="1403731" y="1525524"/>
                  </a:lnTo>
                  <a:lnTo>
                    <a:pt x="1414145" y="1525524"/>
                  </a:lnTo>
                  <a:lnTo>
                    <a:pt x="1414145" y="731012"/>
                  </a:lnTo>
                  <a:close/>
                </a:path>
                <a:path w="4084954" h="1525904">
                  <a:moveTo>
                    <a:pt x="1472184" y="317766"/>
                  </a:moveTo>
                  <a:lnTo>
                    <a:pt x="1461770" y="317766"/>
                  </a:lnTo>
                  <a:lnTo>
                    <a:pt x="1461770" y="1525524"/>
                  </a:lnTo>
                  <a:lnTo>
                    <a:pt x="1472184" y="1525524"/>
                  </a:lnTo>
                  <a:lnTo>
                    <a:pt x="1472184" y="317766"/>
                  </a:lnTo>
                  <a:close/>
                </a:path>
                <a:path w="4084954" h="1525904">
                  <a:moveTo>
                    <a:pt x="1530210" y="540258"/>
                  </a:moveTo>
                  <a:lnTo>
                    <a:pt x="1519809" y="540258"/>
                  </a:lnTo>
                  <a:lnTo>
                    <a:pt x="1519809" y="1525524"/>
                  </a:lnTo>
                  <a:lnTo>
                    <a:pt x="1530210" y="1525524"/>
                  </a:lnTo>
                  <a:lnTo>
                    <a:pt x="1530210" y="540258"/>
                  </a:lnTo>
                  <a:close/>
                </a:path>
                <a:path w="4084954" h="1525904">
                  <a:moveTo>
                    <a:pt x="1588262" y="508508"/>
                  </a:moveTo>
                  <a:lnTo>
                    <a:pt x="1577848" y="508508"/>
                  </a:lnTo>
                  <a:lnTo>
                    <a:pt x="1577848" y="1525524"/>
                  </a:lnTo>
                  <a:lnTo>
                    <a:pt x="1588262" y="1525524"/>
                  </a:lnTo>
                  <a:lnTo>
                    <a:pt x="1588262" y="508508"/>
                  </a:lnTo>
                  <a:close/>
                </a:path>
                <a:path w="4084954" h="1525904">
                  <a:moveTo>
                    <a:pt x="1646301" y="603885"/>
                  </a:moveTo>
                  <a:lnTo>
                    <a:pt x="1635887" y="603885"/>
                  </a:lnTo>
                  <a:lnTo>
                    <a:pt x="1635887" y="1525524"/>
                  </a:lnTo>
                  <a:lnTo>
                    <a:pt x="1646301" y="1525524"/>
                  </a:lnTo>
                  <a:lnTo>
                    <a:pt x="1646301" y="603885"/>
                  </a:lnTo>
                  <a:close/>
                </a:path>
                <a:path w="4084954" h="1525904">
                  <a:moveTo>
                    <a:pt x="1704340" y="953389"/>
                  </a:moveTo>
                  <a:lnTo>
                    <a:pt x="1693926" y="953389"/>
                  </a:lnTo>
                  <a:lnTo>
                    <a:pt x="1693926" y="1525524"/>
                  </a:lnTo>
                  <a:lnTo>
                    <a:pt x="1704340" y="1525524"/>
                  </a:lnTo>
                  <a:lnTo>
                    <a:pt x="1704340" y="953389"/>
                  </a:lnTo>
                  <a:close/>
                </a:path>
                <a:path w="4084954" h="1525904">
                  <a:moveTo>
                    <a:pt x="1762366" y="540258"/>
                  </a:moveTo>
                  <a:lnTo>
                    <a:pt x="1751965" y="540258"/>
                  </a:lnTo>
                  <a:lnTo>
                    <a:pt x="1751965" y="1525524"/>
                  </a:lnTo>
                  <a:lnTo>
                    <a:pt x="1762366" y="1525524"/>
                  </a:lnTo>
                  <a:lnTo>
                    <a:pt x="1762366" y="540258"/>
                  </a:lnTo>
                  <a:close/>
                </a:path>
                <a:path w="4084954" h="1525904">
                  <a:moveTo>
                    <a:pt x="1820418" y="444881"/>
                  </a:moveTo>
                  <a:lnTo>
                    <a:pt x="1810004" y="444881"/>
                  </a:lnTo>
                  <a:lnTo>
                    <a:pt x="1810004" y="1525524"/>
                  </a:lnTo>
                  <a:lnTo>
                    <a:pt x="1820418" y="1525524"/>
                  </a:lnTo>
                  <a:lnTo>
                    <a:pt x="1820418" y="444881"/>
                  </a:lnTo>
                  <a:close/>
                </a:path>
                <a:path w="4084954" h="1525904">
                  <a:moveTo>
                    <a:pt x="1878584" y="286016"/>
                  </a:moveTo>
                  <a:lnTo>
                    <a:pt x="1868170" y="286016"/>
                  </a:lnTo>
                  <a:lnTo>
                    <a:pt x="1868170" y="1525524"/>
                  </a:lnTo>
                  <a:lnTo>
                    <a:pt x="1878584" y="1525524"/>
                  </a:lnTo>
                  <a:lnTo>
                    <a:pt x="1878584" y="286016"/>
                  </a:lnTo>
                  <a:close/>
                </a:path>
                <a:path w="4084954" h="1525904">
                  <a:moveTo>
                    <a:pt x="1936610" y="190627"/>
                  </a:moveTo>
                  <a:lnTo>
                    <a:pt x="1926209" y="190627"/>
                  </a:lnTo>
                  <a:lnTo>
                    <a:pt x="1926209" y="1525524"/>
                  </a:lnTo>
                  <a:lnTo>
                    <a:pt x="1936610" y="1525524"/>
                  </a:lnTo>
                  <a:lnTo>
                    <a:pt x="1936610" y="190627"/>
                  </a:lnTo>
                  <a:close/>
                </a:path>
                <a:path w="4084954" h="1525904">
                  <a:moveTo>
                    <a:pt x="1994662" y="540258"/>
                  </a:moveTo>
                  <a:lnTo>
                    <a:pt x="1984248" y="540258"/>
                  </a:lnTo>
                  <a:lnTo>
                    <a:pt x="1984248" y="1525524"/>
                  </a:lnTo>
                  <a:lnTo>
                    <a:pt x="1994662" y="1525524"/>
                  </a:lnTo>
                  <a:lnTo>
                    <a:pt x="1994662" y="540258"/>
                  </a:lnTo>
                  <a:close/>
                </a:path>
                <a:path w="4084954" h="1525904">
                  <a:moveTo>
                    <a:pt x="2052701" y="1080516"/>
                  </a:moveTo>
                  <a:lnTo>
                    <a:pt x="2042287" y="1080516"/>
                  </a:lnTo>
                  <a:lnTo>
                    <a:pt x="2042287" y="1525524"/>
                  </a:lnTo>
                  <a:lnTo>
                    <a:pt x="2052701" y="1525524"/>
                  </a:lnTo>
                  <a:lnTo>
                    <a:pt x="2052701" y="1080516"/>
                  </a:lnTo>
                  <a:close/>
                </a:path>
                <a:path w="4084954" h="1525904">
                  <a:moveTo>
                    <a:pt x="2110740" y="889889"/>
                  </a:moveTo>
                  <a:lnTo>
                    <a:pt x="2100326" y="889889"/>
                  </a:lnTo>
                  <a:lnTo>
                    <a:pt x="2100326" y="1525524"/>
                  </a:lnTo>
                  <a:lnTo>
                    <a:pt x="2110740" y="1525524"/>
                  </a:lnTo>
                  <a:lnTo>
                    <a:pt x="2110740" y="889889"/>
                  </a:lnTo>
                  <a:close/>
                </a:path>
                <a:path w="4084954" h="1525904">
                  <a:moveTo>
                    <a:pt x="2168766" y="476631"/>
                  </a:moveTo>
                  <a:lnTo>
                    <a:pt x="2158365" y="476631"/>
                  </a:lnTo>
                  <a:lnTo>
                    <a:pt x="2158365" y="1525524"/>
                  </a:lnTo>
                  <a:lnTo>
                    <a:pt x="2168766" y="1525524"/>
                  </a:lnTo>
                  <a:lnTo>
                    <a:pt x="2168766" y="476631"/>
                  </a:lnTo>
                  <a:close/>
                </a:path>
                <a:path w="4084954" h="1525904">
                  <a:moveTo>
                    <a:pt x="2226818" y="444881"/>
                  </a:moveTo>
                  <a:lnTo>
                    <a:pt x="2216404" y="444881"/>
                  </a:lnTo>
                  <a:lnTo>
                    <a:pt x="2216404" y="1525524"/>
                  </a:lnTo>
                  <a:lnTo>
                    <a:pt x="2226818" y="1525524"/>
                  </a:lnTo>
                  <a:lnTo>
                    <a:pt x="2226818" y="444881"/>
                  </a:lnTo>
                  <a:close/>
                </a:path>
                <a:path w="4084954" h="1525904">
                  <a:moveTo>
                    <a:pt x="2284844" y="254266"/>
                  </a:moveTo>
                  <a:lnTo>
                    <a:pt x="2274443" y="254266"/>
                  </a:lnTo>
                  <a:lnTo>
                    <a:pt x="2274443" y="1525524"/>
                  </a:lnTo>
                  <a:lnTo>
                    <a:pt x="2284844" y="1525524"/>
                  </a:lnTo>
                  <a:lnTo>
                    <a:pt x="2284844" y="254266"/>
                  </a:lnTo>
                  <a:close/>
                </a:path>
                <a:path w="4084954" h="1525904">
                  <a:moveTo>
                    <a:pt x="2342896" y="953389"/>
                  </a:moveTo>
                  <a:lnTo>
                    <a:pt x="2332482" y="953389"/>
                  </a:lnTo>
                  <a:lnTo>
                    <a:pt x="2332482" y="1525524"/>
                  </a:lnTo>
                  <a:lnTo>
                    <a:pt x="2342896" y="1525524"/>
                  </a:lnTo>
                  <a:lnTo>
                    <a:pt x="2342896" y="953389"/>
                  </a:lnTo>
                  <a:close/>
                </a:path>
                <a:path w="4084954" h="1525904">
                  <a:moveTo>
                    <a:pt x="2400935" y="699135"/>
                  </a:moveTo>
                  <a:lnTo>
                    <a:pt x="2390521" y="699135"/>
                  </a:lnTo>
                  <a:lnTo>
                    <a:pt x="2390521" y="1525524"/>
                  </a:lnTo>
                  <a:lnTo>
                    <a:pt x="2400935" y="1525524"/>
                  </a:lnTo>
                  <a:lnTo>
                    <a:pt x="2400935" y="699135"/>
                  </a:lnTo>
                  <a:close/>
                </a:path>
                <a:path w="4084954" h="1525904">
                  <a:moveTo>
                    <a:pt x="2459101" y="985266"/>
                  </a:moveTo>
                  <a:lnTo>
                    <a:pt x="2448687" y="985266"/>
                  </a:lnTo>
                  <a:lnTo>
                    <a:pt x="2448687" y="1525524"/>
                  </a:lnTo>
                  <a:lnTo>
                    <a:pt x="2459101" y="1525524"/>
                  </a:lnTo>
                  <a:lnTo>
                    <a:pt x="2459101" y="985266"/>
                  </a:lnTo>
                  <a:close/>
                </a:path>
                <a:path w="4084954" h="1525904">
                  <a:moveTo>
                    <a:pt x="2517140" y="476631"/>
                  </a:moveTo>
                  <a:lnTo>
                    <a:pt x="2506726" y="476631"/>
                  </a:lnTo>
                  <a:lnTo>
                    <a:pt x="2506726" y="1525524"/>
                  </a:lnTo>
                  <a:lnTo>
                    <a:pt x="2517140" y="1525524"/>
                  </a:lnTo>
                  <a:lnTo>
                    <a:pt x="2517140" y="476631"/>
                  </a:lnTo>
                  <a:close/>
                </a:path>
                <a:path w="4084954" h="1525904">
                  <a:moveTo>
                    <a:pt x="2575179" y="540258"/>
                  </a:moveTo>
                  <a:lnTo>
                    <a:pt x="2564765" y="540258"/>
                  </a:lnTo>
                  <a:lnTo>
                    <a:pt x="2564765" y="1525524"/>
                  </a:lnTo>
                  <a:lnTo>
                    <a:pt x="2575179" y="1525524"/>
                  </a:lnTo>
                  <a:lnTo>
                    <a:pt x="2575179" y="540258"/>
                  </a:lnTo>
                  <a:close/>
                </a:path>
                <a:path w="4084954" h="1525904">
                  <a:moveTo>
                    <a:pt x="2633218" y="381393"/>
                  </a:moveTo>
                  <a:lnTo>
                    <a:pt x="2622804" y="381393"/>
                  </a:lnTo>
                  <a:lnTo>
                    <a:pt x="2622804" y="1525524"/>
                  </a:lnTo>
                  <a:lnTo>
                    <a:pt x="2633218" y="1525524"/>
                  </a:lnTo>
                  <a:lnTo>
                    <a:pt x="2633218" y="381393"/>
                  </a:lnTo>
                  <a:close/>
                </a:path>
                <a:path w="4084954" h="1525904">
                  <a:moveTo>
                    <a:pt x="2691244" y="699135"/>
                  </a:moveTo>
                  <a:lnTo>
                    <a:pt x="2680843" y="699135"/>
                  </a:lnTo>
                  <a:lnTo>
                    <a:pt x="2680843" y="1525524"/>
                  </a:lnTo>
                  <a:lnTo>
                    <a:pt x="2691244" y="1525524"/>
                  </a:lnTo>
                  <a:lnTo>
                    <a:pt x="2691244" y="699135"/>
                  </a:lnTo>
                  <a:close/>
                </a:path>
                <a:path w="4084954" h="1525904">
                  <a:moveTo>
                    <a:pt x="2749296" y="826262"/>
                  </a:moveTo>
                  <a:lnTo>
                    <a:pt x="2738882" y="826262"/>
                  </a:lnTo>
                  <a:lnTo>
                    <a:pt x="2738882" y="1525524"/>
                  </a:lnTo>
                  <a:lnTo>
                    <a:pt x="2749296" y="1525524"/>
                  </a:lnTo>
                  <a:lnTo>
                    <a:pt x="2749296" y="826262"/>
                  </a:lnTo>
                  <a:close/>
                </a:path>
                <a:path w="4084954" h="1525904">
                  <a:moveTo>
                    <a:pt x="2807335" y="540258"/>
                  </a:moveTo>
                  <a:lnTo>
                    <a:pt x="2796921" y="540258"/>
                  </a:lnTo>
                  <a:lnTo>
                    <a:pt x="2796921" y="1525524"/>
                  </a:lnTo>
                  <a:lnTo>
                    <a:pt x="2807335" y="1525524"/>
                  </a:lnTo>
                  <a:lnTo>
                    <a:pt x="2807335" y="540258"/>
                  </a:lnTo>
                  <a:close/>
                </a:path>
                <a:path w="4084954" h="1525904">
                  <a:moveTo>
                    <a:pt x="2865374" y="381393"/>
                  </a:moveTo>
                  <a:lnTo>
                    <a:pt x="2854960" y="381393"/>
                  </a:lnTo>
                  <a:lnTo>
                    <a:pt x="2854960" y="1525524"/>
                  </a:lnTo>
                  <a:lnTo>
                    <a:pt x="2865374" y="1525524"/>
                  </a:lnTo>
                  <a:lnTo>
                    <a:pt x="2865374" y="381393"/>
                  </a:lnTo>
                  <a:close/>
                </a:path>
                <a:path w="4084954" h="1525904">
                  <a:moveTo>
                    <a:pt x="2923413" y="603885"/>
                  </a:moveTo>
                  <a:lnTo>
                    <a:pt x="2912999" y="603885"/>
                  </a:lnTo>
                  <a:lnTo>
                    <a:pt x="2912999" y="1525524"/>
                  </a:lnTo>
                  <a:lnTo>
                    <a:pt x="2923413" y="1525524"/>
                  </a:lnTo>
                  <a:lnTo>
                    <a:pt x="2923413" y="603885"/>
                  </a:lnTo>
                  <a:close/>
                </a:path>
                <a:path w="4084954" h="1525904">
                  <a:moveTo>
                    <a:pt x="2981579" y="667385"/>
                  </a:moveTo>
                  <a:lnTo>
                    <a:pt x="2971165" y="667385"/>
                  </a:lnTo>
                  <a:lnTo>
                    <a:pt x="2971165" y="1525524"/>
                  </a:lnTo>
                  <a:lnTo>
                    <a:pt x="2981579" y="1525524"/>
                  </a:lnTo>
                  <a:lnTo>
                    <a:pt x="2981579" y="667385"/>
                  </a:lnTo>
                  <a:close/>
                </a:path>
                <a:path w="4084954" h="1525904">
                  <a:moveTo>
                    <a:pt x="3039618" y="667385"/>
                  </a:moveTo>
                  <a:lnTo>
                    <a:pt x="3029204" y="667385"/>
                  </a:lnTo>
                  <a:lnTo>
                    <a:pt x="3029204" y="1525524"/>
                  </a:lnTo>
                  <a:lnTo>
                    <a:pt x="3039618" y="1525524"/>
                  </a:lnTo>
                  <a:lnTo>
                    <a:pt x="3039618" y="667385"/>
                  </a:lnTo>
                  <a:close/>
                </a:path>
                <a:path w="4084954" h="1525904">
                  <a:moveTo>
                    <a:pt x="3097644" y="731012"/>
                  </a:moveTo>
                  <a:lnTo>
                    <a:pt x="3087243" y="731012"/>
                  </a:lnTo>
                  <a:lnTo>
                    <a:pt x="3087243" y="1525524"/>
                  </a:lnTo>
                  <a:lnTo>
                    <a:pt x="3097644" y="1525524"/>
                  </a:lnTo>
                  <a:lnTo>
                    <a:pt x="3097644" y="731012"/>
                  </a:lnTo>
                  <a:close/>
                </a:path>
                <a:path w="4084954" h="1525904">
                  <a:moveTo>
                    <a:pt x="3155696" y="699135"/>
                  </a:moveTo>
                  <a:lnTo>
                    <a:pt x="3145282" y="699135"/>
                  </a:lnTo>
                  <a:lnTo>
                    <a:pt x="3145282" y="1525524"/>
                  </a:lnTo>
                  <a:lnTo>
                    <a:pt x="3155696" y="1525524"/>
                  </a:lnTo>
                  <a:lnTo>
                    <a:pt x="3155696" y="699135"/>
                  </a:lnTo>
                  <a:close/>
                </a:path>
                <a:path w="4084954" h="1525904">
                  <a:moveTo>
                    <a:pt x="3213735" y="254266"/>
                  </a:moveTo>
                  <a:lnTo>
                    <a:pt x="3203321" y="254266"/>
                  </a:lnTo>
                  <a:lnTo>
                    <a:pt x="3203321" y="1525524"/>
                  </a:lnTo>
                  <a:lnTo>
                    <a:pt x="3213735" y="1525524"/>
                  </a:lnTo>
                  <a:lnTo>
                    <a:pt x="3213735" y="254266"/>
                  </a:lnTo>
                  <a:close/>
                </a:path>
                <a:path w="4084954" h="1525904">
                  <a:moveTo>
                    <a:pt x="3271774" y="603885"/>
                  </a:moveTo>
                  <a:lnTo>
                    <a:pt x="3261360" y="603885"/>
                  </a:lnTo>
                  <a:lnTo>
                    <a:pt x="3261360" y="1525524"/>
                  </a:lnTo>
                  <a:lnTo>
                    <a:pt x="3271774" y="1525524"/>
                  </a:lnTo>
                  <a:lnTo>
                    <a:pt x="3271774" y="603885"/>
                  </a:lnTo>
                  <a:close/>
                </a:path>
                <a:path w="4084954" h="1525904">
                  <a:moveTo>
                    <a:pt x="3329813" y="1017016"/>
                  </a:moveTo>
                  <a:lnTo>
                    <a:pt x="3319399" y="1017016"/>
                  </a:lnTo>
                  <a:lnTo>
                    <a:pt x="3319399" y="1525524"/>
                  </a:lnTo>
                  <a:lnTo>
                    <a:pt x="3329813" y="1525524"/>
                  </a:lnTo>
                  <a:lnTo>
                    <a:pt x="3329813" y="1017016"/>
                  </a:lnTo>
                  <a:close/>
                </a:path>
                <a:path w="4084954" h="1525904">
                  <a:moveTo>
                    <a:pt x="3387852" y="508508"/>
                  </a:moveTo>
                  <a:lnTo>
                    <a:pt x="3377438" y="508508"/>
                  </a:lnTo>
                  <a:lnTo>
                    <a:pt x="3377438" y="1525524"/>
                  </a:lnTo>
                  <a:lnTo>
                    <a:pt x="3387852" y="1525524"/>
                  </a:lnTo>
                  <a:lnTo>
                    <a:pt x="3387852" y="508508"/>
                  </a:lnTo>
                  <a:close/>
                </a:path>
                <a:path w="4084954" h="1525904">
                  <a:moveTo>
                    <a:pt x="3445891" y="794512"/>
                  </a:moveTo>
                  <a:lnTo>
                    <a:pt x="3435477" y="794512"/>
                  </a:lnTo>
                  <a:lnTo>
                    <a:pt x="3435477" y="1525524"/>
                  </a:lnTo>
                  <a:lnTo>
                    <a:pt x="3445891" y="1525524"/>
                  </a:lnTo>
                  <a:lnTo>
                    <a:pt x="3445891" y="794512"/>
                  </a:lnTo>
                  <a:close/>
                </a:path>
                <a:path w="4084954" h="1525904">
                  <a:moveTo>
                    <a:pt x="3503930" y="826262"/>
                  </a:moveTo>
                  <a:lnTo>
                    <a:pt x="3493516" y="826262"/>
                  </a:lnTo>
                  <a:lnTo>
                    <a:pt x="3493516" y="1525524"/>
                  </a:lnTo>
                  <a:lnTo>
                    <a:pt x="3503930" y="1525524"/>
                  </a:lnTo>
                  <a:lnTo>
                    <a:pt x="3503930" y="826262"/>
                  </a:lnTo>
                  <a:close/>
                </a:path>
                <a:path w="4084954" h="1525904">
                  <a:moveTo>
                    <a:pt x="3562096" y="699135"/>
                  </a:moveTo>
                  <a:lnTo>
                    <a:pt x="3551682" y="699135"/>
                  </a:lnTo>
                  <a:lnTo>
                    <a:pt x="3551682" y="1525524"/>
                  </a:lnTo>
                  <a:lnTo>
                    <a:pt x="3562096" y="1525524"/>
                  </a:lnTo>
                  <a:lnTo>
                    <a:pt x="3562096" y="699135"/>
                  </a:lnTo>
                  <a:close/>
                </a:path>
                <a:path w="4084954" h="1525904">
                  <a:moveTo>
                    <a:pt x="3620135" y="635635"/>
                  </a:moveTo>
                  <a:lnTo>
                    <a:pt x="3609721" y="635635"/>
                  </a:lnTo>
                  <a:lnTo>
                    <a:pt x="3609721" y="1525524"/>
                  </a:lnTo>
                  <a:lnTo>
                    <a:pt x="3620135" y="1525524"/>
                  </a:lnTo>
                  <a:lnTo>
                    <a:pt x="3620135" y="635635"/>
                  </a:lnTo>
                  <a:close/>
                </a:path>
                <a:path w="4084954" h="1525904">
                  <a:moveTo>
                    <a:pt x="3678174" y="953389"/>
                  </a:moveTo>
                  <a:lnTo>
                    <a:pt x="3667760" y="953389"/>
                  </a:lnTo>
                  <a:lnTo>
                    <a:pt x="3667760" y="1525524"/>
                  </a:lnTo>
                  <a:lnTo>
                    <a:pt x="3678174" y="1525524"/>
                  </a:lnTo>
                  <a:lnTo>
                    <a:pt x="3678174" y="953389"/>
                  </a:lnTo>
                  <a:close/>
                </a:path>
                <a:path w="4084954" h="1525904">
                  <a:moveTo>
                    <a:pt x="3736213" y="1017016"/>
                  </a:moveTo>
                  <a:lnTo>
                    <a:pt x="3725799" y="1017016"/>
                  </a:lnTo>
                  <a:lnTo>
                    <a:pt x="3725799" y="1525524"/>
                  </a:lnTo>
                  <a:lnTo>
                    <a:pt x="3736213" y="1525524"/>
                  </a:lnTo>
                  <a:lnTo>
                    <a:pt x="3736213" y="1017016"/>
                  </a:lnTo>
                  <a:close/>
                </a:path>
                <a:path w="4084954" h="1525904">
                  <a:moveTo>
                    <a:pt x="3794252" y="985266"/>
                  </a:moveTo>
                  <a:lnTo>
                    <a:pt x="3783838" y="985266"/>
                  </a:lnTo>
                  <a:lnTo>
                    <a:pt x="3783838" y="1525524"/>
                  </a:lnTo>
                  <a:lnTo>
                    <a:pt x="3794252" y="1525524"/>
                  </a:lnTo>
                  <a:lnTo>
                    <a:pt x="3794252" y="985266"/>
                  </a:lnTo>
                  <a:close/>
                </a:path>
                <a:path w="4084954" h="1525904">
                  <a:moveTo>
                    <a:pt x="3852291" y="1048766"/>
                  </a:moveTo>
                  <a:lnTo>
                    <a:pt x="3841877" y="1048766"/>
                  </a:lnTo>
                  <a:lnTo>
                    <a:pt x="3841877" y="1525524"/>
                  </a:lnTo>
                  <a:lnTo>
                    <a:pt x="3852291" y="1525524"/>
                  </a:lnTo>
                  <a:lnTo>
                    <a:pt x="3852291" y="1048766"/>
                  </a:lnTo>
                  <a:close/>
                </a:path>
                <a:path w="4084954" h="1525904">
                  <a:moveTo>
                    <a:pt x="3910330" y="413131"/>
                  </a:moveTo>
                  <a:lnTo>
                    <a:pt x="3899916" y="413131"/>
                  </a:lnTo>
                  <a:lnTo>
                    <a:pt x="3899916" y="1525524"/>
                  </a:lnTo>
                  <a:lnTo>
                    <a:pt x="3910330" y="1525524"/>
                  </a:lnTo>
                  <a:lnTo>
                    <a:pt x="3910330" y="413131"/>
                  </a:lnTo>
                  <a:close/>
                </a:path>
                <a:path w="4084954" h="1525904">
                  <a:moveTo>
                    <a:pt x="3968369" y="0"/>
                  </a:moveTo>
                  <a:lnTo>
                    <a:pt x="3957955" y="0"/>
                  </a:lnTo>
                  <a:lnTo>
                    <a:pt x="3957955" y="1525524"/>
                  </a:lnTo>
                  <a:lnTo>
                    <a:pt x="3968369" y="1525524"/>
                  </a:lnTo>
                  <a:lnTo>
                    <a:pt x="3968369" y="0"/>
                  </a:lnTo>
                  <a:close/>
                </a:path>
                <a:path w="4084954" h="1525904">
                  <a:moveTo>
                    <a:pt x="4026395" y="794512"/>
                  </a:moveTo>
                  <a:lnTo>
                    <a:pt x="4015994" y="794512"/>
                  </a:lnTo>
                  <a:lnTo>
                    <a:pt x="4015994" y="1525524"/>
                  </a:lnTo>
                  <a:lnTo>
                    <a:pt x="4026395" y="1525524"/>
                  </a:lnTo>
                  <a:lnTo>
                    <a:pt x="4026395" y="794512"/>
                  </a:lnTo>
                  <a:close/>
                </a:path>
                <a:path w="4084954" h="1525904">
                  <a:moveTo>
                    <a:pt x="4084574" y="635635"/>
                  </a:moveTo>
                  <a:lnTo>
                    <a:pt x="4074160" y="635635"/>
                  </a:lnTo>
                  <a:lnTo>
                    <a:pt x="4074160" y="1525524"/>
                  </a:lnTo>
                  <a:lnTo>
                    <a:pt x="4084574" y="1525524"/>
                  </a:lnTo>
                  <a:lnTo>
                    <a:pt x="4084574" y="635635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2" name="object 112" descr=""/>
            <p:cNvSpPr/>
            <p:nvPr/>
          </p:nvSpPr>
          <p:spPr>
            <a:xfrm>
              <a:off x="5198872" y="7550023"/>
              <a:ext cx="4074160" cy="1112520"/>
            </a:xfrm>
            <a:custGeom>
              <a:avLst/>
              <a:gdLst/>
              <a:ahLst/>
              <a:cxnLst/>
              <a:rect l="l" t="t" r="r" b="b"/>
              <a:pathLst>
                <a:path w="4074159" h="1112520">
                  <a:moveTo>
                    <a:pt x="10414" y="222504"/>
                  </a:moveTo>
                  <a:lnTo>
                    <a:pt x="0" y="222504"/>
                  </a:lnTo>
                  <a:lnTo>
                    <a:pt x="0" y="1112393"/>
                  </a:lnTo>
                  <a:lnTo>
                    <a:pt x="10414" y="1112393"/>
                  </a:lnTo>
                  <a:lnTo>
                    <a:pt x="10414" y="222504"/>
                  </a:lnTo>
                  <a:close/>
                </a:path>
                <a:path w="4074159" h="1112520">
                  <a:moveTo>
                    <a:pt x="68453" y="635635"/>
                  </a:moveTo>
                  <a:lnTo>
                    <a:pt x="58039" y="635635"/>
                  </a:lnTo>
                  <a:lnTo>
                    <a:pt x="58039" y="1112393"/>
                  </a:lnTo>
                  <a:lnTo>
                    <a:pt x="68453" y="1112393"/>
                  </a:lnTo>
                  <a:lnTo>
                    <a:pt x="68453" y="635635"/>
                  </a:lnTo>
                  <a:close/>
                </a:path>
                <a:path w="4074159" h="1112520">
                  <a:moveTo>
                    <a:pt x="126492" y="254254"/>
                  </a:moveTo>
                  <a:lnTo>
                    <a:pt x="116078" y="254254"/>
                  </a:lnTo>
                  <a:lnTo>
                    <a:pt x="116078" y="1112393"/>
                  </a:lnTo>
                  <a:lnTo>
                    <a:pt x="126492" y="1112393"/>
                  </a:lnTo>
                  <a:lnTo>
                    <a:pt x="126492" y="254254"/>
                  </a:lnTo>
                  <a:close/>
                </a:path>
                <a:path w="4074159" h="1112520">
                  <a:moveTo>
                    <a:pt x="184531" y="476758"/>
                  </a:moveTo>
                  <a:lnTo>
                    <a:pt x="174117" y="476758"/>
                  </a:lnTo>
                  <a:lnTo>
                    <a:pt x="174117" y="1112393"/>
                  </a:lnTo>
                  <a:lnTo>
                    <a:pt x="184531" y="1112393"/>
                  </a:lnTo>
                  <a:lnTo>
                    <a:pt x="184531" y="476758"/>
                  </a:lnTo>
                  <a:close/>
                </a:path>
                <a:path w="4074159" h="1112520">
                  <a:moveTo>
                    <a:pt x="242570" y="222504"/>
                  </a:moveTo>
                  <a:lnTo>
                    <a:pt x="232156" y="222504"/>
                  </a:lnTo>
                  <a:lnTo>
                    <a:pt x="232156" y="1112393"/>
                  </a:lnTo>
                  <a:lnTo>
                    <a:pt x="242570" y="1112393"/>
                  </a:lnTo>
                  <a:lnTo>
                    <a:pt x="242570" y="222504"/>
                  </a:lnTo>
                  <a:close/>
                </a:path>
                <a:path w="4074159" h="1112520">
                  <a:moveTo>
                    <a:pt x="300609" y="63500"/>
                  </a:moveTo>
                  <a:lnTo>
                    <a:pt x="290195" y="63500"/>
                  </a:lnTo>
                  <a:lnTo>
                    <a:pt x="290195" y="1112393"/>
                  </a:lnTo>
                  <a:lnTo>
                    <a:pt x="300609" y="1112393"/>
                  </a:lnTo>
                  <a:lnTo>
                    <a:pt x="300609" y="63500"/>
                  </a:lnTo>
                  <a:close/>
                </a:path>
                <a:path w="4074159" h="1112520">
                  <a:moveTo>
                    <a:pt x="358635" y="0"/>
                  </a:moveTo>
                  <a:lnTo>
                    <a:pt x="348234" y="0"/>
                  </a:lnTo>
                  <a:lnTo>
                    <a:pt x="348234" y="1112393"/>
                  </a:lnTo>
                  <a:lnTo>
                    <a:pt x="358635" y="1112393"/>
                  </a:lnTo>
                  <a:lnTo>
                    <a:pt x="358635" y="0"/>
                  </a:lnTo>
                  <a:close/>
                </a:path>
                <a:path w="4074159" h="1112520">
                  <a:moveTo>
                    <a:pt x="416687" y="127127"/>
                  </a:moveTo>
                  <a:lnTo>
                    <a:pt x="406273" y="127127"/>
                  </a:lnTo>
                  <a:lnTo>
                    <a:pt x="406273" y="1112393"/>
                  </a:lnTo>
                  <a:lnTo>
                    <a:pt x="416687" y="1112393"/>
                  </a:lnTo>
                  <a:lnTo>
                    <a:pt x="416687" y="127127"/>
                  </a:lnTo>
                  <a:close/>
                </a:path>
                <a:path w="4074159" h="1112520">
                  <a:moveTo>
                    <a:pt x="474726" y="190754"/>
                  </a:moveTo>
                  <a:lnTo>
                    <a:pt x="464312" y="190754"/>
                  </a:lnTo>
                  <a:lnTo>
                    <a:pt x="464312" y="1112393"/>
                  </a:lnTo>
                  <a:lnTo>
                    <a:pt x="474726" y="1112393"/>
                  </a:lnTo>
                  <a:lnTo>
                    <a:pt x="474726" y="190754"/>
                  </a:lnTo>
                  <a:close/>
                </a:path>
                <a:path w="4074159" h="1112520">
                  <a:moveTo>
                    <a:pt x="532892" y="254254"/>
                  </a:moveTo>
                  <a:lnTo>
                    <a:pt x="522478" y="254254"/>
                  </a:lnTo>
                  <a:lnTo>
                    <a:pt x="522478" y="1112393"/>
                  </a:lnTo>
                  <a:lnTo>
                    <a:pt x="532892" y="1112393"/>
                  </a:lnTo>
                  <a:lnTo>
                    <a:pt x="532892" y="254254"/>
                  </a:lnTo>
                  <a:close/>
                </a:path>
                <a:path w="4074159" h="1112520">
                  <a:moveTo>
                    <a:pt x="590931" y="31750"/>
                  </a:moveTo>
                  <a:lnTo>
                    <a:pt x="580517" y="31750"/>
                  </a:lnTo>
                  <a:lnTo>
                    <a:pt x="580517" y="1112393"/>
                  </a:lnTo>
                  <a:lnTo>
                    <a:pt x="590931" y="1112393"/>
                  </a:lnTo>
                  <a:lnTo>
                    <a:pt x="590931" y="31750"/>
                  </a:lnTo>
                  <a:close/>
                </a:path>
                <a:path w="4074159" h="1112520">
                  <a:moveTo>
                    <a:pt x="648970" y="95377"/>
                  </a:moveTo>
                  <a:lnTo>
                    <a:pt x="638556" y="95377"/>
                  </a:lnTo>
                  <a:lnTo>
                    <a:pt x="638556" y="1112393"/>
                  </a:lnTo>
                  <a:lnTo>
                    <a:pt x="648970" y="1112393"/>
                  </a:lnTo>
                  <a:lnTo>
                    <a:pt x="648970" y="95377"/>
                  </a:lnTo>
                  <a:close/>
                </a:path>
                <a:path w="4074159" h="1112520">
                  <a:moveTo>
                    <a:pt x="707009" y="317881"/>
                  </a:moveTo>
                  <a:lnTo>
                    <a:pt x="696595" y="317881"/>
                  </a:lnTo>
                  <a:lnTo>
                    <a:pt x="696595" y="1112393"/>
                  </a:lnTo>
                  <a:lnTo>
                    <a:pt x="707009" y="1112393"/>
                  </a:lnTo>
                  <a:lnTo>
                    <a:pt x="707009" y="317881"/>
                  </a:lnTo>
                  <a:close/>
                </a:path>
                <a:path w="4074159" h="1112520">
                  <a:moveTo>
                    <a:pt x="765035" y="381381"/>
                  </a:moveTo>
                  <a:lnTo>
                    <a:pt x="754634" y="381381"/>
                  </a:lnTo>
                  <a:lnTo>
                    <a:pt x="754634" y="1112393"/>
                  </a:lnTo>
                  <a:lnTo>
                    <a:pt x="765035" y="1112393"/>
                  </a:lnTo>
                  <a:lnTo>
                    <a:pt x="765035" y="381381"/>
                  </a:lnTo>
                  <a:close/>
                </a:path>
                <a:path w="4074159" h="1112520">
                  <a:moveTo>
                    <a:pt x="823087" y="635635"/>
                  </a:moveTo>
                  <a:lnTo>
                    <a:pt x="812673" y="635635"/>
                  </a:lnTo>
                  <a:lnTo>
                    <a:pt x="812673" y="1112393"/>
                  </a:lnTo>
                  <a:lnTo>
                    <a:pt x="823087" y="1112393"/>
                  </a:lnTo>
                  <a:lnTo>
                    <a:pt x="823087" y="635635"/>
                  </a:lnTo>
                  <a:close/>
                </a:path>
                <a:path w="4074159" h="1112520">
                  <a:moveTo>
                    <a:pt x="881126" y="572135"/>
                  </a:moveTo>
                  <a:lnTo>
                    <a:pt x="870712" y="572135"/>
                  </a:lnTo>
                  <a:lnTo>
                    <a:pt x="870712" y="1112393"/>
                  </a:lnTo>
                  <a:lnTo>
                    <a:pt x="881126" y="1112393"/>
                  </a:lnTo>
                  <a:lnTo>
                    <a:pt x="881126" y="572135"/>
                  </a:lnTo>
                  <a:close/>
                </a:path>
                <a:path w="4074159" h="1112520">
                  <a:moveTo>
                    <a:pt x="939165" y="349631"/>
                  </a:moveTo>
                  <a:lnTo>
                    <a:pt x="928751" y="349631"/>
                  </a:lnTo>
                  <a:lnTo>
                    <a:pt x="928751" y="1112393"/>
                  </a:lnTo>
                  <a:lnTo>
                    <a:pt x="939165" y="1112393"/>
                  </a:lnTo>
                  <a:lnTo>
                    <a:pt x="939165" y="349631"/>
                  </a:lnTo>
                  <a:close/>
                </a:path>
                <a:path w="4074159" h="1112520">
                  <a:moveTo>
                    <a:pt x="997204" y="476758"/>
                  </a:moveTo>
                  <a:lnTo>
                    <a:pt x="986790" y="476758"/>
                  </a:lnTo>
                  <a:lnTo>
                    <a:pt x="986790" y="1112393"/>
                  </a:lnTo>
                  <a:lnTo>
                    <a:pt x="997204" y="1112393"/>
                  </a:lnTo>
                  <a:lnTo>
                    <a:pt x="997204" y="476758"/>
                  </a:lnTo>
                  <a:close/>
                </a:path>
                <a:path w="4074159" h="1112520">
                  <a:moveTo>
                    <a:pt x="1055243" y="635635"/>
                  </a:moveTo>
                  <a:lnTo>
                    <a:pt x="1044829" y="635635"/>
                  </a:lnTo>
                  <a:lnTo>
                    <a:pt x="1044829" y="1112393"/>
                  </a:lnTo>
                  <a:lnTo>
                    <a:pt x="1055243" y="1112393"/>
                  </a:lnTo>
                  <a:lnTo>
                    <a:pt x="1055243" y="635635"/>
                  </a:lnTo>
                  <a:close/>
                </a:path>
                <a:path w="4074159" h="1112520">
                  <a:moveTo>
                    <a:pt x="1113409" y="413131"/>
                  </a:moveTo>
                  <a:lnTo>
                    <a:pt x="1102995" y="413131"/>
                  </a:lnTo>
                  <a:lnTo>
                    <a:pt x="1102995" y="1112393"/>
                  </a:lnTo>
                  <a:lnTo>
                    <a:pt x="1113409" y="1112393"/>
                  </a:lnTo>
                  <a:lnTo>
                    <a:pt x="1113409" y="413131"/>
                  </a:lnTo>
                  <a:close/>
                </a:path>
                <a:path w="4074159" h="1112520">
                  <a:moveTo>
                    <a:pt x="1171435" y="317881"/>
                  </a:moveTo>
                  <a:lnTo>
                    <a:pt x="1161034" y="317881"/>
                  </a:lnTo>
                  <a:lnTo>
                    <a:pt x="1161034" y="1112393"/>
                  </a:lnTo>
                  <a:lnTo>
                    <a:pt x="1171435" y="1112393"/>
                  </a:lnTo>
                  <a:lnTo>
                    <a:pt x="1171435" y="317881"/>
                  </a:lnTo>
                  <a:close/>
                </a:path>
                <a:path w="4074159" h="1112520">
                  <a:moveTo>
                    <a:pt x="1229487" y="31750"/>
                  </a:moveTo>
                  <a:lnTo>
                    <a:pt x="1219073" y="31750"/>
                  </a:lnTo>
                  <a:lnTo>
                    <a:pt x="1219073" y="1112393"/>
                  </a:lnTo>
                  <a:lnTo>
                    <a:pt x="1229487" y="1112393"/>
                  </a:lnTo>
                  <a:lnTo>
                    <a:pt x="1229487" y="31750"/>
                  </a:lnTo>
                  <a:close/>
                </a:path>
                <a:path w="4074159" h="1112520">
                  <a:moveTo>
                    <a:pt x="1287526" y="540258"/>
                  </a:moveTo>
                  <a:lnTo>
                    <a:pt x="1277112" y="540258"/>
                  </a:lnTo>
                  <a:lnTo>
                    <a:pt x="1277112" y="1112393"/>
                  </a:lnTo>
                  <a:lnTo>
                    <a:pt x="1287526" y="1112393"/>
                  </a:lnTo>
                  <a:lnTo>
                    <a:pt x="1287526" y="540258"/>
                  </a:lnTo>
                  <a:close/>
                </a:path>
                <a:path w="4074159" h="1112520">
                  <a:moveTo>
                    <a:pt x="1345565" y="286004"/>
                  </a:moveTo>
                  <a:lnTo>
                    <a:pt x="1335151" y="286004"/>
                  </a:lnTo>
                  <a:lnTo>
                    <a:pt x="1335151" y="1112393"/>
                  </a:lnTo>
                  <a:lnTo>
                    <a:pt x="1345565" y="1112393"/>
                  </a:lnTo>
                  <a:lnTo>
                    <a:pt x="1345565" y="286004"/>
                  </a:lnTo>
                  <a:close/>
                </a:path>
                <a:path w="4074159" h="1112520">
                  <a:moveTo>
                    <a:pt x="1403604" y="63500"/>
                  </a:moveTo>
                  <a:lnTo>
                    <a:pt x="1393177" y="63500"/>
                  </a:lnTo>
                  <a:lnTo>
                    <a:pt x="1393177" y="1112393"/>
                  </a:lnTo>
                  <a:lnTo>
                    <a:pt x="1403604" y="1112393"/>
                  </a:lnTo>
                  <a:lnTo>
                    <a:pt x="1403604" y="63500"/>
                  </a:lnTo>
                  <a:close/>
                </a:path>
                <a:path w="4074159" h="1112520">
                  <a:moveTo>
                    <a:pt x="1461643" y="603885"/>
                  </a:moveTo>
                  <a:lnTo>
                    <a:pt x="1451229" y="603885"/>
                  </a:lnTo>
                  <a:lnTo>
                    <a:pt x="1451229" y="1112393"/>
                  </a:lnTo>
                  <a:lnTo>
                    <a:pt x="1461643" y="1112393"/>
                  </a:lnTo>
                  <a:lnTo>
                    <a:pt x="1461643" y="603885"/>
                  </a:lnTo>
                  <a:close/>
                </a:path>
                <a:path w="4074159" h="1112520">
                  <a:moveTo>
                    <a:pt x="1519682" y="222504"/>
                  </a:moveTo>
                  <a:lnTo>
                    <a:pt x="1509268" y="222504"/>
                  </a:lnTo>
                  <a:lnTo>
                    <a:pt x="1509268" y="1112393"/>
                  </a:lnTo>
                  <a:lnTo>
                    <a:pt x="1519682" y="1112393"/>
                  </a:lnTo>
                  <a:lnTo>
                    <a:pt x="1519682" y="222504"/>
                  </a:lnTo>
                  <a:close/>
                </a:path>
                <a:path w="4074159" h="1112520">
                  <a:moveTo>
                    <a:pt x="1577721" y="381381"/>
                  </a:moveTo>
                  <a:lnTo>
                    <a:pt x="1567307" y="381381"/>
                  </a:lnTo>
                  <a:lnTo>
                    <a:pt x="1567307" y="1112393"/>
                  </a:lnTo>
                  <a:lnTo>
                    <a:pt x="1577721" y="1112393"/>
                  </a:lnTo>
                  <a:lnTo>
                    <a:pt x="1577721" y="381381"/>
                  </a:lnTo>
                  <a:close/>
                </a:path>
                <a:path w="4074159" h="1112520">
                  <a:moveTo>
                    <a:pt x="1635887" y="222504"/>
                  </a:moveTo>
                  <a:lnTo>
                    <a:pt x="1625473" y="222504"/>
                  </a:lnTo>
                  <a:lnTo>
                    <a:pt x="1625473" y="1112393"/>
                  </a:lnTo>
                  <a:lnTo>
                    <a:pt x="1635887" y="1112393"/>
                  </a:lnTo>
                  <a:lnTo>
                    <a:pt x="1635887" y="222504"/>
                  </a:lnTo>
                  <a:close/>
                </a:path>
                <a:path w="4074159" h="1112520">
                  <a:moveTo>
                    <a:pt x="1693926" y="349631"/>
                  </a:moveTo>
                  <a:lnTo>
                    <a:pt x="1683512" y="349631"/>
                  </a:lnTo>
                  <a:lnTo>
                    <a:pt x="1683512" y="1112393"/>
                  </a:lnTo>
                  <a:lnTo>
                    <a:pt x="1693926" y="1112393"/>
                  </a:lnTo>
                  <a:lnTo>
                    <a:pt x="1693926" y="349631"/>
                  </a:lnTo>
                  <a:close/>
                </a:path>
                <a:path w="4074159" h="1112520">
                  <a:moveTo>
                    <a:pt x="1751965" y="445008"/>
                  </a:moveTo>
                  <a:lnTo>
                    <a:pt x="1741551" y="445008"/>
                  </a:lnTo>
                  <a:lnTo>
                    <a:pt x="1741551" y="1112393"/>
                  </a:lnTo>
                  <a:lnTo>
                    <a:pt x="1751965" y="1112393"/>
                  </a:lnTo>
                  <a:lnTo>
                    <a:pt x="1751965" y="445008"/>
                  </a:lnTo>
                  <a:close/>
                </a:path>
                <a:path w="4074159" h="1112520">
                  <a:moveTo>
                    <a:pt x="1810004" y="254254"/>
                  </a:moveTo>
                  <a:lnTo>
                    <a:pt x="1799590" y="254254"/>
                  </a:lnTo>
                  <a:lnTo>
                    <a:pt x="1799590" y="1112393"/>
                  </a:lnTo>
                  <a:lnTo>
                    <a:pt x="1810004" y="1112393"/>
                  </a:lnTo>
                  <a:lnTo>
                    <a:pt x="1810004" y="254254"/>
                  </a:lnTo>
                  <a:close/>
                </a:path>
                <a:path w="4074159" h="1112520">
                  <a:moveTo>
                    <a:pt x="1868043" y="476758"/>
                  </a:moveTo>
                  <a:lnTo>
                    <a:pt x="1857629" y="476758"/>
                  </a:lnTo>
                  <a:lnTo>
                    <a:pt x="1857629" y="1112393"/>
                  </a:lnTo>
                  <a:lnTo>
                    <a:pt x="1868043" y="1112393"/>
                  </a:lnTo>
                  <a:lnTo>
                    <a:pt x="1868043" y="476758"/>
                  </a:lnTo>
                  <a:close/>
                </a:path>
                <a:path w="4074159" h="1112520">
                  <a:moveTo>
                    <a:pt x="1926082" y="286004"/>
                  </a:moveTo>
                  <a:lnTo>
                    <a:pt x="1915668" y="286004"/>
                  </a:lnTo>
                  <a:lnTo>
                    <a:pt x="1915668" y="1112393"/>
                  </a:lnTo>
                  <a:lnTo>
                    <a:pt x="1926082" y="1112393"/>
                  </a:lnTo>
                  <a:lnTo>
                    <a:pt x="1926082" y="286004"/>
                  </a:lnTo>
                  <a:close/>
                </a:path>
                <a:path w="4074159" h="1112520">
                  <a:moveTo>
                    <a:pt x="1984121" y="95377"/>
                  </a:moveTo>
                  <a:lnTo>
                    <a:pt x="1973707" y="95377"/>
                  </a:lnTo>
                  <a:lnTo>
                    <a:pt x="1973707" y="1112393"/>
                  </a:lnTo>
                  <a:lnTo>
                    <a:pt x="1984121" y="1112393"/>
                  </a:lnTo>
                  <a:lnTo>
                    <a:pt x="1984121" y="95377"/>
                  </a:lnTo>
                  <a:close/>
                </a:path>
                <a:path w="4074159" h="1112520">
                  <a:moveTo>
                    <a:pt x="2042160" y="508508"/>
                  </a:moveTo>
                  <a:lnTo>
                    <a:pt x="2031746" y="508508"/>
                  </a:lnTo>
                  <a:lnTo>
                    <a:pt x="2031746" y="1112393"/>
                  </a:lnTo>
                  <a:lnTo>
                    <a:pt x="2042160" y="1112393"/>
                  </a:lnTo>
                  <a:lnTo>
                    <a:pt x="2042160" y="508508"/>
                  </a:lnTo>
                  <a:close/>
                </a:path>
                <a:path w="4074159" h="1112520">
                  <a:moveTo>
                    <a:pt x="2100199" y="381381"/>
                  </a:moveTo>
                  <a:lnTo>
                    <a:pt x="2089785" y="381381"/>
                  </a:lnTo>
                  <a:lnTo>
                    <a:pt x="2089785" y="1112393"/>
                  </a:lnTo>
                  <a:lnTo>
                    <a:pt x="2100199" y="1112393"/>
                  </a:lnTo>
                  <a:lnTo>
                    <a:pt x="2100199" y="381381"/>
                  </a:lnTo>
                  <a:close/>
                </a:path>
                <a:path w="4074159" h="1112520">
                  <a:moveTo>
                    <a:pt x="2158365" y="731012"/>
                  </a:moveTo>
                  <a:lnTo>
                    <a:pt x="2147951" y="731012"/>
                  </a:lnTo>
                  <a:lnTo>
                    <a:pt x="2147951" y="1112393"/>
                  </a:lnTo>
                  <a:lnTo>
                    <a:pt x="2158365" y="1112393"/>
                  </a:lnTo>
                  <a:lnTo>
                    <a:pt x="2158365" y="731012"/>
                  </a:lnTo>
                  <a:close/>
                </a:path>
                <a:path w="4074159" h="1112520">
                  <a:moveTo>
                    <a:pt x="2216404" y="381381"/>
                  </a:moveTo>
                  <a:lnTo>
                    <a:pt x="2205990" y="381381"/>
                  </a:lnTo>
                  <a:lnTo>
                    <a:pt x="2205990" y="1112393"/>
                  </a:lnTo>
                  <a:lnTo>
                    <a:pt x="2216404" y="1112393"/>
                  </a:lnTo>
                  <a:lnTo>
                    <a:pt x="2216404" y="381381"/>
                  </a:lnTo>
                  <a:close/>
                </a:path>
                <a:path w="4074159" h="1112520">
                  <a:moveTo>
                    <a:pt x="2274443" y="731012"/>
                  </a:moveTo>
                  <a:lnTo>
                    <a:pt x="2264029" y="731012"/>
                  </a:lnTo>
                  <a:lnTo>
                    <a:pt x="2264029" y="1112393"/>
                  </a:lnTo>
                  <a:lnTo>
                    <a:pt x="2274443" y="1112393"/>
                  </a:lnTo>
                  <a:lnTo>
                    <a:pt x="2274443" y="731012"/>
                  </a:lnTo>
                  <a:close/>
                </a:path>
                <a:path w="4074159" h="1112520">
                  <a:moveTo>
                    <a:pt x="2332482" y="445008"/>
                  </a:moveTo>
                  <a:lnTo>
                    <a:pt x="2322068" y="445008"/>
                  </a:lnTo>
                  <a:lnTo>
                    <a:pt x="2322068" y="1112393"/>
                  </a:lnTo>
                  <a:lnTo>
                    <a:pt x="2332482" y="1112393"/>
                  </a:lnTo>
                  <a:lnTo>
                    <a:pt x="2332482" y="445008"/>
                  </a:lnTo>
                  <a:close/>
                </a:path>
                <a:path w="4074159" h="1112520">
                  <a:moveTo>
                    <a:pt x="2390521" y="476758"/>
                  </a:moveTo>
                  <a:lnTo>
                    <a:pt x="2380107" y="476758"/>
                  </a:lnTo>
                  <a:lnTo>
                    <a:pt x="2380107" y="1112393"/>
                  </a:lnTo>
                  <a:lnTo>
                    <a:pt x="2390521" y="1112393"/>
                  </a:lnTo>
                  <a:lnTo>
                    <a:pt x="2390521" y="476758"/>
                  </a:lnTo>
                  <a:close/>
                </a:path>
                <a:path w="4074159" h="1112520">
                  <a:moveTo>
                    <a:pt x="2448560" y="381381"/>
                  </a:moveTo>
                  <a:lnTo>
                    <a:pt x="2438146" y="381381"/>
                  </a:lnTo>
                  <a:lnTo>
                    <a:pt x="2438146" y="1112393"/>
                  </a:lnTo>
                  <a:lnTo>
                    <a:pt x="2448560" y="1112393"/>
                  </a:lnTo>
                  <a:lnTo>
                    <a:pt x="2448560" y="381381"/>
                  </a:lnTo>
                  <a:close/>
                </a:path>
                <a:path w="4074159" h="1112520">
                  <a:moveTo>
                    <a:pt x="2506599" y="540258"/>
                  </a:moveTo>
                  <a:lnTo>
                    <a:pt x="2496185" y="540258"/>
                  </a:lnTo>
                  <a:lnTo>
                    <a:pt x="2496185" y="1112393"/>
                  </a:lnTo>
                  <a:lnTo>
                    <a:pt x="2506599" y="1112393"/>
                  </a:lnTo>
                  <a:lnTo>
                    <a:pt x="2506599" y="540258"/>
                  </a:lnTo>
                  <a:close/>
                </a:path>
                <a:path w="4074159" h="1112520">
                  <a:moveTo>
                    <a:pt x="2564638" y="667385"/>
                  </a:moveTo>
                  <a:lnTo>
                    <a:pt x="2554224" y="667385"/>
                  </a:lnTo>
                  <a:lnTo>
                    <a:pt x="2554224" y="1112393"/>
                  </a:lnTo>
                  <a:lnTo>
                    <a:pt x="2564638" y="1112393"/>
                  </a:lnTo>
                  <a:lnTo>
                    <a:pt x="2564638" y="667385"/>
                  </a:lnTo>
                  <a:close/>
                </a:path>
                <a:path w="4074159" h="1112520">
                  <a:moveTo>
                    <a:pt x="2622677" y="158877"/>
                  </a:moveTo>
                  <a:lnTo>
                    <a:pt x="2612263" y="158877"/>
                  </a:lnTo>
                  <a:lnTo>
                    <a:pt x="2612263" y="1112393"/>
                  </a:lnTo>
                  <a:lnTo>
                    <a:pt x="2622677" y="1112393"/>
                  </a:lnTo>
                  <a:lnTo>
                    <a:pt x="2622677" y="158877"/>
                  </a:lnTo>
                  <a:close/>
                </a:path>
                <a:path w="4074159" h="1112520">
                  <a:moveTo>
                    <a:pt x="2680716" y="572135"/>
                  </a:moveTo>
                  <a:lnTo>
                    <a:pt x="2670302" y="572135"/>
                  </a:lnTo>
                  <a:lnTo>
                    <a:pt x="2670302" y="1112393"/>
                  </a:lnTo>
                  <a:lnTo>
                    <a:pt x="2680716" y="1112393"/>
                  </a:lnTo>
                  <a:lnTo>
                    <a:pt x="2680716" y="572135"/>
                  </a:lnTo>
                  <a:close/>
                </a:path>
                <a:path w="4074159" h="1112520">
                  <a:moveTo>
                    <a:pt x="2738882" y="476758"/>
                  </a:moveTo>
                  <a:lnTo>
                    <a:pt x="2728468" y="476758"/>
                  </a:lnTo>
                  <a:lnTo>
                    <a:pt x="2728468" y="1112393"/>
                  </a:lnTo>
                  <a:lnTo>
                    <a:pt x="2738882" y="1112393"/>
                  </a:lnTo>
                  <a:lnTo>
                    <a:pt x="2738882" y="476758"/>
                  </a:lnTo>
                  <a:close/>
                </a:path>
                <a:path w="4074159" h="1112520">
                  <a:moveTo>
                    <a:pt x="2796921" y="349631"/>
                  </a:moveTo>
                  <a:lnTo>
                    <a:pt x="2786507" y="349631"/>
                  </a:lnTo>
                  <a:lnTo>
                    <a:pt x="2786507" y="1112393"/>
                  </a:lnTo>
                  <a:lnTo>
                    <a:pt x="2796921" y="1112393"/>
                  </a:lnTo>
                  <a:lnTo>
                    <a:pt x="2796921" y="349631"/>
                  </a:lnTo>
                  <a:close/>
                </a:path>
                <a:path w="4074159" h="1112520">
                  <a:moveTo>
                    <a:pt x="2860154" y="635635"/>
                  </a:moveTo>
                  <a:lnTo>
                    <a:pt x="2847086" y="635635"/>
                  </a:lnTo>
                  <a:lnTo>
                    <a:pt x="2847086" y="1112393"/>
                  </a:lnTo>
                  <a:lnTo>
                    <a:pt x="2860154" y="1112393"/>
                  </a:lnTo>
                  <a:lnTo>
                    <a:pt x="2860154" y="635635"/>
                  </a:lnTo>
                  <a:close/>
                </a:path>
                <a:path w="4074159" h="1112520">
                  <a:moveTo>
                    <a:pt x="2912999" y="635635"/>
                  </a:moveTo>
                  <a:lnTo>
                    <a:pt x="2902585" y="635635"/>
                  </a:lnTo>
                  <a:lnTo>
                    <a:pt x="2902585" y="1112393"/>
                  </a:lnTo>
                  <a:lnTo>
                    <a:pt x="2912999" y="1112393"/>
                  </a:lnTo>
                  <a:lnTo>
                    <a:pt x="2912999" y="635635"/>
                  </a:lnTo>
                  <a:close/>
                </a:path>
                <a:path w="4074159" h="1112520">
                  <a:moveTo>
                    <a:pt x="2971038" y="317881"/>
                  </a:moveTo>
                  <a:lnTo>
                    <a:pt x="2960624" y="317881"/>
                  </a:lnTo>
                  <a:lnTo>
                    <a:pt x="2960624" y="1112393"/>
                  </a:lnTo>
                  <a:lnTo>
                    <a:pt x="2971038" y="1112393"/>
                  </a:lnTo>
                  <a:lnTo>
                    <a:pt x="2971038" y="317881"/>
                  </a:lnTo>
                  <a:close/>
                </a:path>
                <a:path w="4074159" h="1112520">
                  <a:moveTo>
                    <a:pt x="3029077" y="317881"/>
                  </a:moveTo>
                  <a:lnTo>
                    <a:pt x="3018663" y="317881"/>
                  </a:lnTo>
                  <a:lnTo>
                    <a:pt x="3018663" y="1112393"/>
                  </a:lnTo>
                  <a:lnTo>
                    <a:pt x="3029077" y="1112393"/>
                  </a:lnTo>
                  <a:lnTo>
                    <a:pt x="3029077" y="317881"/>
                  </a:lnTo>
                  <a:close/>
                </a:path>
                <a:path w="4074159" h="1112520">
                  <a:moveTo>
                    <a:pt x="3087116" y="476758"/>
                  </a:moveTo>
                  <a:lnTo>
                    <a:pt x="3076702" y="476758"/>
                  </a:lnTo>
                  <a:lnTo>
                    <a:pt x="3076702" y="1112393"/>
                  </a:lnTo>
                  <a:lnTo>
                    <a:pt x="3087116" y="1112393"/>
                  </a:lnTo>
                  <a:lnTo>
                    <a:pt x="3087116" y="476758"/>
                  </a:lnTo>
                  <a:close/>
                </a:path>
                <a:path w="4074159" h="1112520">
                  <a:moveTo>
                    <a:pt x="3145155" y="508508"/>
                  </a:moveTo>
                  <a:lnTo>
                    <a:pt x="3134741" y="508508"/>
                  </a:lnTo>
                  <a:lnTo>
                    <a:pt x="3134741" y="1112393"/>
                  </a:lnTo>
                  <a:lnTo>
                    <a:pt x="3145155" y="1112393"/>
                  </a:lnTo>
                  <a:lnTo>
                    <a:pt x="3145155" y="508508"/>
                  </a:lnTo>
                  <a:close/>
                </a:path>
                <a:path w="4074159" h="1112520">
                  <a:moveTo>
                    <a:pt x="3203194" y="826389"/>
                  </a:moveTo>
                  <a:lnTo>
                    <a:pt x="3192780" y="826389"/>
                  </a:lnTo>
                  <a:lnTo>
                    <a:pt x="3192780" y="1112393"/>
                  </a:lnTo>
                  <a:lnTo>
                    <a:pt x="3203194" y="1112393"/>
                  </a:lnTo>
                  <a:lnTo>
                    <a:pt x="3203194" y="826389"/>
                  </a:lnTo>
                  <a:close/>
                </a:path>
                <a:path w="4074159" h="1112520">
                  <a:moveTo>
                    <a:pt x="3261360" y="349631"/>
                  </a:moveTo>
                  <a:lnTo>
                    <a:pt x="3250946" y="349631"/>
                  </a:lnTo>
                  <a:lnTo>
                    <a:pt x="3250946" y="1112393"/>
                  </a:lnTo>
                  <a:lnTo>
                    <a:pt x="3261360" y="1112393"/>
                  </a:lnTo>
                  <a:lnTo>
                    <a:pt x="3261360" y="349631"/>
                  </a:lnTo>
                  <a:close/>
                </a:path>
                <a:path w="4074159" h="1112520">
                  <a:moveTo>
                    <a:pt x="3319399" y="413131"/>
                  </a:moveTo>
                  <a:lnTo>
                    <a:pt x="3308985" y="413131"/>
                  </a:lnTo>
                  <a:lnTo>
                    <a:pt x="3308985" y="1112393"/>
                  </a:lnTo>
                  <a:lnTo>
                    <a:pt x="3319399" y="1112393"/>
                  </a:lnTo>
                  <a:lnTo>
                    <a:pt x="3319399" y="413131"/>
                  </a:lnTo>
                  <a:close/>
                </a:path>
                <a:path w="4074159" h="1112520">
                  <a:moveTo>
                    <a:pt x="3377438" y="508508"/>
                  </a:moveTo>
                  <a:lnTo>
                    <a:pt x="3367024" y="508508"/>
                  </a:lnTo>
                  <a:lnTo>
                    <a:pt x="3367024" y="1112393"/>
                  </a:lnTo>
                  <a:lnTo>
                    <a:pt x="3377438" y="1112393"/>
                  </a:lnTo>
                  <a:lnTo>
                    <a:pt x="3377438" y="508508"/>
                  </a:lnTo>
                  <a:close/>
                </a:path>
                <a:path w="4074159" h="1112520">
                  <a:moveTo>
                    <a:pt x="3435477" y="349631"/>
                  </a:moveTo>
                  <a:lnTo>
                    <a:pt x="3425063" y="349631"/>
                  </a:lnTo>
                  <a:lnTo>
                    <a:pt x="3425063" y="1112393"/>
                  </a:lnTo>
                  <a:lnTo>
                    <a:pt x="3435477" y="1112393"/>
                  </a:lnTo>
                  <a:lnTo>
                    <a:pt x="3435477" y="349631"/>
                  </a:lnTo>
                  <a:close/>
                </a:path>
                <a:path w="4074159" h="1112520">
                  <a:moveTo>
                    <a:pt x="3493516" y="445008"/>
                  </a:moveTo>
                  <a:lnTo>
                    <a:pt x="3483102" y="445008"/>
                  </a:lnTo>
                  <a:lnTo>
                    <a:pt x="3483102" y="1112393"/>
                  </a:lnTo>
                  <a:lnTo>
                    <a:pt x="3493516" y="1112393"/>
                  </a:lnTo>
                  <a:lnTo>
                    <a:pt x="3493516" y="445008"/>
                  </a:lnTo>
                  <a:close/>
                </a:path>
                <a:path w="4074159" h="1112520">
                  <a:moveTo>
                    <a:pt x="3551555" y="572135"/>
                  </a:moveTo>
                  <a:lnTo>
                    <a:pt x="3541141" y="572135"/>
                  </a:lnTo>
                  <a:lnTo>
                    <a:pt x="3541141" y="1112393"/>
                  </a:lnTo>
                  <a:lnTo>
                    <a:pt x="3551555" y="1112393"/>
                  </a:lnTo>
                  <a:lnTo>
                    <a:pt x="3551555" y="572135"/>
                  </a:lnTo>
                  <a:close/>
                </a:path>
                <a:path w="4074159" h="1112520">
                  <a:moveTo>
                    <a:pt x="3609594" y="413131"/>
                  </a:moveTo>
                  <a:lnTo>
                    <a:pt x="3599180" y="413131"/>
                  </a:lnTo>
                  <a:lnTo>
                    <a:pt x="3599180" y="1112393"/>
                  </a:lnTo>
                  <a:lnTo>
                    <a:pt x="3609594" y="1112393"/>
                  </a:lnTo>
                  <a:lnTo>
                    <a:pt x="3609594" y="413131"/>
                  </a:lnTo>
                  <a:close/>
                </a:path>
                <a:path w="4074159" h="1112520">
                  <a:moveTo>
                    <a:pt x="3667633" y="158877"/>
                  </a:moveTo>
                  <a:lnTo>
                    <a:pt x="3657219" y="158877"/>
                  </a:lnTo>
                  <a:lnTo>
                    <a:pt x="3657219" y="1112393"/>
                  </a:lnTo>
                  <a:lnTo>
                    <a:pt x="3667633" y="1112393"/>
                  </a:lnTo>
                  <a:lnTo>
                    <a:pt x="3667633" y="158877"/>
                  </a:lnTo>
                  <a:close/>
                </a:path>
                <a:path w="4074159" h="1112520">
                  <a:moveTo>
                    <a:pt x="3725672" y="317881"/>
                  </a:moveTo>
                  <a:lnTo>
                    <a:pt x="3715258" y="317881"/>
                  </a:lnTo>
                  <a:lnTo>
                    <a:pt x="3715258" y="1112393"/>
                  </a:lnTo>
                  <a:lnTo>
                    <a:pt x="3725672" y="1112393"/>
                  </a:lnTo>
                  <a:lnTo>
                    <a:pt x="3725672" y="317881"/>
                  </a:lnTo>
                  <a:close/>
                </a:path>
                <a:path w="4074159" h="1112520">
                  <a:moveTo>
                    <a:pt x="3783838" y="540258"/>
                  </a:moveTo>
                  <a:lnTo>
                    <a:pt x="3773424" y="540258"/>
                  </a:lnTo>
                  <a:lnTo>
                    <a:pt x="3773424" y="1112393"/>
                  </a:lnTo>
                  <a:lnTo>
                    <a:pt x="3783838" y="1112393"/>
                  </a:lnTo>
                  <a:lnTo>
                    <a:pt x="3783838" y="540258"/>
                  </a:lnTo>
                  <a:close/>
                </a:path>
                <a:path w="4074159" h="1112520">
                  <a:moveTo>
                    <a:pt x="3841877" y="603885"/>
                  </a:moveTo>
                  <a:lnTo>
                    <a:pt x="3831463" y="603885"/>
                  </a:lnTo>
                  <a:lnTo>
                    <a:pt x="3831463" y="1112393"/>
                  </a:lnTo>
                  <a:lnTo>
                    <a:pt x="3841877" y="1112393"/>
                  </a:lnTo>
                  <a:lnTo>
                    <a:pt x="3841877" y="603885"/>
                  </a:lnTo>
                  <a:close/>
                </a:path>
                <a:path w="4074159" h="1112520">
                  <a:moveTo>
                    <a:pt x="3899916" y="635635"/>
                  </a:moveTo>
                  <a:lnTo>
                    <a:pt x="3889502" y="635635"/>
                  </a:lnTo>
                  <a:lnTo>
                    <a:pt x="3889502" y="1112393"/>
                  </a:lnTo>
                  <a:lnTo>
                    <a:pt x="3899916" y="1112393"/>
                  </a:lnTo>
                  <a:lnTo>
                    <a:pt x="3899916" y="635635"/>
                  </a:lnTo>
                  <a:close/>
                </a:path>
                <a:path w="4074159" h="1112520">
                  <a:moveTo>
                    <a:pt x="3957955" y="635635"/>
                  </a:moveTo>
                  <a:lnTo>
                    <a:pt x="3947541" y="635635"/>
                  </a:lnTo>
                  <a:lnTo>
                    <a:pt x="3947541" y="1112393"/>
                  </a:lnTo>
                  <a:lnTo>
                    <a:pt x="3957955" y="1112393"/>
                  </a:lnTo>
                  <a:lnTo>
                    <a:pt x="3957955" y="635635"/>
                  </a:lnTo>
                  <a:close/>
                </a:path>
                <a:path w="4074159" h="1112520">
                  <a:moveTo>
                    <a:pt x="4015994" y="445008"/>
                  </a:moveTo>
                  <a:lnTo>
                    <a:pt x="4005580" y="445008"/>
                  </a:lnTo>
                  <a:lnTo>
                    <a:pt x="4005580" y="1112393"/>
                  </a:lnTo>
                  <a:lnTo>
                    <a:pt x="4015994" y="1112393"/>
                  </a:lnTo>
                  <a:lnTo>
                    <a:pt x="4015994" y="445008"/>
                  </a:lnTo>
                  <a:close/>
                </a:path>
                <a:path w="4074159" h="1112520">
                  <a:moveTo>
                    <a:pt x="4074033" y="731012"/>
                  </a:moveTo>
                  <a:lnTo>
                    <a:pt x="4063619" y="731012"/>
                  </a:lnTo>
                  <a:lnTo>
                    <a:pt x="4063619" y="1112393"/>
                  </a:lnTo>
                  <a:lnTo>
                    <a:pt x="4074033" y="1112393"/>
                  </a:lnTo>
                  <a:lnTo>
                    <a:pt x="4074033" y="731012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3" name="object 113" descr=""/>
            <p:cNvSpPr/>
            <p:nvPr/>
          </p:nvSpPr>
          <p:spPr>
            <a:xfrm>
              <a:off x="9262491" y="7708900"/>
              <a:ext cx="4079875" cy="953769"/>
            </a:xfrm>
            <a:custGeom>
              <a:avLst/>
              <a:gdLst/>
              <a:ahLst/>
              <a:cxnLst/>
              <a:rect l="l" t="t" r="r" b="b"/>
              <a:pathLst>
                <a:path w="4079875" h="953770">
                  <a:moveTo>
                    <a:pt x="10414" y="572135"/>
                  </a:moveTo>
                  <a:lnTo>
                    <a:pt x="0" y="572135"/>
                  </a:lnTo>
                  <a:lnTo>
                    <a:pt x="0" y="953516"/>
                  </a:lnTo>
                  <a:lnTo>
                    <a:pt x="10414" y="953516"/>
                  </a:lnTo>
                  <a:lnTo>
                    <a:pt x="10414" y="572135"/>
                  </a:lnTo>
                  <a:close/>
                </a:path>
                <a:path w="4079875" h="953770">
                  <a:moveTo>
                    <a:pt x="68453" y="190754"/>
                  </a:moveTo>
                  <a:lnTo>
                    <a:pt x="58039" y="190754"/>
                  </a:lnTo>
                  <a:lnTo>
                    <a:pt x="58039" y="953516"/>
                  </a:lnTo>
                  <a:lnTo>
                    <a:pt x="68453" y="953516"/>
                  </a:lnTo>
                  <a:lnTo>
                    <a:pt x="68453" y="190754"/>
                  </a:lnTo>
                  <a:close/>
                </a:path>
                <a:path w="4079875" h="953770">
                  <a:moveTo>
                    <a:pt x="126492" y="222504"/>
                  </a:moveTo>
                  <a:lnTo>
                    <a:pt x="116078" y="222504"/>
                  </a:lnTo>
                  <a:lnTo>
                    <a:pt x="116078" y="953516"/>
                  </a:lnTo>
                  <a:lnTo>
                    <a:pt x="126492" y="953516"/>
                  </a:lnTo>
                  <a:lnTo>
                    <a:pt x="126492" y="222504"/>
                  </a:lnTo>
                  <a:close/>
                </a:path>
                <a:path w="4079875" h="953770">
                  <a:moveTo>
                    <a:pt x="184531" y="508508"/>
                  </a:moveTo>
                  <a:lnTo>
                    <a:pt x="174117" y="508508"/>
                  </a:lnTo>
                  <a:lnTo>
                    <a:pt x="174117" y="953516"/>
                  </a:lnTo>
                  <a:lnTo>
                    <a:pt x="184531" y="953516"/>
                  </a:lnTo>
                  <a:lnTo>
                    <a:pt x="184531" y="508508"/>
                  </a:lnTo>
                  <a:close/>
                </a:path>
                <a:path w="4079875" h="953770">
                  <a:moveTo>
                    <a:pt x="242570" y="317881"/>
                  </a:moveTo>
                  <a:lnTo>
                    <a:pt x="232156" y="317881"/>
                  </a:lnTo>
                  <a:lnTo>
                    <a:pt x="232156" y="953516"/>
                  </a:lnTo>
                  <a:lnTo>
                    <a:pt x="242570" y="953516"/>
                  </a:lnTo>
                  <a:lnTo>
                    <a:pt x="242570" y="317881"/>
                  </a:lnTo>
                  <a:close/>
                </a:path>
                <a:path w="4079875" h="953770">
                  <a:moveTo>
                    <a:pt x="300736" y="286131"/>
                  </a:moveTo>
                  <a:lnTo>
                    <a:pt x="290322" y="286131"/>
                  </a:lnTo>
                  <a:lnTo>
                    <a:pt x="290322" y="953516"/>
                  </a:lnTo>
                  <a:lnTo>
                    <a:pt x="300736" y="953516"/>
                  </a:lnTo>
                  <a:lnTo>
                    <a:pt x="300736" y="286131"/>
                  </a:lnTo>
                  <a:close/>
                </a:path>
                <a:path w="4079875" h="953770">
                  <a:moveTo>
                    <a:pt x="358775" y="31877"/>
                  </a:moveTo>
                  <a:lnTo>
                    <a:pt x="348361" y="31877"/>
                  </a:lnTo>
                  <a:lnTo>
                    <a:pt x="348361" y="953516"/>
                  </a:lnTo>
                  <a:lnTo>
                    <a:pt x="358775" y="953516"/>
                  </a:lnTo>
                  <a:lnTo>
                    <a:pt x="358775" y="31877"/>
                  </a:lnTo>
                  <a:close/>
                </a:path>
                <a:path w="4079875" h="953770">
                  <a:moveTo>
                    <a:pt x="416814" y="127127"/>
                  </a:moveTo>
                  <a:lnTo>
                    <a:pt x="406400" y="127127"/>
                  </a:lnTo>
                  <a:lnTo>
                    <a:pt x="406400" y="953516"/>
                  </a:lnTo>
                  <a:lnTo>
                    <a:pt x="416814" y="953516"/>
                  </a:lnTo>
                  <a:lnTo>
                    <a:pt x="416814" y="127127"/>
                  </a:lnTo>
                  <a:close/>
                </a:path>
                <a:path w="4079875" h="953770">
                  <a:moveTo>
                    <a:pt x="474853" y="0"/>
                  </a:moveTo>
                  <a:lnTo>
                    <a:pt x="464439" y="0"/>
                  </a:lnTo>
                  <a:lnTo>
                    <a:pt x="464439" y="953516"/>
                  </a:lnTo>
                  <a:lnTo>
                    <a:pt x="474853" y="953516"/>
                  </a:lnTo>
                  <a:lnTo>
                    <a:pt x="474853" y="0"/>
                  </a:lnTo>
                  <a:close/>
                </a:path>
                <a:path w="4079875" h="953770">
                  <a:moveTo>
                    <a:pt x="532892" y="381381"/>
                  </a:moveTo>
                  <a:lnTo>
                    <a:pt x="522478" y="381381"/>
                  </a:lnTo>
                  <a:lnTo>
                    <a:pt x="522478" y="953516"/>
                  </a:lnTo>
                  <a:lnTo>
                    <a:pt x="532892" y="953516"/>
                  </a:lnTo>
                  <a:lnTo>
                    <a:pt x="532892" y="381381"/>
                  </a:lnTo>
                  <a:close/>
                </a:path>
                <a:path w="4079875" h="953770">
                  <a:moveTo>
                    <a:pt x="590931" y="572135"/>
                  </a:moveTo>
                  <a:lnTo>
                    <a:pt x="580517" y="572135"/>
                  </a:lnTo>
                  <a:lnTo>
                    <a:pt x="580517" y="953516"/>
                  </a:lnTo>
                  <a:lnTo>
                    <a:pt x="590931" y="953516"/>
                  </a:lnTo>
                  <a:lnTo>
                    <a:pt x="590931" y="572135"/>
                  </a:lnTo>
                  <a:close/>
                </a:path>
                <a:path w="4079875" h="953770">
                  <a:moveTo>
                    <a:pt x="648970" y="381381"/>
                  </a:moveTo>
                  <a:lnTo>
                    <a:pt x="638556" y="381381"/>
                  </a:lnTo>
                  <a:lnTo>
                    <a:pt x="638556" y="953516"/>
                  </a:lnTo>
                  <a:lnTo>
                    <a:pt x="648970" y="953516"/>
                  </a:lnTo>
                  <a:lnTo>
                    <a:pt x="648970" y="381381"/>
                  </a:lnTo>
                  <a:close/>
                </a:path>
                <a:path w="4079875" h="953770">
                  <a:moveTo>
                    <a:pt x="707009" y="476758"/>
                  </a:moveTo>
                  <a:lnTo>
                    <a:pt x="696595" y="476758"/>
                  </a:lnTo>
                  <a:lnTo>
                    <a:pt x="696595" y="953516"/>
                  </a:lnTo>
                  <a:lnTo>
                    <a:pt x="707009" y="953516"/>
                  </a:lnTo>
                  <a:lnTo>
                    <a:pt x="707009" y="476758"/>
                  </a:lnTo>
                  <a:close/>
                </a:path>
                <a:path w="4079875" h="953770">
                  <a:moveTo>
                    <a:pt x="765048" y="413258"/>
                  </a:moveTo>
                  <a:lnTo>
                    <a:pt x="754634" y="413258"/>
                  </a:lnTo>
                  <a:lnTo>
                    <a:pt x="754634" y="953516"/>
                  </a:lnTo>
                  <a:lnTo>
                    <a:pt x="765048" y="953516"/>
                  </a:lnTo>
                  <a:lnTo>
                    <a:pt x="765048" y="413258"/>
                  </a:lnTo>
                  <a:close/>
                </a:path>
                <a:path w="4079875" h="953770">
                  <a:moveTo>
                    <a:pt x="828421" y="635635"/>
                  </a:moveTo>
                  <a:lnTo>
                    <a:pt x="815340" y="635635"/>
                  </a:lnTo>
                  <a:lnTo>
                    <a:pt x="815340" y="953516"/>
                  </a:lnTo>
                  <a:lnTo>
                    <a:pt x="828421" y="953516"/>
                  </a:lnTo>
                  <a:lnTo>
                    <a:pt x="828421" y="635635"/>
                  </a:lnTo>
                  <a:close/>
                </a:path>
                <a:path w="4079875" h="953770">
                  <a:moveTo>
                    <a:pt x="881253" y="286131"/>
                  </a:moveTo>
                  <a:lnTo>
                    <a:pt x="870839" y="286131"/>
                  </a:lnTo>
                  <a:lnTo>
                    <a:pt x="870839" y="953516"/>
                  </a:lnTo>
                  <a:lnTo>
                    <a:pt x="881253" y="953516"/>
                  </a:lnTo>
                  <a:lnTo>
                    <a:pt x="881253" y="286131"/>
                  </a:lnTo>
                  <a:close/>
                </a:path>
                <a:path w="4079875" h="953770">
                  <a:moveTo>
                    <a:pt x="939292" y="413258"/>
                  </a:moveTo>
                  <a:lnTo>
                    <a:pt x="928878" y="413258"/>
                  </a:lnTo>
                  <a:lnTo>
                    <a:pt x="928878" y="953516"/>
                  </a:lnTo>
                  <a:lnTo>
                    <a:pt x="939292" y="953516"/>
                  </a:lnTo>
                  <a:lnTo>
                    <a:pt x="939292" y="413258"/>
                  </a:lnTo>
                  <a:close/>
                </a:path>
                <a:path w="4079875" h="953770">
                  <a:moveTo>
                    <a:pt x="997331" y="476758"/>
                  </a:moveTo>
                  <a:lnTo>
                    <a:pt x="986917" y="476758"/>
                  </a:lnTo>
                  <a:lnTo>
                    <a:pt x="986917" y="953516"/>
                  </a:lnTo>
                  <a:lnTo>
                    <a:pt x="997331" y="953516"/>
                  </a:lnTo>
                  <a:lnTo>
                    <a:pt x="997331" y="476758"/>
                  </a:lnTo>
                  <a:close/>
                </a:path>
                <a:path w="4079875" h="953770">
                  <a:moveTo>
                    <a:pt x="1055370" y="476758"/>
                  </a:moveTo>
                  <a:lnTo>
                    <a:pt x="1044956" y="476758"/>
                  </a:lnTo>
                  <a:lnTo>
                    <a:pt x="1044956" y="953516"/>
                  </a:lnTo>
                  <a:lnTo>
                    <a:pt x="1055370" y="953516"/>
                  </a:lnTo>
                  <a:lnTo>
                    <a:pt x="1055370" y="476758"/>
                  </a:lnTo>
                  <a:close/>
                </a:path>
                <a:path w="4079875" h="953770">
                  <a:moveTo>
                    <a:pt x="1113409" y="381381"/>
                  </a:moveTo>
                  <a:lnTo>
                    <a:pt x="1102995" y="381381"/>
                  </a:lnTo>
                  <a:lnTo>
                    <a:pt x="1102995" y="953516"/>
                  </a:lnTo>
                  <a:lnTo>
                    <a:pt x="1113409" y="953516"/>
                  </a:lnTo>
                  <a:lnTo>
                    <a:pt x="1113409" y="381381"/>
                  </a:lnTo>
                  <a:close/>
                </a:path>
                <a:path w="4079875" h="953770">
                  <a:moveTo>
                    <a:pt x="1171448" y="190754"/>
                  </a:moveTo>
                  <a:lnTo>
                    <a:pt x="1161034" y="190754"/>
                  </a:lnTo>
                  <a:lnTo>
                    <a:pt x="1161034" y="953516"/>
                  </a:lnTo>
                  <a:lnTo>
                    <a:pt x="1171448" y="953516"/>
                  </a:lnTo>
                  <a:lnTo>
                    <a:pt x="1171448" y="190754"/>
                  </a:lnTo>
                  <a:close/>
                </a:path>
                <a:path w="4079875" h="953770">
                  <a:moveTo>
                    <a:pt x="1229487" y="127127"/>
                  </a:moveTo>
                  <a:lnTo>
                    <a:pt x="1219073" y="127127"/>
                  </a:lnTo>
                  <a:lnTo>
                    <a:pt x="1219073" y="953516"/>
                  </a:lnTo>
                  <a:lnTo>
                    <a:pt x="1229487" y="953516"/>
                  </a:lnTo>
                  <a:lnTo>
                    <a:pt x="1229487" y="127127"/>
                  </a:lnTo>
                  <a:close/>
                </a:path>
                <a:path w="4079875" h="953770">
                  <a:moveTo>
                    <a:pt x="1292860" y="667512"/>
                  </a:moveTo>
                  <a:lnTo>
                    <a:pt x="1279779" y="667512"/>
                  </a:lnTo>
                  <a:lnTo>
                    <a:pt x="1279779" y="953516"/>
                  </a:lnTo>
                  <a:lnTo>
                    <a:pt x="1292860" y="953516"/>
                  </a:lnTo>
                  <a:lnTo>
                    <a:pt x="1292860" y="667512"/>
                  </a:lnTo>
                  <a:close/>
                </a:path>
                <a:path w="4079875" h="953770">
                  <a:moveTo>
                    <a:pt x="1345692" y="445008"/>
                  </a:moveTo>
                  <a:lnTo>
                    <a:pt x="1335278" y="445008"/>
                  </a:lnTo>
                  <a:lnTo>
                    <a:pt x="1335278" y="953516"/>
                  </a:lnTo>
                  <a:lnTo>
                    <a:pt x="1345692" y="953516"/>
                  </a:lnTo>
                  <a:lnTo>
                    <a:pt x="1345692" y="445008"/>
                  </a:lnTo>
                  <a:close/>
                </a:path>
                <a:path w="4079875" h="953770">
                  <a:moveTo>
                    <a:pt x="1403731" y="445008"/>
                  </a:moveTo>
                  <a:lnTo>
                    <a:pt x="1393317" y="445008"/>
                  </a:lnTo>
                  <a:lnTo>
                    <a:pt x="1393317" y="953516"/>
                  </a:lnTo>
                  <a:lnTo>
                    <a:pt x="1403731" y="953516"/>
                  </a:lnTo>
                  <a:lnTo>
                    <a:pt x="1403731" y="445008"/>
                  </a:lnTo>
                  <a:close/>
                </a:path>
                <a:path w="4079875" h="953770">
                  <a:moveTo>
                    <a:pt x="1461770" y="508508"/>
                  </a:moveTo>
                  <a:lnTo>
                    <a:pt x="1451356" y="508508"/>
                  </a:lnTo>
                  <a:lnTo>
                    <a:pt x="1451356" y="953516"/>
                  </a:lnTo>
                  <a:lnTo>
                    <a:pt x="1461770" y="953516"/>
                  </a:lnTo>
                  <a:lnTo>
                    <a:pt x="1461770" y="508508"/>
                  </a:lnTo>
                  <a:close/>
                </a:path>
                <a:path w="4079875" h="953770">
                  <a:moveTo>
                    <a:pt x="1519809" y="317881"/>
                  </a:moveTo>
                  <a:lnTo>
                    <a:pt x="1509395" y="317881"/>
                  </a:lnTo>
                  <a:lnTo>
                    <a:pt x="1509395" y="953516"/>
                  </a:lnTo>
                  <a:lnTo>
                    <a:pt x="1519809" y="953516"/>
                  </a:lnTo>
                  <a:lnTo>
                    <a:pt x="1519809" y="317881"/>
                  </a:lnTo>
                  <a:close/>
                </a:path>
                <a:path w="4079875" h="953770">
                  <a:moveTo>
                    <a:pt x="1577848" y="603885"/>
                  </a:moveTo>
                  <a:lnTo>
                    <a:pt x="1567434" y="603885"/>
                  </a:lnTo>
                  <a:lnTo>
                    <a:pt x="1567434" y="953516"/>
                  </a:lnTo>
                  <a:lnTo>
                    <a:pt x="1577848" y="953516"/>
                  </a:lnTo>
                  <a:lnTo>
                    <a:pt x="1577848" y="603885"/>
                  </a:lnTo>
                  <a:close/>
                </a:path>
                <a:path w="4079875" h="953770">
                  <a:moveTo>
                    <a:pt x="1635887" y="286131"/>
                  </a:moveTo>
                  <a:lnTo>
                    <a:pt x="1625473" y="286131"/>
                  </a:lnTo>
                  <a:lnTo>
                    <a:pt x="1625473" y="953516"/>
                  </a:lnTo>
                  <a:lnTo>
                    <a:pt x="1635887" y="953516"/>
                  </a:lnTo>
                  <a:lnTo>
                    <a:pt x="1635887" y="286131"/>
                  </a:lnTo>
                  <a:close/>
                </a:path>
                <a:path w="4079875" h="953770">
                  <a:moveTo>
                    <a:pt x="1693926" y="286131"/>
                  </a:moveTo>
                  <a:lnTo>
                    <a:pt x="1683512" y="286131"/>
                  </a:lnTo>
                  <a:lnTo>
                    <a:pt x="1683512" y="953516"/>
                  </a:lnTo>
                  <a:lnTo>
                    <a:pt x="1693926" y="953516"/>
                  </a:lnTo>
                  <a:lnTo>
                    <a:pt x="1693926" y="286131"/>
                  </a:lnTo>
                  <a:close/>
                </a:path>
                <a:path w="4079875" h="953770">
                  <a:moveTo>
                    <a:pt x="1751965" y="317881"/>
                  </a:moveTo>
                  <a:lnTo>
                    <a:pt x="1741551" y="317881"/>
                  </a:lnTo>
                  <a:lnTo>
                    <a:pt x="1741551" y="953516"/>
                  </a:lnTo>
                  <a:lnTo>
                    <a:pt x="1751965" y="953516"/>
                  </a:lnTo>
                  <a:lnTo>
                    <a:pt x="1751965" y="317881"/>
                  </a:lnTo>
                  <a:close/>
                </a:path>
                <a:path w="4079875" h="953770">
                  <a:moveTo>
                    <a:pt x="1810004" y="540385"/>
                  </a:moveTo>
                  <a:lnTo>
                    <a:pt x="1799590" y="540385"/>
                  </a:lnTo>
                  <a:lnTo>
                    <a:pt x="1799590" y="953516"/>
                  </a:lnTo>
                  <a:lnTo>
                    <a:pt x="1810004" y="953516"/>
                  </a:lnTo>
                  <a:lnTo>
                    <a:pt x="1810004" y="540385"/>
                  </a:lnTo>
                  <a:close/>
                </a:path>
                <a:path w="4079875" h="953770">
                  <a:moveTo>
                    <a:pt x="1873364" y="476758"/>
                  </a:moveTo>
                  <a:lnTo>
                    <a:pt x="1860296" y="476758"/>
                  </a:lnTo>
                  <a:lnTo>
                    <a:pt x="1860296" y="953516"/>
                  </a:lnTo>
                  <a:lnTo>
                    <a:pt x="1873364" y="953516"/>
                  </a:lnTo>
                  <a:lnTo>
                    <a:pt x="1873364" y="476758"/>
                  </a:lnTo>
                  <a:close/>
                </a:path>
                <a:path w="4079875" h="953770">
                  <a:moveTo>
                    <a:pt x="1926209" y="286131"/>
                  </a:moveTo>
                  <a:lnTo>
                    <a:pt x="1915795" y="286131"/>
                  </a:lnTo>
                  <a:lnTo>
                    <a:pt x="1915795" y="953516"/>
                  </a:lnTo>
                  <a:lnTo>
                    <a:pt x="1926209" y="953516"/>
                  </a:lnTo>
                  <a:lnTo>
                    <a:pt x="1926209" y="286131"/>
                  </a:lnTo>
                  <a:close/>
                </a:path>
                <a:path w="4079875" h="953770">
                  <a:moveTo>
                    <a:pt x="1984248" y="413258"/>
                  </a:moveTo>
                  <a:lnTo>
                    <a:pt x="1973834" y="413258"/>
                  </a:lnTo>
                  <a:lnTo>
                    <a:pt x="1973834" y="953516"/>
                  </a:lnTo>
                  <a:lnTo>
                    <a:pt x="1984248" y="953516"/>
                  </a:lnTo>
                  <a:lnTo>
                    <a:pt x="1984248" y="413258"/>
                  </a:lnTo>
                  <a:close/>
                </a:path>
                <a:path w="4079875" h="953770">
                  <a:moveTo>
                    <a:pt x="2042287" y="317881"/>
                  </a:moveTo>
                  <a:lnTo>
                    <a:pt x="2031873" y="317881"/>
                  </a:lnTo>
                  <a:lnTo>
                    <a:pt x="2031873" y="953516"/>
                  </a:lnTo>
                  <a:lnTo>
                    <a:pt x="2042287" y="953516"/>
                  </a:lnTo>
                  <a:lnTo>
                    <a:pt x="2042287" y="317881"/>
                  </a:lnTo>
                  <a:close/>
                </a:path>
                <a:path w="4079875" h="953770">
                  <a:moveTo>
                    <a:pt x="2100326" y="667512"/>
                  </a:moveTo>
                  <a:lnTo>
                    <a:pt x="2089912" y="667512"/>
                  </a:lnTo>
                  <a:lnTo>
                    <a:pt x="2089912" y="953516"/>
                  </a:lnTo>
                  <a:lnTo>
                    <a:pt x="2100326" y="953516"/>
                  </a:lnTo>
                  <a:lnTo>
                    <a:pt x="2100326" y="667512"/>
                  </a:lnTo>
                  <a:close/>
                </a:path>
                <a:path w="4079875" h="953770">
                  <a:moveTo>
                    <a:pt x="2158365" y="95377"/>
                  </a:moveTo>
                  <a:lnTo>
                    <a:pt x="2147951" y="95377"/>
                  </a:lnTo>
                  <a:lnTo>
                    <a:pt x="2147951" y="953516"/>
                  </a:lnTo>
                  <a:lnTo>
                    <a:pt x="2158365" y="953516"/>
                  </a:lnTo>
                  <a:lnTo>
                    <a:pt x="2158365" y="95377"/>
                  </a:lnTo>
                  <a:close/>
                </a:path>
                <a:path w="4079875" h="953770">
                  <a:moveTo>
                    <a:pt x="2216404" y="413258"/>
                  </a:moveTo>
                  <a:lnTo>
                    <a:pt x="2205990" y="413258"/>
                  </a:lnTo>
                  <a:lnTo>
                    <a:pt x="2205990" y="953516"/>
                  </a:lnTo>
                  <a:lnTo>
                    <a:pt x="2216404" y="953516"/>
                  </a:lnTo>
                  <a:lnTo>
                    <a:pt x="2216404" y="413258"/>
                  </a:lnTo>
                  <a:close/>
                </a:path>
                <a:path w="4079875" h="953770">
                  <a:moveTo>
                    <a:pt x="2274443" y="699262"/>
                  </a:moveTo>
                  <a:lnTo>
                    <a:pt x="2264029" y="699262"/>
                  </a:lnTo>
                  <a:lnTo>
                    <a:pt x="2264029" y="953516"/>
                  </a:lnTo>
                  <a:lnTo>
                    <a:pt x="2274443" y="953516"/>
                  </a:lnTo>
                  <a:lnTo>
                    <a:pt x="2274443" y="699262"/>
                  </a:lnTo>
                  <a:close/>
                </a:path>
                <a:path w="4079875" h="953770">
                  <a:moveTo>
                    <a:pt x="2332482" y="603885"/>
                  </a:moveTo>
                  <a:lnTo>
                    <a:pt x="2322068" y="603885"/>
                  </a:lnTo>
                  <a:lnTo>
                    <a:pt x="2322068" y="953516"/>
                  </a:lnTo>
                  <a:lnTo>
                    <a:pt x="2332482" y="953516"/>
                  </a:lnTo>
                  <a:lnTo>
                    <a:pt x="2332482" y="603885"/>
                  </a:lnTo>
                  <a:close/>
                </a:path>
                <a:path w="4079875" h="953770">
                  <a:moveTo>
                    <a:pt x="2390521" y="445008"/>
                  </a:moveTo>
                  <a:lnTo>
                    <a:pt x="2380107" y="445008"/>
                  </a:lnTo>
                  <a:lnTo>
                    <a:pt x="2380107" y="953516"/>
                  </a:lnTo>
                  <a:lnTo>
                    <a:pt x="2390521" y="953516"/>
                  </a:lnTo>
                  <a:lnTo>
                    <a:pt x="2390521" y="445008"/>
                  </a:lnTo>
                  <a:close/>
                </a:path>
                <a:path w="4079875" h="953770">
                  <a:moveTo>
                    <a:pt x="2453894" y="540385"/>
                  </a:moveTo>
                  <a:lnTo>
                    <a:pt x="2440813" y="540385"/>
                  </a:lnTo>
                  <a:lnTo>
                    <a:pt x="2440813" y="953516"/>
                  </a:lnTo>
                  <a:lnTo>
                    <a:pt x="2453894" y="953516"/>
                  </a:lnTo>
                  <a:lnTo>
                    <a:pt x="2453894" y="540385"/>
                  </a:lnTo>
                  <a:close/>
                </a:path>
                <a:path w="4079875" h="953770">
                  <a:moveTo>
                    <a:pt x="2506726" y="508508"/>
                  </a:moveTo>
                  <a:lnTo>
                    <a:pt x="2496312" y="508508"/>
                  </a:lnTo>
                  <a:lnTo>
                    <a:pt x="2496312" y="953516"/>
                  </a:lnTo>
                  <a:lnTo>
                    <a:pt x="2506726" y="953516"/>
                  </a:lnTo>
                  <a:lnTo>
                    <a:pt x="2506726" y="508508"/>
                  </a:lnTo>
                  <a:close/>
                </a:path>
                <a:path w="4079875" h="953770">
                  <a:moveTo>
                    <a:pt x="2564765" y="540385"/>
                  </a:moveTo>
                  <a:lnTo>
                    <a:pt x="2554351" y="540385"/>
                  </a:lnTo>
                  <a:lnTo>
                    <a:pt x="2554351" y="953516"/>
                  </a:lnTo>
                  <a:lnTo>
                    <a:pt x="2564765" y="953516"/>
                  </a:lnTo>
                  <a:lnTo>
                    <a:pt x="2564765" y="540385"/>
                  </a:lnTo>
                  <a:close/>
                </a:path>
                <a:path w="4079875" h="953770">
                  <a:moveTo>
                    <a:pt x="2628011" y="826389"/>
                  </a:moveTo>
                  <a:lnTo>
                    <a:pt x="2614930" y="826389"/>
                  </a:lnTo>
                  <a:lnTo>
                    <a:pt x="2614930" y="953516"/>
                  </a:lnTo>
                  <a:lnTo>
                    <a:pt x="2628011" y="953516"/>
                  </a:lnTo>
                  <a:lnTo>
                    <a:pt x="2628011" y="826389"/>
                  </a:lnTo>
                  <a:close/>
                </a:path>
                <a:path w="4079875" h="953770">
                  <a:moveTo>
                    <a:pt x="2680843" y="731012"/>
                  </a:moveTo>
                  <a:lnTo>
                    <a:pt x="2670429" y="731012"/>
                  </a:lnTo>
                  <a:lnTo>
                    <a:pt x="2670429" y="953516"/>
                  </a:lnTo>
                  <a:lnTo>
                    <a:pt x="2680843" y="953516"/>
                  </a:lnTo>
                  <a:lnTo>
                    <a:pt x="2680843" y="731012"/>
                  </a:lnTo>
                  <a:close/>
                </a:path>
                <a:path w="4079875" h="953770">
                  <a:moveTo>
                    <a:pt x="2738882" y="699262"/>
                  </a:moveTo>
                  <a:lnTo>
                    <a:pt x="2728468" y="699262"/>
                  </a:lnTo>
                  <a:lnTo>
                    <a:pt x="2728468" y="953516"/>
                  </a:lnTo>
                  <a:lnTo>
                    <a:pt x="2738882" y="953516"/>
                  </a:lnTo>
                  <a:lnTo>
                    <a:pt x="2738882" y="699262"/>
                  </a:lnTo>
                  <a:close/>
                </a:path>
                <a:path w="4079875" h="953770">
                  <a:moveTo>
                    <a:pt x="2796921" y="667512"/>
                  </a:moveTo>
                  <a:lnTo>
                    <a:pt x="2786507" y="667512"/>
                  </a:lnTo>
                  <a:lnTo>
                    <a:pt x="2786507" y="953516"/>
                  </a:lnTo>
                  <a:lnTo>
                    <a:pt x="2796921" y="953516"/>
                  </a:lnTo>
                  <a:lnTo>
                    <a:pt x="2796921" y="667512"/>
                  </a:lnTo>
                  <a:close/>
                </a:path>
                <a:path w="4079875" h="953770">
                  <a:moveTo>
                    <a:pt x="2860294" y="667512"/>
                  </a:moveTo>
                  <a:lnTo>
                    <a:pt x="2847213" y="667512"/>
                  </a:lnTo>
                  <a:lnTo>
                    <a:pt x="2847213" y="953516"/>
                  </a:lnTo>
                  <a:lnTo>
                    <a:pt x="2860294" y="953516"/>
                  </a:lnTo>
                  <a:lnTo>
                    <a:pt x="2860294" y="667512"/>
                  </a:lnTo>
                  <a:close/>
                </a:path>
                <a:path w="4079875" h="953770">
                  <a:moveTo>
                    <a:pt x="2912999" y="667512"/>
                  </a:moveTo>
                  <a:lnTo>
                    <a:pt x="2902585" y="667512"/>
                  </a:lnTo>
                  <a:lnTo>
                    <a:pt x="2902585" y="953516"/>
                  </a:lnTo>
                  <a:lnTo>
                    <a:pt x="2912999" y="953516"/>
                  </a:lnTo>
                  <a:lnTo>
                    <a:pt x="2912999" y="667512"/>
                  </a:lnTo>
                  <a:close/>
                </a:path>
                <a:path w="4079875" h="953770">
                  <a:moveTo>
                    <a:pt x="2971038" y="889889"/>
                  </a:moveTo>
                  <a:lnTo>
                    <a:pt x="2960624" y="889889"/>
                  </a:lnTo>
                  <a:lnTo>
                    <a:pt x="2960624" y="953516"/>
                  </a:lnTo>
                  <a:lnTo>
                    <a:pt x="2971038" y="953516"/>
                  </a:lnTo>
                  <a:lnTo>
                    <a:pt x="2971038" y="889889"/>
                  </a:lnTo>
                  <a:close/>
                </a:path>
                <a:path w="4079875" h="953770">
                  <a:moveTo>
                    <a:pt x="3029204" y="381381"/>
                  </a:moveTo>
                  <a:lnTo>
                    <a:pt x="3018790" y="381381"/>
                  </a:lnTo>
                  <a:lnTo>
                    <a:pt x="3018790" y="953516"/>
                  </a:lnTo>
                  <a:lnTo>
                    <a:pt x="3029204" y="953516"/>
                  </a:lnTo>
                  <a:lnTo>
                    <a:pt x="3029204" y="381381"/>
                  </a:lnTo>
                  <a:close/>
                </a:path>
                <a:path w="4079875" h="953770">
                  <a:moveTo>
                    <a:pt x="3087243" y="381381"/>
                  </a:moveTo>
                  <a:lnTo>
                    <a:pt x="3076829" y="381381"/>
                  </a:lnTo>
                  <a:lnTo>
                    <a:pt x="3076829" y="953516"/>
                  </a:lnTo>
                  <a:lnTo>
                    <a:pt x="3087243" y="953516"/>
                  </a:lnTo>
                  <a:lnTo>
                    <a:pt x="3087243" y="381381"/>
                  </a:lnTo>
                  <a:close/>
                </a:path>
                <a:path w="4079875" h="953770">
                  <a:moveTo>
                    <a:pt x="3145282" y="222504"/>
                  </a:moveTo>
                  <a:lnTo>
                    <a:pt x="3134868" y="222504"/>
                  </a:lnTo>
                  <a:lnTo>
                    <a:pt x="3134868" y="953516"/>
                  </a:lnTo>
                  <a:lnTo>
                    <a:pt x="3145282" y="953516"/>
                  </a:lnTo>
                  <a:lnTo>
                    <a:pt x="3145282" y="222504"/>
                  </a:lnTo>
                  <a:close/>
                </a:path>
                <a:path w="4079875" h="953770">
                  <a:moveTo>
                    <a:pt x="3203321" y="540385"/>
                  </a:moveTo>
                  <a:lnTo>
                    <a:pt x="3192907" y="540385"/>
                  </a:lnTo>
                  <a:lnTo>
                    <a:pt x="3192907" y="953516"/>
                  </a:lnTo>
                  <a:lnTo>
                    <a:pt x="3203321" y="953516"/>
                  </a:lnTo>
                  <a:lnTo>
                    <a:pt x="3203321" y="540385"/>
                  </a:lnTo>
                  <a:close/>
                </a:path>
                <a:path w="4079875" h="953770">
                  <a:moveTo>
                    <a:pt x="3261360" y="699262"/>
                  </a:moveTo>
                  <a:lnTo>
                    <a:pt x="3250946" y="699262"/>
                  </a:lnTo>
                  <a:lnTo>
                    <a:pt x="3250946" y="953516"/>
                  </a:lnTo>
                  <a:lnTo>
                    <a:pt x="3261360" y="953516"/>
                  </a:lnTo>
                  <a:lnTo>
                    <a:pt x="3261360" y="699262"/>
                  </a:lnTo>
                  <a:close/>
                </a:path>
                <a:path w="4079875" h="953770">
                  <a:moveTo>
                    <a:pt x="3324733" y="572135"/>
                  </a:moveTo>
                  <a:lnTo>
                    <a:pt x="3311652" y="572135"/>
                  </a:lnTo>
                  <a:lnTo>
                    <a:pt x="3311652" y="953516"/>
                  </a:lnTo>
                  <a:lnTo>
                    <a:pt x="3324733" y="953516"/>
                  </a:lnTo>
                  <a:lnTo>
                    <a:pt x="3324733" y="572135"/>
                  </a:lnTo>
                  <a:close/>
                </a:path>
                <a:path w="4079875" h="953770">
                  <a:moveTo>
                    <a:pt x="3382759" y="603885"/>
                  </a:moveTo>
                  <a:lnTo>
                    <a:pt x="3369691" y="603885"/>
                  </a:lnTo>
                  <a:lnTo>
                    <a:pt x="3369691" y="953516"/>
                  </a:lnTo>
                  <a:lnTo>
                    <a:pt x="3382759" y="953516"/>
                  </a:lnTo>
                  <a:lnTo>
                    <a:pt x="3382759" y="603885"/>
                  </a:lnTo>
                  <a:close/>
                </a:path>
                <a:path w="4079875" h="953770">
                  <a:moveTo>
                    <a:pt x="3435477" y="317881"/>
                  </a:moveTo>
                  <a:lnTo>
                    <a:pt x="3425063" y="317881"/>
                  </a:lnTo>
                  <a:lnTo>
                    <a:pt x="3425063" y="953516"/>
                  </a:lnTo>
                  <a:lnTo>
                    <a:pt x="3435477" y="953516"/>
                  </a:lnTo>
                  <a:lnTo>
                    <a:pt x="3435477" y="317881"/>
                  </a:lnTo>
                  <a:close/>
                </a:path>
                <a:path w="4079875" h="953770">
                  <a:moveTo>
                    <a:pt x="3493516" y="603885"/>
                  </a:moveTo>
                  <a:lnTo>
                    <a:pt x="3483102" y="603885"/>
                  </a:lnTo>
                  <a:lnTo>
                    <a:pt x="3483102" y="953516"/>
                  </a:lnTo>
                  <a:lnTo>
                    <a:pt x="3493516" y="953516"/>
                  </a:lnTo>
                  <a:lnTo>
                    <a:pt x="3493516" y="603885"/>
                  </a:lnTo>
                  <a:close/>
                </a:path>
                <a:path w="4079875" h="953770">
                  <a:moveTo>
                    <a:pt x="3551682" y="540385"/>
                  </a:moveTo>
                  <a:lnTo>
                    <a:pt x="3541268" y="540385"/>
                  </a:lnTo>
                  <a:lnTo>
                    <a:pt x="3541268" y="953516"/>
                  </a:lnTo>
                  <a:lnTo>
                    <a:pt x="3551682" y="953516"/>
                  </a:lnTo>
                  <a:lnTo>
                    <a:pt x="3551682" y="540385"/>
                  </a:lnTo>
                  <a:close/>
                </a:path>
                <a:path w="4079875" h="953770">
                  <a:moveTo>
                    <a:pt x="3609721" y="699262"/>
                  </a:moveTo>
                  <a:lnTo>
                    <a:pt x="3599307" y="699262"/>
                  </a:lnTo>
                  <a:lnTo>
                    <a:pt x="3599307" y="953516"/>
                  </a:lnTo>
                  <a:lnTo>
                    <a:pt x="3609721" y="953516"/>
                  </a:lnTo>
                  <a:lnTo>
                    <a:pt x="3609721" y="699262"/>
                  </a:lnTo>
                  <a:close/>
                </a:path>
                <a:path w="4079875" h="953770">
                  <a:moveTo>
                    <a:pt x="3667760" y="762762"/>
                  </a:moveTo>
                  <a:lnTo>
                    <a:pt x="3657346" y="762762"/>
                  </a:lnTo>
                  <a:lnTo>
                    <a:pt x="3657346" y="953516"/>
                  </a:lnTo>
                  <a:lnTo>
                    <a:pt x="3667760" y="953516"/>
                  </a:lnTo>
                  <a:lnTo>
                    <a:pt x="3667760" y="762762"/>
                  </a:lnTo>
                  <a:close/>
                </a:path>
                <a:path w="4079875" h="953770">
                  <a:moveTo>
                    <a:pt x="3725799" y="699262"/>
                  </a:moveTo>
                  <a:lnTo>
                    <a:pt x="3715385" y="699262"/>
                  </a:lnTo>
                  <a:lnTo>
                    <a:pt x="3715385" y="953516"/>
                  </a:lnTo>
                  <a:lnTo>
                    <a:pt x="3725799" y="953516"/>
                  </a:lnTo>
                  <a:lnTo>
                    <a:pt x="3725799" y="699262"/>
                  </a:lnTo>
                  <a:close/>
                </a:path>
                <a:path w="4079875" h="953770">
                  <a:moveTo>
                    <a:pt x="3783838" y="635635"/>
                  </a:moveTo>
                  <a:lnTo>
                    <a:pt x="3773424" y="635635"/>
                  </a:lnTo>
                  <a:lnTo>
                    <a:pt x="3773424" y="953516"/>
                  </a:lnTo>
                  <a:lnTo>
                    <a:pt x="3783838" y="953516"/>
                  </a:lnTo>
                  <a:lnTo>
                    <a:pt x="3783838" y="635635"/>
                  </a:lnTo>
                  <a:close/>
                </a:path>
                <a:path w="4079875" h="953770">
                  <a:moveTo>
                    <a:pt x="3847211" y="508508"/>
                  </a:moveTo>
                  <a:lnTo>
                    <a:pt x="3834130" y="508508"/>
                  </a:lnTo>
                  <a:lnTo>
                    <a:pt x="3834130" y="953516"/>
                  </a:lnTo>
                  <a:lnTo>
                    <a:pt x="3847211" y="953516"/>
                  </a:lnTo>
                  <a:lnTo>
                    <a:pt x="3847211" y="508508"/>
                  </a:lnTo>
                  <a:close/>
                </a:path>
                <a:path w="4079875" h="953770">
                  <a:moveTo>
                    <a:pt x="3899903" y="667512"/>
                  </a:moveTo>
                  <a:lnTo>
                    <a:pt x="3889489" y="667512"/>
                  </a:lnTo>
                  <a:lnTo>
                    <a:pt x="3889489" y="953516"/>
                  </a:lnTo>
                  <a:lnTo>
                    <a:pt x="3899903" y="953516"/>
                  </a:lnTo>
                  <a:lnTo>
                    <a:pt x="3899903" y="667512"/>
                  </a:lnTo>
                  <a:close/>
                </a:path>
                <a:path w="4079875" h="953770">
                  <a:moveTo>
                    <a:pt x="3963276" y="826389"/>
                  </a:moveTo>
                  <a:lnTo>
                    <a:pt x="3950195" y="826389"/>
                  </a:lnTo>
                  <a:lnTo>
                    <a:pt x="3950195" y="953516"/>
                  </a:lnTo>
                  <a:lnTo>
                    <a:pt x="3963276" y="953516"/>
                  </a:lnTo>
                  <a:lnTo>
                    <a:pt x="3963276" y="826389"/>
                  </a:lnTo>
                  <a:close/>
                </a:path>
                <a:path w="4079875" h="953770">
                  <a:moveTo>
                    <a:pt x="4029951" y="731012"/>
                  </a:moveTo>
                  <a:lnTo>
                    <a:pt x="4012565" y="731012"/>
                  </a:lnTo>
                  <a:lnTo>
                    <a:pt x="4012565" y="953516"/>
                  </a:lnTo>
                  <a:lnTo>
                    <a:pt x="4029951" y="953516"/>
                  </a:lnTo>
                  <a:lnTo>
                    <a:pt x="4029951" y="731012"/>
                  </a:lnTo>
                  <a:close/>
                </a:path>
                <a:path w="4079875" h="953770">
                  <a:moveTo>
                    <a:pt x="4079367" y="476758"/>
                  </a:moveTo>
                  <a:lnTo>
                    <a:pt x="4066286" y="476758"/>
                  </a:lnTo>
                  <a:lnTo>
                    <a:pt x="4066286" y="953516"/>
                  </a:lnTo>
                  <a:lnTo>
                    <a:pt x="4079367" y="953516"/>
                  </a:lnTo>
                  <a:lnTo>
                    <a:pt x="4079367" y="476758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4" name="object 114" descr=""/>
            <p:cNvSpPr/>
            <p:nvPr/>
          </p:nvSpPr>
          <p:spPr>
            <a:xfrm>
              <a:off x="13328777" y="7899654"/>
              <a:ext cx="2277110" cy="763270"/>
            </a:xfrm>
            <a:custGeom>
              <a:avLst/>
              <a:gdLst/>
              <a:ahLst/>
              <a:cxnLst/>
              <a:rect l="l" t="t" r="r" b="b"/>
              <a:pathLst>
                <a:path w="2277109" h="763270">
                  <a:moveTo>
                    <a:pt x="13081" y="286004"/>
                  </a:moveTo>
                  <a:lnTo>
                    <a:pt x="0" y="286004"/>
                  </a:lnTo>
                  <a:lnTo>
                    <a:pt x="0" y="762762"/>
                  </a:lnTo>
                  <a:lnTo>
                    <a:pt x="13081" y="762762"/>
                  </a:lnTo>
                  <a:lnTo>
                    <a:pt x="13081" y="286004"/>
                  </a:lnTo>
                  <a:close/>
                </a:path>
                <a:path w="2277109" h="763270">
                  <a:moveTo>
                    <a:pt x="65913" y="349631"/>
                  </a:moveTo>
                  <a:lnTo>
                    <a:pt x="55499" y="349631"/>
                  </a:lnTo>
                  <a:lnTo>
                    <a:pt x="55499" y="762762"/>
                  </a:lnTo>
                  <a:lnTo>
                    <a:pt x="65913" y="762762"/>
                  </a:lnTo>
                  <a:lnTo>
                    <a:pt x="65913" y="349631"/>
                  </a:lnTo>
                  <a:close/>
                </a:path>
                <a:path w="2277109" h="763270">
                  <a:moveTo>
                    <a:pt x="123952" y="317754"/>
                  </a:moveTo>
                  <a:lnTo>
                    <a:pt x="113538" y="317754"/>
                  </a:lnTo>
                  <a:lnTo>
                    <a:pt x="113538" y="762762"/>
                  </a:lnTo>
                  <a:lnTo>
                    <a:pt x="123952" y="762762"/>
                  </a:lnTo>
                  <a:lnTo>
                    <a:pt x="123952" y="317754"/>
                  </a:lnTo>
                  <a:close/>
                </a:path>
                <a:path w="2277109" h="763270">
                  <a:moveTo>
                    <a:pt x="187198" y="63500"/>
                  </a:moveTo>
                  <a:lnTo>
                    <a:pt x="174117" y="63500"/>
                  </a:lnTo>
                  <a:lnTo>
                    <a:pt x="174117" y="762762"/>
                  </a:lnTo>
                  <a:lnTo>
                    <a:pt x="187198" y="762762"/>
                  </a:lnTo>
                  <a:lnTo>
                    <a:pt x="187198" y="63500"/>
                  </a:lnTo>
                  <a:close/>
                </a:path>
                <a:path w="2277109" h="763270">
                  <a:moveTo>
                    <a:pt x="245364" y="572008"/>
                  </a:moveTo>
                  <a:lnTo>
                    <a:pt x="232283" y="572008"/>
                  </a:lnTo>
                  <a:lnTo>
                    <a:pt x="232283" y="762762"/>
                  </a:lnTo>
                  <a:lnTo>
                    <a:pt x="245364" y="762762"/>
                  </a:lnTo>
                  <a:lnTo>
                    <a:pt x="245364" y="572008"/>
                  </a:lnTo>
                  <a:close/>
                </a:path>
                <a:path w="2277109" h="763270">
                  <a:moveTo>
                    <a:pt x="303390" y="635635"/>
                  </a:moveTo>
                  <a:lnTo>
                    <a:pt x="290322" y="635635"/>
                  </a:lnTo>
                  <a:lnTo>
                    <a:pt x="290322" y="762762"/>
                  </a:lnTo>
                  <a:lnTo>
                    <a:pt x="303390" y="762762"/>
                  </a:lnTo>
                  <a:lnTo>
                    <a:pt x="303390" y="635635"/>
                  </a:lnTo>
                  <a:close/>
                </a:path>
                <a:path w="2277109" h="763270">
                  <a:moveTo>
                    <a:pt x="361442" y="286004"/>
                  </a:moveTo>
                  <a:lnTo>
                    <a:pt x="348361" y="286004"/>
                  </a:lnTo>
                  <a:lnTo>
                    <a:pt x="348361" y="762762"/>
                  </a:lnTo>
                  <a:lnTo>
                    <a:pt x="361442" y="762762"/>
                  </a:lnTo>
                  <a:lnTo>
                    <a:pt x="361442" y="286004"/>
                  </a:lnTo>
                  <a:close/>
                </a:path>
                <a:path w="2277109" h="763270">
                  <a:moveTo>
                    <a:pt x="419481" y="158877"/>
                  </a:moveTo>
                  <a:lnTo>
                    <a:pt x="406400" y="158877"/>
                  </a:lnTo>
                  <a:lnTo>
                    <a:pt x="406400" y="762762"/>
                  </a:lnTo>
                  <a:lnTo>
                    <a:pt x="419481" y="762762"/>
                  </a:lnTo>
                  <a:lnTo>
                    <a:pt x="419481" y="158877"/>
                  </a:lnTo>
                  <a:close/>
                </a:path>
                <a:path w="2277109" h="763270">
                  <a:moveTo>
                    <a:pt x="477520" y="286004"/>
                  </a:moveTo>
                  <a:lnTo>
                    <a:pt x="464439" y="286004"/>
                  </a:lnTo>
                  <a:lnTo>
                    <a:pt x="464439" y="762762"/>
                  </a:lnTo>
                  <a:lnTo>
                    <a:pt x="477520" y="762762"/>
                  </a:lnTo>
                  <a:lnTo>
                    <a:pt x="477520" y="286004"/>
                  </a:lnTo>
                  <a:close/>
                </a:path>
                <a:path w="2277109" h="763270">
                  <a:moveTo>
                    <a:pt x="530225" y="381381"/>
                  </a:moveTo>
                  <a:lnTo>
                    <a:pt x="519811" y="381381"/>
                  </a:lnTo>
                  <a:lnTo>
                    <a:pt x="519811" y="762762"/>
                  </a:lnTo>
                  <a:lnTo>
                    <a:pt x="530225" y="762762"/>
                  </a:lnTo>
                  <a:lnTo>
                    <a:pt x="530225" y="381381"/>
                  </a:lnTo>
                  <a:close/>
                </a:path>
                <a:path w="2277109" h="763270">
                  <a:moveTo>
                    <a:pt x="588391" y="413131"/>
                  </a:moveTo>
                  <a:lnTo>
                    <a:pt x="577977" y="413131"/>
                  </a:lnTo>
                  <a:lnTo>
                    <a:pt x="577977" y="762762"/>
                  </a:lnTo>
                  <a:lnTo>
                    <a:pt x="588391" y="762762"/>
                  </a:lnTo>
                  <a:lnTo>
                    <a:pt x="588391" y="413131"/>
                  </a:lnTo>
                  <a:close/>
                </a:path>
                <a:path w="2277109" h="763270">
                  <a:moveTo>
                    <a:pt x="646417" y="381381"/>
                  </a:moveTo>
                  <a:lnTo>
                    <a:pt x="636016" y="381381"/>
                  </a:lnTo>
                  <a:lnTo>
                    <a:pt x="636016" y="762762"/>
                  </a:lnTo>
                  <a:lnTo>
                    <a:pt x="646417" y="762762"/>
                  </a:lnTo>
                  <a:lnTo>
                    <a:pt x="646417" y="381381"/>
                  </a:lnTo>
                  <a:close/>
                </a:path>
                <a:path w="2277109" h="763270">
                  <a:moveTo>
                    <a:pt x="704469" y="413131"/>
                  </a:moveTo>
                  <a:lnTo>
                    <a:pt x="694055" y="413131"/>
                  </a:lnTo>
                  <a:lnTo>
                    <a:pt x="694055" y="762762"/>
                  </a:lnTo>
                  <a:lnTo>
                    <a:pt x="704469" y="762762"/>
                  </a:lnTo>
                  <a:lnTo>
                    <a:pt x="704469" y="413131"/>
                  </a:lnTo>
                  <a:close/>
                </a:path>
                <a:path w="2277109" h="763270">
                  <a:moveTo>
                    <a:pt x="762508" y="540258"/>
                  </a:moveTo>
                  <a:lnTo>
                    <a:pt x="752094" y="540258"/>
                  </a:lnTo>
                  <a:lnTo>
                    <a:pt x="752094" y="762762"/>
                  </a:lnTo>
                  <a:lnTo>
                    <a:pt x="762508" y="762762"/>
                  </a:lnTo>
                  <a:lnTo>
                    <a:pt x="762508" y="540258"/>
                  </a:lnTo>
                  <a:close/>
                </a:path>
                <a:path w="2277109" h="763270">
                  <a:moveTo>
                    <a:pt x="820547" y="413131"/>
                  </a:moveTo>
                  <a:lnTo>
                    <a:pt x="810133" y="413131"/>
                  </a:lnTo>
                  <a:lnTo>
                    <a:pt x="810133" y="762762"/>
                  </a:lnTo>
                  <a:lnTo>
                    <a:pt x="820547" y="762762"/>
                  </a:lnTo>
                  <a:lnTo>
                    <a:pt x="820547" y="413131"/>
                  </a:lnTo>
                  <a:close/>
                </a:path>
                <a:path w="2277109" h="763270">
                  <a:moveTo>
                    <a:pt x="878573" y="286004"/>
                  </a:moveTo>
                  <a:lnTo>
                    <a:pt x="868172" y="286004"/>
                  </a:lnTo>
                  <a:lnTo>
                    <a:pt x="868172" y="762762"/>
                  </a:lnTo>
                  <a:lnTo>
                    <a:pt x="878573" y="762762"/>
                  </a:lnTo>
                  <a:lnTo>
                    <a:pt x="878573" y="286004"/>
                  </a:lnTo>
                  <a:close/>
                </a:path>
                <a:path w="2277109" h="763270">
                  <a:moveTo>
                    <a:pt x="936625" y="0"/>
                  </a:moveTo>
                  <a:lnTo>
                    <a:pt x="926211" y="0"/>
                  </a:lnTo>
                  <a:lnTo>
                    <a:pt x="926211" y="762762"/>
                  </a:lnTo>
                  <a:lnTo>
                    <a:pt x="936625" y="762762"/>
                  </a:lnTo>
                  <a:lnTo>
                    <a:pt x="936625" y="0"/>
                  </a:lnTo>
                  <a:close/>
                </a:path>
                <a:path w="2277109" h="763270">
                  <a:moveTo>
                    <a:pt x="999998" y="603885"/>
                  </a:moveTo>
                  <a:lnTo>
                    <a:pt x="986917" y="603885"/>
                  </a:lnTo>
                  <a:lnTo>
                    <a:pt x="986917" y="762762"/>
                  </a:lnTo>
                  <a:lnTo>
                    <a:pt x="999998" y="762762"/>
                  </a:lnTo>
                  <a:lnTo>
                    <a:pt x="999998" y="603885"/>
                  </a:lnTo>
                  <a:close/>
                </a:path>
                <a:path w="2277109" h="763270">
                  <a:moveTo>
                    <a:pt x="1066673" y="476758"/>
                  </a:moveTo>
                  <a:lnTo>
                    <a:pt x="1049274" y="476758"/>
                  </a:lnTo>
                  <a:lnTo>
                    <a:pt x="1049274" y="762762"/>
                  </a:lnTo>
                  <a:lnTo>
                    <a:pt x="1066673" y="762762"/>
                  </a:lnTo>
                  <a:lnTo>
                    <a:pt x="1066673" y="476758"/>
                  </a:lnTo>
                  <a:close/>
                </a:path>
                <a:path w="2277109" h="763270">
                  <a:moveTo>
                    <a:pt x="1116063" y="508508"/>
                  </a:moveTo>
                  <a:lnTo>
                    <a:pt x="1102995" y="508508"/>
                  </a:lnTo>
                  <a:lnTo>
                    <a:pt x="1102995" y="762762"/>
                  </a:lnTo>
                  <a:lnTo>
                    <a:pt x="1116063" y="762762"/>
                  </a:lnTo>
                  <a:lnTo>
                    <a:pt x="1116063" y="508508"/>
                  </a:lnTo>
                  <a:close/>
                </a:path>
                <a:path w="2277109" h="763270">
                  <a:moveTo>
                    <a:pt x="1168908" y="476758"/>
                  </a:moveTo>
                  <a:lnTo>
                    <a:pt x="1158494" y="476758"/>
                  </a:lnTo>
                  <a:lnTo>
                    <a:pt x="1158494" y="762762"/>
                  </a:lnTo>
                  <a:lnTo>
                    <a:pt x="1168908" y="762762"/>
                  </a:lnTo>
                  <a:lnTo>
                    <a:pt x="1168908" y="476758"/>
                  </a:lnTo>
                  <a:close/>
                </a:path>
                <a:path w="2277109" h="763270">
                  <a:moveTo>
                    <a:pt x="1226947" y="349631"/>
                  </a:moveTo>
                  <a:lnTo>
                    <a:pt x="1216533" y="349631"/>
                  </a:lnTo>
                  <a:lnTo>
                    <a:pt x="1216533" y="762762"/>
                  </a:lnTo>
                  <a:lnTo>
                    <a:pt x="1226947" y="762762"/>
                  </a:lnTo>
                  <a:lnTo>
                    <a:pt x="1226947" y="349631"/>
                  </a:lnTo>
                  <a:close/>
                </a:path>
                <a:path w="2277109" h="763270">
                  <a:moveTo>
                    <a:pt x="1298956" y="667385"/>
                  </a:moveTo>
                  <a:lnTo>
                    <a:pt x="1281557" y="667385"/>
                  </a:lnTo>
                  <a:lnTo>
                    <a:pt x="1281557" y="762762"/>
                  </a:lnTo>
                  <a:lnTo>
                    <a:pt x="1298956" y="762762"/>
                  </a:lnTo>
                  <a:lnTo>
                    <a:pt x="1298956" y="667385"/>
                  </a:lnTo>
                  <a:close/>
                </a:path>
                <a:path w="2277109" h="763270">
                  <a:moveTo>
                    <a:pt x="1348359" y="699135"/>
                  </a:moveTo>
                  <a:lnTo>
                    <a:pt x="1335278" y="699135"/>
                  </a:lnTo>
                  <a:lnTo>
                    <a:pt x="1335278" y="762762"/>
                  </a:lnTo>
                  <a:lnTo>
                    <a:pt x="1348359" y="762762"/>
                  </a:lnTo>
                  <a:lnTo>
                    <a:pt x="1348359" y="699135"/>
                  </a:lnTo>
                  <a:close/>
                </a:path>
                <a:path w="2277109" h="763270">
                  <a:moveTo>
                    <a:pt x="1401064" y="603885"/>
                  </a:moveTo>
                  <a:lnTo>
                    <a:pt x="1390650" y="603885"/>
                  </a:lnTo>
                  <a:lnTo>
                    <a:pt x="1390650" y="762762"/>
                  </a:lnTo>
                  <a:lnTo>
                    <a:pt x="1401064" y="762762"/>
                  </a:lnTo>
                  <a:lnTo>
                    <a:pt x="1401064" y="603885"/>
                  </a:lnTo>
                  <a:close/>
                </a:path>
                <a:path w="2277109" h="763270">
                  <a:moveTo>
                    <a:pt x="1464437" y="572008"/>
                  </a:moveTo>
                  <a:lnTo>
                    <a:pt x="1451356" y="572008"/>
                  </a:lnTo>
                  <a:lnTo>
                    <a:pt x="1451356" y="762762"/>
                  </a:lnTo>
                  <a:lnTo>
                    <a:pt x="1464437" y="762762"/>
                  </a:lnTo>
                  <a:lnTo>
                    <a:pt x="1464437" y="572008"/>
                  </a:lnTo>
                  <a:close/>
                </a:path>
                <a:path w="2277109" h="763270">
                  <a:moveTo>
                    <a:pt x="1517142" y="635635"/>
                  </a:moveTo>
                  <a:lnTo>
                    <a:pt x="1506728" y="635635"/>
                  </a:lnTo>
                  <a:lnTo>
                    <a:pt x="1506728" y="762762"/>
                  </a:lnTo>
                  <a:lnTo>
                    <a:pt x="1517142" y="762762"/>
                  </a:lnTo>
                  <a:lnTo>
                    <a:pt x="1517142" y="635635"/>
                  </a:lnTo>
                  <a:close/>
                </a:path>
                <a:path w="2277109" h="763270">
                  <a:moveTo>
                    <a:pt x="1589138" y="476758"/>
                  </a:moveTo>
                  <a:lnTo>
                    <a:pt x="1571752" y="476758"/>
                  </a:lnTo>
                  <a:lnTo>
                    <a:pt x="1571752" y="762762"/>
                  </a:lnTo>
                  <a:lnTo>
                    <a:pt x="1589138" y="762762"/>
                  </a:lnTo>
                  <a:lnTo>
                    <a:pt x="1589138" y="476758"/>
                  </a:lnTo>
                  <a:close/>
                </a:path>
                <a:path w="2277109" h="763270">
                  <a:moveTo>
                    <a:pt x="1638554" y="635635"/>
                  </a:moveTo>
                  <a:lnTo>
                    <a:pt x="1625473" y="635635"/>
                  </a:lnTo>
                  <a:lnTo>
                    <a:pt x="1625473" y="762762"/>
                  </a:lnTo>
                  <a:lnTo>
                    <a:pt x="1638554" y="762762"/>
                  </a:lnTo>
                  <a:lnTo>
                    <a:pt x="1638554" y="635635"/>
                  </a:lnTo>
                  <a:close/>
                </a:path>
                <a:path w="2277109" h="763270">
                  <a:moveTo>
                    <a:pt x="1696593" y="540258"/>
                  </a:moveTo>
                  <a:lnTo>
                    <a:pt x="1683512" y="540258"/>
                  </a:lnTo>
                  <a:lnTo>
                    <a:pt x="1683512" y="762762"/>
                  </a:lnTo>
                  <a:lnTo>
                    <a:pt x="1696593" y="762762"/>
                  </a:lnTo>
                  <a:lnTo>
                    <a:pt x="1696593" y="540258"/>
                  </a:lnTo>
                  <a:close/>
                </a:path>
                <a:path w="2277109" h="763270">
                  <a:moveTo>
                    <a:pt x="1763395" y="603885"/>
                  </a:moveTo>
                  <a:lnTo>
                    <a:pt x="1745996" y="603885"/>
                  </a:lnTo>
                  <a:lnTo>
                    <a:pt x="1745996" y="762762"/>
                  </a:lnTo>
                  <a:lnTo>
                    <a:pt x="1763395" y="762762"/>
                  </a:lnTo>
                  <a:lnTo>
                    <a:pt x="1763395" y="603885"/>
                  </a:lnTo>
                  <a:close/>
                </a:path>
                <a:path w="2277109" h="763270">
                  <a:moveTo>
                    <a:pt x="1812671" y="540258"/>
                  </a:moveTo>
                  <a:lnTo>
                    <a:pt x="1799590" y="540258"/>
                  </a:lnTo>
                  <a:lnTo>
                    <a:pt x="1799590" y="762762"/>
                  </a:lnTo>
                  <a:lnTo>
                    <a:pt x="1812671" y="762762"/>
                  </a:lnTo>
                  <a:lnTo>
                    <a:pt x="1812671" y="540258"/>
                  </a:lnTo>
                  <a:close/>
                </a:path>
                <a:path w="2277109" h="763270">
                  <a:moveTo>
                    <a:pt x="1870837" y="508508"/>
                  </a:moveTo>
                  <a:lnTo>
                    <a:pt x="1857756" y="508508"/>
                  </a:lnTo>
                  <a:lnTo>
                    <a:pt x="1857756" y="762762"/>
                  </a:lnTo>
                  <a:lnTo>
                    <a:pt x="1870837" y="762762"/>
                  </a:lnTo>
                  <a:lnTo>
                    <a:pt x="1870837" y="508508"/>
                  </a:lnTo>
                  <a:close/>
                </a:path>
                <a:path w="2277109" h="763270">
                  <a:moveTo>
                    <a:pt x="1954911" y="540258"/>
                  </a:moveTo>
                  <a:lnTo>
                    <a:pt x="1928749" y="540258"/>
                  </a:lnTo>
                  <a:lnTo>
                    <a:pt x="1928749" y="762762"/>
                  </a:lnTo>
                  <a:lnTo>
                    <a:pt x="1954911" y="762762"/>
                  </a:lnTo>
                  <a:lnTo>
                    <a:pt x="1954911" y="540258"/>
                  </a:lnTo>
                  <a:close/>
                </a:path>
                <a:path w="2277109" h="763270">
                  <a:moveTo>
                    <a:pt x="1986915" y="476758"/>
                  </a:moveTo>
                  <a:lnTo>
                    <a:pt x="1973834" y="476758"/>
                  </a:lnTo>
                  <a:lnTo>
                    <a:pt x="1973834" y="762762"/>
                  </a:lnTo>
                  <a:lnTo>
                    <a:pt x="1986915" y="762762"/>
                  </a:lnTo>
                  <a:lnTo>
                    <a:pt x="1986915" y="476758"/>
                  </a:lnTo>
                  <a:close/>
                </a:path>
                <a:path w="2277109" h="763270">
                  <a:moveTo>
                    <a:pt x="2044954" y="667385"/>
                  </a:moveTo>
                  <a:lnTo>
                    <a:pt x="2031873" y="667385"/>
                  </a:lnTo>
                  <a:lnTo>
                    <a:pt x="2031873" y="762762"/>
                  </a:lnTo>
                  <a:lnTo>
                    <a:pt x="2044954" y="762762"/>
                  </a:lnTo>
                  <a:lnTo>
                    <a:pt x="2044954" y="667385"/>
                  </a:lnTo>
                  <a:close/>
                </a:path>
                <a:path w="2277109" h="763270">
                  <a:moveTo>
                    <a:pt x="2111629" y="349631"/>
                  </a:moveTo>
                  <a:lnTo>
                    <a:pt x="2094230" y="349631"/>
                  </a:lnTo>
                  <a:lnTo>
                    <a:pt x="2094230" y="762762"/>
                  </a:lnTo>
                  <a:lnTo>
                    <a:pt x="2111629" y="762762"/>
                  </a:lnTo>
                  <a:lnTo>
                    <a:pt x="2111629" y="349631"/>
                  </a:lnTo>
                  <a:close/>
                </a:path>
                <a:path w="2277109" h="763270">
                  <a:moveTo>
                    <a:pt x="2169668" y="540258"/>
                  </a:moveTo>
                  <a:lnTo>
                    <a:pt x="2152269" y="540258"/>
                  </a:lnTo>
                  <a:lnTo>
                    <a:pt x="2152269" y="762762"/>
                  </a:lnTo>
                  <a:lnTo>
                    <a:pt x="2169668" y="762762"/>
                  </a:lnTo>
                  <a:lnTo>
                    <a:pt x="2169668" y="540258"/>
                  </a:lnTo>
                  <a:close/>
                </a:path>
                <a:path w="2277109" h="763270">
                  <a:moveTo>
                    <a:pt x="2227694" y="603885"/>
                  </a:moveTo>
                  <a:lnTo>
                    <a:pt x="2210308" y="603885"/>
                  </a:lnTo>
                  <a:lnTo>
                    <a:pt x="2210308" y="762762"/>
                  </a:lnTo>
                  <a:lnTo>
                    <a:pt x="2227694" y="762762"/>
                  </a:lnTo>
                  <a:lnTo>
                    <a:pt x="2227694" y="603885"/>
                  </a:lnTo>
                  <a:close/>
                </a:path>
                <a:path w="2277109" h="763270">
                  <a:moveTo>
                    <a:pt x="2277110" y="699135"/>
                  </a:moveTo>
                  <a:lnTo>
                    <a:pt x="2250948" y="699135"/>
                  </a:lnTo>
                  <a:lnTo>
                    <a:pt x="2250948" y="762762"/>
                  </a:lnTo>
                  <a:lnTo>
                    <a:pt x="2277110" y="762762"/>
                  </a:lnTo>
                  <a:lnTo>
                    <a:pt x="2277110" y="699135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5" name="object 115" descr=""/>
            <p:cNvSpPr/>
            <p:nvPr/>
          </p:nvSpPr>
          <p:spPr>
            <a:xfrm>
              <a:off x="1137793" y="7772527"/>
              <a:ext cx="4082415" cy="890269"/>
            </a:xfrm>
            <a:custGeom>
              <a:avLst/>
              <a:gdLst/>
              <a:ahLst/>
              <a:cxnLst/>
              <a:rect l="l" t="t" r="r" b="b"/>
              <a:pathLst>
                <a:path w="4082415" h="890270">
                  <a:moveTo>
                    <a:pt x="13081" y="858139"/>
                  </a:moveTo>
                  <a:lnTo>
                    <a:pt x="0" y="858139"/>
                  </a:lnTo>
                  <a:lnTo>
                    <a:pt x="0" y="889889"/>
                  </a:lnTo>
                  <a:lnTo>
                    <a:pt x="13081" y="889889"/>
                  </a:lnTo>
                  <a:lnTo>
                    <a:pt x="13081" y="858139"/>
                  </a:lnTo>
                  <a:close/>
                </a:path>
                <a:path w="4082415" h="890270">
                  <a:moveTo>
                    <a:pt x="71120" y="858139"/>
                  </a:moveTo>
                  <a:lnTo>
                    <a:pt x="58039" y="858139"/>
                  </a:lnTo>
                  <a:lnTo>
                    <a:pt x="58039" y="889889"/>
                  </a:lnTo>
                  <a:lnTo>
                    <a:pt x="71120" y="889889"/>
                  </a:lnTo>
                  <a:lnTo>
                    <a:pt x="71120" y="858139"/>
                  </a:lnTo>
                  <a:close/>
                </a:path>
                <a:path w="4082415" h="890270">
                  <a:moveTo>
                    <a:pt x="129159" y="762762"/>
                  </a:moveTo>
                  <a:lnTo>
                    <a:pt x="116078" y="762762"/>
                  </a:lnTo>
                  <a:lnTo>
                    <a:pt x="116078" y="889889"/>
                  </a:lnTo>
                  <a:lnTo>
                    <a:pt x="129159" y="889889"/>
                  </a:lnTo>
                  <a:lnTo>
                    <a:pt x="129159" y="762762"/>
                  </a:lnTo>
                  <a:close/>
                </a:path>
                <a:path w="4082415" h="890270">
                  <a:moveTo>
                    <a:pt x="187198" y="826262"/>
                  </a:moveTo>
                  <a:lnTo>
                    <a:pt x="174117" y="826262"/>
                  </a:lnTo>
                  <a:lnTo>
                    <a:pt x="174117" y="889889"/>
                  </a:lnTo>
                  <a:lnTo>
                    <a:pt x="187198" y="889889"/>
                  </a:lnTo>
                  <a:lnTo>
                    <a:pt x="187198" y="826262"/>
                  </a:lnTo>
                  <a:close/>
                </a:path>
                <a:path w="4082415" h="890270">
                  <a:moveTo>
                    <a:pt x="245237" y="794512"/>
                  </a:moveTo>
                  <a:lnTo>
                    <a:pt x="232156" y="794512"/>
                  </a:lnTo>
                  <a:lnTo>
                    <a:pt x="232156" y="889889"/>
                  </a:lnTo>
                  <a:lnTo>
                    <a:pt x="245237" y="889889"/>
                  </a:lnTo>
                  <a:lnTo>
                    <a:pt x="245237" y="794512"/>
                  </a:lnTo>
                  <a:close/>
                </a:path>
                <a:path w="4082415" h="890270">
                  <a:moveTo>
                    <a:pt x="303276" y="794512"/>
                  </a:moveTo>
                  <a:lnTo>
                    <a:pt x="290195" y="794512"/>
                  </a:lnTo>
                  <a:lnTo>
                    <a:pt x="290195" y="889889"/>
                  </a:lnTo>
                  <a:lnTo>
                    <a:pt x="303276" y="889889"/>
                  </a:lnTo>
                  <a:lnTo>
                    <a:pt x="303276" y="794512"/>
                  </a:lnTo>
                  <a:close/>
                </a:path>
                <a:path w="4082415" h="890270">
                  <a:moveTo>
                    <a:pt x="361315" y="762762"/>
                  </a:moveTo>
                  <a:lnTo>
                    <a:pt x="348234" y="762762"/>
                  </a:lnTo>
                  <a:lnTo>
                    <a:pt x="348234" y="889889"/>
                  </a:lnTo>
                  <a:lnTo>
                    <a:pt x="361315" y="889889"/>
                  </a:lnTo>
                  <a:lnTo>
                    <a:pt x="361315" y="762762"/>
                  </a:lnTo>
                  <a:close/>
                </a:path>
                <a:path w="4082415" h="890270">
                  <a:moveTo>
                    <a:pt x="424561" y="794512"/>
                  </a:moveTo>
                  <a:lnTo>
                    <a:pt x="414147" y="794512"/>
                  </a:lnTo>
                  <a:lnTo>
                    <a:pt x="414147" y="889889"/>
                  </a:lnTo>
                  <a:lnTo>
                    <a:pt x="424561" y="889889"/>
                  </a:lnTo>
                  <a:lnTo>
                    <a:pt x="424561" y="794512"/>
                  </a:lnTo>
                  <a:close/>
                </a:path>
                <a:path w="4082415" h="890270">
                  <a:moveTo>
                    <a:pt x="477520" y="858139"/>
                  </a:moveTo>
                  <a:lnTo>
                    <a:pt x="464439" y="858139"/>
                  </a:lnTo>
                  <a:lnTo>
                    <a:pt x="464439" y="889889"/>
                  </a:lnTo>
                  <a:lnTo>
                    <a:pt x="477520" y="889889"/>
                  </a:lnTo>
                  <a:lnTo>
                    <a:pt x="477520" y="858139"/>
                  </a:lnTo>
                  <a:close/>
                </a:path>
                <a:path w="4082415" h="890270">
                  <a:moveTo>
                    <a:pt x="540639" y="762762"/>
                  </a:moveTo>
                  <a:lnTo>
                    <a:pt x="530225" y="762762"/>
                  </a:lnTo>
                  <a:lnTo>
                    <a:pt x="530225" y="889889"/>
                  </a:lnTo>
                  <a:lnTo>
                    <a:pt x="540639" y="889889"/>
                  </a:lnTo>
                  <a:lnTo>
                    <a:pt x="540639" y="762762"/>
                  </a:lnTo>
                  <a:close/>
                </a:path>
                <a:path w="4082415" h="890270">
                  <a:moveTo>
                    <a:pt x="598678" y="794512"/>
                  </a:moveTo>
                  <a:lnTo>
                    <a:pt x="588264" y="794512"/>
                  </a:lnTo>
                  <a:lnTo>
                    <a:pt x="588264" y="889889"/>
                  </a:lnTo>
                  <a:lnTo>
                    <a:pt x="598678" y="889889"/>
                  </a:lnTo>
                  <a:lnTo>
                    <a:pt x="598678" y="794512"/>
                  </a:lnTo>
                  <a:close/>
                </a:path>
                <a:path w="4082415" h="890270">
                  <a:moveTo>
                    <a:pt x="656844" y="762762"/>
                  </a:moveTo>
                  <a:lnTo>
                    <a:pt x="646430" y="762762"/>
                  </a:lnTo>
                  <a:lnTo>
                    <a:pt x="646430" y="889889"/>
                  </a:lnTo>
                  <a:lnTo>
                    <a:pt x="656844" y="889889"/>
                  </a:lnTo>
                  <a:lnTo>
                    <a:pt x="656844" y="762762"/>
                  </a:lnTo>
                  <a:close/>
                </a:path>
                <a:path w="4082415" h="890270">
                  <a:moveTo>
                    <a:pt x="714883" y="762762"/>
                  </a:moveTo>
                  <a:lnTo>
                    <a:pt x="704469" y="762762"/>
                  </a:lnTo>
                  <a:lnTo>
                    <a:pt x="704469" y="889889"/>
                  </a:lnTo>
                  <a:lnTo>
                    <a:pt x="714883" y="889889"/>
                  </a:lnTo>
                  <a:lnTo>
                    <a:pt x="714883" y="762762"/>
                  </a:lnTo>
                  <a:close/>
                </a:path>
                <a:path w="4082415" h="890270">
                  <a:moveTo>
                    <a:pt x="772922" y="540258"/>
                  </a:moveTo>
                  <a:lnTo>
                    <a:pt x="762508" y="540258"/>
                  </a:lnTo>
                  <a:lnTo>
                    <a:pt x="762508" y="889889"/>
                  </a:lnTo>
                  <a:lnTo>
                    <a:pt x="772922" y="889889"/>
                  </a:lnTo>
                  <a:lnTo>
                    <a:pt x="772922" y="540258"/>
                  </a:lnTo>
                  <a:close/>
                </a:path>
                <a:path w="4082415" h="890270">
                  <a:moveTo>
                    <a:pt x="830948" y="190627"/>
                  </a:moveTo>
                  <a:lnTo>
                    <a:pt x="820547" y="190627"/>
                  </a:lnTo>
                  <a:lnTo>
                    <a:pt x="820547" y="889889"/>
                  </a:lnTo>
                  <a:lnTo>
                    <a:pt x="830948" y="889889"/>
                  </a:lnTo>
                  <a:lnTo>
                    <a:pt x="830948" y="190627"/>
                  </a:lnTo>
                  <a:close/>
                </a:path>
                <a:path w="4082415" h="890270">
                  <a:moveTo>
                    <a:pt x="889000" y="158877"/>
                  </a:moveTo>
                  <a:lnTo>
                    <a:pt x="878586" y="158877"/>
                  </a:lnTo>
                  <a:lnTo>
                    <a:pt x="878586" y="889889"/>
                  </a:lnTo>
                  <a:lnTo>
                    <a:pt x="889000" y="889889"/>
                  </a:lnTo>
                  <a:lnTo>
                    <a:pt x="889000" y="158877"/>
                  </a:lnTo>
                  <a:close/>
                </a:path>
                <a:path w="4082415" h="890270">
                  <a:moveTo>
                    <a:pt x="947039" y="0"/>
                  </a:moveTo>
                  <a:lnTo>
                    <a:pt x="936625" y="0"/>
                  </a:lnTo>
                  <a:lnTo>
                    <a:pt x="936625" y="889889"/>
                  </a:lnTo>
                  <a:lnTo>
                    <a:pt x="947039" y="889889"/>
                  </a:lnTo>
                  <a:lnTo>
                    <a:pt x="947039" y="0"/>
                  </a:lnTo>
                  <a:close/>
                </a:path>
                <a:path w="4082415" h="890270">
                  <a:moveTo>
                    <a:pt x="1005078" y="413131"/>
                  </a:moveTo>
                  <a:lnTo>
                    <a:pt x="994664" y="413131"/>
                  </a:lnTo>
                  <a:lnTo>
                    <a:pt x="994664" y="889889"/>
                  </a:lnTo>
                  <a:lnTo>
                    <a:pt x="1005078" y="889889"/>
                  </a:lnTo>
                  <a:lnTo>
                    <a:pt x="1005078" y="413131"/>
                  </a:lnTo>
                  <a:close/>
                </a:path>
                <a:path w="4082415" h="890270">
                  <a:moveTo>
                    <a:pt x="1063104" y="381381"/>
                  </a:moveTo>
                  <a:lnTo>
                    <a:pt x="1052703" y="381381"/>
                  </a:lnTo>
                  <a:lnTo>
                    <a:pt x="1052703" y="889889"/>
                  </a:lnTo>
                  <a:lnTo>
                    <a:pt x="1063104" y="889889"/>
                  </a:lnTo>
                  <a:lnTo>
                    <a:pt x="1063104" y="381381"/>
                  </a:lnTo>
                  <a:close/>
                </a:path>
                <a:path w="4082415" h="890270">
                  <a:moveTo>
                    <a:pt x="1121156" y="413131"/>
                  </a:moveTo>
                  <a:lnTo>
                    <a:pt x="1110742" y="413131"/>
                  </a:lnTo>
                  <a:lnTo>
                    <a:pt x="1110742" y="889889"/>
                  </a:lnTo>
                  <a:lnTo>
                    <a:pt x="1121156" y="889889"/>
                  </a:lnTo>
                  <a:lnTo>
                    <a:pt x="1121156" y="413131"/>
                  </a:lnTo>
                  <a:close/>
                </a:path>
                <a:path w="4082415" h="890270">
                  <a:moveTo>
                    <a:pt x="1179322" y="413131"/>
                  </a:moveTo>
                  <a:lnTo>
                    <a:pt x="1168908" y="413131"/>
                  </a:lnTo>
                  <a:lnTo>
                    <a:pt x="1168908" y="889889"/>
                  </a:lnTo>
                  <a:lnTo>
                    <a:pt x="1179322" y="889889"/>
                  </a:lnTo>
                  <a:lnTo>
                    <a:pt x="1179322" y="413131"/>
                  </a:lnTo>
                  <a:close/>
                </a:path>
                <a:path w="4082415" h="890270">
                  <a:moveTo>
                    <a:pt x="1237348" y="603885"/>
                  </a:moveTo>
                  <a:lnTo>
                    <a:pt x="1226947" y="603885"/>
                  </a:lnTo>
                  <a:lnTo>
                    <a:pt x="1226947" y="889889"/>
                  </a:lnTo>
                  <a:lnTo>
                    <a:pt x="1237348" y="889889"/>
                  </a:lnTo>
                  <a:lnTo>
                    <a:pt x="1237348" y="603885"/>
                  </a:lnTo>
                  <a:close/>
                </a:path>
                <a:path w="4082415" h="890270">
                  <a:moveTo>
                    <a:pt x="1295400" y="381381"/>
                  </a:moveTo>
                  <a:lnTo>
                    <a:pt x="1284986" y="381381"/>
                  </a:lnTo>
                  <a:lnTo>
                    <a:pt x="1284986" y="889889"/>
                  </a:lnTo>
                  <a:lnTo>
                    <a:pt x="1295400" y="889889"/>
                  </a:lnTo>
                  <a:lnTo>
                    <a:pt x="1295400" y="381381"/>
                  </a:lnTo>
                  <a:close/>
                </a:path>
                <a:path w="4082415" h="890270">
                  <a:moveTo>
                    <a:pt x="1353439" y="540258"/>
                  </a:moveTo>
                  <a:lnTo>
                    <a:pt x="1343025" y="540258"/>
                  </a:lnTo>
                  <a:lnTo>
                    <a:pt x="1343025" y="889889"/>
                  </a:lnTo>
                  <a:lnTo>
                    <a:pt x="1353439" y="889889"/>
                  </a:lnTo>
                  <a:lnTo>
                    <a:pt x="1353439" y="540258"/>
                  </a:lnTo>
                  <a:close/>
                </a:path>
                <a:path w="4082415" h="890270">
                  <a:moveTo>
                    <a:pt x="1411478" y="317754"/>
                  </a:moveTo>
                  <a:lnTo>
                    <a:pt x="1401064" y="317754"/>
                  </a:lnTo>
                  <a:lnTo>
                    <a:pt x="1401064" y="889889"/>
                  </a:lnTo>
                  <a:lnTo>
                    <a:pt x="1411478" y="889889"/>
                  </a:lnTo>
                  <a:lnTo>
                    <a:pt x="1411478" y="317754"/>
                  </a:lnTo>
                  <a:close/>
                </a:path>
                <a:path w="4082415" h="890270">
                  <a:moveTo>
                    <a:pt x="1469504" y="286004"/>
                  </a:moveTo>
                  <a:lnTo>
                    <a:pt x="1459103" y="286004"/>
                  </a:lnTo>
                  <a:lnTo>
                    <a:pt x="1459103" y="889889"/>
                  </a:lnTo>
                  <a:lnTo>
                    <a:pt x="1469504" y="889889"/>
                  </a:lnTo>
                  <a:lnTo>
                    <a:pt x="1469504" y="286004"/>
                  </a:lnTo>
                  <a:close/>
                </a:path>
                <a:path w="4082415" h="890270">
                  <a:moveTo>
                    <a:pt x="1527556" y="413131"/>
                  </a:moveTo>
                  <a:lnTo>
                    <a:pt x="1517142" y="413131"/>
                  </a:lnTo>
                  <a:lnTo>
                    <a:pt x="1517142" y="889889"/>
                  </a:lnTo>
                  <a:lnTo>
                    <a:pt x="1527556" y="889889"/>
                  </a:lnTo>
                  <a:lnTo>
                    <a:pt x="1527556" y="413131"/>
                  </a:lnTo>
                  <a:close/>
                </a:path>
                <a:path w="4082415" h="890270">
                  <a:moveTo>
                    <a:pt x="1585595" y="572008"/>
                  </a:moveTo>
                  <a:lnTo>
                    <a:pt x="1575181" y="572008"/>
                  </a:lnTo>
                  <a:lnTo>
                    <a:pt x="1575181" y="889889"/>
                  </a:lnTo>
                  <a:lnTo>
                    <a:pt x="1585595" y="889889"/>
                  </a:lnTo>
                  <a:lnTo>
                    <a:pt x="1585595" y="572008"/>
                  </a:lnTo>
                  <a:close/>
                </a:path>
                <a:path w="4082415" h="890270">
                  <a:moveTo>
                    <a:pt x="1643634" y="540258"/>
                  </a:moveTo>
                  <a:lnTo>
                    <a:pt x="1633220" y="540258"/>
                  </a:lnTo>
                  <a:lnTo>
                    <a:pt x="1633220" y="889889"/>
                  </a:lnTo>
                  <a:lnTo>
                    <a:pt x="1643634" y="889889"/>
                  </a:lnTo>
                  <a:lnTo>
                    <a:pt x="1643634" y="540258"/>
                  </a:lnTo>
                  <a:close/>
                </a:path>
                <a:path w="4082415" h="890270">
                  <a:moveTo>
                    <a:pt x="1701660" y="603885"/>
                  </a:moveTo>
                  <a:lnTo>
                    <a:pt x="1691259" y="603885"/>
                  </a:lnTo>
                  <a:lnTo>
                    <a:pt x="1691259" y="889889"/>
                  </a:lnTo>
                  <a:lnTo>
                    <a:pt x="1701660" y="889889"/>
                  </a:lnTo>
                  <a:lnTo>
                    <a:pt x="1701660" y="603885"/>
                  </a:lnTo>
                  <a:close/>
                </a:path>
                <a:path w="4082415" h="890270">
                  <a:moveTo>
                    <a:pt x="1759839" y="413131"/>
                  </a:moveTo>
                  <a:lnTo>
                    <a:pt x="1749425" y="413131"/>
                  </a:lnTo>
                  <a:lnTo>
                    <a:pt x="1749425" y="889889"/>
                  </a:lnTo>
                  <a:lnTo>
                    <a:pt x="1759839" y="889889"/>
                  </a:lnTo>
                  <a:lnTo>
                    <a:pt x="1759839" y="413131"/>
                  </a:lnTo>
                  <a:close/>
                </a:path>
                <a:path w="4082415" h="890270">
                  <a:moveTo>
                    <a:pt x="1817878" y="635635"/>
                  </a:moveTo>
                  <a:lnTo>
                    <a:pt x="1807464" y="635635"/>
                  </a:lnTo>
                  <a:lnTo>
                    <a:pt x="1807464" y="889889"/>
                  </a:lnTo>
                  <a:lnTo>
                    <a:pt x="1817878" y="889889"/>
                  </a:lnTo>
                  <a:lnTo>
                    <a:pt x="1817878" y="635635"/>
                  </a:lnTo>
                  <a:close/>
                </a:path>
                <a:path w="4082415" h="890270">
                  <a:moveTo>
                    <a:pt x="1875904" y="413131"/>
                  </a:moveTo>
                  <a:lnTo>
                    <a:pt x="1865503" y="413131"/>
                  </a:lnTo>
                  <a:lnTo>
                    <a:pt x="1865503" y="889889"/>
                  </a:lnTo>
                  <a:lnTo>
                    <a:pt x="1875904" y="889889"/>
                  </a:lnTo>
                  <a:lnTo>
                    <a:pt x="1875904" y="413131"/>
                  </a:lnTo>
                  <a:close/>
                </a:path>
                <a:path w="4082415" h="890270">
                  <a:moveTo>
                    <a:pt x="1933956" y="381381"/>
                  </a:moveTo>
                  <a:lnTo>
                    <a:pt x="1923542" y="381381"/>
                  </a:lnTo>
                  <a:lnTo>
                    <a:pt x="1923542" y="889889"/>
                  </a:lnTo>
                  <a:lnTo>
                    <a:pt x="1933956" y="889889"/>
                  </a:lnTo>
                  <a:lnTo>
                    <a:pt x="1933956" y="381381"/>
                  </a:lnTo>
                  <a:close/>
                </a:path>
                <a:path w="4082415" h="890270">
                  <a:moveTo>
                    <a:pt x="1991995" y="508508"/>
                  </a:moveTo>
                  <a:lnTo>
                    <a:pt x="1981581" y="508508"/>
                  </a:lnTo>
                  <a:lnTo>
                    <a:pt x="1981581" y="889889"/>
                  </a:lnTo>
                  <a:lnTo>
                    <a:pt x="1991995" y="889889"/>
                  </a:lnTo>
                  <a:lnTo>
                    <a:pt x="1991995" y="508508"/>
                  </a:lnTo>
                  <a:close/>
                </a:path>
                <a:path w="4082415" h="890270">
                  <a:moveTo>
                    <a:pt x="2050034" y="667385"/>
                  </a:moveTo>
                  <a:lnTo>
                    <a:pt x="2039620" y="667385"/>
                  </a:lnTo>
                  <a:lnTo>
                    <a:pt x="2039620" y="889889"/>
                  </a:lnTo>
                  <a:lnTo>
                    <a:pt x="2050034" y="889889"/>
                  </a:lnTo>
                  <a:lnTo>
                    <a:pt x="2050034" y="667385"/>
                  </a:lnTo>
                  <a:close/>
                </a:path>
                <a:path w="4082415" h="890270">
                  <a:moveTo>
                    <a:pt x="2108060" y="444881"/>
                  </a:moveTo>
                  <a:lnTo>
                    <a:pt x="2097659" y="444881"/>
                  </a:lnTo>
                  <a:lnTo>
                    <a:pt x="2097659" y="889889"/>
                  </a:lnTo>
                  <a:lnTo>
                    <a:pt x="2108060" y="889889"/>
                  </a:lnTo>
                  <a:lnTo>
                    <a:pt x="2108060" y="444881"/>
                  </a:lnTo>
                  <a:close/>
                </a:path>
                <a:path w="4082415" h="890270">
                  <a:moveTo>
                    <a:pt x="2166099" y="508508"/>
                  </a:moveTo>
                  <a:lnTo>
                    <a:pt x="2155685" y="508508"/>
                  </a:lnTo>
                  <a:lnTo>
                    <a:pt x="2155685" y="889889"/>
                  </a:lnTo>
                  <a:lnTo>
                    <a:pt x="2166099" y="889889"/>
                  </a:lnTo>
                  <a:lnTo>
                    <a:pt x="2166099" y="508508"/>
                  </a:lnTo>
                  <a:close/>
                </a:path>
                <a:path w="4082415" h="890270">
                  <a:moveTo>
                    <a:pt x="2224138" y="444881"/>
                  </a:moveTo>
                  <a:lnTo>
                    <a:pt x="2213737" y="444881"/>
                  </a:lnTo>
                  <a:lnTo>
                    <a:pt x="2213737" y="889889"/>
                  </a:lnTo>
                  <a:lnTo>
                    <a:pt x="2224138" y="889889"/>
                  </a:lnTo>
                  <a:lnTo>
                    <a:pt x="2224138" y="444881"/>
                  </a:lnTo>
                  <a:close/>
                </a:path>
                <a:path w="4082415" h="890270">
                  <a:moveTo>
                    <a:pt x="2282317" y="286004"/>
                  </a:moveTo>
                  <a:lnTo>
                    <a:pt x="2271903" y="286004"/>
                  </a:lnTo>
                  <a:lnTo>
                    <a:pt x="2271903" y="889889"/>
                  </a:lnTo>
                  <a:lnTo>
                    <a:pt x="2282317" y="889889"/>
                  </a:lnTo>
                  <a:lnTo>
                    <a:pt x="2282317" y="286004"/>
                  </a:lnTo>
                  <a:close/>
                </a:path>
                <a:path w="4082415" h="890270">
                  <a:moveTo>
                    <a:pt x="2340356" y="476758"/>
                  </a:moveTo>
                  <a:lnTo>
                    <a:pt x="2329942" y="476758"/>
                  </a:lnTo>
                  <a:lnTo>
                    <a:pt x="2329942" y="889889"/>
                  </a:lnTo>
                  <a:lnTo>
                    <a:pt x="2340356" y="889889"/>
                  </a:lnTo>
                  <a:lnTo>
                    <a:pt x="2340356" y="476758"/>
                  </a:lnTo>
                  <a:close/>
                </a:path>
                <a:path w="4082415" h="890270">
                  <a:moveTo>
                    <a:pt x="2398395" y="572008"/>
                  </a:moveTo>
                  <a:lnTo>
                    <a:pt x="2387981" y="572008"/>
                  </a:lnTo>
                  <a:lnTo>
                    <a:pt x="2387981" y="889889"/>
                  </a:lnTo>
                  <a:lnTo>
                    <a:pt x="2398395" y="889889"/>
                  </a:lnTo>
                  <a:lnTo>
                    <a:pt x="2398395" y="572008"/>
                  </a:lnTo>
                  <a:close/>
                </a:path>
                <a:path w="4082415" h="890270">
                  <a:moveTo>
                    <a:pt x="2456434" y="603885"/>
                  </a:moveTo>
                  <a:lnTo>
                    <a:pt x="2446020" y="603885"/>
                  </a:lnTo>
                  <a:lnTo>
                    <a:pt x="2446020" y="889889"/>
                  </a:lnTo>
                  <a:lnTo>
                    <a:pt x="2456434" y="889889"/>
                  </a:lnTo>
                  <a:lnTo>
                    <a:pt x="2456434" y="603885"/>
                  </a:lnTo>
                  <a:close/>
                </a:path>
                <a:path w="4082415" h="890270">
                  <a:moveTo>
                    <a:pt x="2514473" y="317754"/>
                  </a:moveTo>
                  <a:lnTo>
                    <a:pt x="2504059" y="317754"/>
                  </a:lnTo>
                  <a:lnTo>
                    <a:pt x="2504059" y="889889"/>
                  </a:lnTo>
                  <a:lnTo>
                    <a:pt x="2514473" y="889889"/>
                  </a:lnTo>
                  <a:lnTo>
                    <a:pt x="2514473" y="317754"/>
                  </a:lnTo>
                  <a:close/>
                </a:path>
                <a:path w="4082415" h="890270">
                  <a:moveTo>
                    <a:pt x="2572512" y="444881"/>
                  </a:moveTo>
                  <a:lnTo>
                    <a:pt x="2562098" y="444881"/>
                  </a:lnTo>
                  <a:lnTo>
                    <a:pt x="2562098" y="889889"/>
                  </a:lnTo>
                  <a:lnTo>
                    <a:pt x="2572512" y="889889"/>
                  </a:lnTo>
                  <a:lnTo>
                    <a:pt x="2572512" y="444881"/>
                  </a:lnTo>
                  <a:close/>
                </a:path>
                <a:path w="4082415" h="890270">
                  <a:moveTo>
                    <a:pt x="2630538" y="413131"/>
                  </a:moveTo>
                  <a:lnTo>
                    <a:pt x="2620137" y="413131"/>
                  </a:lnTo>
                  <a:lnTo>
                    <a:pt x="2620137" y="889889"/>
                  </a:lnTo>
                  <a:lnTo>
                    <a:pt x="2630538" y="889889"/>
                  </a:lnTo>
                  <a:lnTo>
                    <a:pt x="2630538" y="413131"/>
                  </a:lnTo>
                  <a:close/>
                </a:path>
                <a:path w="4082415" h="890270">
                  <a:moveTo>
                    <a:pt x="2688590" y="540258"/>
                  </a:moveTo>
                  <a:lnTo>
                    <a:pt x="2678176" y="540258"/>
                  </a:lnTo>
                  <a:lnTo>
                    <a:pt x="2678176" y="889889"/>
                  </a:lnTo>
                  <a:lnTo>
                    <a:pt x="2688590" y="889889"/>
                  </a:lnTo>
                  <a:lnTo>
                    <a:pt x="2688590" y="540258"/>
                  </a:lnTo>
                  <a:close/>
                </a:path>
                <a:path w="4082415" h="890270">
                  <a:moveTo>
                    <a:pt x="2746629" y="603885"/>
                  </a:moveTo>
                  <a:lnTo>
                    <a:pt x="2736215" y="603885"/>
                  </a:lnTo>
                  <a:lnTo>
                    <a:pt x="2736215" y="889889"/>
                  </a:lnTo>
                  <a:lnTo>
                    <a:pt x="2746629" y="889889"/>
                  </a:lnTo>
                  <a:lnTo>
                    <a:pt x="2746629" y="603885"/>
                  </a:lnTo>
                  <a:close/>
                </a:path>
                <a:path w="4082415" h="890270">
                  <a:moveTo>
                    <a:pt x="2804668" y="508508"/>
                  </a:moveTo>
                  <a:lnTo>
                    <a:pt x="2794254" y="508508"/>
                  </a:lnTo>
                  <a:lnTo>
                    <a:pt x="2794254" y="889889"/>
                  </a:lnTo>
                  <a:lnTo>
                    <a:pt x="2804668" y="889889"/>
                  </a:lnTo>
                  <a:lnTo>
                    <a:pt x="2804668" y="508508"/>
                  </a:lnTo>
                  <a:close/>
                </a:path>
                <a:path w="4082415" h="890270">
                  <a:moveTo>
                    <a:pt x="2862834" y="572008"/>
                  </a:moveTo>
                  <a:lnTo>
                    <a:pt x="2852420" y="572008"/>
                  </a:lnTo>
                  <a:lnTo>
                    <a:pt x="2852420" y="889889"/>
                  </a:lnTo>
                  <a:lnTo>
                    <a:pt x="2862834" y="889889"/>
                  </a:lnTo>
                  <a:lnTo>
                    <a:pt x="2862834" y="572008"/>
                  </a:lnTo>
                  <a:close/>
                </a:path>
                <a:path w="4082415" h="890270">
                  <a:moveTo>
                    <a:pt x="2920873" y="476758"/>
                  </a:moveTo>
                  <a:lnTo>
                    <a:pt x="2910459" y="476758"/>
                  </a:lnTo>
                  <a:lnTo>
                    <a:pt x="2910459" y="889889"/>
                  </a:lnTo>
                  <a:lnTo>
                    <a:pt x="2920873" y="889889"/>
                  </a:lnTo>
                  <a:lnTo>
                    <a:pt x="2920873" y="476758"/>
                  </a:lnTo>
                  <a:close/>
                </a:path>
                <a:path w="4082415" h="890270">
                  <a:moveTo>
                    <a:pt x="2978912" y="286004"/>
                  </a:moveTo>
                  <a:lnTo>
                    <a:pt x="2968498" y="286004"/>
                  </a:lnTo>
                  <a:lnTo>
                    <a:pt x="2968498" y="889889"/>
                  </a:lnTo>
                  <a:lnTo>
                    <a:pt x="2978912" y="889889"/>
                  </a:lnTo>
                  <a:lnTo>
                    <a:pt x="2978912" y="286004"/>
                  </a:lnTo>
                  <a:close/>
                </a:path>
                <a:path w="4082415" h="890270">
                  <a:moveTo>
                    <a:pt x="3036938" y="444881"/>
                  </a:moveTo>
                  <a:lnTo>
                    <a:pt x="3026537" y="444881"/>
                  </a:lnTo>
                  <a:lnTo>
                    <a:pt x="3026537" y="889889"/>
                  </a:lnTo>
                  <a:lnTo>
                    <a:pt x="3036938" y="889889"/>
                  </a:lnTo>
                  <a:lnTo>
                    <a:pt x="3036938" y="444881"/>
                  </a:lnTo>
                  <a:close/>
                </a:path>
                <a:path w="4082415" h="890270">
                  <a:moveTo>
                    <a:pt x="3094990" y="508508"/>
                  </a:moveTo>
                  <a:lnTo>
                    <a:pt x="3084576" y="508508"/>
                  </a:lnTo>
                  <a:lnTo>
                    <a:pt x="3084576" y="889889"/>
                  </a:lnTo>
                  <a:lnTo>
                    <a:pt x="3094990" y="889889"/>
                  </a:lnTo>
                  <a:lnTo>
                    <a:pt x="3094990" y="508508"/>
                  </a:lnTo>
                  <a:close/>
                </a:path>
                <a:path w="4082415" h="890270">
                  <a:moveTo>
                    <a:pt x="3153029" y="572008"/>
                  </a:moveTo>
                  <a:lnTo>
                    <a:pt x="3142615" y="572008"/>
                  </a:lnTo>
                  <a:lnTo>
                    <a:pt x="3142615" y="889889"/>
                  </a:lnTo>
                  <a:lnTo>
                    <a:pt x="3153029" y="889889"/>
                  </a:lnTo>
                  <a:lnTo>
                    <a:pt x="3153029" y="572008"/>
                  </a:lnTo>
                  <a:close/>
                </a:path>
                <a:path w="4082415" h="890270">
                  <a:moveTo>
                    <a:pt x="3211068" y="476758"/>
                  </a:moveTo>
                  <a:lnTo>
                    <a:pt x="3200654" y="476758"/>
                  </a:lnTo>
                  <a:lnTo>
                    <a:pt x="3200654" y="889889"/>
                  </a:lnTo>
                  <a:lnTo>
                    <a:pt x="3211068" y="889889"/>
                  </a:lnTo>
                  <a:lnTo>
                    <a:pt x="3211068" y="476758"/>
                  </a:lnTo>
                  <a:close/>
                </a:path>
                <a:path w="4082415" h="890270">
                  <a:moveTo>
                    <a:pt x="3269107" y="349631"/>
                  </a:moveTo>
                  <a:lnTo>
                    <a:pt x="3258693" y="349631"/>
                  </a:lnTo>
                  <a:lnTo>
                    <a:pt x="3258693" y="889889"/>
                  </a:lnTo>
                  <a:lnTo>
                    <a:pt x="3269107" y="889889"/>
                  </a:lnTo>
                  <a:lnTo>
                    <a:pt x="3269107" y="349631"/>
                  </a:lnTo>
                  <a:close/>
                </a:path>
                <a:path w="4082415" h="890270">
                  <a:moveTo>
                    <a:pt x="3327146" y="699135"/>
                  </a:moveTo>
                  <a:lnTo>
                    <a:pt x="3316732" y="699135"/>
                  </a:lnTo>
                  <a:lnTo>
                    <a:pt x="3316732" y="889889"/>
                  </a:lnTo>
                  <a:lnTo>
                    <a:pt x="3327146" y="889889"/>
                  </a:lnTo>
                  <a:lnTo>
                    <a:pt x="3327146" y="699135"/>
                  </a:lnTo>
                  <a:close/>
                </a:path>
                <a:path w="4082415" h="890270">
                  <a:moveTo>
                    <a:pt x="3385312" y="667385"/>
                  </a:moveTo>
                  <a:lnTo>
                    <a:pt x="3374898" y="667385"/>
                  </a:lnTo>
                  <a:lnTo>
                    <a:pt x="3374898" y="889889"/>
                  </a:lnTo>
                  <a:lnTo>
                    <a:pt x="3385312" y="889889"/>
                  </a:lnTo>
                  <a:lnTo>
                    <a:pt x="3385312" y="667385"/>
                  </a:lnTo>
                  <a:close/>
                </a:path>
                <a:path w="4082415" h="890270">
                  <a:moveTo>
                    <a:pt x="3443338" y="572008"/>
                  </a:moveTo>
                  <a:lnTo>
                    <a:pt x="3432937" y="572008"/>
                  </a:lnTo>
                  <a:lnTo>
                    <a:pt x="3432937" y="889889"/>
                  </a:lnTo>
                  <a:lnTo>
                    <a:pt x="3443338" y="889889"/>
                  </a:lnTo>
                  <a:lnTo>
                    <a:pt x="3443338" y="572008"/>
                  </a:lnTo>
                  <a:close/>
                </a:path>
                <a:path w="4082415" h="890270">
                  <a:moveTo>
                    <a:pt x="3501390" y="413131"/>
                  </a:moveTo>
                  <a:lnTo>
                    <a:pt x="3490976" y="413131"/>
                  </a:lnTo>
                  <a:lnTo>
                    <a:pt x="3490976" y="889889"/>
                  </a:lnTo>
                  <a:lnTo>
                    <a:pt x="3501390" y="889889"/>
                  </a:lnTo>
                  <a:lnTo>
                    <a:pt x="3501390" y="413131"/>
                  </a:lnTo>
                  <a:close/>
                </a:path>
                <a:path w="4082415" h="890270">
                  <a:moveTo>
                    <a:pt x="3559429" y="349631"/>
                  </a:moveTo>
                  <a:lnTo>
                    <a:pt x="3549015" y="349631"/>
                  </a:lnTo>
                  <a:lnTo>
                    <a:pt x="3549015" y="889889"/>
                  </a:lnTo>
                  <a:lnTo>
                    <a:pt x="3559429" y="889889"/>
                  </a:lnTo>
                  <a:lnTo>
                    <a:pt x="3559429" y="349631"/>
                  </a:lnTo>
                  <a:close/>
                </a:path>
                <a:path w="4082415" h="890270">
                  <a:moveTo>
                    <a:pt x="3617468" y="413131"/>
                  </a:moveTo>
                  <a:lnTo>
                    <a:pt x="3607054" y="413131"/>
                  </a:lnTo>
                  <a:lnTo>
                    <a:pt x="3607054" y="889889"/>
                  </a:lnTo>
                  <a:lnTo>
                    <a:pt x="3617468" y="889889"/>
                  </a:lnTo>
                  <a:lnTo>
                    <a:pt x="3617468" y="413131"/>
                  </a:lnTo>
                  <a:close/>
                </a:path>
                <a:path w="4082415" h="890270">
                  <a:moveTo>
                    <a:pt x="3675507" y="667385"/>
                  </a:moveTo>
                  <a:lnTo>
                    <a:pt x="3665093" y="667385"/>
                  </a:lnTo>
                  <a:lnTo>
                    <a:pt x="3665093" y="889889"/>
                  </a:lnTo>
                  <a:lnTo>
                    <a:pt x="3675507" y="889889"/>
                  </a:lnTo>
                  <a:lnTo>
                    <a:pt x="3675507" y="667385"/>
                  </a:lnTo>
                  <a:close/>
                </a:path>
                <a:path w="4082415" h="890270">
                  <a:moveTo>
                    <a:pt x="3733546" y="635635"/>
                  </a:moveTo>
                  <a:lnTo>
                    <a:pt x="3723132" y="635635"/>
                  </a:lnTo>
                  <a:lnTo>
                    <a:pt x="3723132" y="889889"/>
                  </a:lnTo>
                  <a:lnTo>
                    <a:pt x="3733546" y="889889"/>
                  </a:lnTo>
                  <a:lnTo>
                    <a:pt x="3733546" y="635635"/>
                  </a:lnTo>
                  <a:close/>
                </a:path>
                <a:path w="4082415" h="890270">
                  <a:moveTo>
                    <a:pt x="3791585" y="413131"/>
                  </a:moveTo>
                  <a:lnTo>
                    <a:pt x="3781171" y="413131"/>
                  </a:lnTo>
                  <a:lnTo>
                    <a:pt x="3781171" y="889889"/>
                  </a:lnTo>
                  <a:lnTo>
                    <a:pt x="3791585" y="889889"/>
                  </a:lnTo>
                  <a:lnTo>
                    <a:pt x="3791585" y="413131"/>
                  </a:lnTo>
                  <a:close/>
                </a:path>
                <a:path w="4082415" h="890270">
                  <a:moveTo>
                    <a:pt x="3849624" y="444881"/>
                  </a:moveTo>
                  <a:lnTo>
                    <a:pt x="3839210" y="444881"/>
                  </a:lnTo>
                  <a:lnTo>
                    <a:pt x="3839210" y="889889"/>
                  </a:lnTo>
                  <a:lnTo>
                    <a:pt x="3849624" y="889889"/>
                  </a:lnTo>
                  <a:lnTo>
                    <a:pt x="3849624" y="444881"/>
                  </a:lnTo>
                  <a:close/>
                </a:path>
                <a:path w="4082415" h="890270">
                  <a:moveTo>
                    <a:pt x="3907790" y="572008"/>
                  </a:moveTo>
                  <a:lnTo>
                    <a:pt x="3897376" y="572008"/>
                  </a:lnTo>
                  <a:lnTo>
                    <a:pt x="3897376" y="889889"/>
                  </a:lnTo>
                  <a:lnTo>
                    <a:pt x="3907790" y="889889"/>
                  </a:lnTo>
                  <a:lnTo>
                    <a:pt x="3907790" y="572008"/>
                  </a:lnTo>
                  <a:close/>
                </a:path>
                <a:path w="4082415" h="890270">
                  <a:moveTo>
                    <a:pt x="3965829" y="254254"/>
                  </a:moveTo>
                  <a:lnTo>
                    <a:pt x="3955415" y="254254"/>
                  </a:lnTo>
                  <a:lnTo>
                    <a:pt x="3955415" y="889889"/>
                  </a:lnTo>
                  <a:lnTo>
                    <a:pt x="3965829" y="889889"/>
                  </a:lnTo>
                  <a:lnTo>
                    <a:pt x="3965829" y="254254"/>
                  </a:lnTo>
                  <a:close/>
                </a:path>
                <a:path w="4082415" h="890270">
                  <a:moveTo>
                    <a:pt x="4023868" y="508508"/>
                  </a:moveTo>
                  <a:lnTo>
                    <a:pt x="4013454" y="508508"/>
                  </a:lnTo>
                  <a:lnTo>
                    <a:pt x="4013454" y="889889"/>
                  </a:lnTo>
                  <a:lnTo>
                    <a:pt x="4023868" y="889889"/>
                  </a:lnTo>
                  <a:lnTo>
                    <a:pt x="4023868" y="508508"/>
                  </a:lnTo>
                  <a:close/>
                </a:path>
                <a:path w="4082415" h="890270">
                  <a:moveTo>
                    <a:pt x="4081907" y="413131"/>
                  </a:moveTo>
                  <a:lnTo>
                    <a:pt x="4071493" y="413131"/>
                  </a:lnTo>
                  <a:lnTo>
                    <a:pt x="4071493" y="889889"/>
                  </a:lnTo>
                  <a:lnTo>
                    <a:pt x="4081907" y="889889"/>
                  </a:lnTo>
                  <a:lnTo>
                    <a:pt x="4081907" y="413131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6" name="object 116" descr=""/>
            <p:cNvSpPr/>
            <p:nvPr/>
          </p:nvSpPr>
          <p:spPr>
            <a:xfrm>
              <a:off x="5209286" y="7995031"/>
              <a:ext cx="4074160" cy="667385"/>
            </a:xfrm>
            <a:custGeom>
              <a:avLst/>
              <a:gdLst/>
              <a:ahLst/>
              <a:cxnLst/>
              <a:rect l="l" t="t" r="r" b="b"/>
              <a:pathLst>
                <a:path w="4074159" h="667384">
                  <a:moveTo>
                    <a:pt x="10414" y="190627"/>
                  </a:moveTo>
                  <a:lnTo>
                    <a:pt x="0" y="190627"/>
                  </a:lnTo>
                  <a:lnTo>
                    <a:pt x="0" y="667385"/>
                  </a:lnTo>
                  <a:lnTo>
                    <a:pt x="10414" y="667385"/>
                  </a:lnTo>
                  <a:lnTo>
                    <a:pt x="10414" y="190627"/>
                  </a:lnTo>
                  <a:close/>
                </a:path>
                <a:path w="4074159" h="667384">
                  <a:moveTo>
                    <a:pt x="68453" y="381381"/>
                  </a:moveTo>
                  <a:lnTo>
                    <a:pt x="58039" y="381381"/>
                  </a:lnTo>
                  <a:lnTo>
                    <a:pt x="58039" y="667385"/>
                  </a:lnTo>
                  <a:lnTo>
                    <a:pt x="68453" y="667385"/>
                  </a:lnTo>
                  <a:lnTo>
                    <a:pt x="68453" y="381381"/>
                  </a:lnTo>
                  <a:close/>
                </a:path>
                <a:path w="4074159" h="667384">
                  <a:moveTo>
                    <a:pt x="126492" y="286004"/>
                  </a:moveTo>
                  <a:lnTo>
                    <a:pt x="116078" y="286004"/>
                  </a:lnTo>
                  <a:lnTo>
                    <a:pt x="116078" y="667385"/>
                  </a:lnTo>
                  <a:lnTo>
                    <a:pt x="126492" y="667385"/>
                  </a:lnTo>
                  <a:lnTo>
                    <a:pt x="126492" y="286004"/>
                  </a:lnTo>
                  <a:close/>
                </a:path>
                <a:path w="4074159" h="667384">
                  <a:moveTo>
                    <a:pt x="184531" y="127127"/>
                  </a:moveTo>
                  <a:lnTo>
                    <a:pt x="174117" y="127127"/>
                  </a:lnTo>
                  <a:lnTo>
                    <a:pt x="174117" y="667385"/>
                  </a:lnTo>
                  <a:lnTo>
                    <a:pt x="184531" y="667385"/>
                  </a:lnTo>
                  <a:lnTo>
                    <a:pt x="184531" y="127127"/>
                  </a:lnTo>
                  <a:close/>
                </a:path>
                <a:path w="4074159" h="667384">
                  <a:moveTo>
                    <a:pt x="242570" y="127127"/>
                  </a:moveTo>
                  <a:lnTo>
                    <a:pt x="232156" y="127127"/>
                  </a:lnTo>
                  <a:lnTo>
                    <a:pt x="232156" y="667385"/>
                  </a:lnTo>
                  <a:lnTo>
                    <a:pt x="242570" y="667385"/>
                  </a:lnTo>
                  <a:lnTo>
                    <a:pt x="242570" y="127127"/>
                  </a:lnTo>
                  <a:close/>
                </a:path>
                <a:path w="4074159" h="667384">
                  <a:moveTo>
                    <a:pt x="300596" y="349504"/>
                  </a:moveTo>
                  <a:lnTo>
                    <a:pt x="290195" y="349504"/>
                  </a:lnTo>
                  <a:lnTo>
                    <a:pt x="290195" y="667385"/>
                  </a:lnTo>
                  <a:lnTo>
                    <a:pt x="300596" y="667385"/>
                  </a:lnTo>
                  <a:lnTo>
                    <a:pt x="300596" y="349504"/>
                  </a:lnTo>
                  <a:close/>
                </a:path>
                <a:path w="4074159" h="667384">
                  <a:moveTo>
                    <a:pt x="358648" y="158877"/>
                  </a:moveTo>
                  <a:lnTo>
                    <a:pt x="348234" y="158877"/>
                  </a:lnTo>
                  <a:lnTo>
                    <a:pt x="348234" y="667385"/>
                  </a:lnTo>
                  <a:lnTo>
                    <a:pt x="358648" y="667385"/>
                  </a:lnTo>
                  <a:lnTo>
                    <a:pt x="358648" y="158877"/>
                  </a:lnTo>
                  <a:close/>
                </a:path>
                <a:path w="4074159" h="667384">
                  <a:moveTo>
                    <a:pt x="416814" y="317754"/>
                  </a:moveTo>
                  <a:lnTo>
                    <a:pt x="406400" y="317754"/>
                  </a:lnTo>
                  <a:lnTo>
                    <a:pt x="406400" y="667385"/>
                  </a:lnTo>
                  <a:lnTo>
                    <a:pt x="416814" y="667385"/>
                  </a:lnTo>
                  <a:lnTo>
                    <a:pt x="416814" y="317754"/>
                  </a:lnTo>
                  <a:close/>
                </a:path>
                <a:path w="4074159" h="667384">
                  <a:moveTo>
                    <a:pt x="474853" y="222377"/>
                  </a:moveTo>
                  <a:lnTo>
                    <a:pt x="464439" y="222377"/>
                  </a:lnTo>
                  <a:lnTo>
                    <a:pt x="464439" y="667385"/>
                  </a:lnTo>
                  <a:lnTo>
                    <a:pt x="474853" y="667385"/>
                  </a:lnTo>
                  <a:lnTo>
                    <a:pt x="474853" y="222377"/>
                  </a:lnTo>
                  <a:close/>
                </a:path>
                <a:path w="4074159" h="667384">
                  <a:moveTo>
                    <a:pt x="532892" y="254254"/>
                  </a:moveTo>
                  <a:lnTo>
                    <a:pt x="522478" y="254254"/>
                  </a:lnTo>
                  <a:lnTo>
                    <a:pt x="522478" y="667385"/>
                  </a:lnTo>
                  <a:lnTo>
                    <a:pt x="532892" y="667385"/>
                  </a:lnTo>
                  <a:lnTo>
                    <a:pt x="532892" y="254254"/>
                  </a:lnTo>
                  <a:close/>
                </a:path>
                <a:path w="4074159" h="667384">
                  <a:moveTo>
                    <a:pt x="590931" y="127127"/>
                  </a:moveTo>
                  <a:lnTo>
                    <a:pt x="580517" y="127127"/>
                  </a:lnTo>
                  <a:lnTo>
                    <a:pt x="580517" y="667385"/>
                  </a:lnTo>
                  <a:lnTo>
                    <a:pt x="590931" y="667385"/>
                  </a:lnTo>
                  <a:lnTo>
                    <a:pt x="590931" y="127127"/>
                  </a:lnTo>
                  <a:close/>
                </a:path>
                <a:path w="4074159" h="667384">
                  <a:moveTo>
                    <a:pt x="648970" y="349504"/>
                  </a:moveTo>
                  <a:lnTo>
                    <a:pt x="638556" y="349504"/>
                  </a:lnTo>
                  <a:lnTo>
                    <a:pt x="638556" y="667385"/>
                  </a:lnTo>
                  <a:lnTo>
                    <a:pt x="648970" y="667385"/>
                  </a:lnTo>
                  <a:lnTo>
                    <a:pt x="648970" y="349504"/>
                  </a:lnTo>
                  <a:close/>
                </a:path>
                <a:path w="4074159" h="667384">
                  <a:moveTo>
                    <a:pt x="706996" y="349504"/>
                  </a:moveTo>
                  <a:lnTo>
                    <a:pt x="696595" y="349504"/>
                  </a:lnTo>
                  <a:lnTo>
                    <a:pt x="696595" y="667385"/>
                  </a:lnTo>
                  <a:lnTo>
                    <a:pt x="706996" y="667385"/>
                  </a:lnTo>
                  <a:lnTo>
                    <a:pt x="706996" y="349504"/>
                  </a:lnTo>
                  <a:close/>
                </a:path>
                <a:path w="4074159" h="667384">
                  <a:moveTo>
                    <a:pt x="765048" y="508508"/>
                  </a:moveTo>
                  <a:lnTo>
                    <a:pt x="754634" y="508508"/>
                  </a:lnTo>
                  <a:lnTo>
                    <a:pt x="754634" y="667385"/>
                  </a:lnTo>
                  <a:lnTo>
                    <a:pt x="765048" y="667385"/>
                  </a:lnTo>
                  <a:lnTo>
                    <a:pt x="765048" y="508508"/>
                  </a:lnTo>
                  <a:close/>
                </a:path>
                <a:path w="4074159" h="667384">
                  <a:moveTo>
                    <a:pt x="823087" y="444881"/>
                  </a:moveTo>
                  <a:lnTo>
                    <a:pt x="812673" y="444881"/>
                  </a:lnTo>
                  <a:lnTo>
                    <a:pt x="812673" y="667385"/>
                  </a:lnTo>
                  <a:lnTo>
                    <a:pt x="823087" y="667385"/>
                  </a:lnTo>
                  <a:lnTo>
                    <a:pt x="823087" y="444881"/>
                  </a:lnTo>
                  <a:close/>
                </a:path>
                <a:path w="4074159" h="667384">
                  <a:moveTo>
                    <a:pt x="881126" y="572008"/>
                  </a:moveTo>
                  <a:lnTo>
                    <a:pt x="870712" y="572008"/>
                  </a:lnTo>
                  <a:lnTo>
                    <a:pt x="870712" y="667385"/>
                  </a:lnTo>
                  <a:lnTo>
                    <a:pt x="881126" y="667385"/>
                  </a:lnTo>
                  <a:lnTo>
                    <a:pt x="881126" y="572008"/>
                  </a:lnTo>
                  <a:close/>
                </a:path>
                <a:path w="4074159" h="667384">
                  <a:moveTo>
                    <a:pt x="939292" y="508508"/>
                  </a:moveTo>
                  <a:lnTo>
                    <a:pt x="928878" y="508508"/>
                  </a:lnTo>
                  <a:lnTo>
                    <a:pt x="928878" y="667385"/>
                  </a:lnTo>
                  <a:lnTo>
                    <a:pt x="939292" y="667385"/>
                  </a:lnTo>
                  <a:lnTo>
                    <a:pt x="939292" y="508508"/>
                  </a:lnTo>
                  <a:close/>
                </a:path>
                <a:path w="4074159" h="667384">
                  <a:moveTo>
                    <a:pt x="997331" y="286004"/>
                  </a:moveTo>
                  <a:lnTo>
                    <a:pt x="986917" y="286004"/>
                  </a:lnTo>
                  <a:lnTo>
                    <a:pt x="986917" y="667385"/>
                  </a:lnTo>
                  <a:lnTo>
                    <a:pt x="997331" y="667385"/>
                  </a:lnTo>
                  <a:lnTo>
                    <a:pt x="997331" y="286004"/>
                  </a:lnTo>
                  <a:close/>
                </a:path>
                <a:path w="4074159" h="667384">
                  <a:moveTo>
                    <a:pt x="1055370" y="317754"/>
                  </a:moveTo>
                  <a:lnTo>
                    <a:pt x="1044956" y="317754"/>
                  </a:lnTo>
                  <a:lnTo>
                    <a:pt x="1044956" y="667385"/>
                  </a:lnTo>
                  <a:lnTo>
                    <a:pt x="1055370" y="667385"/>
                  </a:lnTo>
                  <a:lnTo>
                    <a:pt x="1055370" y="317754"/>
                  </a:lnTo>
                  <a:close/>
                </a:path>
                <a:path w="4074159" h="667384">
                  <a:moveTo>
                    <a:pt x="1113396" y="286004"/>
                  </a:moveTo>
                  <a:lnTo>
                    <a:pt x="1102995" y="286004"/>
                  </a:lnTo>
                  <a:lnTo>
                    <a:pt x="1102995" y="667385"/>
                  </a:lnTo>
                  <a:lnTo>
                    <a:pt x="1113396" y="667385"/>
                  </a:lnTo>
                  <a:lnTo>
                    <a:pt x="1113396" y="286004"/>
                  </a:lnTo>
                  <a:close/>
                </a:path>
                <a:path w="4074159" h="667384">
                  <a:moveTo>
                    <a:pt x="1171448" y="286004"/>
                  </a:moveTo>
                  <a:lnTo>
                    <a:pt x="1161034" y="286004"/>
                  </a:lnTo>
                  <a:lnTo>
                    <a:pt x="1161034" y="667385"/>
                  </a:lnTo>
                  <a:lnTo>
                    <a:pt x="1171448" y="667385"/>
                  </a:lnTo>
                  <a:lnTo>
                    <a:pt x="1171448" y="286004"/>
                  </a:lnTo>
                  <a:close/>
                </a:path>
                <a:path w="4074159" h="667384">
                  <a:moveTo>
                    <a:pt x="1229487" y="0"/>
                  </a:moveTo>
                  <a:lnTo>
                    <a:pt x="1219073" y="0"/>
                  </a:lnTo>
                  <a:lnTo>
                    <a:pt x="1219073" y="667385"/>
                  </a:lnTo>
                  <a:lnTo>
                    <a:pt x="1229487" y="667385"/>
                  </a:lnTo>
                  <a:lnTo>
                    <a:pt x="1229487" y="0"/>
                  </a:lnTo>
                  <a:close/>
                </a:path>
                <a:path w="4074159" h="667384">
                  <a:moveTo>
                    <a:pt x="1287526" y="413131"/>
                  </a:moveTo>
                  <a:lnTo>
                    <a:pt x="1277112" y="413131"/>
                  </a:lnTo>
                  <a:lnTo>
                    <a:pt x="1277112" y="667385"/>
                  </a:lnTo>
                  <a:lnTo>
                    <a:pt x="1287526" y="667385"/>
                  </a:lnTo>
                  <a:lnTo>
                    <a:pt x="1287526" y="413131"/>
                  </a:lnTo>
                  <a:close/>
                </a:path>
                <a:path w="4074159" h="667384">
                  <a:moveTo>
                    <a:pt x="1345565" y="222377"/>
                  </a:moveTo>
                  <a:lnTo>
                    <a:pt x="1335138" y="222377"/>
                  </a:lnTo>
                  <a:lnTo>
                    <a:pt x="1335138" y="667385"/>
                  </a:lnTo>
                  <a:lnTo>
                    <a:pt x="1345565" y="667385"/>
                  </a:lnTo>
                  <a:lnTo>
                    <a:pt x="1345565" y="222377"/>
                  </a:lnTo>
                  <a:close/>
                </a:path>
                <a:path w="4074159" h="667384">
                  <a:moveTo>
                    <a:pt x="1403604" y="381381"/>
                  </a:moveTo>
                  <a:lnTo>
                    <a:pt x="1393190" y="381381"/>
                  </a:lnTo>
                  <a:lnTo>
                    <a:pt x="1393190" y="667385"/>
                  </a:lnTo>
                  <a:lnTo>
                    <a:pt x="1403604" y="667385"/>
                  </a:lnTo>
                  <a:lnTo>
                    <a:pt x="1403604" y="381381"/>
                  </a:lnTo>
                  <a:close/>
                </a:path>
                <a:path w="4074159" h="667384">
                  <a:moveTo>
                    <a:pt x="1461770" y="444881"/>
                  </a:moveTo>
                  <a:lnTo>
                    <a:pt x="1451356" y="444881"/>
                  </a:lnTo>
                  <a:lnTo>
                    <a:pt x="1451356" y="667385"/>
                  </a:lnTo>
                  <a:lnTo>
                    <a:pt x="1461770" y="667385"/>
                  </a:lnTo>
                  <a:lnTo>
                    <a:pt x="1461770" y="444881"/>
                  </a:lnTo>
                  <a:close/>
                </a:path>
                <a:path w="4074159" h="667384">
                  <a:moveTo>
                    <a:pt x="1519809" y="349504"/>
                  </a:moveTo>
                  <a:lnTo>
                    <a:pt x="1509395" y="349504"/>
                  </a:lnTo>
                  <a:lnTo>
                    <a:pt x="1509395" y="667385"/>
                  </a:lnTo>
                  <a:lnTo>
                    <a:pt x="1519809" y="667385"/>
                  </a:lnTo>
                  <a:lnTo>
                    <a:pt x="1519809" y="349504"/>
                  </a:lnTo>
                  <a:close/>
                </a:path>
                <a:path w="4074159" h="667384">
                  <a:moveTo>
                    <a:pt x="1577848" y="317754"/>
                  </a:moveTo>
                  <a:lnTo>
                    <a:pt x="1567434" y="317754"/>
                  </a:lnTo>
                  <a:lnTo>
                    <a:pt x="1567434" y="667385"/>
                  </a:lnTo>
                  <a:lnTo>
                    <a:pt x="1577848" y="667385"/>
                  </a:lnTo>
                  <a:lnTo>
                    <a:pt x="1577848" y="317754"/>
                  </a:lnTo>
                  <a:close/>
                </a:path>
                <a:path w="4074159" h="667384">
                  <a:moveTo>
                    <a:pt x="1635887" y="349504"/>
                  </a:moveTo>
                  <a:lnTo>
                    <a:pt x="1625473" y="349504"/>
                  </a:lnTo>
                  <a:lnTo>
                    <a:pt x="1625473" y="667385"/>
                  </a:lnTo>
                  <a:lnTo>
                    <a:pt x="1635887" y="667385"/>
                  </a:lnTo>
                  <a:lnTo>
                    <a:pt x="1635887" y="349504"/>
                  </a:lnTo>
                  <a:close/>
                </a:path>
                <a:path w="4074159" h="667384">
                  <a:moveTo>
                    <a:pt x="1693926" y="444881"/>
                  </a:moveTo>
                  <a:lnTo>
                    <a:pt x="1683512" y="444881"/>
                  </a:lnTo>
                  <a:lnTo>
                    <a:pt x="1683512" y="667385"/>
                  </a:lnTo>
                  <a:lnTo>
                    <a:pt x="1693926" y="667385"/>
                  </a:lnTo>
                  <a:lnTo>
                    <a:pt x="1693926" y="444881"/>
                  </a:lnTo>
                  <a:close/>
                </a:path>
                <a:path w="4074159" h="667384">
                  <a:moveTo>
                    <a:pt x="1751965" y="349504"/>
                  </a:moveTo>
                  <a:lnTo>
                    <a:pt x="1741551" y="349504"/>
                  </a:lnTo>
                  <a:lnTo>
                    <a:pt x="1741551" y="667385"/>
                  </a:lnTo>
                  <a:lnTo>
                    <a:pt x="1751965" y="667385"/>
                  </a:lnTo>
                  <a:lnTo>
                    <a:pt x="1751965" y="349504"/>
                  </a:lnTo>
                  <a:close/>
                </a:path>
                <a:path w="4074159" h="667384">
                  <a:moveTo>
                    <a:pt x="1810004" y="349504"/>
                  </a:moveTo>
                  <a:lnTo>
                    <a:pt x="1799590" y="349504"/>
                  </a:lnTo>
                  <a:lnTo>
                    <a:pt x="1799590" y="667385"/>
                  </a:lnTo>
                  <a:lnTo>
                    <a:pt x="1810004" y="667385"/>
                  </a:lnTo>
                  <a:lnTo>
                    <a:pt x="1810004" y="349504"/>
                  </a:lnTo>
                  <a:close/>
                </a:path>
                <a:path w="4074159" h="667384">
                  <a:moveTo>
                    <a:pt x="1868043" y="476631"/>
                  </a:moveTo>
                  <a:lnTo>
                    <a:pt x="1857629" y="476631"/>
                  </a:lnTo>
                  <a:lnTo>
                    <a:pt x="1857629" y="667385"/>
                  </a:lnTo>
                  <a:lnTo>
                    <a:pt x="1868043" y="667385"/>
                  </a:lnTo>
                  <a:lnTo>
                    <a:pt x="1868043" y="476631"/>
                  </a:lnTo>
                  <a:close/>
                </a:path>
                <a:path w="4074159" h="667384">
                  <a:moveTo>
                    <a:pt x="1926082" y="317754"/>
                  </a:moveTo>
                  <a:lnTo>
                    <a:pt x="1915668" y="317754"/>
                  </a:lnTo>
                  <a:lnTo>
                    <a:pt x="1915668" y="667385"/>
                  </a:lnTo>
                  <a:lnTo>
                    <a:pt x="1926082" y="667385"/>
                  </a:lnTo>
                  <a:lnTo>
                    <a:pt x="1926082" y="317754"/>
                  </a:lnTo>
                  <a:close/>
                </a:path>
                <a:path w="4074159" h="667384">
                  <a:moveTo>
                    <a:pt x="1984121" y="286004"/>
                  </a:moveTo>
                  <a:lnTo>
                    <a:pt x="1973707" y="286004"/>
                  </a:lnTo>
                  <a:lnTo>
                    <a:pt x="1973707" y="667385"/>
                  </a:lnTo>
                  <a:lnTo>
                    <a:pt x="1984121" y="667385"/>
                  </a:lnTo>
                  <a:lnTo>
                    <a:pt x="1984121" y="286004"/>
                  </a:lnTo>
                  <a:close/>
                </a:path>
                <a:path w="4074159" h="667384">
                  <a:moveTo>
                    <a:pt x="2042287" y="444881"/>
                  </a:moveTo>
                  <a:lnTo>
                    <a:pt x="2031873" y="444881"/>
                  </a:lnTo>
                  <a:lnTo>
                    <a:pt x="2031873" y="667385"/>
                  </a:lnTo>
                  <a:lnTo>
                    <a:pt x="2042287" y="667385"/>
                  </a:lnTo>
                  <a:lnTo>
                    <a:pt x="2042287" y="444881"/>
                  </a:lnTo>
                  <a:close/>
                </a:path>
                <a:path w="4074159" h="667384">
                  <a:moveTo>
                    <a:pt x="2100326" y="572008"/>
                  </a:moveTo>
                  <a:lnTo>
                    <a:pt x="2089912" y="572008"/>
                  </a:lnTo>
                  <a:lnTo>
                    <a:pt x="2089912" y="667385"/>
                  </a:lnTo>
                  <a:lnTo>
                    <a:pt x="2100326" y="667385"/>
                  </a:lnTo>
                  <a:lnTo>
                    <a:pt x="2100326" y="572008"/>
                  </a:lnTo>
                  <a:close/>
                </a:path>
                <a:path w="4074159" h="667384">
                  <a:moveTo>
                    <a:pt x="2158365" y="476631"/>
                  </a:moveTo>
                  <a:lnTo>
                    <a:pt x="2147951" y="476631"/>
                  </a:lnTo>
                  <a:lnTo>
                    <a:pt x="2147951" y="667385"/>
                  </a:lnTo>
                  <a:lnTo>
                    <a:pt x="2158365" y="667385"/>
                  </a:lnTo>
                  <a:lnTo>
                    <a:pt x="2158365" y="476631"/>
                  </a:lnTo>
                  <a:close/>
                </a:path>
                <a:path w="4074159" h="667384">
                  <a:moveTo>
                    <a:pt x="2216404" y="317754"/>
                  </a:moveTo>
                  <a:lnTo>
                    <a:pt x="2205990" y="317754"/>
                  </a:lnTo>
                  <a:lnTo>
                    <a:pt x="2205990" y="667385"/>
                  </a:lnTo>
                  <a:lnTo>
                    <a:pt x="2216404" y="667385"/>
                  </a:lnTo>
                  <a:lnTo>
                    <a:pt x="2216404" y="317754"/>
                  </a:lnTo>
                  <a:close/>
                </a:path>
                <a:path w="4074159" h="667384">
                  <a:moveTo>
                    <a:pt x="2274443" y="381381"/>
                  </a:moveTo>
                  <a:lnTo>
                    <a:pt x="2264029" y="381381"/>
                  </a:lnTo>
                  <a:lnTo>
                    <a:pt x="2264029" y="667385"/>
                  </a:lnTo>
                  <a:lnTo>
                    <a:pt x="2274443" y="667385"/>
                  </a:lnTo>
                  <a:lnTo>
                    <a:pt x="2274443" y="381381"/>
                  </a:lnTo>
                  <a:close/>
                </a:path>
                <a:path w="4074159" h="667384">
                  <a:moveTo>
                    <a:pt x="2332482" y="317754"/>
                  </a:moveTo>
                  <a:lnTo>
                    <a:pt x="2322068" y="317754"/>
                  </a:lnTo>
                  <a:lnTo>
                    <a:pt x="2322068" y="667385"/>
                  </a:lnTo>
                  <a:lnTo>
                    <a:pt x="2332482" y="667385"/>
                  </a:lnTo>
                  <a:lnTo>
                    <a:pt x="2332482" y="317754"/>
                  </a:lnTo>
                  <a:close/>
                </a:path>
                <a:path w="4074159" h="667384">
                  <a:moveTo>
                    <a:pt x="2390521" y="349504"/>
                  </a:moveTo>
                  <a:lnTo>
                    <a:pt x="2380107" y="349504"/>
                  </a:lnTo>
                  <a:lnTo>
                    <a:pt x="2380107" y="667385"/>
                  </a:lnTo>
                  <a:lnTo>
                    <a:pt x="2390521" y="667385"/>
                  </a:lnTo>
                  <a:lnTo>
                    <a:pt x="2390521" y="349504"/>
                  </a:lnTo>
                  <a:close/>
                </a:path>
                <a:path w="4074159" h="667384">
                  <a:moveTo>
                    <a:pt x="2448560" y="349504"/>
                  </a:moveTo>
                  <a:lnTo>
                    <a:pt x="2438146" y="349504"/>
                  </a:lnTo>
                  <a:lnTo>
                    <a:pt x="2438146" y="667385"/>
                  </a:lnTo>
                  <a:lnTo>
                    <a:pt x="2448560" y="667385"/>
                  </a:lnTo>
                  <a:lnTo>
                    <a:pt x="2448560" y="349504"/>
                  </a:lnTo>
                  <a:close/>
                </a:path>
                <a:path w="4074159" h="667384">
                  <a:moveTo>
                    <a:pt x="2506599" y="413131"/>
                  </a:moveTo>
                  <a:lnTo>
                    <a:pt x="2496185" y="413131"/>
                  </a:lnTo>
                  <a:lnTo>
                    <a:pt x="2496185" y="667385"/>
                  </a:lnTo>
                  <a:lnTo>
                    <a:pt x="2506599" y="667385"/>
                  </a:lnTo>
                  <a:lnTo>
                    <a:pt x="2506599" y="413131"/>
                  </a:lnTo>
                  <a:close/>
                </a:path>
                <a:path w="4074159" h="667384">
                  <a:moveTo>
                    <a:pt x="2564765" y="381381"/>
                  </a:moveTo>
                  <a:lnTo>
                    <a:pt x="2554351" y="381381"/>
                  </a:lnTo>
                  <a:lnTo>
                    <a:pt x="2554351" y="667385"/>
                  </a:lnTo>
                  <a:lnTo>
                    <a:pt x="2564765" y="667385"/>
                  </a:lnTo>
                  <a:lnTo>
                    <a:pt x="2564765" y="381381"/>
                  </a:lnTo>
                  <a:close/>
                </a:path>
                <a:path w="4074159" h="667384">
                  <a:moveTo>
                    <a:pt x="2622804" y="381381"/>
                  </a:moveTo>
                  <a:lnTo>
                    <a:pt x="2612390" y="381381"/>
                  </a:lnTo>
                  <a:lnTo>
                    <a:pt x="2612390" y="667385"/>
                  </a:lnTo>
                  <a:lnTo>
                    <a:pt x="2622804" y="667385"/>
                  </a:lnTo>
                  <a:lnTo>
                    <a:pt x="2622804" y="381381"/>
                  </a:lnTo>
                  <a:close/>
                </a:path>
                <a:path w="4074159" h="667384">
                  <a:moveTo>
                    <a:pt x="2680843" y="381381"/>
                  </a:moveTo>
                  <a:lnTo>
                    <a:pt x="2670429" y="381381"/>
                  </a:lnTo>
                  <a:lnTo>
                    <a:pt x="2670429" y="667385"/>
                  </a:lnTo>
                  <a:lnTo>
                    <a:pt x="2680843" y="667385"/>
                  </a:lnTo>
                  <a:lnTo>
                    <a:pt x="2680843" y="381381"/>
                  </a:lnTo>
                  <a:close/>
                </a:path>
                <a:path w="4074159" h="667384">
                  <a:moveTo>
                    <a:pt x="2738882" y="444881"/>
                  </a:moveTo>
                  <a:lnTo>
                    <a:pt x="2728468" y="444881"/>
                  </a:lnTo>
                  <a:lnTo>
                    <a:pt x="2728468" y="667385"/>
                  </a:lnTo>
                  <a:lnTo>
                    <a:pt x="2738882" y="667385"/>
                  </a:lnTo>
                  <a:lnTo>
                    <a:pt x="2738882" y="444881"/>
                  </a:lnTo>
                  <a:close/>
                </a:path>
                <a:path w="4074159" h="667384">
                  <a:moveTo>
                    <a:pt x="2796921" y="158877"/>
                  </a:moveTo>
                  <a:lnTo>
                    <a:pt x="2786507" y="158877"/>
                  </a:lnTo>
                  <a:lnTo>
                    <a:pt x="2786507" y="667385"/>
                  </a:lnTo>
                  <a:lnTo>
                    <a:pt x="2796921" y="667385"/>
                  </a:lnTo>
                  <a:lnTo>
                    <a:pt x="2796921" y="158877"/>
                  </a:lnTo>
                  <a:close/>
                </a:path>
                <a:path w="4074159" h="667384">
                  <a:moveTo>
                    <a:pt x="2862834" y="444881"/>
                  </a:moveTo>
                  <a:lnTo>
                    <a:pt x="2849753" y="444881"/>
                  </a:lnTo>
                  <a:lnTo>
                    <a:pt x="2849753" y="667385"/>
                  </a:lnTo>
                  <a:lnTo>
                    <a:pt x="2862834" y="667385"/>
                  </a:lnTo>
                  <a:lnTo>
                    <a:pt x="2862834" y="444881"/>
                  </a:lnTo>
                  <a:close/>
                </a:path>
                <a:path w="4074159" h="667384">
                  <a:moveTo>
                    <a:pt x="2912999" y="476631"/>
                  </a:moveTo>
                  <a:lnTo>
                    <a:pt x="2902585" y="476631"/>
                  </a:lnTo>
                  <a:lnTo>
                    <a:pt x="2902585" y="667385"/>
                  </a:lnTo>
                  <a:lnTo>
                    <a:pt x="2912999" y="667385"/>
                  </a:lnTo>
                  <a:lnTo>
                    <a:pt x="2912999" y="476631"/>
                  </a:lnTo>
                  <a:close/>
                </a:path>
                <a:path w="4074159" h="667384">
                  <a:moveTo>
                    <a:pt x="2971038" y="349504"/>
                  </a:moveTo>
                  <a:lnTo>
                    <a:pt x="2960624" y="349504"/>
                  </a:lnTo>
                  <a:lnTo>
                    <a:pt x="2960624" y="667385"/>
                  </a:lnTo>
                  <a:lnTo>
                    <a:pt x="2971038" y="667385"/>
                  </a:lnTo>
                  <a:lnTo>
                    <a:pt x="2971038" y="349504"/>
                  </a:lnTo>
                  <a:close/>
                </a:path>
                <a:path w="4074159" h="667384">
                  <a:moveTo>
                    <a:pt x="3029077" y="127127"/>
                  </a:moveTo>
                  <a:lnTo>
                    <a:pt x="3018663" y="127127"/>
                  </a:lnTo>
                  <a:lnTo>
                    <a:pt x="3018663" y="667385"/>
                  </a:lnTo>
                  <a:lnTo>
                    <a:pt x="3029077" y="667385"/>
                  </a:lnTo>
                  <a:lnTo>
                    <a:pt x="3029077" y="127127"/>
                  </a:lnTo>
                  <a:close/>
                </a:path>
                <a:path w="4074159" h="667384">
                  <a:moveTo>
                    <a:pt x="3087243" y="381381"/>
                  </a:moveTo>
                  <a:lnTo>
                    <a:pt x="3076829" y="381381"/>
                  </a:lnTo>
                  <a:lnTo>
                    <a:pt x="3076829" y="667385"/>
                  </a:lnTo>
                  <a:lnTo>
                    <a:pt x="3087243" y="667385"/>
                  </a:lnTo>
                  <a:lnTo>
                    <a:pt x="3087243" y="381381"/>
                  </a:lnTo>
                  <a:close/>
                </a:path>
                <a:path w="4074159" h="667384">
                  <a:moveTo>
                    <a:pt x="3145282" y="381381"/>
                  </a:moveTo>
                  <a:lnTo>
                    <a:pt x="3134868" y="381381"/>
                  </a:lnTo>
                  <a:lnTo>
                    <a:pt x="3134868" y="667385"/>
                  </a:lnTo>
                  <a:lnTo>
                    <a:pt x="3145282" y="667385"/>
                  </a:lnTo>
                  <a:lnTo>
                    <a:pt x="3145282" y="381381"/>
                  </a:lnTo>
                  <a:close/>
                </a:path>
                <a:path w="4074159" h="667384">
                  <a:moveTo>
                    <a:pt x="3203321" y="444881"/>
                  </a:moveTo>
                  <a:lnTo>
                    <a:pt x="3192907" y="444881"/>
                  </a:lnTo>
                  <a:lnTo>
                    <a:pt x="3192907" y="667385"/>
                  </a:lnTo>
                  <a:lnTo>
                    <a:pt x="3203321" y="667385"/>
                  </a:lnTo>
                  <a:lnTo>
                    <a:pt x="3203321" y="444881"/>
                  </a:lnTo>
                  <a:close/>
                </a:path>
                <a:path w="4074159" h="667384">
                  <a:moveTo>
                    <a:pt x="3261360" y="508508"/>
                  </a:moveTo>
                  <a:lnTo>
                    <a:pt x="3250946" y="508508"/>
                  </a:lnTo>
                  <a:lnTo>
                    <a:pt x="3250946" y="667385"/>
                  </a:lnTo>
                  <a:lnTo>
                    <a:pt x="3261360" y="667385"/>
                  </a:lnTo>
                  <a:lnTo>
                    <a:pt x="3261360" y="508508"/>
                  </a:lnTo>
                  <a:close/>
                </a:path>
                <a:path w="4074159" h="667384">
                  <a:moveTo>
                    <a:pt x="3319399" y="508508"/>
                  </a:moveTo>
                  <a:lnTo>
                    <a:pt x="3308985" y="508508"/>
                  </a:lnTo>
                  <a:lnTo>
                    <a:pt x="3308985" y="667385"/>
                  </a:lnTo>
                  <a:lnTo>
                    <a:pt x="3319399" y="667385"/>
                  </a:lnTo>
                  <a:lnTo>
                    <a:pt x="3319399" y="508508"/>
                  </a:lnTo>
                  <a:close/>
                </a:path>
                <a:path w="4074159" h="667384">
                  <a:moveTo>
                    <a:pt x="3377438" y="222377"/>
                  </a:moveTo>
                  <a:lnTo>
                    <a:pt x="3367024" y="222377"/>
                  </a:lnTo>
                  <a:lnTo>
                    <a:pt x="3367024" y="667385"/>
                  </a:lnTo>
                  <a:lnTo>
                    <a:pt x="3377438" y="667385"/>
                  </a:lnTo>
                  <a:lnTo>
                    <a:pt x="3377438" y="222377"/>
                  </a:lnTo>
                  <a:close/>
                </a:path>
                <a:path w="4074159" h="667384">
                  <a:moveTo>
                    <a:pt x="3435477" y="381381"/>
                  </a:moveTo>
                  <a:lnTo>
                    <a:pt x="3425063" y="381381"/>
                  </a:lnTo>
                  <a:lnTo>
                    <a:pt x="3425063" y="667385"/>
                  </a:lnTo>
                  <a:lnTo>
                    <a:pt x="3435477" y="667385"/>
                  </a:lnTo>
                  <a:lnTo>
                    <a:pt x="3435477" y="381381"/>
                  </a:lnTo>
                  <a:close/>
                </a:path>
                <a:path w="4074159" h="667384">
                  <a:moveTo>
                    <a:pt x="3493516" y="158877"/>
                  </a:moveTo>
                  <a:lnTo>
                    <a:pt x="3483102" y="158877"/>
                  </a:lnTo>
                  <a:lnTo>
                    <a:pt x="3483102" y="667385"/>
                  </a:lnTo>
                  <a:lnTo>
                    <a:pt x="3493516" y="667385"/>
                  </a:lnTo>
                  <a:lnTo>
                    <a:pt x="3493516" y="158877"/>
                  </a:lnTo>
                  <a:close/>
                </a:path>
                <a:path w="4074159" h="667384">
                  <a:moveTo>
                    <a:pt x="3551555" y="381381"/>
                  </a:moveTo>
                  <a:lnTo>
                    <a:pt x="3541141" y="381381"/>
                  </a:lnTo>
                  <a:lnTo>
                    <a:pt x="3541141" y="667385"/>
                  </a:lnTo>
                  <a:lnTo>
                    <a:pt x="3551555" y="667385"/>
                  </a:lnTo>
                  <a:lnTo>
                    <a:pt x="3551555" y="381381"/>
                  </a:lnTo>
                  <a:close/>
                </a:path>
                <a:path w="4074159" h="667384">
                  <a:moveTo>
                    <a:pt x="3609594" y="381381"/>
                  </a:moveTo>
                  <a:lnTo>
                    <a:pt x="3599180" y="381381"/>
                  </a:lnTo>
                  <a:lnTo>
                    <a:pt x="3599180" y="667385"/>
                  </a:lnTo>
                  <a:lnTo>
                    <a:pt x="3609594" y="667385"/>
                  </a:lnTo>
                  <a:lnTo>
                    <a:pt x="3609594" y="381381"/>
                  </a:lnTo>
                  <a:close/>
                </a:path>
                <a:path w="4074159" h="667384">
                  <a:moveTo>
                    <a:pt x="3667760" y="413131"/>
                  </a:moveTo>
                  <a:lnTo>
                    <a:pt x="3657346" y="413131"/>
                  </a:lnTo>
                  <a:lnTo>
                    <a:pt x="3657346" y="667385"/>
                  </a:lnTo>
                  <a:lnTo>
                    <a:pt x="3667760" y="667385"/>
                  </a:lnTo>
                  <a:lnTo>
                    <a:pt x="3667760" y="413131"/>
                  </a:lnTo>
                  <a:close/>
                </a:path>
                <a:path w="4074159" h="667384">
                  <a:moveTo>
                    <a:pt x="3725799" y="476631"/>
                  </a:moveTo>
                  <a:lnTo>
                    <a:pt x="3715385" y="476631"/>
                  </a:lnTo>
                  <a:lnTo>
                    <a:pt x="3715385" y="667385"/>
                  </a:lnTo>
                  <a:lnTo>
                    <a:pt x="3725799" y="667385"/>
                  </a:lnTo>
                  <a:lnTo>
                    <a:pt x="3725799" y="476631"/>
                  </a:lnTo>
                  <a:close/>
                </a:path>
                <a:path w="4074159" h="667384">
                  <a:moveTo>
                    <a:pt x="3783838" y="444881"/>
                  </a:moveTo>
                  <a:lnTo>
                    <a:pt x="3773424" y="444881"/>
                  </a:lnTo>
                  <a:lnTo>
                    <a:pt x="3773424" y="667385"/>
                  </a:lnTo>
                  <a:lnTo>
                    <a:pt x="3783838" y="667385"/>
                  </a:lnTo>
                  <a:lnTo>
                    <a:pt x="3783838" y="444881"/>
                  </a:lnTo>
                  <a:close/>
                </a:path>
                <a:path w="4074159" h="667384">
                  <a:moveTo>
                    <a:pt x="3841877" y="254254"/>
                  </a:moveTo>
                  <a:lnTo>
                    <a:pt x="3831463" y="254254"/>
                  </a:lnTo>
                  <a:lnTo>
                    <a:pt x="3831463" y="667385"/>
                  </a:lnTo>
                  <a:lnTo>
                    <a:pt x="3841877" y="667385"/>
                  </a:lnTo>
                  <a:lnTo>
                    <a:pt x="3841877" y="254254"/>
                  </a:lnTo>
                  <a:close/>
                </a:path>
                <a:path w="4074159" h="667384">
                  <a:moveTo>
                    <a:pt x="3899916" y="317754"/>
                  </a:moveTo>
                  <a:lnTo>
                    <a:pt x="3889502" y="317754"/>
                  </a:lnTo>
                  <a:lnTo>
                    <a:pt x="3889502" y="667385"/>
                  </a:lnTo>
                  <a:lnTo>
                    <a:pt x="3899916" y="667385"/>
                  </a:lnTo>
                  <a:lnTo>
                    <a:pt x="3899916" y="317754"/>
                  </a:lnTo>
                  <a:close/>
                </a:path>
                <a:path w="4074159" h="667384">
                  <a:moveTo>
                    <a:pt x="3957955" y="572008"/>
                  </a:moveTo>
                  <a:lnTo>
                    <a:pt x="3947541" y="572008"/>
                  </a:lnTo>
                  <a:lnTo>
                    <a:pt x="3947541" y="667385"/>
                  </a:lnTo>
                  <a:lnTo>
                    <a:pt x="3957955" y="667385"/>
                  </a:lnTo>
                  <a:lnTo>
                    <a:pt x="3957955" y="572008"/>
                  </a:lnTo>
                  <a:close/>
                </a:path>
                <a:path w="4074159" h="667384">
                  <a:moveTo>
                    <a:pt x="4015994" y="317754"/>
                  </a:moveTo>
                  <a:lnTo>
                    <a:pt x="4005580" y="317754"/>
                  </a:lnTo>
                  <a:lnTo>
                    <a:pt x="4005580" y="667385"/>
                  </a:lnTo>
                  <a:lnTo>
                    <a:pt x="4015994" y="667385"/>
                  </a:lnTo>
                  <a:lnTo>
                    <a:pt x="4015994" y="317754"/>
                  </a:lnTo>
                  <a:close/>
                </a:path>
                <a:path w="4074159" h="667384">
                  <a:moveTo>
                    <a:pt x="4074033" y="540258"/>
                  </a:moveTo>
                  <a:lnTo>
                    <a:pt x="4063619" y="540258"/>
                  </a:lnTo>
                  <a:lnTo>
                    <a:pt x="4063619" y="667385"/>
                  </a:lnTo>
                  <a:lnTo>
                    <a:pt x="4074033" y="667385"/>
                  </a:lnTo>
                  <a:lnTo>
                    <a:pt x="4074033" y="540258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7" name="object 117" descr=""/>
            <p:cNvSpPr/>
            <p:nvPr/>
          </p:nvSpPr>
          <p:spPr>
            <a:xfrm>
              <a:off x="9272905" y="8249285"/>
              <a:ext cx="4132579" cy="413384"/>
            </a:xfrm>
            <a:custGeom>
              <a:avLst/>
              <a:gdLst/>
              <a:ahLst/>
              <a:cxnLst/>
              <a:rect l="l" t="t" r="r" b="b"/>
              <a:pathLst>
                <a:path w="4132580" h="413384">
                  <a:moveTo>
                    <a:pt x="10414" y="286004"/>
                  </a:moveTo>
                  <a:lnTo>
                    <a:pt x="0" y="286004"/>
                  </a:lnTo>
                  <a:lnTo>
                    <a:pt x="0" y="413131"/>
                  </a:lnTo>
                  <a:lnTo>
                    <a:pt x="10414" y="413131"/>
                  </a:lnTo>
                  <a:lnTo>
                    <a:pt x="10414" y="286004"/>
                  </a:lnTo>
                  <a:close/>
                </a:path>
                <a:path w="4132580" h="413384">
                  <a:moveTo>
                    <a:pt x="68453" y="286004"/>
                  </a:moveTo>
                  <a:lnTo>
                    <a:pt x="58039" y="286004"/>
                  </a:lnTo>
                  <a:lnTo>
                    <a:pt x="58039" y="413131"/>
                  </a:lnTo>
                  <a:lnTo>
                    <a:pt x="68453" y="413131"/>
                  </a:lnTo>
                  <a:lnTo>
                    <a:pt x="68453" y="286004"/>
                  </a:lnTo>
                  <a:close/>
                </a:path>
                <a:path w="4132580" h="413384">
                  <a:moveTo>
                    <a:pt x="126619" y="190627"/>
                  </a:moveTo>
                  <a:lnTo>
                    <a:pt x="116205" y="190627"/>
                  </a:lnTo>
                  <a:lnTo>
                    <a:pt x="116205" y="413131"/>
                  </a:lnTo>
                  <a:lnTo>
                    <a:pt x="126619" y="413131"/>
                  </a:lnTo>
                  <a:lnTo>
                    <a:pt x="126619" y="190627"/>
                  </a:lnTo>
                  <a:close/>
                </a:path>
                <a:path w="4132580" h="413384">
                  <a:moveTo>
                    <a:pt x="184658" y="286004"/>
                  </a:moveTo>
                  <a:lnTo>
                    <a:pt x="174244" y="286004"/>
                  </a:lnTo>
                  <a:lnTo>
                    <a:pt x="174244" y="413131"/>
                  </a:lnTo>
                  <a:lnTo>
                    <a:pt x="184658" y="413131"/>
                  </a:lnTo>
                  <a:lnTo>
                    <a:pt x="184658" y="286004"/>
                  </a:lnTo>
                  <a:close/>
                </a:path>
                <a:path w="4132580" h="413384">
                  <a:moveTo>
                    <a:pt x="242697" y="31750"/>
                  </a:moveTo>
                  <a:lnTo>
                    <a:pt x="232283" y="31750"/>
                  </a:lnTo>
                  <a:lnTo>
                    <a:pt x="232283" y="413131"/>
                  </a:lnTo>
                  <a:lnTo>
                    <a:pt x="242697" y="413131"/>
                  </a:lnTo>
                  <a:lnTo>
                    <a:pt x="242697" y="31750"/>
                  </a:lnTo>
                  <a:close/>
                </a:path>
                <a:path w="4132580" h="413384">
                  <a:moveTo>
                    <a:pt x="300736" y="286004"/>
                  </a:moveTo>
                  <a:lnTo>
                    <a:pt x="290322" y="286004"/>
                  </a:lnTo>
                  <a:lnTo>
                    <a:pt x="290322" y="413131"/>
                  </a:lnTo>
                  <a:lnTo>
                    <a:pt x="300736" y="413131"/>
                  </a:lnTo>
                  <a:lnTo>
                    <a:pt x="300736" y="286004"/>
                  </a:lnTo>
                  <a:close/>
                </a:path>
                <a:path w="4132580" h="413384">
                  <a:moveTo>
                    <a:pt x="358775" y="127127"/>
                  </a:moveTo>
                  <a:lnTo>
                    <a:pt x="348361" y="127127"/>
                  </a:lnTo>
                  <a:lnTo>
                    <a:pt x="348361" y="413131"/>
                  </a:lnTo>
                  <a:lnTo>
                    <a:pt x="358775" y="413131"/>
                  </a:lnTo>
                  <a:lnTo>
                    <a:pt x="358775" y="127127"/>
                  </a:lnTo>
                  <a:close/>
                </a:path>
                <a:path w="4132580" h="413384">
                  <a:moveTo>
                    <a:pt x="416814" y="317754"/>
                  </a:moveTo>
                  <a:lnTo>
                    <a:pt x="406400" y="317754"/>
                  </a:lnTo>
                  <a:lnTo>
                    <a:pt x="406400" y="413131"/>
                  </a:lnTo>
                  <a:lnTo>
                    <a:pt x="416814" y="413131"/>
                  </a:lnTo>
                  <a:lnTo>
                    <a:pt x="416814" y="317754"/>
                  </a:lnTo>
                  <a:close/>
                </a:path>
                <a:path w="4132580" h="413384">
                  <a:moveTo>
                    <a:pt x="474853" y="0"/>
                  </a:moveTo>
                  <a:lnTo>
                    <a:pt x="464439" y="0"/>
                  </a:lnTo>
                  <a:lnTo>
                    <a:pt x="464439" y="413131"/>
                  </a:lnTo>
                  <a:lnTo>
                    <a:pt x="474853" y="413131"/>
                  </a:lnTo>
                  <a:lnTo>
                    <a:pt x="474853" y="0"/>
                  </a:lnTo>
                  <a:close/>
                </a:path>
                <a:path w="4132580" h="413384">
                  <a:moveTo>
                    <a:pt x="532892" y="286004"/>
                  </a:moveTo>
                  <a:lnTo>
                    <a:pt x="522478" y="286004"/>
                  </a:lnTo>
                  <a:lnTo>
                    <a:pt x="522478" y="413131"/>
                  </a:lnTo>
                  <a:lnTo>
                    <a:pt x="532892" y="413131"/>
                  </a:lnTo>
                  <a:lnTo>
                    <a:pt x="532892" y="286004"/>
                  </a:lnTo>
                  <a:close/>
                </a:path>
                <a:path w="4132580" h="413384">
                  <a:moveTo>
                    <a:pt x="590931" y="254254"/>
                  </a:moveTo>
                  <a:lnTo>
                    <a:pt x="580517" y="254254"/>
                  </a:lnTo>
                  <a:lnTo>
                    <a:pt x="580517" y="413131"/>
                  </a:lnTo>
                  <a:lnTo>
                    <a:pt x="590931" y="413131"/>
                  </a:lnTo>
                  <a:lnTo>
                    <a:pt x="590931" y="254254"/>
                  </a:lnTo>
                  <a:close/>
                </a:path>
                <a:path w="4132580" h="413384">
                  <a:moveTo>
                    <a:pt x="649097" y="222377"/>
                  </a:moveTo>
                  <a:lnTo>
                    <a:pt x="638683" y="222377"/>
                  </a:lnTo>
                  <a:lnTo>
                    <a:pt x="638683" y="413131"/>
                  </a:lnTo>
                  <a:lnTo>
                    <a:pt x="649097" y="413131"/>
                  </a:lnTo>
                  <a:lnTo>
                    <a:pt x="649097" y="222377"/>
                  </a:lnTo>
                  <a:close/>
                </a:path>
                <a:path w="4132580" h="413384">
                  <a:moveTo>
                    <a:pt x="707136" y="222377"/>
                  </a:moveTo>
                  <a:lnTo>
                    <a:pt x="696722" y="222377"/>
                  </a:lnTo>
                  <a:lnTo>
                    <a:pt x="696722" y="413131"/>
                  </a:lnTo>
                  <a:lnTo>
                    <a:pt x="707136" y="413131"/>
                  </a:lnTo>
                  <a:lnTo>
                    <a:pt x="707136" y="222377"/>
                  </a:lnTo>
                  <a:close/>
                </a:path>
                <a:path w="4132580" h="413384">
                  <a:moveTo>
                    <a:pt x="765175" y="254254"/>
                  </a:moveTo>
                  <a:lnTo>
                    <a:pt x="754761" y="254254"/>
                  </a:lnTo>
                  <a:lnTo>
                    <a:pt x="754761" y="413131"/>
                  </a:lnTo>
                  <a:lnTo>
                    <a:pt x="765175" y="413131"/>
                  </a:lnTo>
                  <a:lnTo>
                    <a:pt x="765175" y="254254"/>
                  </a:lnTo>
                  <a:close/>
                </a:path>
                <a:path w="4132580" h="413384">
                  <a:moveTo>
                    <a:pt x="831075" y="190627"/>
                  </a:moveTo>
                  <a:lnTo>
                    <a:pt x="818007" y="190627"/>
                  </a:lnTo>
                  <a:lnTo>
                    <a:pt x="818007" y="413131"/>
                  </a:lnTo>
                  <a:lnTo>
                    <a:pt x="831075" y="413131"/>
                  </a:lnTo>
                  <a:lnTo>
                    <a:pt x="831075" y="190627"/>
                  </a:lnTo>
                  <a:close/>
                </a:path>
                <a:path w="4132580" h="413384">
                  <a:moveTo>
                    <a:pt x="881253" y="190627"/>
                  </a:moveTo>
                  <a:lnTo>
                    <a:pt x="870839" y="190627"/>
                  </a:lnTo>
                  <a:lnTo>
                    <a:pt x="870839" y="413131"/>
                  </a:lnTo>
                  <a:lnTo>
                    <a:pt x="881253" y="413131"/>
                  </a:lnTo>
                  <a:lnTo>
                    <a:pt x="881253" y="190627"/>
                  </a:lnTo>
                  <a:close/>
                </a:path>
                <a:path w="4132580" h="413384">
                  <a:moveTo>
                    <a:pt x="939292" y="190627"/>
                  </a:moveTo>
                  <a:lnTo>
                    <a:pt x="928878" y="190627"/>
                  </a:lnTo>
                  <a:lnTo>
                    <a:pt x="928878" y="413131"/>
                  </a:lnTo>
                  <a:lnTo>
                    <a:pt x="939292" y="413131"/>
                  </a:lnTo>
                  <a:lnTo>
                    <a:pt x="939292" y="190627"/>
                  </a:lnTo>
                  <a:close/>
                </a:path>
                <a:path w="4132580" h="413384">
                  <a:moveTo>
                    <a:pt x="997331" y="63500"/>
                  </a:moveTo>
                  <a:lnTo>
                    <a:pt x="986917" y="63500"/>
                  </a:lnTo>
                  <a:lnTo>
                    <a:pt x="986917" y="413131"/>
                  </a:lnTo>
                  <a:lnTo>
                    <a:pt x="997331" y="413131"/>
                  </a:lnTo>
                  <a:lnTo>
                    <a:pt x="997331" y="63500"/>
                  </a:lnTo>
                  <a:close/>
                </a:path>
                <a:path w="4132580" h="413384">
                  <a:moveTo>
                    <a:pt x="1055370" y="286004"/>
                  </a:moveTo>
                  <a:lnTo>
                    <a:pt x="1044956" y="286004"/>
                  </a:lnTo>
                  <a:lnTo>
                    <a:pt x="1044956" y="413131"/>
                  </a:lnTo>
                  <a:lnTo>
                    <a:pt x="1055370" y="413131"/>
                  </a:lnTo>
                  <a:lnTo>
                    <a:pt x="1055370" y="286004"/>
                  </a:lnTo>
                  <a:close/>
                </a:path>
                <a:path w="4132580" h="413384">
                  <a:moveTo>
                    <a:pt x="1113409" y="349504"/>
                  </a:moveTo>
                  <a:lnTo>
                    <a:pt x="1102995" y="349504"/>
                  </a:lnTo>
                  <a:lnTo>
                    <a:pt x="1102995" y="413131"/>
                  </a:lnTo>
                  <a:lnTo>
                    <a:pt x="1113409" y="413131"/>
                  </a:lnTo>
                  <a:lnTo>
                    <a:pt x="1113409" y="349504"/>
                  </a:lnTo>
                  <a:close/>
                </a:path>
                <a:path w="4132580" h="413384">
                  <a:moveTo>
                    <a:pt x="1171448" y="190627"/>
                  </a:moveTo>
                  <a:lnTo>
                    <a:pt x="1161034" y="190627"/>
                  </a:lnTo>
                  <a:lnTo>
                    <a:pt x="1161034" y="413131"/>
                  </a:lnTo>
                  <a:lnTo>
                    <a:pt x="1171448" y="413131"/>
                  </a:lnTo>
                  <a:lnTo>
                    <a:pt x="1171448" y="190627"/>
                  </a:lnTo>
                  <a:close/>
                </a:path>
                <a:path w="4132580" h="413384">
                  <a:moveTo>
                    <a:pt x="1229614" y="127127"/>
                  </a:moveTo>
                  <a:lnTo>
                    <a:pt x="1219200" y="127127"/>
                  </a:lnTo>
                  <a:lnTo>
                    <a:pt x="1219200" y="413131"/>
                  </a:lnTo>
                  <a:lnTo>
                    <a:pt x="1229614" y="413131"/>
                  </a:lnTo>
                  <a:lnTo>
                    <a:pt x="1229614" y="127127"/>
                  </a:lnTo>
                  <a:close/>
                </a:path>
                <a:path w="4132580" h="413384">
                  <a:moveTo>
                    <a:pt x="1295527" y="190627"/>
                  </a:moveTo>
                  <a:lnTo>
                    <a:pt x="1282446" y="190627"/>
                  </a:lnTo>
                  <a:lnTo>
                    <a:pt x="1282446" y="413131"/>
                  </a:lnTo>
                  <a:lnTo>
                    <a:pt x="1295527" y="413131"/>
                  </a:lnTo>
                  <a:lnTo>
                    <a:pt x="1295527" y="190627"/>
                  </a:lnTo>
                  <a:close/>
                </a:path>
                <a:path w="4132580" h="413384">
                  <a:moveTo>
                    <a:pt x="1345692" y="158877"/>
                  </a:moveTo>
                  <a:lnTo>
                    <a:pt x="1335278" y="158877"/>
                  </a:lnTo>
                  <a:lnTo>
                    <a:pt x="1335278" y="413131"/>
                  </a:lnTo>
                  <a:lnTo>
                    <a:pt x="1345692" y="413131"/>
                  </a:lnTo>
                  <a:lnTo>
                    <a:pt x="1345692" y="158877"/>
                  </a:lnTo>
                  <a:close/>
                </a:path>
                <a:path w="4132580" h="413384">
                  <a:moveTo>
                    <a:pt x="1403731" y="349504"/>
                  </a:moveTo>
                  <a:lnTo>
                    <a:pt x="1393317" y="349504"/>
                  </a:lnTo>
                  <a:lnTo>
                    <a:pt x="1393317" y="413131"/>
                  </a:lnTo>
                  <a:lnTo>
                    <a:pt x="1403731" y="413131"/>
                  </a:lnTo>
                  <a:lnTo>
                    <a:pt x="1403731" y="349504"/>
                  </a:lnTo>
                  <a:close/>
                </a:path>
                <a:path w="4132580" h="413384">
                  <a:moveTo>
                    <a:pt x="1461770" y="190627"/>
                  </a:moveTo>
                  <a:lnTo>
                    <a:pt x="1451356" y="190627"/>
                  </a:lnTo>
                  <a:lnTo>
                    <a:pt x="1451356" y="413131"/>
                  </a:lnTo>
                  <a:lnTo>
                    <a:pt x="1461770" y="413131"/>
                  </a:lnTo>
                  <a:lnTo>
                    <a:pt x="1461770" y="190627"/>
                  </a:lnTo>
                  <a:close/>
                </a:path>
                <a:path w="4132580" h="413384">
                  <a:moveTo>
                    <a:pt x="1519809" y="286004"/>
                  </a:moveTo>
                  <a:lnTo>
                    <a:pt x="1509395" y="286004"/>
                  </a:lnTo>
                  <a:lnTo>
                    <a:pt x="1509395" y="413131"/>
                  </a:lnTo>
                  <a:lnTo>
                    <a:pt x="1519809" y="413131"/>
                  </a:lnTo>
                  <a:lnTo>
                    <a:pt x="1519809" y="286004"/>
                  </a:lnTo>
                  <a:close/>
                </a:path>
                <a:path w="4132580" h="413384">
                  <a:moveTo>
                    <a:pt x="1577848" y="63500"/>
                  </a:moveTo>
                  <a:lnTo>
                    <a:pt x="1567434" y="63500"/>
                  </a:lnTo>
                  <a:lnTo>
                    <a:pt x="1567434" y="413131"/>
                  </a:lnTo>
                  <a:lnTo>
                    <a:pt x="1577848" y="413131"/>
                  </a:lnTo>
                  <a:lnTo>
                    <a:pt x="1577848" y="63500"/>
                  </a:lnTo>
                  <a:close/>
                </a:path>
                <a:path w="4132580" h="413384">
                  <a:moveTo>
                    <a:pt x="1635887" y="158877"/>
                  </a:moveTo>
                  <a:lnTo>
                    <a:pt x="1625473" y="158877"/>
                  </a:lnTo>
                  <a:lnTo>
                    <a:pt x="1625473" y="413131"/>
                  </a:lnTo>
                  <a:lnTo>
                    <a:pt x="1635887" y="413131"/>
                  </a:lnTo>
                  <a:lnTo>
                    <a:pt x="1635887" y="158877"/>
                  </a:lnTo>
                  <a:close/>
                </a:path>
                <a:path w="4132580" h="413384">
                  <a:moveTo>
                    <a:pt x="1693926" y="127127"/>
                  </a:moveTo>
                  <a:lnTo>
                    <a:pt x="1683512" y="127127"/>
                  </a:lnTo>
                  <a:lnTo>
                    <a:pt x="1683512" y="413131"/>
                  </a:lnTo>
                  <a:lnTo>
                    <a:pt x="1693926" y="413131"/>
                  </a:lnTo>
                  <a:lnTo>
                    <a:pt x="1693926" y="127127"/>
                  </a:lnTo>
                  <a:close/>
                </a:path>
                <a:path w="4132580" h="413384">
                  <a:moveTo>
                    <a:pt x="1752092" y="63500"/>
                  </a:moveTo>
                  <a:lnTo>
                    <a:pt x="1741678" y="63500"/>
                  </a:lnTo>
                  <a:lnTo>
                    <a:pt x="1741678" y="413131"/>
                  </a:lnTo>
                  <a:lnTo>
                    <a:pt x="1752092" y="413131"/>
                  </a:lnTo>
                  <a:lnTo>
                    <a:pt x="1752092" y="63500"/>
                  </a:lnTo>
                  <a:close/>
                </a:path>
                <a:path w="4132580" h="413384">
                  <a:moveTo>
                    <a:pt x="1810131" y="254254"/>
                  </a:moveTo>
                  <a:lnTo>
                    <a:pt x="1799717" y="254254"/>
                  </a:lnTo>
                  <a:lnTo>
                    <a:pt x="1799717" y="413131"/>
                  </a:lnTo>
                  <a:lnTo>
                    <a:pt x="1810131" y="413131"/>
                  </a:lnTo>
                  <a:lnTo>
                    <a:pt x="1810131" y="254254"/>
                  </a:lnTo>
                  <a:close/>
                </a:path>
                <a:path w="4132580" h="413384">
                  <a:moveTo>
                    <a:pt x="1876044" y="286004"/>
                  </a:moveTo>
                  <a:lnTo>
                    <a:pt x="1862963" y="286004"/>
                  </a:lnTo>
                  <a:lnTo>
                    <a:pt x="1862963" y="413131"/>
                  </a:lnTo>
                  <a:lnTo>
                    <a:pt x="1876044" y="413131"/>
                  </a:lnTo>
                  <a:lnTo>
                    <a:pt x="1876044" y="286004"/>
                  </a:lnTo>
                  <a:close/>
                </a:path>
                <a:path w="4132580" h="413384">
                  <a:moveTo>
                    <a:pt x="1926209" y="317754"/>
                  </a:moveTo>
                  <a:lnTo>
                    <a:pt x="1915795" y="317754"/>
                  </a:lnTo>
                  <a:lnTo>
                    <a:pt x="1915795" y="413131"/>
                  </a:lnTo>
                  <a:lnTo>
                    <a:pt x="1926209" y="413131"/>
                  </a:lnTo>
                  <a:lnTo>
                    <a:pt x="1926209" y="317754"/>
                  </a:lnTo>
                  <a:close/>
                </a:path>
                <a:path w="4132580" h="413384">
                  <a:moveTo>
                    <a:pt x="1984248" y="254254"/>
                  </a:moveTo>
                  <a:lnTo>
                    <a:pt x="1973834" y="254254"/>
                  </a:lnTo>
                  <a:lnTo>
                    <a:pt x="1973834" y="413131"/>
                  </a:lnTo>
                  <a:lnTo>
                    <a:pt x="1984248" y="413131"/>
                  </a:lnTo>
                  <a:lnTo>
                    <a:pt x="1984248" y="254254"/>
                  </a:lnTo>
                  <a:close/>
                </a:path>
                <a:path w="4132580" h="413384">
                  <a:moveTo>
                    <a:pt x="2042287" y="286004"/>
                  </a:moveTo>
                  <a:lnTo>
                    <a:pt x="2031873" y="286004"/>
                  </a:lnTo>
                  <a:lnTo>
                    <a:pt x="2031873" y="413131"/>
                  </a:lnTo>
                  <a:lnTo>
                    <a:pt x="2042287" y="413131"/>
                  </a:lnTo>
                  <a:lnTo>
                    <a:pt x="2042287" y="286004"/>
                  </a:lnTo>
                  <a:close/>
                </a:path>
                <a:path w="4132580" h="413384">
                  <a:moveTo>
                    <a:pt x="2100326" y="222377"/>
                  </a:moveTo>
                  <a:lnTo>
                    <a:pt x="2089912" y="222377"/>
                  </a:lnTo>
                  <a:lnTo>
                    <a:pt x="2089912" y="413131"/>
                  </a:lnTo>
                  <a:lnTo>
                    <a:pt x="2100326" y="413131"/>
                  </a:lnTo>
                  <a:lnTo>
                    <a:pt x="2100326" y="222377"/>
                  </a:lnTo>
                  <a:close/>
                </a:path>
                <a:path w="4132580" h="413384">
                  <a:moveTo>
                    <a:pt x="2158365" y="317754"/>
                  </a:moveTo>
                  <a:lnTo>
                    <a:pt x="2147951" y="317754"/>
                  </a:lnTo>
                  <a:lnTo>
                    <a:pt x="2147951" y="413131"/>
                  </a:lnTo>
                  <a:lnTo>
                    <a:pt x="2158365" y="413131"/>
                  </a:lnTo>
                  <a:lnTo>
                    <a:pt x="2158365" y="317754"/>
                  </a:lnTo>
                  <a:close/>
                </a:path>
                <a:path w="4132580" h="413384">
                  <a:moveTo>
                    <a:pt x="2216404" y="286004"/>
                  </a:moveTo>
                  <a:lnTo>
                    <a:pt x="2205990" y="286004"/>
                  </a:lnTo>
                  <a:lnTo>
                    <a:pt x="2205990" y="413131"/>
                  </a:lnTo>
                  <a:lnTo>
                    <a:pt x="2216404" y="413131"/>
                  </a:lnTo>
                  <a:lnTo>
                    <a:pt x="2216404" y="286004"/>
                  </a:lnTo>
                  <a:close/>
                </a:path>
                <a:path w="4132580" h="413384">
                  <a:moveTo>
                    <a:pt x="2274443" y="349504"/>
                  </a:moveTo>
                  <a:lnTo>
                    <a:pt x="2264029" y="349504"/>
                  </a:lnTo>
                  <a:lnTo>
                    <a:pt x="2264029" y="413131"/>
                  </a:lnTo>
                  <a:lnTo>
                    <a:pt x="2274443" y="413131"/>
                  </a:lnTo>
                  <a:lnTo>
                    <a:pt x="2274443" y="349504"/>
                  </a:lnTo>
                  <a:close/>
                </a:path>
                <a:path w="4132580" h="413384">
                  <a:moveTo>
                    <a:pt x="2332609" y="286004"/>
                  </a:moveTo>
                  <a:lnTo>
                    <a:pt x="2322195" y="286004"/>
                  </a:lnTo>
                  <a:lnTo>
                    <a:pt x="2322195" y="413131"/>
                  </a:lnTo>
                  <a:lnTo>
                    <a:pt x="2332609" y="413131"/>
                  </a:lnTo>
                  <a:lnTo>
                    <a:pt x="2332609" y="286004"/>
                  </a:lnTo>
                  <a:close/>
                </a:path>
                <a:path w="4132580" h="413384">
                  <a:moveTo>
                    <a:pt x="2390648" y="286004"/>
                  </a:moveTo>
                  <a:lnTo>
                    <a:pt x="2380234" y="286004"/>
                  </a:lnTo>
                  <a:lnTo>
                    <a:pt x="2380234" y="413131"/>
                  </a:lnTo>
                  <a:lnTo>
                    <a:pt x="2390648" y="413131"/>
                  </a:lnTo>
                  <a:lnTo>
                    <a:pt x="2390648" y="286004"/>
                  </a:lnTo>
                  <a:close/>
                </a:path>
                <a:path w="4132580" h="413384">
                  <a:moveTo>
                    <a:pt x="2456548" y="286004"/>
                  </a:moveTo>
                  <a:lnTo>
                    <a:pt x="2443480" y="286004"/>
                  </a:lnTo>
                  <a:lnTo>
                    <a:pt x="2443480" y="413131"/>
                  </a:lnTo>
                  <a:lnTo>
                    <a:pt x="2456548" y="413131"/>
                  </a:lnTo>
                  <a:lnTo>
                    <a:pt x="2456548" y="286004"/>
                  </a:lnTo>
                  <a:close/>
                </a:path>
                <a:path w="4132580" h="413384">
                  <a:moveTo>
                    <a:pt x="2506726" y="190627"/>
                  </a:moveTo>
                  <a:lnTo>
                    <a:pt x="2496312" y="190627"/>
                  </a:lnTo>
                  <a:lnTo>
                    <a:pt x="2496312" y="413131"/>
                  </a:lnTo>
                  <a:lnTo>
                    <a:pt x="2506726" y="413131"/>
                  </a:lnTo>
                  <a:lnTo>
                    <a:pt x="2506726" y="190627"/>
                  </a:lnTo>
                  <a:close/>
                </a:path>
                <a:path w="4132580" h="413384">
                  <a:moveTo>
                    <a:pt x="2564765" y="190627"/>
                  </a:moveTo>
                  <a:lnTo>
                    <a:pt x="2554351" y="190627"/>
                  </a:lnTo>
                  <a:lnTo>
                    <a:pt x="2554351" y="413131"/>
                  </a:lnTo>
                  <a:lnTo>
                    <a:pt x="2564765" y="413131"/>
                  </a:lnTo>
                  <a:lnTo>
                    <a:pt x="2564765" y="190627"/>
                  </a:lnTo>
                  <a:close/>
                </a:path>
                <a:path w="4132580" h="413384">
                  <a:moveTo>
                    <a:pt x="2630678" y="286004"/>
                  </a:moveTo>
                  <a:lnTo>
                    <a:pt x="2617597" y="286004"/>
                  </a:lnTo>
                  <a:lnTo>
                    <a:pt x="2617597" y="413131"/>
                  </a:lnTo>
                  <a:lnTo>
                    <a:pt x="2630678" y="413131"/>
                  </a:lnTo>
                  <a:lnTo>
                    <a:pt x="2630678" y="286004"/>
                  </a:lnTo>
                  <a:close/>
                </a:path>
                <a:path w="4132580" h="413384">
                  <a:moveTo>
                    <a:pt x="2680843" y="190627"/>
                  </a:moveTo>
                  <a:lnTo>
                    <a:pt x="2670429" y="190627"/>
                  </a:lnTo>
                  <a:lnTo>
                    <a:pt x="2670429" y="413131"/>
                  </a:lnTo>
                  <a:lnTo>
                    <a:pt x="2680843" y="413131"/>
                  </a:lnTo>
                  <a:lnTo>
                    <a:pt x="2680843" y="190627"/>
                  </a:lnTo>
                  <a:close/>
                </a:path>
                <a:path w="4132580" h="413384">
                  <a:moveTo>
                    <a:pt x="2738882" y="190627"/>
                  </a:moveTo>
                  <a:lnTo>
                    <a:pt x="2728468" y="190627"/>
                  </a:lnTo>
                  <a:lnTo>
                    <a:pt x="2728468" y="413131"/>
                  </a:lnTo>
                  <a:lnTo>
                    <a:pt x="2738882" y="413131"/>
                  </a:lnTo>
                  <a:lnTo>
                    <a:pt x="2738882" y="190627"/>
                  </a:lnTo>
                  <a:close/>
                </a:path>
                <a:path w="4132580" h="413384">
                  <a:moveTo>
                    <a:pt x="2796921" y="349504"/>
                  </a:moveTo>
                  <a:lnTo>
                    <a:pt x="2786507" y="349504"/>
                  </a:lnTo>
                  <a:lnTo>
                    <a:pt x="2786507" y="413131"/>
                  </a:lnTo>
                  <a:lnTo>
                    <a:pt x="2796921" y="413131"/>
                  </a:lnTo>
                  <a:lnTo>
                    <a:pt x="2796921" y="349504"/>
                  </a:lnTo>
                  <a:close/>
                </a:path>
                <a:path w="4132580" h="413384">
                  <a:moveTo>
                    <a:pt x="2862948" y="381381"/>
                  </a:moveTo>
                  <a:lnTo>
                    <a:pt x="2849880" y="381381"/>
                  </a:lnTo>
                  <a:lnTo>
                    <a:pt x="2849880" y="413131"/>
                  </a:lnTo>
                  <a:lnTo>
                    <a:pt x="2862948" y="413131"/>
                  </a:lnTo>
                  <a:lnTo>
                    <a:pt x="2862948" y="381381"/>
                  </a:lnTo>
                  <a:close/>
                </a:path>
                <a:path w="4132580" h="413384">
                  <a:moveTo>
                    <a:pt x="2913126" y="254254"/>
                  </a:moveTo>
                  <a:lnTo>
                    <a:pt x="2902712" y="254254"/>
                  </a:lnTo>
                  <a:lnTo>
                    <a:pt x="2902712" y="413131"/>
                  </a:lnTo>
                  <a:lnTo>
                    <a:pt x="2913126" y="413131"/>
                  </a:lnTo>
                  <a:lnTo>
                    <a:pt x="2913126" y="254254"/>
                  </a:lnTo>
                  <a:close/>
                </a:path>
                <a:path w="4132580" h="413384">
                  <a:moveTo>
                    <a:pt x="2971165" y="127127"/>
                  </a:moveTo>
                  <a:lnTo>
                    <a:pt x="2960751" y="127127"/>
                  </a:lnTo>
                  <a:lnTo>
                    <a:pt x="2960751" y="413131"/>
                  </a:lnTo>
                  <a:lnTo>
                    <a:pt x="2971165" y="413131"/>
                  </a:lnTo>
                  <a:lnTo>
                    <a:pt x="2971165" y="127127"/>
                  </a:lnTo>
                  <a:close/>
                </a:path>
                <a:path w="4132580" h="413384">
                  <a:moveTo>
                    <a:pt x="3029204" y="381381"/>
                  </a:moveTo>
                  <a:lnTo>
                    <a:pt x="3018790" y="381381"/>
                  </a:lnTo>
                  <a:lnTo>
                    <a:pt x="3018790" y="413131"/>
                  </a:lnTo>
                  <a:lnTo>
                    <a:pt x="3029204" y="413131"/>
                  </a:lnTo>
                  <a:lnTo>
                    <a:pt x="3029204" y="381381"/>
                  </a:lnTo>
                  <a:close/>
                </a:path>
                <a:path w="4132580" h="413384">
                  <a:moveTo>
                    <a:pt x="3087243" y="222377"/>
                  </a:moveTo>
                  <a:lnTo>
                    <a:pt x="3076829" y="222377"/>
                  </a:lnTo>
                  <a:lnTo>
                    <a:pt x="3076829" y="413131"/>
                  </a:lnTo>
                  <a:lnTo>
                    <a:pt x="3087243" y="413131"/>
                  </a:lnTo>
                  <a:lnTo>
                    <a:pt x="3087243" y="222377"/>
                  </a:lnTo>
                  <a:close/>
                </a:path>
                <a:path w="4132580" h="413384">
                  <a:moveTo>
                    <a:pt x="3145282" y="349504"/>
                  </a:moveTo>
                  <a:lnTo>
                    <a:pt x="3134868" y="349504"/>
                  </a:lnTo>
                  <a:lnTo>
                    <a:pt x="3134868" y="413131"/>
                  </a:lnTo>
                  <a:lnTo>
                    <a:pt x="3145282" y="413131"/>
                  </a:lnTo>
                  <a:lnTo>
                    <a:pt x="3145282" y="349504"/>
                  </a:lnTo>
                  <a:close/>
                </a:path>
                <a:path w="4132580" h="413384">
                  <a:moveTo>
                    <a:pt x="3203321" y="190627"/>
                  </a:moveTo>
                  <a:lnTo>
                    <a:pt x="3192907" y="190627"/>
                  </a:lnTo>
                  <a:lnTo>
                    <a:pt x="3192907" y="413131"/>
                  </a:lnTo>
                  <a:lnTo>
                    <a:pt x="3203321" y="413131"/>
                  </a:lnTo>
                  <a:lnTo>
                    <a:pt x="3203321" y="190627"/>
                  </a:lnTo>
                  <a:close/>
                </a:path>
                <a:path w="4132580" h="413384">
                  <a:moveTo>
                    <a:pt x="3261360" y="349504"/>
                  </a:moveTo>
                  <a:lnTo>
                    <a:pt x="3250946" y="349504"/>
                  </a:lnTo>
                  <a:lnTo>
                    <a:pt x="3250946" y="413131"/>
                  </a:lnTo>
                  <a:lnTo>
                    <a:pt x="3261360" y="413131"/>
                  </a:lnTo>
                  <a:lnTo>
                    <a:pt x="3261360" y="349504"/>
                  </a:lnTo>
                  <a:close/>
                </a:path>
                <a:path w="4132580" h="413384">
                  <a:moveTo>
                    <a:pt x="3327400" y="190627"/>
                  </a:moveTo>
                  <a:lnTo>
                    <a:pt x="3314319" y="190627"/>
                  </a:lnTo>
                  <a:lnTo>
                    <a:pt x="3314319" y="413131"/>
                  </a:lnTo>
                  <a:lnTo>
                    <a:pt x="3327400" y="413131"/>
                  </a:lnTo>
                  <a:lnTo>
                    <a:pt x="3327400" y="190627"/>
                  </a:lnTo>
                  <a:close/>
                </a:path>
                <a:path w="4132580" h="413384">
                  <a:moveTo>
                    <a:pt x="3385439" y="254254"/>
                  </a:moveTo>
                  <a:lnTo>
                    <a:pt x="3372358" y="254254"/>
                  </a:lnTo>
                  <a:lnTo>
                    <a:pt x="3372358" y="413131"/>
                  </a:lnTo>
                  <a:lnTo>
                    <a:pt x="3385439" y="413131"/>
                  </a:lnTo>
                  <a:lnTo>
                    <a:pt x="3385439" y="254254"/>
                  </a:lnTo>
                  <a:close/>
                </a:path>
                <a:path w="4132580" h="413384">
                  <a:moveTo>
                    <a:pt x="3435604" y="190627"/>
                  </a:moveTo>
                  <a:lnTo>
                    <a:pt x="3425190" y="190627"/>
                  </a:lnTo>
                  <a:lnTo>
                    <a:pt x="3425190" y="413131"/>
                  </a:lnTo>
                  <a:lnTo>
                    <a:pt x="3435604" y="413131"/>
                  </a:lnTo>
                  <a:lnTo>
                    <a:pt x="3435604" y="190627"/>
                  </a:lnTo>
                  <a:close/>
                </a:path>
                <a:path w="4132580" h="413384">
                  <a:moveTo>
                    <a:pt x="3493643" y="286004"/>
                  </a:moveTo>
                  <a:lnTo>
                    <a:pt x="3483229" y="286004"/>
                  </a:lnTo>
                  <a:lnTo>
                    <a:pt x="3483229" y="413131"/>
                  </a:lnTo>
                  <a:lnTo>
                    <a:pt x="3493643" y="413131"/>
                  </a:lnTo>
                  <a:lnTo>
                    <a:pt x="3493643" y="286004"/>
                  </a:lnTo>
                  <a:close/>
                </a:path>
                <a:path w="4132580" h="413384">
                  <a:moveTo>
                    <a:pt x="3551682" y="349504"/>
                  </a:moveTo>
                  <a:lnTo>
                    <a:pt x="3541268" y="349504"/>
                  </a:lnTo>
                  <a:lnTo>
                    <a:pt x="3541268" y="413131"/>
                  </a:lnTo>
                  <a:lnTo>
                    <a:pt x="3551682" y="413131"/>
                  </a:lnTo>
                  <a:lnTo>
                    <a:pt x="3551682" y="349504"/>
                  </a:lnTo>
                  <a:close/>
                </a:path>
                <a:path w="4132580" h="413384">
                  <a:moveTo>
                    <a:pt x="3609721" y="317754"/>
                  </a:moveTo>
                  <a:lnTo>
                    <a:pt x="3599307" y="317754"/>
                  </a:lnTo>
                  <a:lnTo>
                    <a:pt x="3599307" y="413131"/>
                  </a:lnTo>
                  <a:lnTo>
                    <a:pt x="3609721" y="413131"/>
                  </a:lnTo>
                  <a:lnTo>
                    <a:pt x="3609721" y="317754"/>
                  </a:lnTo>
                  <a:close/>
                </a:path>
                <a:path w="4132580" h="413384">
                  <a:moveTo>
                    <a:pt x="3667760" y="222377"/>
                  </a:moveTo>
                  <a:lnTo>
                    <a:pt x="3657346" y="222377"/>
                  </a:lnTo>
                  <a:lnTo>
                    <a:pt x="3657346" y="413131"/>
                  </a:lnTo>
                  <a:lnTo>
                    <a:pt x="3667760" y="413131"/>
                  </a:lnTo>
                  <a:lnTo>
                    <a:pt x="3667760" y="222377"/>
                  </a:lnTo>
                  <a:close/>
                </a:path>
                <a:path w="4132580" h="413384">
                  <a:moveTo>
                    <a:pt x="3725799" y="254254"/>
                  </a:moveTo>
                  <a:lnTo>
                    <a:pt x="3715385" y="254254"/>
                  </a:lnTo>
                  <a:lnTo>
                    <a:pt x="3715385" y="413131"/>
                  </a:lnTo>
                  <a:lnTo>
                    <a:pt x="3725799" y="413131"/>
                  </a:lnTo>
                  <a:lnTo>
                    <a:pt x="3725799" y="254254"/>
                  </a:lnTo>
                  <a:close/>
                </a:path>
                <a:path w="4132580" h="413384">
                  <a:moveTo>
                    <a:pt x="3783825" y="317754"/>
                  </a:moveTo>
                  <a:lnTo>
                    <a:pt x="3773424" y="317754"/>
                  </a:lnTo>
                  <a:lnTo>
                    <a:pt x="3773424" y="413131"/>
                  </a:lnTo>
                  <a:lnTo>
                    <a:pt x="3783825" y="413131"/>
                  </a:lnTo>
                  <a:lnTo>
                    <a:pt x="3783825" y="317754"/>
                  </a:lnTo>
                  <a:close/>
                </a:path>
                <a:path w="4132580" h="413384">
                  <a:moveTo>
                    <a:pt x="3849878" y="317754"/>
                  </a:moveTo>
                  <a:lnTo>
                    <a:pt x="3836797" y="317754"/>
                  </a:lnTo>
                  <a:lnTo>
                    <a:pt x="3836797" y="413131"/>
                  </a:lnTo>
                  <a:lnTo>
                    <a:pt x="3849878" y="413131"/>
                  </a:lnTo>
                  <a:lnTo>
                    <a:pt x="3849878" y="317754"/>
                  </a:lnTo>
                  <a:close/>
                </a:path>
                <a:path w="4132580" h="413384">
                  <a:moveTo>
                    <a:pt x="3899916" y="349504"/>
                  </a:moveTo>
                  <a:lnTo>
                    <a:pt x="3889502" y="349504"/>
                  </a:lnTo>
                  <a:lnTo>
                    <a:pt x="3889502" y="413131"/>
                  </a:lnTo>
                  <a:lnTo>
                    <a:pt x="3899916" y="413131"/>
                  </a:lnTo>
                  <a:lnTo>
                    <a:pt x="3899916" y="349504"/>
                  </a:lnTo>
                  <a:close/>
                </a:path>
                <a:path w="4132580" h="413384">
                  <a:moveTo>
                    <a:pt x="3965956" y="317754"/>
                  </a:moveTo>
                  <a:lnTo>
                    <a:pt x="3952875" y="317754"/>
                  </a:lnTo>
                  <a:lnTo>
                    <a:pt x="3952875" y="413131"/>
                  </a:lnTo>
                  <a:lnTo>
                    <a:pt x="3965956" y="413131"/>
                  </a:lnTo>
                  <a:lnTo>
                    <a:pt x="3965956" y="317754"/>
                  </a:lnTo>
                  <a:close/>
                </a:path>
                <a:path w="4132580" h="413384">
                  <a:moveTo>
                    <a:pt x="4082034" y="317754"/>
                  </a:moveTo>
                  <a:lnTo>
                    <a:pt x="4068953" y="317754"/>
                  </a:lnTo>
                  <a:lnTo>
                    <a:pt x="4068953" y="413131"/>
                  </a:lnTo>
                  <a:lnTo>
                    <a:pt x="4082034" y="413131"/>
                  </a:lnTo>
                  <a:lnTo>
                    <a:pt x="4082034" y="317754"/>
                  </a:lnTo>
                  <a:close/>
                </a:path>
                <a:path w="4132580" h="413384">
                  <a:moveTo>
                    <a:pt x="4132199" y="127127"/>
                  </a:moveTo>
                  <a:lnTo>
                    <a:pt x="4121785" y="127127"/>
                  </a:lnTo>
                  <a:lnTo>
                    <a:pt x="4121785" y="413131"/>
                  </a:lnTo>
                  <a:lnTo>
                    <a:pt x="4132199" y="413131"/>
                  </a:lnTo>
                  <a:lnTo>
                    <a:pt x="4132199" y="127127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8" name="object 118" descr=""/>
            <p:cNvSpPr/>
            <p:nvPr/>
          </p:nvSpPr>
          <p:spPr>
            <a:xfrm>
              <a:off x="13394690" y="8376412"/>
              <a:ext cx="1171575" cy="286385"/>
            </a:xfrm>
            <a:custGeom>
              <a:avLst/>
              <a:gdLst/>
              <a:ahLst/>
              <a:cxnLst/>
              <a:rect l="l" t="t" r="r" b="b"/>
              <a:pathLst>
                <a:path w="1171575" h="286384">
                  <a:moveTo>
                    <a:pt x="10414" y="0"/>
                  </a:moveTo>
                  <a:lnTo>
                    <a:pt x="0" y="0"/>
                  </a:lnTo>
                  <a:lnTo>
                    <a:pt x="0" y="286004"/>
                  </a:lnTo>
                  <a:lnTo>
                    <a:pt x="10414" y="286004"/>
                  </a:lnTo>
                  <a:lnTo>
                    <a:pt x="10414" y="0"/>
                  </a:lnTo>
                  <a:close/>
                </a:path>
                <a:path w="1171575" h="286384">
                  <a:moveTo>
                    <a:pt x="68453" y="158877"/>
                  </a:moveTo>
                  <a:lnTo>
                    <a:pt x="58039" y="158877"/>
                  </a:lnTo>
                  <a:lnTo>
                    <a:pt x="58039" y="286004"/>
                  </a:lnTo>
                  <a:lnTo>
                    <a:pt x="68453" y="286004"/>
                  </a:lnTo>
                  <a:lnTo>
                    <a:pt x="68453" y="158877"/>
                  </a:lnTo>
                  <a:close/>
                </a:path>
                <a:path w="1171575" h="286384">
                  <a:moveTo>
                    <a:pt x="134366" y="127127"/>
                  </a:moveTo>
                  <a:lnTo>
                    <a:pt x="121285" y="127127"/>
                  </a:lnTo>
                  <a:lnTo>
                    <a:pt x="121285" y="286004"/>
                  </a:lnTo>
                  <a:lnTo>
                    <a:pt x="134366" y="286004"/>
                  </a:lnTo>
                  <a:lnTo>
                    <a:pt x="134366" y="127127"/>
                  </a:lnTo>
                  <a:close/>
                </a:path>
                <a:path w="1171575" h="286384">
                  <a:moveTo>
                    <a:pt x="192405" y="158877"/>
                  </a:moveTo>
                  <a:lnTo>
                    <a:pt x="179324" y="158877"/>
                  </a:lnTo>
                  <a:lnTo>
                    <a:pt x="179324" y="286004"/>
                  </a:lnTo>
                  <a:lnTo>
                    <a:pt x="192405" y="286004"/>
                  </a:lnTo>
                  <a:lnTo>
                    <a:pt x="192405" y="158877"/>
                  </a:lnTo>
                  <a:close/>
                </a:path>
                <a:path w="1171575" h="286384">
                  <a:moveTo>
                    <a:pt x="250444" y="222377"/>
                  </a:moveTo>
                  <a:lnTo>
                    <a:pt x="237363" y="222377"/>
                  </a:lnTo>
                  <a:lnTo>
                    <a:pt x="237363" y="286004"/>
                  </a:lnTo>
                  <a:lnTo>
                    <a:pt x="250444" y="286004"/>
                  </a:lnTo>
                  <a:lnTo>
                    <a:pt x="250444" y="222377"/>
                  </a:lnTo>
                  <a:close/>
                </a:path>
                <a:path w="1171575" h="286384">
                  <a:moveTo>
                    <a:pt x="366649" y="127127"/>
                  </a:moveTo>
                  <a:lnTo>
                    <a:pt x="353568" y="127127"/>
                  </a:lnTo>
                  <a:lnTo>
                    <a:pt x="353568" y="286004"/>
                  </a:lnTo>
                  <a:lnTo>
                    <a:pt x="366649" y="286004"/>
                  </a:lnTo>
                  <a:lnTo>
                    <a:pt x="366649" y="127127"/>
                  </a:lnTo>
                  <a:close/>
                </a:path>
                <a:path w="1171575" h="286384">
                  <a:moveTo>
                    <a:pt x="424675" y="190627"/>
                  </a:moveTo>
                  <a:lnTo>
                    <a:pt x="411607" y="190627"/>
                  </a:lnTo>
                  <a:lnTo>
                    <a:pt x="411607" y="286004"/>
                  </a:lnTo>
                  <a:lnTo>
                    <a:pt x="424675" y="286004"/>
                  </a:lnTo>
                  <a:lnTo>
                    <a:pt x="424675" y="190627"/>
                  </a:lnTo>
                  <a:close/>
                </a:path>
                <a:path w="1171575" h="286384">
                  <a:moveTo>
                    <a:pt x="474853" y="190627"/>
                  </a:moveTo>
                  <a:lnTo>
                    <a:pt x="464439" y="190627"/>
                  </a:lnTo>
                  <a:lnTo>
                    <a:pt x="464439" y="286004"/>
                  </a:lnTo>
                  <a:lnTo>
                    <a:pt x="474853" y="286004"/>
                  </a:lnTo>
                  <a:lnTo>
                    <a:pt x="474853" y="190627"/>
                  </a:lnTo>
                  <a:close/>
                </a:path>
                <a:path w="1171575" h="286384">
                  <a:moveTo>
                    <a:pt x="532879" y="95250"/>
                  </a:moveTo>
                  <a:lnTo>
                    <a:pt x="522478" y="95250"/>
                  </a:lnTo>
                  <a:lnTo>
                    <a:pt x="522478" y="286004"/>
                  </a:lnTo>
                  <a:lnTo>
                    <a:pt x="532879" y="286004"/>
                  </a:lnTo>
                  <a:lnTo>
                    <a:pt x="532879" y="95250"/>
                  </a:lnTo>
                  <a:close/>
                </a:path>
                <a:path w="1171575" h="286384">
                  <a:moveTo>
                    <a:pt x="590931" y="222377"/>
                  </a:moveTo>
                  <a:lnTo>
                    <a:pt x="580517" y="222377"/>
                  </a:lnTo>
                  <a:lnTo>
                    <a:pt x="580517" y="286004"/>
                  </a:lnTo>
                  <a:lnTo>
                    <a:pt x="590931" y="286004"/>
                  </a:lnTo>
                  <a:lnTo>
                    <a:pt x="590931" y="222377"/>
                  </a:lnTo>
                  <a:close/>
                </a:path>
                <a:path w="1171575" h="286384">
                  <a:moveTo>
                    <a:pt x="648970" y="222377"/>
                  </a:moveTo>
                  <a:lnTo>
                    <a:pt x="638556" y="222377"/>
                  </a:lnTo>
                  <a:lnTo>
                    <a:pt x="638556" y="286004"/>
                  </a:lnTo>
                  <a:lnTo>
                    <a:pt x="648970" y="286004"/>
                  </a:lnTo>
                  <a:lnTo>
                    <a:pt x="648970" y="222377"/>
                  </a:lnTo>
                  <a:close/>
                </a:path>
                <a:path w="1171575" h="286384">
                  <a:moveTo>
                    <a:pt x="707009" y="127127"/>
                  </a:moveTo>
                  <a:lnTo>
                    <a:pt x="696595" y="127127"/>
                  </a:lnTo>
                  <a:lnTo>
                    <a:pt x="696595" y="286004"/>
                  </a:lnTo>
                  <a:lnTo>
                    <a:pt x="707009" y="286004"/>
                  </a:lnTo>
                  <a:lnTo>
                    <a:pt x="707009" y="127127"/>
                  </a:lnTo>
                  <a:close/>
                </a:path>
                <a:path w="1171575" h="286384">
                  <a:moveTo>
                    <a:pt x="765035" y="254254"/>
                  </a:moveTo>
                  <a:lnTo>
                    <a:pt x="754634" y="254254"/>
                  </a:lnTo>
                  <a:lnTo>
                    <a:pt x="754634" y="286004"/>
                  </a:lnTo>
                  <a:lnTo>
                    <a:pt x="765035" y="286004"/>
                  </a:lnTo>
                  <a:lnTo>
                    <a:pt x="765035" y="254254"/>
                  </a:lnTo>
                  <a:close/>
                </a:path>
                <a:path w="1171575" h="286384">
                  <a:moveTo>
                    <a:pt x="823087" y="127127"/>
                  </a:moveTo>
                  <a:lnTo>
                    <a:pt x="812673" y="127127"/>
                  </a:lnTo>
                  <a:lnTo>
                    <a:pt x="812673" y="286004"/>
                  </a:lnTo>
                  <a:lnTo>
                    <a:pt x="823087" y="286004"/>
                  </a:lnTo>
                  <a:lnTo>
                    <a:pt x="823087" y="127127"/>
                  </a:lnTo>
                  <a:close/>
                </a:path>
                <a:path w="1171575" h="286384">
                  <a:moveTo>
                    <a:pt x="881253" y="95250"/>
                  </a:moveTo>
                  <a:lnTo>
                    <a:pt x="870839" y="95250"/>
                  </a:lnTo>
                  <a:lnTo>
                    <a:pt x="870839" y="286004"/>
                  </a:lnTo>
                  <a:lnTo>
                    <a:pt x="881253" y="286004"/>
                  </a:lnTo>
                  <a:lnTo>
                    <a:pt x="881253" y="95250"/>
                  </a:lnTo>
                  <a:close/>
                </a:path>
                <a:path w="1171575" h="286384">
                  <a:moveTo>
                    <a:pt x="947166" y="222377"/>
                  </a:moveTo>
                  <a:lnTo>
                    <a:pt x="934085" y="222377"/>
                  </a:lnTo>
                  <a:lnTo>
                    <a:pt x="934085" y="286004"/>
                  </a:lnTo>
                  <a:lnTo>
                    <a:pt x="947166" y="286004"/>
                  </a:lnTo>
                  <a:lnTo>
                    <a:pt x="947166" y="222377"/>
                  </a:lnTo>
                  <a:close/>
                </a:path>
                <a:path w="1171575" h="286384">
                  <a:moveTo>
                    <a:pt x="1063244" y="254254"/>
                  </a:moveTo>
                  <a:lnTo>
                    <a:pt x="1050163" y="254254"/>
                  </a:lnTo>
                  <a:lnTo>
                    <a:pt x="1050163" y="286004"/>
                  </a:lnTo>
                  <a:lnTo>
                    <a:pt x="1063244" y="286004"/>
                  </a:lnTo>
                  <a:lnTo>
                    <a:pt x="1063244" y="254254"/>
                  </a:lnTo>
                  <a:close/>
                </a:path>
                <a:path w="1171575" h="286384">
                  <a:moveTo>
                    <a:pt x="1113409" y="254254"/>
                  </a:moveTo>
                  <a:lnTo>
                    <a:pt x="1102995" y="254254"/>
                  </a:lnTo>
                  <a:lnTo>
                    <a:pt x="1102995" y="286004"/>
                  </a:lnTo>
                  <a:lnTo>
                    <a:pt x="1113409" y="286004"/>
                  </a:lnTo>
                  <a:lnTo>
                    <a:pt x="1113409" y="254254"/>
                  </a:lnTo>
                  <a:close/>
                </a:path>
                <a:path w="1171575" h="286384">
                  <a:moveTo>
                    <a:pt x="1171435" y="254254"/>
                  </a:moveTo>
                  <a:lnTo>
                    <a:pt x="1161034" y="254254"/>
                  </a:lnTo>
                  <a:lnTo>
                    <a:pt x="1161034" y="286004"/>
                  </a:lnTo>
                  <a:lnTo>
                    <a:pt x="1171435" y="286004"/>
                  </a:lnTo>
                  <a:lnTo>
                    <a:pt x="1171435" y="254254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9" name="object 119" descr=""/>
            <p:cNvSpPr/>
            <p:nvPr/>
          </p:nvSpPr>
          <p:spPr>
            <a:xfrm>
              <a:off x="14627733" y="8662416"/>
              <a:ext cx="17780" cy="0"/>
            </a:xfrm>
            <a:custGeom>
              <a:avLst/>
              <a:gdLst/>
              <a:ahLst/>
              <a:cxnLst/>
              <a:rect l="l" t="t" r="r" b="b"/>
              <a:pathLst>
                <a:path w="17780" h="0">
                  <a:moveTo>
                    <a:pt x="0" y="0"/>
                  </a:moveTo>
                  <a:lnTo>
                    <a:pt x="17398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DFD625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0" name="object 120" descr=""/>
            <p:cNvSpPr/>
            <p:nvPr/>
          </p:nvSpPr>
          <p:spPr>
            <a:xfrm>
              <a:off x="14677009" y="8535289"/>
              <a:ext cx="955040" cy="127635"/>
            </a:xfrm>
            <a:custGeom>
              <a:avLst/>
              <a:gdLst/>
              <a:ahLst/>
              <a:cxnLst/>
              <a:rect l="l" t="t" r="r" b="b"/>
              <a:pathLst>
                <a:path w="955040" h="127634">
                  <a:moveTo>
                    <a:pt x="13081" y="95377"/>
                  </a:moveTo>
                  <a:lnTo>
                    <a:pt x="0" y="95377"/>
                  </a:lnTo>
                  <a:lnTo>
                    <a:pt x="0" y="127127"/>
                  </a:lnTo>
                  <a:lnTo>
                    <a:pt x="13081" y="127127"/>
                  </a:lnTo>
                  <a:lnTo>
                    <a:pt x="13081" y="95377"/>
                  </a:lnTo>
                  <a:close/>
                </a:path>
                <a:path w="955040" h="127634">
                  <a:moveTo>
                    <a:pt x="63233" y="63500"/>
                  </a:moveTo>
                  <a:lnTo>
                    <a:pt x="52832" y="63500"/>
                  </a:lnTo>
                  <a:lnTo>
                    <a:pt x="52832" y="127127"/>
                  </a:lnTo>
                  <a:lnTo>
                    <a:pt x="63233" y="127127"/>
                  </a:lnTo>
                  <a:lnTo>
                    <a:pt x="63233" y="63500"/>
                  </a:lnTo>
                  <a:close/>
                </a:path>
                <a:path w="955040" h="127634">
                  <a:moveTo>
                    <a:pt x="129286" y="31750"/>
                  </a:moveTo>
                  <a:lnTo>
                    <a:pt x="116205" y="31750"/>
                  </a:lnTo>
                  <a:lnTo>
                    <a:pt x="116205" y="127127"/>
                  </a:lnTo>
                  <a:lnTo>
                    <a:pt x="129286" y="127127"/>
                  </a:lnTo>
                  <a:lnTo>
                    <a:pt x="129286" y="31750"/>
                  </a:lnTo>
                  <a:close/>
                </a:path>
                <a:path w="955040" h="127634">
                  <a:moveTo>
                    <a:pt x="179451" y="95377"/>
                  </a:moveTo>
                  <a:lnTo>
                    <a:pt x="169037" y="95377"/>
                  </a:lnTo>
                  <a:lnTo>
                    <a:pt x="169037" y="127127"/>
                  </a:lnTo>
                  <a:lnTo>
                    <a:pt x="179451" y="127127"/>
                  </a:lnTo>
                  <a:lnTo>
                    <a:pt x="179451" y="95377"/>
                  </a:lnTo>
                  <a:close/>
                </a:path>
                <a:path w="955040" h="127634">
                  <a:moveTo>
                    <a:pt x="258318" y="31750"/>
                  </a:moveTo>
                  <a:lnTo>
                    <a:pt x="240919" y="31750"/>
                  </a:lnTo>
                  <a:lnTo>
                    <a:pt x="240919" y="127127"/>
                  </a:lnTo>
                  <a:lnTo>
                    <a:pt x="258318" y="127127"/>
                  </a:lnTo>
                  <a:lnTo>
                    <a:pt x="258318" y="31750"/>
                  </a:lnTo>
                  <a:close/>
                </a:path>
                <a:path w="955040" h="127634">
                  <a:moveTo>
                    <a:pt x="303403" y="63500"/>
                  </a:moveTo>
                  <a:lnTo>
                    <a:pt x="290322" y="63500"/>
                  </a:lnTo>
                  <a:lnTo>
                    <a:pt x="290322" y="127127"/>
                  </a:lnTo>
                  <a:lnTo>
                    <a:pt x="303403" y="127127"/>
                  </a:lnTo>
                  <a:lnTo>
                    <a:pt x="303403" y="63500"/>
                  </a:lnTo>
                  <a:close/>
                </a:path>
                <a:path w="955040" h="127634">
                  <a:moveTo>
                    <a:pt x="361429" y="95377"/>
                  </a:moveTo>
                  <a:lnTo>
                    <a:pt x="348361" y="95377"/>
                  </a:lnTo>
                  <a:lnTo>
                    <a:pt x="348361" y="127127"/>
                  </a:lnTo>
                  <a:lnTo>
                    <a:pt x="361429" y="127127"/>
                  </a:lnTo>
                  <a:lnTo>
                    <a:pt x="361429" y="95377"/>
                  </a:lnTo>
                  <a:close/>
                </a:path>
                <a:path w="955040" h="127634">
                  <a:moveTo>
                    <a:pt x="477520" y="63500"/>
                  </a:moveTo>
                  <a:lnTo>
                    <a:pt x="464439" y="63500"/>
                  </a:lnTo>
                  <a:lnTo>
                    <a:pt x="464439" y="127127"/>
                  </a:lnTo>
                  <a:lnTo>
                    <a:pt x="477520" y="127127"/>
                  </a:lnTo>
                  <a:lnTo>
                    <a:pt x="477520" y="63500"/>
                  </a:lnTo>
                  <a:close/>
                </a:path>
                <a:path w="955040" h="127634">
                  <a:moveTo>
                    <a:pt x="535559" y="63500"/>
                  </a:moveTo>
                  <a:lnTo>
                    <a:pt x="522478" y="63500"/>
                  </a:lnTo>
                  <a:lnTo>
                    <a:pt x="522478" y="127127"/>
                  </a:lnTo>
                  <a:lnTo>
                    <a:pt x="535559" y="127127"/>
                  </a:lnTo>
                  <a:lnTo>
                    <a:pt x="535559" y="63500"/>
                  </a:lnTo>
                  <a:close/>
                </a:path>
                <a:path w="955040" h="127634">
                  <a:moveTo>
                    <a:pt x="651764" y="63500"/>
                  </a:moveTo>
                  <a:lnTo>
                    <a:pt x="638683" y="63500"/>
                  </a:lnTo>
                  <a:lnTo>
                    <a:pt x="638683" y="127127"/>
                  </a:lnTo>
                  <a:lnTo>
                    <a:pt x="651764" y="127127"/>
                  </a:lnTo>
                  <a:lnTo>
                    <a:pt x="651764" y="63500"/>
                  </a:lnTo>
                  <a:close/>
                </a:path>
                <a:path w="955040" h="127634">
                  <a:moveTo>
                    <a:pt x="709803" y="31750"/>
                  </a:moveTo>
                  <a:lnTo>
                    <a:pt x="696722" y="31750"/>
                  </a:lnTo>
                  <a:lnTo>
                    <a:pt x="696722" y="127127"/>
                  </a:lnTo>
                  <a:lnTo>
                    <a:pt x="709803" y="127127"/>
                  </a:lnTo>
                  <a:lnTo>
                    <a:pt x="709803" y="31750"/>
                  </a:lnTo>
                  <a:close/>
                </a:path>
                <a:path w="955040" h="127634">
                  <a:moveTo>
                    <a:pt x="780783" y="0"/>
                  </a:moveTo>
                  <a:lnTo>
                    <a:pt x="763397" y="0"/>
                  </a:lnTo>
                  <a:lnTo>
                    <a:pt x="763397" y="127127"/>
                  </a:lnTo>
                  <a:lnTo>
                    <a:pt x="780783" y="127127"/>
                  </a:lnTo>
                  <a:lnTo>
                    <a:pt x="780783" y="0"/>
                  </a:lnTo>
                  <a:close/>
                </a:path>
                <a:path w="955040" h="127634">
                  <a:moveTo>
                    <a:pt x="955040" y="95377"/>
                  </a:moveTo>
                  <a:lnTo>
                    <a:pt x="928878" y="95377"/>
                  </a:lnTo>
                  <a:lnTo>
                    <a:pt x="928878" y="127127"/>
                  </a:lnTo>
                  <a:lnTo>
                    <a:pt x="955040" y="127127"/>
                  </a:lnTo>
                  <a:lnTo>
                    <a:pt x="955040" y="95377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1" name="object 121" descr=""/>
            <p:cNvSpPr/>
            <p:nvPr/>
          </p:nvSpPr>
          <p:spPr>
            <a:xfrm>
              <a:off x="1150873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13081" y="0"/>
                  </a:moveTo>
                  <a:lnTo>
                    <a:pt x="0" y="0"/>
                  </a:lnTo>
                  <a:lnTo>
                    <a:pt x="13081" y="0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2" name="object 122" descr=""/>
            <p:cNvSpPr/>
            <p:nvPr/>
          </p:nvSpPr>
          <p:spPr>
            <a:xfrm>
              <a:off x="1150873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1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3" name="object 123" descr=""/>
            <p:cNvSpPr/>
            <p:nvPr/>
          </p:nvSpPr>
          <p:spPr>
            <a:xfrm>
              <a:off x="1208913" y="8249285"/>
              <a:ext cx="4079240" cy="413384"/>
            </a:xfrm>
            <a:custGeom>
              <a:avLst/>
              <a:gdLst/>
              <a:ahLst/>
              <a:cxnLst/>
              <a:rect l="l" t="t" r="r" b="b"/>
              <a:pathLst>
                <a:path w="4079240" h="413384">
                  <a:moveTo>
                    <a:pt x="13081" y="381381"/>
                  </a:moveTo>
                  <a:lnTo>
                    <a:pt x="0" y="381381"/>
                  </a:lnTo>
                  <a:lnTo>
                    <a:pt x="0" y="413131"/>
                  </a:lnTo>
                  <a:lnTo>
                    <a:pt x="13081" y="413131"/>
                  </a:lnTo>
                  <a:lnTo>
                    <a:pt x="13081" y="381381"/>
                  </a:lnTo>
                  <a:close/>
                </a:path>
                <a:path w="4079240" h="413384">
                  <a:moveTo>
                    <a:pt x="71120" y="381381"/>
                  </a:moveTo>
                  <a:lnTo>
                    <a:pt x="58039" y="381381"/>
                  </a:lnTo>
                  <a:lnTo>
                    <a:pt x="58039" y="413131"/>
                  </a:lnTo>
                  <a:lnTo>
                    <a:pt x="71120" y="413131"/>
                  </a:lnTo>
                  <a:lnTo>
                    <a:pt x="71120" y="381381"/>
                  </a:lnTo>
                  <a:close/>
                </a:path>
                <a:path w="4079240" h="413384">
                  <a:moveTo>
                    <a:pt x="129159" y="349504"/>
                  </a:moveTo>
                  <a:lnTo>
                    <a:pt x="116078" y="349504"/>
                  </a:lnTo>
                  <a:lnTo>
                    <a:pt x="116078" y="413131"/>
                  </a:lnTo>
                  <a:lnTo>
                    <a:pt x="129159" y="413131"/>
                  </a:lnTo>
                  <a:lnTo>
                    <a:pt x="129159" y="349504"/>
                  </a:lnTo>
                  <a:close/>
                </a:path>
                <a:path w="4079240" h="413384">
                  <a:moveTo>
                    <a:pt x="187198" y="317754"/>
                  </a:moveTo>
                  <a:lnTo>
                    <a:pt x="174117" y="317754"/>
                  </a:lnTo>
                  <a:lnTo>
                    <a:pt x="174117" y="413131"/>
                  </a:lnTo>
                  <a:lnTo>
                    <a:pt x="187198" y="413131"/>
                  </a:lnTo>
                  <a:lnTo>
                    <a:pt x="187198" y="317754"/>
                  </a:lnTo>
                  <a:close/>
                </a:path>
                <a:path w="4079240" h="413384">
                  <a:moveTo>
                    <a:pt x="245237" y="349504"/>
                  </a:moveTo>
                  <a:lnTo>
                    <a:pt x="232156" y="349504"/>
                  </a:lnTo>
                  <a:lnTo>
                    <a:pt x="232156" y="413131"/>
                  </a:lnTo>
                  <a:lnTo>
                    <a:pt x="245237" y="413131"/>
                  </a:lnTo>
                  <a:lnTo>
                    <a:pt x="245237" y="349504"/>
                  </a:lnTo>
                  <a:close/>
                </a:path>
                <a:path w="4079240" h="413384">
                  <a:moveTo>
                    <a:pt x="303276" y="381381"/>
                  </a:moveTo>
                  <a:lnTo>
                    <a:pt x="290195" y="381381"/>
                  </a:lnTo>
                  <a:lnTo>
                    <a:pt x="290195" y="413131"/>
                  </a:lnTo>
                  <a:lnTo>
                    <a:pt x="303276" y="413131"/>
                  </a:lnTo>
                  <a:lnTo>
                    <a:pt x="303276" y="381381"/>
                  </a:lnTo>
                  <a:close/>
                </a:path>
                <a:path w="4079240" h="413384">
                  <a:moveTo>
                    <a:pt x="363842" y="349504"/>
                  </a:moveTo>
                  <a:lnTo>
                    <a:pt x="353441" y="349504"/>
                  </a:lnTo>
                  <a:lnTo>
                    <a:pt x="353441" y="413131"/>
                  </a:lnTo>
                  <a:lnTo>
                    <a:pt x="363842" y="413131"/>
                  </a:lnTo>
                  <a:lnTo>
                    <a:pt x="363842" y="349504"/>
                  </a:lnTo>
                  <a:close/>
                </a:path>
                <a:path w="4079240" h="413384">
                  <a:moveTo>
                    <a:pt x="419354" y="381381"/>
                  </a:moveTo>
                  <a:lnTo>
                    <a:pt x="406273" y="381381"/>
                  </a:lnTo>
                  <a:lnTo>
                    <a:pt x="406273" y="413131"/>
                  </a:lnTo>
                  <a:lnTo>
                    <a:pt x="419354" y="413131"/>
                  </a:lnTo>
                  <a:lnTo>
                    <a:pt x="419354" y="381381"/>
                  </a:lnTo>
                  <a:close/>
                </a:path>
                <a:path w="4079240" h="413384">
                  <a:moveTo>
                    <a:pt x="480047" y="222377"/>
                  </a:moveTo>
                  <a:lnTo>
                    <a:pt x="469646" y="222377"/>
                  </a:lnTo>
                  <a:lnTo>
                    <a:pt x="469646" y="413131"/>
                  </a:lnTo>
                  <a:lnTo>
                    <a:pt x="480047" y="413131"/>
                  </a:lnTo>
                  <a:lnTo>
                    <a:pt x="480047" y="222377"/>
                  </a:lnTo>
                  <a:close/>
                </a:path>
                <a:path w="4079240" h="413384">
                  <a:moveTo>
                    <a:pt x="538099" y="381381"/>
                  </a:moveTo>
                  <a:lnTo>
                    <a:pt x="527685" y="381381"/>
                  </a:lnTo>
                  <a:lnTo>
                    <a:pt x="527685" y="413131"/>
                  </a:lnTo>
                  <a:lnTo>
                    <a:pt x="538099" y="413131"/>
                  </a:lnTo>
                  <a:lnTo>
                    <a:pt x="538099" y="381381"/>
                  </a:lnTo>
                  <a:close/>
                </a:path>
                <a:path w="4079240" h="413384">
                  <a:moveTo>
                    <a:pt x="596138" y="349504"/>
                  </a:moveTo>
                  <a:lnTo>
                    <a:pt x="585724" y="349504"/>
                  </a:lnTo>
                  <a:lnTo>
                    <a:pt x="585724" y="413131"/>
                  </a:lnTo>
                  <a:lnTo>
                    <a:pt x="596138" y="413131"/>
                  </a:lnTo>
                  <a:lnTo>
                    <a:pt x="596138" y="349504"/>
                  </a:lnTo>
                  <a:close/>
                </a:path>
                <a:path w="4079240" h="413384">
                  <a:moveTo>
                    <a:pt x="654177" y="254254"/>
                  </a:moveTo>
                  <a:lnTo>
                    <a:pt x="643763" y="254254"/>
                  </a:lnTo>
                  <a:lnTo>
                    <a:pt x="643763" y="413131"/>
                  </a:lnTo>
                  <a:lnTo>
                    <a:pt x="654177" y="413131"/>
                  </a:lnTo>
                  <a:lnTo>
                    <a:pt x="654177" y="254254"/>
                  </a:lnTo>
                  <a:close/>
                </a:path>
                <a:path w="4079240" h="413384">
                  <a:moveTo>
                    <a:pt x="712203" y="158877"/>
                  </a:moveTo>
                  <a:lnTo>
                    <a:pt x="701802" y="158877"/>
                  </a:lnTo>
                  <a:lnTo>
                    <a:pt x="701802" y="413131"/>
                  </a:lnTo>
                  <a:lnTo>
                    <a:pt x="712203" y="413131"/>
                  </a:lnTo>
                  <a:lnTo>
                    <a:pt x="712203" y="158877"/>
                  </a:lnTo>
                  <a:close/>
                </a:path>
                <a:path w="4079240" h="413384">
                  <a:moveTo>
                    <a:pt x="770255" y="190627"/>
                  </a:moveTo>
                  <a:lnTo>
                    <a:pt x="759841" y="190627"/>
                  </a:lnTo>
                  <a:lnTo>
                    <a:pt x="759841" y="413131"/>
                  </a:lnTo>
                  <a:lnTo>
                    <a:pt x="770255" y="413131"/>
                  </a:lnTo>
                  <a:lnTo>
                    <a:pt x="770255" y="190627"/>
                  </a:lnTo>
                  <a:close/>
                </a:path>
                <a:path w="4079240" h="413384">
                  <a:moveTo>
                    <a:pt x="828294" y="349504"/>
                  </a:moveTo>
                  <a:lnTo>
                    <a:pt x="817880" y="349504"/>
                  </a:lnTo>
                  <a:lnTo>
                    <a:pt x="817880" y="413131"/>
                  </a:lnTo>
                  <a:lnTo>
                    <a:pt x="828294" y="413131"/>
                  </a:lnTo>
                  <a:lnTo>
                    <a:pt x="828294" y="349504"/>
                  </a:lnTo>
                  <a:close/>
                </a:path>
                <a:path w="4079240" h="413384">
                  <a:moveTo>
                    <a:pt x="886333" y="190627"/>
                  </a:moveTo>
                  <a:lnTo>
                    <a:pt x="875919" y="190627"/>
                  </a:lnTo>
                  <a:lnTo>
                    <a:pt x="875919" y="413131"/>
                  </a:lnTo>
                  <a:lnTo>
                    <a:pt x="886333" y="413131"/>
                  </a:lnTo>
                  <a:lnTo>
                    <a:pt x="886333" y="190627"/>
                  </a:lnTo>
                  <a:close/>
                </a:path>
                <a:path w="4079240" h="413384">
                  <a:moveTo>
                    <a:pt x="944359" y="95250"/>
                  </a:moveTo>
                  <a:lnTo>
                    <a:pt x="933958" y="95250"/>
                  </a:lnTo>
                  <a:lnTo>
                    <a:pt x="933958" y="413131"/>
                  </a:lnTo>
                  <a:lnTo>
                    <a:pt x="944359" y="413131"/>
                  </a:lnTo>
                  <a:lnTo>
                    <a:pt x="944359" y="95250"/>
                  </a:lnTo>
                  <a:close/>
                </a:path>
                <a:path w="4079240" h="413384">
                  <a:moveTo>
                    <a:pt x="1002538" y="158877"/>
                  </a:moveTo>
                  <a:lnTo>
                    <a:pt x="992124" y="158877"/>
                  </a:lnTo>
                  <a:lnTo>
                    <a:pt x="992124" y="413131"/>
                  </a:lnTo>
                  <a:lnTo>
                    <a:pt x="1002538" y="413131"/>
                  </a:lnTo>
                  <a:lnTo>
                    <a:pt x="1002538" y="158877"/>
                  </a:lnTo>
                  <a:close/>
                </a:path>
                <a:path w="4079240" h="413384">
                  <a:moveTo>
                    <a:pt x="1060577" y="190627"/>
                  </a:moveTo>
                  <a:lnTo>
                    <a:pt x="1050163" y="190627"/>
                  </a:lnTo>
                  <a:lnTo>
                    <a:pt x="1050163" y="413131"/>
                  </a:lnTo>
                  <a:lnTo>
                    <a:pt x="1060577" y="413131"/>
                  </a:lnTo>
                  <a:lnTo>
                    <a:pt x="1060577" y="190627"/>
                  </a:lnTo>
                  <a:close/>
                </a:path>
                <a:path w="4079240" h="413384">
                  <a:moveTo>
                    <a:pt x="1118603" y="31750"/>
                  </a:moveTo>
                  <a:lnTo>
                    <a:pt x="1108202" y="31750"/>
                  </a:lnTo>
                  <a:lnTo>
                    <a:pt x="1108202" y="413131"/>
                  </a:lnTo>
                  <a:lnTo>
                    <a:pt x="1118603" y="413131"/>
                  </a:lnTo>
                  <a:lnTo>
                    <a:pt x="1118603" y="31750"/>
                  </a:lnTo>
                  <a:close/>
                </a:path>
                <a:path w="4079240" h="413384">
                  <a:moveTo>
                    <a:pt x="1176655" y="349504"/>
                  </a:moveTo>
                  <a:lnTo>
                    <a:pt x="1166241" y="349504"/>
                  </a:lnTo>
                  <a:lnTo>
                    <a:pt x="1166241" y="413131"/>
                  </a:lnTo>
                  <a:lnTo>
                    <a:pt x="1176655" y="413131"/>
                  </a:lnTo>
                  <a:lnTo>
                    <a:pt x="1176655" y="349504"/>
                  </a:lnTo>
                  <a:close/>
                </a:path>
                <a:path w="4079240" h="413384">
                  <a:moveTo>
                    <a:pt x="1234694" y="222377"/>
                  </a:moveTo>
                  <a:lnTo>
                    <a:pt x="1224280" y="222377"/>
                  </a:lnTo>
                  <a:lnTo>
                    <a:pt x="1224280" y="413131"/>
                  </a:lnTo>
                  <a:lnTo>
                    <a:pt x="1234694" y="413131"/>
                  </a:lnTo>
                  <a:lnTo>
                    <a:pt x="1234694" y="222377"/>
                  </a:lnTo>
                  <a:close/>
                </a:path>
                <a:path w="4079240" h="413384">
                  <a:moveTo>
                    <a:pt x="1292733" y="31750"/>
                  </a:moveTo>
                  <a:lnTo>
                    <a:pt x="1282319" y="31750"/>
                  </a:lnTo>
                  <a:lnTo>
                    <a:pt x="1282319" y="413131"/>
                  </a:lnTo>
                  <a:lnTo>
                    <a:pt x="1292733" y="413131"/>
                  </a:lnTo>
                  <a:lnTo>
                    <a:pt x="1292733" y="31750"/>
                  </a:lnTo>
                  <a:close/>
                </a:path>
                <a:path w="4079240" h="413384">
                  <a:moveTo>
                    <a:pt x="1350759" y="63500"/>
                  </a:moveTo>
                  <a:lnTo>
                    <a:pt x="1340358" y="63500"/>
                  </a:lnTo>
                  <a:lnTo>
                    <a:pt x="1340358" y="413131"/>
                  </a:lnTo>
                  <a:lnTo>
                    <a:pt x="1350759" y="413131"/>
                  </a:lnTo>
                  <a:lnTo>
                    <a:pt x="1350759" y="63500"/>
                  </a:lnTo>
                  <a:close/>
                </a:path>
                <a:path w="4079240" h="413384">
                  <a:moveTo>
                    <a:pt x="1408811" y="190627"/>
                  </a:moveTo>
                  <a:lnTo>
                    <a:pt x="1398397" y="190627"/>
                  </a:lnTo>
                  <a:lnTo>
                    <a:pt x="1398397" y="413131"/>
                  </a:lnTo>
                  <a:lnTo>
                    <a:pt x="1408811" y="413131"/>
                  </a:lnTo>
                  <a:lnTo>
                    <a:pt x="1408811" y="190627"/>
                  </a:lnTo>
                  <a:close/>
                </a:path>
                <a:path w="4079240" h="413384">
                  <a:moveTo>
                    <a:pt x="1466850" y="95250"/>
                  </a:moveTo>
                  <a:lnTo>
                    <a:pt x="1456436" y="95250"/>
                  </a:lnTo>
                  <a:lnTo>
                    <a:pt x="1456436" y="413131"/>
                  </a:lnTo>
                  <a:lnTo>
                    <a:pt x="1466850" y="413131"/>
                  </a:lnTo>
                  <a:lnTo>
                    <a:pt x="1466850" y="95250"/>
                  </a:lnTo>
                  <a:close/>
                </a:path>
                <a:path w="4079240" h="413384">
                  <a:moveTo>
                    <a:pt x="1525003" y="222377"/>
                  </a:moveTo>
                  <a:lnTo>
                    <a:pt x="1514602" y="222377"/>
                  </a:lnTo>
                  <a:lnTo>
                    <a:pt x="1514602" y="413131"/>
                  </a:lnTo>
                  <a:lnTo>
                    <a:pt x="1525003" y="413131"/>
                  </a:lnTo>
                  <a:lnTo>
                    <a:pt x="1525003" y="222377"/>
                  </a:lnTo>
                  <a:close/>
                </a:path>
                <a:path w="4079240" h="413384">
                  <a:moveTo>
                    <a:pt x="1583055" y="190627"/>
                  </a:moveTo>
                  <a:lnTo>
                    <a:pt x="1572641" y="190627"/>
                  </a:lnTo>
                  <a:lnTo>
                    <a:pt x="1572641" y="413131"/>
                  </a:lnTo>
                  <a:lnTo>
                    <a:pt x="1583055" y="413131"/>
                  </a:lnTo>
                  <a:lnTo>
                    <a:pt x="1583055" y="190627"/>
                  </a:lnTo>
                  <a:close/>
                </a:path>
                <a:path w="4079240" h="413384">
                  <a:moveTo>
                    <a:pt x="1641094" y="222377"/>
                  </a:moveTo>
                  <a:lnTo>
                    <a:pt x="1630680" y="222377"/>
                  </a:lnTo>
                  <a:lnTo>
                    <a:pt x="1630680" y="413131"/>
                  </a:lnTo>
                  <a:lnTo>
                    <a:pt x="1641094" y="413131"/>
                  </a:lnTo>
                  <a:lnTo>
                    <a:pt x="1641094" y="222377"/>
                  </a:lnTo>
                  <a:close/>
                </a:path>
                <a:path w="4079240" h="413384">
                  <a:moveTo>
                    <a:pt x="1699133" y="254254"/>
                  </a:moveTo>
                  <a:lnTo>
                    <a:pt x="1688719" y="254254"/>
                  </a:lnTo>
                  <a:lnTo>
                    <a:pt x="1688719" y="413131"/>
                  </a:lnTo>
                  <a:lnTo>
                    <a:pt x="1699133" y="413131"/>
                  </a:lnTo>
                  <a:lnTo>
                    <a:pt x="1699133" y="254254"/>
                  </a:lnTo>
                  <a:close/>
                </a:path>
                <a:path w="4079240" h="413384">
                  <a:moveTo>
                    <a:pt x="1757159" y="95250"/>
                  </a:moveTo>
                  <a:lnTo>
                    <a:pt x="1746758" y="95250"/>
                  </a:lnTo>
                  <a:lnTo>
                    <a:pt x="1746758" y="413131"/>
                  </a:lnTo>
                  <a:lnTo>
                    <a:pt x="1757159" y="413131"/>
                  </a:lnTo>
                  <a:lnTo>
                    <a:pt x="1757159" y="95250"/>
                  </a:lnTo>
                  <a:close/>
                </a:path>
                <a:path w="4079240" h="413384">
                  <a:moveTo>
                    <a:pt x="1815211" y="127127"/>
                  </a:moveTo>
                  <a:lnTo>
                    <a:pt x="1804797" y="127127"/>
                  </a:lnTo>
                  <a:lnTo>
                    <a:pt x="1804797" y="413131"/>
                  </a:lnTo>
                  <a:lnTo>
                    <a:pt x="1815211" y="413131"/>
                  </a:lnTo>
                  <a:lnTo>
                    <a:pt x="1815211" y="127127"/>
                  </a:lnTo>
                  <a:close/>
                </a:path>
                <a:path w="4079240" h="413384">
                  <a:moveTo>
                    <a:pt x="1873250" y="190627"/>
                  </a:moveTo>
                  <a:lnTo>
                    <a:pt x="1862836" y="190627"/>
                  </a:lnTo>
                  <a:lnTo>
                    <a:pt x="1862836" y="413131"/>
                  </a:lnTo>
                  <a:lnTo>
                    <a:pt x="1873250" y="413131"/>
                  </a:lnTo>
                  <a:lnTo>
                    <a:pt x="1873250" y="190627"/>
                  </a:lnTo>
                  <a:close/>
                </a:path>
                <a:path w="4079240" h="413384">
                  <a:moveTo>
                    <a:pt x="1931289" y="95250"/>
                  </a:moveTo>
                  <a:lnTo>
                    <a:pt x="1920875" y="95250"/>
                  </a:lnTo>
                  <a:lnTo>
                    <a:pt x="1920875" y="413131"/>
                  </a:lnTo>
                  <a:lnTo>
                    <a:pt x="1931289" y="413131"/>
                  </a:lnTo>
                  <a:lnTo>
                    <a:pt x="1931289" y="95250"/>
                  </a:lnTo>
                  <a:close/>
                </a:path>
                <a:path w="4079240" h="413384">
                  <a:moveTo>
                    <a:pt x="1989315" y="222377"/>
                  </a:moveTo>
                  <a:lnTo>
                    <a:pt x="1978914" y="222377"/>
                  </a:lnTo>
                  <a:lnTo>
                    <a:pt x="1978914" y="413131"/>
                  </a:lnTo>
                  <a:lnTo>
                    <a:pt x="1989315" y="413131"/>
                  </a:lnTo>
                  <a:lnTo>
                    <a:pt x="1989315" y="222377"/>
                  </a:lnTo>
                  <a:close/>
                </a:path>
                <a:path w="4079240" h="413384">
                  <a:moveTo>
                    <a:pt x="2047367" y="190627"/>
                  </a:moveTo>
                  <a:lnTo>
                    <a:pt x="2036953" y="190627"/>
                  </a:lnTo>
                  <a:lnTo>
                    <a:pt x="2036953" y="413131"/>
                  </a:lnTo>
                  <a:lnTo>
                    <a:pt x="2047367" y="413131"/>
                  </a:lnTo>
                  <a:lnTo>
                    <a:pt x="2047367" y="190627"/>
                  </a:lnTo>
                  <a:close/>
                </a:path>
                <a:path w="4079240" h="413384">
                  <a:moveTo>
                    <a:pt x="2105533" y="222377"/>
                  </a:moveTo>
                  <a:lnTo>
                    <a:pt x="2095119" y="222377"/>
                  </a:lnTo>
                  <a:lnTo>
                    <a:pt x="2095119" y="413131"/>
                  </a:lnTo>
                  <a:lnTo>
                    <a:pt x="2105533" y="413131"/>
                  </a:lnTo>
                  <a:lnTo>
                    <a:pt x="2105533" y="222377"/>
                  </a:lnTo>
                  <a:close/>
                </a:path>
                <a:path w="4079240" h="413384">
                  <a:moveTo>
                    <a:pt x="2163572" y="317754"/>
                  </a:moveTo>
                  <a:lnTo>
                    <a:pt x="2153158" y="317754"/>
                  </a:lnTo>
                  <a:lnTo>
                    <a:pt x="2153158" y="413131"/>
                  </a:lnTo>
                  <a:lnTo>
                    <a:pt x="2163572" y="413131"/>
                  </a:lnTo>
                  <a:lnTo>
                    <a:pt x="2163572" y="317754"/>
                  </a:lnTo>
                  <a:close/>
                </a:path>
                <a:path w="4079240" h="413384">
                  <a:moveTo>
                    <a:pt x="2221611" y="190627"/>
                  </a:moveTo>
                  <a:lnTo>
                    <a:pt x="2211197" y="190627"/>
                  </a:lnTo>
                  <a:lnTo>
                    <a:pt x="2211197" y="413131"/>
                  </a:lnTo>
                  <a:lnTo>
                    <a:pt x="2221611" y="413131"/>
                  </a:lnTo>
                  <a:lnTo>
                    <a:pt x="2221611" y="190627"/>
                  </a:lnTo>
                  <a:close/>
                </a:path>
                <a:path w="4079240" h="413384">
                  <a:moveTo>
                    <a:pt x="2279650" y="158877"/>
                  </a:moveTo>
                  <a:lnTo>
                    <a:pt x="2269236" y="158877"/>
                  </a:lnTo>
                  <a:lnTo>
                    <a:pt x="2269236" y="413131"/>
                  </a:lnTo>
                  <a:lnTo>
                    <a:pt x="2279650" y="413131"/>
                  </a:lnTo>
                  <a:lnTo>
                    <a:pt x="2279650" y="158877"/>
                  </a:lnTo>
                  <a:close/>
                </a:path>
                <a:path w="4079240" h="413384">
                  <a:moveTo>
                    <a:pt x="2337689" y="317754"/>
                  </a:moveTo>
                  <a:lnTo>
                    <a:pt x="2327275" y="317754"/>
                  </a:lnTo>
                  <a:lnTo>
                    <a:pt x="2327275" y="413131"/>
                  </a:lnTo>
                  <a:lnTo>
                    <a:pt x="2337689" y="413131"/>
                  </a:lnTo>
                  <a:lnTo>
                    <a:pt x="2337689" y="317754"/>
                  </a:lnTo>
                  <a:close/>
                </a:path>
                <a:path w="4079240" h="413384">
                  <a:moveTo>
                    <a:pt x="2395728" y="254254"/>
                  </a:moveTo>
                  <a:lnTo>
                    <a:pt x="2385314" y="254254"/>
                  </a:lnTo>
                  <a:lnTo>
                    <a:pt x="2385314" y="413131"/>
                  </a:lnTo>
                  <a:lnTo>
                    <a:pt x="2395728" y="413131"/>
                  </a:lnTo>
                  <a:lnTo>
                    <a:pt x="2395728" y="254254"/>
                  </a:lnTo>
                  <a:close/>
                </a:path>
                <a:path w="4079240" h="413384">
                  <a:moveTo>
                    <a:pt x="2453767" y="190627"/>
                  </a:moveTo>
                  <a:lnTo>
                    <a:pt x="2443353" y="190627"/>
                  </a:lnTo>
                  <a:lnTo>
                    <a:pt x="2443353" y="413131"/>
                  </a:lnTo>
                  <a:lnTo>
                    <a:pt x="2453767" y="413131"/>
                  </a:lnTo>
                  <a:lnTo>
                    <a:pt x="2453767" y="190627"/>
                  </a:lnTo>
                  <a:close/>
                </a:path>
                <a:path w="4079240" h="413384">
                  <a:moveTo>
                    <a:pt x="2511793" y="95250"/>
                  </a:moveTo>
                  <a:lnTo>
                    <a:pt x="2501392" y="95250"/>
                  </a:lnTo>
                  <a:lnTo>
                    <a:pt x="2501392" y="413131"/>
                  </a:lnTo>
                  <a:lnTo>
                    <a:pt x="2511793" y="413131"/>
                  </a:lnTo>
                  <a:lnTo>
                    <a:pt x="2511793" y="95250"/>
                  </a:lnTo>
                  <a:close/>
                </a:path>
                <a:path w="4079240" h="413384">
                  <a:moveTo>
                    <a:pt x="2569845" y="127127"/>
                  </a:moveTo>
                  <a:lnTo>
                    <a:pt x="2559431" y="127127"/>
                  </a:lnTo>
                  <a:lnTo>
                    <a:pt x="2559431" y="413131"/>
                  </a:lnTo>
                  <a:lnTo>
                    <a:pt x="2569845" y="413131"/>
                  </a:lnTo>
                  <a:lnTo>
                    <a:pt x="2569845" y="127127"/>
                  </a:lnTo>
                  <a:close/>
                </a:path>
                <a:path w="4079240" h="413384">
                  <a:moveTo>
                    <a:pt x="2628011" y="254254"/>
                  </a:moveTo>
                  <a:lnTo>
                    <a:pt x="2617597" y="254254"/>
                  </a:lnTo>
                  <a:lnTo>
                    <a:pt x="2617597" y="413131"/>
                  </a:lnTo>
                  <a:lnTo>
                    <a:pt x="2628011" y="413131"/>
                  </a:lnTo>
                  <a:lnTo>
                    <a:pt x="2628011" y="254254"/>
                  </a:lnTo>
                  <a:close/>
                </a:path>
                <a:path w="4079240" h="413384">
                  <a:moveTo>
                    <a:pt x="2686050" y="317754"/>
                  </a:moveTo>
                  <a:lnTo>
                    <a:pt x="2675636" y="317754"/>
                  </a:lnTo>
                  <a:lnTo>
                    <a:pt x="2675636" y="413131"/>
                  </a:lnTo>
                  <a:lnTo>
                    <a:pt x="2686050" y="413131"/>
                  </a:lnTo>
                  <a:lnTo>
                    <a:pt x="2686050" y="317754"/>
                  </a:lnTo>
                  <a:close/>
                </a:path>
                <a:path w="4079240" h="413384">
                  <a:moveTo>
                    <a:pt x="2744089" y="222377"/>
                  </a:moveTo>
                  <a:lnTo>
                    <a:pt x="2733675" y="222377"/>
                  </a:lnTo>
                  <a:lnTo>
                    <a:pt x="2733675" y="413131"/>
                  </a:lnTo>
                  <a:lnTo>
                    <a:pt x="2744089" y="413131"/>
                  </a:lnTo>
                  <a:lnTo>
                    <a:pt x="2744089" y="222377"/>
                  </a:lnTo>
                  <a:close/>
                </a:path>
                <a:path w="4079240" h="413384">
                  <a:moveTo>
                    <a:pt x="2802128" y="95250"/>
                  </a:moveTo>
                  <a:lnTo>
                    <a:pt x="2791714" y="95250"/>
                  </a:lnTo>
                  <a:lnTo>
                    <a:pt x="2791714" y="413131"/>
                  </a:lnTo>
                  <a:lnTo>
                    <a:pt x="2802128" y="413131"/>
                  </a:lnTo>
                  <a:lnTo>
                    <a:pt x="2802128" y="95250"/>
                  </a:lnTo>
                  <a:close/>
                </a:path>
                <a:path w="4079240" h="413384">
                  <a:moveTo>
                    <a:pt x="2860167" y="190627"/>
                  </a:moveTo>
                  <a:lnTo>
                    <a:pt x="2849753" y="190627"/>
                  </a:lnTo>
                  <a:lnTo>
                    <a:pt x="2849753" y="413131"/>
                  </a:lnTo>
                  <a:lnTo>
                    <a:pt x="2860167" y="413131"/>
                  </a:lnTo>
                  <a:lnTo>
                    <a:pt x="2860167" y="190627"/>
                  </a:lnTo>
                  <a:close/>
                </a:path>
                <a:path w="4079240" h="413384">
                  <a:moveTo>
                    <a:pt x="2918193" y="158877"/>
                  </a:moveTo>
                  <a:lnTo>
                    <a:pt x="2907792" y="158877"/>
                  </a:lnTo>
                  <a:lnTo>
                    <a:pt x="2907792" y="413131"/>
                  </a:lnTo>
                  <a:lnTo>
                    <a:pt x="2918193" y="413131"/>
                  </a:lnTo>
                  <a:lnTo>
                    <a:pt x="2918193" y="158877"/>
                  </a:lnTo>
                  <a:close/>
                </a:path>
                <a:path w="4079240" h="413384">
                  <a:moveTo>
                    <a:pt x="2976245" y="222377"/>
                  </a:moveTo>
                  <a:lnTo>
                    <a:pt x="2965831" y="222377"/>
                  </a:lnTo>
                  <a:lnTo>
                    <a:pt x="2965831" y="413131"/>
                  </a:lnTo>
                  <a:lnTo>
                    <a:pt x="2976245" y="413131"/>
                  </a:lnTo>
                  <a:lnTo>
                    <a:pt x="2976245" y="222377"/>
                  </a:lnTo>
                  <a:close/>
                </a:path>
                <a:path w="4079240" h="413384">
                  <a:moveTo>
                    <a:pt x="3034284" y="286004"/>
                  </a:moveTo>
                  <a:lnTo>
                    <a:pt x="3023870" y="286004"/>
                  </a:lnTo>
                  <a:lnTo>
                    <a:pt x="3023870" y="413131"/>
                  </a:lnTo>
                  <a:lnTo>
                    <a:pt x="3034284" y="413131"/>
                  </a:lnTo>
                  <a:lnTo>
                    <a:pt x="3034284" y="286004"/>
                  </a:lnTo>
                  <a:close/>
                </a:path>
                <a:path w="4079240" h="413384">
                  <a:moveTo>
                    <a:pt x="3092323" y="190627"/>
                  </a:moveTo>
                  <a:lnTo>
                    <a:pt x="3081909" y="190627"/>
                  </a:lnTo>
                  <a:lnTo>
                    <a:pt x="3081909" y="413131"/>
                  </a:lnTo>
                  <a:lnTo>
                    <a:pt x="3092323" y="413131"/>
                  </a:lnTo>
                  <a:lnTo>
                    <a:pt x="3092323" y="190627"/>
                  </a:lnTo>
                  <a:close/>
                </a:path>
                <a:path w="4079240" h="413384">
                  <a:moveTo>
                    <a:pt x="3150489" y="286004"/>
                  </a:moveTo>
                  <a:lnTo>
                    <a:pt x="3140075" y="286004"/>
                  </a:lnTo>
                  <a:lnTo>
                    <a:pt x="3140075" y="413131"/>
                  </a:lnTo>
                  <a:lnTo>
                    <a:pt x="3150489" y="413131"/>
                  </a:lnTo>
                  <a:lnTo>
                    <a:pt x="3150489" y="286004"/>
                  </a:lnTo>
                  <a:close/>
                </a:path>
                <a:path w="4079240" h="413384">
                  <a:moveTo>
                    <a:pt x="3208528" y="317754"/>
                  </a:moveTo>
                  <a:lnTo>
                    <a:pt x="3198114" y="317754"/>
                  </a:lnTo>
                  <a:lnTo>
                    <a:pt x="3198114" y="413131"/>
                  </a:lnTo>
                  <a:lnTo>
                    <a:pt x="3208528" y="413131"/>
                  </a:lnTo>
                  <a:lnTo>
                    <a:pt x="3208528" y="317754"/>
                  </a:lnTo>
                  <a:close/>
                </a:path>
                <a:path w="4079240" h="413384">
                  <a:moveTo>
                    <a:pt x="3266567" y="349504"/>
                  </a:moveTo>
                  <a:lnTo>
                    <a:pt x="3256153" y="349504"/>
                  </a:lnTo>
                  <a:lnTo>
                    <a:pt x="3256153" y="413131"/>
                  </a:lnTo>
                  <a:lnTo>
                    <a:pt x="3266567" y="413131"/>
                  </a:lnTo>
                  <a:lnTo>
                    <a:pt x="3266567" y="349504"/>
                  </a:lnTo>
                  <a:close/>
                </a:path>
                <a:path w="4079240" h="413384">
                  <a:moveTo>
                    <a:pt x="3324593" y="0"/>
                  </a:moveTo>
                  <a:lnTo>
                    <a:pt x="3314192" y="0"/>
                  </a:lnTo>
                  <a:lnTo>
                    <a:pt x="3314192" y="413131"/>
                  </a:lnTo>
                  <a:lnTo>
                    <a:pt x="3324593" y="413131"/>
                  </a:lnTo>
                  <a:lnTo>
                    <a:pt x="3324593" y="0"/>
                  </a:lnTo>
                  <a:close/>
                </a:path>
                <a:path w="4079240" h="413384">
                  <a:moveTo>
                    <a:pt x="3382645" y="381381"/>
                  </a:moveTo>
                  <a:lnTo>
                    <a:pt x="3372231" y="381381"/>
                  </a:lnTo>
                  <a:lnTo>
                    <a:pt x="3372231" y="413131"/>
                  </a:lnTo>
                  <a:lnTo>
                    <a:pt x="3382645" y="413131"/>
                  </a:lnTo>
                  <a:lnTo>
                    <a:pt x="3382645" y="381381"/>
                  </a:lnTo>
                  <a:close/>
                </a:path>
                <a:path w="4079240" h="413384">
                  <a:moveTo>
                    <a:pt x="3440684" y="286004"/>
                  </a:moveTo>
                  <a:lnTo>
                    <a:pt x="3430270" y="286004"/>
                  </a:lnTo>
                  <a:lnTo>
                    <a:pt x="3430270" y="413131"/>
                  </a:lnTo>
                  <a:lnTo>
                    <a:pt x="3440684" y="413131"/>
                  </a:lnTo>
                  <a:lnTo>
                    <a:pt x="3440684" y="286004"/>
                  </a:lnTo>
                  <a:close/>
                </a:path>
                <a:path w="4079240" h="413384">
                  <a:moveTo>
                    <a:pt x="3498723" y="63500"/>
                  </a:moveTo>
                  <a:lnTo>
                    <a:pt x="3488309" y="63500"/>
                  </a:lnTo>
                  <a:lnTo>
                    <a:pt x="3488309" y="413131"/>
                  </a:lnTo>
                  <a:lnTo>
                    <a:pt x="3498723" y="413131"/>
                  </a:lnTo>
                  <a:lnTo>
                    <a:pt x="3498723" y="63500"/>
                  </a:lnTo>
                  <a:close/>
                </a:path>
                <a:path w="4079240" h="413384">
                  <a:moveTo>
                    <a:pt x="3556762" y="222377"/>
                  </a:moveTo>
                  <a:lnTo>
                    <a:pt x="3546348" y="222377"/>
                  </a:lnTo>
                  <a:lnTo>
                    <a:pt x="3546348" y="413131"/>
                  </a:lnTo>
                  <a:lnTo>
                    <a:pt x="3556762" y="413131"/>
                  </a:lnTo>
                  <a:lnTo>
                    <a:pt x="3556762" y="222377"/>
                  </a:lnTo>
                  <a:close/>
                </a:path>
                <a:path w="4079240" h="413384">
                  <a:moveTo>
                    <a:pt x="3614801" y="190627"/>
                  </a:moveTo>
                  <a:lnTo>
                    <a:pt x="3604387" y="190627"/>
                  </a:lnTo>
                  <a:lnTo>
                    <a:pt x="3604387" y="413131"/>
                  </a:lnTo>
                  <a:lnTo>
                    <a:pt x="3614801" y="413131"/>
                  </a:lnTo>
                  <a:lnTo>
                    <a:pt x="3614801" y="190627"/>
                  </a:lnTo>
                  <a:close/>
                </a:path>
                <a:path w="4079240" h="413384">
                  <a:moveTo>
                    <a:pt x="3672840" y="222377"/>
                  </a:moveTo>
                  <a:lnTo>
                    <a:pt x="3662426" y="222377"/>
                  </a:lnTo>
                  <a:lnTo>
                    <a:pt x="3662426" y="413131"/>
                  </a:lnTo>
                  <a:lnTo>
                    <a:pt x="3672840" y="413131"/>
                  </a:lnTo>
                  <a:lnTo>
                    <a:pt x="3672840" y="222377"/>
                  </a:lnTo>
                  <a:close/>
                </a:path>
                <a:path w="4079240" h="413384">
                  <a:moveTo>
                    <a:pt x="3730993" y="222377"/>
                  </a:moveTo>
                  <a:lnTo>
                    <a:pt x="3720592" y="222377"/>
                  </a:lnTo>
                  <a:lnTo>
                    <a:pt x="3720592" y="413131"/>
                  </a:lnTo>
                  <a:lnTo>
                    <a:pt x="3730993" y="413131"/>
                  </a:lnTo>
                  <a:lnTo>
                    <a:pt x="3730993" y="222377"/>
                  </a:lnTo>
                  <a:close/>
                </a:path>
                <a:path w="4079240" h="413384">
                  <a:moveTo>
                    <a:pt x="3789045" y="286004"/>
                  </a:moveTo>
                  <a:lnTo>
                    <a:pt x="3778631" y="286004"/>
                  </a:lnTo>
                  <a:lnTo>
                    <a:pt x="3778631" y="413131"/>
                  </a:lnTo>
                  <a:lnTo>
                    <a:pt x="3789045" y="413131"/>
                  </a:lnTo>
                  <a:lnTo>
                    <a:pt x="3789045" y="286004"/>
                  </a:lnTo>
                  <a:close/>
                </a:path>
                <a:path w="4079240" h="413384">
                  <a:moveTo>
                    <a:pt x="3847084" y="127127"/>
                  </a:moveTo>
                  <a:lnTo>
                    <a:pt x="3836670" y="127127"/>
                  </a:lnTo>
                  <a:lnTo>
                    <a:pt x="3836670" y="413131"/>
                  </a:lnTo>
                  <a:lnTo>
                    <a:pt x="3847084" y="413131"/>
                  </a:lnTo>
                  <a:lnTo>
                    <a:pt x="3847084" y="127127"/>
                  </a:lnTo>
                  <a:close/>
                </a:path>
                <a:path w="4079240" h="413384">
                  <a:moveTo>
                    <a:pt x="3905123" y="0"/>
                  </a:moveTo>
                  <a:lnTo>
                    <a:pt x="3894709" y="0"/>
                  </a:lnTo>
                  <a:lnTo>
                    <a:pt x="3894709" y="413131"/>
                  </a:lnTo>
                  <a:lnTo>
                    <a:pt x="3905123" y="413131"/>
                  </a:lnTo>
                  <a:lnTo>
                    <a:pt x="3905123" y="0"/>
                  </a:lnTo>
                  <a:close/>
                </a:path>
                <a:path w="4079240" h="413384">
                  <a:moveTo>
                    <a:pt x="3963162" y="95250"/>
                  </a:moveTo>
                  <a:lnTo>
                    <a:pt x="3952748" y="95250"/>
                  </a:lnTo>
                  <a:lnTo>
                    <a:pt x="3952748" y="413131"/>
                  </a:lnTo>
                  <a:lnTo>
                    <a:pt x="3963162" y="413131"/>
                  </a:lnTo>
                  <a:lnTo>
                    <a:pt x="3963162" y="95250"/>
                  </a:lnTo>
                  <a:close/>
                </a:path>
                <a:path w="4079240" h="413384">
                  <a:moveTo>
                    <a:pt x="4021201" y="286004"/>
                  </a:moveTo>
                  <a:lnTo>
                    <a:pt x="4010787" y="286004"/>
                  </a:lnTo>
                  <a:lnTo>
                    <a:pt x="4010787" y="413131"/>
                  </a:lnTo>
                  <a:lnTo>
                    <a:pt x="4021201" y="413131"/>
                  </a:lnTo>
                  <a:lnTo>
                    <a:pt x="4021201" y="286004"/>
                  </a:lnTo>
                  <a:close/>
                </a:path>
                <a:path w="4079240" h="413384">
                  <a:moveTo>
                    <a:pt x="4079240" y="95250"/>
                  </a:moveTo>
                  <a:lnTo>
                    <a:pt x="4068826" y="95250"/>
                  </a:lnTo>
                  <a:lnTo>
                    <a:pt x="4068826" y="413131"/>
                  </a:lnTo>
                  <a:lnTo>
                    <a:pt x="4079240" y="413131"/>
                  </a:lnTo>
                  <a:lnTo>
                    <a:pt x="4079240" y="95250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4" name="object 124" descr=""/>
            <p:cNvSpPr/>
            <p:nvPr/>
          </p:nvSpPr>
          <p:spPr>
            <a:xfrm>
              <a:off x="5277739" y="8312785"/>
              <a:ext cx="4132579" cy="349885"/>
            </a:xfrm>
            <a:custGeom>
              <a:avLst/>
              <a:gdLst/>
              <a:ahLst/>
              <a:cxnLst/>
              <a:rect l="l" t="t" r="r" b="b"/>
              <a:pathLst>
                <a:path w="4132579" h="349884">
                  <a:moveTo>
                    <a:pt x="10414" y="31750"/>
                  </a:moveTo>
                  <a:lnTo>
                    <a:pt x="0" y="31750"/>
                  </a:lnTo>
                  <a:lnTo>
                    <a:pt x="0" y="349631"/>
                  </a:lnTo>
                  <a:lnTo>
                    <a:pt x="10414" y="349631"/>
                  </a:lnTo>
                  <a:lnTo>
                    <a:pt x="10414" y="31750"/>
                  </a:lnTo>
                  <a:close/>
                </a:path>
                <a:path w="4132579" h="349884">
                  <a:moveTo>
                    <a:pt x="68453" y="222504"/>
                  </a:moveTo>
                  <a:lnTo>
                    <a:pt x="58039" y="222504"/>
                  </a:lnTo>
                  <a:lnTo>
                    <a:pt x="58039" y="349631"/>
                  </a:lnTo>
                  <a:lnTo>
                    <a:pt x="68453" y="349631"/>
                  </a:lnTo>
                  <a:lnTo>
                    <a:pt x="68453" y="222504"/>
                  </a:lnTo>
                  <a:close/>
                </a:path>
                <a:path w="4132579" h="349884">
                  <a:moveTo>
                    <a:pt x="126492" y="286004"/>
                  </a:moveTo>
                  <a:lnTo>
                    <a:pt x="116078" y="286004"/>
                  </a:lnTo>
                  <a:lnTo>
                    <a:pt x="116078" y="349631"/>
                  </a:lnTo>
                  <a:lnTo>
                    <a:pt x="126492" y="349631"/>
                  </a:lnTo>
                  <a:lnTo>
                    <a:pt x="126492" y="286004"/>
                  </a:lnTo>
                  <a:close/>
                </a:path>
                <a:path w="4132579" h="349884">
                  <a:moveTo>
                    <a:pt x="184658" y="254254"/>
                  </a:moveTo>
                  <a:lnTo>
                    <a:pt x="174244" y="254254"/>
                  </a:lnTo>
                  <a:lnTo>
                    <a:pt x="174244" y="349631"/>
                  </a:lnTo>
                  <a:lnTo>
                    <a:pt x="184658" y="349631"/>
                  </a:lnTo>
                  <a:lnTo>
                    <a:pt x="184658" y="254254"/>
                  </a:lnTo>
                  <a:close/>
                </a:path>
                <a:path w="4132579" h="349884">
                  <a:moveTo>
                    <a:pt x="242697" y="222504"/>
                  </a:moveTo>
                  <a:lnTo>
                    <a:pt x="232283" y="222504"/>
                  </a:lnTo>
                  <a:lnTo>
                    <a:pt x="232283" y="349631"/>
                  </a:lnTo>
                  <a:lnTo>
                    <a:pt x="242697" y="349631"/>
                  </a:lnTo>
                  <a:lnTo>
                    <a:pt x="242697" y="222504"/>
                  </a:lnTo>
                  <a:close/>
                </a:path>
                <a:path w="4132579" h="349884">
                  <a:moveTo>
                    <a:pt x="300736" y="127127"/>
                  </a:moveTo>
                  <a:lnTo>
                    <a:pt x="290322" y="127127"/>
                  </a:lnTo>
                  <a:lnTo>
                    <a:pt x="290322" y="349631"/>
                  </a:lnTo>
                  <a:lnTo>
                    <a:pt x="300736" y="349631"/>
                  </a:lnTo>
                  <a:lnTo>
                    <a:pt x="300736" y="127127"/>
                  </a:lnTo>
                  <a:close/>
                </a:path>
                <a:path w="4132579" h="349884">
                  <a:moveTo>
                    <a:pt x="358775" y="127127"/>
                  </a:moveTo>
                  <a:lnTo>
                    <a:pt x="348361" y="127127"/>
                  </a:lnTo>
                  <a:lnTo>
                    <a:pt x="348361" y="349631"/>
                  </a:lnTo>
                  <a:lnTo>
                    <a:pt x="358775" y="349631"/>
                  </a:lnTo>
                  <a:lnTo>
                    <a:pt x="358775" y="127127"/>
                  </a:lnTo>
                  <a:close/>
                </a:path>
                <a:path w="4132579" h="349884">
                  <a:moveTo>
                    <a:pt x="416814" y="190754"/>
                  </a:moveTo>
                  <a:lnTo>
                    <a:pt x="406400" y="190754"/>
                  </a:lnTo>
                  <a:lnTo>
                    <a:pt x="406400" y="349631"/>
                  </a:lnTo>
                  <a:lnTo>
                    <a:pt x="416814" y="349631"/>
                  </a:lnTo>
                  <a:lnTo>
                    <a:pt x="416814" y="190754"/>
                  </a:lnTo>
                  <a:close/>
                </a:path>
                <a:path w="4132579" h="349884">
                  <a:moveTo>
                    <a:pt x="474853" y="286004"/>
                  </a:moveTo>
                  <a:lnTo>
                    <a:pt x="464439" y="286004"/>
                  </a:lnTo>
                  <a:lnTo>
                    <a:pt x="464439" y="349631"/>
                  </a:lnTo>
                  <a:lnTo>
                    <a:pt x="474853" y="349631"/>
                  </a:lnTo>
                  <a:lnTo>
                    <a:pt x="474853" y="286004"/>
                  </a:lnTo>
                  <a:close/>
                </a:path>
                <a:path w="4132579" h="349884">
                  <a:moveTo>
                    <a:pt x="532892" y="190754"/>
                  </a:moveTo>
                  <a:lnTo>
                    <a:pt x="522478" y="190754"/>
                  </a:lnTo>
                  <a:lnTo>
                    <a:pt x="522478" y="349631"/>
                  </a:lnTo>
                  <a:lnTo>
                    <a:pt x="532892" y="349631"/>
                  </a:lnTo>
                  <a:lnTo>
                    <a:pt x="532892" y="190754"/>
                  </a:lnTo>
                  <a:close/>
                </a:path>
                <a:path w="4132579" h="349884">
                  <a:moveTo>
                    <a:pt x="590918" y="222504"/>
                  </a:moveTo>
                  <a:lnTo>
                    <a:pt x="580517" y="222504"/>
                  </a:lnTo>
                  <a:lnTo>
                    <a:pt x="580517" y="349631"/>
                  </a:lnTo>
                  <a:lnTo>
                    <a:pt x="590918" y="349631"/>
                  </a:lnTo>
                  <a:lnTo>
                    <a:pt x="590918" y="222504"/>
                  </a:lnTo>
                  <a:close/>
                </a:path>
                <a:path w="4132579" h="349884">
                  <a:moveTo>
                    <a:pt x="648970" y="286004"/>
                  </a:moveTo>
                  <a:lnTo>
                    <a:pt x="638556" y="286004"/>
                  </a:lnTo>
                  <a:lnTo>
                    <a:pt x="638556" y="349631"/>
                  </a:lnTo>
                  <a:lnTo>
                    <a:pt x="648970" y="349631"/>
                  </a:lnTo>
                  <a:lnTo>
                    <a:pt x="648970" y="286004"/>
                  </a:lnTo>
                  <a:close/>
                </a:path>
                <a:path w="4132579" h="349884">
                  <a:moveTo>
                    <a:pt x="707136" y="286004"/>
                  </a:moveTo>
                  <a:lnTo>
                    <a:pt x="696722" y="286004"/>
                  </a:lnTo>
                  <a:lnTo>
                    <a:pt x="696722" y="349631"/>
                  </a:lnTo>
                  <a:lnTo>
                    <a:pt x="707136" y="349631"/>
                  </a:lnTo>
                  <a:lnTo>
                    <a:pt x="707136" y="286004"/>
                  </a:lnTo>
                  <a:close/>
                </a:path>
                <a:path w="4132579" h="349884">
                  <a:moveTo>
                    <a:pt x="765175" y="127127"/>
                  </a:moveTo>
                  <a:lnTo>
                    <a:pt x="754761" y="127127"/>
                  </a:lnTo>
                  <a:lnTo>
                    <a:pt x="754761" y="349631"/>
                  </a:lnTo>
                  <a:lnTo>
                    <a:pt x="765175" y="349631"/>
                  </a:lnTo>
                  <a:lnTo>
                    <a:pt x="765175" y="127127"/>
                  </a:lnTo>
                  <a:close/>
                </a:path>
                <a:path w="4132579" h="349884">
                  <a:moveTo>
                    <a:pt x="823214" y="254254"/>
                  </a:moveTo>
                  <a:lnTo>
                    <a:pt x="812800" y="254254"/>
                  </a:lnTo>
                  <a:lnTo>
                    <a:pt x="812800" y="349631"/>
                  </a:lnTo>
                  <a:lnTo>
                    <a:pt x="823214" y="349631"/>
                  </a:lnTo>
                  <a:lnTo>
                    <a:pt x="823214" y="254254"/>
                  </a:lnTo>
                  <a:close/>
                </a:path>
                <a:path w="4132579" h="349884">
                  <a:moveTo>
                    <a:pt x="881253" y="222504"/>
                  </a:moveTo>
                  <a:lnTo>
                    <a:pt x="870839" y="222504"/>
                  </a:lnTo>
                  <a:lnTo>
                    <a:pt x="870839" y="349631"/>
                  </a:lnTo>
                  <a:lnTo>
                    <a:pt x="881253" y="349631"/>
                  </a:lnTo>
                  <a:lnTo>
                    <a:pt x="881253" y="222504"/>
                  </a:lnTo>
                  <a:close/>
                </a:path>
                <a:path w="4132579" h="349884">
                  <a:moveTo>
                    <a:pt x="939292" y="190754"/>
                  </a:moveTo>
                  <a:lnTo>
                    <a:pt x="928878" y="190754"/>
                  </a:lnTo>
                  <a:lnTo>
                    <a:pt x="928878" y="349631"/>
                  </a:lnTo>
                  <a:lnTo>
                    <a:pt x="939292" y="349631"/>
                  </a:lnTo>
                  <a:lnTo>
                    <a:pt x="939292" y="190754"/>
                  </a:lnTo>
                  <a:close/>
                </a:path>
                <a:path w="4132579" h="349884">
                  <a:moveTo>
                    <a:pt x="997318" y="190754"/>
                  </a:moveTo>
                  <a:lnTo>
                    <a:pt x="986917" y="190754"/>
                  </a:lnTo>
                  <a:lnTo>
                    <a:pt x="986917" y="349631"/>
                  </a:lnTo>
                  <a:lnTo>
                    <a:pt x="997318" y="349631"/>
                  </a:lnTo>
                  <a:lnTo>
                    <a:pt x="997318" y="190754"/>
                  </a:lnTo>
                  <a:close/>
                </a:path>
                <a:path w="4132579" h="349884">
                  <a:moveTo>
                    <a:pt x="1055370" y="222504"/>
                  </a:moveTo>
                  <a:lnTo>
                    <a:pt x="1044956" y="222504"/>
                  </a:lnTo>
                  <a:lnTo>
                    <a:pt x="1044956" y="349631"/>
                  </a:lnTo>
                  <a:lnTo>
                    <a:pt x="1055370" y="349631"/>
                  </a:lnTo>
                  <a:lnTo>
                    <a:pt x="1055370" y="222504"/>
                  </a:lnTo>
                  <a:close/>
                </a:path>
                <a:path w="4132579" h="349884">
                  <a:moveTo>
                    <a:pt x="1113409" y="158877"/>
                  </a:moveTo>
                  <a:lnTo>
                    <a:pt x="1102995" y="158877"/>
                  </a:lnTo>
                  <a:lnTo>
                    <a:pt x="1102995" y="349631"/>
                  </a:lnTo>
                  <a:lnTo>
                    <a:pt x="1113409" y="349631"/>
                  </a:lnTo>
                  <a:lnTo>
                    <a:pt x="1113409" y="158877"/>
                  </a:lnTo>
                  <a:close/>
                </a:path>
                <a:path w="4132579" h="349884">
                  <a:moveTo>
                    <a:pt x="1171448" y="0"/>
                  </a:moveTo>
                  <a:lnTo>
                    <a:pt x="1161034" y="0"/>
                  </a:lnTo>
                  <a:lnTo>
                    <a:pt x="1161034" y="349631"/>
                  </a:lnTo>
                  <a:lnTo>
                    <a:pt x="1171448" y="349631"/>
                  </a:lnTo>
                  <a:lnTo>
                    <a:pt x="1171448" y="0"/>
                  </a:lnTo>
                  <a:close/>
                </a:path>
                <a:path w="4132579" h="349884">
                  <a:moveTo>
                    <a:pt x="1229487" y="190754"/>
                  </a:moveTo>
                  <a:lnTo>
                    <a:pt x="1219073" y="190754"/>
                  </a:lnTo>
                  <a:lnTo>
                    <a:pt x="1219073" y="349631"/>
                  </a:lnTo>
                  <a:lnTo>
                    <a:pt x="1229487" y="349631"/>
                  </a:lnTo>
                  <a:lnTo>
                    <a:pt x="1229487" y="190754"/>
                  </a:lnTo>
                  <a:close/>
                </a:path>
                <a:path w="4132579" h="349884">
                  <a:moveTo>
                    <a:pt x="1287653" y="286004"/>
                  </a:moveTo>
                  <a:lnTo>
                    <a:pt x="1277239" y="286004"/>
                  </a:lnTo>
                  <a:lnTo>
                    <a:pt x="1277239" y="349631"/>
                  </a:lnTo>
                  <a:lnTo>
                    <a:pt x="1287653" y="349631"/>
                  </a:lnTo>
                  <a:lnTo>
                    <a:pt x="1287653" y="286004"/>
                  </a:lnTo>
                  <a:close/>
                </a:path>
                <a:path w="4132579" h="349884">
                  <a:moveTo>
                    <a:pt x="1345692" y="190754"/>
                  </a:moveTo>
                  <a:lnTo>
                    <a:pt x="1335278" y="190754"/>
                  </a:lnTo>
                  <a:lnTo>
                    <a:pt x="1335278" y="349631"/>
                  </a:lnTo>
                  <a:lnTo>
                    <a:pt x="1345692" y="349631"/>
                  </a:lnTo>
                  <a:lnTo>
                    <a:pt x="1345692" y="190754"/>
                  </a:lnTo>
                  <a:close/>
                </a:path>
                <a:path w="4132579" h="349884">
                  <a:moveTo>
                    <a:pt x="1403731" y="190754"/>
                  </a:moveTo>
                  <a:lnTo>
                    <a:pt x="1393317" y="190754"/>
                  </a:lnTo>
                  <a:lnTo>
                    <a:pt x="1393317" y="349631"/>
                  </a:lnTo>
                  <a:lnTo>
                    <a:pt x="1403731" y="349631"/>
                  </a:lnTo>
                  <a:lnTo>
                    <a:pt x="1403731" y="190754"/>
                  </a:lnTo>
                  <a:close/>
                </a:path>
                <a:path w="4132579" h="349884">
                  <a:moveTo>
                    <a:pt x="1461770" y="190754"/>
                  </a:moveTo>
                  <a:lnTo>
                    <a:pt x="1451356" y="190754"/>
                  </a:lnTo>
                  <a:lnTo>
                    <a:pt x="1451356" y="349631"/>
                  </a:lnTo>
                  <a:lnTo>
                    <a:pt x="1461770" y="349631"/>
                  </a:lnTo>
                  <a:lnTo>
                    <a:pt x="1461770" y="190754"/>
                  </a:lnTo>
                  <a:close/>
                </a:path>
                <a:path w="4132579" h="349884">
                  <a:moveTo>
                    <a:pt x="1519809" y="254254"/>
                  </a:moveTo>
                  <a:lnTo>
                    <a:pt x="1509395" y="254254"/>
                  </a:lnTo>
                  <a:lnTo>
                    <a:pt x="1509395" y="349631"/>
                  </a:lnTo>
                  <a:lnTo>
                    <a:pt x="1519809" y="349631"/>
                  </a:lnTo>
                  <a:lnTo>
                    <a:pt x="1519809" y="254254"/>
                  </a:lnTo>
                  <a:close/>
                </a:path>
                <a:path w="4132579" h="349884">
                  <a:moveTo>
                    <a:pt x="1577848" y="190754"/>
                  </a:moveTo>
                  <a:lnTo>
                    <a:pt x="1567434" y="190754"/>
                  </a:lnTo>
                  <a:lnTo>
                    <a:pt x="1567434" y="349631"/>
                  </a:lnTo>
                  <a:lnTo>
                    <a:pt x="1577848" y="349631"/>
                  </a:lnTo>
                  <a:lnTo>
                    <a:pt x="1577848" y="190754"/>
                  </a:lnTo>
                  <a:close/>
                </a:path>
                <a:path w="4132579" h="349884">
                  <a:moveTo>
                    <a:pt x="1635887" y="190754"/>
                  </a:moveTo>
                  <a:lnTo>
                    <a:pt x="1625473" y="190754"/>
                  </a:lnTo>
                  <a:lnTo>
                    <a:pt x="1625473" y="349631"/>
                  </a:lnTo>
                  <a:lnTo>
                    <a:pt x="1635887" y="349631"/>
                  </a:lnTo>
                  <a:lnTo>
                    <a:pt x="1635887" y="190754"/>
                  </a:lnTo>
                  <a:close/>
                </a:path>
                <a:path w="4132579" h="349884">
                  <a:moveTo>
                    <a:pt x="1693926" y="222504"/>
                  </a:moveTo>
                  <a:lnTo>
                    <a:pt x="1683512" y="222504"/>
                  </a:lnTo>
                  <a:lnTo>
                    <a:pt x="1683512" y="349631"/>
                  </a:lnTo>
                  <a:lnTo>
                    <a:pt x="1693926" y="349631"/>
                  </a:lnTo>
                  <a:lnTo>
                    <a:pt x="1693926" y="222504"/>
                  </a:lnTo>
                  <a:close/>
                </a:path>
                <a:path w="4132579" h="349884">
                  <a:moveTo>
                    <a:pt x="1751965" y="190754"/>
                  </a:moveTo>
                  <a:lnTo>
                    <a:pt x="1741551" y="190754"/>
                  </a:lnTo>
                  <a:lnTo>
                    <a:pt x="1741551" y="349631"/>
                  </a:lnTo>
                  <a:lnTo>
                    <a:pt x="1751965" y="349631"/>
                  </a:lnTo>
                  <a:lnTo>
                    <a:pt x="1751965" y="190754"/>
                  </a:lnTo>
                  <a:close/>
                </a:path>
                <a:path w="4132579" h="349884">
                  <a:moveTo>
                    <a:pt x="1810131" y="190754"/>
                  </a:moveTo>
                  <a:lnTo>
                    <a:pt x="1799717" y="190754"/>
                  </a:lnTo>
                  <a:lnTo>
                    <a:pt x="1799717" y="349631"/>
                  </a:lnTo>
                  <a:lnTo>
                    <a:pt x="1810131" y="349631"/>
                  </a:lnTo>
                  <a:lnTo>
                    <a:pt x="1810131" y="190754"/>
                  </a:lnTo>
                  <a:close/>
                </a:path>
                <a:path w="4132579" h="349884">
                  <a:moveTo>
                    <a:pt x="1868170" y="127127"/>
                  </a:moveTo>
                  <a:lnTo>
                    <a:pt x="1857756" y="127127"/>
                  </a:lnTo>
                  <a:lnTo>
                    <a:pt x="1857756" y="349631"/>
                  </a:lnTo>
                  <a:lnTo>
                    <a:pt x="1868170" y="349631"/>
                  </a:lnTo>
                  <a:lnTo>
                    <a:pt x="1868170" y="127127"/>
                  </a:lnTo>
                  <a:close/>
                </a:path>
                <a:path w="4132579" h="349884">
                  <a:moveTo>
                    <a:pt x="1926209" y="190754"/>
                  </a:moveTo>
                  <a:lnTo>
                    <a:pt x="1915795" y="190754"/>
                  </a:lnTo>
                  <a:lnTo>
                    <a:pt x="1915795" y="349631"/>
                  </a:lnTo>
                  <a:lnTo>
                    <a:pt x="1926209" y="349631"/>
                  </a:lnTo>
                  <a:lnTo>
                    <a:pt x="1926209" y="190754"/>
                  </a:lnTo>
                  <a:close/>
                </a:path>
                <a:path w="4132579" h="349884">
                  <a:moveTo>
                    <a:pt x="1984248" y="190754"/>
                  </a:moveTo>
                  <a:lnTo>
                    <a:pt x="1973834" y="190754"/>
                  </a:lnTo>
                  <a:lnTo>
                    <a:pt x="1973834" y="349631"/>
                  </a:lnTo>
                  <a:lnTo>
                    <a:pt x="1984248" y="349631"/>
                  </a:lnTo>
                  <a:lnTo>
                    <a:pt x="1984248" y="190754"/>
                  </a:lnTo>
                  <a:close/>
                </a:path>
                <a:path w="4132579" h="349884">
                  <a:moveTo>
                    <a:pt x="2042287" y="286004"/>
                  </a:moveTo>
                  <a:lnTo>
                    <a:pt x="2031873" y="286004"/>
                  </a:lnTo>
                  <a:lnTo>
                    <a:pt x="2031873" y="349631"/>
                  </a:lnTo>
                  <a:lnTo>
                    <a:pt x="2042287" y="349631"/>
                  </a:lnTo>
                  <a:lnTo>
                    <a:pt x="2042287" y="286004"/>
                  </a:lnTo>
                  <a:close/>
                </a:path>
                <a:path w="4132579" h="349884">
                  <a:moveTo>
                    <a:pt x="2100326" y="95377"/>
                  </a:moveTo>
                  <a:lnTo>
                    <a:pt x="2089912" y="95377"/>
                  </a:lnTo>
                  <a:lnTo>
                    <a:pt x="2089912" y="349631"/>
                  </a:lnTo>
                  <a:lnTo>
                    <a:pt x="2100326" y="349631"/>
                  </a:lnTo>
                  <a:lnTo>
                    <a:pt x="2100326" y="95377"/>
                  </a:lnTo>
                  <a:close/>
                </a:path>
                <a:path w="4132579" h="349884">
                  <a:moveTo>
                    <a:pt x="2158365" y="286004"/>
                  </a:moveTo>
                  <a:lnTo>
                    <a:pt x="2147951" y="286004"/>
                  </a:lnTo>
                  <a:lnTo>
                    <a:pt x="2147951" y="349631"/>
                  </a:lnTo>
                  <a:lnTo>
                    <a:pt x="2158365" y="349631"/>
                  </a:lnTo>
                  <a:lnTo>
                    <a:pt x="2158365" y="286004"/>
                  </a:lnTo>
                  <a:close/>
                </a:path>
                <a:path w="4132579" h="349884">
                  <a:moveTo>
                    <a:pt x="2216404" y="190754"/>
                  </a:moveTo>
                  <a:lnTo>
                    <a:pt x="2205990" y="190754"/>
                  </a:lnTo>
                  <a:lnTo>
                    <a:pt x="2205990" y="349631"/>
                  </a:lnTo>
                  <a:lnTo>
                    <a:pt x="2216404" y="349631"/>
                  </a:lnTo>
                  <a:lnTo>
                    <a:pt x="2216404" y="190754"/>
                  </a:lnTo>
                  <a:close/>
                </a:path>
                <a:path w="4132579" h="349884">
                  <a:moveTo>
                    <a:pt x="2274443" y="222504"/>
                  </a:moveTo>
                  <a:lnTo>
                    <a:pt x="2264029" y="222504"/>
                  </a:lnTo>
                  <a:lnTo>
                    <a:pt x="2264029" y="349631"/>
                  </a:lnTo>
                  <a:lnTo>
                    <a:pt x="2274443" y="349631"/>
                  </a:lnTo>
                  <a:lnTo>
                    <a:pt x="2274443" y="222504"/>
                  </a:lnTo>
                  <a:close/>
                </a:path>
                <a:path w="4132579" h="349884">
                  <a:moveTo>
                    <a:pt x="2332609" y="127127"/>
                  </a:moveTo>
                  <a:lnTo>
                    <a:pt x="2322195" y="127127"/>
                  </a:lnTo>
                  <a:lnTo>
                    <a:pt x="2322195" y="349631"/>
                  </a:lnTo>
                  <a:lnTo>
                    <a:pt x="2332609" y="349631"/>
                  </a:lnTo>
                  <a:lnTo>
                    <a:pt x="2332609" y="127127"/>
                  </a:lnTo>
                  <a:close/>
                </a:path>
                <a:path w="4132579" h="349884">
                  <a:moveTo>
                    <a:pt x="2390648" y="95377"/>
                  </a:moveTo>
                  <a:lnTo>
                    <a:pt x="2380234" y="95377"/>
                  </a:lnTo>
                  <a:lnTo>
                    <a:pt x="2380234" y="349631"/>
                  </a:lnTo>
                  <a:lnTo>
                    <a:pt x="2390648" y="349631"/>
                  </a:lnTo>
                  <a:lnTo>
                    <a:pt x="2390648" y="95377"/>
                  </a:lnTo>
                  <a:close/>
                </a:path>
                <a:path w="4132579" h="349884">
                  <a:moveTo>
                    <a:pt x="2448687" y="254254"/>
                  </a:moveTo>
                  <a:lnTo>
                    <a:pt x="2438273" y="254254"/>
                  </a:lnTo>
                  <a:lnTo>
                    <a:pt x="2438273" y="349631"/>
                  </a:lnTo>
                  <a:lnTo>
                    <a:pt x="2448687" y="349631"/>
                  </a:lnTo>
                  <a:lnTo>
                    <a:pt x="2448687" y="254254"/>
                  </a:lnTo>
                  <a:close/>
                </a:path>
                <a:path w="4132579" h="349884">
                  <a:moveTo>
                    <a:pt x="2506726" y="254254"/>
                  </a:moveTo>
                  <a:lnTo>
                    <a:pt x="2496312" y="254254"/>
                  </a:lnTo>
                  <a:lnTo>
                    <a:pt x="2496312" y="349631"/>
                  </a:lnTo>
                  <a:lnTo>
                    <a:pt x="2506726" y="349631"/>
                  </a:lnTo>
                  <a:lnTo>
                    <a:pt x="2506726" y="254254"/>
                  </a:lnTo>
                  <a:close/>
                </a:path>
                <a:path w="4132579" h="349884">
                  <a:moveTo>
                    <a:pt x="2564765" y="286004"/>
                  </a:moveTo>
                  <a:lnTo>
                    <a:pt x="2554351" y="286004"/>
                  </a:lnTo>
                  <a:lnTo>
                    <a:pt x="2554351" y="349631"/>
                  </a:lnTo>
                  <a:lnTo>
                    <a:pt x="2564765" y="349631"/>
                  </a:lnTo>
                  <a:lnTo>
                    <a:pt x="2564765" y="286004"/>
                  </a:lnTo>
                  <a:close/>
                </a:path>
                <a:path w="4132579" h="349884">
                  <a:moveTo>
                    <a:pt x="2622804" y="222504"/>
                  </a:moveTo>
                  <a:lnTo>
                    <a:pt x="2612390" y="222504"/>
                  </a:lnTo>
                  <a:lnTo>
                    <a:pt x="2612390" y="349631"/>
                  </a:lnTo>
                  <a:lnTo>
                    <a:pt x="2622804" y="349631"/>
                  </a:lnTo>
                  <a:lnTo>
                    <a:pt x="2622804" y="222504"/>
                  </a:lnTo>
                  <a:close/>
                </a:path>
                <a:path w="4132579" h="349884">
                  <a:moveTo>
                    <a:pt x="2680843" y="190754"/>
                  </a:moveTo>
                  <a:lnTo>
                    <a:pt x="2670429" y="190754"/>
                  </a:lnTo>
                  <a:lnTo>
                    <a:pt x="2670429" y="349631"/>
                  </a:lnTo>
                  <a:lnTo>
                    <a:pt x="2680843" y="349631"/>
                  </a:lnTo>
                  <a:lnTo>
                    <a:pt x="2680843" y="190754"/>
                  </a:lnTo>
                  <a:close/>
                </a:path>
                <a:path w="4132579" h="349884">
                  <a:moveTo>
                    <a:pt x="2738882" y="190754"/>
                  </a:moveTo>
                  <a:lnTo>
                    <a:pt x="2728468" y="190754"/>
                  </a:lnTo>
                  <a:lnTo>
                    <a:pt x="2728468" y="349631"/>
                  </a:lnTo>
                  <a:lnTo>
                    <a:pt x="2738882" y="349631"/>
                  </a:lnTo>
                  <a:lnTo>
                    <a:pt x="2738882" y="190754"/>
                  </a:lnTo>
                  <a:close/>
                </a:path>
                <a:path w="4132579" h="349884">
                  <a:moveTo>
                    <a:pt x="2854960" y="222504"/>
                  </a:moveTo>
                  <a:lnTo>
                    <a:pt x="2844546" y="222504"/>
                  </a:lnTo>
                  <a:lnTo>
                    <a:pt x="2844546" y="349631"/>
                  </a:lnTo>
                  <a:lnTo>
                    <a:pt x="2854960" y="349631"/>
                  </a:lnTo>
                  <a:lnTo>
                    <a:pt x="2854960" y="222504"/>
                  </a:lnTo>
                  <a:close/>
                </a:path>
                <a:path w="4132579" h="349884">
                  <a:moveTo>
                    <a:pt x="2913126" y="190754"/>
                  </a:moveTo>
                  <a:lnTo>
                    <a:pt x="2902712" y="190754"/>
                  </a:lnTo>
                  <a:lnTo>
                    <a:pt x="2902712" y="349631"/>
                  </a:lnTo>
                  <a:lnTo>
                    <a:pt x="2913126" y="349631"/>
                  </a:lnTo>
                  <a:lnTo>
                    <a:pt x="2913126" y="190754"/>
                  </a:lnTo>
                  <a:close/>
                </a:path>
                <a:path w="4132579" h="349884">
                  <a:moveTo>
                    <a:pt x="2971165" y="127127"/>
                  </a:moveTo>
                  <a:lnTo>
                    <a:pt x="2960751" y="127127"/>
                  </a:lnTo>
                  <a:lnTo>
                    <a:pt x="2960751" y="349631"/>
                  </a:lnTo>
                  <a:lnTo>
                    <a:pt x="2971165" y="349631"/>
                  </a:lnTo>
                  <a:lnTo>
                    <a:pt x="2971165" y="127127"/>
                  </a:lnTo>
                  <a:close/>
                </a:path>
                <a:path w="4132579" h="349884">
                  <a:moveTo>
                    <a:pt x="3029204" y="158877"/>
                  </a:moveTo>
                  <a:lnTo>
                    <a:pt x="3018790" y="158877"/>
                  </a:lnTo>
                  <a:lnTo>
                    <a:pt x="3018790" y="349631"/>
                  </a:lnTo>
                  <a:lnTo>
                    <a:pt x="3029204" y="349631"/>
                  </a:lnTo>
                  <a:lnTo>
                    <a:pt x="3029204" y="158877"/>
                  </a:lnTo>
                  <a:close/>
                </a:path>
                <a:path w="4132579" h="349884">
                  <a:moveTo>
                    <a:pt x="3087243" y="286004"/>
                  </a:moveTo>
                  <a:lnTo>
                    <a:pt x="3076829" y="286004"/>
                  </a:lnTo>
                  <a:lnTo>
                    <a:pt x="3076829" y="349631"/>
                  </a:lnTo>
                  <a:lnTo>
                    <a:pt x="3087243" y="349631"/>
                  </a:lnTo>
                  <a:lnTo>
                    <a:pt x="3087243" y="286004"/>
                  </a:lnTo>
                  <a:close/>
                </a:path>
                <a:path w="4132579" h="349884">
                  <a:moveTo>
                    <a:pt x="3145282" y="317881"/>
                  </a:moveTo>
                  <a:lnTo>
                    <a:pt x="3134868" y="317881"/>
                  </a:lnTo>
                  <a:lnTo>
                    <a:pt x="3134868" y="349631"/>
                  </a:lnTo>
                  <a:lnTo>
                    <a:pt x="3145282" y="349631"/>
                  </a:lnTo>
                  <a:lnTo>
                    <a:pt x="3145282" y="317881"/>
                  </a:lnTo>
                  <a:close/>
                </a:path>
                <a:path w="4132579" h="349884">
                  <a:moveTo>
                    <a:pt x="3203321" y="286004"/>
                  </a:moveTo>
                  <a:lnTo>
                    <a:pt x="3192907" y="286004"/>
                  </a:lnTo>
                  <a:lnTo>
                    <a:pt x="3192907" y="349631"/>
                  </a:lnTo>
                  <a:lnTo>
                    <a:pt x="3203321" y="349631"/>
                  </a:lnTo>
                  <a:lnTo>
                    <a:pt x="3203321" y="286004"/>
                  </a:lnTo>
                  <a:close/>
                </a:path>
                <a:path w="4132579" h="349884">
                  <a:moveTo>
                    <a:pt x="3261360" y="317881"/>
                  </a:moveTo>
                  <a:lnTo>
                    <a:pt x="3250946" y="317881"/>
                  </a:lnTo>
                  <a:lnTo>
                    <a:pt x="3250946" y="349631"/>
                  </a:lnTo>
                  <a:lnTo>
                    <a:pt x="3261360" y="349631"/>
                  </a:lnTo>
                  <a:lnTo>
                    <a:pt x="3261360" y="317881"/>
                  </a:lnTo>
                  <a:close/>
                </a:path>
                <a:path w="4132579" h="349884">
                  <a:moveTo>
                    <a:pt x="3319399" y="63627"/>
                  </a:moveTo>
                  <a:lnTo>
                    <a:pt x="3308985" y="63627"/>
                  </a:lnTo>
                  <a:lnTo>
                    <a:pt x="3308985" y="349631"/>
                  </a:lnTo>
                  <a:lnTo>
                    <a:pt x="3319399" y="349631"/>
                  </a:lnTo>
                  <a:lnTo>
                    <a:pt x="3319399" y="63627"/>
                  </a:lnTo>
                  <a:close/>
                </a:path>
                <a:path w="4132579" h="349884">
                  <a:moveTo>
                    <a:pt x="3377438" y="254254"/>
                  </a:moveTo>
                  <a:lnTo>
                    <a:pt x="3367024" y="254254"/>
                  </a:lnTo>
                  <a:lnTo>
                    <a:pt x="3367024" y="349631"/>
                  </a:lnTo>
                  <a:lnTo>
                    <a:pt x="3377438" y="349631"/>
                  </a:lnTo>
                  <a:lnTo>
                    <a:pt x="3377438" y="254254"/>
                  </a:lnTo>
                  <a:close/>
                </a:path>
                <a:path w="4132579" h="349884">
                  <a:moveTo>
                    <a:pt x="3435604" y="158877"/>
                  </a:moveTo>
                  <a:lnTo>
                    <a:pt x="3425190" y="158877"/>
                  </a:lnTo>
                  <a:lnTo>
                    <a:pt x="3425190" y="349631"/>
                  </a:lnTo>
                  <a:lnTo>
                    <a:pt x="3435604" y="349631"/>
                  </a:lnTo>
                  <a:lnTo>
                    <a:pt x="3435604" y="158877"/>
                  </a:lnTo>
                  <a:close/>
                </a:path>
                <a:path w="4132579" h="349884">
                  <a:moveTo>
                    <a:pt x="3493643" y="190754"/>
                  </a:moveTo>
                  <a:lnTo>
                    <a:pt x="3483229" y="190754"/>
                  </a:lnTo>
                  <a:lnTo>
                    <a:pt x="3483229" y="349631"/>
                  </a:lnTo>
                  <a:lnTo>
                    <a:pt x="3493643" y="349631"/>
                  </a:lnTo>
                  <a:lnTo>
                    <a:pt x="3493643" y="190754"/>
                  </a:lnTo>
                  <a:close/>
                </a:path>
                <a:path w="4132579" h="349884">
                  <a:moveTo>
                    <a:pt x="3551682" y="254254"/>
                  </a:moveTo>
                  <a:lnTo>
                    <a:pt x="3541268" y="254254"/>
                  </a:lnTo>
                  <a:lnTo>
                    <a:pt x="3541268" y="349631"/>
                  </a:lnTo>
                  <a:lnTo>
                    <a:pt x="3551682" y="349631"/>
                  </a:lnTo>
                  <a:lnTo>
                    <a:pt x="3551682" y="254254"/>
                  </a:lnTo>
                  <a:close/>
                </a:path>
                <a:path w="4132579" h="349884">
                  <a:moveTo>
                    <a:pt x="3609721" y="222504"/>
                  </a:moveTo>
                  <a:lnTo>
                    <a:pt x="3599307" y="222504"/>
                  </a:lnTo>
                  <a:lnTo>
                    <a:pt x="3599307" y="349631"/>
                  </a:lnTo>
                  <a:lnTo>
                    <a:pt x="3609721" y="349631"/>
                  </a:lnTo>
                  <a:lnTo>
                    <a:pt x="3609721" y="222504"/>
                  </a:lnTo>
                  <a:close/>
                </a:path>
                <a:path w="4132579" h="349884">
                  <a:moveTo>
                    <a:pt x="3667760" y="95377"/>
                  </a:moveTo>
                  <a:lnTo>
                    <a:pt x="3657346" y="95377"/>
                  </a:lnTo>
                  <a:lnTo>
                    <a:pt x="3657346" y="349631"/>
                  </a:lnTo>
                  <a:lnTo>
                    <a:pt x="3667760" y="349631"/>
                  </a:lnTo>
                  <a:lnTo>
                    <a:pt x="3667760" y="95377"/>
                  </a:lnTo>
                  <a:close/>
                </a:path>
                <a:path w="4132579" h="349884">
                  <a:moveTo>
                    <a:pt x="3725799" y="286004"/>
                  </a:moveTo>
                  <a:lnTo>
                    <a:pt x="3715385" y="286004"/>
                  </a:lnTo>
                  <a:lnTo>
                    <a:pt x="3715385" y="349631"/>
                  </a:lnTo>
                  <a:lnTo>
                    <a:pt x="3725799" y="349631"/>
                  </a:lnTo>
                  <a:lnTo>
                    <a:pt x="3725799" y="286004"/>
                  </a:lnTo>
                  <a:close/>
                </a:path>
                <a:path w="4132579" h="349884">
                  <a:moveTo>
                    <a:pt x="3783838" y="286004"/>
                  </a:moveTo>
                  <a:lnTo>
                    <a:pt x="3773424" y="286004"/>
                  </a:lnTo>
                  <a:lnTo>
                    <a:pt x="3773424" y="349631"/>
                  </a:lnTo>
                  <a:lnTo>
                    <a:pt x="3783838" y="349631"/>
                  </a:lnTo>
                  <a:lnTo>
                    <a:pt x="3783838" y="286004"/>
                  </a:lnTo>
                  <a:close/>
                </a:path>
                <a:path w="4132579" h="349884">
                  <a:moveTo>
                    <a:pt x="3841877" y="317881"/>
                  </a:moveTo>
                  <a:lnTo>
                    <a:pt x="3831463" y="317881"/>
                  </a:lnTo>
                  <a:lnTo>
                    <a:pt x="3831463" y="349631"/>
                  </a:lnTo>
                  <a:lnTo>
                    <a:pt x="3841877" y="349631"/>
                  </a:lnTo>
                  <a:lnTo>
                    <a:pt x="3841877" y="317881"/>
                  </a:lnTo>
                  <a:close/>
                </a:path>
                <a:path w="4132579" h="349884">
                  <a:moveTo>
                    <a:pt x="3899916" y="222504"/>
                  </a:moveTo>
                  <a:lnTo>
                    <a:pt x="3889502" y="222504"/>
                  </a:lnTo>
                  <a:lnTo>
                    <a:pt x="3889502" y="349631"/>
                  </a:lnTo>
                  <a:lnTo>
                    <a:pt x="3899916" y="349631"/>
                  </a:lnTo>
                  <a:lnTo>
                    <a:pt x="3899916" y="222504"/>
                  </a:lnTo>
                  <a:close/>
                </a:path>
                <a:path w="4132579" h="349884">
                  <a:moveTo>
                    <a:pt x="3957955" y="286004"/>
                  </a:moveTo>
                  <a:lnTo>
                    <a:pt x="3947541" y="286004"/>
                  </a:lnTo>
                  <a:lnTo>
                    <a:pt x="3947541" y="349631"/>
                  </a:lnTo>
                  <a:lnTo>
                    <a:pt x="3957955" y="349631"/>
                  </a:lnTo>
                  <a:lnTo>
                    <a:pt x="3957955" y="286004"/>
                  </a:lnTo>
                  <a:close/>
                </a:path>
                <a:path w="4132579" h="349884">
                  <a:moveTo>
                    <a:pt x="4016121" y="317881"/>
                  </a:moveTo>
                  <a:lnTo>
                    <a:pt x="4005707" y="317881"/>
                  </a:lnTo>
                  <a:lnTo>
                    <a:pt x="4005707" y="349631"/>
                  </a:lnTo>
                  <a:lnTo>
                    <a:pt x="4016121" y="349631"/>
                  </a:lnTo>
                  <a:lnTo>
                    <a:pt x="4016121" y="317881"/>
                  </a:lnTo>
                  <a:close/>
                </a:path>
                <a:path w="4132579" h="349884">
                  <a:moveTo>
                    <a:pt x="4074160" y="254254"/>
                  </a:moveTo>
                  <a:lnTo>
                    <a:pt x="4063746" y="254254"/>
                  </a:lnTo>
                  <a:lnTo>
                    <a:pt x="4063746" y="349631"/>
                  </a:lnTo>
                  <a:lnTo>
                    <a:pt x="4074160" y="349631"/>
                  </a:lnTo>
                  <a:lnTo>
                    <a:pt x="4074160" y="254254"/>
                  </a:lnTo>
                  <a:close/>
                </a:path>
                <a:path w="4132579" h="349884">
                  <a:moveTo>
                    <a:pt x="4132199" y="317881"/>
                  </a:moveTo>
                  <a:lnTo>
                    <a:pt x="4121785" y="317881"/>
                  </a:lnTo>
                  <a:lnTo>
                    <a:pt x="4121785" y="349631"/>
                  </a:lnTo>
                  <a:lnTo>
                    <a:pt x="4132199" y="349631"/>
                  </a:lnTo>
                  <a:lnTo>
                    <a:pt x="4132199" y="317881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5" name="object 125" descr=""/>
            <p:cNvSpPr/>
            <p:nvPr/>
          </p:nvSpPr>
          <p:spPr>
            <a:xfrm>
              <a:off x="9399524" y="8439912"/>
              <a:ext cx="1461770" cy="222885"/>
            </a:xfrm>
            <a:custGeom>
              <a:avLst/>
              <a:gdLst/>
              <a:ahLst/>
              <a:cxnLst/>
              <a:rect l="l" t="t" r="r" b="b"/>
              <a:pathLst>
                <a:path w="1461770" h="222884">
                  <a:moveTo>
                    <a:pt x="10414" y="190754"/>
                  </a:moveTo>
                  <a:lnTo>
                    <a:pt x="0" y="190754"/>
                  </a:lnTo>
                  <a:lnTo>
                    <a:pt x="0" y="222504"/>
                  </a:lnTo>
                  <a:lnTo>
                    <a:pt x="10414" y="222504"/>
                  </a:lnTo>
                  <a:lnTo>
                    <a:pt x="10414" y="190754"/>
                  </a:lnTo>
                  <a:close/>
                </a:path>
                <a:path w="1461770" h="222884">
                  <a:moveTo>
                    <a:pt x="68453" y="158877"/>
                  </a:moveTo>
                  <a:lnTo>
                    <a:pt x="58039" y="158877"/>
                  </a:lnTo>
                  <a:lnTo>
                    <a:pt x="58039" y="222504"/>
                  </a:lnTo>
                  <a:lnTo>
                    <a:pt x="68453" y="222504"/>
                  </a:lnTo>
                  <a:lnTo>
                    <a:pt x="68453" y="158877"/>
                  </a:lnTo>
                  <a:close/>
                </a:path>
                <a:path w="1461770" h="222884">
                  <a:moveTo>
                    <a:pt x="126492" y="95377"/>
                  </a:moveTo>
                  <a:lnTo>
                    <a:pt x="116078" y="95377"/>
                  </a:lnTo>
                  <a:lnTo>
                    <a:pt x="116078" y="222504"/>
                  </a:lnTo>
                  <a:lnTo>
                    <a:pt x="126492" y="222504"/>
                  </a:lnTo>
                  <a:lnTo>
                    <a:pt x="126492" y="95377"/>
                  </a:lnTo>
                  <a:close/>
                </a:path>
                <a:path w="1461770" h="222884">
                  <a:moveTo>
                    <a:pt x="184531" y="158877"/>
                  </a:moveTo>
                  <a:lnTo>
                    <a:pt x="174117" y="158877"/>
                  </a:lnTo>
                  <a:lnTo>
                    <a:pt x="174117" y="222504"/>
                  </a:lnTo>
                  <a:lnTo>
                    <a:pt x="184531" y="222504"/>
                  </a:lnTo>
                  <a:lnTo>
                    <a:pt x="184531" y="158877"/>
                  </a:lnTo>
                  <a:close/>
                </a:path>
                <a:path w="1461770" h="222884">
                  <a:moveTo>
                    <a:pt x="242570" y="127127"/>
                  </a:moveTo>
                  <a:lnTo>
                    <a:pt x="232156" y="127127"/>
                  </a:lnTo>
                  <a:lnTo>
                    <a:pt x="232156" y="222504"/>
                  </a:lnTo>
                  <a:lnTo>
                    <a:pt x="242570" y="222504"/>
                  </a:lnTo>
                  <a:lnTo>
                    <a:pt x="242570" y="127127"/>
                  </a:lnTo>
                  <a:close/>
                </a:path>
                <a:path w="1461770" h="222884">
                  <a:moveTo>
                    <a:pt x="300609" y="0"/>
                  </a:moveTo>
                  <a:lnTo>
                    <a:pt x="290195" y="0"/>
                  </a:lnTo>
                  <a:lnTo>
                    <a:pt x="290195" y="222504"/>
                  </a:lnTo>
                  <a:lnTo>
                    <a:pt x="300609" y="222504"/>
                  </a:lnTo>
                  <a:lnTo>
                    <a:pt x="300609" y="0"/>
                  </a:lnTo>
                  <a:close/>
                </a:path>
                <a:path w="1461770" h="222884">
                  <a:moveTo>
                    <a:pt x="358648" y="31750"/>
                  </a:moveTo>
                  <a:lnTo>
                    <a:pt x="348234" y="31750"/>
                  </a:lnTo>
                  <a:lnTo>
                    <a:pt x="348234" y="222504"/>
                  </a:lnTo>
                  <a:lnTo>
                    <a:pt x="358648" y="222504"/>
                  </a:lnTo>
                  <a:lnTo>
                    <a:pt x="358648" y="31750"/>
                  </a:lnTo>
                  <a:close/>
                </a:path>
                <a:path w="1461770" h="222884">
                  <a:moveTo>
                    <a:pt x="416814" y="63627"/>
                  </a:moveTo>
                  <a:lnTo>
                    <a:pt x="406400" y="63627"/>
                  </a:lnTo>
                  <a:lnTo>
                    <a:pt x="406400" y="222504"/>
                  </a:lnTo>
                  <a:lnTo>
                    <a:pt x="416814" y="222504"/>
                  </a:lnTo>
                  <a:lnTo>
                    <a:pt x="416814" y="63627"/>
                  </a:lnTo>
                  <a:close/>
                </a:path>
                <a:path w="1461770" h="222884">
                  <a:moveTo>
                    <a:pt x="474853" y="158877"/>
                  </a:moveTo>
                  <a:lnTo>
                    <a:pt x="464439" y="158877"/>
                  </a:lnTo>
                  <a:lnTo>
                    <a:pt x="464439" y="222504"/>
                  </a:lnTo>
                  <a:lnTo>
                    <a:pt x="474853" y="222504"/>
                  </a:lnTo>
                  <a:lnTo>
                    <a:pt x="474853" y="158877"/>
                  </a:lnTo>
                  <a:close/>
                </a:path>
                <a:path w="1461770" h="222884">
                  <a:moveTo>
                    <a:pt x="532892" y="127127"/>
                  </a:moveTo>
                  <a:lnTo>
                    <a:pt x="522478" y="127127"/>
                  </a:lnTo>
                  <a:lnTo>
                    <a:pt x="522478" y="222504"/>
                  </a:lnTo>
                  <a:lnTo>
                    <a:pt x="532892" y="222504"/>
                  </a:lnTo>
                  <a:lnTo>
                    <a:pt x="532892" y="127127"/>
                  </a:lnTo>
                  <a:close/>
                </a:path>
                <a:path w="1461770" h="222884">
                  <a:moveTo>
                    <a:pt x="590931" y="158877"/>
                  </a:moveTo>
                  <a:lnTo>
                    <a:pt x="580517" y="158877"/>
                  </a:lnTo>
                  <a:lnTo>
                    <a:pt x="580517" y="222504"/>
                  </a:lnTo>
                  <a:lnTo>
                    <a:pt x="590931" y="222504"/>
                  </a:lnTo>
                  <a:lnTo>
                    <a:pt x="590931" y="158877"/>
                  </a:lnTo>
                  <a:close/>
                </a:path>
                <a:path w="1461770" h="222884">
                  <a:moveTo>
                    <a:pt x="648970" y="158877"/>
                  </a:moveTo>
                  <a:lnTo>
                    <a:pt x="638556" y="158877"/>
                  </a:lnTo>
                  <a:lnTo>
                    <a:pt x="638556" y="222504"/>
                  </a:lnTo>
                  <a:lnTo>
                    <a:pt x="648970" y="222504"/>
                  </a:lnTo>
                  <a:lnTo>
                    <a:pt x="648970" y="158877"/>
                  </a:lnTo>
                  <a:close/>
                </a:path>
                <a:path w="1461770" h="222884">
                  <a:moveTo>
                    <a:pt x="717550" y="127127"/>
                  </a:moveTo>
                  <a:lnTo>
                    <a:pt x="704469" y="127127"/>
                  </a:lnTo>
                  <a:lnTo>
                    <a:pt x="704469" y="222504"/>
                  </a:lnTo>
                  <a:lnTo>
                    <a:pt x="717550" y="222504"/>
                  </a:lnTo>
                  <a:lnTo>
                    <a:pt x="717550" y="127127"/>
                  </a:lnTo>
                  <a:close/>
                </a:path>
                <a:path w="1461770" h="222884">
                  <a:moveTo>
                    <a:pt x="765048" y="190754"/>
                  </a:moveTo>
                  <a:lnTo>
                    <a:pt x="754634" y="190754"/>
                  </a:lnTo>
                  <a:lnTo>
                    <a:pt x="754634" y="222504"/>
                  </a:lnTo>
                  <a:lnTo>
                    <a:pt x="765048" y="222504"/>
                  </a:lnTo>
                  <a:lnTo>
                    <a:pt x="765048" y="190754"/>
                  </a:lnTo>
                  <a:close/>
                </a:path>
                <a:path w="1461770" h="222884">
                  <a:moveTo>
                    <a:pt x="823087" y="63627"/>
                  </a:moveTo>
                  <a:lnTo>
                    <a:pt x="812673" y="63627"/>
                  </a:lnTo>
                  <a:lnTo>
                    <a:pt x="812673" y="222504"/>
                  </a:lnTo>
                  <a:lnTo>
                    <a:pt x="823087" y="222504"/>
                  </a:lnTo>
                  <a:lnTo>
                    <a:pt x="823087" y="63627"/>
                  </a:lnTo>
                  <a:close/>
                </a:path>
                <a:path w="1461770" h="222884">
                  <a:moveTo>
                    <a:pt x="881126" y="95377"/>
                  </a:moveTo>
                  <a:lnTo>
                    <a:pt x="870712" y="95377"/>
                  </a:lnTo>
                  <a:lnTo>
                    <a:pt x="870712" y="222504"/>
                  </a:lnTo>
                  <a:lnTo>
                    <a:pt x="881126" y="222504"/>
                  </a:lnTo>
                  <a:lnTo>
                    <a:pt x="881126" y="95377"/>
                  </a:lnTo>
                  <a:close/>
                </a:path>
                <a:path w="1461770" h="222884">
                  <a:moveTo>
                    <a:pt x="939292" y="63627"/>
                  </a:moveTo>
                  <a:lnTo>
                    <a:pt x="928878" y="63627"/>
                  </a:lnTo>
                  <a:lnTo>
                    <a:pt x="928878" y="222504"/>
                  </a:lnTo>
                  <a:lnTo>
                    <a:pt x="939292" y="222504"/>
                  </a:lnTo>
                  <a:lnTo>
                    <a:pt x="939292" y="63627"/>
                  </a:lnTo>
                  <a:close/>
                </a:path>
                <a:path w="1461770" h="222884">
                  <a:moveTo>
                    <a:pt x="997331" y="158877"/>
                  </a:moveTo>
                  <a:lnTo>
                    <a:pt x="986917" y="158877"/>
                  </a:lnTo>
                  <a:lnTo>
                    <a:pt x="986917" y="222504"/>
                  </a:lnTo>
                  <a:lnTo>
                    <a:pt x="997331" y="222504"/>
                  </a:lnTo>
                  <a:lnTo>
                    <a:pt x="997331" y="158877"/>
                  </a:lnTo>
                  <a:close/>
                </a:path>
                <a:path w="1461770" h="222884">
                  <a:moveTo>
                    <a:pt x="1055370" y="190754"/>
                  </a:moveTo>
                  <a:lnTo>
                    <a:pt x="1044956" y="190754"/>
                  </a:lnTo>
                  <a:lnTo>
                    <a:pt x="1044956" y="222504"/>
                  </a:lnTo>
                  <a:lnTo>
                    <a:pt x="1055370" y="222504"/>
                  </a:lnTo>
                  <a:lnTo>
                    <a:pt x="1055370" y="190754"/>
                  </a:lnTo>
                  <a:close/>
                </a:path>
                <a:path w="1461770" h="222884">
                  <a:moveTo>
                    <a:pt x="1113409" y="31750"/>
                  </a:moveTo>
                  <a:lnTo>
                    <a:pt x="1102995" y="31750"/>
                  </a:lnTo>
                  <a:lnTo>
                    <a:pt x="1102995" y="222504"/>
                  </a:lnTo>
                  <a:lnTo>
                    <a:pt x="1113409" y="222504"/>
                  </a:lnTo>
                  <a:lnTo>
                    <a:pt x="1113409" y="31750"/>
                  </a:lnTo>
                  <a:close/>
                </a:path>
                <a:path w="1461770" h="222884">
                  <a:moveTo>
                    <a:pt x="1229487" y="190754"/>
                  </a:moveTo>
                  <a:lnTo>
                    <a:pt x="1219073" y="190754"/>
                  </a:lnTo>
                  <a:lnTo>
                    <a:pt x="1219073" y="222504"/>
                  </a:lnTo>
                  <a:lnTo>
                    <a:pt x="1229487" y="222504"/>
                  </a:lnTo>
                  <a:lnTo>
                    <a:pt x="1229487" y="190754"/>
                  </a:lnTo>
                  <a:close/>
                </a:path>
                <a:path w="1461770" h="222884">
                  <a:moveTo>
                    <a:pt x="1287526" y="127127"/>
                  </a:moveTo>
                  <a:lnTo>
                    <a:pt x="1277112" y="127127"/>
                  </a:lnTo>
                  <a:lnTo>
                    <a:pt x="1277112" y="222504"/>
                  </a:lnTo>
                  <a:lnTo>
                    <a:pt x="1287526" y="222504"/>
                  </a:lnTo>
                  <a:lnTo>
                    <a:pt x="1287526" y="127127"/>
                  </a:lnTo>
                  <a:close/>
                </a:path>
                <a:path w="1461770" h="222884">
                  <a:moveTo>
                    <a:pt x="1345565" y="158877"/>
                  </a:moveTo>
                  <a:lnTo>
                    <a:pt x="1335151" y="158877"/>
                  </a:lnTo>
                  <a:lnTo>
                    <a:pt x="1335151" y="222504"/>
                  </a:lnTo>
                  <a:lnTo>
                    <a:pt x="1345565" y="222504"/>
                  </a:lnTo>
                  <a:lnTo>
                    <a:pt x="1345565" y="158877"/>
                  </a:lnTo>
                  <a:close/>
                </a:path>
                <a:path w="1461770" h="222884">
                  <a:moveTo>
                    <a:pt x="1403604" y="127127"/>
                  </a:moveTo>
                  <a:lnTo>
                    <a:pt x="1393190" y="127127"/>
                  </a:lnTo>
                  <a:lnTo>
                    <a:pt x="1393190" y="222504"/>
                  </a:lnTo>
                  <a:lnTo>
                    <a:pt x="1403604" y="222504"/>
                  </a:lnTo>
                  <a:lnTo>
                    <a:pt x="1403604" y="127127"/>
                  </a:lnTo>
                  <a:close/>
                </a:path>
                <a:path w="1461770" h="222884">
                  <a:moveTo>
                    <a:pt x="1461643" y="190754"/>
                  </a:moveTo>
                  <a:lnTo>
                    <a:pt x="1451229" y="190754"/>
                  </a:lnTo>
                  <a:lnTo>
                    <a:pt x="1451229" y="222504"/>
                  </a:lnTo>
                  <a:lnTo>
                    <a:pt x="1461643" y="222504"/>
                  </a:lnTo>
                  <a:lnTo>
                    <a:pt x="1461643" y="190754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6" name="object 126" descr=""/>
            <p:cNvSpPr/>
            <p:nvPr/>
          </p:nvSpPr>
          <p:spPr>
            <a:xfrm>
              <a:off x="10908918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5" h="0">
                  <a:moveTo>
                    <a:pt x="0" y="0"/>
                  </a:moveTo>
                  <a:lnTo>
                    <a:pt x="10414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7" name="object 127" descr=""/>
            <p:cNvSpPr/>
            <p:nvPr/>
          </p:nvSpPr>
          <p:spPr>
            <a:xfrm>
              <a:off x="10966958" y="8471662"/>
              <a:ext cx="1403985" cy="191135"/>
            </a:xfrm>
            <a:custGeom>
              <a:avLst/>
              <a:gdLst/>
              <a:ahLst/>
              <a:cxnLst/>
              <a:rect l="l" t="t" r="r" b="b"/>
              <a:pathLst>
                <a:path w="1403984" h="191134">
                  <a:moveTo>
                    <a:pt x="10414" y="159004"/>
                  </a:moveTo>
                  <a:lnTo>
                    <a:pt x="0" y="159004"/>
                  </a:lnTo>
                  <a:lnTo>
                    <a:pt x="0" y="190754"/>
                  </a:lnTo>
                  <a:lnTo>
                    <a:pt x="10414" y="190754"/>
                  </a:lnTo>
                  <a:lnTo>
                    <a:pt x="10414" y="159004"/>
                  </a:lnTo>
                  <a:close/>
                </a:path>
                <a:path w="1403984" h="191134">
                  <a:moveTo>
                    <a:pt x="68453" y="95377"/>
                  </a:moveTo>
                  <a:lnTo>
                    <a:pt x="58039" y="95377"/>
                  </a:lnTo>
                  <a:lnTo>
                    <a:pt x="58039" y="190754"/>
                  </a:lnTo>
                  <a:lnTo>
                    <a:pt x="68453" y="190754"/>
                  </a:lnTo>
                  <a:lnTo>
                    <a:pt x="68453" y="95377"/>
                  </a:lnTo>
                  <a:close/>
                </a:path>
                <a:path w="1403984" h="191134">
                  <a:moveTo>
                    <a:pt x="126492" y="95377"/>
                  </a:moveTo>
                  <a:lnTo>
                    <a:pt x="116078" y="95377"/>
                  </a:lnTo>
                  <a:lnTo>
                    <a:pt x="116078" y="190754"/>
                  </a:lnTo>
                  <a:lnTo>
                    <a:pt x="126492" y="190754"/>
                  </a:lnTo>
                  <a:lnTo>
                    <a:pt x="126492" y="95377"/>
                  </a:lnTo>
                  <a:close/>
                </a:path>
                <a:path w="1403984" h="191134">
                  <a:moveTo>
                    <a:pt x="242570" y="63627"/>
                  </a:moveTo>
                  <a:lnTo>
                    <a:pt x="232156" y="63627"/>
                  </a:lnTo>
                  <a:lnTo>
                    <a:pt x="232156" y="190754"/>
                  </a:lnTo>
                  <a:lnTo>
                    <a:pt x="242570" y="190754"/>
                  </a:lnTo>
                  <a:lnTo>
                    <a:pt x="242570" y="63627"/>
                  </a:lnTo>
                  <a:close/>
                </a:path>
                <a:path w="1403984" h="191134">
                  <a:moveTo>
                    <a:pt x="300609" y="63627"/>
                  </a:moveTo>
                  <a:lnTo>
                    <a:pt x="290195" y="63627"/>
                  </a:lnTo>
                  <a:lnTo>
                    <a:pt x="290195" y="190754"/>
                  </a:lnTo>
                  <a:lnTo>
                    <a:pt x="300609" y="190754"/>
                  </a:lnTo>
                  <a:lnTo>
                    <a:pt x="300609" y="63627"/>
                  </a:lnTo>
                  <a:close/>
                </a:path>
                <a:path w="1403984" h="191134">
                  <a:moveTo>
                    <a:pt x="358648" y="95377"/>
                  </a:moveTo>
                  <a:lnTo>
                    <a:pt x="348234" y="95377"/>
                  </a:lnTo>
                  <a:lnTo>
                    <a:pt x="348234" y="190754"/>
                  </a:lnTo>
                  <a:lnTo>
                    <a:pt x="358648" y="190754"/>
                  </a:lnTo>
                  <a:lnTo>
                    <a:pt x="358648" y="95377"/>
                  </a:lnTo>
                  <a:close/>
                </a:path>
                <a:path w="1403984" h="191134">
                  <a:moveTo>
                    <a:pt x="416687" y="31877"/>
                  </a:moveTo>
                  <a:lnTo>
                    <a:pt x="406273" y="31877"/>
                  </a:lnTo>
                  <a:lnTo>
                    <a:pt x="406273" y="190754"/>
                  </a:lnTo>
                  <a:lnTo>
                    <a:pt x="416687" y="190754"/>
                  </a:lnTo>
                  <a:lnTo>
                    <a:pt x="416687" y="31877"/>
                  </a:lnTo>
                  <a:close/>
                </a:path>
                <a:path w="1403984" h="191134">
                  <a:moveTo>
                    <a:pt x="474853" y="0"/>
                  </a:moveTo>
                  <a:lnTo>
                    <a:pt x="464439" y="0"/>
                  </a:lnTo>
                  <a:lnTo>
                    <a:pt x="464439" y="190754"/>
                  </a:lnTo>
                  <a:lnTo>
                    <a:pt x="474853" y="190754"/>
                  </a:lnTo>
                  <a:lnTo>
                    <a:pt x="474853" y="0"/>
                  </a:lnTo>
                  <a:close/>
                </a:path>
                <a:path w="1403984" h="191134">
                  <a:moveTo>
                    <a:pt x="532892" y="127127"/>
                  </a:moveTo>
                  <a:lnTo>
                    <a:pt x="522478" y="127127"/>
                  </a:lnTo>
                  <a:lnTo>
                    <a:pt x="522478" y="190754"/>
                  </a:lnTo>
                  <a:lnTo>
                    <a:pt x="532892" y="190754"/>
                  </a:lnTo>
                  <a:lnTo>
                    <a:pt x="532892" y="127127"/>
                  </a:lnTo>
                  <a:close/>
                </a:path>
                <a:path w="1403984" h="191134">
                  <a:moveTo>
                    <a:pt x="590931" y="95377"/>
                  </a:moveTo>
                  <a:lnTo>
                    <a:pt x="580517" y="95377"/>
                  </a:lnTo>
                  <a:lnTo>
                    <a:pt x="580517" y="190754"/>
                  </a:lnTo>
                  <a:lnTo>
                    <a:pt x="590931" y="190754"/>
                  </a:lnTo>
                  <a:lnTo>
                    <a:pt x="590931" y="95377"/>
                  </a:lnTo>
                  <a:close/>
                </a:path>
                <a:path w="1403984" h="191134">
                  <a:moveTo>
                    <a:pt x="648970" y="127127"/>
                  </a:moveTo>
                  <a:lnTo>
                    <a:pt x="638556" y="127127"/>
                  </a:lnTo>
                  <a:lnTo>
                    <a:pt x="638556" y="190754"/>
                  </a:lnTo>
                  <a:lnTo>
                    <a:pt x="648970" y="190754"/>
                  </a:lnTo>
                  <a:lnTo>
                    <a:pt x="648970" y="127127"/>
                  </a:lnTo>
                  <a:close/>
                </a:path>
                <a:path w="1403984" h="191134">
                  <a:moveTo>
                    <a:pt x="707009" y="127127"/>
                  </a:moveTo>
                  <a:lnTo>
                    <a:pt x="696595" y="127127"/>
                  </a:lnTo>
                  <a:lnTo>
                    <a:pt x="696595" y="190754"/>
                  </a:lnTo>
                  <a:lnTo>
                    <a:pt x="707009" y="190754"/>
                  </a:lnTo>
                  <a:lnTo>
                    <a:pt x="707009" y="127127"/>
                  </a:lnTo>
                  <a:close/>
                </a:path>
                <a:path w="1403984" h="191134">
                  <a:moveTo>
                    <a:pt x="823087" y="159004"/>
                  </a:moveTo>
                  <a:lnTo>
                    <a:pt x="812673" y="159004"/>
                  </a:lnTo>
                  <a:lnTo>
                    <a:pt x="812673" y="190754"/>
                  </a:lnTo>
                  <a:lnTo>
                    <a:pt x="823087" y="190754"/>
                  </a:lnTo>
                  <a:lnTo>
                    <a:pt x="823087" y="159004"/>
                  </a:lnTo>
                  <a:close/>
                </a:path>
                <a:path w="1403984" h="191134">
                  <a:moveTo>
                    <a:pt x="881126" y="159004"/>
                  </a:moveTo>
                  <a:lnTo>
                    <a:pt x="870712" y="159004"/>
                  </a:lnTo>
                  <a:lnTo>
                    <a:pt x="870712" y="190754"/>
                  </a:lnTo>
                  <a:lnTo>
                    <a:pt x="881126" y="190754"/>
                  </a:lnTo>
                  <a:lnTo>
                    <a:pt x="881126" y="159004"/>
                  </a:lnTo>
                  <a:close/>
                </a:path>
                <a:path w="1403984" h="191134">
                  <a:moveTo>
                    <a:pt x="997331" y="95377"/>
                  </a:moveTo>
                  <a:lnTo>
                    <a:pt x="986917" y="95377"/>
                  </a:lnTo>
                  <a:lnTo>
                    <a:pt x="986917" y="190754"/>
                  </a:lnTo>
                  <a:lnTo>
                    <a:pt x="997331" y="190754"/>
                  </a:lnTo>
                  <a:lnTo>
                    <a:pt x="997331" y="95377"/>
                  </a:lnTo>
                  <a:close/>
                </a:path>
                <a:path w="1403984" h="191134">
                  <a:moveTo>
                    <a:pt x="1055370" y="127127"/>
                  </a:moveTo>
                  <a:lnTo>
                    <a:pt x="1044956" y="127127"/>
                  </a:lnTo>
                  <a:lnTo>
                    <a:pt x="1044956" y="190754"/>
                  </a:lnTo>
                  <a:lnTo>
                    <a:pt x="1055370" y="190754"/>
                  </a:lnTo>
                  <a:lnTo>
                    <a:pt x="1055370" y="127127"/>
                  </a:lnTo>
                  <a:close/>
                </a:path>
                <a:path w="1403984" h="191134">
                  <a:moveTo>
                    <a:pt x="1113409" y="127127"/>
                  </a:moveTo>
                  <a:lnTo>
                    <a:pt x="1102995" y="127127"/>
                  </a:lnTo>
                  <a:lnTo>
                    <a:pt x="1102995" y="190754"/>
                  </a:lnTo>
                  <a:lnTo>
                    <a:pt x="1113409" y="190754"/>
                  </a:lnTo>
                  <a:lnTo>
                    <a:pt x="1113409" y="127127"/>
                  </a:lnTo>
                  <a:close/>
                </a:path>
                <a:path w="1403984" h="191134">
                  <a:moveTo>
                    <a:pt x="1229487" y="159004"/>
                  </a:moveTo>
                  <a:lnTo>
                    <a:pt x="1219073" y="159004"/>
                  </a:lnTo>
                  <a:lnTo>
                    <a:pt x="1219073" y="190754"/>
                  </a:lnTo>
                  <a:lnTo>
                    <a:pt x="1229487" y="190754"/>
                  </a:lnTo>
                  <a:lnTo>
                    <a:pt x="1229487" y="159004"/>
                  </a:lnTo>
                  <a:close/>
                </a:path>
                <a:path w="1403984" h="191134">
                  <a:moveTo>
                    <a:pt x="1287526" y="127127"/>
                  </a:moveTo>
                  <a:lnTo>
                    <a:pt x="1277112" y="127127"/>
                  </a:lnTo>
                  <a:lnTo>
                    <a:pt x="1277112" y="190754"/>
                  </a:lnTo>
                  <a:lnTo>
                    <a:pt x="1287526" y="190754"/>
                  </a:lnTo>
                  <a:lnTo>
                    <a:pt x="1287526" y="127127"/>
                  </a:lnTo>
                  <a:close/>
                </a:path>
                <a:path w="1403984" h="191134">
                  <a:moveTo>
                    <a:pt x="1345565" y="127127"/>
                  </a:moveTo>
                  <a:lnTo>
                    <a:pt x="1335151" y="127127"/>
                  </a:lnTo>
                  <a:lnTo>
                    <a:pt x="1335151" y="190754"/>
                  </a:lnTo>
                  <a:lnTo>
                    <a:pt x="1345565" y="190754"/>
                  </a:lnTo>
                  <a:lnTo>
                    <a:pt x="1345565" y="127127"/>
                  </a:lnTo>
                  <a:close/>
                </a:path>
                <a:path w="1403984" h="191134">
                  <a:moveTo>
                    <a:pt x="1403604" y="159004"/>
                  </a:moveTo>
                  <a:lnTo>
                    <a:pt x="1393190" y="159004"/>
                  </a:lnTo>
                  <a:lnTo>
                    <a:pt x="1393190" y="190754"/>
                  </a:lnTo>
                  <a:lnTo>
                    <a:pt x="1403604" y="190754"/>
                  </a:lnTo>
                  <a:lnTo>
                    <a:pt x="1403604" y="159004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8" name="object 128" descr=""/>
            <p:cNvSpPr/>
            <p:nvPr/>
          </p:nvSpPr>
          <p:spPr>
            <a:xfrm>
              <a:off x="12418187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5" h="0">
                  <a:moveTo>
                    <a:pt x="0" y="0"/>
                  </a:moveTo>
                  <a:lnTo>
                    <a:pt x="10414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9" name="object 129" descr=""/>
            <p:cNvSpPr/>
            <p:nvPr/>
          </p:nvSpPr>
          <p:spPr>
            <a:xfrm>
              <a:off x="12476226" y="8503539"/>
              <a:ext cx="707390" cy="159385"/>
            </a:xfrm>
            <a:custGeom>
              <a:avLst/>
              <a:gdLst/>
              <a:ahLst/>
              <a:cxnLst/>
              <a:rect l="l" t="t" r="r" b="b"/>
              <a:pathLst>
                <a:path w="707390" h="159384">
                  <a:moveTo>
                    <a:pt x="10414" y="0"/>
                  </a:moveTo>
                  <a:lnTo>
                    <a:pt x="0" y="0"/>
                  </a:lnTo>
                  <a:lnTo>
                    <a:pt x="0" y="158877"/>
                  </a:lnTo>
                  <a:lnTo>
                    <a:pt x="10414" y="158877"/>
                  </a:lnTo>
                  <a:lnTo>
                    <a:pt x="10414" y="0"/>
                  </a:lnTo>
                  <a:close/>
                </a:path>
                <a:path w="707390" h="159384">
                  <a:moveTo>
                    <a:pt x="68580" y="63500"/>
                  </a:moveTo>
                  <a:lnTo>
                    <a:pt x="58166" y="63500"/>
                  </a:lnTo>
                  <a:lnTo>
                    <a:pt x="58166" y="158877"/>
                  </a:lnTo>
                  <a:lnTo>
                    <a:pt x="68580" y="158877"/>
                  </a:lnTo>
                  <a:lnTo>
                    <a:pt x="68580" y="63500"/>
                  </a:lnTo>
                  <a:close/>
                </a:path>
                <a:path w="707390" h="159384">
                  <a:moveTo>
                    <a:pt x="242697" y="63500"/>
                  </a:moveTo>
                  <a:lnTo>
                    <a:pt x="232283" y="63500"/>
                  </a:lnTo>
                  <a:lnTo>
                    <a:pt x="232283" y="158877"/>
                  </a:lnTo>
                  <a:lnTo>
                    <a:pt x="242697" y="158877"/>
                  </a:lnTo>
                  <a:lnTo>
                    <a:pt x="242697" y="63500"/>
                  </a:lnTo>
                  <a:close/>
                </a:path>
                <a:path w="707390" h="159384">
                  <a:moveTo>
                    <a:pt x="300736" y="127127"/>
                  </a:moveTo>
                  <a:lnTo>
                    <a:pt x="290322" y="127127"/>
                  </a:lnTo>
                  <a:lnTo>
                    <a:pt x="290322" y="158877"/>
                  </a:lnTo>
                  <a:lnTo>
                    <a:pt x="300736" y="158877"/>
                  </a:lnTo>
                  <a:lnTo>
                    <a:pt x="300736" y="127127"/>
                  </a:lnTo>
                  <a:close/>
                </a:path>
                <a:path w="707390" h="159384">
                  <a:moveTo>
                    <a:pt x="358775" y="127127"/>
                  </a:moveTo>
                  <a:lnTo>
                    <a:pt x="348361" y="127127"/>
                  </a:lnTo>
                  <a:lnTo>
                    <a:pt x="348361" y="158877"/>
                  </a:lnTo>
                  <a:lnTo>
                    <a:pt x="358775" y="158877"/>
                  </a:lnTo>
                  <a:lnTo>
                    <a:pt x="358775" y="127127"/>
                  </a:lnTo>
                  <a:close/>
                </a:path>
                <a:path w="707390" h="159384">
                  <a:moveTo>
                    <a:pt x="416814" y="127127"/>
                  </a:moveTo>
                  <a:lnTo>
                    <a:pt x="406400" y="127127"/>
                  </a:lnTo>
                  <a:lnTo>
                    <a:pt x="406400" y="158877"/>
                  </a:lnTo>
                  <a:lnTo>
                    <a:pt x="416814" y="158877"/>
                  </a:lnTo>
                  <a:lnTo>
                    <a:pt x="416814" y="127127"/>
                  </a:lnTo>
                  <a:close/>
                </a:path>
                <a:path w="707390" h="159384">
                  <a:moveTo>
                    <a:pt x="474853" y="127127"/>
                  </a:moveTo>
                  <a:lnTo>
                    <a:pt x="464439" y="127127"/>
                  </a:lnTo>
                  <a:lnTo>
                    <a:pt x="464439" y="158877"/>
                  </a:lnTo>
                  <a:lnTo>
                    <a:pt x="474853" y="158877"/>
                  </a:lnTo>
                  <a:lnTo>
                    <a:pt x="474853" y="127127"/>
                  </a:lnTo>
                  <a:close/>
                </a:path>
                <a:path w="707390" h="159384">
                  <a:moveTo>
                    <a:pt x="532879" y="95250"/>
                  </a:moveTo>
                  <a:lnTo>
                    <a:pt x="522478" y="95250"/>
                  </a:lnTo>
                  <a:lnTo>
                    <a:pt x="522478" y="158877"/>
                  </a:lnTo>
                  <a:lnTo>
                    <a:pt x="532879" y="158877"/>
                  </a:lnTo>
                  <a:lnTo>
                    <a:pt x="532879" y="95250"/>
                  </a:lnTo>
                  <a:close/>
                </a:path>
                <a:path w="707390" h="159384">
                  <a:moveTo>
                    <a:pt x="591045" y="95250"/>
                  </a:moveTo>
                  <a:lnTo>
                    <a:pt x="580631" y="95250"/>
                  </a:lnTo>
                  <a:lnTo>
                    <a:pt x="580631" y="158877"/>
                  </a:lnTo>
                  <a:lnTo>
                    <a:pt x="591045" y="158877"/>
                  </a:lnTo>
                  <a:lnTo>
                    <a:pt x="591045" y="95250"/>
                  </a:lnTo>
                  <a:close/>
                </a:path>
                <a:path w="707390" h="159384">
                  <a:moveTo>
                    <a:pt x="707136" y="127127"/>
                  </a:moveTo>
                  <a:lnTo>
                    <a:pt x="696722" y="127127"/>
                  </a:lnTo>
                  <a:lnTo>
                    <a:pt x="696722" y="158877"/>
                  </a:lnTo>
                  <a:lnTo>
                    <a:pt x="707136" y="158877"/>
                  </a:lnTo>
                  <a:lnTo>
                    <a:pt x="707136" y="127127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0" name="object 130" descr=""/>
            <p:cNvSpPr/>
            <p:nvPr/>
          </p:nvSpPr>
          <p:spPr>
            <a:xfrm>
              <a:off x="13238861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0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1" name="object 131" descr=""/>
            <p:cNvSpPr/>
            <p:nvPr/>
          </p:nvSpPr>
          <p:spPr>
            <a:xfrm>
              <a:off x="13292455" y="8567039"/>
              <a:ext cx="2107565" cy="95885"/>
            </a:xfrm>
            <a:custGeom>
              <a:avLst/>
              <a:gdLst/>
              <a:ahLst/>
              <a:cxnLst/>
              <a:rect l="l" t="t" r="r" b="b"/>
              <a:pathLst>
                <a:path w="2107565" h="95884">
                  <a:moveTo>
                    <a:pt x="17399" y="63627"/>
                  </a:moveTo>
                  <a:lnTo>
                    <a:pt x="0" y="63627"/>
                  </a:lnTo>
                  <a:lnTo>
                    <a:pt x="0" y="95377"/>
                  </a:lnTo>
                  <a:lnTo>
                    <a:pt x="17399" y="95377"/>
                  </a:lnTo>
                  <a:lnTo>
                    <a:pt x="17399" y="63627"/>
                  </a:lnTo>
                  <a:close/>
                </a:path>
                <a:path w="2107565" h="95884">
                  <a:moveTo>
                    <a:pt x="123063" y="63627"/>
                  </a:moveTo>
                  <a:lnTo>
                    <a:pt x="112649" y="63627"/>
                  </a:lnTo>
                  <a:lnTo>
                    <a:pt x="112649" y="95377"/>
                  </a:lnTo>
                  <a:lnTo>
                    <a:pt x="123063" y="95377"/>
                  </a:lnTo>
                  <a:lnTo>
                    <a:pt x="123063" y="63627"/>
                  </a:lnTo>
                  <a:close/>
                </a:path>
                <a:path w="2107565" h="95884">
                  <a:moveTo>
                    <a:pt x="181089" y="63627"/>
                  </a:moveTo>
                  <a:lnTo>
                    <a:pt x="170688" y="63627"/>
                  </a:lnTo>
                  <a:lnTo>
                    <a:pt x="170688" y="95377"/>
                  </a:lnTo>
                  <a:lnTo>
                    <a:pt x="181089" y="95377"/>
                  </a:lnTo>
                  <a:lnTo>
                    <a:pt x="181089" y="63627"/>
                  </a:lnTo>
                  <a:close/>
                </a:path>
                <a:path w="2107565" h="95884">
                  <a:moveTo>
                    <a:pt x="249682" y="63627"/>
                  </a:moveTo>
                  <a:lnTo>
                    <a:pt x="236601" y="63627"/>
                  </a:lnTo>
                  <a:lnTo>
                    <a:pt x="236601" y="95377"/>
                  </a:lnTo>
                  <a:lnTo>
                    <a:pt x="249682" y="95377"/>
                  </a:lnTo>
                  <a:lnTo>
                    <a:pt x="249682" y="63627"/>
                  </a:lnTo>
                  <a:close/>
                </a:path>
                <a:path w="2107565" h="95884">
                  <a:moveTo>
                    <a:pt x="307708" y="63627"/>
                  </a:moveTo>
                  <a:lnTo>
                    <a:pt x="294640" y="63627"/>
                  </a:lnTo>
                  <a:lnTo>
                    <a:pt x="294640" y="95377"/>
                  </a:lnTo>
                  <a:lnTo>
                    <a:pt x="307708" y="95377"/>
                  </a:lnTo>
                  <a:lnTo>
                    <a:pt x="307708" y="63627"/>
                  </a:lnTo>
                  <a:close/>
                </a:path>
                <a:path w="2107565" h="95884">
                  <a:moveTo>
                    <a:pt x="410845" y="63627"/>
                  </a:moveTo>
                  <a:lnTo>
                    <a:pt x="397764" y="63627"/>
                  </a:lnTo>
                  <a:lnTo>
                    <a:pt x="397764" y="95377"/>
                  </a:lnTo>
                  <a:lnTo>
                    <a:pt x="410845" y="95377"/>
                  </a:lnTo>
                  <a:lnTo>
                    <a:pt x="410845" y="63627"/>
                  </a:lnTo>
                  <a:close/>
                </a:path>
                <a:path w="2107565" h="95884">
                  <a:moveTo>
                    <a:pt x="540004" y="0"/>
                  </a:moveTo>
                  <a:lnTo>
                    <a:pt x="526923" y="0"/>
                  </a:lnTo>
                  <a:lnTo>
                    <a:pt x="526923" y="95377"/>
                  </a:lnTo>
                  <a:lnTo>
                    <a:pt x="540004" y="95377"/>
                  </a:lnTo>
                  <a:lnTo>
                    <a:pt x="540004" y="0"/>
                  </a:lnTo>
                  <a:close/>
                </a:path>
                <a:path w="2107565" h="95884">
                  <a:moveTo>
                    <a:pt x="587489" y="63627"/>
                  </a:moveTo>
                  <a:lnTo>
                    <a:pt x="577088" y="63627"/>
                  </a:lnTo>
                  <a:lnTo>
                    <a:pt x="577088" y="95377"/>
                  </a:lnTo>
                  <a:lnTo>
                    <a:pt x="587489" y="95377"/>
                  </a:lnTo>
                  <a:lnTo>
                    <a:pt x="587489" y="63627"/>
                  </a:lnTo>
                  <a:close/>
                </a:path>
                <a:path w="2107565" h="95884">
                  <a:moveTo>
                    <a:pt x="645541" y="63627"/>
                  </a:moveTo>
                  <a:lnTo>
                    <a:pt x="635127" y="63627"/>
                  </a:lnTo>
                  <a:lnTo>
                    <a:pt x="635127" y="95377"/>
                  </a:lnTo>
                  <a:lnTo>
                    <a:pt x="645541" y="95377"/>
                  </a:lnTo>
                  <a:lnTo>
                    <a:pt x="645541" y="63627"/>
                  </a:lnTo>
                  <a:close/>
                </a:path>
                <a:path w="2107565" h="95884">
                  <a:moveTo>
                    <a:pt x="703580" y="63627"/>
                  </a:moveTo>
                  <a:lnTo>
                    <a:pt x="693166" y="63627"/>
                  </a:lnTo>
                  <a:lnTo>
                    <a:pt x="693166" y="95377"/>
                  </a:lnTo>
                  <a:lnTo>
                    <a:pt x="703580" y="95377"/>
                  </a:lnTo>
                  <a:lnTo>
                    <a:pt x="703580" y="63627"/>
                  </a:lnTo>
                  <a:close/>
                </a:path>
                <a:path w="2107565" h="95884">
                  <a:moveTo>
                    <a:pt x="761619" y="63627"/>
                  </a:moveTo>
                  <a:lnTo>
                    <a:pt x="751205" y="63627"/>
                  </a:lnTo>
                  <a:lnTo>
                    <a:pt x="751205" y="95377"/>
                  </a:lnTo>
                  <a:lnTo>
                    <a:pt x="761619" y="95377"/>
                  </a:lnTo>
                  <a:lnTo>
                    <a:pt x="761619" y="63627"/>
                  </a:lnTo>
                  <a:close/>
                </a:path>
                <a:path w="2107565" h="95884">
                  <a:moveTo>
                    <a:pt x="819645" y="31750"/>
                  </a:moveTo>
                  <a:lnTo>
                    <a:pt x="809244" y="31750"/>
                  </a:lnTo>
                  <a:lnTo>
                    <a:pt x="809244" y="95377"/>
                  </a:lnTo>
                  <a:lnTo>
                    <a:pt x="819645" y="95377"/>
                  </a:lnTo>
                  <a:lnTo>
                    <a:pt x="819645" y="31750"/>
                  </a:lnTo>
                  <a:close/>
                </a:path>
                <a:path w="2107565" h="95884">
                  <a:moveTo>
                    <a:pt x="877824" y="63627"/>
                  </a:moveTo>
                  <a:lnTo>
                    <a:pt x="867410" y="63627"/>
                  </a:lnTo>
                  <a:lnTo>
                    <a:pt x="867410" y="95377"/>
                  </a:lnTo>
                  <a:lnTo>
                    <a:pt x="877824" y="95377"/>
                  </a:lnTo>
                  <a:lnTo>
                    <a:pt x="877824" y="63627"/>
                  </a:lnTo>
                  <a:close/>
                </a:path>
                <a:path w="2107565" h="95884">
                  <a:moveTo>
                    <a:pt x="935863" y="63627"/>
                  </a:moveTo>
                  <a:lnTo>
                    <a:pt x="925449" y="63627"/>
                  </a:lnTo>
                  <a:lnTo>
                    <a:pt x="925449" y="95377"/>
                  </a:lnTo>
                  <a:lnTo>
                    <a:pt x="935863" y="95377"/>
                  </a:lnTo>
                  <a:lnTo>
                    <a:pt x="935863" y="63627"/>
                  </a:lnTo>
                  <a:close/>
                </a:path>
                <a:path w="2107565" h="95884">
                  <a:moveTo>
                    <a:pt x="993889" y="63627"/>
                  </a:moveTo>
                  <a:lnTo>
                    <a:pt x="983488" y="63627"/>
                  </a:lnTo>
                  <a:lnTo>
                    <a:pt x="983488" y="95377"/>
                  </a:lnTo>
                  <a:lnTo>
                    <a:pt x="993889" y="95377"/>
                  </a:lnTo>
                  <a:lnTo>
                    <a:pt x="993889" y="63627"/>
                  </a:lnTo>
                  <a:close/>
                </a:path>
                <a:path w="2107565" h="95884">
                  <a:moveTo>
                    <a:pt x="1062482" y="63627"/>
                  </a:moveTo>
                  <a:lnTo>
                    <a:pt x="1049401" y="63627"/>
                  </a:lnTo>
                  <a:lnTo>
                    <a:pt x="1049401" y="95377"/>
                  </a:lnTo>
                  <a:lnTo>
                    <a:pt x="1062482" y="95377"/>
                  </a:lnTo>
                  <a:lnTo>
                    <a:pt x="1062482" y="63627"/>
                  </a:lnTo>
                  <a:close/>
                </a:path>
                <a:path w="2107565" h="95884">
                  <a:moveTo>
                    <a:pt x="1178560" y="63627"/>
                  </a:moveTo>
                  <a:lnTo>
                    <a:pt x="1165479" y="63627"/>
                  </a:lnTo>
                  <a:lnTo>
                    <a:pt x="1165479" y="95377"/>
                  </a:lnTo>
                  <a:lnTo>
                    <a:pt x="1178560" y="95377"/>
                  </a:lnTo>
                  <a:lnTo>
                    <a:pt x="1178560" y="63627"/>
                  </a:lnTo>
                  <a:close/>
                </a:path>
                <a:path w="2107565" h="95884">
                  <a:moveTo>
                    <a:pt x="1226045" y="63627"/>
                  </a:moveTo>
                  <a:lnTo>
                    <a:pt x="1215644" y="63627"/>
                  </a:lnTo>
                  <a:lnTo>
                    <a:pt x="1215644" y="95377"/>
                  </a:lnTo>
                  <a:lnTo>
                    <a:pt x="1226045" y="95377"/>
                  </a:lnTo>
                  <a:lnTo>
                    <a:pt x="1226045" y="63627"/>
                  </a:lnTo>
                  <a:close/>
                </a:path>
                <a:path w="2107565" h="95884">
                  <a:moveTo>
                    <a:pt x="1284097" y="0"/>
                  </a:moveTo>
                  <a:lnTo>
                    <a:pt x="1273683" y="0"/>
                  </a:lnTo>
                  <a:lnTo>
                    <a:pt x="1273683" y="95377"/>
                  </a:lnTo>
                  <a:lnTo>
                    <a:pt x="1284097" y="95377"/>
                  </a:lnTo>
                  <a:lnTo>
                    <a:pt x="1284097" y="0"/>
                  </a:lnTo>
                  <a:close/>
                </a:path>
                <a:path w="2107565" h="95884">
                  <a:moveTo>
                    <a:pt x="1458341" y="63627"/>
                  </a:moveTo>
                  <a:lnTo>
                    <a:pt x="1447927" y="63627"/>
                  </a:lnTo>
                  <a:lnTo>
                    <a:pt x="1447927" y="95377"/>
                  </a:lnTo>
                  <a:lnTo>
                    <a:pt x="1458341" y="95377"/>
                  </a:lnTo>
                  <a:lnTo>
                    <a:pt x="1458341" y="63627"/>
                  </a:lnTo>
                  <a:close/>
                </a:path>
                <a:path w="2107565" h="95884">
                  <a:moveTo>
                    <a:pt x="1526794" y="63627"/>
                  </a:moveTo>
                  <a:lnTo>
                    <a:pt x="1513713" y="63627"/>
                  </a:lnTo>
                  <a:lnTo>
                    <a:pt x="1513713" y="95377"/>
                  </a:lnTo>
                  <a:lnTo>
                    <a:pt x="1526794" y="95377"/>
                  </a:lnTo>
                  <a:lnTo>
                    <a:pt x="1526794" y="63627"/>
                  </a:lnTo>
                  <a:close/>
                </a:path>
                <a:path w="2107565" h="95884">
                  <a:moveTo>
                    <a:pt x="1574419" y="0"/>
                  </a:moveTo>
                  <a:lnTo>
                    <a:pt x="1564005" y="0"/>
                  </a:lnTo>
                  <a:lnTo>
                    <a:pt x="1564005" y="95377"/>
                  </a:lnTo>
                  <a:lnTo>
                    <a:pt x="1574419" y="95377"/>
                  </a:lnTo>
                  <a:lnTo>
                    <a:pt x="1574419" y="0"/>
                  </a:lnTo>
                  <a:close/>
                </a:path>
                <a:path w="2107565" h="95884">
                  <a:moveTo>
                    <a:pt x="1701038" y="63627"/>
                  </a:moveTo>
                  <a:lnTo>
                    <a:pt x="1687957" y="63627"/>
                  </a:lnTo>
                  <a:lnTo>
                    <a:pt x="1687957" y="95377"/>
                  </a:lnTo>
                  <a:lnTo>
                    <a:pt x="1701038" y="95377"/>
                  </a:lnTo>
                  <a:lnTo>
                    <a:pt x="1701038" y="63627"/>
                  </a:lnTo>
                  <a:close/>
                </a:path>
                <a:path w="2107565" h="95884">
                  <a:moveTo>
                    <a:pt x="1759077" y="63627"/>
                  </a:moveTo>
                  <a:lnTo>
                    <a:pt x="1745996" y="63627"/>
                  </a:lnTo>
                  <a:lnTo>
                    <a:pt x="1745996" y="95377"/>
                  </a:lnTo>
                  <a:lnTo>
                    <a:pt x="1759077" y="95377"/>
                  </a:lnTo>
                  <a:lnTo>
                    <a:pt x="1759077" y="63627"/>
                  </a:lnTo>
                  <a:close/>
                </a:path>
                <a:path w="2107565" h="95884">
                  <a:moveTo>
                    <a:pt x="1817103" y="31750"/>
                  </a:moveTo>
                  <a:lnTo>
                    <a:pt x="1799717" y="31750"/>
                  </a:lnTo>
                  <a:lnTo>
                    <a:pt x="1799717" y="95377"/>
                  </a:lnTo>
                  <a:lnTo>
                    <a:pt x="1817103" y="95377"/>
                  </a:lnTo>
                  <a:lnTo>
                    <a:pt x="1817103" y="31750"/>
                  </a:lnTo>
                  <a:close/>
                </a:path>
                <a:path w="2107565" h="95884">
                  <a:moveTo>
                    <a:pt x="1875155" y="63627"/>
                  </a:moveTo>
                  <a:lnTo>
                    <a:pt x="1862074" y="63627"/>
                  </a:lnTo>
                  <a:lnTo>
                    <a:pt x="1862074" y="95377"/>
                  </a:lnTo>
                  <a:lnTo>
                    <a:pt x="1875155" y="95377"/>
                  </a:lnTo>
                  <a:lnTo>
                    <a:pt x="1875155" y="63627"/>
                  </a:lnTo>
                  <a:close/>
                </a:path>
                <a:path w="2107565" h="95884">
                  <a:moveTo>
                    <a:pt x="1933194" y="31750"/>
                  </a:moveTo>
                  <a:lnTo>
                    <a:pt x="1920113" y="31750"/>
                  </a:lnTo>
                  <a:lnTo>
                    <a:pt x="1920113" y="95377"/>
                  </a:lnTo>
                  <a:lnTo>
                    <a:pt x="1933194" y="95377"/>
                  </a:lnTo>
                  <a:lnTo>
                    <a:pt x="1933194" y="31750"/>
                  </a:lnTo>
                  <a:close/>
                </a:path>
                <a:path w="2107565" h="95884">
                  <a:moveTo>
                    <a:pt x="2049272" y="63627"/>
                  </a:moveTo>
                  <a:lnTo>
                    <a:pt x="2036191" y="63627"/>
                  </a:lnTo>
                  <a:lnTo>
                    <a:pt x="2036191" y="95377"/>
                  </a:lnTo>
                  <a:lnTo>
                    <a:pt x="2049272" y="95377"/>
                  </a:lnTo>
                  <a:lnTo>
                    <a:pt x="2049272" y="63627"/>
                  </a:lnTo>
                  <a:close/>
                </a:path>
                <a:path w="2107565" h="95884">
                  <a:moveTo>
                    <a:pt x="2107438" y="63627"/>
                  </a:moveTo>
                  <a:lnTo>
                    <a:pt x="2094357" y="63627"/>
                  </a:lnTo>
                  <a:lnTo>
                    <a:pt x="2094357" y="95377"/>
                  </a:lnTo>
                  <a:lnTo>
                    <a:pt x="2107438" y="95377"/>
                  </a:lnTo>
                  <a:lnTo>
                    <a:pt x="2107438" y="63627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2" name="object 132" descr=""/>
            <p:cNvSpPr/>
            <p:nvPr/>
          </p:nvSpPr>
          <p:spPr>
            <a:xfrm>
              <a:off x="1163827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13081" y="0"/>
                  </a:moveTo>
                  <a:lnTo>
                    <a:pt x="0" y="0"/>
                  </a:lnTo>
                  <a:lnTo>
                    <a:pt x="13081" y="0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3" name="object 133" descr=""/>
            <p:cNvSpPr/>
            <p:nvPr/>
          </p:nvSpPr>
          <p:spPr>
            <a:xfrm>
              <a:off x="1163827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1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BCA7E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4" name="object 134" descr=""/>
            <p:cNvSpPr/>
            <p:nvPr/>
          </p:nvSpPr>
          <p:spPr>
            <a:xfrm>
              <a:off x="1221867" y="7867904"/>
              <a:ext cx="4077335" cy="795020"/>
            </a:xfrm>
            <a:custGeom>
              <a:avLst/>
              <a:gdLst/>
              <a:ahLst/>
              <a:cxnLst/>
              <a:rect l="l" t="t" r="r" b="b"/>
              <a:pathLst>
                <a:path w="4077335" h="795020">
                  <a:moveTo>
                    <a:pt x="13081" y="730885"/>
                  </a:moveTo>
                  <a:lnTo>
                    <a:pt x="0" y="730885"/>
                  </a:lnTo>
                  <a:lnTo>
                    <a:pt x="0" y="794512"/>
                  </a:lnTo>
                  <a:lnTo>
                    <a:pt x="13081" y="794512"/>
                  </a:lnTo>
                  <a:lnTo>
                    <a:pt x="13081" y="730885"/>
                  </a:lnTo>
                  <a:close/>
                </a:path>
                <a:path w="4077335" h="795020">
                  <a:moveTo>
                    <a:pt x="71247" y="730885"/>
                  </a:moveTo>
                  <a:lnTo>
                    <a:pt x="58166" y="730885"/>
                  </a:lnTo>
                  <a:lnTo>
                    <a:pt x="58166" y="794512"/>
                  </a:lnTo>
                  <a:lnTo>
                    <a:pt x="71247" y="794512"/>
                  </a:lnTo>
                  <a:lnTo>
                    <a:pt x="71247" y="730885"/>
                  </a:lnTo>
                  <a:close/>
                </a:path>
                <a:path w="4077335" h="795020">
                  <a:moveTo>
                    <a:pt x="129286" y="635635"/>
                  </a:moveTo>
                  <a:lnTo>
                    <a:pt x="116205" y="635635"/>
                  </a:lnTo>
                  <a:lnTo>
                    <a:pt x="116205" y="794512"/>
                  </a:lnTo>
                  <a:lnTo>
                    <a:pt x="129286" y="794512"/>
                  </a:lnTo>
                  <a:lnTo>
                    <a:pt x="129286" y="635635"/>
                  </a:lnTo>
                  <a:close/>
                </a:path>
                <a:path w="4077335" h="795020">
                  <a:moveTo>
                    <a:pt x="187325" y="699135"/>
                  </a:moveTo>
                  <a:lnTo>
                    <a:pt x="174244" y="699135"/>
                  </a:lnTo>
                  <a:lnTo>
                    <a:pt x="174244" y="794512"/>
                  </a:lnTo>
                  <a:lnTo>
                    <a:pt x="187325" y="794512"/>
                  </a:lnTo>
                  <a:lnTo>
                    <a:pt x="187325" y="699135"/>
                  </a:lnTo>
                  <a:close/>
                </a:path>
                <a:path w="4077335" h="795020">
                  <a:moveTo>
                    <a:pt x="245364" y="730885"/>
                  </a:moveTo>
                  <a:lnTo>
                    <a:pt x="232283" y="730885"/>
                  </a:lnTo>
                  <a:lnTo>
                    <a:pt x="232283" y="794512"/>
                  </a:lnTo>
                  <a:lnTo>
                    <a:pt x="245364" y="794512"/>
                  </a:lnTo>
                  <a:lnTo>
                    <a:pt x="245364" y="730885"/>
                  </a:lnTo>
                  <a:close/>
                </a:path>
                <a:path w="4077335" h="795020">
                  <a:moveTo>
                    <a:pt x="303403" y="508508"/>
                  </a:moveTo>
                  <a:lnTo>
                    <a:pt x="290322" y="508508"/>
                  </a:lnTo>
                  <a:lnTo>
                    <a:pt x="290322" y="794512"/>
                  </a:lnTo>
                  <a:lnTo>
                    <a:pt x="303403" y="794512"/>
                  </a:lnTo>
                  <a:lnTo>
                    <a:pt x="303403" y="508508"/>
                  </a:lnTo>
                  <a:close/>
                </a:path>
                <a:path w="4077335" h="795020">
                  <a:moveTo>
                    <a:pt x="361429" y="540258"/>
                  </a:moveTo>
                  <a:lnTo>
                    <a:pt x="351028" y="540258"/>
                  </a:lnTo>
                  <a:lnTo>
                    <a:pt x="351028" y="794512"/>
                  </a:lnTo>
                  <a:lnTo>
                    <a:pt x="361429" y="794512"/>
                  </a:lnTo>
                  <a:lnTo>
                    <a:pt x="361429" y="540258"/>
                  </a:lnTo>
                  <a:close/>
                </a:path>
                <a:path w="4077335" h="795020">
                  <a:moveTo>
                    <a:pt x="419481" y="476631"/>
                  </a:moveTo>
                  <a:lnTo>
                    <a:pt x="406400" y="476631"/>
                  </a:lnTo>
                  <a:lnTo>
                    <a:pt x="406400" y="794512"/>
                  </a:lnTo>
                  <a:lnTo>
                    <a:pt x="419481" y="794512"/>
                  </a:lnTo>
                  <a:lnTo>
                    <a:pt x="419481" y="476631"/>
                  </a:lnTo>
                  <a:close/>
                </a:path>
                <a:path w="4077335" h="795020">
                  <a:moveTo>
                    <a:pt x="477520" y="699135"/>
                  </a:moveTo>
                  <a:lnTo>
                    <a:pt x="467106" y="699135"/>
                  </a:lnTo>
                  <a:lnTo>
                    <a:pt x="467106" y="794512"/>
                  </a:lnTo>
                  <a:lnTo>
                    <a:pt x="477520" y="794512"/>
                  </a:lnTo>
                  <a:lnTo>
                    <a:pt x="477520" y="699135"/>
                  </a:lnTo>
                  <a:close/>
                </a:path>
                <a:path w="4077335" h="795020">
                  <a:moveTo>
                    <a:pt x="535559" y="635635"/>
                  </a:moveTo>
                  <a:lnTo>
                    <a:pt x="525145" y="635635"/>
                  </a:lnTo>
                  <a:lnTo>
                    <a:pt x="525145" y="794512"/>
                  </a:lnTo>
                  <a:lnTo>
                    <a:pt x="535559" y="794512"/>
                  </a:lnTo>
                  <a:lnTo>
                    <a:pt x="535559" y="635635"/>
                  </a:lnTo>
                  <a:close/>
                </a:path>
                <a:path w="4077335" h="795020">
                  <a:moveTo>
                    <a:pt x="593598" y="572008"/>
                  </a:moveTo>
                  <a:lnTo>
                    <a:pt x="583184" y="572008"/>
                  </a:lnTo>
                  <a:lnTo>
                    <a:pt x="583184" y="794512"/>
                  </a:lnTo>
                  <a:lnTo>
                    <a:pt x="593598" y="794512"/>
                  </a:lnTo>
                  <a:lnTo>
                    <a:pt x="593598" y="572008"/>
                  </a:lnTo>
                  <a:close/>
                </a:path>
                <a:path w="4077335" h="795020">
                  <a:moveTo>
                    <a:pt x="651624" y="317754"/>
                  </a:moveTo>
                  <a:lnTo>
                    <a:pt x="641223" y="317754"/>
                  </a:lnTo>
                  <a:lnTo>
                    <a:pt x="641223" y="794512"/>
                  </a:lnTo>
                  <a:lnTo>
                    <a:pt x="651624" y="794512"/>
                  </a:lnTo>
                  <a:lnTo>
                    <a:pt x="651624" y="317754"/>
                  </a:lnTo>
                  <a:close/>
                </a:path>
                <a:path w="4077335" h="795020">
                  <a:moveTo>
                    <a:pt x="709676" y="540258"/>
                  </a:moveTo>
                  <a:lnTo>
                    <a:pt x="699262" y="540258"/>
                  </a:lnTo>
                  <a:lnTo>
                    <a:pt x="699262" y="794512"/>
                  </a:lnTo>
                  <a:lnTo>
                    <a:pt x="709676" y="794512"/>
                  </a:lnTo>
                  <a:lnTo>
                    <a:pt x="709676" y="540258"/>
                  </a:lnTo>
                  <a:close/>
                </a:path>
                <a:path w="4077335" h="795020">
                  <a:moveTo>
                    <a:pt x="767715" y="63500"/>
                  </a:moveTo>
                  <a:lnTo>
                    <a:pt x="757301" y="63500"/>
                  </a:lnTo>
                  <a:lnTo>
                    <a:pt x="757301" y="794512"/>
                  </a:lnTo>
                  <a:lnTo>
                    <a:pt x="767715" y="794512"/>
                  </a:lnTo>
                  <a:lnTo>
                    <a:pt x="767715" y="63500"/>
                  </a:lnTo>
                  <a:close/>
                </a:path>
                <a:path w="4077335" h="795020">
                  <a:moveTo>
                    <a:pt x="825868" y="381381"/>
                  </a:moveTo>
                  <a:lnTo>
                    <a:pt x="815467" y="381381"/>
                  </a:lnTo>
                  <a:lnTo>
                    <a:pt x="815467" y="794512"/>
                  </a:lnTo>
                  <a:lnTo>
                    <a:pt x="825868" y="794512"/>
                  </a:lnTo>
                  <a:lnTo>
                    <a:pt x="825868" y="381381"/>
                  </a:lnTo>
                  <a:close/>
                </a:path>
                <a:path w="4077335" h="795020">
                  <a:moveTo>
                    <a:pt x="883920" y="413131"/>
                  </a:moveTo>
                  <a:lnTo>
                    <a:pt x="873506" y="413131"/>
                  </a:lnTo>
                  <a:lnTo>
                    <a:pt x="873506" y="794512"/>
                  </a:lnTo>
                  <a:lnTo>
                    <a:pt x="883920" y="794512"/>
                  </a:lnTo>
                  <a:lnTo>
                    <a:pt x="883920" y="413131"/>
                  </a:lnTo>
                  <a:close/>
                </a:path>
                <a:path w="4077335" h="795020">
                  <a:moveTo>
                    <a:pt x="941959" y="540258"/>
                  </a:moveTo>
                  <a:lnTo>
                    <a:pt x="931545" y="540258"/>
                  </a:lnTo>
                  <a:lnTo>
                    <a:pt x="931545" y="794512"/>
                  </a:lnTo>
                  <a:lnTo>
                    <a:pt x="941959" y="794512"/>
                  </a:lnTo>
                  <a:lnTo>
                    <a:pt x="941959" y="540258"/>
                  </a:lnTo>
                  <a:close/>
                </a:path>
                <a:path w="4077335" h="795020">
                  <a:moveTo>
                    <a:pt x="999998" y="222377"/>
                  </a:moveTo>
                  <a:lnTo>
                    <a:pt x="989584" y="222377"/>
                  </a:lnTo>
                  <a:lnTo>
                    <a:pt x="989584" y="794512"/>
                  </a:lnTo>
                  <a:lnTo>
                    <a:pt x="999998" y="794512"/>
                  </a:lnTo>
                  <a:lnTo>
                    <a:pt x="999998" y="222377"/>
                  </a:lnTo>
                  <a:close/>
                </a:path>
                <a:path w="4077335" h="795020">
                  <a:moveTo>
                    <a:pt x="1058024" y="254254"/>
                  </a:moveTo>
                  <a:lnTo>
                    <a:pt x="1047623" y="254254"/>
                  </a:lnTo>
                  <a:lnTo>
                    <a:pt x="1047623" y="794512"/>
                  </a:lnTo>
                  <a:lnTo>
                    <a:pt x="1058024" y="794512"/>
                  </a:lnTo>
                  <a:lnTo>
                    <a:pt x="1058024" y="254254"/>
                  </a:lnTo>
                  <a:close/>
                </a:path>
                <a:path w="4077335" h="795020">
                  <a:moveTo>
                    <a:pt x="1116076" y="286004"/>
                  </a:moveTo>
                  <a:lnTo>
                    <a:pt x="1105662" y="286004"/>
                  </a:lnTo>
                  <a:lnTo>
                    <a:pt x="1105662" y="794512"/>
                  </a:lnTo>
                  <a:lnTo>
                    <a:pt x="1116076" y="794512"/>
                  </a:lnTo>
                  <a:lnTo>
                    <a:pt x="1116076" y="286004"/>
                  </a:lnTo>
                  <a:close/>
                </a:path>
                <a:path w="4077335" h="795020">
                  <a:moveTo>
                    <a:pt x="1174115" y="444881"/>
                  </a:moveTo>
                  <a:lnTo>
                    <a:pt x="1163701" y="444881"/>
                  </a:lnTo>
                  <a:lnTo>
                    <a:pt x="1163701" y="794512"/>
                  </a:lnTo>
                  <a:lnTo>
                    <a:pt x="1174115" y="794512"/>
                  </a:lnTo>
                  <a:lnTo>
                    <a:pt x="1174115" y="444881"/>
                  </a:lnTo>
                  <a:close/>
                </a:path>
                <a:path w="4077335" h="795020">
                  <a:moveTo>
                    <a:pt x="1232154" y="317754"/>
                  </a:moveTo>
                  <a:lnTo>
                    <a:pt x="1221740" y="317754"/>
                  </a:lnTo>
                  <a:lnTo>
                    <a:pt x="1221740" y="794512"/>
                  </a:lnTo>
                  <a:lnTo>
                    <a:pt x="1232154" y="794512"/>
                  </a:lnTo>
                  <a:lnTo>
                    <a:pt x="1232154" y="317754"/>
                  </a:lnTo>
                  <a:close/>
                </a:path>
                <a:path w="4077335" h="795020">
                  <a:moveTo>
                    <a:pt x="1290180" y="444881"/>
                  </a:moveTo>
                  <a:lnTo>
                    <a:pt x="1279779" y="444881"/>
                  </a:lnTo>
                  <a:lnTo>
                    <a:pt x="1279779" y="794512"/>
                  </a:lnTo>
                  <a:lnTo>
                    <a:pt x="1290180" y="794512"/>
                  </a:lnTo>
                  <a:lnTo>
                    <a:pt x="1290180" y="444881"/>
                  </a:lnTo>
                  <a:close/>
                </a:path>
                <a:path w="4077335" h="795020">
                  <a:moveTo>
                    <a:pt x="1348232" y="349504"/>
                  </a:moveTo>
                  <a:lnTo>
                    <a:pt x="1337818" y="349504"/>
                  </a:lnTo>
                  <a:lnTo>
                    <a:pt x="1337818" y="794512"/>
                  </a:lnTo>
                  <a:lnTo>
                    <a:pt x="1348232" y="794512"/>
                  </a:lnTo>
                  <a:lnTo>
                    <a:pt x="1348232" y="349504"/>
                  </a:lnTo>
                  <a:close/>
                </a:path>
                <a:path w="4077335" h="795020">
                  <a:moveTo>
                    <a:pt x="1406398" y="0"/>
                  </a:moveTo>
                  <a:lnTo>
                    <a:pt x="1395984" y="0"/>
                  </a:lnTo>
                  <a:lnTo>
                    <a:pt x="1395984" y="794512"/>
                  </a:lnTo>
                  <a:lnTo>
                    <a:pt x="1406398" y="794512"/>
                  </a:lnTo>
                  <a:lnTo>
                    <a:pt x="1406398" y="0"/>
                  </a:lnTo>
                  <a:close/>
                </a:path>
                <a:path w="4077335" h="795020">
                  <a:moveTo>
                    <a:pt x="1464424" y="286004"/>
                  </a:moveTo>
                  <a:lnTo>
                    <a:pt x="1454023" y="286004"/>
                  </a:lnTo>
                  <a:lnTo>
                    <a:pt x="1454023" y="794512"/>
                  </a:lnTo>
                  <a:lnTo>
                    <a:pt x="1464424" y="794512"/>
                  </a:lnTo>
                  <a:lnTo>
                    <a:pt x="1464424" y="286004"/>
                  </a:lnTo>
                  <a:close/>
                </a:path>
                <a:path w="4077335" h="795020">
                  <a:moveTo>
                    <a:pt x="1522476" y="444881"/>
                  </a:moveTo>
                  <a:lnTo>
                    <a:pt x="1512062" y="444881"/>
                  </a:lnTo>
                  <a:lnTo>
                    <a:pt x="1512062" y="794512"/>
                  </a:lnTo>
                  <a:lnTo>
                    <a:pt x="1522476" y="794512"/>
                  </a:lnTo>
                  <a:lnTo>
                    <a:pt x="1522476" y="444881"/>
                  </a:lnTo>
                  <a:close/>
                </a:path>
                <a:path w="4077335" h="795020">
                  <a:moveTo>
                    <a:pt x="1580515" y="508508"/>
                  </a:moveTo>
                  <a:lnTo>
                    <a:pt x="1570101" y="508508"/>
                  </a:lnTo>
                  <a:lnTo>
                    <a:pt x="1570101" y="794512"/>
                  </a:lnTo>
                  <a:lnTo>
                    <a:pt x="1580515" y="794512"/>
                  </a:lnTo>
                  <a:lnTo>
                    <a:pt x="1580515" y="508508"/>
                  </a:lnTo>
                  <a:close/>
                </a:path>
                <a:path w="4077335" h="795020">
                  <a:moveTo>
                    <a:pt x="1638554" y="317754"/>
                  </a:moveTo>
                  <a:lnTo>
                    <a:pt x="1628140" y="317754"/>
                  </a:lnTo>
                  <a:lnTo>
                    <a:pt x="1628140" y="794512"/>
                  </a:lnTo>
                  <a:lnTo>
                    <a:pt x="1638554" y="794512"/>
                  </a:lnTo>
                  <a:lnTo>
                    <a:pt x="1638554" y="317754"/>
                  </a:lnTo>
                  <a:close/>
                </a:path>
                <a:path w="4077335" h="795020">
                  <a:moveTo>
                    <a:pt x="1696580" y="444881"/>
                  </a:moveTo>
                  <a:lnTo>
                    <a:pt x="1686179" y="444881"/>
                  </a:lnTo>
                  <a:lnTo>
                    <a:pt x="1686179" y="794512"/>
                  </a:lnTo>
                  <a:lnTo>
                    <a:pt x="1696580" y="794512"/>
                  </a:lnTo>
                  <a:lnTo>
                    <a:pt x="1696580" y="444881"/>
                  </a:lnTo>
                  <a:close/>
                </a:path>
                <a:path w="4077335" h="795020">
                  <a:moveTo>
                    <a:pt x="1754632" y="158877"/>
                  </a:moveTo>
                  <a:lnTo>
                    <a:pt x="1744218" y="158877"/>
                  </a:lnTo>
                  <a:lnTo>
                    <a:pt x="1744218" y="794512"/>
                  </a:lnTo>
                  <a:lnTo>
                    <a:pt x="1754632" y="794512"/>
                  </a:lnTo>
                  <a:lnTo>
                    <a:pt x="1754632" y="158877"/>
                  </a:lnTo>
                  <a:close/>
                </a:path>
                <a:path w="4077335" h="795020">
                  <a:moveTo>
                    <a:pt x="1812671" y="190627"/>
                  </a:moveTo>
                  <a:lnTo>
                    <a:pt x="1802257" y="190627"/>
                  </a:lnTo>
                  <a:lnTo>
                    <a:pt x="1802257" y="794512"/>
                  </a:lnTo>
                  <a:lnTo>
                    <a:pt x="1812671" y="794512"/>
                  </a:lnTo>
                  <a:lnTo>
                    <a:pt x="1812671" y="190627"/>
                  </a:lnTo>
                  <a:close/>
                </a:path>
                <a:path w="4077335" h="795020">
                  <a:moveTo>
                    <a:pt x="1870710" y="381381"/>
                  </a:moveTo>
                  <a:lnTo>
                    <a:pt x="1860296" y="381381"/>
                  </a:lnTo>
                  <a:lnTo>
                    <a:pt x="1860296" y="794512"/>
                  </a:lnTo>
                  <a:lnTo>
                    <a:pt x="1870710" y="794512"/>
                  </a:lnTo>
                  <a:lnTo>
                    <a:pt x="1870710" y="381381"/>
                  </a:lnTo>
                  <a:close/>
                </a:path>
                <a:path w="4077335" h="795020">
                  <a:moveTo>
                    <a:pt x="1928876" y="444881"/>
                  </a:moveTo>
                  <a:lnTo>
                    <a:pt x="1918462" y="444881"/>
                  </a:lnTo>
                  <a:lnTo>
                    <a:pt x="1918462" y="794512"/>
                  </a:lnTo>
                  <a:lnTo>
                    <a:pt x="1928876" y="794512"/>
                  </a:lnTo>
                  <a:lnTo>
                    <a:pt x="1928876" y="444881"/>
                  </a:lnTo>
                  <a:close/>
                </a:path>
                <a:path w="4077335" h="795020">
                  <a:moveTo>
                    <a:pt x="1986915" y="349504"/>
                  </a:moveTo>
                  <a:lnTo>
                    <a:pt x="1976501" y="349504"/>
                  </a:lnTo>
                  <a:lnTo>
                    <a:pt x="1976501" y="794512"/>
                  </a:lnTo>
                  <a:lnTo>
                    <a:pt x="1986915" y="794512"/>
                  </a:lnTo>
                  <a:lnTo>
                    <a:pt x="1986915" y="349504"/>
                  </a:lnTo>
                  <a:close/>
                </a:path>
                <a:path w="4077335" h="795020">
                  <a:moveTo>
                    <a:pt x="2044954" y="508508"/>
                  </a:moveTo>
                  <a:lnTo>
                    <a:pt x="2034540" y="508508"/>
                  </a:lnTo>
                  <a:lnTo>
                    <a:pt x="2034540" y="794512"/>
                  </a:lnTo>
                  <a:lnTo>
                    <a:pt x="2044954" y="794512"/>
                  </a:lnTo>
                  <a:lnTo>
                    <a:pt x="2044954" y="508508"/>
                  </a:lnTo>
                  <a:close/>
                </a:path>
                <a:path w="4077335" h="795020">
                  <a:moveTo>
                    <a:pt x="2102993" y="572008"/>
                  </a:moveTo>
                  <a:lnTo>
                    <a:pt x="2092579" y="572008"/>
                  </a:lnTo>
                  <a:lnTo>
                    <a:pt x="2092579" y="794512"/>
                  </a:lnTo>
                  <a:lnTo>
                    <a:pt x="2102993" y="794512"/>
                  </a:lnTo>
                  <a:lnTo>
                    <a:pt x="2102993" y="572008"/>
                  </a:lnTo>
                  <a:close/>
                </a:path>
                <a:path w="4077335" h="795020">
                  <a:moveTo>
                    <a:pt x="2161032" y="476631"/>
                  </a:moveTo>
                  <a:lnTo>
                    <a:pt x="2150618" y="476631"/>
                  </a:lnTo>
                  <a:lnTo>
                    <a:pt x="2150618" y="794512"/>
                  </a:lnTo>
                  <a:lnTo>
                    <a:pt x="2161032" y="794512"/>
                  </a:lnTo>
                  <a:lnTo>
                    <a:pt x="2161032" y="476631"/>
                  </a:lnTo>
                  <a:close/>
                </a:path>
                <a:path w="4077335" h="795020">
                  <a:moveTo>
                    <a:pt x="2219071" y="222377"/>
                  </a:moveTo>
                  <a:lnTo>
                    <a:pt x="2208657" y="222377"/>
                  </a:lnTo>
                  <a:lnTo>
                    <a:pt x="2208657" y="794512"/>
                  </a:lnTo>
                  <a:lnTo>
                    <a:pt x="2219071" y="794512"/>
                  </a:lnTo>
                  <a:lnTo>
                    <a:pt x="2219071" y="222377"/>
                  </a:lnTo>
                  <a:close/>
                </a:path>
                <a:path w="4077335" h="795020">
                  <a:moveTo>
                    <a:pt x="2277110" y="317754"/>
                  </a:moveTo>
                  <a:lnTo>
                    <a:pt x="2266696" y="317754"/>
                  </a:lnTo>
                  <a:lnTo>
                    <a:pt x="2266696" y="794512"/>
                  </a:lnTo>
                  <a:lnTo>
                    <a:pt x="2277110" y="794512"/>
                  </a:lnTo>
                  <a:lnTo>
                    <a:pt x="2277110" y="317754"/>
                  </a:lnTo>
                  <a:close/>
                </a:path>
                <a:path w="4077335" h="795020">
                  <a:moveTo>
                    <a:pt x="2335149" y="317754"/>
                  </a:moveTo>
                  <a:lnTo>
                    <a:pt x="2324735" y="317754"/>
                  </a:lnTo>
                  <a:lnTo>
                    <a:pt x="2324735" y="794512"/>
                  </a:lnTo>
                  <a:lnTo>
                    <a:pt x="2335149" y="794512"/>
                  </a:lnTo>
                  <a:lnTo>
                    <a:pt x="2335149" y="317754"/>
                  </a:lnTo>
                  <a:close/>
                </a:path>
                <a:path w="4077335" h="795020">
                  <a:moveTo>
                    <a:pt x="2393188" y="572008"/>
                  </a:moveTo>
                  <a:lnTo>
                    <a:pt x="2382774" y="572008"/>
                  </a:lnTo>
                  <a:lnTo>
                    <a:pt x="2382774" y="794512"/>
                  </a:lnTo>
                  <a:lnTo>
                    <a:pt x="2393188" y="794512"/>
                  </a:lnTo>
                  <a:lnTo>
                    <a:pt x="2393188" y="572008"/>
                  </a:lnTo>
                  <a:close/>
                </a:path>
                <a:path w="4077335" h="795020">
                  <a:moveTo>
                    <a:pt x="2451354" y="572008"/>
                  </a:moveTo>
                  <a:lnTo>
                    <a:pt x="2440940" y="572008"/>
                  </a:lnTo>
                  <a:lnTo>
                    <a:pt x="2440940" y="794512"/>
                  </a:lnTo>
                  <a:lnTo>
                    <a:pt x="2451354" y="794512"/>
                  </a:lnTo>
                  <a:lnTo>
                    <a:pt x="2451354" y="572008"/>
                  </a:lnTo>
                  <a:close/>
                </a:path>
                <a:path w="4077335" h="795020">
                  <a:moveTo>
                    <a:pt x="2509393" y="381381"/>
                  </a:moveTo>
                  <a:lnTo>
                    <a:pt x="2498979" y="381381"/>
                  </a:lnTo>
                  <a:lnTo>
                    <a:pt x="2498979" y="794512"/>
                  </a:lnTo>
                  <a:lnTo>
                    <a:pt x="2509393" y="794512"/>
                  </a:lnTo>
                  <a:lnTo>
                    <a:pt x="2509393" y="381381"/>
                  </a:lnTo>
                  <a:close/>
                </a:path>
                <a:path w="4077335" h="795020">
                  <a:moveTo>
                    <a:pt x="2567432" y="667385"/>
                  </a:moveTo>
                  <a:lnTo>
                    <a:pt x="2557018" y="667385"/>
                  </a:lnTo>
                  <a:lnTo>
                    <a:pt x="2557018" y="794512"/>
                  </a:lnTo>
                  <a:lnTo>
                    <a:pt x="2567432" y="794512"/>
                  </a:lnTo>
                  <a:lnTo>
                    <a:pt x="2567432" y="667385"/>
                  </a:lnTo>
                  <a:close/>
                </a:path>
                <a:path w="4077335" h="795020">
                  <a:moveTo>
                    <a:pt x="2625471" y="413131"/>
                  </a:moveTo>
                  <a:lnTo>
                    <a:pt x="2615057" y="413131"/>
                  </a:lnTo>
                  <a:lnTo>
                    <a:pt x="2615057" y="794512"/>
                  </a:lnTo>
                  <a:lnTo>
                    <a:pt x="2625471" y="794512"/>
                  </a:lnTo>
                  <a:lnTo>
                    <a:pt x="2625471" y="413131"/>
                  </a:lnTo>
                  <a:close/>
                </a:path>
                <a:path w="4077335" h="795020">
                  <a:moveTo>
                    <a:pt x="2683510" y="476631"/>
                  </a:moveTo>
                  <a:lnTo>
                    <a:pt x="2673096" y="476631"/>
                  </a:lnTo>
                  <a:lnTo>
                    <a:pt x="2673096" y="794512"/>
                  </a:lnTo>
                  <a:lnTo>
                    <a:pt x="2683510" y="794512"/>
                  </a:lnTo>
                  <a:lnTo>
                    <a:pt x="2683510" y="476631"/>
                  </a:lnTo>
                  <a:close/>
                </a:path>
                <a:path w="4077335" h="795020">
                  <a:moveTo>
                    <a:pt x="2741549" y="413131"/>
                  </a:moveTo>
                  <a:lnTo>
                    <a:pt x="2731135" y="413131"/>
                  </a:lnTo>
                  <a:lnTo>
                    <a:pt x="2731135" y="794512"/>
                  </a:lnTo>
                  <a:lnTo>
                    <a:pt x="2741549" y="794512"/>
                  </a:lnTo>
                  <a:lnTo>
                    <a:pt x="2741549" y="413131"/>
                  </a:lnTo>
                  <a:close/>
                </a:path>
                <a:path w="4077335" h="795020">
                  <a:moveTo>
                    <a:pt x="2799588" y="286004"/>
                  </a:moveTo>
                  <a:lnTo>
                    <a:pt x="2789174" y="286004"/>
                  </a:lnTo>
                  <a:lnTo>
                    <a:pt x="2789174" y="794512"/>
                  </a:lnTo>
                  <a:lnTo>
                    <a:pt x="2799588" y="794512"/>
                  </a:lnTo>
                  <a:lnTo>
                    <a:pt x="2799588" y="286004"/>
                  </a:lnTo>
                  <a:close/>
                </a:path>
                <a:path w="4077335" h="795020">
                  <a:moveTo>
                    <a:pt x="2857614" y="381381"/>
                  </a:moveTo>
                  <a:lnTo>
                    <a:pt x="2847213" y="381381"/>
                  </a:lnTo>
                  <a:lnTo>
                    <a:pt x="2847213" y="794512"/>
                  </a:lnTo>
                  <a:lnTo>
                    <a:pt x="2857614" y="794512"/>
                  </a:lnTo>
                  <a:lnTo>
                    <a:pt x="2857614" y="381381"/>
                  </a:lnTo>
                  <a:close/>
                </a:path>
                <a:path w="4077335" h="795020">
                  <a:moveTo>
                    <a:pt x="2915666" y="317754"/>
                  </a:moveTo>
                  <a:lnTo>
                    <a:pt x="2905252" y="317754"/>
                  </a:lnTo>
                  <a:lnTo>
                    <a:pt x="2905252" y="794512"/>
                  </a:lnTo>
                  <a:lnTo>
                    <a:pt x="2915666" y="794512"/>
                  </a:lnTo>
                  <a:lnTo>
                    <a:pt x="2915666" y="317754"/>
                  </a:lnTo>
                  <a:close/>
                </a:path>
                <a:path w="4077335" h="795020">
                  <a:moveTo>
                    <a:pt x="2973705" y="381381"/>
                  </a:moveTo>
                  <a:lnTo>
                    <a:pt x="2963291" y="381381"/>
                  </a:lnTo>
                  <a:lnTo>
                    <a:pt x="2963291" y="794512"/>
                  </a:lnTo>
                  <a:lnTo>
                    <a:pt x="2973705" y="794512"/>
                  </a:lnTo>
                  <a:lnTo>
                    <a:pt x="2973705" y="381381"/>
                  </a:lnTo>
                  <a:close/>
                </a:path>
                <a:path w="4077335" h="795020">
                  <a:moveTo>
                    <a:pt x="3031871" y="635635"/>
                  </a:moveTo>
                  <a:lnTo>
                    <a:pt x="3021457" y="635635"/>
                  </a:lnTo>
                  <a:lnTo>
                    <a:pt x="3021457" y="794512"/>
                  </a:lnTo>
                  <a:lnTo>
                    <a:pt x="3031871" y="794512"/>
                  </a:lnTo>
                  <a:lnTo>
                    <a:pt x="3031871" y="635635"/>
                  </a:lnTo>
                  <a:close/>
                </a:path>
                <a:path w="4077335" h="795020">
                  <a:moveTo>
                    <a:pt x="3089910" y="508508"/>
                  </a:moveTo>
                  <a:lnTo>
                    <a:pt x="3079496" y="508508"/>
                  </a:lnTo>
                  <a:lnTo>
                    <a:pt x="3079496" y="794512"/>
                  </a:lnTo>
                  <a:lnTo>
                    <a:pt x="3089910" y="794512"/>
                  </a:lnTo>
                  <a:lnTo>
                    <a:pt x="3089910" y="508508"/>
                  </a:lnTo>
                  <a:close/>
                </a:path>
                <a:path w="4077335" h="795020">
                  <a:moveTo>
                    <a:pt x="3147949" y="413131"/>
                  </a:moveTo>
                  <a:lnTo>
                    <a:pt x="3137535" y="413131"/>
                  </a:lnTo>
                  <a:lnTo>
                    <a:pt x="3137535" y="794512"/>
                  </a:lnTo>
                  <a:lnTo>
                    <a:pt x="3147949" y="794512"/>
                  </a:lnTo>
                  <a:lnTo>
                    <a:pt x="3147949" y="413131"/>
                  </a:lnTo>
                  <a:close/>
                </a:path>
                <a:path w="4077335" h="795020">
                  <a:moveTo>
                    <a:pt x="3205988" y="413131"/>
                  </a:moveTo>
                  <a:lnTo>
                    <a:pt x="3195574" y="413131"/>
                  </a:lnTo>
                  <a:lnTo>
                    <a:pt x="3195574" y="794512"/>
                  </a:lnTo>
                  <a:lnTo>
                    <a:pt x="3205988" y="794512"/>
                  </a:lnTo>
                  <a:lnTo>
                    <a:pt x="3205988" y="413131"/>
                  </a:lnTo>
                  <a:close/>
                </a:path>
                <a:path w="4077335" h="795020">
                  <a:moveTo>
                    <a:pt x="3264014" y="476631"/>
                  </a:moveTo>
                  <a:lnTo>
                    <a:pt x="3253613" y="476631"/>
                  </a:lnTo>
                  <a:lnTo>
                    <a:pt x="3253613" y="794512"/>
                  </a:lnTo>
                  <a:lnTo>
                    <a:pt x="3264014" y="794512"/>
                  </a:lnTo>
                  <a:lnTo>
                    <a:pt x="3264014" y="476631"/>
                  </a:lnTo>
                  <a:close/>
                </a:path>
                <a:path w="4077335" h="795020">
                  <a:moveTo>
                    <a:pt x="3322066" y="349504"/>
                  </a:moveTo>
                  <a:lnTo>
                    <a:pt x="3311652" y="349504"/>
                  </a:lnTo>
                  <a:lnTo>
                    <a:pt x="3311652" y="794512"/>
                  </a:lnTo>
                  <a:lnTo>
                    <a:pt x="3322066" y="794512"/>
                  </a:lnTo>
                  <a:lnTo>
                    <a:pt x="3322066" y="349504"/>
                  </a:lnTo>
                  <a:close/>
                </a:path>
                <a:path w="4077335" h="795020">
                  <a:moveTo>
                    <a:pt x="3380105" y="444881"/>
                  </a:moveTo>
                  <a:lnTo>
                    <a:pt x="3369691" y="444881"/>
                  </a:lnTo>
                  <a:lnTo>
                    <a:pt x="3369691" y="794512"/>
                  </a:lnTo>
                  <a:lnTo>
                    <a:pt x="3380105" y="794512"/>
                  </a:lnTo>
                  <a:lnTo>
                    <a:pt x="3380105" y="444881"/>
                  </a:lnTo>
                  <a:close/>
                </a:path>
                <a:path w="4077335" h="795020">
                  <a:moveTo>
                    <a:pt x="3438144" y="413131"/>
                  </a:moveTo>
                  <a:lnTo>
                    <a:pt x="3427730" y="413131"/>
                  </a:lnTo>
                  <a:lnTo>
                    <a:pt x="3427730" y="794512"/>
                  </a:lnTo>
                  <a:lnTo>
                    <a:pt x="3438144" y="794512"/>
                  </a:lnTo>
                  <a:lnTo>
                    <a:pt x="3438144" y="413131"/>
                  </a:lnTo>
                  <a:close/>
                </a:path>
                <a:path w="4077335" h="795020">
                  <a:moveTo>
                    <a:pt x="3496183" y="158877"/>
                  </a:moveTo>
                  <a:lnTo>
                    <a:pt x="3485769" y="158877"/>
                  </a:lnTo>
                  <a:lnTo>
                    <a:pt x="3485769" y="794512"/>
                  </a:lnTo>
                  <a:lnTo>
                    <a:pt x="3496183" y="794512"/>
                  </a:lnTo>
                  <a:lnTo>
                    <a:pt x="3496183" y="158877"/>
                  </a:lnTo>
                  <a:close/>
                </a:path>
                <a:path w="4077335" h="795020">
                  <a:moveTo>
                    <a:pt x="3554349" y="603758"/>
                  </a:moveTo>
                  <a:lnTo>
                    <a:pt x="3543935" y="603758"/>
                  </a:lnTo>
                  <a:lnTo>
                    <a:pt x="3543935" y="794512"/>
                  </a:lnTo>
                  <a:lnTo>
                    <a:pt x="3554349" y="794512"/>
                  </a:lnTo>
                  <a:lnTo>
                    <a:pt x="3554349" y="603758"/>
                  </a:lnTo>
                  <a:close/>
                </a:path>
                <a:path w="4077335" h="795020">
                  <a:moveTo>
                    <a:pt x="3612388" y="349504"/>
                  </a:moveTo>
                  <a:lnTo>
                    <a:pt x="3601974" y="349504"/>
                  </a:lnTo>
                  <a:lnTo>
                    <a:pt x="3601974" y="794512"/>
                  </a:lnTo>
                  <a:lnTo>
                    <a:pt x="3612388" y="794512"/>
                  </a:lnTo>
                  <a:lnTo>
                    <a:pt x="3612388" y="349504"/>
                  </a:lnTo>
                  <a:close/>
                </a:path>
                <a:path w="4077335" h="795020">
                  <a:moveTo>
                    <a:pt x="3670414" y="508508"/>
                  </a:moveTo>
                  <a:lnTo>
                    <a:pt x="3660013" y="508508"/>
                  </a:lnTo>
                  <a:lnTo>
                    <a:pt x="3660013" y="794512"/>
                  </a:lnTo>
                  <a:lnTo>
                    <a:pt x="3670414" y="794512"/>
                  </a:lnTo>
                  <a:lnTo>
                    <a:pt x="3670414" y="508508"/>
                  </a:lnTo>
                  <a:close/>
                </a:path>
                <a:path w="4077335" h="795020">
                  <a:moveTo>
                    <a:pt x="3728466" y="572008"/>
                  </a:moveTo>
                  <a:lnTo>
                    <a:pt x="3718052" y="572008"/>
                  </a:lnTo>
                  <a:lnTo>
                    <a:pt x="3718052" y="794512"/>
                  </a:lnTo>
                  <a:lnTo>
                    <a:pt x="3728466" y="794512"/>
                  </a:lnTo>
                  <a:lnTo>
                    <a:pt x="3728466" y="572008"/>
                  </a:lnTo>
                  <a:close/>
                </a:path>
                <a:path w="4077335" h="795020">
                  <a:moveTo>
                    <a:pt x="3786505" y="349504"/>
                  </a:moveTo>
                  <a:lnTo>
                    <a:pt x="3776091" y="349504"/>
                  </a:lnTo>
                  <a:lnTo>
                    <a:pt x="3776091" y="794512"/>
                  </a:lnTo>
                  <a:lnTo>
                    <a:pt x="3786505" y="794512"/>
                  </a:lnTo>
                  <a:lnTo>
                    <a:pt x="3786505" y="349504"/>
                  </a:lnTo>
                  <a:close/>
                </a:path>
                <a:path w="4077335" h="795020">
                  <a:moveTo>
                    <a:pt x="3844544" y="381381"/>
                  </a:moveTo>
                  <a:lnTo>
                    <a:pt x="3834130" y="381381"/>
                  </a:lnTo>
                  <a:lnTo>
                    <a:pt x="3834130" y="794512"/>
                  </a:lnTo>
                  <a:lnTo>
                    <a:pt x="3844544" y="794512"/>
                  </a:lnTo>
                  <a:lnTo>
                    <a:pt x="3844544" y="381381"/>
                  </a:lnTo>
                  <a:close/>
                </a:path>
                <a:path w="4077335" h="795020">
                  <a:moveTo>
                    <a:pt x="3902583" y="413131"/>
                  </a:moveTo>
                  <a:lnTo>
                    <a:pt x="3892169" y="413131"/>
                  </a:lnTo>
                  <a:lnTo>
                    <a:pt x="3892169" y="794512"/>
                  </a:lnTo>
                  <a:lnTo>
                    <a:pt x="3902583" y="794512"/>
                  </a:lnTo>
                  <a:lnTo>
                    <a:pt x="3902583" y="413131"/>
                  </a:lnTo>
                  <a:close/>
                </a:path>
                <a:path w="4077335" h="795020">
                  <a:moveTo>
                    <a:pt x="3960622" y="413131"/>
                  </a:moveTo>
                  <a:lnTo>
                    <a:pt x="3950208" y="413131"/>
                  </a:lnTo>
                  <a:lnTo>
                    <a:pt x="3950208" y="794512"/>
                  </a:lnTo>
                  <a:lnTo>
                    <a:pt x="3960622" y="794512"/>
                  </a:lnTo>
                  <a:lnTo>
                    <a:pt x="3960622" y="413131"/>
                  </a:lnTo>
                  <a:close/>
                </a:path>
                <a:path w="4077335" h="795020">
                  <a:moveTo>
                    <a:pt x="4018661" y="381381"/>
                  </a:moveTo>
                  <a:lnTo>
                    <a:pt x="4008247" y="381381"/>
                  </a:lnTo>
                  <a:lnTo>
                    <a:pt x="4008247" y="794512"/>
                  </a:lnTo>
                  <a:lnTo>
                    <a:pt x="4018661" y="794512"/>
                  </a:lnTo>
                  <a:lnTo>
                    <a:pt x="4018661" y="381381"/>
                  </a:lnTo>
                  <a:close/>
                </a:path>
                <a:path w="4077335" h="795020">
                  <a:moveTo>
                    <a:pt x="4076814" y="540258"/>
                  </a:moveTo>
                  <a:lnTo>
                    <a:pt x="4066413" y="540258"/>
                  </a:lnTo>
                  <a:lnTo>
                    <a:pt x="4066413" y="794512"/>
                  </a:lnTo>
                  <a:lnTo>
                    <a:pt x="4076814" y="794512"/>
                  </a:lnTo>
                  <a:lnTo>
                    <a:pt x="4076814" y="540258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5" name="object 135" descr=""/>
            <p:cNvSpPr/>
            <p:nvPr/>
          </p:nvSpPr>
          <p:spPr>
            <a:xfrm>
              <a:off x="5288280" y="7963154"/>
              <a:ext cx="4074160" cy="699770"/>
            </a:xfrm>
            <a:custGeom>
              <a:avLst/>
              <a:gdLst/>
              <a:ahLst/>
              <a:cxnLst/>
              <a:rect l="l" t="t" r="r" b="b"/>
              <a:pathLst>
                <a:path w="4074159" h="699770">
                  <a:moveTo>
                    <a:pt x="10401" y="445008"/>
                  </a:moveTo>
                  <a:lnTo>
                    <a:pt x="0" y="445008"/>
                  </a:lnTo>
                  <a:lnTo>
                    <a:pt x="0" y="699262"/>
                  </a:lnTo>
                  <a:lnTo>
                    <a:pt x="10401" y="699262"/>
                  </a:lnTo>
                  <a:lnTo>
                    <a:pt x="10401" y="445008"/>
                  </a:lnTo>
                  <a:close/>
                </a:path>
                <a:path w="4074159" h="699770">
                  <a:moveTo>
                    <a:pt x="68453" y="540385"/>
                  </a:moveTo>
                  <a:lnTo>
                    <a:pt x="58039" y="540385"/>
                  </a:lnTo>
                  <a:lnTo>
                    <a:pt x="58039" y="699262"/>
                  </a:lnTo>
                  <a:lnTo>
                    <a:pt x="68453" y="699262"/>
                  </a:lnTo>
                  <a:lnTo>
                    <a:pt x="68453" y="540385"/>
                  </a:lnTo>
                  <a:close/>
                </a:path>
                <a:path w="4074159" h="699770">
                  <a:moveTo>
                    <a:pt x="126492" y="413258"/>
                  </a:moveTo>
                  <a:lnTo>
                    <a:pt x="116078" y="413258"/>
                  </a:lnTo>
                  <a:lnTo>
                    <a:pt x="116078" y="699262"/>
                  </a:lnTo>
                  <a:lnTo>
                    <a:pt x="126492" y="699262"/>
                  </a:lnTo>
                  <a:lnTo>
                    <a:pt x="126492" y="413258"/>
                  </a:lnTo>
                  <a:close/>
                </a:path>
                <a:path w="4074159" h="699770">
                  <a:moveTo>
                    <a:pt x="184531" y="413258"/>
                  </a:moveTo>
                  <a:lnTo>
                    <a:pt x="174117" y="413258"/>
                  </a:lnTo>
                  <a:lnTo>
                    <a:pt x="174117" y="699262"/>
                  </a:lnTo>
                  <a:lnTo>
                    <a:pt x="184531" y="699262"/>
                  </a:lnTo>
                  <a:lnTo>
                    <a:pt x="184531" y="413258"/>
                  </a:lnTo>
                  <a:close/>
                </a:path>
                <a:path w="4074159" h="699770">
                  <a:moveTo>
                    <a:pt x="242570" y="127127"/>
                  </a:moveTo>
                  <a:lnTo>
                    <a:pt x="232156" y="127127"/>
                  </a:lnTo>
                  <a:lnTo>
                    <a:pt x="232156" y="699262"/>
                  </a:lnTo>
                  <a:lnTo>
                    <a:pt x="242570" y="699262"/>
                  </a:lnTo>
                  <a:lnTo>
                    <a:pt x="242570" y="127127"/>
                  </a:lnTo>
                  <a:close/>
                </a:path>
                <a:path w="4074159" h="699770">
                  <a:moveTo>
                    <a:pt x="300609" y="317881"/>
                  </a:moveTo>
                  <a:lnTo>
                    <a:pt x="290195" y="317881"/>
                  </a:lnTo>
                  <a:lnTo>
                    <a:pt x="290195" y="699262"/>
                  </a:lnTo>
                  <a:lnTo>
                    <a:pt x="300609" y="699262"/>
                  </a:lnTo>
                  <a:lnTo>
                    <a:pt x="300609" y="317881"/>
                  </a:lnTo>
                  <a:close/>
                </a:path>
                <a:path w="4074159" h="699770">
                  <a:moveTo>
                    <a:pt x="358648" y="349631"/>
                  </a:moveTo>
                  <a:lnTo>
                    <a:pt x="348234" y="349631"/>
                  </a:lnTo>
                  <a:lnTo>
                    <a:pt x="348234" y="699262"/>
                  </a:lnTo>
                  <a:lnTo>
                    <a:pt x="358648" y="699262"/>
                  </a:lnTo>
                  <a:lnTo>
                    <a:pt x="358648" y="349631"/>
                  </a:lnTo>
                  <a:close/>
                </a:path>
                <a:path w="4074159" h="699770">
                  <a:moveTo>
                    <a:pt x="416687" y="286131"/>
                  </a:moveTo>
                  <a:lnTo>
                    <a:pt x="406273" y="286131"/>
                  </a:lnTo>
                  <a:lnTo>
                    <a:pt x="406273" y="699262"/>
                  </a:lnTo>
                  <a:lnTo>
                    <a:pt x="416687" y="699262"/>
                  </a:lnTo>
                  <a:lnTo>
                    <a:pt x="416687" y="286131"/>
                  </a:lnTo>
                  <a:close/>
                </a:path>
                <a:path w="4074159" h="699770">
                  <a:moveTo>
                    <a:pt x="474726" y="254254"/>
                  </a:moveTo>
                  <a:lnTo>
                    <a:pt x="464312" y="254254"/>
                  </a:lnTo>
                  <a:lnTo>
                    <a:pt x="464312" y="699262"/>
                  </a:lnTo>
                  <a:lnTo>
                    <a:pt x="474726" y="699262"/>
                  </a:lnTo>
                  <a:lnTo>
                    <a:pt x="474726" y="254254"/>
                  </a:lnTo>
                  <a:close/>
                </a:path>
                <a:path w="4074159" h="699770">
                  <a:moveTo>
                    <a:pt x="532752" y="317881"/>
                  </a:moveTo>
                  <a:lnTo>
                    <a:pt x="522351" y="317881"/>
                  </a:lnTo>
                  <a:lnTo>
                    <a:pt x="522351" y="699262"/>
                  </a:lnTo>
                  <a:lnTo>
                    <a:pt x="532752" y="699262"/>
                  </a:lnTo>
                  <a:lnTo>
                    <a:pt x="532752" y="317881"/>
                  </a:lnTo>
                  <a:close/>
                </a:path>
                <a:path w="4074159" h="699770">
                  <a:moveTo>
                    <a:pt x="590931" y="381381"/>
                  </a:moveTo>
                  <a:lnTo>
                    <a:pt x="580517" y="381381"/>
                  </a:lnTo>
                  <a:lnTo>
                    <a:pt x="580517" y="699262"/>
                  </a:lnTo>
                  <a:lnTo>
                    <a:pt x="590931" y="699262"/>
                  </a:lnTo>
                  <a:lnTo>
                    <a:pt x="590931" y="381381"/>
                  </a:lnTo>
                  <a:close/>
                </a:path>
                <a:path w="4074159" h="699770">
                  <a:moveTo>
                    <a:pt x="648970" y="222504"/>
                  </a:moveTo>
                  <a:lnTo>
                    <a:pt x="638556" y="222504"/>
                  </a:lnTo>
                  <a:lnTo>
                    <a:pt x="638556" y="699262"/>
                  </a:lnTo>
                  <a:lnTo>
                    <a:pt x="648970" y="699262"/>
                  </a:lnTo>
                  <a:lnTo>
                    <a:pt x="648970" y="222504"/>
                  </a:lnTo>
                  <a:close/>
                </a:path>
                <a:path w="4074159" h="699770">
                  <a:moveTo>
                    <a:pt x="707009" y="254254"/>
                  </a:moveTo>
                  <a:lnTo>
                    <a:pt x="696595" y="254254"/>
                  </a:lnTo>
                  <a:lnTo>
                    <a:pt x="696595" y="699262"/>
                  </a:lnTo>
                  <a:lnTo>
                    <a:pt x="707009" y="699262"/>
                  </a:lnTo>
                  <a:lnTo>
                    <a:pt x="707009" y="254254"/>
                  </a:lnTo>
                  <a:close/>
                </a:path>
                <a:path w="4074159" h="699770">
                  <a:moveTo>
                    <a:pt x="765048" y="317881"/>
                  </a:moveTo>
                  <a:lnTo>
                    <a:pt x="754634" y="317881"/>
                  </a:lnTo>
                  <a:lnTo>
                    <a:pt x="754634" y="699262"/>
                  </a:lnTo>
                  <a:lnTo>
                    <a:pt x="765048" y="699262"/>
                  </a:lnTo>
                  <a:lnTo>
                    <a:pt x="765048" y="317881"/>
                  </a:lnTo>
                  <a:close/>
                </a:path>
                <a:path w="4074159" h="699770">
                  <a:moveTo>
                    <a:pt x="823087" y="381381"/>
                  </a:moveTo>
                  <a:lnTo>
                    <a:pt x="812673" y="381381"/>
                  </a:lnTo>
                  <a:lnTo>
                    <a:pt x="812673" y="699262"/>
                  </a:lnTo>
                  <a:lnTo>
                    <a:pt x="823087" y="699262"/>
                  </a:lnTo>
                  <a:lnTo>
                    <a:pt x="823087" y="381381"/>
                  </a:lnTo>
                  <a:close/>
                </a:path>
                <a:path w="4074159" h="699770">
                  <a:moveTo>
                    <a:pt x="881126" y="381381"/>
                  </a:moveTo>
                  <a:lnTo>
                    <a:pt x="870712" y="381381"/>
                  </a:lnTo>
                  <a:lnTo>
                    <a:pt x="870712" y="699262"/>
                  </a:lnTo>
                  <a:lnTo>
                    <a:pt x="881126" y="699262"/>
                  </a:lnTo>
                  <a:lnTo>
                    <a:pt x="881126" y="381381"/>
                  </a:lnTo>
                  <a:close/>
                </a:path>
                <a:path w="4074159" h="699770">
                  <a:moveTo>
                    <a:pt x="939152" y="349631"/>
                  </a:moveTo>
                  <a:lnTo>
                    <a:pt x="928751" y="349631"/>
                  </a:lnTo>
                  <a:lnTo>
                    <a:pt x="928751" y="699262"/>
                  </a:lnTo>
                  <a:lnTo>
                    <a:pt x="939152" y="699262"/>
                  </a:lnTo>
                  <a:lnTo>
                    <a:pt x="939152" y="349631"/>
                  </a:lnTo>
                  <a:close/>
                </a:path>
                <a:path w="4074159" h="699770">
                  <a:moveTo>
                    <a:pt x="997204" y="381381"/>
                  </a:moveTo>
                  <a:lnTo>
                    <a:pt x="986790" y="381381"/>
                  </a:lnTo>
                  <a:lnTo>
                    <a:pt x="986790" y="699262"/>
                  </a:lnTo>
                  <a:lnTo>
                    <a:pt x="997204" y="699262"/>
                  </a:lnTo>
                  <a:lnTo>
                    <a:pt x="997204" y="381381"/>
                  </a:lnTo>
                  <a:close/>
                </a:path>
                <a:path w="4074159" h="699770">
                  <a:moveTo>
                    <a:pt x="1055243" y="476758"/>
                  </a:moveTo>
                  <a:lnTo>
                    <a:pt x="1044829" y="476758"/>
                  </a:lnTo>
                  <a:lnTo>
                    <a:pt x="1044829" y="699262"/>
                  </a:lnTo>
                  <a:lnTo>
                    <a:pt x="1055243" y="699262"/>
                  </a:lnTo>
                  <a:lnTo>
                    <a:pt x="1055243" y="476758"/>
                  </a:lnTo>
                  <a:close/>
                </a:path>
                <a:path w="4074159" h="699770">
                  <a:moveTo>
                    <a:pt x="1113409" y="508508"/>
                  </a:moveTo>
                  <a:lnTo>
                    <a:pt x="1102995" y="508508"/>
                  </a:lnTo>
                  <a:lnTo>
                    <a:pt x="1102995" y="699262"/>
                  </a:lnTo>
                  <a:lnTo>
                    <a:pt x="1113409" y="699262"/>
                  </a:lnTo>
                  <a:lnTo>
                    <a:pt x="1113409" y="508508"/>
                  </a:lnTo>
                  <a:close/>
                </a:path>
                <a:path w="4074159" h="699770">
                  <a:moveTo>
                    <a:pt x="1171448" y="0"/>
                  </a:moveTo>
                  <a:lnTo>
                    <a:pt x="1161034" y="0"/>
                  </a:lnTo>
                  <a:lnTo>
                    <a:pt x="1161034" y="699262"/>
                  </a:lnTo>
                  <a:lnTo>
                    <a:pt x="1171448" y="699262"/>
                  </a:lnTo>
                  <a:lnTo>
                    <a:pt x="1171448" y="0"/>
                  </a:lnTo>
                  <a:close/>
                </a:path>
                <a:path w="4074159" h="699770">
                  <a:moveTo>
                    <a:pt x="1229487" y="476758"/>
                  </a:moveTo>
                  <a:lnTo>
                    <a:pt x="1219073" y="476758"/>
                  </a:lnTo>
                  <a:lnTo>
                    <a:pt x="1219073" y="699262"/>
                  </a:lnTo>
                  <a:lnTo>
                    <a:pt x="1229487" y="699262"/>
                  </a:lnTo>
                  <a:lnTo>
                    <a:pt x="1229487" y="476758"/>
                  </a:lnTo>
                  <a:close/>
                </a:path>
                <a:path w="4074159" h="699770">
                  <a:moveTo>
                    <a:pt x="1287526" y="476758"/>
                  </a:moveTo>
                  <a:lnTo>
                    <a:pt x="1277112" y="476758"/>
                  </a:lnTo>
                  <a:lnTo>
                    <a:pt x="1277112" y="699262"/>
                  </a:lnTo>
                  <a:lnTo>
                    <a:pt x="1287526" y="699262"/>
                  </a:lnTo>
                  <a:lnTo>
                    <a:pt x="1287526" y="476758"/>
                  </a:lnTo>
                  <a:close/>
                </a:path>
                <a:path w="4074159" h="699770">
                  <a:moveTo>
                    <a:pt x="1345565" y="413258"/>
                  </a:moveTo>
                  <a:lnTo>
                    <a:pt x="1335151" y="413258"/>
                  </a:lnTo>
                  <a:lnTo>
                    <a:pt x="1335151" y="699262"/>
                  </a:lnTo>
                  <a:lnTo>
                    <a:pt x="1345565" y="699262"/>
                  </a:lnTo>
                  <a:lnTo>
                    <a:pt x="1345565" y="413258"/>
                  </a:lnTo>
                  <a:close/>
                </a:path>
                <a:path w="4074159" h="699770">
                  <a:moveTo>
                    <a:pt x="1403604" y="508508"/>
                  </a:moveTo>
                  <a:lnTo>
                    <a:pt x="1393190" y="508508"/>
                  </a:lnTo>
                  <a:lnTo>
                    <a:pt x="1393190" y="699262"/>
                  </a:lnTo>
                  <a:lnTo>
                    <a:pt x="1403604" y="699262"/>
                  </a:lnTo>
                  <a:lnTo>
                    <a:pt x="1403604" y="508508"/>
                  </a:lnTo>
                  <a:close/>
                </a:path>
                <a:path w="4074159" h="699770">
                  <a:moveTo>
                    <a:pt x="1461643" y="445008"/>
                  </a:moveTo>
                  <a:lnTo>
                    <a:pt x="1451229" y="445008"/>
                  </a:lnTo>
                  <a:lnTo>
                    <a:pt x="1451229" y="699262"/>
                  </a:lnTo>
                  <a:lnTo>
                    <a:pt x="1461643" y="699262"/>
                  </a:lnTo>
                  <a:lnTo>
                    <a:pt x="1461643" y="445008"/>
                  </a:lnTo>
                  <a:close/>
                </a:path>
                <a:path w="4074159" h="699770">
                  <a:moveTo>
                    <a:pt x="1519682" y="413258"/>
                  </a:moveTo>
                  <a:lnTo>
                    <a:pt x="1509268" y="413258"/>
                  </a:lnTo>
                  <a:lnTo>
                    <a:pt x="1509268" y="699262"/>
                  </a:lnTo>
                  <a:lnTo>
                    <a:pt x="1519682" y="699262"/>
                  </a:lnTo>
                  <a:lnTo>
                    <a:pt x="1519682" y="413258"/>
                  </a:lnTo>
                  <a:close/>
                </a:path>
                <a:path w="4074159" h="699770">
                  <a:moveTo>
                    <a:pt x="1577721" y="476758"/>
                  </a:moveTo>
                  <a:lnTo>
                    <a:pt x="1567307" y="476758"/>
                  </a:lnTo>
                  <a:lnTo>
                    <a:pt x="1567307" y="699262"/>
                  </a:lnTo>
                  <a:lnTo>
                    <a:pt x="1577721" y="699262"/>
                  </a:lnTo>
                  <a:lnTo>
                    <a:pt x="1577721" y="476758"/>
                  </a:lnTo>
                  <a:close/>
                </a:path>
                <a:path w="4074159" h="699770">
                  <a:moveTo>
                    <a:pt x="1635887" y="317881"/>
                  </a:moveTo>
                  <a:lnTo>
                    <a:pt x="1625473" y="317881"/>
                  </a:lnTo>
                  <a:lnTo>
                    <a:pt x="1625473" y="699262"/>
                  </a:lnTo>
                  <a:lnTo>
                    <a:pt x="1635887" y="699262"/>
                  </a:lnTo>
                  <a:lnTo>
                    <a:pt x="1635887" y="317881"/>
                  </a:lnTo>
                  <a:close/>
                </a:path>
                <a:path w="4074159" h="699770">
                  <a:moveTo>
                    <a:pt x="1693926" y="349631"/>
                  </a:moveTo>
                  <a:lnTo>
                    <a:pt x="1683512" y="349631"/>
                  </a:lnTo>
                  <a:lnTo>
                    <a:pt x="1683512" y="699262"/>
                  </a:lnTo>
                  <a:lnTo>
                    <a:pt x="1693926" y="699262"/>
                  </a:lnTo>
                  <a:lnTo>
                    <a:pt x="1693926" y="349631"/>
                  </a:lnTo>
                  <a:close/>
                </a:path>
                <a:path w="4074159" h="699770">
                  <a:moveTo>
                    <a:pt x="1751965" y="476758"/>
                  </a:moveTo>
                  <a:lnTo>
                    <a:pt x="1741551" y="476758"/>
                  </a:lnTo>
                  <a:lnTo>
                    <a:pt x="1741551" y="699262"/>
                  </a:lnTo>
                  <a:lnTo>
                    <a:pt x="1751965" y="699262"/>
                  </a:lnTo>
                  <a:lnTo>
                    <a:pt x="1751965" y="476758"/>
                  </a:lnTo>
                  <a:close/>
                </a:path>
                <a:path w="4074159" h="699770">
                  <a:moveTo>
                    <a:pt x="1810004" y="349631"/>
                  </a:moveTo>
                  <a:lnTo>
                    <a:pt x="1799590" y="349631"/>
                  </a:lnTo>
                  <a:lnTo>
                    <a:pt x="1799590" y="699262"/>
                  </a:lnTo>
                  <a:lnTo>
                    <a:pt x="1810004" y="699262"/>
                  </a:lnTo>
                  <a:lnTo>
                    <a:pt x="1810004" y="349631"/>
                  </a:lnTo>
                  <a:close/>
                </a:path>
                <a:path w="4074159" h="699770">
                  <a:moveTo>
                    <a:pt x="1868043" y="445008"/>
                  </a:moveTo>
                  <a:lnTo>
                    <a:pt x="1857629" y="445008"/>
                  </a:lnTo>
                  <a:lnTo>
                    <a:pt x="1857629" y="699262"/>
                  </a:lnTo>
                  <a:lnTo>
                    <a:pt x="1868043" y="699262"/>
                  </a:lnTo>
                  <a:lnTo>
                    <a:pt x="1868043" y="445008"/>
                  </a:lnTo>
                  <a:close/>
                </a:path>
                <a:path w="4074159" h="699770">
                  <a:moveTo>
                    <a:pt x="1926082" y="190754"/>
                  </a:moveTo>
                  <a:lnTo>
                    <a:pt x="1915668" y="190754"/>
                  </a:lnTo>
                  <a:lnTo>
                    <a:pt x="1915668" y="699262"/>
                  </a:lnTo>
                  <a:lnTo>
                    <a:pt x="1926082" y="699262"/>
                  </a:lnTo>
                  <a:lnTo>
                    <a:pt x="1926082" y="190754"/>
                  </a:lnTo>
                  <a:close/>
                </a:path>
                <a:path w="4074159" h="699770">
                  <a:moveTo>
                    <a:pt x="1984121" y="540385"/>
                  </a:moveTo>
                  <a:lnTo>
                    <a:pt x="1973707" y="540385"/>
                  </a:lnTo>
                  <a:lnTo>
                    <a:pt x="1973707" y="699262"/>
                  </a:lnTo>
                  <a:lnTo>
                    <a:pt x="1984121" y="699262"/>
                  </a:lnTo>
                  <a:lnTo>
                    <a:pt x="1984121" y="540385"/>
                  </a:lnTo>
                  <a:close/>
                </a:path>
                <a:path w="4074159" h="699770">
                  <a:moveTo>
                    <a:pt x="2042160" y="349631"/>
                  </a:moveTo>
                  <a:lnTo>
                    <a:pt x="2031746" y="349631"/>
                  </a:lnTo>
                  <a:lnTo>
                    <a:pt x="2031746" y="699262"/>
                  </a:lnTo>
                  <a:lnTo>
                    <a:pt x="2042160" y="699262"/>
                  </a:lnTo>
                  <a:lnTo>
                    <a:pt x="2042160" y="349631"/>
                  </a:lnTo>
                  <a:close/>
                </a:path>
                <a:path w="4074159" h="699770">
                  <a:moveTo>
                    <a:pt x="2100199" y="540385"/>
                  </a:moveTo>
                  <a:lnTo>
                    <a:pt x="2089785" y="540385"/>
                  </a:lnTo>
                  <a:lnTo>
                    <a:pt x="2089785" y="699262"/>
                  </a:lnTo>
                  <a:lnTo>
                    <a:pt x="2100199" y="699262"/>
                  </a:lnTo>
                  <a:lnTo>
                    <a:pt x="2100199" y="540385"/>
                  </a:lnTo>
                  <a:close/>
                </a:path>
                <a:path w="4074159" h="699770">
                  <a:moveTo>
                    <a:pt x="2158238" y="572135"/>
                  </a:moveTo>
                  <a:lnTo>
                    <a:pt x="2147824" y="572135"/>
                  </a:lnTo>
                  <a:lnTo>
                    <a:pt x="2147824" y="699262"/>
                  </a:lnTo>
                  <a:lnTo>
                    <a:pt x="2158238" y="699262"/>
                  </a:lnTo>
                  <a:lnTo>
                    <a:pt x="2158238" y="572135"/>
                  </a:lnTo>
                  <a:close/>
                </a:path>
                <a:path w="4074159" h="699770">
                  <a:moveTo>
                    <a:pt x="2216404" y="508508"/>
                  </a:moveTo>
                  <a:lnTo>
                    <a:pt x="2205990" y="508508"/>
                  </a:lnTo>
                  <a:lnTo>
                    <a:pt x="2205990" y="699262"/>
                  </a:lnTo>
                  <a:lnTo>
                    <a:pt x="2216404" y="699262"/>
                  </a:lnTo>
                  <a:lnTo>
                    <a:pt x="2216404" y="508508"/>
                  </a:lnTo>
                  <a:close/>
                </a:path>
                <a:path w="4074159" h="699770">
                  <a:moveTo>
                    <a:pt x="2274443" y="508508"/>
                  </a:moveTo>
                  <a:lnTo>
                    <a:pt x="2264029" y="508508"/>
                  </a:lnTo>
                  <a:lnTo>
                    <a:pt x="2264029" y="699262"/>
                  </a:lnTo>
                  <a:lnTo>
                    <a:pt x="2274443" y="699262"/>
                  </a:lnTo>
                  <a:lnTo>
                    <a:pt x="2274443" y="508508"/>
                  </a:lnTo>
                  <a:close/>
                </a:path>
                <a:path w="4074159" h="699770">
                  <a:moveTo>
                    <a:pt x="2332482" y="540385"/>
                  </a:moveTo>
                  <a:lnTo>
                    <a:pt x="2322068" y="540385"/>
                  </a:lnTo>
                  <a:lnTo>
                    <a:pt x="2322068" y="699262"/>
                  </a:lnTo>
                  <a:lnTo>
                    <a:pt x="2332482" y="699262"/>
                  </a:lnTo>
                  <a:lnTo>
                    <a:pt x="2332482" y="540385"/>
                  </a:lnTo>
                  <a:close/>
                </a:path>
                <a:path w="4074159" h="699770">
                  <a:moveTo>
                    <a:pt x="2390521" y="572135"/>
                  </a:moveTo>
                  <a:lnTo>
                    <a:pt x="2380107" y="572135"/>
                  </a:lnTo>
                  <a:lnTo>
                    <a:pt x="2380107" y="699262"/>
                  </a:lnTo>
                  <a:lnTo>
                    <a:pt x="2390521" y="699262"/>
                  </a:lnTo>
                  <a:lnTo>
                    <a:pt x="2390521" y="572135"/>
                  </a:lnTo>
                  <a:close/>
                </a:path>
                <a:path w="4074159" h="699770">
                  <a:moveTo>
                    <a:pt x="2448560" y="508508"/>
                  </a:moveTo>
                  <a:lnTo>
                    <a:pt x="2438146" y="508508"/>
                  </a:lnTo>
                  <a:lnTo>
                    <a:pt x="2438146" y="699262"/>
                  </a:lnTo>
                  <a:lnTo>
                    <a:pt x="2448560" y="699262"/>
                  </a:lnTo>
                  <a:lnTo>
                    <a:pt x="2448560" y="508508"/>
                  </a:lnTo>
                  <a:close/>
                </a:path>
                <a:path w="4074159" h="699770">
                  <a:moveTo>
                    <a:pt x="2506599" y="476758"/>
                  </a:moveTo>
                  <a:lnTo>
                    <a:pt x="2496185" y="476758"/>
                  </a:lnTo>
                  <a:lnTo>
                    <a:pt x="2496185" y="699262"/>
                  </a:lnTo>
                  <a:lnTo>
                    <a:pt x="2506599" y="699262"/>
                  </a:lnTo>
                  <a:lnTo>
                    <a:pt x="2506599" y="476758"/>
                  </a:lnTo>
                  <a:close/>
                </a:path>
                <a:path w="4074159" h="699770">
                  <a:moveTo>
                    <a:pt x="2564638" y="508508"/>
                  </a:moveTo>
                  <a:lnTo>
                    <a:pt x="2554224" y="508508"/>
                  </a:lnTo>
                  <a:lnTo>
                    <a:pt x="2554224" y="699262"/>
                  </a:lnTo>
                  <a:lnTo>
                    <a:pt x="2564638" y="699262"/>
                  </a:lnTo>
                  <a:lnTo>
                    <a:pt x="2564638" y="508508"/>
                  </a:lnTo>
                  <a:close/>
                </a:path>
                <a:path w="4074159" h="699770">
                  <a:moveTo>
                    <a:pt x="2622677" y="508508"/>
                  </a:moveTo>
                  <a:lnTo>
                    <a:pt x="2612263" y="508508"/>
                  </a:lnTo>
                  <a:lnTo>
                    <a:pt x="2612263" y="699262"/>
                  </a:lnTo>
                  <a:lnTo>
                    <a:pt x="2622677" y="699262"/>
                  </a:lnTo>
                  <a:lnTo>
                    <a:pt x="2622677" y="508508"/>
                  </a:lnTo>
                  <a:close/>
                </a:path>
                <a:path w="4074159" h="699770">
                  <a:moveTo>
                    <a:pt x="2680716" y="572135"/>
                  </a:moveTo>
                  <a:lnTo>
                    <a:pt x="2670302" y="572135"/>
                  </a:lnTo>
                  <a:lnTo>
                    <a:pt x="2670302" y="699262"/>
                  </a:lnTo>
                  <a:lnTo>
                    <a:pt x="2680716" y="699262"/>
                  </a:lnTo>
                  <a:lnTo>
                    <a:pt x="2680716" y="572135"/>
                  </a:lnTo>
                  <a:close/>
                </a:path>
                <a:path w="4074159" h="699770">
                  <a:moveTo>
                    <a:pt x="2738882" y="572135"/>
                  </a:moveTo>
                  <a:lnTo>
                    <a:pt x="2728468" y="572135"/>
                  </a:lnTo>
                  <a:lnTo>
                    <a:pt x="2728468" y="699262"/>
                  </a:lnTo>
                  <a:lnTo>
                    <a:pt x="2738882" y="699262"/>
                  </a:lnTo>
                  <a:lnTo>
                    <a:pt x="2738882" y="572135"/>
                  </a:lnTo>
                  <a:close/>
                </a:path>
                <a:path w="4074159" h="699770">
                  <a:moveTo>
                    <a:pt x="2796921" y="508508"/>
                  </a:moveTo>
                  <a:lnTo>
                    <a:pt x="2783840" y="508508"/>
                  </a:lnTo>
                  <a:lnTo>
                    <a:pt x="2783840" y="699262"/>
                  </a:lnTo>
                  <a:lnTo>
                    <a:pt x="2796921" y="699262"/>
                  </a:lnTo>
                  <a:lnTo>
                    <a:pt x="2796921" y="508508"/>
                  </a:lnTo>
                  <a:close/>
                </a:path>
                <a:path w="4074159" h="699770">
                  <a:moveTo>
                    <a:pt x="2854960" y="445008"/>
                  </a:moveTo>
                  <a:lnTo>
                    <a:pt x="2844546" y="445008"/>
                  </a:lnTo>
                  <a:lnTo>
                    <a:pt x="2844546" y="699262"/>
                  </a:lnTo>
                  <a:lnTo>
                    <a:pt x="2854960" y="699262"/>
                  </a:lnTo>
                  <a:lnTo>
                    <a:pt x="2854960" y="445008"/>
                  </a:lnTo>
                  <a:close/>
                </a:path>
                <a:path w="4074159" h="699770">
                  <a:moveTo>
                    <a:pt x="2912999" y="381381"/>
                  </a:moveTo>
                  <a:lnTo>
                    <a:pt x="2902585" y="381381"/>
                  </a:lnTo>
                  <a:lnTo>
                    <a:pt x="2902585" y="699262"/>
                  </a:lnTo>
                  <a:lnTo>
                    <a:pt x="2912999" y="699262"/>
                  </a:lnTo>
                  <a:lnTo>
                    <a:pt x="2912999" y="381381"/>
                  </a:lnTo>
                  <a:close/>
                </a:path>
                <a:path w="4074159" h="699770">
                  <a:moveTo>
                    <a:pt x="2971038" y="317881"/>
                  </a:moveTo>
                  <a:lnTo>
                    <a:pt x="2960624" y="317881"/>
                  </a:lnTo>
                  <a:lnTo>
                    <a:pt x="2960624" y="699262"/>
                  </a:lnTo>
                  <a:lnTo>
                    <a:pt x="2971038" y="699262"/>
                  </a:lnTo>
                  <a:lnTo>
                    <a:pt x="2971038" y="317881"/>
                  </a:lnTo>
                  <a:close/>
                </a:path>
                <a:path w="4074159" h="699770">
                  <a:moveTo>
                    <a:pt x="3029077" y="445008"/>
                  </a:moveTo>
                  <a:lnTo>
                    <a:pt x="3018663" y="445008"/>
                  </a:lnTo>
                  <a:lnTo>
                    <a:pt x="3018663" y="699262"/>
                  </a:lnTo>
                  <a:lnTo>
                    <a:pt x="3029077" y="699262"/>
                  </a:lnTo>
                  <a:lnTo>
                    <a:pt x="3029077" y="445008"/>
                  </a:lnTo>
                  <a:close/>
                </a:path>
                <a:path w="4074159" h="699770">
                  <a:moveTo>
                    <a:pt x="3087116" y="476758"/>
                  </a:moveTo>
                  <a:lnTo>
                    <a:pt x="3076702" y="476758"/>
                  </a:lnTo>
                  <a:lnTo>
                    <a:pt x="3076702" y="699262"/>
                  </a:lnTo>
                  <a:lnTo>
                    <a:pt x="3087116" y="699262"/>
                  </a:lnTo>
                  <a:lnTo>
                    <a:pt x="3087116" y="476758"/>
                  </a:lnTo>
                  <a:close/>
                </a:path>
                <a:path w="4074159" h="699770">
                  <a:moveTo>
                    <a:pt x="3145155" y="572135"/>
                  </a:moveTo>
                  <a:lnTo>
                    <a:pt x="3134741" y="572135"/>
                  </a:lnTo>
                  <a:lnTo>
                    <a:pt x="3134741" y="699262"/>
                  </a:lnTo>
                  <a:lnTo>
                    <a:pt x="3145155" y="699262"/>
                  </a:lnTo>
                  <a:lnTo>
                    <a:pt x="3145155" y="572135"/>
                  </a:lnTo>
                  <a:close/>
                </a:path>
                <a:path w="4074159" h="699770">
                  <a:moveTo>
                    <a:pt x="3203194" y="540385"/>
                  </a:moveTo>
                  <a:lnTo>
                    <a:pt x="3192780" y="540385"/>
                  </a:lnTo>
                  <a:lnTo>
                    <a:pt x="3192780" y="699262"/>
                  </a:lnTo>
                  <a:lnTo>
                    <a:pt x="3203194" y="699262"/>
                  </a:lnTo>
                  <a:lnTo>
                    <a:pt x="3203194" y="540385"/>
                  </a:lnTo>
                  <a:close/>
                </a:path>
                <a:path w="4074159" h="699770">
                  <a:moveTo>
                    <a:pt x="3261233" y="445008"/>
                  </a:moveTo>
                  <a:lnTo>
                    <a:pt x="3250819" y="445008"/>
                  </a:lnTo>
                  <a:lnTo>
                    <a:pt x="3250819" y="699262"/>
                  </a:lnTo>
                  <a:lnTo>
                    <a:pt x="3261233" y="699262"/>
                  </a:lnTo>
                  <a:lnTo>
                    <a:pt x="3261233" y="445008"/>
                  </a:lnTo>
                  <a:close/>
                </a:path>
                <a:path w="4074159" h="699770">
                  <a:moveTo>
                    <a:pt x="3319399" y="572135"/>
                  </a:moveTo>
                  <a:lnTo>
                    <a:pt x="3308985" y="572135"/>
                  </a:lnTo>
                  <a:lnTo>
                    <a:pt x="3308985" y="699262"/>
                  </a:lnTo>
                  <a:lnTo>
                    <a:pt x="3319399" y="699262"/>
                  </a:lnTo>
                  <a:lnTo>
                    <a:pt x="3319399" y="572135"/>
                  </a:lnTo>
                  <a:close/>
                </a:path>
                <a:path w="4074159" h="699770">
                  <a:moveTo>
                    <a:pt x="3377438" y="413258"/>
                  </a:moveTo>
                  <a:lnTo>
                    <a:pt x="3367024" y="413258"/>
                  </a:lnTo>
                  <a:lnTo>
                    <a:pt x="3367024" y="699262"/>
                  </a:lnTo>
                  <a:lnTo>
                    <a:pt x="3377438" y="699262"/>
                  </a:lnTo>
                  <a:lnTo>
                    <a:pt x="3377438" y="413258"/>
                  </a:lnTo>
                  <a:close/>
                </a:path>
                <a:path w="4074159" h="699770">
                  <a:moveTo>
                    <a:pt x="3435477" y="508508"/>
                  </a:moveTo>
                  <a:lnTo>
                    <a:pt x="3425063" y="508508"/>
                  </a:lnTo>
                  <a:lnTo>
                    <a:pt x="3425063" y="699262"/>
                  </a:lnTo>
                  <a:lnTo>
                    <a:pt x="3435477" y="699262"/>
                  </a:lnTo>
                  <a:lnTo>
                    <a:pt x="3435477" y="508508"/>
                  </a:lnTo>
                  <a:close/>
                </a:path>
                <a:path w="4074159" h="699770">
                  <a:moveTo>
                    <a:pt x="3493516" y="572135"/>
                  </a:moveTo>
                  <a:lnTo>
                    <a:pt x="3483102" y="572135"/>
                  </a:lnTo>
                  <a:lnTo>
                    <a:pt x="3483102" y="699262"/>
                  </a:lnTo>
                  <a:lnTo>
                    <a:pt x="3493516" y="699262"/>
                  </a:lnTo>
                  <a:lnTo>
                    <a:pt x="3493516" y="572135"/>
                  </a:lnTo>
                  <a:close/>
                </a:path>
                <a:path w="4074159" h="699770">
                  <a:moveTo>
                    <a:pt x="3551555" y="572135"/>
                  </a:moveTo>
                  <a:lnTo>
                    <a:pt x="3541141" y="572135"/>
                  </a:lnTo>
                  <a:lnTo>
                    <a:pt x="3541141" y="699262"/>
                  </a:lnTo>
                  <a:lnTo>
                    <a:pt x="3551555" y="699262"/>
                  </a:lnTo>
                  <a:lnTo>
                    <a:pt x="3551555" y="572135"/>
                  </a:lnTo>
                  <a:close/>
                </a:path>
                <a:path w="4074159" h="699770">
                  <a:moveTo>
                    <a:pt x="3609594" y="349631"/>
                  </a:moveTo>
                  <a:lnTo>
                    <a:pt x="3599180" y="349631"/>
                  </a:lnTo>
                  <a:lnTo>
                    <a:pt x="3599180" y="699262"/>
                  </a:lnTo>
                  <a:lnTo>
                    <a:pt x="3609594" y="699262"/>
                  </a:lnTo>
                  <a:lnTo>
                    <a:pt x="3609594" y="349631"/>
                  </a:lnTo>
                  <a:close/>
                </a:path>
                <a:path w="4074159" h="699770">
                  <a:moveTo>
                    <a:pt x="3667633" y="413258"/>
                  </a:moveTo>
                  <a:lnTo>
                    <a:pt x="3657219" y="413258"/>
                  </a:lnTo>
                  <a:lnTo>
                    <a:pt x="3657219" y="699262"/>
                  </a:lnTo>
                  <a:lnTo>
                    <a:pt x="3667633" y="699262"/>
                  </a:lnTo>
                  <a:lnTo>
                    <a:pt x="3667633" y="413258"/>
                  </a:lnTo>
                  <a:close/>
                </a:path>
                <a:path w="4074159" h="699770">
                  <a:moveTo>
                    <a:pt x="3725672" y="508508"/>
                  </a:moveTo>
                  <a:lnTo>
                    <a:pt x="3715258" y="508508"/>
                  </a:lnTo>
                  <a:lnTo>
                    <a:pt x="3715258" y="699262"/>
                  </a:lnTo>
                  <a:lnTo>
                    <a:pt x="3725672" y="699262"/>
                  </a:lnTo>
                  <a:lnTo>
                    <a:pt x="3725672" y="508508"/>
                  </a:lnTo>
                  <a:close/>
                </a:path>
                <a:path w="4074159" h="699770">
                  <a:moveTo>
                    <a:pt x="3783711" y="413258"/>
                  </a:moveTo>
                  <a:lnTo>
                    <a:pt x="3773297" y="413258"/>
                  </a:lnTo>
                  <a:lnTo>
                    <a:pt x="3773297" y="699262"/>
                  </a:lnTo>
                  <a:lnTo>
                    <a:pt x="3783711" y="699262"/>
                  </a:lnTo>
                  <a:lnTo>
                    <a:pt x="3783711" y="413258"/>
                  </a:lnTo>
                  <a:close/>
                </a:path>
                <a:path w="4074159" h="699770">
                  <a:moveTo>
                    <a:pt x="3841877" y="476758"/>
                  </a:moveTo>
                  <a:lnTo>
                    <a:pt x="3831463" y="476758"/>
                  </a:lnTo>
                  <a:lnTo>
                    <a:pt x="3831463" y="699262"/>
                  </a:lnTo>
                  <a:lnTo>
                    <a:pt x="3841877" y="699262"/>
                  </a:lnTo>
                  <a:lnTo>
                    <a:pt x="3841877" y="476758"/>
                  </a:lnTo>
                  <a:close/>
                </a:path>
                <a:path w="4074159" h="699770">
                  <a:moveTo>
                    <a:pt x="3899916" y="508508"/>
                  </a:moveTo>
                  <a:lnTo>
                    <a:pt x="3889502" y="508508"/>
                  </a:lnTo>
                  <a:lnTo>
                    <a:pt x="3889502" y="699262"/>
                  </a:lnTo>
                  <a:lnTo>
                    <a:pt x="3899916" y="699262"/>
                  </a:lnTo>
                  <a:lnTo>
                    <a:pt x="3899916" y="508508"/>
                  </a:lnTo>
                  <a:close/>
                </a:path>
                <a:path w="4074159" h="699770">
                  <a:moveTo>
                    <a:pt x="3957955" y="349631"/>
                  </a:moveTo>
                  <a:lnTo>
                    <a:pt x="3947541" y="349631"/>
                  </a:lnTo>
                  <a:lnTo>
                    <a:pt x="3947541" y="699262"/>
                  </a:lnTo>
                  <a:lnTo>
                    <a:pt x="3957955" y="699262"/>
                  </a:lnTo>
                  <a:lnTo>
                    <a:pt x="3957955" y="349631"/>
                  </a:lnTo>
                  <a:close/>
                </a:path>
                <a:path w="4074159" h="699770">
                  <a:moveTo>
                    <a:pt x="4015994" y="349631"/>
                  </a:moveTo>
                  <a:lnTo>
                    <a:pt x="4005580" y="349631"/>
                  </a:lnTo>
                  <a:lnTo>
                    <a:pt x="4005580" y="699262"/>
                  </a:lnTo>
                  <a:lnTo>
                    <a:pt x="4015994" y="699262"/>
                  </a:lnTo>
                  <a:lnTo>
                    <a:pt x="4015994" y="349631"/>
                  </a:lnTo>
                  <a:close/>
                </a:path>
                <a:path w="4074159" h="699770">
                  <a:moveTo>
                    <a:pt x="4074033" y="445008"/>
                  </a:moveTo>
                  <a:lnTo>
                    <a:pt x="4063619" y="445008"/>
                  </a:lnTo>
                  <a:lnTo>
                    <a:pt x="4063619" y="699262"/>
                  </a:lnTo>
                  <a:lnTo>
                    <a:pt x="4074033" y="699262"/>
                  </a:lnTo>
                  <a:lnTo>
                    <a:pt x="4074033" y="445008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6" name="object 136" descr=""/>
            <p:cNvSpPr/>
            <p:nvPr/>
          </p:nvSpPr>
          <p:spPr>
            <a:xfrm>
              <a:off x="9351899" y="8408162"/>
              <a:ext cx="2739390" cy="254635"/>
            </a:xfrm>
            <a:custGeom>
              <a:avLst/>
              <a:gdLst/>
              <a:ahLst/>
              <a:cxnLst/>
              <a:rect l="l" t="t" r="r" b="b"/>
              <a:pathLst>
                <a:path w="2739390" h="254634">
                  <a:moveTo>
                    <a:pt x="10414" y="0"/>
                  </a:moveTo>
                  <a:lnTo>
                    <a:pt x="0" y="0"/>
                  </a:lnTo>
                  <a:lnTo>
                    <a:pt x="0" y="254254"/>
                  </a:lnTo>
                  <a:lnTo>
                    <a:pt x="10414" y="254254"/>
                  </a:lnTo>
                  <a:lnTo>
                    <a:pt x="10414" y="0"/>
                  </a:lnTo>
                  <a:close/>
                </a:path>
                <a:path w="2739390" h="254634">
                  <a:moveTo>
                    <a:pt x="68453" y="127127"/>
                  </a:moveTo>
                  <a:lnTo>
                    <a:pt x="58039" y="127127"/>
                  </a:lnTo>
                  <a:lnTo>
                    <a:pt x="58039" y="254254"/>
                  </a:lnTo>
                  <a:lnTo>
                    <a:pt x="68453" y="254254"/>
                  </a:lnTo>
                  <a:lnTo>
                    <a:pt x="68453" y="127127"/>
                  </a:lnTo>
                  <a:close/>
                </a:path>
                <a:path w="2739390" h="254634">
                  <a:moveTo>
                    <a:pt x="126492" y="127127"/>
                  </a:moveTo>
                  <a:lnTo>
                    <a:pt x="116078" y="127127"/>
                  </a:lnTo>
                  <a:lnTo>
                    <a:pt x="116078" y="254254"/>
                  </a:lnTo>
                  <a:lnTo>
                    <a:pt x="126492" y="254254"/>
                  </a:lnTo>
                  <a:lnTo>
                    <a:pt x="126492" y="127127"/>
                  </a:lnTo>
                  <a:close/>
                </a:path>
                <a:path w="2739390" h="254634">
                  <a:moveTo>
                    <a:pt x="184531" y="95377"/>
                  </a:moveTo>
                  <a:lnTo>
                    <a:pt x="174117" y="95377"/>
                  </a:lnTo>
                  <a:lnTo>
                    <a:pt x="174117" y="254254"/>
                  </a:lnTo>
                  <a:lnTo>
                    <a:pt x="184531" y="254254"/>
                  </a:lnTo>
                  <a:lnTo>
                    <a:pt x="184531" y="95377"/>
                  </a:lnTo>
                  <a:close/>
                </a:path>
                <a:path w="2739390" h="254634">
                  <a:moveTo>
                    <a:pt x="242570" y="190627"/>
                  </a:moveTo>
                  <a:lnTo>
                    <a:pt x="232156" y="190627"/>
                  </a:lnTo>
                  <a:lnTo>
                    <a:pt x="232156" y="254254"/>
                  </a:lnTo>
                  <a:lnTo>
                    <a:pt x="242570" y="254254"/>
                  </a:lnTo>
                  <a:lnTo>
                    <a:pt x="242570" y="190627"/>
                  </a:lnTo>
                  <a:close/>
                </a:path>
                <a:path w="2739390" h="254634">
                  <a:moveTo>
                    <a:pt x="300736" y="63500"/>
                  </a:moveTo>
                  <a:lnTo>
                    <a:pt x="290322" y="63500"/>
                  </a:lnTo>
                  <a:lnTo>
                    <a:pt x="290322" y="254254"/>
                  </a:lnTo>
                  <a:lnTo>
                    <a:pt x="300736" y="254254"/>
                  </a:lnTo>
                  <a:lnTo>
                    <a:pt x="300736" y="63500"/>
                  </a:lnTo>
                  <a:close/>
                </a:path>
                <a:path w="2739390" h="254634">
                  <a:moveTo>
                    <a:pt x="358775" y="63500"/>
                  </a:moveTo>
                  <a:lnTo>
                    <a:pt x="348361" y="63500"/>
                  </a:lnTo>
                  <a:lnTo>
                    <a:pt x="348361" y="254254"/>
                  </a:lnTo>
                  <a:lnTo>
                    <a:pt x="358775" y="254254"/>
                  </a:lnTo>
                  <a:lnTo>
                    <a:pt x="358775" y="63500"/>
                  </a:lnTo>
                  <a:close/>
                </a:path>
                <a:path w="2739390" h="254634">
                  <a:moveTo>
                    <a:pt x="416814" y="0"/>
                  </a:moveTo>
                  <a:lnTo>
                    <a:pt x="406400" y="0"/>
                  </a:lnTo>
                  <a:lnTo>
                    <a:pt x="406400" y="254254"/>
                  </a:lnTo>
                  <a:lnTo>
                    <a:pt x="416814" y="254254"/>
                  </a:lnTo>
                  <a:lnTo>
                    <a:pt x="416814" y="0"/>
                  </a:lnTo>
                  <a:close/>
                </a:path>
                <a:path w="2739390" h="254634">
                  <a:moveTo>
                    <a:pt x="474853" y="95377"/>
                  </a:moveTo>
                  <a:lnTo>
                    <a:pt x="464439" y="95377"/>
                  </a:lnTo>
                  <a:lnTo>
                    <a:pt x="464439" y="254254"/>
                  </a:lnTo>
                  <a:lnTo>
                    <a:pt x="474853" y="254254"/>
                  </a:lnTo>
                  <a:lnTo>
                    <a:pt x="474853" y="95377"/>
                  </a:lnTo>
                  <a:close/>
                </a:path>
                <a:path w="2739390" h="254634">
                  <a:moveTo>
                    <a:pt x="532892" y="158877"/>
                  </a:moveTo>
                  <a:lnTo>
                    <a:pt x="522478" y="158877"/>
                  </a:lnTo>
                  <a:lnTo>
                    <a:pt x="522478" y="254254"/>
                  </a:lnTo>
                  <a:lnTo>
                    <a:pt x="532892" y="254254"/>
                  </a:lnTo>
                  <a:lnTo>
                    <a:pt x="532892" y="158877"/>
                  </a:lnTo>
                  <a:close/>
                </a:path>
                <a:path w="2739390" h="254634">
                  <a:moveTo>
                    <a:pt x="590931" y="127127"/>
                  </a:moveTo>
                  <a:lnTo>
                    <a:pt x="580517" y="127127"/>
                  </a:lnTo>
                  <a:lnTo>
                    <a:pt x="580517" y="254254"/>
                  </a:lnTo>
                  <a:lnTo>
                    <a:pt x="590931" y="254254"/>
                  </a:lnTo>
                  <a:lnTo>
                    <a:pt x="590931" y="127127"/>
                  </a:lnTo>
                  <a:close/>
                </a:path>
                <a:path w="2739390" h="254634">
                  <a:moveTo>
                    <a:pt x="648970" y="63500"/>
                  </a:moveTo>
                  <a:lnTo>
                    <a:pt x="638556" y="63500"/>
                  </a:lnTo>
                  <a:lnTo>
                    <a:pt x="638556" y="254254"/>
                  </a:lnTo>
                  <a:lnTo>
                    <a:pt x="648970" y="254254"/>
                  </a:lnTo>
                  <a:lnTo>
                    <a:pt x="648970" y="63500"/>
                  </a:lnTo>
                  <a:close/>
                </a:path>
                <a:path w="2739390" h="254634">
                  <a:moveTo>
                    <a:pt x="707009" y="95377"/>
                  </a:moveTo>
                  <a:lnTo>
                    <a:pt x="696595" y="95377"/>
                  </a:lnTo>
                  <a:lnTo>
                    <a:pt x="696595" y="254254"/>
                  </a:lnTo>
                  <a:lnTo>
                    <a:pt x="707009" y="254254"/>
                  </a:lnTo>
                  <a:lnTo>
                    <a:pt x="707009" y="95377"/>
                  </a:lnTo>
                  <a:close/>
                </a:path>
                <a:path w="2739390" h="254634">
                  <a:moveTo>
                    <a:pt x="823087" y="158877"/>
                  </a:moveTo>
                  <a:lnTo>
                    <a:pt x="812673" y="158877"/>
                  </a:lnTo>
                  <a:lnTo>
                    <a:pt x="812673" y="254254"/>
                  </a:lnTo>
                  <a:lnTo>
                    <a:pt x="823087" y="254254"/>
                  </a:lnTo>
                  <a:lnTo>
                    <a:pt x="823087" y="158877"/>
                  </a:lnTo>
                  <a:close/>
                </a:path>
                <a:path w="2739390" h="254634">
                  <a:moveTo>
                    <a:pt x="881253" y="0"/>
                  </a:moveTo>
                  <a:lnTo>
                    <a:pt x="870839" y="0"/>
                  </a:lnTo>
                  <a:lnTo>
                    <a:pt x="870839" y="254254"/>
                  </a:lnTo>
                  <a:lnTo>
                    <a:pt x="881253" y="254254"/>
                  </a:lnTo>
                  <a:lnTo>
                    <a:pt x="881253" y="0"/>
                  </a:lnTo>
                  <a:close/>
                </a:path>
                <a:path w="2739390" h="254634">
                  <a:moveTo>
                    <a:pt x="939292" y="222504"/>
                  </a:moveTo>
                  <a:lnTo>
                    <a:pt x="928878" y="222504"/>
                  </a:lnTo>
                  <a:lnTo>
                    <a:pt x="928878" y="254254"/>
                  </a:lnTo>
                  <a:lnTo>
                    <a:pt x="939292" y="254254"/>
                  </a:lnTo>
                  <a:lnTo>
                    <a:pt x="939292" y="222504"/>
                  </a:lnTo>
                  <a:close/>
                </a:path>
                <a:path w="2739390" h="254634">
                  <a:moveTo>
                    <a:pt x="997331" y="63500"/>
                  </a:moveTo>
                  <a:lnTo>
                    <a:pt x="986917" y="63500"/>
                  </a:lnTo>
                  <a:lnTo>
                    <a:pt x="986917" y="254254"/>
                  </a:lnTo>
                  <a:lnTo>
                    <a:pt x="997331" y="254254"/>
                  </a:lnTo>
                  <a:lnTo>
                    <a:pt x="997331" y="63500"/>
                  </a:lnTo>
                  <a:close/>
                </a:path>
                <a:path w="2739390" h="254634">
                  <a:moveTo>
                    <a:pt x="1055370" y="0"/>
                  </a:moveTo>
                  <a:lnTo>
                    <a:pt x="1044956" y="0"/>
                  </a:lnTo>
                  <a:lnTo>
                    <a:pt x="1044956" y="254254"/>
                  </a:lnTo>
                  <a:lnTo>
                    <a:pt x="1055370" y="254254"/>
                  </a:lnTo>
                  <a:lnTo>
                    <a:pt x="1055370" y="0"/>
                  </a:lnTo>
                  <a:close/>
                </a:path>
                <a:path w="2739390" h="254634">
                  <a:moveTo>
                    <a:pt x="1113409" y="95377"/>
                  </a:moveTo>
                  <a:lnTo>
                    <a:pt x="1102995" y="95377"/>
                  </a:lnTo>
                  <a:lnTo>
                    <a:pt x="1102995" y="254254"/>
                  </a:lnTo>
                  <a:lnTo>
                    <a:pt x="1113409" y="254254"/>
                  </a:lnTo>
                  <a:lnTo>
                    <a:pt x="1113409" y="95377"/>
                  </a:lnTo>
                  <a:close/>
                </a:path>
                <a:path w="2739390" h="254634">
                  <a:moveTo>
                    <a:pt x="1171448" y="95377"/>
                  </a:moveTo>
                  <a:lnTo>
                    <a:pt x="1161034" y="95377"/>
                  </a:lnTo>
                  <a:lnTo>
                    <a:pt x="1161034" y="254254"/>
                  </a:lnTo>
                  <a:lnTo>
                    <a:pt x="1171448" y="254254"/>
                  </a:lnTo>
                  <a:lnTo>
                    <a:pt x="1171448" y="95377"/>
                  </a:lnTo>
                  <a:close/>
                </a:path>
                <a:path w="2739390" h="254634">
                  <a:moveTo>
                    <a:pt x="1229601" y="190627"/>
                  </a:moveTo>
                  <a:lnTo>
                    <a:pt x="1216533" y="190627"/>
                  </a:lnTo>
                  <a:lnTo>
                    <a:pt x="1216533" y="254254"/>
                  </a:lnTo>
                  <a:lnTo>
                    <a:pt x="1229601" y="254254"/>
                  </a:lnTo>
                  <a:lnTo>
                    <a:pt x="1229601" y="190627"/>
                  </a:lnTo>
                  <a:close/>
                </a:path>
                <a:path w="2739390" h="254634">
                  <a:moveTo>
                    <a:pt x="1287526" y="127127"/>
                  </a:moveTo>
                  <a:lnTo>
                    <a:pt x="1277112" y="127127"/>
                  </a:lnTo>
                  <a:lnTo>
                    <a:pt x="1277112" y="254254"/>
                  </a:lnTo>
                  <a:lnTo>
                    <a:pt x="1287526" y="254254"/>
                  </a:lnTo>
                  <a:lnTo>
                    <a:pt x="1287526" y="127127"/>
                  </a:lnTo>
                  <a:close/>
                </a:path>
                <a:path w="2739390" h="254634">
                  <a:moveTo>
                    <a:pt x="1345565" y="158877"/>
                  </a:moveTo>
                  <a:lnTo>
                    <a:pt x="1335151" y="158877"/>
                  </a:lnTo>
                  <a:lnTo>
                    <a:pt x="1335151" y="254254"/>
                  </a:lnTo>
                  <a:lnTo>
                    <a:pt x="1345565" y="254254"/>
                  </a:lnTo>
                  <a:lnTo>
                    <a:pt x="1345565" y="158877"/>
                  </a:lnTo>
                  <a:close/>
                </a:path>
                <a:path w="2739390" h="254634">
                  <a:moveTo>
                    <a:pt x="1403731" y="127127"/>
                  </a:moveTo>
                  <a:lnTo>
                    <a:pt x="1393317" y="127127"/>
                  </a:lnTo>
                  <a:lnTo>
                    <a:pt x="1393317" y="254254"/>
                  </a:lnTo>
                  <a:lnTo>
                    <a:pt x="1403731" y="254254"/>
                  </a:lnTo>
                  <a:lnTo>
                    <a:pt x="1403731" y="127127"/>
                  </a:lnTo>
                  <a:close/>
                </a:path>
                <a:path w="2739390" h="254634">
                  <a:moveTo>
                    <a:pt x="1461770" y="158877"/>
                  </a:moveTo>
                  <a:lnTo>
                    <a:pt x="1451356" y="158877"/>
                  </a:lnTo>
                  <a:lnTo>
                    <a:pt x="1451356" y="254254"/>
                  </a:lnTo>
                  <a:lnTo>
                    <a:pt x="1461770" y="254254"/>
                  </a:lnTo>
                  <a:lnTo>
                    <a:pt x="1461770" y="158877"/>
                  </a:lnTo>
                  <a:close/>
                </a:path>
                <a:path w="2739390" h="254634">
                  <a:moveTo>
                    <a:pt x="1519809" y="190627"/>
                  </a:moveTo>
                  <a:lnTo>
                    <a:pt x="1509395" y="190627"/>
                  </a:lnTo>
                  <a:lnTo>
                    <a:pt x="1509395" y="254254"/>
                  </a:lnTo>
                  <a:lnTo>
                    <a:pt x="1519809" y="254254"/>
                  </a:lnTo>
                  <a:lnTo>
                    <a:pt x="1519809" y="190627"/>
                  </a:lnTo>
                  <a:close/>
                </a:path>
                <a:path w="2739390" h="254634">
                  <a:moveTo>
                    <a:pt x="1577848" y="190627"/>
                  </a:moveTo>
                  <a:lnTo>
                    <a:pt x="1567434" y="190627"/>
                  </a:lnTo>
                  <a:lnTo>
                    <a:pt x="1567434" y="254254"/>
                  </a:lnTo>
                  <a:lnTo>
                    <a:pt x="1577848" y="254254"/>
                  </a:lnTo>
                  <a:lnTo>
                    <a:pt x="1577848" y="190627"/>
                  </a:lnTo>
                  <a:close/>
                </a:path>
                <a:path w="2739390" h="254634">
                  <a:moveTo>
                    <a:pt x="1635887" y="63500"/>
                  </a:moveTo>
                  <a:lnTo>
                    <a:pt x="1625473" y="63500"/>
                  </a:lnTo>
                  <a:lnTo>
                    <a:pt x="1625473" y="254254"/>
                  </a:lnTo>
                  <a:lnTo>
                    <a:pt x="1635887" y="254254"/>
                  </a:lnTo>
                  <a:lnTo>
                    <a:pt x="1635887" y="63500"/>
                  </a:lnTo>
                  <a:close/>
                </a:path>
                <a:path w="2739390" h="254634">
                  <a:moveTo>
                    <a:pt x="1693926" y="127127"/>
                  </a:moveTo>
                  <a:lnTo>
                    <a:pt x="1683512" y="127127"/>
                  </a:lnTo>
                  <a:lnTo>
                    <a:pt x="1683512" y="254254"/>
                  </a:lnTo>
                  <a:lnTo>
                    <a:pt x="1693926" y="254254"/>
                  </a:lnTo>
                  <a:lnTo>
                    <a:pt x="1693926" y="127127"/>
                  </a:lnTo>
                  <a:close/>
                </a:path>
                <a:path w="2739390" h="254634">
                  <a:moveTo>
                    <a:pt x="1751965" y="190627"/>
                  </a:moveTo>
                  <a:lnTo>
                    <a:pt x="1741551" y="190627"/>
                  </a:lnTo>
                  <a:lnTo>
                    <a:pt x="1741551" y="254254"/>
                  </a:lnTo>
                  <a:lnTo>
                    <a:pt x="1751965" y="254254"/>
                  </a:lnTo>
                  <a:lnTo>
                    <a:pt x="1751965" y="190627"/>
                  </a:lnTo>
                  <a:close/>
                </a:path>
                <a:path w="2739390" h="254634">
                  <a:moveTo>
                    <a:pt x="1810131" y="127127"/>
                  </a:moveTo>
                  <a:lnTo>
                    <a:pt x="1797050" y="127127"/>
                  </a:lnTo>
                  <a:lnTo>
                    <a:pt x="1797050" y="254254"/>
                  </a:lnTo>
                  <a:lnTo>
                    <a:pt x="1810131" y="254254"/>
                  </a:lnTo>
                  <a:lnTo>
                    <a:pt x="1810131" y="127127"/>
                  </a:lnTo>
                  <a:close/>
                </a:path>
                <a:path w="2739390" h="254634">
                  <a:moveTo>
                    <a:pt x="1868043" y="222504"/>
                  </a:moveTo>
                  <a:lnTo>
                    <a:pt x="1857629" y="222504"/>
                  </a:lnTo>
                  <a:lnTo>
                    <a:pt x="1857629" y="254254"/>
                  </a:lnTo>
                  <a:lnTo>
                    <a:pt x="1868043" y="254254"/>
                  </a:lnTo>
                  <a:lnTo>
                    <a:pt x="1868043" y="222504"/>
                  </a:lnTo>
                  <a:close/>
                </a:path>
                <a:path w="2739390" h="254634">
                  <a:moveTo>
                    <a:pt x="1926209" y="158877"/>
                  </a:moveTo>
                  <a:lnTo>
                    <a:pt x="1915795" y="158877"/>
                  </a:lnTo>
                  <a:lnTo>
                    <a:pt x="1915795" y="254254"/>
                  </a:lnTo>
                  <a:lnTo>
                    <a:pt x="1926209" y="254254"/>
                  </a:lnTo>
                  <a:lnTo>
                    <a:pt x="1926209" y="158877"/>
                  </a:lnTo>
                  <a:close/>
                </a:path>
                <a:path w="2739390" h="254634">
                  <a:moveTo>
                    <a:pt x="1984248" y="158877"/>
                  </a:moveTo>
                  <a:lnTo>
                    <a:pt x="1973834" y="158877"/>
                  </a:lnTo>
                  <a:lnTo>
                    <a:pt x="1973834" y="254254"/>
                  </a:lnTo>
                  <a:lnTo>
                    <a:pt x="1984248" y="254254"/>
                  </a:lnTo>
                  <a:lnTo>
                    <a:pt x="1984248" y="158877"/>
                  </a:lnTo>
                  <a:close/>
                </a:path>
                <a:path w="2739390" h="254634">
                  <a:moveTo>
                    <a:pt x="2042287" y="95377"/>
                  </a:moveTo>
                  <a:lnTo>
                    <a:pt x="2031873" y="95377"/>
                  </a:lnTo>
                  <a:lnTo>
                    <a:pt x="2031873" y="254254"/>
                  </a:lnTo>
                  <a:lnTo>
                    <a:pt x="2042287" y="254254"/>
                  </a:lnTo>
                  <a:lnTo>
                    <a:pt x="2042287" y="95377"/>
                  </a:lnTo>
                  <a:close/>
                </a:path>
                <a:path w="2739390" h="254634">
                  <a:moveTo>
                    <a:pt x="2100326" y="127127"/>
                  </a:moveTo>
                  <a:lnTo>
                    <a:pt x="2089912" y="127127"/>
                  </a:lnTo>
                  <a:lnTo>
                    <a:pt x="2089912" y="254254"/>
                  </a:lnTo>
                  <a:lnTo>
                    <a:pt x="2100326" y="254254"/>
                  </a:lnTo>
                  <a:lnTo>
                    <a:pt x="2100326" y="127127"/>
                  </a:lnTo>
                  <a:close/>
                </a:path>
                <a:path w="2739390" h="254634">
                  <a:moveTo>
                    <a:pt x="2158365" y="158877"/>
                  </a:moveTo>
                  <a:lnTo>
                    <a:pt x="2147951" y="158877"/>
                  </a:lnTo>
                  <a:lnTo>
                    <a:pt x="2147951" y="254254"/>
                  </a:lnTo>
                  <a:lnTo>
                    <a:pt x="2158365" y="254254"/>
                  </a:lnTo>
                  <a:lnTo>
                    <a:pt x="2158365" y="158877"/>
                  </a:lnTo>
                  <a:close/>
                </a:path>
                <a:path w="2739390" h="254634">
                  <a:moveTo>
                    <a:pt x="2216404" y="127127"/>
                  </a:moveTo>
                  <a:lnTo>
                    <a:pt x="2205990" y="127127"/>
                  </a:lnTo>
                  <a:lnTo>
                    <a:pt x="2205990" y="254254"/>
                  </a:lnTo>
                  <a:lnTo>
                    <a:pt x="2216404" y="254254"/>
                  </a:lnTo>
                  <a:lnTo>
                    <a:pt x="2216404" y="127127"/>
                  </a:lnTo>
                  <a:close/>
                </a:path>
                <a:path w="2739390" h="254634">
                  <a:moveTo>
                    <a:pt x="2274443" y="127127"/>
                  </a:moveTo>
                  <a:lnTo>
                    <a:pt x="2264029" y="127127"/>
                  </a:lnTo>
                  <a:lnTo>
                    <a:pt x="2264029" y="254254"/>
                  </a:lnTo>
                  <a:lnTo>
                    <a:pt x="2274443" y="254254"/>
                  </a:lnTo>
                  <a:lnTo>
                    <a:pt x="2274443" y="127127"/>
                  </a:lnTo>
                  <a:close/>
                </a:path>
                <a:path w="2739390" h="254634">
                  <a:moveTo>
                    <a:pt x="2332482" y="190627"/>
                  </a:moveTo>
                  <a:lnTo>
                    <a:pt x="2322068" y="190627"/>
                  </a:lnTo>
                  <a:lnTo>
                    <a:pt x="2322068" y="254254"/>
                  </a:lnTo>
                  <a:lnTo>
                    <a:pt x="2332482" y="254254"/>
                  </a:lnTo>
                  <a:lnTo>
                    <a:pt x="2332482" y="190627"/>
                  </a:lnTo>
                  <a:close/>
                </a:path>
                <a:path w="2739390" h="254634">
                  <a:moveTo>
                    <a:pt x="2390648" y="158877"/>
                  </a:moveTo>
                  <a:lnTo>
                    <a:pt x="2377567" y="158877"/>
                  </a:lnTo>
                  <a:lnTo>
                    <a:pt x="2377567" y="254254"/>
                  </a:lnTo>
                  <a:lnTo>
                    <a:pt x="2390648" y="254254"/>
                  </a:lnTo>
                  <a:lnTo>
                    <a:pt x="2390648" y="158877"/>
                  </a:lnTo>
                  <a:close/>
                </a:path>
                <a:path w="2739390" h="254634">
                  <a:moveTo>
                    <a:pt x="2448560" y="222504"/>
                  </a:moveTo>
                  <a:lnTo>
                    <a:pt x="2438146" y="222504"/>
                  </a:lnTo>
                  <a:lnTo>
                    <a:pt x="2438146" y="254254"/>
                  </a:lnTo>
                  <a:lnTo>
                    <a:pt x="2448560" y="254254"/>
                  </a:lnTo>
                  <a:lnTo>
                    <a:pt x="2448560" y="222504"/>
                  </a:lnTo>
                  <a:close/>
                </a:path>
                <a:path w="2739390" h="254634">
                  <a:moveTo>
                    <a:pt x="2506726" y="190627"/>
                  </a:moveTo>
                  <a:lnTo>
                    <a:pt x="2496312" y="190627"/>
                  </a:lnTo>
                  <a:lnTo>
                    <a:pt x="2496312" y="254254"/>
                  </a:lnTo>
                  <a:lnTo>
                    <a:pt x="2506726" y="254254"/>
                  </a:lnTo>
                  <a:lnTo>
                    <a:pt x="2506726" y="190627"/>
                  </a:lnTo>
                  <a:close/>
                </a:path>
                <a:path w="2739390" h="254634">
                  <a:moveTo>
                    <a:pt x="2564752" y="190627"/>
                  </a:moveTo>
                  <a:lnTo>
                    <a:pt x="2551684" y="190627"/>
                  </a:lnTo>
                  <a:lnTo>
                    <a:pt x="2551684" y="254254"/>
                  </a:lnTo>
                  <a:lnTo>
                    <a:pt x="2564752" y="254254"/>
                  </a:lnTo>
                  <a:lnTo>
                    <a:pt x="2564752" y="190627"/>
                  </a:lnTo>
                  <a:close/>
                </a:path>
                <a:path w="2739390" h="254634">
                  <a:moveTo>
                    <a:pt x="2622804" y="190627"/>
                  </a:moveTo>
                  <a:lnTo>
                    <a:pt x="2612390" y="190627"/>
                  </a:lnTo>
                  <a:lnTo>
                    <a:pt x="2612390" y="254254"/>
                  </a:lnTo>
                  <a:lnTo>
                    <a:pt x="2622804" y="254254"/>
                  </a:lnTo>
                  <a:lnTo>
                    <a:pt x="2622804" y="190627"/>
                  </a:lnTo>
                  <a:close/>
                </a:path>
                <a:path w="2739390" h="254634">
                  <a:moveTo>
                    <a:pt x="2680843" y="95377"/>
                  </a:moveTo>
                  <a:lnTo>
                    <a:pt x="2670429" y="95377"/>
                  </a:lnTo>
                  <a:lnTo>
                    <a:pt x="2670429" y="254254"/>
                  </a:lnTo>
                  <a:lnTo>
                    <a:pt x="2680843" y="254254"/>
                  </a:lnTo>
                  <a:lnTo>
                    <a:pt x="2680843" y="95377"/>
                  </a:lnTo>
                  <a:close/>
                </a:path>
                <a:path w="2739390" h="254634">
                  <a:moveTo>
                    <a:pt x="2738882" y="95377"/>
                  </a:moveTo>
                  <a:lnTo>
                    <a:pt x="2728468" y="95377"/>
                  </a:lnTo>
                  <a:lnTo>
                    <a:pt x="2728468" y="254254"/>
                  </a:lnTo>
                  <a:lnTo>
                    <a:pt x="2738882" y="254254"/>
                  </a:lnTo>
                  <a:lnTo>
                    <a:pt x="2738882" y="95377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7" name="object 137" descr=""/>
            <p:cNvSpPr/>
            <p:nvPr/>
          </p:nvSpPr>
          <p:spPr>
            <a:xfrm>
              <a:off x="12135865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0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BCA7E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8" name="object 138" descr=""/>
            <p:cNvSpPr/>
            <p:nvPr/>
          </p:nvSpPr>
          <p:spPr>
            <a:xfrm>
              <a:off x="12196445" y="8471662"/>
              <a:ext cx="2100580" cy="191135"/>
            </a:xfrm>
            <a:custGeom>
              <a:avLst/>
              <a:gdLst/>
              <a:ahLst/>
              <a:cxnLst/>
              <a:rect l="l" t="t" r="r" b="b"/>
              <a:pathLst>
                <a:path w="2100580" h="191134">
                  <a:moveTo>
                    <a:pt x="10414" y="63627"/>
                  </a:moveTo>
                  <a:lnTo>
                    <a:pt x="0" y="63627"/>
                  </a:lnTo>
                  <a:lnTo>
                    <a:pt x="0" y="190754"/>
                  </a:lnTo>
                  <a:lnTo>
                    <a:pt x="10414" y="190754"/>
                  </a:lnTo>
                  <a:lnTo>
                    <a:pt x="10414" y="63627"/>
                  </a:lnTo>
                  <a:close/>
                </a:path>
                <a:path w="2100580" h="191134">
                  <a:moveTo>
                    <a:pt x="68453" y="95377"/>
                  </a:moveTo>
                  <a:lnTo>
                    <a:pt x="58039" y="95377"/>
                  </a:lnTo>
                  <a:lnTo>
                    <a:pt x="58039" y="190754"/>
                  </a:lnTo>
                  <a:lnTo>
                    <a:pt x="68453" y="190754"/>
                  </a:lnTo>
                  <a:lnTo>
                    <a:pt x="68453" y="95377"/>
                  </a:lnTo>
                  <a:close/>
                </a:path>
                <a:path w="2100580" h="191134">
                  <a:moveTo>
                    <a:pt x="126492" y="95377"/>
                  </a:moveTo>
                  <a:lnTo>
                    <a:pt x="116078" y="95377"/>
                  </a:lnTo>
                  <a:lnTo>
                    <a:pt x="116078" y="190754"/>
                  </a:lnTo>
                  <a:lnTo>
                    <a:pt x="126492" y="190754"/>
                  </a:lnTo>
                  <a:lnTo>
                    <a:pt x="126492" y="95377"/>
                  </a:lnTo>
                  <a:close/>
                </a:path>
                <a:path w="2100580" h="191134">
                  <a:moveTo>
                    <a:pt x="184658" y="127127"/>
                  </a:moveTo>
                  <a:lnTo>
                    <a:pt x="174244" y="127127"/>
                  </a:lnTo>
                  <a:lnTo>
                    <a:pt x="174244" y="190754"/>
                  </a:lnTo>
                  <a:lnTo>
                    <a:pt x="184658" y="190754"/>
                  </a:lnTo>
                  <a:lnTo>
                    <a:pt x="184658" y="127127"/>
                  </a:lnTo>
                  <a:close/>
                </a:path>
                <a:path w="2100580" h="191134">
                  <a:moveTo>
                    <a:pt x="242697" y="63627"/>
                  </a:moveTo>
                  <a:lnTo>
                    <a:pt x="232283" y="63627"/>
                  </a:lnTo>
                  <a:lnTo>
                    <a:pt x="232283" y="190754"/>
                  </a:lnTo>
                  <a:lnTo>
                    <a:pt x="242697" y="190754"/>
                  </a:lnTo>
                  <a:lnTo>
                    <a:pt x="242697" y="63627"/>
                  </a:lnTo>
                  <a:close/>
                </a:path>
                <a:path w="2100580" h="191134">
                  <a:moveTo>
                    <a:pt x="300736" y="0"/>
                  </a:moveTo>
                  <a:lnTo>
                    <a:pt x="290322" y="0"/>
                  </a:lnTo>
                  <a:lnTo>
                    <a:pt x="290322" y="190754"/>
                  </a:lnTo>
                  <a:lnTo>
                    <a:pt x="300736" y="190754"/>
                  </a:lnTo>
                  <a:lnTo>
                    <a:pt x="300736" y="0"/>
                  </a:lnTo>
                  <a:close/>
                </a:path>
                <a:path w="2100580" h="191134">
                  <a:moveTo>
                    <a:pt x="358775" y="31877"/>
                  </a:moveTo>
                  <a:lnTo>
                    <a:pt x="348361" y="31877"/>
                  </a:lnTo>
                  <a:lnTo>
                    <a:pt x="348361" y="190754"/>
                  </a:lnTo>
                  <a:lnTo>
                    <a:pt x="358775" y="190754"/>
                  </a:lnTo>
                  <a:lnTo>
                    <a:pt x="358775" y="31877"/>
                  </a:lnTo>
                  <a:close/>
                </a:path>
                <a:path w="2100580" h="191134">
                  <a:moveTo>
                    <a:pt x="416814" y="95377"/>
                  </a:moveTo>
                  <a:lnTo>
                    <a:pt x="403733" y="95377"/>
                  </a:lnTo>
                  <a:lnTo>
                    <a:pt x="403733" y="190754"/>
                  </a:lnTo>
                  <a:lnTo>
                    <a:pt x="416814" y="190754"/>
                  </a:lnTo>
                  <a:lnTo>
                    <a:pt x="416814" y="95377"/>
                  </a:lnTo>
                  <a:close/>
                </a:path>
                <a:path w="2100580" h="191134">
                  <a:moveTo>
                    <a:pt x="474980" y="63627"/>
                  </a:moveTo>
                  <a:lnTo>
                    <a:pt x="461899" y="63627"/>
                  </a:lnTo>
                  <a:lnTo>
                    <a:pt x="461899" y="190754"/>
                  </a:lnTo>
                  <a:lnTo>
                    <a:pt x="474980" y="190754"/>
                  </a:lnTo>
                  <a:lnTo>
                    <a:pt x="474980" y="63627"/>
                  </a:lnTo>
                  <a:close/>
                </a:path>
                <a:path w="2100580" h="191134">
                  <a:moveTo>
                    <a:pt x="532892" y="63627"/>
                  </a:moveTo>
                  <a:lnTo>
                    <a:pt x="522478" y="63627"/>
                  </a:lnTo>
                  <a:lnTo>
                    <a:pt x="522478" y="190754"/>
                  </a:lnTo>
                  <a:lnTo>
                    <a:pt x="532892" y="190754"/>
                  </a:lnTo>
                  <a:lnTo>
                    <a:pt x="532892" y="63627"/>
                  </a:lnTo>
                  <a:close/>
                </a:path>
                <a:path w="2100580" h="191134">
                  <a:moveTo>
                    <a:pt x="590931" y="95377"/>
                  </a:moveTo>
                  <a:lnTo>
                    <a:pt x="580517" y="95377"/>
                  </a:lnTo>
                  <a:lnTo>
                    <a:pt x="580517" y="190754"/>
                  </a:lnTo>
                  <a:lnTo>
                    <a:pt x="590931" y="190754"/>
                  </a:lnTo>
                  <a:lnTo>
                    <a:pt x="590931" y="95377"/>
                  </a:lnTo>
                  <a:close/>
                </a:path>
                <a:path w="2100580" h="191134">
                  <a:moveTo>
                    <a:pt x="648970" y="95377"/>
                  </a:moveTo>
                  <a:lnTo>
                    <a:pt x="638556" y="95377"/>
                  </a:lnTo>
                  <a:lnTo>
                    <a:pt x="638556" y="190754"/>
                  </a:lnTo>
                  <a:lnTo>
                    <a:pt x="648970" y="190754"/>
                  </a:lnTo>
                  <a:lnTo>
                    <a:pt x="648970" y="95377"/>
                  </a:lnTo>
                  <a:close/>
                </a:path>
                <a:path w="2100580" h="191134">
                  <a:moveTo>
                    <a:pt x="707136" y="95377"/>
                  </a:moveTo>
                  <a:lnTo>
                    <a:pt x="696722" y="95377"/>
                  </a:lnTo>
                  <a:lnTo>
                    <a:pt x="696722" y="190754"/>
                  </a:lnTo>
                  <a:lnTo>
                    <a:pt x="707136" y="190754"/>
                  </a:lnTo>
                  <a:lnTo>
                    <a:pt x="707136" y="95377"/>
                  </a:lnTo>
                  <a:close/>
                </a:path>
                <a:path w="2100580" h="191134">
                  <a:moveTo>
                    <a:pt x="765175" y="31877"/>
                  </a:moveTo>
                  <a:lnTo>
                    <a:pt x="754761" y="31877"/>
                  </a:lnTo>
                  <a:lnTo>
                    <a:pt x="754761" y="190754"/>
                  </a:lnTo>
                  <a:lnTo>
                    <a:pt x="765175" y="190754"/>
                  </a:lnTo>
                  <a:lnTo>
                    <a:pt x="765175" y="31877"/>
                  </a:lnTo>
                  <a:close/>
                </a:path>
                <a:path w="2100580" h="191134">
                  <a:moveTo>
                    <a:pt x="823201" y="31877"/>
                  </a:moveTo>
                  <a:lnTo>
                    <a:pt x="812787" y="31877"/>
                  </a:lnTo>
                  <a:lnTo>
                    <a:pt x="812787" y="190754"/>
                  </a:lnTo>
                  <a:lnTo>
                    <a:pt x="823201" y="190754"/>
                  </a:lnTo>
                  <a:lnTo>
                    <a:pt x="823201" y="31877"/>
                  </a:lnTo>
                  <a:close/>
                </a:path>
                <a:path w="2100580" h="191134">
                  <a:moveTo>
                    <a:pt x="881253" y="159004"/>
                  </a:moveTo>
                  <a:lnTo>
                    <a:pt x="870839" y="159004"/>
                  </a:lnTo>
                  <a:lnTo>
                    <a:pt x="870839" y="190754"/>
                  </a:lnTo>
                  <a:lnTo>
                    <a:pt x="881253" y="190754"/>
                  </a:lnTo>
                  <a:lnTo>
                    <a:pt x="881253" y="159004"/>
                  </a:lnTo>
                  <a:close/>
                </a:path>
                <a:path w="2100580" h="191134">
                  <a:moveTo>
                    <a:pt x="939292" y="63627"/>
                  </a:moveTo>
                  <a:lnTo>
                    <a:pt x="926211" y="63627"/>
                  </a:lnTo>
                  <a:lnTo>
                    <a:pt x="926211" y="190754"/>
                  </a:lnTo>
                  <a:lnTo>
                    <a:pt x="939292" y="190754"/>
                  </a:lnTo>
                  <a:lnTo>
                    <a:pt x="939292" y="63627"/>
                  </a:lnTo>
                  <a:close/>
                </a:path>
                <a:path w="2100580" h="191134">
                  <a:moveTo>
                    <a:pt x="997318" y="95377"/>
                  </a:moveTo>
                  <a:lnTo>
                    <a:pt x="986917" y="95377"/>
                  </a:lnTo>
                  <a:lnTo>
                    <a:pt x="986917" y="190754"/>
                  </a:lnTo>
                  <a:lnTo>
                    <a:pt x="997318" y="190754"/>
                  </a:lnTo>
                  <a:lnTo>
                    <a:pt x="997318" y="95377"/>
                  </a:lnTo>
                  <a:close/>
                </a:path>
                <a:path w="2100580" h="191134">
                  <a:moveTo>
                    <a:pt x="1171575" y="95377"/>
                  </a:moveTo>
                  <a:lnTo>
                    <a:pt x="1158494" y="95377"/>
                  </a:lnTo>
                  <a:lnTo>
                    <a:pt x="1158494" y="190754"/>
                  </a:lnTo>
                  <a:lnTo>
                    <a:pt x="1171575" y="190754"/>
                  </a:lnTo>
                  <a:lnTo>
                    <a:pt x="1171575" y="95377"/>
                  </a:lnTo>
                  <a:close/>
                </a:path>
                <a:path w="2100580" h="191134">
                  <a:moveTo>
                    <a:pt x="1229474" y="127127"/>
                  </a:moveTo>
                  <a:lnTo>
                    <a:pt x="1219073" y="127127"/>
                  </a:lnTo>
                  <a:lnTo>
                    <a:pt x="1219073" y="190754"/>
                  </a:lnTo>
                  <a:lnTo>
                    <a:pt x="1229474" y="190754"/>
                  </a:lnTo>
                  <a:lnTo>
                    <a:pt x="1229474" y="127127"/>
                  </a:lnTo>
                  <a:close/>
                </a:path>
                <a:path w="2100580" h="191134">
                  <a:moveTo>
                    <a:pt x="1287653" y="95377"/>
                  </a:moveTo>
                  <a:lnTo>
                    <a:pt x="1277239" y="95377"/>
                  </a:lnTo>
                  <a:lnTo>
                    <a:pt x="1277239" y="190754"/>
                  </a:lnTo>
                  <a:lnTo>
                    <a:pt x="1287653" y="190754"/>
                  </a:lnTo>
                  <a:lnTo>
                    <a:pt x="1287653" y="95377"/>
                  </a:lnTo>
                  <a:close/>
                </a:path>
                <a:path w="2100580" h="191134">
                  <a:moveTo>
                    <a:pt x="1461770" y="95377"/>
                  </a:moveTo>
                  <a:lnTo>
                    <a:pt x="1448689" y="95377"/>
                  </a:lnTo>
                  <a:lnTo>
                    <a:pt x="1448689" y="190754"/>
                  </a:lnTo>
                  <a:lnTo>
                    <a:pt x="1461770" y="190754"/>
                  </a:lnTo>
                  <a:lnTo>
                    <a:pt x="1461770" y="95377"/>
                  </a:lnTo>
                  <a:close/>
                </a:path>
                <a:path w="2100580" h="191134">
                  <a:moveTo>
                    <a:pt x="1519809" y="95377"/>
                  </a:moveTo>
                  <a:lnTo>
                    <a:pt x="1506728" y="95377"/>
                  </a:lnTo>
                  <a:lnTo>
                    <a:pt x="1506728" y="190754"/>
                  </a:lnTo>
                  <a:lnTo>
                    <a:pt x="1519809" y="190754"/>
                  </a:lnTo>
                  <a:lnTo>
                    <a:pt x="1519809" y="95377"/>
                  </a:lnTo>
                  <a:close/>
                </a:path>
                <a:path w="2100580" h="191134">
                  <a:moveTo>
                    <a:pt x="1577975" y="159004"/>
                  </a:moveTo>
                  <a:lnTo>
                    <a:pt x="1564894" y="159004"/>
                  </a:lnTo>
                  <a:lnTo>
                    <a:pt x="1564894" y="190754"/>
                  </a:lnTo>
                  <a:lnTo>
                    <a:pt x="1577975" y="190754"/>
                  </a:lnTo>
                  <a:lnTo>
                    <a:pt x="1577975" y="159004"/>
                  </a:lnTo>
                  <a:close/>
                </a:path>
                <a:path w="2100580" h="191134">
                  <a:moveTo>
                    <a:pt x="1693926" y="63627"/>
                  </a:moveTo>
                  <a:lnTo>
                    <a:pt x="1683512" y="63627"/>
                  </a:lnTo>
                  <a:lnTo>
                    <a:pt x="1683512" y="190754"/>
                  </a:lnTo>
                  <a:lnTo>
                    <a:pt x="1693926" y="190754"/>
                  </a:lnTo>
                  <a:lnTo>
                    <a:pt x="1693926" y="63627"/>
                  </a:lnTo>
                  <a:close/>
                </a:path>
                <a:path w="2100580" h="191134">
                  <a:moveTo>
                    <a:pt x="1751965" y="159004"/>
                  </a:moveTo>
                  <a:lnTo>
                    <a:pt x="1741551" y="159004"/>
                  </a:lnTo>
                  <a:lnTo>
                    <a:pt x="1741551" y="190754"/>
                  </a:lnTo>
                  <a:lnTo>
                    <a:pt x="1751965" y="190754"/>
                  </a:lnTo>
                  <a:lnTo>
                    <a:pt x="1751965" y="159004"/>
                  </a:lnTo>
                  <a:close/>
                </a:path>
                <a:path w="2100580" h="191134">
                  <a:moveTo>
                    <a:pt x="1810118" y="127127"/>
                  </a:moveTo>
                  <a:lnTo>
                    <a:pt x="1799717" y="127127"/>
                  </a:lnTo>
                  <a:lnTo>
                    <a:pt x="1799717" y="190754"/>
                  </a:lnTo>
                  <a:lnTo>
                    <a:pt x="1810118" y="190754"/>
                  </a:lnTo>
                  <a:lnTo>
                    <a:pt x="1810118" y="127127"/>
                  </a:lnTo>
                  <a:close/>
                </a:path>
                <a:path w="2100580" h="191134">
                  <a:moveTo>
                    <a:pt x="1868170" y="95377"/>
                  </a:moveTo>
                  <a:lnTo>
                    <a:pt x="1857756" y="95377"/>
                  </a:lnTo>
                  <a:lnTo>
                    <a:pt x="1857756" y="190754"/>
                  </a:lnTo>
                  <a:lnTo>
                    <a:pt x="1868170" y="190754"/>
                  </a:lnTo>
                  <a:lnTo>
                    <a:pt x="1868170" y="95377"/>
                  </a:lnTo>
                  <a:close/>
                </a:path>
                <a:path w="2100580" h="191134">
                  <a:moveTo>
                    <a:pt x="1926209" y="63627"/>
                  </a:moveTo>
                  <a:lnTo>
                    <a:pt x="1915795" y="63627"/>
                  </a:lnTo>
                  <a:lnTo>
                    <a:pt x="1915795" y="190754"/>
                  </a:lnTo>
                  <a:lnTo>
                    <a:pt x="1926209" y="190754"/>
                  </a:lnTo>
                  <a:lnTo>
                    <a:pt x="1926209" y="63627"/>
                  </a:lnTo>
                  <a:close/>
                </a:path>
                <a:path w="2100580" h="191134">
                  <a:moveTo>
                    <a:pt x="1984248" y="127127"/>
                  </a:moveTo>
                  <a:lnTo>
                    <a:pt x="1973834" y="127127"/>
                  </a:lnTo>
                  <a:lnTo>
                    <a:pt x="1973834" y="190754"/>
                  </a:lnTo>
                  <a:lnTo>
                    <a:pt x="1984248" y="190754"/>
                  </a:lnTo>
                  <a:lnTo>
                    <a:pt x="1984248" y="127127"/>
                  </a:lnTo>
                  <a:close/>
                </a:path>
                <a:path w="2100580" h="191134">
                  <a:moveTo>
                    <a:pt x="2042274" y="127127"/>
                  </a:moveTo>
                  <a:lnTo>
                    <a:pt x="2031873" y="127127"/>
                  </a:lnTo>
                  <a:lnTo>
                    <a:pt x="2031873" y="190754"/>
                  </a:lnTo>
                  <a:lnTo>
                    <a:pt x="2042274" y="190754"/>
                  </a:lnTo>
                  <a:lnTo>
                    <a:pt x="2042274" y="127127"/>
                  </a:lnTo>
                  <a:close/>
                </a:path>
                <a:path w="2100580" h="191134">
                  <a:moveTo>
                    <a:pt x="2100326" y="63627"/>
                  </a:moveTo>
                  <a:lnTo>
                    <a:pt x="2089912" y="63627"/>
                  </a:lnTo>
                  <a:lnTo>
                    <a:pt x="2089912" y="190754"/>
                  </a:lnTo>
                  <a:lnTo>
                    <a:pt x="2100326" y="190754"/>
                  </a:lnTo>
                  <a:lnTo>
                    <a:pt x="2100326" y="63627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9" name="object 139" descr=""/>
            <p:cNvSpPr/>
            <p:nvPr/>
          </p:nvSpPr>
          <p:spPr>
            <a:xfrm>
              <a:off x="14395450" y="8662416"/>
              <a:ext cx="17780" cy="0"/>
            </a:xfrm>
            <a:custGeom>
              <a:avLst/>
              <a:gdLst/>
              <a:ahLst/>
              <a:cxnLst/>
              <a:rect l="l" t="t" r="r" b="b"/>
              <a:pathLst>
                <a:path w="17780" h="0">
                  <a:moveTo>
                    <a:pt x="0" y="0"/>
                  </a:moveTo>
                  <a:lnTo>
                    <a:pt x="17398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BCA7E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40" name="object 140" descr=""/>
            <p:cNvSpPr/>
            <p:nvPr/>
          </p:nvSpPr>
          <p:spPr>
            <a:xfrm>
              <a:off x="14518641" y="8598789"/>
              <a:ext cx="1055370" cy="64135"/>
            </a:xfrm>
            <a:custGeom>
              <a:avLst/>
              <a:gdLst/>
              <a:ahLst/>
              <a:cxnLst/>
              <a:rect l="l" t="t" r="r" b="b"/>
              <a:pathLst>
                <a:path w="1055369" h="64134">
                  <a:moveTo>
                    <a:pt x="10414" y="0"/>
                  </a:moveTo>
                  <a:lnTo>
                    <a:pt x="0" y="0"/>
                  </a:lnTo>
                  <a:lnTo>
                    <a:pt x="0" y="63627"/>
                  </a:lnTo>
                  <a:lnTo>
                    <a:pt x="10414" y="63627"/>
                  </a:lnTo>
                  <a:lnTo>
                    <a:pt x="10414" y="0"/>
                  </a:lnTo>
                  <a:close/>
                </a:path>
                <a:path w="1055369" h="64134">
                  <a:moveTo>
                    <a:pt x="68453" y="31877"/>
                  </a:moveTo>
                  <a:lnTo>
                    <a:pt x="58039" y="31877"/>
                  </a:lnTo>
                  <a:lnTo>
                    <a:pt x="58039" y="63627"/>
                  </a:lnTo>
                  <a:lnTo>
                    <a:pt x="68453" y="63627"/>
                  </a:lnTo>
                  <a:lnTo>
                    <a:pt x="68453" y="31877"/>
                  </a:lnTo>
                  <a:close/>
                </a:path>
                <a:path w="1055369" h="64134">
                  <a:moveTo>
                    <a:pt x="184531" y="31877"/>
                  </a:moveTo>
                  <a:lnTo>
                    <a:pt x="171450" y="31877"/>
                  </a:lnTo>
                  <a:lnTo>
                    <a:pt x="171450" y="63627"/>
                  </a:lnTo>
                  <a:lnTo>
                    <a:pt x="184531" y="63627"/>
                  </a:lnTo>
                  <a:lnTo>
                    <a:pt x="184531" y="31877"/>
                  </a:lnTo>
                  <a:close/>
                </a:path>
                <a:path w="1055369" h="64134">
                  <a:moveTo>
                    <a:pt x="242570" y="31877"/>
                  </a:moveTo>
                  <a:lnTo>
                    <a:pt x="232156" y="31877"/>
                  </a:lnTo>
                  <a:lnTo>
                    <a:pt x="232156" y="63627"/>
                  </a:lnTo>
                  <a:lnTo>
                    <a:pt x="242570" y="63627"/>
                  </a:lnTo>
                  <a:lnTo>
                    <a:pt x="242570" y="31877"/>
                  </a:lnTo>
                  <a:close/>
                </a:path>
                <a:path w="1055369" h="64134">
                  <a:moveTo>
                    <a:pt x="358635" y="0"/>
                  </a:moveTo>
                  <a:lnTo>
                    <a:pt x="348234" y="0"/>
                  </a:lnTo>
                  <a:lnTo>
                    <a:pt x="348234" y="63627"/>
                  </a:lnTo>
                  <a:lnTo>
                    <a:pt x="358635" y="63627"/>
                  </a:lnTo>
                  <a:lnTo>
                    <a:pt x="358635" y="0"/>
                  </a:lnTo>
                  <a:close/>
                </a:path>
                <a:path w="1055369" h="64134">
                  <a:moveTo>
                    <a:pt x="997191" y="31877"/>
                  </a:moveTo>
                  <a:lnTo>
                    <a:pt x="979805" y="31877"/>
                  </a:lnTo>
                  <a:lnTo>
                    <a:pt x="979805" y="63627"/>
                  </a:lnTo>
                  <a:lnTo>
                    <a:pt x="997191" y="63627"/>
                  </a:lnTo>
                  <a:lnTo>
                    <a:pt x="997191" y="31877"/>
                  </a:lnTo>
                  <a:close/>
                </a:path>
                <a:path w="1055369" h="64134">
                  <a:moveTo>
                    <a:pt x="1055370" y="31877"/>
                  </a:moveTo>
                  <a:lnTo>
                    <a:pt x="1037971" y="31877"/>
                  </a:lnTo>
                  <a:lnTo>
                    <a:pt x="1037971" y="63627"/>
                  </a:lnTo>
                  <a:lnTo>
                    <a:pt x="1055370" y="63627"/>
                  </a:lnTo>
                  <a:lnTo>
                    <a:pt x="1055370" y="31877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41" name="object 141" descr=""/>
          <p:cNvSpPr txBox="1"/>
          <p:nvPr/>
        </p:nvSpPr>
        <p:spPr>
          <a:xfrm>
            <a:off x="286258" y="8576436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2" name="object 142" descr=""/>
          <p:cNvSpPr txBox="1"/>
          <p:nvPr/>
        </p:nvSpPr>
        <p:spPr>
          <a:xfrm>
            <a:off x="260858" y="8481186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43" name="object 143" descr=""/>
          <p:cNvSpPr txBox="1"/>
          <p:nvPr/>
        </p:nvSpPr>
        <p:spPr>
          <a:xfrm>
            <a:off x="260858" y="8385809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44" name="object 144" descr=""/>
          <p:cNvSpPr txBox="1"/>
          <p:nvPr/>
        </p:nvSpPr>
        <p:spPr>
          <a:xfrm>
            <a:off x="260858" y="8290432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45" name="object 145" descr=""/>
          <p:cNvSpPr txBox="1"/>
          <p:nvPr/>
        </p:nvSpPr>
        <p:spPr>
          <a:xfrm>
            <a:off x="197357" y="8195056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6" name="object 146" descr=""/>
          <p:cNvSpPr txBox="1"/>
          <p:nvPr/>
        </p:nvSpPr>
        <p:spPr>
          <a:xfrm>
            <a:off x="197357" y="8099806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7" name="object 147" descr=""/>
          <p:cNvSpPr txBox="1"/>
          <p:nvPr/>
        </p:nvSpPr>
        <p:spPr>
          <a:xfrm>
            <a:off x="197357" y="8004429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8" name="object 148" descr=""/>
          <p:cNvSpPr txBox="1"/>
          <p:nvPr/>
        </p:nvSpPr>
        <p:spPr>
          <a:xfrm>
            <a:off x="197357" y="7909052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9" name="object 149" descr=""/>
          <p:cNvSpPr txBox="1"/>
          <p:nvPr/>
        </p:nvSpPr>
        <p:spPr>
          <a:xfrm>
            <a:off x="197357" y="7813675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3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0" name="object 150" descr=""/>
          <p:cNvSpPr txBox="1"/>
          <p:nvPr/>
        </p:nvSpPr>
        <p:spPr>
          <a:xfrm>
            <a:off x="197357" y="771829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6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1" name="object 151" descr=""/>
          <p:cNvSpPr txBox="1"/>
          <p:nvPr/>
        </p:nvSpPr>
        <p:spPr>
          <a:xfrm>
            <a:off x="197357" y="762304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9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2" name="object 152" descr=""/>
          <p:cNvSpPr txBox="1"/>
          <p:nvPr/>
        </p:nvSpPr>
        <p:spPr>
          <a:xfrm>
            <a:off x="197357" y="7527670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3" name="object 153" descr=""/>
          <p:cNvSpPr txBox="1"/>
          <p:nvPr/>
        </p:nvSpPr>
        <p:spPr>
          <a:xfrm>
            <a:off x="197357" y="7432293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5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4" name="object 154" descr=""/>
          <p:cNvSpPr txBox="1"/>
          <p:nvPr/>
        </p:nvSpPr>
        <p:spPr>
          <a:xfrm>
            <a:off x="197357" y="733691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8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55" name="object 155" descr=""/>
          <p:cNvSpPr txBox="1"/>
          <p:nvPr/>
        </p:nvSpPr>
        <p:spPr>
          <a:xfrm>
            <a:off x="197357" y="724166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80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sz="900" spc="-42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12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56" name="object 156" descr=""/>
          <p:cNvSpPr txBox="1"/>
          <p:nvPr/>
        </p:nvSpPr>
        <p:spPr>
          <a:xfrm>
            <a:off x="222758" y="6667147"/>
            <a:ext cx="1750695" cy="546735"/>
          </a:xfrm>
          <a:prstGeom prst="rect">
            <a:avLst/>
          </a:prstGeom>
        </p:spPr>
        <p:txBody>
          <a:bodyPr wrap="square" lIns="0" tIns="121920" rIns="0" bIns="0" rtlCol="0" vert="horz">
            <a:spAutoFit/>
          </a:bodyPr>
          <a:lstStyle/>
          <a:p>
            <a:pPr marL="201930">
              <a:lnSpc>
                <a:spcPct val="100000"/>
              </a:lnSpc>
              <a:spcBef>
                <a:spcPts val="960"/>
              </a:spcBef>
            </a:pPr>
            <a:r>
              <a:rPr dirty="0" sz="1300">
                <a:latin typeface="Arial"/>
                <a:cs typeface="Arial"/>
              </a:rPr>
              <a:t>Number of </a:t>
            </a:r>
            <a:r>
              <a:rPr dirty="0" sz="1300" spc="-10">
                <a:latin typeface="Arial"/>
                <a:cs typeface="Arial"/>
              </a:rPr>
              <a:t>censoring</a:t>
            </a:r>
            <a:endParaRPr sz="13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6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48</a:t>
            </a:r>
            <a:endParaRPr sz="900">
              <a:latin typeface="Arial"/>
              <a:cs typeface="Arial"/>
            </a:endParaRPr>
          </a:p>
        </p:txBody>
      </p:sp>
      <p:sp>
        <p:nvSpPr>
          <p:cNvPr id="157" name="object 157" descr=""/>
          <p:cNvSpPr txBox="1"/>
          <p:nvPr/>
        </p:nvSpPr>
        <p:spPr>
          <a:xfrm>
            <a:off x="1106297" y="875639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58" name="object 158" descr=""/>
          <p:cNvSpPr txBox="1"/>
          <p:nvPr/>
        </p:nvSpPr>
        <p:spPr>
          <a:xfrm>
            <a:off x="3977132" y="875639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59" name="object 159" descr=""/>
          <p:cNvSpPr txBox="1"/>
          <p:nvPr/>
        </p:nvSpPr>
        <p:spPr>
          <a:xfrm>
            <a:off x="6848093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60" name="object 160" descr=""/>
          <p:cNvSpPr txBox="1"/>
          <p:nvPr/>
        </p:nvSpPr>
        <p:spPr>
          <a:xfrm>
            <a:off x="9750679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61" name="object 161" descr=""/>
          <p:cNvSpPr txBox="1"/>
          <p:nvPr/>
        </p:nvSpPr>
        <p:spPr>
          <a:xfrm>
            <a:off x="12653264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62" name="object 162" descr=""/>
          <p:cNvSpPr txBox="1"/>
          <p:nvPr/>
        </p:nvSpPr>
        <p:spPr>
          <a:xfrm>
            <a:off x="15555976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63" name="object 163" descr=""/>
          <p:cNvSpPr txBox="1"/>
          <p:nvPr/>
        </p:nvSpPr>
        <p:spPr>
          <a:xfrm>
            <a:off x="8239506" y="8891269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64" name="object 164" descr=""/>
          <p:cNvSpPr txBox="1"/>
          <p:nvPr/>
        </p:nvSpPr>
        <p:spPr>
          <a:xfrm>
            <a:off x="30759" y="7618984"/>
            <a:ext cx="181610" cy="56134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10">
                <a:latin typeface="Arial"/>
                <a:cs typeface="Arial"/>
              </a:rPr>
              <a:t>n.censor</a:t>
            </a:r>
            <a:endParaRPr sz="11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Graphics Output</dc:title>
  <dcterms:created xsi:type="dcterms:W3CDTF">2025-11-12T03:34:52Z</dcterms:created>
  <dcterms:modified xsi:type="dcterms:W3CDTF">2025-11-12T03:34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8-12T00:00:00Z</vt:filetime>
  </property>
  <property fmtid="{D5CDD505-2E9C-101B-9397-08002B2CF9AE}" pid="3" name="Creator">
    <vt:lpwstr>R</vt:lpwstr>
  </property>
  <property fmtid="{D5CDD505-2E9C-101B-9397-08002B2CF9AE}" pid="4" name="LastSaved">
    <vt:filetime>2025-11-12T00:00:00Z</vt:filetime>
  </property>
  <property fmtid="{D5CDD505-2E9C-101B-9397-08002B2CF9AE}" pid="5" name="Producer">
    <vt:lpwstr>R 4.5.0</vt:lpwstr>
  </property>
</Properties>
</file>